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7772400" cy="10058400"/>
  <p:notesSz cx="7772400" cy="100584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14" d="100"/>
          <a:sy n="214" d="100"/>
        </p:scale>
        <p:origin x="-6426" y="-660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82930" y="3118104"/>
            <a:ext cx="6606540" cy="211226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65860" y="5632704"/>
            <a:ext cx="5440680" cy="25146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6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6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88620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002786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6/2022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6/2022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6/2022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88620" y="402336"/>
            <a:ext cx="6995160" cy="16093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88620" y="2313432"/>
            <a:ext cx="6995160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642616" y="9354312"/>
            <a:ext cx="2487168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88620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6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596128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object 135">
            <a:extLst>
              <a:ext uri="{FF2B5EF4-FFF2-40B4-BE49-F238E27FC236}">
                <a16:creationId xmlns:a16="http://schemas.microsoft.com/office/drawing/2014/main" id="{BAAB6A1C-2925-99B6-8DF9-79D7106F129B}"/>
              </a:ext>
            </a:extLst>
          </p:cNvPr>
          <p:cNvSpPr/>
          <p:nvPr/>
        </p:nvSpPr>
        <p:spPr>
          <a:xfrm>
            <a:off x="6699363" y="1371629"/>
            <a:ext cx="381000" cy="245745"/>
          </a:xfrm>
          <a:custGeom>
            <a:avLst/>
            <a:gdLst/>
            <a:ahLst/>
            <a:cxnLst/>
            <a:rect l="l" t="t" r="r" b="b"/>
            <a:pathLst>
              <a:path w="381000" h="245744">
                <a:moveTo>
                  <a:pt x="0" y="60947"/>
                </a:moveTo>
                <a:lnTo>
                  <a:pt x="259029" y="60947"/>
                </a:lnTo>
                <a:lnTo>
                  <a:pt x="259029" y="0"/>
                </a:lnTo>
                <a:lnTo>
                  <a:pt x="380923" y="123418"/>
                </a:lnTo>
                <a:lnTo>
                  <a:pt x="259029" y="245325"/>
                </a:lnTo>
                <a:lnTo>
                  <a:pt x="259029" y="184365"/>
                </a:lnTo>
                <a:lnTo>
                  <a:pt x="0" y="184365"/>
                </a:lnTo>
                <a:lnTo>
                  <a:pt x="0" y="60947"/>
                </a:lnTo>
                <a:close/>
              </a:path>
            </a:pathLst>
          </a:custGeom>
          <a:solidFill>
            <a:schemeClr val="tx1"/>
          </a:solidFill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3" name="object 137">
            <a:extLst>
              <a:ext uri="{FF2B5EF4-FFF2-40B4-BE49-F238E27FC236}">
                <a16:creationId xmlns:a16="http://schemas.microsoft.com/office/drawing/2014/main" id="{842AE9B0-17BB-2A55-BC9E-B7713E6BA2F7}"/>
              </a:ext>
            </a:extLst>
          </p:cNvPr>
          <p:cNvSpPr/>
          <p:nvPr/>
        </p:nvSpPr>
        <p:spPr>
          <a:xfrm>
            <a:off x="4267682" y="1371629"/>
            <a:ext cx="381000" cy="245745"/>
          </a:xfrm>
          <a:custGeom>
            <a:avLst/>
            <a:gdLst/>
            <a:ahLst/>
            <a:cxnLst/>
            <a:rect l="l" t="t" r="r" b="b"/>
            <a:pathLst>
              <a:path w="381000" h="245744">
                <a:moveTo>
                  <a:pt x="380911" y="60947"/>
                </a:moveTo>
                <a:lnTo>
                  <a:pt x="121894" y="60947"/>
                </a:lnTo>
                <a:lnTo>
                  <a:pt x="121894" y="0"/>
                </a:lnTo>
                <a:lnTo>
                  <a:pt x="0" y="123418"/>
                </a:lnTo>
                <a:lnTo>
                  <a:pt x="121894" y="245325"/>
                </a:lnTo>
                <a:lnTo>
                  <a:pt x="121894" y="184365"/>
                </a:lnTo>
                <a:lnTo>
                  <a:pt x="380911" y="184365"/>
                </a:lnTo>
                <a:lnTo>
                  <a:pt x="380911" y="60947"/>
                </a:lnTo>
                <a:close/>
              </a:path>
            </a:pathLst>
          </a:custGeom>
          <a:solidFill>
            <a:schemeClr val="tx1"/>
          </a:solidFill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5" name="object 135">
            <a:extLst>
              <a:ext uri="{FF2B5EF4-FFF2-40B4-BE49-F238E27FC236}">
                <a16:creationId xmlns:a16="http://schemas.microsoft.com/office/drawing/2014/main" id="{8BD501AB-B75F-BF90-DA0D-882545935A83}"/>
              </a:ext>
            </a:extLst>
          </p:cNvPr>
          <p:cNvSpPr/>
          <p:nvPr/>
        </p:nvSpPr>
        <p:spPr>
          <a:xfrm>
            <a:off x="6699363" y="3370664"/>
            <a:ext cx="381000" cy="245745"/>
          </a:xfrm>
          <a:custGeom>
            <a:avLst/>
            <a:gdLst/>
            <a:ahLst/>
            <a:cxnLst/>
            <a:rect l="l" t="t" r="r" b="b"/>
            <a:pathLst>
              <a:path w="381000" h="245744">
                <a:moveTo>
                  <a:pt x="0" y="60947"/>
                </a:moveTo>
                <a:lnTo>
                  <a:pt x="259029" y="60947"/>
                </a:lnTo>
                <a:lnTo>
                  <a:pt x="259029" y="0"/>
                </a:lnTo>
                <a:lnTo>
                  <a:pt x="380923" y="123418"/>
                </a:lnTo>
                <a:lnTo>
                  <a:pt x="259029" y="245325"/>
                </a:lnTo>
                <a:lnTo>
                  <a:pt x="259029" y="184365"/>
                </a:lnTo>
                <a:lnTo>
                  <a:pt x="0" y="184365"/>
                </a:lnTo>
                <a:lnTo>
                  <a:pt x="0" y="60947"/>
                </a:lnTo>
                <a:close/>
              </a:path>
            </a:pathLst>
          </a:custGeom>
          <a:solidFill>
            <a:schemeClr val="tx1"/>
          </a:solidFill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7" name="object 137">
            <a:extLst>
              <a:ext uri="{FF2B5EF4-FFF2-40B4-BE49-F238E27FC236}">
                <a16:creationId xmlns:a16="http://schemas.microsoft.com/office/drawing/2014/main" id="{6C07275B-5E17-2C25-2A9A-50D902F8921C}"/>
              </a:ext>
            </a:extLst>
          </p:cNvPr>
          <p:cNvSpPr/>
          <p:nvPr/>
        </p:nvSpPr>
        <p:spPr>
          <a:xfrm>
            <a:off x="4267682" y="3370664"/>
            <a:ext cx="381000" cy="245745"/>
          </a:xfrm>
          <a:custGeom>
            <a:avLst/>
            <a:gdLst/>
            <a:ahLst/>
            <a:cxnLst/>
            <a:rect l="l" t="t" r="r" b="b"/>
            <a:pathLst>
              <a:path w="381000" h="245744">
                <a:moveTo>
                  <a:pt x="380911" y="60947"/>
                </a:moveTo>
                <a:lnTo>
                  <a:pt x="121894" y="60947"/>
                </a:lnTo>
                <a:lnTo>
                  <a:pt x="121894" y="0"/>
                </a:lnTo>
                <a:lnTo>
                  <a:pt x="0" y="123418"/>
                </a:lnTo>
                <a:lnTo>
                  <a:pt x="121894" y="245325"/>
                </a:lnTo>
                <a:lnTo>
                  <a:pt x="121894" y="184365"/>
                </a:lnTo>
                <a:lnTo>
                  <a:pt x="380911" y="184365"/>
                </a:lnTo>
                <a:lnTo>
                  <a:pt x="380911" y="60947"/>
                </a:lnTo>
                <a:close/>
              </a:path>
            </a:pathLst>
          </a:custGeom>
          <a:solidFill>
            <a:schemeClr val="tx1"/>
          </a:solidFill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9" name="object 135">
            <a:extLst>
              <a:ext uri="{FF2B5EF4-FFF2-40B4-BE49-F238E27FC236}">
                <a16:creationId xmlns:a16="http://schemas.microsoft.com/office/drawing/2014/main" id="{D89EC811-9726-94FE-04B5-C7F2FB816959}"/>
              </a:ext>
            </a:extLst>
          </p:cNvPr>
          <p:cNvSpPr/>
          <p:nvPr/>
        </p:nvSpPr>
        <p:spPr>
          <a:xfrm>
            <a:off x="3062183" y="3378200"/>
            <a:ext cx="381000" cy="245745"/>
          </a:xfrm>
          <a:custGeom>
            <a:avLst/>
            <a:gdLst/>
            <a:ahLst/>
            <a:cxnLst/>
            <a:rect l="l" t="t" r="r" b="b"/>
            <a:pathLst>
              <a:path w="381000" h="245744">
                <a:moveTo>
                  <a:pt x="0" y="60947"/>
                </a:moveTo>
                <a:lnTo>
                  <a:pt x="259029" y="60947"/>
                </a:lnTo>
                <a:lnTo>
                  <a:pt x="259029" y="0"/>
                </a:lnTo>
                <a:lnTo>
                  <a:pt x="380923" y="123418"/>
                </a:lnTo>
                <a:lnTo>
                  <a:pt x="259029" y="245325"/>
                </a:lnTo>
                <a:lnTo>
                  <a:pt x="259029" y="184365"/>
                </a:lnTo>
                <a:lnTo>
                  <a:pt x="0" y="184365"/>
                </a:lnTo>
                <a:lnTo>
                  <a:pt x="0" y="60947"/>
                </a:lnTo>
                <a:close/>
              </a:path>
            </a:pathLst>
          </a:custGeom>
          <a:solidFill>
            <a:schemeClr val="tx1"/>
          </a:solidFill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1" name="object 137">
            <a:extLst>
              <a:ext uri="{FF2B5EF4-FFF2-40B4-BE49-F238E27FC236}">
                <a16:creationId xmlns:a16="http://schemas.microsoft.com/office/drawing/2014/main" id="{7A4FF0CD-526A-D618-83F0-44DCB69D2EB1}"/>
              </a:ext>
            </a:extLst>
          </p:cNvPr>
          <p:cNvSpPr/>
          <p:nvPr/>
        </p:nvSpPr>
        <p:spPr>
          <a:xfrm>
            <a:off x="630502" y="3378200"/>
            <a:ext cx="381000" cy="245745"/>
          </a:xfrm>
          <a:custGeom>
            <a:avLst/>
            <a:gdLst/>
            <a:ahLst/>
            <a:cxnLst/>
            <a:rect l="l" t="t" r="r" b="b"/>
            <a:pathLst>
              <a:path w="381000" h="245744">
                <a:moveTo>
                  <a:pt x="380911" y="60947"/>
                </a:moveTo>
                <a:lnTo>
                  <a:pt x="121894" y="60947"/>
                </a:lnTo>
                <a:lnTo>
                  <a:pt x="121894" y="0"/>
                </a:lnTo>
                <a:lnTo>
                  <a:pt x="0" y="123418"/>
                </a:lnTo>
                <a:lnTo>
                  <a:pt x="121894" y="245325"/>
                </a:lnTo>
                <a:lnTo>
                  <a:pt x="121894" y="184365"/>
                </a:lnTo>
                <a:lnTo>
                  <a:pt x="380911" y="184365"/>
                </a:lnTo>
                <a:lnTo>
                  <a:pt x="380911" y="60947"/>
                </a:lnTo>
                <a:close/>
              </a:path>
            </a:pathLst>
          </a:custGeom>
          <a:solidFill>
            <a:schemeClr val="tx1"/>
          </a:solidFill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object 2"/>
          <p:cNvSpPr txBox="1"/>
          <p:nvPr/>
        </p:nvSpPr>
        <p:spPr>
          <a:xfrm>
            <a:off x="587213" y="5390496"/>
            <a:ext cx="9969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B</a:t>
            </a:r>
            <a:endParaRPr sz="8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5679814" y="5697391"/>
            <a:ext cx="149225" cy="1435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110"/>
              </a:lnSpc>
            </a:pPr>
            <a:r>
              <a:rPr sz="1000" dirty="0">
                <a:latin typeface="Arial"/>
                <a:cs typeface="Arial"/>
              </a:rPr>
              <a:t>*</a:t>
            </a:r>
            <a:r>
              <a:rPr sz="1000" spc="-10" dirty="0">
                <a:latin typeface="Arial"/>
                <a:cs typeface="Arial"/>
              </a:rPr>
              <a:t>*</a:t>
            </a:r>
            <a:r>
              <a:rPr sz="1000" dirty="0">
                <a:latin typeface="Arial"/>
                <a:cs typeface="Arial"/>
              </a:rPr>
              <a:t>*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4" name="object 4"/>
          <p:cNvGrpSpPr/>
          <p:nvPr/>
        </p:nvGrpSpPr>
        <p:grpSpPr>
          <a:xfrm>
            <a:off x="4519536" y="5559466"/>
            <a:ext cx="1702435" cy="1416685"/>
            <a:chOff x="4519536" y="5559466"/>
            <a:chExt cx="1702435" cy="1416685"/>
          </a:xfrm>
        </p:grpSpPr>
        <p:sp>
          <p:nvSpPr>
            <p:cNvPr id="5" name="object 5"/>
            <p:cNvSpPr/>
            <p:nvPr/>
          </p:nvSpPr>
          <p:spPr>
            <a:xfrm>
              <a:off x="4523346" y="5563273"/>
              <a:ext cx="1694814" cy="1412875"/>
            </a:xfrm>
            <a:custGeom>
              <a:avLst/>
              <a:gdLst/>
              <a:ahLst/>
              <a:cxnLst/>
              <a:rect l="l" t="t" r="r" b="b"/>
              <a:pathLst>
                <a:path w="1694814" h="1412875">
                  <a:moveTo>
                    <a:pt x="1694319" y="0"/>
                  </a:moveTo>
                  <a:lnTo>
                    <a:pt x="0" y="0"/>
                  </a:lnTo>
                  <a:lnTo>
                    <a:pt x="0" y="1412532"/>
                  </a:lnTo>
                  <a:lnTo>
                    <a:pt x="1694319" y="1412532"/>
                  </a:lnTo>
                  <a:lnTo>
                    <a:pt x="1694319" y="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4523346" y="5563276"/>
              <a:ext cx="1694814" cy="0"/>
            </a:xfrm>
            <a:custGeom>
              <a:avLst/>
              <a:gdLst/>
              <a:ahLst/>
              <a:cxnLst/>
              <a:rect l="l" t="t" r="r" b="b"/>
              <a:pathLst>
                <a:path w="1694814">
                  <a:moveTo>
                    <a:pt x="1694319" y="0"/>
                  </a:moveTo>
                  <a:lnTo>
                    <a:pt x="0" y="0"/>
                  </a:lnTo>
                </a:path>
              </a:pathLst>
            </a:custGeom>
            <a:ln w="7620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4661986" y="6316021"/>
              <a:ext cx="254635" cy="573405"/>
            </a:xfrm>
            <a:custGeom>
              <a:avLst/>
              <a:gdLst/>
              <a:ahLst/>
              <a:cxnLst/>
              <a:rect l="l" t="t" r="r" b="b"/>
              <a:pathLst>
                <a:path w="254635" h="573404">
                  <a:moveTo>
                    <a:pt x="149326" y="0"/>
                  </a:moveTo>
                  <a:lnTo>
                    <a:pt x="105143" y="0"/>
                  </a:lnTo>
                  <a:lnTo>
                    <a:pt x="102095" y="3048"/>
                  </a:lnTo>
                  <a:lnTo>
                    <a:pt x="102095" y="4571"/>
                  </a:lnTo>
                  <a:lnTo>
                    <a:pt x="100571" y="4571"/>
                  </a:lnTo>
                  <a:lnTo>
                    <a:pt x="100571" y="6095"/>
                  </a:lnTo>
                  <a:lnTo>
                    <a:pt x="99047" y="7620"/>
                  </a:lnTo>
                  <a:lnTo>
                    <a:pt x="99047" y="9131"/>
                  </a:lnTo>
                  <a:lnTo>
                    <a:pt x="97523" y="9131"/>
                  </a:lnTo>
                  <a:lnTo>
                    <a:pt x="97523" y="10667"/>
                  </a:lnTo>
                  <a:lnTo>
                    <a:pt x="95999" y="12192"/>
                  </a:lnTo>
                  <a:lnTo>
                    <a:pt x="94475" y="12192"/>
                  </a:lnTo>
                  <a:lnTo>
                    <a:pt x="94475" y="13715"/>
                  </a:lnTo>
                  <a:lnTo>
                    <a:pt x="89903" y="18287"/>
                  </a:lnTo>
                  <a:lnTo>
                    <a:pt x="89903" y="19812"/>
                  </a:lnTo>
                  <a:lnTo>
                    <a:pt x="88379" y="21323"/>
                  </a:lnTo>
                  <a:lnTo>
                    <a:pt x="86855" y="21323"/>
                  </a:lnTo>
                  <a:lnTo>
                    <a:pt x="86855" y="22859"/>
                  </a:lnTo>
                  <a:lnTo>
                    <a:pt x="79247" y="30479"/>
                  </a:lnTo>
                  <a:lnTo>
                    <a:pt x="76187" y="31991"/>
                  </a:lnTo>
                  <a:lnTo>
                    <a:pt x="76187" y="33515"/>
                  </a:lnTo>
                  <a:lnTo>
                    <a:pt x="74663" y="35039"/>
                  </a:lnTo>
                  <a:lnTo>
                    <a:pt x="73139" y="35039"/>
                  </a:lnTo>
                  <a:lnTo>
                    <a:pt x="71627" y="36576"/>
                  </a:lnTo>
                  <a:lnTo>
                    <a:pt x="71627" y="38100"/>
                  </a:lnTo>
                  <a:lnTo>
                    <a:pt x="70103" y="39623"/>
                  </a:lnTo>
                  <a:lnTo>
                    <a:pt x="68579" y="39623"/>
                  </a:lnTo>
                  <a:lnTo>
                    <a:pt x="60959" y="47231"/>
                  </a:lnTo>
                  <a:lnTo>
                    <a:pt x="59435" y="47231"/>
                  </a:lnTo>
                  <a:lnTo>
                    <a:pt x="54863" y="51815"/>
                  </a:lnTo>
                  <a:lnTo>
                    <a:pt x="53339" y="51815"/>
                  </a:lnTo>
                  <a:lnTo>
                    <a:pt x="53339" y="53327"/>
                  </a:lnTo>
                  <a:lnTo>
                    <a:pt x="50291" y="56375"/>
                  </a:lnTo>
                  <a:lnTo>
                    <a:pt x="48767" y="56375"/>
                  </a:lnTo>
                  <a:lnTo>
                    <a:pt x="44195" y="60959"/>
                  </a:lnTo>
                  <a:lnTo>
                    <a:pt x="42671" y="60959"/>
                  </a:lnTo>
                  <a:lnTo>
                    <a:pt x="41147" y="62484"/>
                  </a:lnTo>
                  <a:lnTo>
                    <a:pt x="41147" y="64007"/>
                  </a:lnTo>
                  <a:lnTo>
                    <a:pt x="39623" y="65519"/>
                  </a:lnTo>
                  <a:lnTo>
                    <a:pt x="38099" y="65519"/>
                  </a:lnTo>
                  <a:lnTo>
                    <a:pt x="28968" y="74676"/>
                  </a:lnTo>
                  <a:lnTo>
                    <a:pt x="25907" y="76187"/>
                  </a:lnTo>
                  <a:lnTo>
                    <a:pt x="22859" y="79235"/>
                  </a:lnTo>
                  <a:lnTo>
                    <a:pt x="22859" y="80759"/>
                  </a:lnTo>
                  <a:lnTo>
                    <a:pt x="21335" y="80759"/>
                  </a:lnTo>
                  <a:lnTo>
                    <a:pt x="19811" y="82283"/>
                  </a:lnTo>
                  <a:lnTo>
                    <a:pt x="19811" y="83807"/>
                  </a:lnTo>
                  <a:lnTo>
                    <a:pt x="18300" y="85331"/>
                  </a:lnTo>
                  <a:lnTo>
                    <a:pt x="16776" y="85331"/>
                  </a:lnTo>
                  <a:lnTo>
                    <a:pt x="16776" y="86855"/>
                  </a:lnTo>
                  <a:lnTo>
                    <a:pt x="15252" y="88379"/>
                  </a:lnTo>
                  <a:lnTo>
                    <a:pt x="15252" y="89903"/>
                  </a:lnTo>
                  <a:lnTo>
                    <a:pt x="13715" y="89903"/>
                  </a:lnTo>
                  <a:lnTo>
                    <a:pt x="12191" y="91427"/>
                  </a:lnTo>
                  <a:lnTo>
                    <a:pt x="12191" y="92951"/>
                  </a:lnTo>
                  <a:lnTo>
                    <a:pt x="9156" y="95999"/>
                  </a:lnTo>
                  <a:lnTo>
                    <a:pt x="9156" y="97510"/>
                  </a:lnTo>
                  <a:lnTo>
                    <a:pt x="7632" y="99047"/>
                  </a:lnTo>
                  <a:lnTo>
                    <a:pt x="7632" y="100571"/>
                  </a:lnTo>
                  <a:lnTo>
                    <a:pt x="4584" y="103619"/>
                  </a:lnTo>
                  <a:lnTo>
                    <a:pt x="4584" y="106667"/>
                  </a:lnTo>
                  <a:lnTo>
                    <a:pt x="3060" y="108178"/>
                  </a:lnTo>
                  <a:lnTo>
                    <a:pt x="3060" y="112763"/>
                  </a:lnTo>
                  <a:lnTo>
                    <a:pt x="1523" y="114287"/>
                  </a:lnTo>
                  <a:lnTo>
                    <a:pt x="1523" y="118846"/>
                  </a:lnTo>
                  <a:lnTo>
                    <a:pt x="0" y="120370"/>
                  </a:lnTo>
                  <a:lnTo>
                    <a:pt x="0" y="138671"/>
                  </a:lnTo>
                  <a:lnTo>
                    <a:pt x="1523" y="140195"/>
                  </a:lnTo>
                  <a:lnTo>
                    <a:pt x="1523" y="146278"/>
                  </a:lnTo>
                  <a:lnTo>
                    <a:pt x="3060" y="147802"/>
                  </a:lnTo>
                  <a:lnTo>
                    <a:pt x="3060" y="153898"/>
                  </a:lnTo>
                  <a:lnTo>
                    <a:pt x="4584" y="155422"/>
                  </a:lnTo>
                  <a:lnTo>
                    <a:pt x="4584" y="161518"/>
                  </a:lnTo>
                  <a:lnTo>
                    <a:pt x="6108" y="163042"/>
                  </a:lnTo>
                  <a:lnTo>
                    <a:pt x="6108" y="166090"/>
                  </a:lnTo>
                  <a:lnTo>
                    <a:pt x="7632" y="167614"/>
                  </a:lnTo>
                  <a:lnTo>
                    <a:pt x="7632" y="172186"/>
                  </a:lnTo>
                  <a:lnTo>
                    <a:pt x="9156" y="173710"/>
                  </a:lnTo>
                  <a:lnTo>
                    <a:pt x="9156" y="178282"/>
                  </a:lnTo>
                  <a:lnTo>
                    <a:pt x="10667" y="179806"/>
                  </a:lnTo>
                  <a:lnTo>
                    <a:pt x="10667" y="182854"/>
                  </a:lnTo>
                  <a:lnTo>
                    <a:pt x="12191" y="184378"/>
                  </a:lnTo>
                  <a:lnTo>
                    <a:pt x="12191" y="187426"/>
                  </a:lnTo>
                  <a:lnTo>
                    <a:pt x="13715" y="187426"/>
                  </a:lnTo>
                  <a:lnTo>
                    <a:pt x="13715" y="190474"/>
                  </a:lnTo>
                  <a:lnTo>
                    <a:pt x="15252" y="191998"/>
                  </a:lnTo>
                  <a:lnTo>
                    <a:pt x="15252" y="195046"/>
                  </a:lnTo>
                  <a:lnTo>
                    <a:pt x="18300" y="198081"/>
                  </a:lnTo>
                  <a:lnTo>
                    <a:pt x="18300" y="201142"/>
                  </a:lnTo>
                  <a:lnTo>
                    <a:pt x="19811" y="201142"/>
                  </a:lnTo>
                  <a:lnTo>
                    <a:pt x="19811" y="204190"/>
                  </a:lnTo>
                  <a:lnTo>
                    <a:pt x="21335" y="204190"/>
                  </a:lnTo>
                  <a:lnTo>
                    <a:pt x="21335" y="205714"/>
                  </a:lnTo>
                  <a:lnTo>
                    <a:pt x="24383" y="208749"/>
                  </a:lnTo>
                  <a:lnTo>
                    <a:pt x="24383" y="211797"/>
                  </a:lnTo>
                  <a:lnTo>
                    <a:pt x="25907" y="211797"/>
                  </a:lnTo>
                  <a:lnTo>
                    <a:pt x="25907" y="213334"/>
                  </a:lnTo>
                  <a:lnTo>
                    <a:pt x="27444" y="214858"/>
                  </a:lnTo>
                  <a:lnTo>
                    <a:pt x="27444" y="216382"/>
                  </a:lnTo>
                  <a:lnTo>
                    <a:pt x="28968" y="216382"/>
                  </a:lnTo>
                  <a:lnTo>
                    <a:pt x="28968" y="219417"/>
                  </a:lnTo>
                  <a:lnTo>
                    <a:pt x="33527" y="223989"/>
                  </a:lnTo>
                  <a:lnTo>
                    <a:pt x="33527" y="225526"/>
                  </a:lnTo>
                  <a:lnTo>
                    <a:pt x="35051" y="227050"/>
                  </a:lnTo>
                  <a:lnTo>
                    <a:pt x="35051" y="228561"/>
                  </a:lnTo>
                  <a:lnTo>
                    <a:pt x="36575" y="230085"/>
                  </a:lnTo>
                  <a:lnTo>
                    <a:pt x="38099" y="230085"/>
                  </a:lnTo>
                  <a:lnTo>
                    <a:pt x="38099" y="231609"/>
                  </a:lnTo>
                  <a:lnTo>
                    <a:pt x="39623" y="233133"/>
                  </a:lnTo>
                  <a:lnTo>
                    <a:pt x="39623" y="234657"/>
                  </a:lnTo>
                  <a:lnTo>
                    <a:pt x="41147" y="236181"/>
                  </a:lnTo>
                  <a:lnTo>
                    <a:pt x="41147" y="237705"/>
                  </a:lnTo>
                  <a:lnTo>
                    <a:pt x="42671" y="237705"/>
                  </a:lnTo>
                  <a:lnTo>
                    <a:pt x="44195" y="239242"/>
                  </a:lnTo>
                  <a:lnTo>
                    <a:pt x="44195" y="242277"/>
                  </a:lnTo>
                  <a:lnTo>
                    <a:pt x="45719" y="242277"/>
                  </a:lnTo>
                  <a:lnTo>
                    <a:pt x="45719" y="243801"/>
                  </a:lnTo>
                  <a:lnTo>
                    <a:pt x="48767" y="246849"/>
                  </a:lnTo>
                  <a:lnTo>
                    <a:pt x="48767" y="248373"/>
                  </a:lnTo>
                  <a:lnTo>
                    <a:pt x="50291" y="249897"/>
                  </a:lnTo>
                  <a:lnTo>
                    <a:pt x="50291" y="251421"/>
                  </a:lnTo>
                  <a:lnTo>
                    <a:pt x="51803" y="251421"/>
                  </a:lnTo>
                  <a:lnTo>
                    <a:pt x="51803" y="252945"/>
                  </a:lnTo>
                  <a:lnTo>
                    <a:pt x="53339" y="254469"/>
                  </a:lnTo>
                  <a:lnTo>
                    <a:pt x="53339" y="255993"/>
                  </a:lnTo>
                  <a:lnTo>
                    <a:pt x="54863" y="257517"/>
                  </a:lnTo>
                  <a:lnTo>
                    <a:pt x="54863" y="259041"/>
                  </a:lnTo>
                  <a:lnTo>
                    <a:pt x="56387" y="260565"/>
                  </a:lnTo>
                  <a:lnTo>
                    <a:pt x="56387" y="262077"/>
                  </a:lnTo>
                  <a:lnTo>
                    <a:pt x="57911" y="263613"/>
                  </a:lnTo>
                  <a:lnTo>
                    <a:pt x="57911" y="265137"/>
                  </a:lnTo>
                  <a:lnTo>
                    <a:pt x="59435" y="265137"/>
                  </a:lnTo>
                  <a:lnTo>
                    <a:pt x="59435" y="268185"/>
                  </a:lnTo>
                  <a:lnTo>
                    <a:pt x="60959" y="269709"/>
                  </a:lnTo>
                  <a:lnTo>
                    <a:pt x="60959" y="271233"/>
                  </a:lnTo>
                  <a:lnTo>
                    <a:pt x="62471" y="272757"/>
                  </a:lnTo>
                  <a:lnTo>
                    <a:pt x="62471" y="275805"/>
                  </a:lnTo>
                  <a:lnTo>
                    <a:pt x="63995" y="275805"/>
                  </a:lnTo>
                  <a:lnTo>
                    <a:pt x="63995" y="280377"/>
                  </a:lnTo>
                  <a:lnTo>
                    <a:pt x="65531" y="280377"/>
                  </a:lnTo>
                  <a:lnTo>
                    <a:pt x="65531" y="284937"/>
                  </a:lnTo>
                  <a:lnTo>
                    <a:pt x="67055" y="286461"/>
                  </a:lnTo>
                  <a:lnTo>
                    <a:pt x="67055" y="289521"/>
                  </a:lnTo>
                  <a:lnTo>
                    <a:pt x="68579" y="291045"/>
                  </a:lnTo>
                  <a:lnTo>
                    <a:pt x="68579" y="297129"/>
                  </a:lnTo>
                  <a:lnTo>
                    <a:pt x="70103" y="297129"/>
                  </a:lnTo>
                  <a:lnTo>
                    <a:pt x="70103" y="304761"/>
                  </a:lnTo>
                  <a:lnTo>
                    <a:pt x="71627" y="306273"/>
                  </a:lnTo>
                  <a:lnTo>
                    <a:pt x="71627" y="313905"/>
                  </a:lnTo>
                  <a:lnTo>
                    <a:pt x="73139" y="315429"/>
                  </a:lnTo>
                  <a:lnTo>
                    <a:pt x="73139" y="318465"/>
                  </a:lnTo>
                  <a:lnTo>
                    <a:pt x="74663" y="318465"/>
                  </a:lnTo>
                  <a:lnTo>
                    <a:pt x="74663" y="324561"/>
                  </a:lnTo>
                  <a:lnTo>
                    <a:pt x="76187" y="326085"/>
                  </a:lnTo>
                  <a:lnTo>
                    <a:pt x="76187" y="330657"/>
                  </a:lnTo>
                  <a:lnTo>
                    <a:pt x="77723" y="332181"/>
                  </a:lnTo>
                  <a:lnTo>
                    <a:pt x="77723" y="333705"/>
                  </a:lnTo>
                  <a:lnTo>
                    <a:pt x="79247" y="333705"/>
                  </a:lnTo>
                  <a:lnTo>
                    <a:pt x="79247" y="338264"/>
                  </a:lnTo>
                  <a:lnTo>
                    <a:pt x="80771" y="339801"/>
                  </a:lnTo>
                  <a:lnTo>
                    <a:pt x="80771" y="342849"/>
                  </a:lnTo>
                  <a:lnTo>
                    <a:pt x="82283" y="342849"/>
                  </a:lnTo>
                  <a:lnTo>
                    <a:pt x="82283" y="345897"/>
                  </a:lnTo>
                  <a:lnTo>
                    <a:pt x="83807" y="347421"/>
                  </a:lnTo>
                  <a:lnTo>
                    <a:pt x="83807" y="348945"/>
                  </a:lnTo>
                  <a:lnTo>
                    <a:pt x="85331" y="350456"/>
                  </a:lnTo>
                  <a:lnTo>
                    <a:pt x="85331" y="353517"/>
                  </a:lnTo>
                  <a:lnTo>
                    <a:pt x="86855" y="355041"/>
                  </a:lnTo>
                  <a:lnTo>
                    <a:pt x="86855" y="356565"/>
                  </a:lnTo>
                  <a:lnTo>
                    <a:pt x="88379" y="358089"/>
                  </a:lnTo>
                  <a:lnTo>
                    <a:pt x="88379" y="359613"/>
                  </a:lnTo>
                  <a:lnTo>
                    <a:pt x="89903" y="361124"/>
                  </a:lnTo>
                  <a:lnTo>
                    <a:pt x="89903" y="362648"/>
                  </a:lnTo>
                  <a:lnTo>
                    <a:pt x="91439" y="364185"/>
                  </a:lnTo>
                  <a:lnTo>
                    <a:pt x="91439" y="365709"/>
                  </a:lnTo>
                  <a:lnTo>
                    <a:pt x="92951" y="365709"/>
                  </a:lnTo>
                  <a:lnTo>
                    <a:pt x="92951" y="367233"/>
                  </a:lnTo>
                  <a:lnTo>
                    <a:pt x="94475" y="368757"/>
                  </a:lnTo>
                  <a:lnTo>
                    <a:pt x="94475" y="370281"/>
                  </a:lnTo>
                  <a:lnTo>
                    <a:pt x="95999" y="371792"/>
                  </a:lnTo>
                  <a:lnTo>
                    <a:pt x="95999" y="373316"/>
                  </a:lnTo>
                  <a:lnTo>
                    <a:pt x="97523" y="374840"/>
                  </a:lnTo>
                  <a:lnTo>
                    <a:pt x="97523" y="376364"/>
                  </a:lnTo>
                  <a:lnTo>
                    <a:pt x="100571" y="379425"/>
                  </a:lnTo>
                  <a:lnTo>
                    <a:pt x="100571" y="382473"/>
                  </a:lnTo>
                  <a:lnTo>
                    <a:pt x="102095" y="382473"/>
                  </a:lnTo>
                  <a:lnTo>
                    <a:pt x="102095" y="385508"/>
                  </a:lnTo>
                  <a:lnTo>
                    <a:pt x="105143" y="388556"/>
                  </a:lnTo>
                  <a:lnTo>
                    <a:pt x="105143" y="391617"/>
                  </a:lnTo>
                  <a:lnTo>
                    <a:pt x="106667" y="391617"/>
                  </a:lnTo>
                  <a:lnTo>
                    <a:pt x="106667" y="394652"/>
                  </a:lnTo>
                  <a:lnTo>
                    <a:pt x="108191" y="394652"/>
                  </a:lnTo>
                  <a:lnTo>
                    <a:pt x="108191" y="396176"/>
                  </a:lnTo>
                  <a:lnTo>
                    <a:pt x="109715" y="397700"/>
                  </a:lnTo>
                  <a:lnTo>
                    <a:pt x="109715" y="399224"/>
                  </a:lnTo>
                  <a:lnTo>
                    <a:pt x="111239" y="400748"/>
                  </a:lnTo>
                  <a:lnTo>
                    <a:pt x="111239" y="403809"/>
                  </a:lnTo>
                  <a:lnTo>
                    <a:pt x="112763" y="405320"/>
                  </a:lnTo>
                  <a:lnTo>
                    <a:pt x="112763" y="406844"/>
                  </a:lnTo>
                  <a:lnTo>
                    <a:pt x="114274" y="406844"/>
                  </a:lnTo>
                  <a:lnTo>
                    <a:pt x="114274" y="411416"/>
                  </a:lnTo>
                  <a:lnTo>
                    <a:pt x="115811" y="411416"/>
                  </a:lnTo>
                  <a:lnTo>
                    <a:pt x="115811" y="415988"/>
                  </a:lnTo>
                  <a:lnTo>
                    <a:pt x="117335" y="415988"/>
                  </a:lnTo>
                  <a:lnTo>
                    <a:pt x="117335" y="420560"/>
                  </a:lnTo>
                  <a:lnTo>
                    <a:pt x="118859" y="422084"/>
                  </a:lnTo>
                  <a:lnTo>
                    <a:pt x="118859" y="423608"/>
                  </a:lnTo>
                  <a:lnTo>
                    <a:pt x="120383" y="425132"/>
                  </a:lnTo>
                  <a:lnTo>
                    <a:pt x="120383" y="431228"/>
                  </a:lnTo>
                  <a:lnTo>
                    <a:pt x="121907" y="432752"/>
                  </a:lnTo>
                  <a:lnTo>
                    <a:pt x="121907" y="438835"/>
                  </a:lnTo>
                  <a:lnTo>
                    <a:pt x="123418" y="440372"/>
                  </a:lnTo>
                  <a:lnTo>
                    <a:pt x="123418" y="446468"/>
                  </a:lnTo>
                  <a:lnTo>
                    <a:pt x="124942" y="446468"/>
                  </a:lnTo>
                  <a:lnTo>
                    <a:pt x="124942" y="463219"/>
                  </a:lnTo>
                  <a:lnTo>
                    <a:pt x="126466" y="464743"/>
                  </a:lnTo>
                  <a:lnTo>
                    <a:pt x="126466" y="505891"/>
                  </a:lnTo>
                  <a:lnTo>
                    <a:pt x="124942" y="507415"/>
                  </a:lnTo>
                  <a:lnTo>
                    <a:pt x="124942" y="531799"/>
                  </a:lnTo>
                  <a:lnTo>
                    <a:pt x="123418" y="533323"/>
                  </a:lnTo>
                  <a:lnTo>
                    <a:pt x="123418" y="547027"/>
                  </a:lnTo>
                  <a:lnTo>
                    <a:pt x="121907" y="547027"/>
                  </a:lnTo>
                  <a:lnTo>
                    <a:pt x="121907" y="572935"/>
                  </a:lnTo>
                  <a:lnTo>
                    <a:pt x="132575" y="572935"/>
                  </a:lnTo>
                  <a:lnTo>
                    <a:pt x="132575" y="554659"/>
                  </a:lnTo>
                  <a:lnTo>
                    <a:pt x="131051" y="554659"/>
                  </a:lnTo>
                  <a:lnTo>
                    <a:pt x="131051" y="531799"/>
                  </a:lnTo>
                  <a:lnTo>
                    <a:pt x="129527" y="530275"/>
                  </a:lnTo>
                  <a:lnTo>
                    <a:pt x="129527" y="518083"/>
                  </a:lnTo>
                  <a:lnTo>
                    <a:pt x="127990" y="516559"/>
                  </a:lnTo>
                  <a:lnTo>
                    <a:pt x="127990" y="458647"/>
                  </a:lnTo>
                  <a:lnTo>
                    <a:pt x="129527" y="457136"/>
                  </a:lnTo>
                  <a:lnTo>
                    <a:pt x="129527" y="447979"/>
                  </a:lnTo>
                  <a:lnTo>
                    <a:pt x="131051" y="446468"/>
                  </a:lnTo>
                  <a:lnTo>
                    <a:pt x="131051" y="437311"/>
                  </a:lnTo>
                  <a:lnTo>
                    <a:pt x="132575" y="437311"/>
                  </a:lnTo>
                  <a:lnTo>
                    <a:pt x="132575" y="429704"/>
                  </a:lnTo>
                  <a:lnTo>
                    <a:pt x="134086" y="428180"/>
                  </a:lnTo>
                  <a:lnTo>
                    <a:pt x="134086" y="425132"/>
                  </a:lnTo>
                  <a:lnTo>
                    <a:pt x="135610" y="423608"/>
                  </a:lnTo>
                  <a:lnTo>
                    <a:pt x="135610" y="419036"/>
                  </a:lnTo>
                  <a:lnTo>
                    <a:pt x="137134" y="419036"/>
                  </a:lnTo>
                  <a:lnTo>
                    <a:pt x="137134" y="415988"/>
                  </a:lnTo>
                  <a:lnTo>
                    <a:pt x="138658" y="414464"/>
                  </a:lnTo>
                  <a:lnTo>
                    <a:pt x="138658" y="411416"/>
                  </a:lnTo>
                  <a:lnTo>
                    <a:pt x="140182" y="411416"/>
                  </a:lnTo>
                  <a:lnTo>
                    <a:pt x="140182" y="406844"/>
                  </a:lnTo>
                  <a:lnTo>
                    <a:pt x="141719" y="406844"/>
                  </a:lnTo>
                  <a:lnTo>
                    <a:pt x="141719" y="403809"/>
                  </a:lnTo>
                  <a:lnTo>
                    <a:pt x="143243" y="402272"/>
                  </a:lnTo>
                  <a:lnTo>
                    <a:pt x="143243" y="399224"/>
                  </a:lnTo>
                  <a:lnTo>
                    <a:pt x="146278" y="396176"/>
                  </a:lnTo>
                  <a:lnTo>
                    <a:pt x="146278" y="394652"/>
                  </a:lnTo>
                  <a:lnTo>
                    <a:pt x="147802" y="393141"/>
                  </a:lnTo>
                  <a:lnTo>
                    <a:pt x="147802" y="391617"/>
                  </a:lnTo>
                  <a:lnTo>
                    <a:pt x="149326" y="390093"/>
                  </a:lnTo>
                  <a:lnTo>
                    <a:pt x="149326" y="388556"/>
                  </a:lnTo>
                  <a:lnTo>
                    <a:pt x="150850" y="387032"/>
                  </a:lnTo>
                  <a:lnTo>
                    <a:pt x="150850" y="385508"/>
                  </a:lnTo>
                  <a:lnTo>
                    <a:pt x="152374" y="383984"/>
                  </a:lnTo>
                  <a:lnTo>
                    <a:pt x="152374" y="382473"/>
                  </a:lnTo>
                  <a:lnTo>
                    <a:pt x="153911" y="380949"/>
                  </a:lnTo>
                  <a:lnTo>
                    <a:pt x="153911" y="379425"/>
                  </a:lnTo>
                  <a:lnTo>
                    <a:pt x="156946" y="376364"/>
                  </a:lnTo>
                  <a:lnTo>
                    <a:pt x="156946" y="373316"/>
                  </a:lnTo>
                  <a:lnTo>
                    <a:pt x="158470" y="373316"/>
                  </a:lnTo>
                  <a:lnTo>
                    <a:pt x="158470" y="370281"/>
                  </a:lnTo>
                  <a:lnTo>
                    <a:pt x="161518" y="367233"/>
                  </a:lnTo>
                  <a:lnTo>
                    <a:pt x="161518" y="365709"/>
                  </a:lnTo>
                  <a:lnTo>
                    <a:pt x="163042" y="364185"/>
                  </a:lnTo>
                  <a:lnTo>
                    <a:pt x="163042" y="362648"/>
                  </a:lnTo>
                  <a:lnTo>
                    <a:pt x="166090" y="359613"/>
                  </a:lnTo>
                  <a:lnTo>
                    <a:pt x="166090" y="356565"/>
                  </a:lnTo>
                  <a:lnTo>
                    <a:pt x="167614" y="356565"/>
                  </a:lnTo>
                  <a:lnTo>
                    <a:pt x="167614" y="351993"/>
                  </a:lnTo>
                  <a:lnTo>
                    <a:pt x="169138" y="351993"/>
                  </a:lnTo>
                  <a:lnTo>
                    <a:pt x="169138" y="350456"/>
                  </a:lnTo>
                  <a:lnTo>
                    <a:pt x="170662" y="348945"/>
                  </a:lnTo>
                  <a:lnTo>
                    <a:pt x="170662" y="347421"/>
                  </a:lnTo>
                  <a:lnTo>
                    <a:pt x="172186" y="345897"/>
                  </a:lnTo>
                  <a:lnTo>
                    <a:pt x="172186" y="342849"/>
                  </a:lnTo>
                  <a:lnTo>
                    <a:pt x="173710" y="341325"/>
                  </a:lnTo>
                  <a:lnTo>
                    <a:pt x="173710" y="338264"/>
                  </a:lnTo>
                  <a:lnTo>
                    <a:pt x="175221" y="336753"/>
                  </a:lnTo>
                  <a:lnTo>
                    <a:pt x="175221" y="333705"/>
                  </a:lnTo>
                  <a:lnTo>
                    <a:pt x="176745" y="333705"/>
                  </a:lnTo>
                  <a:lnTo>
                    <a:pt x="176745" y="330657"/>
                  </a:lnTo>
                  <a:lnTo>
                    <a:pt x="178269" y="329133"/>
                  </a:lnTo>
                  <a:lnTo>
                    <a:pt x="178269" y="323037"/>
                  </a:lnTo>
                  <a:lnTo>
                    <a:pt x="179806" y="323037"/>
                  </a:lnTo>
                  <a:lnTo>
                    <a:pt x="179806" y="318465"/>
                  </a:lnTo>
                  <a:lnTo>
                    <a:pt x="181330" y="318465"/>
                  </a:lnTo>
                  <a:lnTo>
                    <a:pt x="181330" y="310845"/>
                  </a:lnTo>
                  <a:lnTo>
                    <a:pt x="182854" y="310845"/>
                  </a:lnTo>
                  <a:lnTo>
                    <a:pt x="182854" y="303237"/>
                  </a:lnTo>
                  <a:lnTo>
                    <a:pt x="184378" y="301713"/>
                  </a:lnTo>
                  <a:lnTo>
                    <a:pt x="184378" y="297129"/>
                  </a:lnTo>
                  <a:lnTo>
                    <a:pt x="185889" y="297129"/>
                  </a:lnTo>
                  <a:lnTo>
                    <a:pt x="185889" y="291045"/>
                  </a:lnTo>
                  <a:lnTo>
                    <a:pt x="187413" y="289521"/>
                  </a:lnTo>
                  <a:lnTo>
                    <a:pt x="187413" y="283425"/>
                  </a:lnTo>
                  <a:lnTo>
                    <a:pt x="188937" y="283425"/>
                  </a:lnTo>
                  <a:lnTo>
                    <a:pt x="188937" y="280377"/>
                  </a:lnTo>
                  <a:lnTo>
                    <a:pt x="190461" y="278853"/>
                  </a:lnTo>
                  <a:lnTo>
                    <a:pt x="190461" y="275805"/>
                  </a:lnTo>
                  <a:lnTo>
                    <a:pt x="191998" y="275805"/>
                  </a:lnTo>
                  <a:lnTo>
                    <a:pt x="191998" y="271233"/>
                  </a:lnTo>
                  <a:lnTo>
                    <a:pt x="193522" y="271233"/>
                  </a:lnTo>
                  <a:lnTo>
                    <a:pt x="193522" y="268185"/>
                  </a:lnTo>
                  <a:lnTo>
                    <a:pt x="195046" y="266661"/>
                  </a:lnTo>
                  <a:lnTo>
                    <a:pt x="195046" y="265137"/>
                  </a:lnTo>
                  <a:lnTo>
                    <a:pt x="196557" y="265137"/>
                  </a:lnTo>
                  <a:lnTo>
                    <a:pt x="196557" y="262077"/>
                  </a:lnTo>
                  <a:lnTo>
                    <a:pt x="198081" y="260565"/>
                  </a:lnTo>
                  <a:lnTo>
                    <a:pt x="198081" y="259041"/>
                  </a:lnTo>
                  <a:lnTo>
                    <a:pt x="201129" y="255993"/>
                  </a:lnTo>
                  <a:lnTo>
                    <a:pt x="201129" y="254469"/>
                  </a:lnTo>
                  <a:lnTo>
                    <a:pt x="202653" y="252945"/>
                  </a:lnTo>
                  <a:lnTo>
                    <a:pt x="202653" y="251421"/>
                  </a:lnTo>
                  <a:lnTo>
                    <a:pt x="204190" y="251421"/>
                  </a:lnTo>
                  <a:lnTo>
                    <a:pt x="204190" y="248373"/>
                  </a:lnTo>
                  <a:lnTo>
                    <a:pt x="205714" y="246849"/>
                  </a:lnTo>
                  <a:lnTo>
                    <a:pt x="207225" y="246849"/>
                  </a:lnTo>
                  <a:lnTo>
                    <a:pt x="207225" y="243801"/>
                  </a:lnTo>
                  <a:lnTo>
                    <a:pt x="210273" y="240753"/>
                  </a:lnTo>
                  <a:lnTo>
                    <a:pt x="210273" y="239242"/>
                  </a:lnTo>
                  <a:lnTo>
                    <a:pt x="213321" y="236181"/>
                  </a:lnTo>
                  <a:lnTo>
                    <a:pt x="213321" y="234657"/>
                  </a:lnTo>
                  <a:lnTo>
                    <a:pt x="214845" y="233133"/>
                  </a:lnTo>
                  <a:lnTo>
                    <a:pt x="216357" y="233133"/>
                  </a:lnTo>
                  <a:lnTo>
                    <a:pt x="216357" y="230085"/>
                  </a:lnTo>
                  <a:lnTo>
                    <a:pt x="217893" y="230085"/>
                  </a:lnTo>
                  <a:lnTo>
                    <a:pt x="217893" y="228561"/>
                  </a:lnTo>
                  <a:lnTo>
                    <a:pt x="219417" y="227050"/>
                  </a:lnTo>
                  <a:lnTo>
                    <a:pt x="219417" y="225526"/>
                  </a:lnTo>
                  <a:lnTo>
                    <a:pt x="220941" y="225526"/>
                  </a:lnTo>
                  <a:lnTo>
                    <a:pt x="220941" y="223989"/>
                  </a:lnTo>
                  <a:lnTo>
                    <a:pt x="222465" y="222465"/>
                  </a:lnTo>
                  <a:lnTo>
                    <a:pt x="222465" y="220941"/>
                  </a:lnTo>
                  <a:lnTo>
                    <a:pt x="223989" y="220941"/>
                  </a:lnTo>
                  <a:lnTo>
                    <a:pt x="223989" y="219417"/>
                  </a:lnTo>
                  <a:lnTo>
                    <a:pt x="225513" y="217893"/>
                  </a:lnTo>
                  <a:lnTo>
                    <a:pt x="225513" y="216382"/>
                  </a:lnTo>
                  <a:lnTo>
                    <a:pt x="227025" y="216382"/>
                  </a:lnTo>
                  <a:lnTo>
                    <a:pt x="227025" y="214858"/>
                  </a:lnTo>
                  <a:lnTo>
                    <a:pt x="228549" y="213334"/>
                  </a:lnTo>
                  <a:lnTo>
                    <a:pt x="228549" y="211797"/>
                  </a:lnTo>
                  <a:lnTo>
                    <a:pt x="231609" y="208749"/>
                  </a:lnTo>
                  <a:lnTo>
                    <a:pt x="231609" y="207225"/>
                  </a:lnTo>
                  <a:lnTo>
                    <a:pt x="233133" y="205714"/>
                  </a:lnTo>
                  <a:lnTo>
                    <a:pt x="233133" y="204190"/>
                  </a:lnTo>
                  <a:lnTo>
                    <a:pt x="234657" y="202666"/>
                  </a:lnTo>
                  <a:lnTo>
                    <a:pt x="234657" y="201142"/>
                  </a:lnTo>
                  <a:lnTo>
                    <a:pt x="236181" y="199605"/>
                  </a:lnTo>
                  <a:lnTo>
                    <a:pt x="236181" y="198081"/>
                  </a:lnTo>
                  <a:lnTo>
                    <a:pt x="237693" y="196557"/>
                  </a:lnTo>
                  <a:lnTo>
                    <a:pt x="237693" y="195046"/>
                  </a:lnTo>
                  <a:lnTo>
                    <a:pt x="239217" y="193522"/>
                  </a:lnTo>
                  <a:lnTo>
                    <a:pt x="239217" y="190474"/>
                  </a:lnTo>
                  <a:lnTo>
                    <a:pt x="240741" y="188950"/>
                  </a:lnTo>
                  <a:lnTo>
                    <a:pt x="240741" y="187426"/>
                  </a:lnTo>
                  <a:lnTo>
                    <a:pt x="242277" y="187426"/>
                  </a:lnTo>
                  <a:lnTo>
                    <a:pt x="242277" y="182854"/>
                  </a:lnTo>
                  <a:lnTo>
                    <a:pt x="243801" y="181330"/>
                  </a:lnTo>
                  <a:lnTo>
                    <a:pt x="243801" y="178282"/>
                  </a:lnTo>
                  <a:lnTo>
                    <a:pt x="245325" y="176758"/>
                  </a:lnTo>
                  <a:lnTo>
                    <a:pt x="245325" y="172186"/>
                  </a:lnTo>
                  <a:lnTo>
                    <a:pt x="246849" y="170662"/>
                  </a:lnTo>
                  <a:lnTo>
                    <a:pt x="246849" y="167614"/>
                  </a:lnTo>
                  <a:lnTo>
                    <a:pt x="248361" y="166090"/>
                  </a:lnTo>
                  <a:lnTo>
                    <a:pt x="248361" y="161518"/>
                  </a:lnTo>
                  <a:lnTo>
                    <a:pt x="249885" y="159994"/>
                  </a:lnTo>
                  <a:lnTo>
                    <a:pt x="249885" y="152374"/>
                  </a:lnTo>
                  <a:lnTo>
                    <a:pt x="251409" y="152374"/>
                  </a:lnTo>
                  <a:lnTo>
                    <a:pt x="251409" y="147802"/>
                  </a:lnTo>
                  <a:lnTo>
                    <a:pt x="252933" y="146278"/>
                  </a:lnTo>
                  <a:lnTo>
                    <a:pt x="252933" y="134086"/>
                  </a:lnTo>
                  <a:lnTo>
                    <a:pt x="254469" y="132562"/>
                  </a:lnTo>
                  <a:lnTo>
                    <a:pt x="254469" y="124955"/>
                  </a:lnTo>
                  <a:lnTo>
                    <a:pt x="252933" y="123418"/>
                  </a:lnTo>
                  <a:lnTo>
                    <a:pt x="252933" y="114287"/>
                  </a:lnTo>
                  <a:lnTo>
                    <a:pt x="251409" y="112763"/>
                  </a:lnTo>
                  <a:lnTo>
                    <a:pt x="251409" y="109702"/>
                  </a:lnTo>
                  <a:lnTo>
                    <a:pt x="249885" y="108178"/>
                  </a:lnTo>
                  <a:lnTo>
                    <a:pt x="249885" y="105143"/>
                  </a:lnTo>
                  <a:lnTo>
                    <a:pt x="248361" y="103619"/>
                  </a:lnTo>
                  <a:lnTo>
                    <a:pt x="248361" y="102095"/>
                  </a:lnTo>
                  <a:lnTo>
                    <a:pt x="246849" y="100571"/>
                  </a:lnTo>
                  <a:lnTo>
                    <a:pt x="246849" y="99047"/>
                  </a:lnTo>
                  <a:lnTo>
                    <a:pt x="243801" y="95999"/>
                  </a:lnTo>
                  <a:lnTo>
                    <a:pt x="243801" y="94475"/>
                  </a:lnTo>
                  <a:lnTo>
                    <a:pt x="242277" y="94475"/>
                  </a:lnTo>
                  <a:lnTo>
                    <a:pt x="242277" y="91427"/>
                  </a:lnTo>
                  <a:lnTo>
                    <a:pt x="240741" y="89903"/>
                  </a:lnTo>
                  <a:lnTo>
                    <a:pt x="239217" y="89903"/>
                  </a:lnTo>
                  <a:lnTo>
                    <a:pt x="239217" y="88379"/>
                  </a:lnTo>
                  <a:lnTo>
                    <a:pt x="237693" y="86855"/>
                  </a:lnTo>
                  <a:lnTo>
                    <a:pt x="237693" y="85331"/>
                  </a:lnTo>
                  <a:lnTo>
                    <a:pt x="236181" y="85331"/>
                  </a:lnTo>
                  <a:lnTo>
                    <a:pt x="233133" y="82283"/>
                  </a:lnTo>
                  <a:lnTo>
                    <a:pt x="233133" y="80759"/>
                  </a:lnTo>
                  <a:lnTo>
                    <a:pt x="231609" y="80759"/>
                  </a:lnTo>
                  <a:lnTo>
                    <a:pt x="231609" y="79235"/>
                  </a:lnTo>
                  <a:lnTo>
                    <a:pt x="228549" y="76187"/>
                  </a:lnTo>
                  <a:lnTo>
                    <a:pt x="227025" y="76187"/>
                  </a:lnTo>
                  <a:lnTo>
                    <a:pt x="227025" y="74676"/>
                  </a:lnTo>
                  <a:lnTo>
                    <a:pt x="223989" y="74676"/>
                  </a:lnTo>
                  <a:lnTo>
                    <a:pt x="223989" y="73139"/>
                  </a:lnTo>
                  <a:lnTo>
                    <a:pt x="220941" y="70091"/>
                  </a:lnTo>
                  <a:lnTo>
                    <a:pt x="219417" y="70091"/>
                  </a:lnTo>
                  <a:lnTo>
                    <a:pt x="219417" y="68567"/>
                  </a:lnTo>
                  <a:lnTo>
                    <a:pt x="216357" y="65519"/>
                  </a:lnTo>
                  <a:lnTo>
                    <a:pt x="214845" y="65519"/>
                  </a:lnTo>
                  <a:lnTo>
                    <a:pt x="211797" y="62484"/>
                  </a:lnTo>
                  <a:lnTo>
                    <a:pt x="211797" y="60959"/>
                  </a:lnTo>
                  <a:lnTo>
                    <a:pt x="208749" y="60959"/>
                  </a:lnTo>
                  <a:lnTo>
                    <a:pt x="208749" y="59423"/>
                  </a:lnTo>
                  <a:lnTo>
                    <a:pt x="205714" y="56375"/>
                  </a:lnTo>
                  <a:lnTo>
                    <a:pt x="204190" y="56375"/>
                  </a:lnTo>
                  <a:lnTo>
                    <a:pt x="201129" y="53327"/>
                  </a:lnTo>
                  <a:lnTo>
                    <a:pt x="201129" y="51815"/>
                  </a:lnTo>
                  <a:lnTo>
                    <a:pt x="198081" y="51815"/>
                  </a:lnTo>
                  <a:lnTo>
                    <a:pt x="198081" y="50292"/>
                  </a:lnTo>
                  <a:lnTo>
                    <a:pt x="195046" y="47231"/>
                  </a:lnTo>
                  <a:lnTo>
                    <a:pt x="193522" y="47231"/>
                  </a:lnTo>
                  <a:lnTo>
                    <a:pt x="190461" y="44183"/>
                  </a:lnTo>
                  <a:lnTo>
                    <a:pt x="188937" y="44183"/>
                  </a:lnTo>
                  <a:lnTo>
                    <a:pt x="188937" y="42659"/>
                  </a:lnTo>
                  <a:lnTo>
                    <a:pt x="185889" y="39623"/>
                  </a:lnTo>
                  <a:lnTo>
                    <a:pt x="184378" y="39623"/>
                  </a:lnTo>
                  <a:lnTo>
                    <a:pt x="181330" y="36576"/>
                  </a:lnTo>
                  <a:lnTo>
                    <a:pt x="181330" y="35039"/>
                  </a:lnTo>
                  <a:lnTo>
                    <a:pt x="179806" y="35039"/>
                  </a:lnTo>
                  <a:lnTo>
                    <a:pt x="175221" y="30479"/>
                  </a:lnTo>
                  <a:lnTo>
                    <a:pt x="173710" y="30479"/>
                  </a:lnTo>
                  <a:lnTo>
                    <a:pt x="173710" y="28956"/>
                  </a:lnTo>
                  <a:lnTo>
                    <a:pt x="167614" y="22859"/>
                  </a:lnTo>
                  <a:lnTo>
                    <a:pt x="167614" y="21323"/>
                  </a:lnTo>
                  <a:lnTo>
                    <a:pt x="166090" y="21323"/>
                  </a:lnTo>
                  <a:lnTo>
                    <a:pt x="163042" y="18287"/>
                  </a:lnTo>
                  <a:lnTo>
                    <a:pt x="163042" y="16764"/>
                  </a:lnTo>
                  <a:lnTo>
                    <a:pt x="161518" y="16764"/>
                  </a:lnTo>
                  <a:lnTo>
                    <a:pt x="161518" y="15240"/>
                  </a:lnTo>
                  <a:lnTo>
                    <a:pt x="156946" y="10667"/>
                  </a:lnTo>
                  <a:lnTo>
                    <a:pt x="156946" y="9131"/>
                  </a:lnTo>
                  <a:lnTo>
                    <a:pt x="155422" y="9131"/>
                  </a:lnTo>
                  <a:lnTo>
                    <a:pt x="155422" y="7620"/>
                  </a:lnTo>
                  <a:lnTo>
                    <a:pt x="150850" y="3048"/>
                  </a:lnTo>
                  <a:lnTo>
                    <a:pt x="150850" y="1523"/>
                  </a:lnTo>
                  <a:lnTo>
                    <a:pt x="149326" y="0"/>
                  </a:lnTo>
                  <a:close/>
                </a:path>
              </a:pathLst>
            </a:custGeom>
            <a:solidFill>
              <a:srgbClr val="F8766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4661986" y="6316021"/>
              <a:ext cx="254635" cy="573405"/>
            </a:xfrm>
            <a:custGeom>
              <a:avLst/>
              <a:gdLst/>
              <a:ahLst/>
              <a:cxnLst/>
              <a:rect l="l" t="t" r="r" b="b"/>
              <a:pathLst>
                <a:path w="254635" h="573404">
                  <a:moveTo>
                    <a:pt x="121907" y="572935"/>
                  </a:moveTo>
                  <a:lnTo>
                    <a:pt x="121907" y="571411"/>
                  </a:lnTo>
                  <a:lnTo>
                    <a:pt x="121907" y="547027"/>
                  </a:lnTo>
                  <a:lnTo>
                    <a:pt x="123418" y="547027"/>
                  </a:lnTo>
                  <a:lnTo>
                    <a:pt x="123418" y="533323"/>
                  </a:lnTo>
                  <a:lnTo>
                    <a:pt x="124942" y="531799"/>
                  </a:lnTo>
                  <a:lnTo>
                    <a:pt x="124942" y="507415"/>
                  </a:lnTo>
                  <a:lnTo>
                    <a:pt x="126466" y="505891"/>
                  </a:lnTo>
                  <a:lnTo>
                    <a:pt x="126466" y="464743"/>
                  </a:lnTo>
                  <a:lnTo>
                    <a:pt x="124942" y="463219"/>
                  </a:lnTo>
                  <a:lnTo>
                    <a:pt x="124942" y="446468"/>
                  </a:lnTo>
                  <a:lnTo>
                    <a:pt x="123418" y="446468"/>
                  </a:lnTo>
                  <a:lnTo>
                    <a:pt x="123418" y="444944"/>
                  </a:lnTo>
                  <a:lnTo>
                    <a:pt x="123418" y="443420"/>
                  </a:lnTo>
                  <a:lnTo>
                    <a:pt x="123418" y="441896"/>
                  </a:lnTo>
                  <a:lnTo>
                    <a:pt x="123418" y="440372"/>
                  </a:lnTo>
                  <a:lnTo>
                    <a:pt x="121907" y="438835"/>
                  </a:lnTo>
                  <a:lnTo>
                    <a:pt x="121907" y="437311"/>
                  </a:lnTo>
                  <a:lnTo>
                    <a:pt x="121907" y="435800"/>
                  </a:lnTo>
                  <a:lnTo>
                    <a:pt x="121907" y="434276"/>
                  </a:lnTo>
                  <a:lnTo>
                    <a:pt x="121907" y="432752"/>
                  </a:lnTo>
                  <a:lnTo>
                    <a:pt x="120383" y="431228"/>
                  </a:lnTo>
                  <a:lnTo>
                    <a:pt x="120383" y="429704"/>
                  </a:lnTo>
                  <a:lnTo>
                    <a:pt x="120383" y="428180"/>
                  </a:lnTo>
                  <a:lnTo>
                    <a:pt x="120383" y="426643"/>
                  </a:lnTo>
                  <a:lnTo>
                    <a:pt x="120383" y="425132"/>
                  </a:lnTo>
                  <a:lnTo>
                    <a:pt x="118859" y="423608"/>
                  </a:lnTo>
                  <a:lnTo>
                    <a:pt x="118859" y="422084"/>
                  </a:lnTo>
                  <a:lnTo>
                    <a:pt x="117335" y="420560"/>
                  </a:lnTo>
                  <a:lnTo>
                    <a:pt x="117335" y="419036"/>
                  </a:lnTo>
                  <a:lnTo>
                    <a:pt x="117335" y="417512"/>
                  </a:lnTo>
                  <a:lnTo>
                    <a:pt x="117335" y="415988"/>
                  </a:lnTo>
                  <a:lnTo>
                    <a:pt x="115811" y="415988"/>
                  </a:lnTo>
                  <a:lnTo>
                    <a:pt x="115811" y="414464"/>
                  </a:lnTo>
                  <a:lnTo>
                    <a:pt x="115811" y="412940"/>
                  </a:lnTo>
                  <a:lnTo>
                    <a:pt x="115811" y="411416"/>
                  </a:lnTo>
                  <a:lnTo>
                    <a:pt x="114274" y="411416"/>
                  </a:lnTo>
                  <a:lnTo>
                    <a:pt x="114274" y="409892"/>
                  </a:lnTo>
                  <a:lnTo>
                    <a:pt x="114274" y="408368"/>
                  </a:lnTo>
                  <a:lnTo>
                    <a:pt x="114274" y="406844"/>
                  </a:lnTo>
                  <a:lnTo>
                    <a:pt x="112763" y="406844"/>
                  </a:lnTo>
                  <a:lnTo>
                    <a:pt x="112763" y="405320"/>
                  </a:lnTo>
                  <a:lnTo>
                    <a:pt x="111239" y="403809"/>
                  </a:lnTo>
                  <a:lnTo>
                    <a:pt x="111239" y="402272"/>
                  </a:lnTo>
                  <a:lnTo>
                    <a:pt x="111239" y="400748"/>
                  </a:lnTo>
                  <a:lnTo>
                    <a:pt x="109715" y="399224"/>
                  </a:lnTo>
                  <a:lnTo>
                    <a:pt x="109715" y="397700"/>
                  </a:lnTo>
                  <a:lnTo>
                    <a:pt x="108191" y="396176"/>
                  </a:lnTo>
                  <a:lnTo>
                    <a:pt x="108191" y="394652"/>
                  </a:lnTo>
                  <a:lnTo>
                    <a:pt x="106667" y="394652"/>
                  </a:lnTo>
                  <a:lnTo>
                    <a:pt x="106667" y="393141"/>
                  </a:lnTo>
                  <a:lnTo>
                    <a:pt x="106667" y="391617"/>
                  </a:lnTo>
                  <a:lnTo>
                    <a:pt x="105143" y="391617"/>
                  </a:lnTo>
                  <a:lnTo>
                    <a:pt x="105143" y="390093"/>
                  </a:lnTo>
                  <a:lnTo>
                    <a:pt x="105143" y="388556"/>
                  </a:lnTo>
                  <a:lnTo>
                    <a:pt x="103619" y="387032"/>
                  </a:lnTo>
                  <a:lnTo>
                    <a:pt x="102095" y="385508"/>
                  </a:lnTo>
                  <a:lnTo>
                    <a:pt x="102095" y="383984"/>
                  </a:lnTo>
                  <a:lnTo>
                    <a:pt x="102095" y="382473"/>
                  </a:lnTo>
                  <a:lnTo>
                    <a:pt x="100571" y="382473"/>
                  </a:lnTo>
                  <a:lnTo>
                    <a:pt x="100571" y="380949"/>
                  </a:lnTo>
                  <a:lnTo>
                    <a:pt x="100571" y="379425"/>
                  </a:lnTo>
                  <a:lnTo>
                    <a:pt x="99047" y="377901"/>
                  </a:lnTo>
                  <a:lnTo>
                    <a:pt x="97523" y="376364"/>
                  </a:lnTo>
                  <a:lnTo>
                    <a:pt x="97523" y="374840"/>
                  </a:lnTo>
                  <a:lnTo>
                    <a:pt x="95999" y="373316"/>
                  </a:lnTo>
                  <a:lnTo>
                    <a:pt x="95999" y="371792"/>
                  </a:lnTo>
                  <a:lnTo>
                    <a:pt x="94475" y="370281"/>
                  </a:lnTo>
                  <a:lnTo>
                    <a:pt x="94475" y="368757"/>
                  </a:lnTo>
                  <a:lnTo>
                    <a:pt x="92951" y="367233"/>
                  </a:lnTo>
                  <a:lnTo>
                    <a:pt x="92951" y="365709"/>
                  </a:lnTo>
                  <a:lnTo>
                    <a:pt x="91439" y="365709"/>
                  </a:lnTo>
                  <a:lnTo>
                    <a:pt x="91439" y="364185"/>
                  </a:lnTo>
                  <a:lnTo>
                    <a:pt x="89903" y="362648"/>
                  </a:lnTo>
                  <a:lnTo>
                    <a:pt x="89903" y="361124"/>
                  </a:lnTo>
                  <a:lnTo>
                    <a:pt x="88379" y="359613"/>
                  </a:lnTo>
                  <a:lnTo>
                    <a:pt x="88379" y="358089"/>
                  </a:lnTo>
                  <a:lnTo>
                    <a:pt x="86855" y="356565"/>
                  </a:lnTo>
                  <a:lnTo>
                    <a:pt x="86855" y="355041"/>
                  </a:lnTo>
                  <a:lnTo>
                    <a:pt x="85331" y="353517"/>
                  </a:lnTo>
                  <a:lnTo>
                    <a:pt x="85331" y="351993"/>
                  </a:lnTo>
                  <a:lnTo>
                    <a:pt x="85331" y="350456"/>
                  </a:lnTo>
                  <a:lnTo>
                    <a:pt x="83807" y="348945"/>
                  </a:lnTo>
                  <a:lnTo>
                    <a:pt x="83807" y="347421"/>
                  </a:lnTo>
                  <a:lnTo>
                    <a:pt x="82283" y="345897"/>
                  </a:lnTo>
                  <a:lnTo>
                    <a:pt x="82283" y="344373"/>
                  </a:lnTo>
                  <a:lnTo>
                    <a:pt x="82283" y="342849"/>
                  </a:lnTo>
                  <a:lnTo>
                    <a:pt x="80771" y="342849"/>
                  </a:lnTo>
                  <a:lnTo>
                    <a:pt x="80771" y="341325"/>
                  </a:lnTo>
                  <a:lnTo>
                    <a:pt x="80771" y="339801"/>
                  </a:lnTo>
                  <a:lnTo>
                    <a:pt x="79247" y="338264"/>
                  </a:lnTo>
                  <a:lnTo>
                    <a:pt x="79247" y="336753"/>
                  </a:lnTo>
                  <a:lnTo>
                    <a:pt x="79247" y="335229"/>
                  </a:lnTo>
                  <a:lnTo>
                    <a:pt x="79247" y="333705"/>
                  </a:lnTo>
                  <a:lnTo>
                    <a:pt x="77723" y="333705"/>
                  </a:lnTo>
                  <a:lnTo>
                    <a:pt x="77723" y="332181"/>
                  </a:lnTo>
                  <a:lnTo>
                    <a:pt x="76187" y="330657"/>
                  </a:lnTo>
                  <a:lnTo>
                    <a:pt x="76187" y="329133"/>
                  </a:lnTo>
                  <a:lnTo>
                    <a:pt x="76187" y="327609"/>
                  </a:lnTo>
                  <a:lnTo>
                    <a:pt x="76187" y="326085"/>
                  </a:lnTo>
                  <a:lnTo>
                    <a:pt x="74663" y="324561"/>
                  </a:lnTo>
                  <a:lnTo>
                    <a:pt x="74663" y="323037"/>
                  </a:lnTo>
                  <a:lnTo>
                    <a:pt x="74663" y="321513"/>
                  </a:lnTo>
                  <a:lnTo>
                    <a:pt x="74663" y="319989"/>
                  </a:lnTo>
                  <a:lnTo>
                    <a:pt x="74663" y="318465"/>
                  </a:lnTo>
                  <a:lnTo>
                    <a:pt x="73139" y="318465"/>
                  </a:lnTo>
                  <a:lnTo>
                    <a:pt x="73139" y="316941"/>
                  </a:lnTo>
                  <a:lnTo>
                    <a:pt x="73139" y="315429"/>
                  </a:lnTo>
                  <a:lnTo>
                    <a:pt x="71627" y="313905"/>
                  </a:lnTo>
                  <a:lnTo>
                    <a:pt x="71627" y="306273"/>
                  </a:lnTo>
                  <a:lnTo>
                    <a:pt x="70103" y="304761"/>
                  </a:lnTo>
                  <a:lnTo>
                    <a:pt x="70103" y="297129"/>
                  </a:lnTo>
                  <a:lnTo>
                    <a:pt x="68579" y="297129"/>
                  </a:lnTo>
                  <a:lnTo>
                    <a:pt x="68579" y="295605"/>
                  </a:lnTo>
                  <a:lnTo>
                    <a:pt x="68579" y="294093"/>
                  </a:lnTo>
                  <a:lnTo>
                    <a:pt x="68579" y="292569"/>
                  </a:lnTo>
                  <a:lnTo>
                    <a:pt x="68579" y="291045"/>
                  </a:lnTo>
                  <a:lnTo>
                    <a:pt x="67055" y="289521"/>
                  </a:lnTo>
                  <a:lnTo>
                    <a:pt x="67055" y="287985"/>
                  </a:lnTo>
                  <a:lnTo>
                    <a:pt x="67055" y="286461"/>
                  </a:lnTo>
                  <a:lnTo>
                    <a:pt x="65531" y="284937"/>
                  </a:lnTo>
                  <a:lnTo>
                    <a:pt x="65531" y="283425"/>
                  </a:lnTo>
                  <a:lnTo>
                    <a:pt x="65531" y="281901"/>
                  </a:lnTo>
                  <a:lnTo>
                    <a:pt x="65531" y="280377"/>
                  </a:lnTo>
                  <a:lnTo>
                    <a:pt x="63995" y="280377"/>
                  </a:lnTo>
                  <a:lnTo>
                    <a:pt x="63995" y="278853"/>
                  </a:lnTo>
                  <a:lnTo>
                    <a:pt x="63995" y="277329"/>
                  </a:lnTo>
                  <a:lnTo>
                    <a:pt x="63995" y="275805"/>
                  </a:lnTo>
                  <a:lnTo>
                    <a:pt x="62471" y="275805"/>
                  </a:lnTo>
                  <a:lnTo>
                    <a:pt x="62471" y="274269"/>
                  </a:lnTo>
                  <a:lnTo>
                    <a:pt x="62471" y="272757"/>
                  </a:lnTo>
                  <a:lnTo>
                    <a:pt x="60959" y="271233"/>
                  </a:lnTo>
                  <a:lnTo>
                    <a:pt x="60959" y="269709"/>
                  </a:lnTo>
                  <a:lnTo>
                    <a:pt x="59435" y="268185"/>
                  </a:lnTo>
                  <a:lnTo>
                    <a:pt x="59435" y="266661"/>
                  </a:lnTo>
                  <a:lnTo>
                    <a:pt x="59435" y="265137"/>
                  </a:lnTo>
                  <a:lnTo>
                    <a:pt x="57911" y="265137"/>
                  </a:lnTo>
                  <a:lnTo>
                    <a:pt x="57911" y="263613"/>
                  </a:lnTo>
                  <a:lnTo>
                    <a:pt x="56387" y="262077"/>
                  </a:lnTo>
                  <a:lnTo>
                    <a:pt x="56387" y="260565"/>
                  </a:lnTo>
                  <a:lnTo>
                    <a:pt x="54863" y="259041"/>
                  </a:lnTo>
                  <a:lnTo>
                    <a:pt x="54863" y="257517"/>
                  </a:lnTo>
                  <a:lnTo>
                    <a:pt x="53339" y="255993"/>
                  </a:lnTo>
                  <a:lnTo>
                    <a:pt x="53339" y="254469"/>
                  </a:lnTo>
                  <a:lnTo>
                    <a:pt x="51803" y="252945"/>
                  </a:lnTo>
                  <a:lnTo>
                    <a:pt x="51803" y="251421"/>
                  </a:lnTo>
                  <a:lnTo>
                    <a:pt x="50291" y="251421"/>
                  </a:lnTo>
                  <a:lnTo>
                    <a:pt x="50291" y="249897"/>
                  </a:lnTo>
                  <a:lnTo>
                    <a:pt x="48767" y="248373"/>
                  </a:lnTo>
                  <a:lnTo>
                    <a:pt x="48767" y="246849"/>
                  </a:lnTo>
                  <a:lnTo>
                    <a:pt x="47243" y="245325"/>
                  </a:lnTo>
                  <a:lnTo>
                    <a:pt x="45719" y="243801"/>
                  </a:lnTo>
                  <a:lnTo>
                    <a:pt x="45719" y="242277"/>
                  </a:lnTo>
                  <a:lnTo>
                    <a:pt x="44195" y="242277"/>
                  </a:lnTo>
                  <a:lnTo>
                    <a:pt x="44195" y="240753"/>
                  </a:lnTo>
                  <a:lnTo>
                    <a:pt x="44195" y="239242"/>
                  </a:lnTo>
                  <a:lnTo>
                    <a:pt x="42671" y="237705"/>
                  </a:lnTo>
                  <a:lnTo>
                    <a:pt x="41147" y="237705"/>
                  </a:lnTo>
                  <a:lnTo>
                    <a:pt x="41147" y="236181"/>
                  </a:lnTo>
                  <a:lnTo>
                    <a:pt x="39623" y="234657"/>
                  </a:lnTo>
                  <a:lnTo>
                    <a:pt x="39623" y="233133"/>
                  </a:lnTo>
                  <a:lnTo>
                    <a:pt x="38099" y="231609"/>
                  </a:lnTo>
                  <a:lnTo>
                    <a:pt x="38099" y="230085"/>
                  </a:lnTo>
                  <a:lnTo>
                    <a:pt x="36575" y="230085"/>
                  </a:lnTo>
                  <a:lnTo>
                    <a:pt x="35051" y="228561"/>
                  </a:lnTo>
                  <a:lnTo>
                    <a:pt x="35051" y="227050"/>
                  </a:lnTo>
                  <a:lnTo>
                    <a:pt x="33527" y="225526"/>
                  </a:lnTo>
                  <a:lnTo>
                    <a:pt x="33527" y="223989"/>
                  </a:lnTo>
                  <a:lnTo>
                    <a:pt x="32003" y="222465"/>
                  </a:lnTo>
                  <a:lnTo>
                    <a:pt x="30479" y="220941"/>
                  </a:lnTo>
                  <a:lnTo>
                    <a:pt x="28968" y="219417"/>
                  </a:lnTo>
                  <a:lnTo>
                    <a:pt x="28968" y="217893"/>
                  </a:lnTo>
                  <a:lnTo>
                    <a:pt x="28968" y="216382"/>
                  </a:lnTo>
                  <a:lnTo>
                    <a:pt x="27444" y="216382"/>
                  </a:lnTo>
                  <a:lnTo>
                    <a:pt x="27444" y="214858"/>
                  </a:lnTo>
                  <a:lnTo>
                    <a:pt x="25907" y="213334"/>
                  </a:lnTo>
                  <a:lnTo>
                    <a:pt x="25907" y="211797"/>
                  </a:lnTo>
                  <a:lnTo>
                    <a:pt x="24383" y="211797"/>
                  </a:lnTo>
                  <a:lnTo>
                    <a:pt x="24383" y="210273"/>
                  </a:lnTo>
                  <a:lnTo>
                    <a:pt x="24383" y="208749"/>
                  </a:lnTo>
                  <a:lnTo>
                    <a:pt x="22859" y="207225"/>
                  </a:lnTo>
                  <a:lnTo>
                    <a:pt x="21335" y="205714"/>
                  </a:lnTo>
                  <a:lnTo>
                    <a:pt x="21335" y="204190"/>
                  </a:lnTo>
                  <a:lnTo>
                    <a:pt x="19811" y="204190"/>
                  </a:lnTo>
                  <a:lnTo>
                    <a:pt x="19811" y="202666"/>
                  </a:lnTo>
                  <a:lnTo>
                    <a:pt x="19811" y="201142"/>
                  </a:lnTo>
                  <a:lnTo>
                    <a:pt x="18300" y="201142"/>
                  </a:lnTo>
                  <a:lnTo>
                    <a:pt x="18300" y="199605"/>
                  </a:lnTo>
                  <a:lnTo>
                    <a:pt x="18300" y="198081"/>
                  </a:lnTo>
                  <a:lnTo>
                    <a:pt x="16776" y="196557"/>
                  </a:lnTo>
                  <a:lnTo>
                    <a:pt x="15252" y="195046"/>
                  </a:lnTo>
                  <a:lnTo>
                    <a:pt x="15252" y="193522"/>
                  </a:lnTo>
                  <a:lnTo>
                    <a:pt x="15252" y="191998"/>
                  </a:lnTo>
                  <a:lnTo>
                    <a:pt x="13715" y="190474"/>
                  </a:lnTo>
                  <a:lnTo>
                    <a:pt x="13715" y="188950"/>
                  </a:lnTo>
                  <a:lnTo>
                    <a:pt x="13715" y="187426"/>
                  </a:lnTo>
                  <a:lnTo>
                    <a:pt x="12191" y="187426"/>
                  </a:lnTo>
                  <a:lnTo>
                    <a:pt x="12191" y="185889"/>
                  </a:lnTo>
                  <a:lnTo>
                    <a:pt x="12191" y="184378"/>
                  </a:lnTo>
                  <a:lnTo>
                    <a:pt x="10667" y="182854"/>
                  </a:lnTo>
                  <a:lnTo>
                    <a:pt x="10667" y="181330"/>
                  </a:lnTo>
                  <a:lnTo>
                    <a:pt x="10667" y="179806"/>
                  </a:lnTo>
                  <a:lnTo>
                    <a:pt x="9156" y="178282"/>
                  </a:lnTo>
                  <a:lnTo>
                    <a:pt x="9156" y="176758"/>
                  </a:lnTo>
                  <a:lnTo>
                    <a:pt x="9156" y="175234"/>
                  </a:lnTo>
                  <a:lnTo>
                    <a:pt x="9156" y="173710"/>
                  </a:lnTo>
                  <a:lnTo>
                    <a:pt x="7632" y="172186"/>
                  </a:lnTo>
                  <a:lnTo>
                    <a:pt x="7632" y="170662"/>
                  </a:lnTo>
                  <a:lnTo>
                    <a:pt x="7632" y="169138"/>
                  </a:lnTo>
                  <a:lnTo>
                    <a:pt x="7632" y="167614"/>
                  </a:lnTo>
                  <a:lnTo>
                    <a:pt x="6108" y="166090"/>
                  </a:lnTo>
                  <a:lnTo>
                    <a:pt x="6108" y="164566"/>
                  </a:lnTo>
                  <a:lnTo>
                    <a:pt x="6108" y="163042"/>
                  </a:lnTo>
                  <a:lnTo>
                    <a:pt x="4584" y="161518"/>
                  </a:lnTo>
                  <a:lnTo>
                    <a:pt x="4584" y="159994"/>
                  </a:lnTo>
                  <a:lnTo>
                    <a:pt x="4584" y="158470"/>
                  </a:lnTo>
                  <a:lnTo>
                    <a:pt x="4584" y="156946"/>
                  </a:lnTo>
                  <a:lnTo>
                    <a:pt x="4584" y="155422"/>
                  </a:lnTo>
                  <a:lnTo>
                    <a:pt x="3060" y="153898"/>
                  </a:lnTo>
                  <a:lnTo>
                    <a:pt x="3060" y="152374"/>
                  </a:lnTo>
                  <a:lnTo>
                    <a:pt x="3060" y="150863"/>
                  </a:lnTo>
                  <a:lnTo>
                    <a:pt x="3060" y="149339"/>
                  </a:lnTo>
                  <a:lnTo>
                    <a:pt x="3060" y="147802"/>
                  </a:lnTo>
                  <a:lnTo>
                    <a:pt x="1523" y="146278"/>
                  </a:lnTo>
                  <a:lnTo>
                    <a:pt x="1523" y="144754"/>
                  </a:lnTo>
                  <a:lnTo>
                    <a:pt x="1523" y="143230"/>
                  </a:lnTo>
                  <a:lnTo>
                    <a:pt x="1523" y="141706"/>
                  </a:lnTo>
                  <a:lnTo>
                    <a:pt x="1523" y="140195"/>
                  </a:lnTo>
                  <a:lnTo>
                    <a:pt x="0" y="138671"/>
                  </a:lnTo>
                  <a:lnTo>
                    <a:pt x="0" y="120370"/>
                  </a:lnTo>
                  <a:lnTo>
                    <a:pt x="1523" y="118846"/>
                  </a:lnTo>
                  <a:lnTo>
                    <a:pt x="1523" y="117335"/>
                  </a:lnTo>
                  <a:lnTo>
                    <a:pt x="1523" y="115811"/>
                  </a:lnTo>
                  <a:lnTo>
                    <a:pt x="1523" y="114287"/>
                  </a:lnTo>
                  <a:lnTo>
                    <a:pt x="3060" y="112763"/>
                  </a:lnTo>
                  <a:lnTo>
                    <a:pt x="3060" y="111239"/>
                  </a:lnTo>
                  <a:lnTo>
                    <a:pt x="3060" y="109702"/>
                  </a:lnTo>
                  <a:lnTo>
                    <a:pt x="3060" y="108178"/>
                  </a:lnTo>
                  <a:lnTo>
                    <a:pt x="4584" y="106667"/>
                  </a:lnTo>
                  <a:lnTo>
                    <a:pt x="4584" y="105143"/>
                  </a:lnTo>
                  <a:lnTo>
                    <a:pt x="4584" y="103619"/>
                  </a:lnTo>
                  <a:lnTo>
                    <a:pt x="6108" y="102095"/>
                  </a:lnTo>
                  <a:lnTo>
                    <a:pt x="7632" y="100571"/>
                  </a:lnTo>
                  <a:lnTo>
                    <a:pt x="7632" y="99047"/>
                  </a:lnTo>
                  <a:lnTo>
                    <a:pt x="9156" y="97510"/>
                  </a:lnTo>
                  <a:lnTo>
                    <a:pt x="9156" y="95999"/>
                  </a:lnTo>
                  <a:lnTo>
                    <a:pt x="10667" y="94475"/>
                  </a:lnTo>
                  <a:lnTo>
                    <a:pt x="12191" y="92951"/>
                  </a:lnTo>
                  <a:lnTo>
                    <a:pt x="12191" y="91427"/>
                  </a:lnTo>
                  <a:lnTo>
                    <a:pt x="13715" y="89903"/>
                  </a:lnTo>
                  <a:lnTo>
                    <a:pt x="15252" y="89903"/>
                  </a:lnTo>
                  <a:lnTo>
                    <a:pt x="15252" y="88379"/>
                  </a:lnTo>
                  <a:lnTo>
                    <a:pt x="16776" y="86855"/>
                  </a:lnTo>
                  <a:lnTo>
                    <a:pt x="16776" y="85331"/>
                  </a:lnTo>
                  <a:lnTo>
                    <a:pt x="18300" y="85331"/>
                  </a:lnTo>
                  <a:lnTo>
                    <a:pt x="19811" y="83807"/>
                  </a:lnTo>
                  <a:lnTo>
                    <a:pt x="19811" y="82283"/>
                  </a:lnTo>
                  <a:lnTo>
                    <a:pt x="21335" y="80759"/>
                  </a:lnTo>
                  <a:lnTo>
                    <a:pt x="22859" y="80759"/>
                  </a:lnTo>
                  <a:lnTo>
                    <a:pt x="22859" y="79235"/>
                  </a:lnTo>
                  <a:lnTo>
                    <a:pt x="24383" y="77711"/>
                  </a:lnTo>
                  <a:lnTo>
                    <a:pt x="25907" y="76187"/>
                  </a:lnTo>
                  <a:lnTo>
                    <a:pt x="28968" y="74676"/>
                  </a:lnTo>
                  <a:lnTo>
                    <a:pt x="30479" y="73139"/>
                  </a:lnTo>
                  <a:lnTo>
                    <a:pt x="32003" y="71615"/>
                  </a:lnTo>
                  <a:lnTo>
                    <a:pt x="33527" y="70091"/>
                  </a:lnTo>
                  <a:lnTo>
                    <a:pt x="35051" y="68567"/>
                  </a:lnTo>
                  <a:lnTo>
                    <a:pt x="36575" y="67043"/>
                  </a:lnTo>
                  <a:lnTo>
                    <a:pt x="38099" y="65519"/>
                  </a:lnTo>
                  <a:lnTo>
                    <a:pt x="39623" y="65519"/>
                  </a:lnTo>
                  <a:lnTo>
                    <a:pt x="41147" y="64007"/>
                  </a:lnTo>
                  <a:lnTo>
                    <a:pt x="41147" y="62484"/>
                  </a:lnTo>
                  <a:lnTo>
                    <a:pt x="42671" y="60959"/>
                  </a:lnTo>
                  <a:lnTo>
                    <a:pt x="44195" y="60959"/>
                  </a:lnTo>
                  <a:lnTo>
                    <a:pt x="45719" y="59423"/>
                  </a:lnTo>
                  <a:lnTo>
                    <a:pt x="47243" y="57899"/>
                  </a:lnTo>
                  <a:lnTo>
                    <a:pt x="48767" y="56375"/>
                  </a:lnTo>
                  <a:lnTo>
                    <a:pt x="50291" y="56375"/>
                  </a:lnTo>
                  <a:lnTo>
                    <a:pt x="51803" y="54851"/>
                  </a:lnTo>
                  <a:lnTo>
                    <a:pt x="53339" y="53327"/>
                  </a:lnTo>
                  <a:lnTo>
                    <a:pt x="53339" y="51815"/>
                  </a:lnTo>
                  <a:lnTo>
                    <a:pt x="54863" y="51815"/>
                  </a:lnTo>
                  <a:lnTo>
                    <a:pt x="56387" y="50292"/>
                  </a:lnTo>
                  <a:lnTo>
                    <a:pt x="57911" y="48767"/>
                  </a:lnTo>
                  <a:lnTo>
                    <a:pt x="59435" y="47231"/>
                  </a:lnTo>
                  <a:lnTo>
                    <a:pt x="60959" y="47231"/>
                  </a:lnTo>
                  <a:lnTo>
                    <a:pt x="62471" y="45707"/>
                  </a:lnTo>
                  <a:lnTo>
                    <a:pt x="63995" y="44183"/>
                  </a:lnTo>
                  <a:lnTo>
                    <a:pt x="65531" y="42659"/>
                  </a:lnTo>
                  <a:lnTo>
                    <a:pt x="67055" y="41148"/>
                  </a:lnTo>
                  <a:lnTo>
                    <a:pt x="68579" y="39623"/>
                  </a:lnTo>
                  <a:lnTo>
                    <a:pt x="70103" y="39623"/>
                  </a:lnTo>
                  <a:lnTo>
                    <a:pt x="71627" y="38100"/>
                  </a:lnTo>
                  <a:lnTo>
                    <a:pt x="71627" y="36576"/>
                  </a:lnTo>
                  <a:lnTo>
                    <a:pt x="73139" y="35039"/>
                  </a:lnTo>
                  <a:lnTo>
                    <a:pt x="74663" y="35039"/>
                  </a:lnTo>
                  <a:lnTo>
                    <a:pt x="76187" y="33515"/>
                  </a:lnTo>
                  <a:lnTo>
                    <a:pt x="76187" y="31991"/>
                  </a:lnTo>
                  <a:lnTo>
                    <a:pt x="79247" y="30479"/>
                  </a:lnTo>
                  <a:lnTo>
                    <a:pt x="80771" y="28956"/>
                  </a:lnTo>
                  <a:lnTo>
                    <a:pt x="82283" y="27431"/>
                  </a:lnTo>
                  <a:lnTo>
                    <a:pt x="83807" y="25907"/>
                  </a:lnTo>
                  <a:lnTo>
                    <a:pt x="85331" y="24384"/>
                  </a:lnTo>
                  <a:lnTo>
                    <a:pt x="86855" y="22859"/>
                  </a:lnTo>
                  <a:lnTo>
                    <a:pt x="86855" y="21323"/>
                  </a:lnTo>
                  <a:lnTo>
                    <a:pt x="88379" y="21323"/>
                  </a:lnTo>
                  <a:lnTo>
                    <a:pt x="89903" y="19812"/>
                  </a:lnTo>
                  <a:lnTo>
                    <a:pt x="89903" y="18287"/>
                  </a:lnTo>
                  <a:lnTo>
                    <a:pt x="91439" y="16764"/>
                  </a:lnTo>
                  <a:lnTo>
                    <a:pt x="92951" y="15240"/>
                  </a:lnTo>
                  <a:lnTo>
                    <a:pt x="94475" y="13715"/>
                  </a:lnTo>
                  <a:lnTo>
                    <a:pt x="94475" y="12192"/>
                  </a:lnTo>
                  <a:lnTo>
                    <a:pt x="95999" y="12192"/>
                  </a:lnTo>
                  <a:lnTo>
                    <a:pt x="97523" y="10667"/>
                  </a:lnTo>
                  <a:lnTo>
                    <a:pt x="97523" y="9131"/>
                  </a:lnTo>
                  <a:lnTo>
                    <a:pt x="99047" y="9131"/>
                  </a:lnTo>
                  <a:lnTo>
                    <a:pt x="99047" y="7620"/>
                  </a:lnTo>
                  <a:lnTo>
                    <a:pt x="100571" y="6095"/>
                  </a:lnTo>
                  <a:lnTo>
                    <a:pt x="100571" y="4571"/>
                  </a:lnTo>
                  <a:lnTo>
                    <a:pt x="102095" y="4571"/>
                  </a:lnTo>
                  <a:lnTo>
                    <a:pt x="102095" y="3048"/>
                  </a:lnTo>
                  <a:lnTo>
                    <a:pt x="103619" y="1523"/>
                  </a:lnTo>
                  <a:lnTo>
                    <a:pt x="105143" y="0"/>
                  </a:lnTo>
                  <a:lnTo>
                    <a:pt x="149326" y="0"/>
                  </a:lnTo>
                  <a:lnTo>
                    <a:pt x="150850" y="1523"/>
                  </a:lnTo>
                  <a:lnTo>
                    <a:pt x="150850" y="3048"/>
                  </a:lnTo>
                  <a:lnTo>
                    <a:pt x="152374" y="4571"/>
                  </a:lnTo>
                  <a:lnTo>
                    <a:pt x="153911" y="6095"/>
                  </a:lnTo>
                  <a:lnTo>
                    <a:pt x="155422" y="7620"/>
                  </a:lnTo>
                  <a:lnTo>
                    <a:pt x="155422" y="9131"/>
                  </a:lnTo>
                  <a:lnTo>
                    <a:pt x="156946" y="9131"/>
                  </a:lnTo>
                  <a:lnTo>
                    <a:pt x="156946" y="10667"/>
                  </a:lnTo>
                  <a:lnTo>
                    <a:pt x="158470" y="12192"/>
                  </a:lnTo>
                  <a:lnTo>
                    <a:pt x="159994" y="13715"/>
                  </a:lnTo>
                  <a:lnTo>
                    <a:pt x="161518" y="15240"/>
                  </a:lnTo>
                  <a:lnTo>
                    <a:pt x="161518" y="16764"/>
                  </a:lnTo>
                  <a:lnTo>
                    <a:pt x="163042" y="16764"/>
                  </a:lnTo>
                  <a:lnTo>
                    <a:pt x="163042" y="18287"/>
                  </a:lnTo>
                  <a:lnTo>
                    <a:pt x="164566" y="19812"/>
                  </a:lnTo>
                  <a:lnTo>
                    <a:pt x="166090" y="21323"/>
                  </a:lnTo>
                  <a:lnTo>
                    <a:pt x="167614" y="21323"/>
                  </a:lnTo>
                  <a:lnTo>
                    <a:pt x="167614" y="22859"/>
                  </a:lnTo>
                  <a:lnTo>
                    <a:pt x="169138" y="24384"/>
                  </a:lnTo>
                  <a:lnTo>
                    <a:pt x="170662" y="25907"/>
                  </a:lnTo>
                  <a:lnTo>
                    <a:pt x="172186" y="27431"/>
                  </a:lnTo>
                  <a:lnTo>
                    <a:pt x="173710" y="28956"/>
                  </a:lnTo>
                  <a:lnTo>
                    <a:pt x="173710" y="30479"/>
                  </a:lnTo>
                  <a:lnTo>
                    <a:pt x="175221" y="30479"/>
                  </a:lnTo>
                  <a:lnTo>
                    <a:pt x="176745" y="31991"/>
                  </a:lnTo>
                  <a:lnTo>
                    <a:pt x="178269" y="33515"/>
                  </a:lnTo>
                  <a:lnTo>
                    <a:pt x="179806" y="35039"/>
                  </a:lnTo>
                  <a:lnTo>
                    <a:pt x="181330" y="35039"/>
                  </a:lnTo>
                  <a:lnTo>
                    <a:pt x="181330" y="36576"/>
                  </a:lnTo>
                  <a:lnTo>
                    <a:pt x="182854" y="38100"/>
                  </a:lnTo>
                  <a:lnTo>
                    <a:pt x="184378" y="39623"/>
                  </a:lnTo>
                  <a:lnTo>
                    <a:pt x="185889" y="39623"/>
                  </a:lnTo>
                  <a:lnTo>
                    <a:pt x="187413" y="41148"/>
                  </a:lnTo>
                  <a:lnTo>
                    <a:pt x="188937" y="42659"/>
                  </a:lnTo>
                  <a:lnTo>
                    <a:pt x="188937" y="44183"/>
                  </a:lnTo>
                  <a:lnTo>
                    <a:pt x="190461" y="44183"/>
                  </a:lnTo>
                  <a:lnTo>
                    <a:pt x="191998" y="45707"/>
                  </a:lnTo>
                  <a:lnTo>
                    <a:pt x="193522" y="47231"/>
                  </a:lnTo>
                  <a:lnTo>
                    <a:pt x="195046" y="47231"/>
                  </a:lnTo>
                  <a:lnTo>
                    <a:pt x="196557" y="48767"/>
                  </a:lnTo>
                  <a:lnTo>
                    <a:pt x="198081" y="50292"/>
                  </a:lnTo>
                  <a:lnTo>
                    <a:pt x="198081" y="51815"/>
                  </a:lnTo>
                  <a:lnTo>
                    <a:pt x="201129" y="51815"/>
                  </a:lnTo>
                  <a:lnTo>
                    <a:pt x="201129" y="53327"/>
                  </a:lnTo>
                  <a:lnTo>
                    <a:pt x="202653" y="54851"/>
                  </a:lnTo>
                  <a:lnTo>
                    <a:pt x="204190" y="56375"/>
                  </a:lnTo>
                  <a:lnTo>
                    <a:pt x="205714" y="56375"/>
                  </a:lnTo>
                  <a:lnTo>
                    <a:pt x="207225" y="57899"/>
                  </a:lnTo>
                  <a:lnTo>
                    <a:pt x="208749" y="59423"/>
                  </a:lnTo>
                  <a:lnTo>
                    <a:pt x="208749" y="60959"/>
                  </a:lnTo>
                  <a:lnTo>
                    <a:pt x="211797" y="60959"/>
                  </a:lnTo>
                  <a:lnTo>
                    <a:pt x="211797" y="62484"/>
                  </a:lnTo>
                  <a:lnTo>
                    <a:pt x="213321" y="64007"/>
                  </a:lnTo>
                  <a:lnTo>
                    <a:pt x="214845" y="65519"/>
                  </a:lnTo>
                  <a:lnTo>
                    <a:pt x="216357" y="65519"/>
                  </a:lnTo>
                  <a:lnTo>
                    <a:pt x="217893" y="67043"/>
                  </a:lnTo>
                  <a:lnTo>
                    <a:pt x="219417" y="68567"/>
                  </a:lnTo>
                  <a:lnTo>
                    <a:pt x="219417" y="70091"/>
                  </a:lnTo>
                  <a:lnTo>
                    <a:pt x="220941" y="70091"/>
                  </a:lnTo>
                  <a:lnTo>
                    <a:pt x="222465" y="71615"/>
                  </a:lnTo>
                  <a:lnTo>
                    <a:pt x="223989" y="73139"/>
                  </a:lnTo>
                  <a:lnTo>
                    <a:pt x="223989" y="74676"/>
                  </a:lnTo>
                  <a:lnTo>
                    <a:pt x="227025" y="74676"/>
                  </a:lnTo>
                  <a:lnTo>
                    <a:pt x="227025" y="76187"/>
                  </a:lnTo>
                  <a:lnTo>
                    <a:pt x="228549" y="76187"/>
                  </a:lnTo>
                  <a:lnTo>
                    <a:pt x="230085" y="77711"/>
                  </a:lnTo>
                  <a:lnTo>
                    <a:pt x="231609" y="79235"/>
                  </a:lnTo>
                  <a:lnTo>
                    <a:pt x="231609" y="80759"/>
                  </a:lnTo>
                  <a:lnTo>
                    <a:pt x="233133" y="80759"/>
                  </a:lnTo>
                  <a:lnTo>
                    <a:pt x="233133" y="82283"/>
                  </a:lnTo>
                  <a:lnTo>
                    <a:pt x="234657" y="83807"/>
                  </a:lnTo>
                  <a:lnTo>
                    <a:pt x="236181" y="85331"/>
                  </a:lnTo>
                  <a:lnTo>
                    <a:pt x="237693" y="85331"/>
                  </a:lnTo>
                  <a:lnTo>
                    <a:pt x="237693" y="86855"/>
                  </a:lnTo>
                  <a:lnTo>
                    <a:pt x="239217" y="88379"/>
                  </a:lnTo>
                  <a:lnTo>
                    <a:pt x="239217" y="89903"/>
                  </a:lnTo>
                  <a:lnTo>
                    <a:pt x="240741" y="89903"/>
                  </a:lnTo>
                  <a:lnTo>
                    <a:pt x="242277" y="91427"/>
                  </a:lnTo>
                  <a:lnTo>
                    <a:pt x="242277" y="92951"/>
                  </a:lnTo>
                  <a:lnTo>
                    <a:pt x="242277" y="94475"/>
                  </a:lnTo>
                  <a:lnTo>
                    <a:pt x="243801" y="94475"/>
                  </a:lnTo>
                  <a:lnTo>
                    <a:pt x="243801" y="95999"/>
                  </a:lnTo>
                  <a:lnTo>
                    <a:pt x="245325" y="97510"/>
                  </a:lnTo>
                  <a:lnTo>
                    <a:pt x="246849" y="99047"/>
                  </a:lnTo>
                  <a:lnTo>
                    <a:pt x="246849" y="100571"/>
                  </a:lnTo>
                  <a:lnTo>
                    <a:pt x="248361" y="102095"/>
                  </a:lnTo>
                  <a:lnTo>
                    <a:pt x="248361" y="103619"/>
                  </a:lnTo>
                  <a:lnTo>
                    <a:pt x="249885" y="105143"/>
                  </a:lnTo>
                  <a:lnTo>
                    <a:pt x="249885" y="106667"/>
                  </a:lnTo>
                  <a:lnTo>
                    <a:pt x="249885" y="108178"/>
                  </a:lnTo>
                  <a:lnTo>
                    <a:pt x="251409" y="109702"/>
                  </a:lnTo>
                  <a:lnTo>
                    <a:pt x="251409" y="111239"/>
                  </a:lnTo>
                  <a:lnTo>
                    <a:pt x="251409" y="112763"/>
                  </a:lnTo>
                  <a:lnTo>
                    <a:pt x="252933" y="114287"/>
                  </a:lnTo>
                  <a:lnTo>
                    <a:pt x="252933" y="115811"/>
                  </a:lnTo>
                  <a:lnTo>
                    <a:pt x="252933" y="117335"/>
                  </a:lnTo>
                  <a:lnTo>
                    <a:pt x="252933" y="118846"/>
                  </a:lnTo>
                  <a:lnTo>
                    <a:pt x="252933" y="120370"/>
                  </a:lnTo>
                  <a:lnTo>
                    <a:pt x="252933" y="121894"/>
                  </a:lnTo>
                  <a:lnTo>
                    <a:pt x="252933" y="123418"/>
                  </a:lnTo>
                  <a:lnTo>
                    <a:pt x="254469" y="124955"/>
                  </a:lnTo>
                  <a:lnTo>
                    <a:pt x="254469" y="132562"/>
                  </a:lnTo>
                  <a:lnTo>
                    <a:pt x="252933" y="134086"/>
                  </a:lnTo>
                  <a:lnTo>
                    <a:pt x="252933" y="146278"/>
                  </a:lnTo>
                  <a:lnTo>
                    <a:pt x="251409" y="147802"/>
                  </a:lnTo>
                  <a:lnTo>
                    <a:pt x="251409" y="149339"/>
                  </a:lnTo>
                  <a:lnTo>
                    <a:pt x="251409" y="150863"/>
                  </a:lnTo>
                  <a:lnTo>
                    <a:pt x="251409" y="152374"/>
                  </a:lnTo>
                  <a:lnTo>
                    <a:pt x="249885" y="152374"/>
                  </a:lnTo>
                  <a:lnTo>
                    <a:pt x="249885" y="159994"/>
                  </a:lnTo>
                  <a:lnTo>
                    <a:pt x="248361" y="161518"/>
                  </a:lnTo>
                  <a:lnTo>
                    <a:pt x="248361" y="163042"/>
                  </a:lnTo>
                  <a:lnTo>
                    <a:pt x="248361" y="164566"/>
                  </a:lnTo>
                  <a:lnTo>
                    <a:pt x="248361" y="166090"/>
                  </a:lnTo>
                  <a:lnTo>
                    <a:pt x="246849" y="167614"/>
                  </a:lnTo>
                  <a:lnTo>
                    <a:pt x="246849" y="169138"/>
                  </a:lnTo>
                  <a:lnTo>
                    <a:pt x="246849" y="170662"/>
                  </a:lnTo>
                  <a:lnTo>
                    <a:pt x="245325" y="172186"/>
                  </a:lnTo>
                  <a:lnTo>
                    <a:pt x="245325" y="173710"/>
                  </a:lnTo>
                  <a:lnTo>
                    <a:pt x="245325" y="175234"/>
                  </a:lnTo>
                  <a:lnTo>
                    <a:pt x="245325" y="176758"/>
                  </a:lnTo>
                  <a:lnTo>
                    <a:pt x="243801" y="178282"/>
                  </a:lnTo>
                  <a:lnTo>
                    <a:pt x="243801" y="179806"/>
                  </a:lnTo>
                  <a:lnTo>
                    <a:pt x="243801" y="181330"/>
                  </a:lnTo>
                  <a:lnTo>
                    <a:pt x="242277" y="182854"/>
                  </a:lnTo>
                  <a:lnTo>
                    <a:pt x="242277" y="184378"/>
                  </a:lnTo>
                  <a:lnTo>
                    <a:pt x="242277" y="185889"/>
                  </a:lnTo>
                  <a:lnTo>
                    <a:pt x="242277" y="187426"/>
                  </a:lnTo>
                  <a:lnTo>
                    <a:pt x="240741" y="187426"/>
                  </a:lnTo>
                  <a:lnTo>
                    <a:pt x="240741" y="188950"/>
                  </a:lnTo>
                  <a:lnTo>
                    <a:pt x="239217" y="190474"/>
                  </a:lnTo>
                  <a:lnTo>
                    <a:pt x="239217" y="191998"/>
                  </a:lnTo>
                  <a:lnTo>
                    <a:pt x="239217" y="193522"/>
                  </a:lnTo>
                  <a:lnTo>
                    <a:pt x="237693" y="195046"/>
                  </a:lnTo>
                  <a:lnTo>
                    <a:pt x="237693" y="196557"/>
                  </a:lnTo>
                  <a:lnTo>
                    <a:pt x="236181" y="198081"/>
                  </a:lnTo>
                  <a:lnTo>
                    <a:pt x="236181" y="199605"/>
                  </a:lnTo>
                  <a:lnTo>
                    <a:pt x="234657" y="201142"/>
                  </a:lnTo>
                  <a:lnTo>
                    <a:pt x="234657" y="202666"/>
                  </a:lnTo>
                  <a:lnTo>
                    <a:pt x="233133" y="204190"/>
                  </a:lnTo>
                  <a:lnTo>
                    <a:pt x="233133" y="205714"/>
                  </a:lnTo>
                  <a:lnTo>
                    <a:pt x="231609" y="207225"/>
                  </a:lnTo>
                  <a:lnTo>
                    <a:pt x="231609" y="208749"/>
                  </a:lnTo>
                  <a:lnTo>
                    <a:pt x="230085" y="210273"/>
                  </a:lnTo>
                  <a:lnTo>
                    <a:pt x="228549" y="211797"/>
                  </a:lnTo>
                  <a:lnTo>
                    <a:pt x="228549" y="213334"/>
                  </a:lnTo>
                  <a:lnTo>
                    <a:pt x="227025" y="214858"/>
                  </a:lnTo>
                  <a:lnTo>
                    <a:pt x="227025" y="216382"/>
                  </a:lnTo>
                  <a:lnTo>
                    <a:pt x="225513" y="216382"/>
                  </a:lnTo>
                  <a:lnTo>
                    <a:pt x="225513" y="217893"/>
                  </a:lnTo>
                  <a:lnTo>
                    <a:pt x="223989" y="219417"/>
                  </a:lnTo>
                  <a:lnTo>
                    <a:pt x="223989" y="220941"/>
                  </a:lnTo>
                  <a:lnTo>
                    <a:pt x="222465" y="220941"/>
                  </a:lnTo>
                  <a:lnTo>
                    <a:pt x="222465" y="222465"/>
                  </a:lnTo>
                  <a:lnTo>
                    <a:pt x="220941" y="223989"/>
                  </a:lnTo>
                  <a:lnTo>
                    <a:pt x="220941" y="225526"/>
                  </a:lnTo>
                  <a:lnTo>
                    <a:pt x="219417" y="225526"/>
                  </a:lnTo>
                  <a:lnTo>
                    <a:pt x="219417" y="227050"/>
                  </a:lnTo>
                  <a:lnTo>
                    <a:pt x="217893" y="228561"/>
                  </a:lnTo>
                  <a:lnTo>
                    <a:pt x="217893" y="230085"/>
                  </a:lnTo>
                  <a:lnTo>
                    <a:pt x="216357" y="230085"/>
                  </a:lnTo>
                  <a:lnTo>
                    <a:pt x="216357" y="231609"/>
                  </a:lnTo>
                  <a:lnTo>
                    <a:pt x="216357" y="233133"/>
                  </a:lnTo>
                  <a:lnTo>
                    <a:pt x="214845" y="233133"/>
                  </a:lnTo>
                  <a:lnTo>
                    <a:pt x="213321" y="234657"/>
                  </a:lnTo>
                  <a:lnTo>
                    <a:pt x="213321" y="236181"/>
                  </a:lnTo>
                  <a:lnTo>
                    <a:pt x="211797" y="237705"/>
                  </a:lnTo>
                  <a:lnTo>
                    <a:pt x="210273" y="239242"/>
                  </a:lnTo>
                  <a:lnTo>
                    <a:pt x="210273" y="240753"/>
                  </a:lnTo>
                  <a:lnTo>
                    <a:pt x="208749" y="242277"/>
                  </a:lnTo>
                  <a:lnTo>
                    <a:pt x="207225" y="243801"/>
                  </a:lnTo>
                  <a:lnTo>
                    <a:pt x="207225" y="245325"/>
                  </a:lnTo>
                  <a:lnTo>
                    <a:pt x="207225" y="246849"/>
                  </a:lnTo>
                  <a:lnTo>
                    <a:pt x="205714" y="246849"/>
                  </a:lnTo>
                  <a:lnTo>
                    <a:pt x="204190" y="248373"/>
                  </a:lnTo>
                  <a:lnTo>
                    <a:pt x="204190" y="249897"/>
                  </a:lnTo>
                  <a:lnTo>
                    <a:pt x="204190" y="251421"/>
                  </a:lnTo>
                  <a:lnTo>
                    <a:pt x="202653" y="251421"/>
                  </a:lnTo>
                  <a:lnTo>
                    <a:pt x="202653" y="252945"/>
                  </a:lnTo>
                  <a:lnTo>
                    <a:pt x="201129" y="254469"/>
                  </a:lnTo>
                  <a:lnTo>
                    <a:pt x="201129" y="255993"/>
                  </a:lnTo>
                  <a:lnTo>
                    <a:pt x="199605" y="257517"/>
                  </a:lnTo>
                  <a:lnTo>
                    <a:pt x="198081" y="259041"/>
                  </a:lnTo>
                  <a:lnTo>
                    <a:pt x="198081" y="260565"/>
                  </a:lnTo>
                  <a:lnTo>
                    <a:pt x="196557" y="262077"/>
                  </a:lnTo>
                  <a:lnTo>
                    <a:pt x="196557" y="263613"/>
                  </a:lnTo>
                  <a:lnTo>
                    <a:pt x="196557" y="265137"/>
                  </a:lnTo>
                  <a:lnTo>
                    <a:pt x="195046" y="265137"/>
                  </a:lnTo>
                  <a:lnTo>
                    <a:pt x="195046" y="266661"/>
                  </a:lnTo>
                  <a:lnTo>
                    <a:pt x="193522" y="268185"/>
                  </a:lnTo>
                  <a:lnTo>
                    <a:pt x="193522" y="269709"/>
                  </a:lnTo>
                  <a:lnTo>
                    <a:pt x="193522" y="271233"/>
                  </a:lnTo>
                  <a:lnTo>
                    <a:pt x="191998" y="271233"/>
                  </a:lnTo>
                  <a:lnTo>
                    <a:pt x="191998" y="272757"/>
                  </a:lnTo>
                  <a:lnTo>
                    <a:pt x="191998" y="274269"/>
                  </a:lnTo>
                  <a:lnTo>
                    <a:pt x="191998" y="275805"/>
                  </a:lnTo>
                  <a:lnTo>
                    <a:pt x="190461" y="275805"/>
                  </a:lnTo>
                  <a:lnTo>
                    <a:pt x="190461" y="277329"/>
                  </a:lnTo>
                  <a:lnTo>
                    <a:pt x="190461" y="278853"/>
                  </a:lnTo>
                  <a:lnTo>
                    <a:pt x="188937" y="280377"/>
                  </a:lnTo>
                  <a:lnTo>
                    <a:pt x="188937" y="281901"/>
                  </a:lnTo>
                  <a:lnTo>
                    <a:pt x="188937" y="283425"/>
                  </a:lnTo>
                  <a:lnTo>
                    <a:pt x="187413" y="283425"/>
                  </a:lnTo>
                  <a:lnTo>
                    <a:pt x="187413" y="284937"/>
                  </a:lnTo>
                  <a:lnTo>
                    <a:pt x="187413" y="286461"/>
                  </a:lnTo>
                  <a:lnTo>
                    <a:pt x="187413" y="287985"/>
                  </a:lnTo>
                  <a:lnTo>
                    <a:pt x="187413" y="289521"/>
                  </a:lnTo>
                  <a:lnTo>
                    <a:pt x="185889" y="291045"/>
                  </a:lnTo>
                  <a:lnTo>
                    <a:pt x="185889" y="292569"/>
                  </a:lnTo>
                  <a:lnTo>
                    <a:pt x="185889" y="294093"/>
                  </a:lnTo>
                  <a:lnTo>
                    <a:pt x="185889" y="295605"/>
                  </a:lnTo>
                  <a:lnTo>
                    <a:pt x="185889" y="297129"/>
                  </a:lnTo>
                  <a:lnTo>
                    <a:pt x="184378" y="297129"/>
                  </a:lnTo>
                  <a:lnTo>
                    <a:pt x="184378" y="298653"/>
                  </a:lnTo>
                  <a:lnTo>
                    <a:pt x="184378" y="300177"/>
                  </a:lnTo>
                  <a:lnTo>
                    <a:pt x="184378" y="301713"/>
                  </a:lnTo>
                  <a:lnTo>
                    <a:pt x="182854" y="303237"/>
                  </a:lnTo>
                  <a:lnTo>
                    <a:pt x="182854" y="310845"/>
                  </a:lnTo>
                  <a:lnTo>
                    <a:pt x="181330" y="310845"/>
                  </a:lnTo>
                  <a:lnTo>
                    <a:pt x="181330" y="318465"/>
                  </a:lnTo>
                  <a:lnTo>
                    <a:pt x="179806" y="318465"/>
                  </a:lnTo>
                  <a:lnTo>
                    <a:pt x="179806" y="319989"/>
                  </a:lnTo>
                  <a:lnTo>
                    <a:pt x="179806" y="321513"/>
                  </a:lnTo>
                  <a:lnTo>
                    <a:pt x="179806" y="323037"/>
                  </a:lnTo>
                  <a:lnTo>
                    <a:pt x="178269" y="323037"/>
                  </a:lnTo>
                  <a:lnTo>
                    <a:pt x="178269" y="324561"/>
                  </a:lnTo>
                  <a:lnTo>
                    <a:pt x="178269" y="326085"/>
                  </a:lnTo>
                  <a:lnTo>
                    <a:pt x="178269" y="327609"/>
                  </a:lnTo>
                  <a:lnTo>
                    <a:pt x="178269" y="329133"/>
                  </a:lnTo>
                  <a:lnTo>
                    <a:pt x="176745" y="330657"/>
                  </a:lnTo>
                  <a:lnTo>
                    <a:pt x="176745" y="332181"/>
                  </a:lnTo>
                  <a:lnTo>
                    <a:pt x="176745" y="333705"/>
                  </a:lnTo>
                  <a:lnTo>
                    <a:pt x="175221" y="333705"/>
                  </a:lnTo>
                  <a:lnTo>
                    <a:pt x="175221" y="335229"/>
                  </a:lnTo>
                  <a:lnTo>
                    <a:pt x="175221" y="336753"/>
                  </a:lnTo>
                  <a:lnTo>
                    <a:pt x="173710" y="338264"/>
                  </a:lnTo>
                  <a:lnTo>
                    <a:pt x="173710" y="339801"/>
                  </a:lnTo>
                  <a:lnTo>
                    <a:pt x="173710" y="341325"/>
                  </a:lnTo>
                  <a:lnTo>
                    <a:pt x="172186" y="342849"/>
                  </a:lnTo>
                  <a:lnTo>
                    <a:pt x="172186" y="344373"/>
                  </a:lnTo>
                  <a:lnTo>
                    <a:pt x="172186" y="345897"/>
                  </a:lnTo>
                  <a:lnTo>
                    <a:pt x="170662" y="347421"/>
                  </a:lnTo>
                  <a:lnTo>
                    <a:pt x="170662" y="348945"/>
                  </a:lnTo>
                  <a:lnTo>
                    <a:pt x="169138" y="350456"/>
                  </a:lnTo>
                  <a:lnTo>
                    <a:pt x="169138" y="351993"/>
                  </a:lnTo>
                  <a:lnTo>
                    <a:pt x="167614" y="351993"/>
                  </a:lnTo>
                  <a:lnTo>
                    <a:pt x="167614" y="353517"/>
                  </a:lnTo>
                  <a:lnTo>
                    <a:pt x="167614" y="355041"/>
                  </a:lnTo>
                  <a:lnTo>
                    <a:pt x="167614" y="356565"/>
                  </a:lnTo>
                  <a:lnTo>
                    <a:pt x="166090" y="356565"/>
                  </a:lnTo>
                  <a:lnTo>
                    <a:pt x="166090" y="358089"/>
                  </a:lnTo>
                  <a:lnTo>
                    <a:pt x="166090" y="359613"/>
                  </a:lnTo>
                  <a:lnTo>
                    <a:pt x="164566" y="361124"/>
                  </a:lnTo>
                  <a:lnTo>
                    <a:pt x="163042" y="362648"/>
                  </a:lnTo>
                  <a:lnTo>
                    <a:pt x="163042" y="364185"/>
                  </a:lnTo>
                  <a:lnTo>
                    <a:pt x="161518" y="365709"/>
                  </a:lnTo>
                  <a:lnTo>
                    <a:pt x="161518" y="367233"/>
                  </a:lnTo>
                  <a:lnTo>
                    <a:pt x="159994" y="368757"/>
                  </a:lnTo>
                  <a:lnTo>
                    <a:pt x="158470" y="370281"/>
                  </a:lnTo>
                  <a:lnTo>
                    <a:pt x="158470" y="371792"/>
                  </a:lnTo>
                  <a:lnTo>
                    <a:pt x="158470" y="373316"/>
                  </a:lnTo>
                  <a:lnTo>
                    <a:pt x="156946" y="373316"/>
                  </a:lnTo>
                  <a:lnTo>
                    <a:pt x="156946" y="374840"/>
                  </a:lnTo>
                  <a:lnTo>
                    <a:pt x="156946" y="376364"/>
                  </a:lnTo>
                  <a:lnTo>
                    <a:pt x="155422" y="377901"/>
                  </a:lnTo>
                  <a:lnTo>
                    <a:pt x="153911" y="379425"/>
                  </a:lnTo>
                  <a:lnTo>
                    <a:pt x="153911" y="380949"/>
                  </a:lnTo>
                  <a:lnTo>
                    <a:pt x="152374" y="382473"/>
                  </a:lnTo>
                  <a:lnTo>
                    <a:pt x="152374" y="383984"/>
                  </a:lnTo>
                  <a:lnTo>
                    <a:pt x="150850" y="385508"/>
                  </a:lnTo>
                  <a:lnTo>
                    <a:pt x="150850" y="387032"/>
                  </a:lnTo>
                  <a:lnTo>
                    <a:pt x="149326" y="388556"/>
                  </a:lnTo>
                  <a:lnTo>
                    <a:pt x="149326" y="390093"/>
                  </a:lnTo>
                  <a:lnTo>
                    <a:pt x="147802" y="391617"/>
                  </a:lnTo>
                  <a:lnTo>
                    <a:pt x="147802" y="393141"/>
                  </a:lnTo>
                  <a:lnTo>
                    <a:pt x="146278" y="394652"/>
                  </a:lnTo>
                  <a:lnTo>
                    <a:pt x="146278" y="396176"/>
                  </a:lnTo>
                  <a:lnTo>
                    <a:pt x="144754" y="397700"/>
                  </a:lnTo>
                  <a:lnTo>
                    <a:pt x="143243" y="399224"/>
                  </a:lnTo>
                  <a:lnTo>
                    <a:pt x="143243" y="400748"/>
                  </a:lnTo>
                  <a:lnTo>
                    <a:pt x="143243" y="402272"/>
                  </a:lnTo>
                  <a:lnTo>
                    <a:pt x="141719" y="403809"/>
                  </a:lnTo>
                  <a:lnTo>
                    <a:pt x="141719" y="405320"/>
                  </a:lnTo>
                  <a:lnTo>
                    <a:pt x="141719" y="406844"/>
                  </a:lnTo>
                  <a:lnTo>
                    <a:pt x="140182" y="406844"/>
                  </a:lnTo>
                  <a:lnTo>
                    <a:pt x="140182" y="408368"/>
                  </a:lnTo>
                  <a:lnTo>
                    <a:pt x="140182" y="409892"/>
                  </a:lnTo>
                  <a:lnTo>
                    <a:pt x="140182" y="411416"/>
                  </a:lnTo>
                  <a:lnTo>
                    <a:pt x="138658" y="411416"/>
                  </a:lnTo>
                  <a:lnTo>
                    <a:pt x="138658" y="412940"/>
                  </a:lnTo>
                  <a:lnTo>
                    <a:pt x="138658" y="414464"/>
                  </a:lnTo>
                  <a:lnTo>
                    <a:pt x="137134" y="415988"/>
                  </a:lnTo>
                  <a:lnTo>
                    <a:pt x="137134" y="417512"/>
                  </a:lnTo>
                  <a:lnTo>
                    <a:pt x="137134" y="419036"/>
                  </a:lnTo>
                  <a:lnTo>
                    <a:pt x="135610" y="419036"/>
                  </a:lnTo>
                  <a:lnTo>
                    <a:pt x="135610" y="420560"/>
                  </a:lnTo>
                  <a:lnTo>
                    <a:pt x="135610" y="422084"/>
                  </a:lnTo>
                  <a:lnTo>
                    <a:pt x="135610" y="423608"/>
                  </a:lnTo>
                  <a:lnTo>
                    <a:pt x="134086" y="425132"/>
                  </a:lnTo>
                  <a:lnTo>
                    <a:pt x="134086" y="426643"/>
                  </a:lnTo>
                  <a:lnTo>
                    <a:pt x="134086" y="428180"/>
                  </a:lnTo>
                  <a:lnTo>
                    <a:pt x="132575" y="429704"/>
                  </a:lnTo>
                  <a:lnTo>
                    <a:pt x="132575" y="437311"/>
                  </a:lnTo>
                  <a:lnTo>
                    <a:pt x="131051" y="437311"/>
                  </a:lnTo>
                  <a:lnTo>
                    <a:pt x="131051" y="446468"/>
                  </a:lnTo>
                  <a:lnTo>
                    <a:pt x="129527" y="447979"/>
                  </a:lnTo>
                  <a:lnTo>
                    <a:pt x="129527" y="457136"/>
                  </a:lnTo>
                  <a:lnTo>
                    <a:pt x="127990" y="458647"/>
                  </a:lnTo>
                  <a:lnTo>
                    <a:pt x="127990" y="516559"/>
                  </a:lnTo>
                  <a:lnTo>
                    <a:pt x="129527" y="518083"/>
                  </a:lnTo>
                  <a:lnTo>
                    <a:pt x="129527" y="530275"/>
                  </a:lnTo>
                  <a:lnTo>
                    <a:pt x="131051" y="531799"/>
                  </a:lnTo>
                  <a:lnTo>
                    <a:pt x="131051" y="554659"/>
                  </a:lnTo>
                  <a:lnTo>
                    <a:pt x="132575" y="554659"/>
                  </a:lnTo>
                  <a:lnTo>
                    <a:pt x="132575" y="572935"/>
                  </a:lnTo>
                  <a:lnTo>
                    <a:pt x="121907" y="572935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5073389" y="6206305"/>
              <a:ext cx="203200" cy="530860"/>
            </a:xfrm>
            <a:custGeom>
              <a:avLst/>
              <a:gdLst/>
              <a:ahLst/>
              <a:cxnLst/>
              <a:rect l="l" t="t" r="r" b="b"/>
              <a:pathLst>
                <a:path w="203200" h="530859">
                  <a:moveTo>
                    <a:pt x="117309" y="0"/>
                  </a:moveTo>
                  <a:lnTo>
                    <a:pt x="86842" y="0"/>
                  </a:lnTo>
                  <a:lnTo>
                    <a:pt x="86842" y="4572"/>
                  </a:lnTo>
                  <a:lnTo>
                    <a:pt x="85318" y="6108"/>
                  </a:lnTo>
                  <a:lnTo>
                    <a:pt x="85318" y="9144"/>
                  </a:lnTo>
                  <a:lnTo>
                    <a:pt x="83807" y="9144"/>
                  </a:lnTo>
                  <a:lnTo>
                    <a:pt x="83807" y="13716"/>
                  </a:lnTo>
                  <a:lnTo>
                    <a:pt x="82283" y="15240"/>
                  </a:lnTo>
                  <a:lnTo>
                    <a:pt x="82283" y="19824"/>
                  </a:lnTo>
                  <a:lnTo>
                    <a:pt x="80746" y="19824"/>
                  </a:lnTo>
                  <a:lnTo>
                    <a:pt x="80746" y="25908"/>
                  </a:lnTo>
                  <a:lnTo>
                    <a:pt x="79222" y="25908"/>
                  </a:lnTo>
                  <a:lnTo>
                    <a:pt x="79222" y="28956"/>
                  </a:lnTo>
                  <a:lnTo>
                    <a:pt x="77698" y="28956"/>
                  </a:lnTo>
                  <a:lnTo>
                    <a:pt x="77698" y="33528"/>
                  </a:lnTo>
                  <a:lnTo>
                    <a:pt x="76174" y="35052"/>
                  </a:lnTo>
                  <a:lnTo>
                    <a:pt x="76174" y="39624"/>
                  </a:lnTo>
                  <a:lnTo>
                    <a:pt x="74650" y="39624"/>
                  </a:lnTo>
                  <a:lnTo>
                    <a:pt x="74650" y="42659"/>
                  </a:lnTo>
                  <a:lnTo>
                    <a:pt x="73139" y="44196"/>
                  </a:lnTo>
                  <a:lnTo>
                    <a:pt x="73139" y="48768"/>
                  </a:lnTo>
                  <a:lnTo>
                    <a:pt x="71615" y="48768"/>
                  </a:lnTo>
                  <a:lnTo>
                    <a:pt x="71615" y="53327"/>
                  </a:lnTo>
                  <a:lnTo>
                    <a:pt x="70091" y="54851"/>
                  </a:lnTo>
                  <a:lnTo>
                    <a:pt x="70091" y="56388"/>
                  </a:lnTo>
                  <a:lnTo>
                    <a:pt x="68554" y="57912"/>
                  </a:lnTo>
                  <a:lnTo>
                    <a:pt x="68554" y="60960"/>
                  </a:lnTo>
                  <a:lnTo>
                    <a:pt x="67030" y="62484"/>
                  </a:lnTo>
                  <a:lnTo>
                    <a:pt x="67030" y="67043"/>
                  </a:lnTo>
                  <a:lnTo>
                    <a:pt x="65506" y="68580"/>
                  </a:lnTo>
                  <a:lnTo>
                    <a:pt x="65506" y="71628"/>
                  </a:lnTo>
                  <a:lnTo>
                    <a:pt x="63982" y="73152"/>
                  </a:lnTo>
                  <a:lnTo>
                    <a:pt x="63982" y="74676"/>
                  </a:lnTo>
                  <a:lnTo>
                    <a:pt x="62471" y="76187"/>
                  </a:lnTo>
                  <a:lnTo>
                    <a:pt x="62471" y="79235"/>
                  </a:lnTo>
                  <a:lnTo>
                    <a:pt x="60947" y="80759"/>
                  </a:lnTo>
                  <a:lnTo>
                    <a:pt x="60947" y="83820"/>
                  </a:lnTo>
                  <a:lnTo>
                    <a:pt x="59423" y="85344"/>
                  </a:lnTo>
                  <a:lnTo>
                    <a:pt x="59423" y="86855"/>
                  </a:lnTo>
                  <a:lnTo>
                    <a:pt x="57899" y="86855"/>
                  </a:lnTo>
                  <a:lnTo>
                    <a:pt x="57899" y="91427"/>
                  </a:lnTo>
                  <a:lnTo>
                    <a:pt x="56362" y="91427"/>
                  </a:lnTo>
                  <a:lnTo>
                    <a:pt x="56362" y="94488"/>
                  </a:lnTo>
                  <a:lnTo>
                    <a:pt x="54838" y="96012"/>
                  </a:lnTo>
                  <a:lnTo>
                    <a:pt x="54838" y="99047"/>
                  </a:lnTo>
                  <a:lnTo>
                    <a:pt x="53327" y="99047"/>
                  </a:lnTo>
                  <a:lnTo>
                    <a:pt x="53327" y="100571"/>
                  </a:lnTo>
                  <a:lnTo>
                    <a:pt x="51803" y="100571"/>
                  </a:lnTo>
                  <a:lnTo>
                    <a:pt x="51803" y="105143"/>
                  </a:lnTo>
                  <a:lnTo>
                    <a:pt x="50279" y="105143"/>
                  </a:lnTo>
                  <a:lnTo>
                    <a:pt x="50279" y="106680"/>
                  </a:lnTo>
                  <a:lnTo>
                    <a:pt x="48755" y="108191"/>
                  </a:lnTo>
                  <a:lnTo>
                    <a:pt x="48755" y="109715"/>
                  </a:lnTo>
                  <a:lnTo>
                    <a:pt x="47231" y="111239"/>
                  </a:lnTo>
                  <a:lnTo>
                    <a:pt x="47231" y="114287"/>
                  </a:lnTo>
                  <a:lnTo>
                    <a:pt x="45707" y="114287"/>
                  </a:lnTo>
                  <a:lnTo>
                    <a:pt x="45707" y="117335"/>
                  </a:lnTo>
                  <a:lnTo>
                    <a:pt x="42659" y="120383"/>
                  </a:lnTo>
                  <a:lnTo>
                    <a:pt x="42659" y="121907"/>
                  </a:lnTo>
                  <a:lnTo>
                    <a:pt x="41135" y="123431"/>
                  </a:lnTo>
                  <a:lnTo>
                    <a:pt x="41135" y="124955"/>
                  </a:lnTo>
                  <a:lnTo>
                    <a:pt x="39611" y="126479"/>
                  </a:lnTo>
                  <a:lnTo>
                    <a:pt x="39611" y="128003"/>
                  </a:lnTo>
                  <a:lnTo>
                    <a:pt x="38087" y="129527"/>
                  </a:lnTo>
                  <a:lnTo>
                    <a:pt x="38087" y="131038"/>
                  </a:lnTo>
                  <a:lnTo>
                    <a:pt x="36563" y="131038"/>
                  </a:lnTo>
                  <a:lnTo>
                    <a:pt x="36563" y="134099"/>
                  </a:lnTo>
                  <a:lnTo>
                    <a:pt x="35039" y="134099"/>
                  </a:lnTo>
                  <a:lnTo>
                    <a:pt x="35039" y="137147"/>
                  </a:lnTo>
                  <a:lnTo>
                    <a:pt x="32004" y="140195"/>
                  </a:lnTo>
                  <a:lnTo>
                    <a:pt x="32004" y="141706"/>
                  </a:lnTo>
                  <a:lnTo>
                    <a:pt x="30467" y="143230"/>
                  </a:lnTo>
                  <a:lnTo>
                    <a:pt x="30467" y="146291"/>
                  </a:lnTo>
                  <a:lnTo>
                    <a:pt x="28943" y="146291"/>
                  </a:lnTo>
                  <a:lnTo>
                    <a:pt x="28943" y="147815"/>
                  </a:lnTo>
                  <a:lnTo>
                    <a:pt x="27419" y="149339"/>
                  </a:lnTo>
                  <a:lnTo>
                    <a:pt x="27419" y="150863"/>
                  </a:lnTo>
                  <a:lnTo>
                    <a:pt x="25895" y="152374"/>
                  </a:lnTo>
                  <a:lnTo>
                    <a:pt x="25895" y="155422"/>
                  </a:lnTo>
                  <a:lnTo>
                    <a:pt x="24371" y="156946"/>
                  </a:lnTo>
                  <a:lnTo>
                    <a:pt x="24371" y="160007"/>
                  </a:lnTo>
                  <a:lnTo>
                    <a:pt x="22847" y="160007"/>
                  </a:lnTo>
                  <a:lnTo>
                    <a:pt x="22847" y="161531"/>
                  </a:lnTo>
                  <a:lnTo>
                    <a:pt x="21336" y="163042"/>
                  </a:lnTo>
                  <a:lnTo>
                    <a:pt x="21336" y="166090"/>
                  </a:lnTo>
                  <a:lnTo>
                    <a:pt x="19812" y="167614"/>
                  </a:lnTo>
                  <a:lnTo>
                    <a:pt x="19812" y="170675"/>
                  </a:lnTo>
                  <a:lnTo>
                    <a:pt x="18275" y="172199"/>
                  </a:lnTo>
                  <a:lnTo>
                    <a:pt x="18275" y="173723"/>
                  </a:lnTo>
                  <a:lnTo>
                    <a:pt x="16751" y="175234"/>
                  </a:lnTo>
                  <a:lnTo>
                    <a:pt x="16751" y="179806"/>
                  </a:lnTo>
                  <a:lnTo>
                    <a:pt x="15227" y="179806"/>
                  </a:lnTo>
                  <a:lnTo>
                    <a:pt x="15227" y="184391"/>
                  </a:lnTo>
                  <a:lnTo>
                    <a:pt x="13703" y="185902"/>
                  </a:lnTo>
                  <a:lnTo>
                    <a:pt x="13703" y="188950"/>
                  </a:lnTo>
                  <a:lnTo>
                    <a:pt x="12179" y="190474"/>
                  </a:lnTo>
                  <a:lnTo>
                    <a:pt x="12179" y="195046"/>
                  </a:lnTo>
                  <a:lnTo>
                    <a:pt x="10668" y="196570"/>
                  </a:lnTo>
                  <a:lnTo>
                    <a:pt x="10668" y="201142"/>
                  </a:lnTo>
                  <a:lnTo>
                    <a:pt x="9144" y="202666"/>
                  </a:lnTo>
                  <a:lnTo>
                    <a:pt x="9144" y="208762"/>
                  </a:lnTo>
                  <a:lnTo>
                    <a:pt x="7620" y="210286"/>
                  </a:lnTo>
                  <a:lnTo>
                    <a:pt x="7620" y="211810"/>
                  </a:lnTo>
                  <a:lnTo>
                    <a:pt x="6083" y="213334"/>
                  </a:lnTo>
                  <a:lnTo>
                    <a:pt x="6083" y="219417"/>
                  </a:lnTo>
                  <a:lnTo>
                    <a:pt x="4559" y="220954"/>
                  </a:lnTo>
                  <a:lnTo>
                    <a:pt x="4559" y="228561"/>
                  </a:lnTo>
                  <a:lnTo>
                    <a:pt x="3035" y="230085"/>
                  </a:lnTo>
                  <a:lnTo>
                    <a:pt x="3035" y="234670"/>
                  </a:lnTo>
                  <a:lnTo>
                    <a:pt x="1511" y="236194"/>
                  </a:lnTo>
                  <a:lnTo>
                    <a:pt x="1511" y="249910"/>
                  </a:lnTo>
                  <a:lnTo>
                    <a:pt x="0" y="251421"/>
                  </a:lnTo>
                  <a:lnTo>
                    <a:pt x="0" y="262089"/>
                  </a:lnTo>
                  <a:lnTo>
                    <a:pt x="1511" y="262089"/>
                  </a:lnTo>
                  <a:lnTo>
                    <a:pt x="1511" y="275805"/>
                  </a:lnTo>
                  <a:lnTo>
                    <a:pt x="3035" y="277329"/>
                  </a:lnTo>
                  <a:lnTo>
                    <a:pt x="3035" y="281901"/>
                  </a:lnTo>
                  <a:lnTo>
                    <a:pt x="4559" y="283425"/>
                  </a:lnTo>
                  <a:lnTo>
                    <a:pt x="4559" y="289521"/>
                  </a:lnTo>
                  <a:lnTo>
                    <a:pt x="6083" y="291045"/>
                  </a:lnTo>
                  <a:lnTo>
                    <a:pt x="6083" y="295605"/>
                  </a:lnTo>
                  <a:lnTo>
                    <a:pt x="7620" y="297141"/>
                  </a:lnTo>
                  <a:lnTo>
                    <a:pt x="7620" y="298665"/>
                  </a:lnTo>
                  <a:lnTo>
                    <a:pt x="9144" y="300189"/>
                  </a:lnTo>
                  <a:lnTo>
                    <a:pt x="9144" y="304761"/>
                  </a:lnTo>
                  <a:lnTo>
                    <a:pt x="10668" y="306273"/>
                  </a:lnTo>
                  <a:lnTo>
                    <a:pt x="10668" y="310857"/>
                  </a:lnTo>
                  <a:lnTo>
                    <a:pt x="12179" y="310857"/>
                  </a:lnTo>
                  <a:lnTo>
                    <a:pt x="12179" y="315429"/>
                  </a:lnTo>
                  <a:lnTo>
                    <a:pt x="13703" y="316941"/>
                  </a:lnTo>
                  <a:lnTo>
                    <a:pt x="13703" y="318465"/>
                  </a:lnTo>
                  <a:lnTo>
                    <a:pt x="15227" y="319989"/>
                  </a:lnTo>
                  <a:lnTo>
                    <a:pt x="15227" y="323049"/>
                  </a:lnTo>
                  <a:lnTo>
                    <a:pt x="16751" y="324573"/>
                  </a:lnTo>
                  <a:lnTo>
                    <a:pt x="16751" y="327609"/>
                  </a:lnTo>
                  <a:lnTo>
                    <a:pt x="18275" y="329133"/>
                  </a:lnTo>
                  <a:lnTo>
                    <a:pt x="18275" y="330657"/>
                  </a:lnTo>
                  <a:lnTo>
                    <a:pt x="19812" y="332181"/>
                  </a:lnTo>
                  <a:lnTo>
                    <a:pt x="19812" y="335241"/>
                  </a:lnTo>
                  <a:lnTo>
                    <a:pt x="21336" y="336765"/>
                  </a:lnTo>
                  <a:lnTo>
                    <a:pt x="21336" y="341325"/>
                  </a:lnTo>
                  <a:lnTo>
                    <a:pt x="22847" y="341325"/>
                  </a:lnTo>
                  <a:lnTo>
                    <a:pt x="22847" y="342849"/>
                  </a:lnTo>
                  <a:lnTo>
                    <a:pt x="24371" y="344373"/>
                  </a:lnTo>
                  <a:lnTo>
                    <a:pt x="24371" y="347433"/>
                  </a:lnTo>
                  <a:lnTo>
                    <a:pt x="25895" y="348957"/>
                  </a:lnTo>
                  <a:lnTo>
                    <a:pt x="25895" y="351993"/>
                  </a:lnTo>
                  <a:lnTo>
                    <a:pt x="27419" y="353517"/>
                  </a:lnTo>
                  <a:lnTo>
                    <a:pt x="27419" y="356565"/>
                  </a:lnTo>
                  <a:lnTo>
                    <a:pt x="28943" y="356565"/>
                  </a:lnTo>
                  <a:lnTo>
                    <a:pt x="28943" y="359613"/>
                  </a:lnTo>
                  <a:lnTo>
                    <a:pt x="30467" y="361137"/>
                  </a:lnTo>
                  <a:lnTo>
                    <a:pt x="30467" y="362661"/>
                  </a:lnTo>
                  <a:lnTo>
                    <a:pt x="32004" y="364185"/>
                  </a:lnTo>
                  <a:lnTo>
                    <a:pt x="32004" y="367233"/>
                  </a:lnTo>
                  <a:lnTo>
                    <a:pt x="33515" y="368757"/>
                  </a:lnTo>
                  <a:lnTo>
                    <a:pt x="33515" y="370281"/>
                  </a:lnTo>
                  <a:lnTo>
                    <a:pt x="35039" y="371792"/>
                  </a:lnTo>
                  <a:lnTo>
                    <a:pt x="35039" y="374853"/>
                  </a:lnTo>
                  <a:lnTo>
                    <a:pt x="36563" y="376377"/>
                  </a:lnTo>
                  <a:lnTo>
                    <a:pt x="36563" y="379425"/>
                  </a:lnTo>
                  <a:lnTo>
                    <a:pt x="39611" y="382473"/>
                  </a:lnTo>
                  <a:lnTo>
                    <a:pt x="39611" y="385521"/>
                  </a:lnTo>
                  <a:lnTo>
                    <a:pt x="41135" y="387045"/>
                  </a:lnTo>
                  <a:lnTo>
                    <a:pt x="41135" y="390093"/>
                  </a:lnTo>
                  <a:lnTo>
                    <a:pt x="42659" y="390093"/>
                  </a:lnTo>
                  <a:lnTo>
                    <a:pt x="42659" y="393141"/>
                  </a:lnTo>
                  <a:lnTo>
                    <a:pt x="44183" y="394652"/>
                  </a:lnTo>
                  <a:lnTo>
                    <a:pt x="44183" y="396176"/>
                  </a:lnTo>
                  <a:lnTo>
                    <a:pt x="45707" y="396176"/>
                  </a:lnTo>
                  <a:lnTo>
                    <a:pt x="45707" y="399237"/>
                  </a:lnTo>
                  <a:lnTo>
                    <a:pt x="47231" y="400761"/>
                  </a:lnTo>
                  <a:lnTo>
                    <a:pt x="47231" y="403809"/>
                  </a:lnTo>
                  <a:lnTo>
                    <a:pt x="48755" y="405320"/>
                  </a:lnTo>
                  <a:lnTo>
                    <a:pt x="48755" y="406844"/>
                  </a:lnTo>
                  <a:lnTo>
                    <a:pt x="50279" y="408368"/>
                  </a:lnTo>
                  <a:lnTo>
                    <a:pt x="50279" y="409892"/>
                  </a:lnTo>
                  <a:lnTo>
                    <a:pt x="51803" y="411429"/>
                  </a:lnTo>
                  <a:lnTo>
                    <a:pt x="51803" y="414477"/>
                  </a:lnTo>
                  <a:lnTo>
                    <a:pt x="53327" y="415988"/>
                  </a:lnTo>
                  <a:lnTo>
                    <a:pt x="53327" y="417512"/>
                  </a:lnTo>
                  <a:lnTo>
                    <a:pt x="54838" y="419036"/>
                  </a:lnTo>
                  <a:lnTo>
                    <a:pt x="54838" y="422084"/>
                  </a:lnTo>
                  <a:lnTo>
                    <a:pt x="56362" y="422084"/>
                  </a:lnTo>
                  <a:lnTo>
                    <a:pt x="56362" y="425145"/>
                  </a:lnTo>
                  <a:lnTo>
                    <a:pt x="57899" y="426656"/>
                  </a:lnTo>
                  <a:lnTo>
                    <a:pt x="57899" y="428180"/>
                  </a:lnTo>
                  <a:lnTo>
                    <a:pt x="59423" y="429704"/>
                  </a:lnTo>
                  <a:lnTo>
                    <a:pt x="59423" y="432752"/>
                  </a:lnTo>
                  <a:lnTo>
                    <a:pt x="60947" y="432752"/>
                  </a:lnTo>
                  <a:lnTo>
                    <a:pt x="60947" y="435813"/>
                  </a:lnTo>
                  <a:lnTo>
                    <a:pt x="62471" y="437324"/>
                  </a:lnTo>
                  <a:lnTo>
                    <a:pt x="62471" y="440372"/>
                  </a:lnTo>
                  <a:lnTo>
                    <a:pt x="63982" y="441896"/>
                  </a:lnTo>
                  <a:lnTo>
                    <a:pt x="63982" y="443420"/>
                  </a:lnTo>
                  <a:lnTo>
                    <a:pt x="65506" y="444944"/>
                  </a:lnTo>
                  <a:lnTo>
                    <a:pt x="65506" y="447992"/>
                  </a:lnTo>
                  <a:lnTo>
                    <a:pt x="67030" y="447992"/>
                  </a:lnTo>
                  <a:lnTo>
                    <a:pt x="67030" y="452564"/>
                  </a:lnTo>
                  <a:lnTo>
                    <a:pt x="68554" y="452564"/>
                  </a:lnTo>
                  <a:lnTo>
                    <a:pt x="68554" y="457136"/>
                  </a:lnTo>
                  <a:lnTo>
                    <a:pt x="70091" y="458660"/>
                  </a:lnTo>
                  <a:lnTo>
                    <a:pt x="70091" y="460171"/>
                  </a:lnTo>
                  <a:lnTo>
                    <a:pt x="71615" y="461708"/>
                  </a:lnTo>
                  <a:lnTo>
                    <a:pt x="71615" y="464756"/>
                  </a:lnTo>
                  <a:lnTo>
                    <a:pt x="73139" y="466280"/>
                  </a:lnTo>
                  <a:lnTo>
                    <a:pt x="73139" y="470839"/>
                  </a:lnTo>
                  <a:lnTo>
                    <a:pt x="74650" y="472363"/>
                  </a:lnTo>
                  <a:lnTo>
                    <a:pt x="74650" y="475424"/>
                  </a:lnTo>
                  <a:lnTo>
                    <a:pt x="76174" y="475424"/>
                  </a:lnTo>
                  <a:lnTo>
                    <a:pt x="76174" y="479996"/>
                  </a:lnTo>
                  <a:lnTo>
                    <a:pt x="77698" y="481507"/>
                  </a:lnTo>
                  <a:lnTo>
                    <a:pt x="77698" y="486092"/>
                  </a:lnTo>
                  <a:lnTo>
                    <a:pt x="79222" y="487616"/>
                  </a:lnTo>
                  <a:lnTo>
                    <a:pt x="79222" y="490664"/>
                  </a:lnTo>
                  <a:lnTo>
                    <a:pt x="80746" y="490664"/>
                  </a:lnTo>
                  <a:lnTo>
                    <a:pt x="80746" y="498271"/>
                  </a:lnTo>
                  <a:lnTo>
                    <a:pt x="82283" y="498271"/>
                  </a:lnTo>
                  <a:lnTo>
                    <a:pt x="82283" y="504367"/>
                  </a:lnTo>
                  <a:lnTo>
                    <a:pt x="83807" y="505891"/>
                  </a:lnTo>
                  <a:lnTo>
                    <a:pt x="83807" y="513524"/>
                  </a:lnTo>
                  <a:lnTo>
                    <a:pt x="85318" y="513524"/>
                  </a:lnTo>
                  <a:lnTo>
                    <a:pt x="85318" y="518083"/>
                  </a:lnTo>
                  <a:lnTo>
                    <a:pt x="86842" y="519607"/>
                  </a:lnTo>
                  <a:lnTo>
                    <a:pt x="86842" y="527227"/>
                  </a:lnTo>
                  <a:lnTo>
                    <a:pt x="88366" y="527227"/>
                  </a:lnTo>
                  <a:lnTo>
                    <a:pt x="88366" y="530275"/>
                  </a:lnTo>
                  <a:lnTo>
                    <a:pt x="115785" y="530275"/>
                  </a:lnTo>
                  <a:lnTo>
                    <a:pt x="115785" y="525703"/>
                  </a:lnTo>
                  <a:lnTo>
                    <a:pt x="117309" y="524192"/>
                  </a:lnTo>
                  <a:lnTo>
                    <a:pt x="117309" y="516559"/>
                  </a:lnTo>
                  <a:lnTo>
                    <a:pt x="118833" y="516559"/>
                  </a:lnTo>
                  <a:lnTo>
                    <a:pt x="118833" y="510463"/>
                  </a:lnTo>
                  <a:lnTo>
                    <a:pt x="120370" y="508939"/>
                  </a:lnTo>
                  <a:lnTo>
                    <a:pt x="120370" y="504367"/>
                  </a:lnTo>
                  <a:lnTo>
                    <a:pt x="121894" y="504367"/>
                  </a:lnTo>
                  <a:lnTo>
                    <a:pt x="121894" y="496747"/>
                  </a:lnTo>
                  <a:lnTo>
                    <a:pt x="123418" y="495223"/>
                  </a:lnTo>
                  <a:lnTo>
                    <a:pt x="123418" y="490664"/>
                  </a:lnTo>
                  <a:lnTo>
                    <a:pt x="124942" y="489140"/>
                  </a:lnTo>
                  <a:lnTo>
                    <a:pt x="124942" y="486092"/>
                  </a:lnTo>
                  <a:lnTo>
                    <a:pt x="126453" y="484555"/>
                  </a:lnTo>
                  <a:lnTo>
                    <a:pt x="126453" y="479996"/>
                  </a:lnTo>
                  <a:lnTo>
                    <a:pt x="127977" y="478472"/>
                  </a:lnTo>
                  <a:lnTo>
                    <a:pt x="127977" y="473900"/>
                  </a:lnTo>
                  <a:lnTo>
                    <a:pt x="129501" y="472363"/>
                  </a:lnTo>
                  <a:lnTo>
                    <a:pt x="129501" y="467804"/>
                  </a:lnTo>
                  <a:lnTo>
                    <a:pt x="131025" y="467804"/>
                  </a:lnTo>
                  <a:lnTo>
                    <a:pt x="131025" y="464756"/>
                  </a:lnTo>
                  <a:lnTo>
                    <a:pt x="132549" y="464756"/>
                  </a:lnTo>
                  <a:lnTo>
                    <a:pt x="132549" y="460171"/>
                  </a:lnTo>
                  <a:lnTo>
                    <a:pt x="134086" y="458660"/>
                  </a:lnTo>
                  <a:lnTo>
                    <a:pt x="134086" y="455612"/>
                  </a:lnTo>
                  <a:lnTo>
                    <a:pt x="135610" y="454088"/>
                  </a:lnTo>
                  <a:lnTo>
                    <a:pt x="135610" y="452564"/>
                  </a:lnTo>
                  <a:lnTo>
                    <a:pt x="137121" y="451040"/>
                  </a:lnTo>
                  <a:lnTo>
                    <a:pt x="137121" y="447992"/>
                  </a:lnTo>
                  <a:lnTo>
                    <a:pt x="138645" y="446468"/>
                  </a:lnTo>
                  <a:lnTo>
                    <a:pt x="138645" y="443420"/>
                  </a:lnTo>
                  <a:lnTo>
                    <a:pt x="140169" y="441896"/>
                  </a:lnTo>
                  <a:lnTo>
                    <a:pt x="140169" y="440372"/>
                  </a:lnTo>
                  <a:lnTo>
                    <a:pt x="141693" y="438848"/>
                  </a:lnTo>
                  <a:lnTo>
                    <a:pt x="141693" y="435813"/>
                  </a:lnTo>
                  <a:lnTo>
                    <a:pt x="143217" y="435813"/>
                  </a:lnTo>
                  <a:lnTo>
                    <a:pt x="143217" y="432752"/>
                  </a:lnTo>
                  <a:lnTo>
                    <a:pt x="144741" y="431228"/>
                  </a:lnTo>
                  <a:lnTo>
                    <a:pt x="144741" y="428180"/>
                  </a:lnTo>
                  <a:lnTo>
                    <a:pt x="146278" y="426656"/>
                  </a:lnTo>
                  <a:lnTo>
                    <a:pt x="146278" y="425145"/>
                  </a:lnTo>
                  <a:lnTo>
                    <a:pt x="147789" y="425145"/>
                  </a:lnTo>
                  <a:lnTo>
                    <a:pt x="147789" y="422084"/>
                  </a:lnTo>
                  <a:lnTo>
                    <a:pt x="149313" y="420560"/>
                  </a:lnTo>
                  <a:lnTo>
                    <a:pt x="149313" y="417512"/>
                  </a:lnTo>
                  <a:lnTo>
                    <a:pt x="150837" y="415988"/>
                  </a:lnTo>
                  <a:lnTo>
                    <a:pt x="150837" y="414477"/>
                  </a:lnTo>
                  <a:lnTo>
                    <a:pt x="152361" y="412953"/>
                  </a:lnTo>
                  <a:lnTo>
                    <a:pt x="152361" y="411429"/>
                  </a:lnTo>
                  <a:lnTo>
                    <a:pt x="153885" y="409892"/>
                  </a:lnTo>
                  <a:lnTo>
                    <a:pt x="153885" y="406844"/>
                  </a:lnTo>
                  <a:lnTo>
                    <a:pt x="155409" y="406844"/>
                  </a:lnTo>
                  <a:lnTo>
                    <a:pt x="155409" y="403809"/>
                  </a:lnTo>
                  <a:lnTo>
                    <a:pt x="156921" y="402285"/>
                  </a:lnTo>
                  <a:lnTo>
                    <a:pt x="156921" y="399237"/>
                  </a:lnTo>
                  <a:lnTo>
                    <a:pt x="158457" y="399237"/>
                  </a:lnTo>
                  <a:lnTo>
                    <a:pt x="158457" y="396176"/>
                  </a:lnTo>
                  <a:lnTo>
                    <a:pt x="159981" y="396176"/>
                  </a:lnTo>
                  <a:lnTo>
                    <a:pt x="159981" y="393141"/>
                  </a:lnTo>
                  <a:lnTo>
                    <a:pt x="161505" y="391617"/>
                  </a:lnTo>
                  <a:lnTo>
                    <a:pt x="161505" y="390093"/>
                  </a:lnTo>
                  <a:lnTo>
                    <a:pt x="163029" y="388569"/>
                  </a:lnTo>
                  <a:lnTo>
                    <a:pt x="163029" y="385521"/>
                  </a:lnTo>
                  <a:lnTo>
                    <a:pt x="164553" y="383984"/>
                  </a:lnTo>
                  <a:lnTo>
                    <a:pt x="164553" y="380949"/>
                  </a:lnTo>
                  <a:lnTo>
                    <a:pt x="166077" y="380949"/>
                  </a:lnTo>
                  <a:lnTo>
                    <a:pt x="166077" y="379425"/>
                  </a:lnTo>
                  <a:lnTo>
                    <a:pt x="167589" y="377901"/>
                  </a:lnTo>
                  <a:lnTo>
                    <a:pt x="167589" y="374853"/>
                  </a:lnTo>
                  <a:lnTo>
                    <a:pt x="169113" y="373329"/>
                  </a:lnTo>
                  <a:lnTo>
                    <a:pt x="169113" y="370281"/>
                  </a:lnTo>
                  <a:lnTo>
                    <a:pt x="170649" y="370281"/>
                  </a:lnTo>
                  <a:lnTo>
                    <a:pt x="170649" y="367233"/>
                  </a:lnTo>
                  <a:lnTo>
                    <a:pt x="172173" y="367233"/>
                  </a:lnTo>
                  <a:lnTo>
                    <a:pt x="172173" y="362661"/>
                  </a:lnTo>
                  <a:lnTo>
                    <a:pt x="173697" y="362661"/>
                  </a:lnTo>
                  <a:lnTo>
                    <a:pt x="173697" y="359613"/>
                  </a:lnTo>
                  <a:lnTo>
                    <a:pt x="175221" y="358089"/>
                  </a:lnTo>
                  <a:lnTo>
                    <a:pt x="175221" y="355041"/>
                  </a:lnTo>
                  <a:lnTo>
                    <a:pt x="176745" y="355041"/>
                  </a:lnTo>
                  <a:lnTo>
                    <a:pt x="176745" y="351993"/>
                  </a:lnTo>
                  <a:lnTo>
                    <a:pt x="178257" y="350469"/>
                  </a:lnTo>
                  <a:lnTo>
                    <a:pt x="178257" y="347433"/>
                  </a:lnTo>
                  <a:lnTo>
                    <a:pt x="179781" y="347433"/>
                  </a:lnTo>
                  <a:lnTo>
                    <a:pt x="179781" y="342849"/>
                  </a:lnTo>
                  <a:lnTo>
                    <a:pt x="181305" y="342849"/>
                  </a:lnTo>
                  <a:lnTo>
                    <a:pt x="181305" y="341325"/>
                  </a:lnTo>
                  <a:lnTo>
                    <a:pt x="182829" y="339801"/>
                  </a:lnTo>
                  <a:lnTo>
                    <a:pt x="182829" y="335241"/>
                  </a:lnTo>
                  <a:lnTo>
                    <a:pt x="184365" y="335241"/>
                  </a:lnTo>
                  <a:lnTo>
                    <a:pt x="184365" y="330657"/>
                  </a:lnTo>
                  <a:lnTo>
                    <a:pt x="185889" y="330657"/>
                  </a:lnTo>
                  <a:lnTo>
                    <a:pt x="185889" y="326097"/>
                  </a:lnTo>
                  <a:lnTo>
                    <a:pt x="187413" y="324573"/>
                  </a:lnTo>
                  <a:lnTo>
                    <a:pt x="187413" y="323049"/>
                  </a:lnTo>
                  <a:lnTo>
                    <a:pt x="188925" y="321525"/>
                  </a:lnTo>
                  <a:lnTo>
                    <a:pt x="188925" y="318465"/>
                  </a:lnTo>
                  <a:lnTo>
                    <a:pt x="190449" y="316941"/>
                  </a:lnTo>
                  <a:lnTo>
                    <a:pt x="190449" y="313905"/>
                  </a:lnTo>
                  <a:lnTo>
                    <a:pt x="191973" y="312381"/>
                  </a:lnTo>
                  <a:lnTo>
                    <a:pt x="191973" y="309333"/>
                  </a:lnTo>
                  <a:lnTo>
                    <a:pt x="193497" y="307797"/>
                  </a:lnTo>
                  <a:lnTo>
                    <a:pt x="193497" y="304761"/>
                  </a:lnTo>
                  <a:lnTo>
                    <a:pt x="195021" y="304761"/>
                  </a:lnTo>
                  <a:lnTo>
                    <a:pt x="195021" y="298665"/>
                  </a:lnTo>
                  <a:lnTo>
                    <a:pt x="196557" y="297141"/>
                  </a:lnTo>
                  <a:lnTo>
                    <a:pt x="196557" y="295605"/>
                  </a:lnTo>
                  <a:lnTo>
                    <a:pt x="198069" y="294093"/>
                  </a:lnTo>
                  <a:lnTo>
                    <a:pt x="198069" y="289521"/>
                  </a:lnTo>
                  <a:lnTo>
                    <a:pt x="199593" y="287997"/>
                  </a:lnTo>
                  <a:lnTo>
                    <a:pt x="199593" y="281901"/>
                  </a:lnTo>
                  <a:lnTo>
                    <a:pt x="201117" y="280377"/>
                  </a:lnTo>
                  <a:lnTo>
                    <a:pt x="201117" y="271246"/>
                  </a:lnTo>
                  <a:lnTo>
                    <a:pt x="202641" y="269709"/>
                  </a:lnTo>
                  <a:lnTo>
                    <a:pt x="202641" y="242277"/>
                  </a:lnTo>
                  <a:lnTo>
                    <a:pt x="201117" y="242277"/>
                  </a:lnTo>
                  <a:lnTo>
                    <a:pt x="201117" y="231609"/>
                  </a:lnTo>
                  <a:lnTo>
                    <a:pt x="199593" y="230085"/>
                  </a:lnTo>
                  <a:lnTo>
                    <a:pt x="199593" y="222478"/>
                  </a:lnTo>
                  <a:lnTo>
                    <a:pt x="198069" y="222478"/>
                  </a:lnTo>
                  <a:lnTo>
                    <a:pt x="198069" y="216382"/>
                  </a:lnTo>
                  <a:lnTo>
                    <a:pt x="196557" y="214858"/>
                  </a:lnTo>
                  <a:lnTo>
                    <a:pt x="196557" y="210286"/>
                  </a:lnTo>
                  <a:lnTo>
                    <a:pt x="195021" y="210286"/>
                  </a:lnTo>
                  <a:lnTo>
                    <a:pt x="195021" y="204190"/>
                  </a:lnTo>
                  <a:lnTo>
                    <a:pt x="193497" y="202666"/>
                  </a:lnTo>
                  <a:lnTo>
                    <a:pt x="193497" y="196570"/>
                  </a:lnTo>
                  <a:lnTo>
                    <a:pt x="191973" y="196570"/>
                  </a:lnTo>
                  <a:lnTo>
                    <a:pt x="191973" y="191998"/>
                  </a:lnTo>
                  <a:lnTo>
                    <a:pt x="190449" y="191998"/>
                  </a:lnTo>
                  <a:lnTo>
                    <a:pt x="190449" y="185902"/>
                  </a:lnTo>
                  <a:lnTo>
                    <a:pt x="188925" y="185902"/>
                  </a:lnTo>
                  <a:lnTo>
                    <a:pt x="188925" y="181330"/>
                  </a:lnTo>
                  <a:lnTo>
                    <a:pt x="187413" y="179806"/>
                  </a:lnTo>
                  <a:lnTo>
                    <a:pt x="187413" y="178282"/>
                  </a:lnTo>
                  <a:lnTo>
                    <a:pt x="185889" y="176758"/>
                  </a:lnTo>
                  <a:lnTo>
                    <a:pt x="185889" y="172199"/>
                  </a:lnTo>
                  <a:lnTo>
                    <a:pt x="184365" y="172199"/>
                  </a:lnTo>
                  <a:lnTo>
                    <a:pt x="184365" y="169138"/>
                  </a:lnTo>
                  <a:lnTo>
                    <a:pt x="182829" y="167614"/>
                  </a:lnTo>
                  <a:lnTo>
                    <a:pt x="182829" y="164566"/>
                  </a:lnTo>
                  <a:lnTo>
                    <a:pt x="181305" y="163042"/>
                  </a:lnTo>
                  <a:lnTo>
                    <a:pt x="181305" y="161531"/>
                  </a:lnTo>
                  <a:lnTo>
                    <a:pt x="179781" y="160007"/>
                  </a:lnTo>
                  <a:lnTo>
                    <a:pt x="179781" y="156946"/>
                  </a:lnTo>
                  <a:lnTo>
                    <a:pt x="178257" y="156946"/>
                  </a:lnTo>
                  <a:lnTo>
                    <a:pt x="178257" y="153898"/>
                  </a:lnTo>
                  <a:lnTo>
                    <a:pt x="176745" y="152374"/>
                  </a:lnTo>
                  <a:lnTo>
                    <a:pt x="176745" y="150863"/>
                  </a:lnTo>
                  <a:lnTo>
                    <a:pt x="175221" y="150863"/>
                  </a:lnTo>
                  <a:lnTo>
                    <a:pt x="175221" y="146291"/>
                  </a:lnTo>
                  <a:lnTo>
                    <a:pt x="173697" y="146291"/>
                  </a:lnTo>
                  <a:lnTo>
                    <a:pt x="173697" y="144767"/>
                  </a:lnTo>
                  <a:lnTo>
                    <a:pt x="172173" y="143230"/>
                  </a:lnTo>
                  <a:lnTo>
                    <a:pt x="172173" y="140195"/>
                  </a:lnTo>
                  <a:lnTo>
                    <a:pt x="170649" y="140195"/>
                  </a:lnTo>
                  <a:lnTo>
                    <a:pt x="170649" y="138671"/>
                  </a:lnTo>
                  <a:lnTo>
                    <a:pt x="169113" y="138671"/>
                  </a:lnTo>
                  <a:lnTo>
                    <a:pt x="169113" y="135623"/>
                  </a:lnTo>
                  <a:lnTo>
                    <a:pt x="167589" y="134099"/>
                  </a:lnTo>
                  <a:lnTo>
                    <a:pt x="167589" y="132575"/>
                  </a:lnTo>
                  <a:lnTo>
                    <a:pt x="164553" y="129527"/>
                  </a:lnTo>
                  <a:lnTo>
                    <a:pt x="164553" y="126479"/>
                  </a:lnTo>
                  <a:lnTo>
                    <a:pt x="163029" y="126479"/>
                  </a:lnTo>
                  <a:lnTo>
                    <a:pt x="163029" y="124955"/>
                  </a:lnTo>
                  <a:lnTo>
                    <a:pt x="161505" y="123431"/>
                  </a:lnTo>
                  <a:lnTo>
                    <a:pt x="161505" y="120383"/>
                  </a:lnTo>
                  <a:lnTo>
                    <a:pt x="159981" y="120383"/>
                  </a:lnTo>
                  <a:lnTo>
                    <a:pt x="159981" y="118846"/>
                  </a:lnTo>
                  <a:lnTo>
                    <a:pt x="158457" y="117335"/>
                  </a:lnTo>
                  <a:lnTo>
                    <a:pt x="158457" y="114287"/>
                  </a:lnTo>
                  <a:lnTo>
                    <a:pt x="156921" y="114287"/>
                  </a:lnTo>
                  <a:lnTo>
                    <a:pt x="156921" y="111239"/>
                  </a:lnTo>
                  <a:lnTo>
                    <a:pt x="155409" y="111239"/>
                  </a:lnTo>
                  <a:lnTo>
                    <a:pt x="155409" y="109715"/>
                  </a:lnTo>
                  <a:lnTo>
                    <a:pt x="153885" y="108191"/>
                  </a:lnTo>
                  <a:lnTo>
                    <a:pt x="153885" y="106680"/>
                  </a:lnTo>
                  <a:lnTo>
                    <a:pt x="152361" y="105143"/>
                  </a:lnTo>
                  <a:lnTo>
                    <a:pt x="152361" y="102095"/>
                  </a:lnTo>
                  <a:lnTo>
                    <a:pt x="149313" y="99047"/>
                  </a:lnTo>
                  <a:lnTo>
                    <a:pt x="149313" y="96012"/>
                  </a:lnTo>
                  <a:lnTo>
                    <a:pt x="147789" y="94488"/>
                  </a:lnTo>
                  <a:lnTo>
                    <a:pt x="147789" y="92951"/>
                  </a:lnTo>
                  <a:lnTo>
                    <a:pt x="146278" y="91427"/>
                  </a:lnTo>
                  <a:lnTo>
                    <a:pt x="146278" y="89903"/>
                  </a:lnTo>
                  <a:lnTo>
                    <a:pt x="144741" y="88379"/>
                  </a:lnTo>
                  <a:lnTo>
                    <a:pt x="144741" y="85344"/>
                  </a:lnTo>
                  <a:lnTo>
                    <a:pt x="143217" y="85344"/>
                  </a:lnTo>
                  <a:lnTo>
                    <a:pt x="143217" y="80759"/>
                  </a:lnTo>
                  <a:lnTo>
                    <a:pt x="141693" y="80759"/>
                  </a:lnTo>
                  <a:lnTo>
                    <a:pt x="141693" y="77711"/>
                  </a:lnTo>
                  <a:lnTo>
                    <a:pt x="140169" y="76187"/>
                  </a:lnTo>
                  <a:lnTo>
                    <a:pt x="140169" y="74676"/>
                  </a:lnTo>
                  <a:lnTo>
                    <a:pt x="138645" y="73152"/>
                  </a:lnTo>
                  <a:lnTo>
                    <a:pt x="138645" y="68580"/>
                  </a:lnTo>
                  <a:lnTo>
                    <a:pt x="137121" y="68580"/>
                  </a:lnTo>
                  <a:lnTo>
                    <a:pt x="137121" y="64008"/>
                  </a:lnTo>
                  <a:lnTo>
                    <a:pt x="135610" y="62484"/>
                  </a:lnTo>
                  <a:lnTo>
                    <a:pt x="135610" y="60960"/>
                  </a:lnTo>
                  <a:lnTo>
                    <a:pt x="134086" y="59436"/>
                  </a:lnTo>
                  <a:lnTo>
                    <a:pt x="134086" y="54851"/>
                  </a:lnTo>
                  <a:lnTo>
                    <a:pt x="132549" y="54851"/>
                  </a:lnTo>
                  <a:lnTo>
                    <a:pt x="132549" y="50292"/>
                  </a:lnTo>
                  <a:lnTo>
                    <a:pt x="131025" y="48768"/>
                  </a:lnTo>
                  <a:lnTo>
                    <a:pt x="131025" y="47244"/>
                  </a:lnTo>
                  <a:lnTo>
                    <a:pt x="129501" y="45720"/>
                  </a:lnTo>
                  <a:lnTo>
                    <a:pt x="129501" y="41148"/>
                  </a:lnTo>
                  <a:lnTo>
                    <a:pt x="127977" y="41148"/>
                  </a:lnTo>
                  <a:lnTo>
                    <a:pt x="127977" y="36576"/>
                  </a:lnTo>
                  <a:lnTo>
                    <a:pt x="126453" y="35052"/>
                  </a:lnTo>
                  <a:lnTo>
                    <a:pt x="126453" y="30480"/>
                  </a:lnTo>
                  <a:lnTo>
                    <a:pt x="124942" y="28956"/>
                  </a:lnTo>
                  <a:lnTo>
                    <a:pt x="124942" y="27432"/>
                  </a:lnTo>
                  <a:lnTo>
                    <a:pt x="123418" y="25908"/>
                  </a:lnTo>
                  <a:lnTo>
                    <a:pt x="123418" y="21336"/>
                  </a:lnTo>
                  <a:lnTo>
                    <a:pt x="121894" y="21336"/>
                  </a:lnTo>
                  <a:lnTo>
                    <a:pt x="121894" y="15240"/>
                  </a:lnTo>
                  <a:lnTo>
                    <a:pt x="120370" y="15240"/>
                  </a:lnTo>
                  <a:lnTo>
                    <a:pt x="120370" y="13716"/>
                  </a:lnTo>
                  <a:lnTo>
                    <a:pt x="118833" y="12192"/>
                  </a:lnTo>
                  <a:lnTo>
                    <a:pt x="118833" y="6108"/>
                  </a:lnTo>
                  <a:lnTo>
                    <a:pt x="117309" y="6108"/>
                  </a:lnTo>
                  <a:lnTo>
                    <a:pt x="117309" y="0"/>
                  </a:lnTo>
                  <a:close/>
                </a:path>
              </a:pathLst>
            </a:custGeom>
            <a:solidFill>
              <a:srgbClr val="7BAD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5073389" y="6206305"/>
              <a:ext cx="203200" cy="530860"/>
            </a:xfrm>
            <a:custGeom>
              <a:avLst/>
              <a:gdLst/>
              <a:ahLst/>
              <a:cxnLst/>
              <a:rect l="l" t="t" r="r" b="b"/>
              <a:pathLst>
                <a:path w="203200" h="530859">
                  <a:moveTo>
                    <a:pt x="88366" y="530275"/>
                  </a:moveTo>
                  <a:lnTo>
                    <a:pt x="88366" y="528751"/>
                  </a:lnTo>
                  <a:lnTo>
                    <a:pt x="88366" y="527227"/>
                  </a:lnTo>
                  <a:lnTo>
                    <a:pt x="86842" y="527227"/>
                  </a:lnTo>
                  <a:lnTo>
                    <a:pt x="86842" y="519607"/>
                  </a:lnTo>
                  <a:lnTo>
                    <a:pt x="85318" y="518083"/>
                  </a:lnTo>
                  <a:lnTo>
                    <a:pt x="85318" y="516559"/>
                  </a:lnTo>
                  <a:lnTo>
                    <a:pt x="85318" y="515035"/>
                  </a:lnTo>
                  <a:lnTo>
                    <a:pt x="85318" y="513524"/>
                  </a:lnTo>
                  <a:lnTo>
                    <a:pt x="83807" y="513524"/>
                  </a:lnTo>
                  <a:lnTo>
                    <a:pt x="83807" y="505891"/>
                  </a:lnTo>
                  <a:lnTo>
                    <a:pt x="82283" y="504367"/>
                  </a:lnTo>
                  <a:lnTo>
                    <a:pt x="82283" y="502856"/>
                  </a:lnTo>
                  <a:lnTo>
                    <a:pt x="82283" y="501332"/>
                  </a:lnTo>
                  <a:lnTo>
                    <a:pt x="82283" y="499808"/>
                  </a:lnTo>
                  <a:lnTo>
                    <a:pt x="82283" y="498271"/>
                  </a:lnTo>
                  <a:lnTo>
                    <a:pt x="80746" y="498271"/>
                  </a:lnTo>
                  <a:lnTo>
                    <a:pt x="80746" y="490664"/>
                  </a:lnTo>
                  <a:lnTo>
                    <a:pt x="79222" y="490664"/>
                  </a:lnTo>
                  <a:lnTo>
                    <a:pt x="79222" y="489140"/>
                  </a:lnTo>
                  <a:lnTo>
                    <a:pt x="79222" y="487616"/>
                  </a:lnTo>
                  <a:lnTo>
                    <a:pt x="77698" y="486092"/>
                  </a:lnTo>
                  <a:lnTo>
                    <a:pt x="77698" y="484555"/>
                  </a:lnTo>
                  <a:lnTo>
                    <a:pt x="77698" y="483031"/>
                  </a:lnTo>
                  <a:lnTo>
                    <a:pt x="77698" y="481507"/>
                  </a:lnTo>
                  <a:lnTo>
                    <a:pt x="76174" y="479996"/>
                  </a:lnTo>
                  <a:lnTo>
                    <a:pt x="76174" y="478472"/>
                  </a:lnTo>
                  <a:lnTo>
                    <a:pt x="76174" y="476948"/>
                  </a:lnTo>
                  <a:lnTo>
                    <a:pt x="76174" y="475424"/>
                  </a:lnTo>
                  <a:lnTo>
                    <a:pt x="74650" y="475424"/>
                  </a:lnTo>
                  <a:lnTo>
                    <a:pt x="74650" y="473900"/>
                  </a:lnTo>
                  <a:lnTo>
                    <a:pt x="74650" y="472363"/>
                  </a:lnTo>
                  <a:lnTo>
                    <a:pt x="73139" y="470839"/>
                  </a:lnTo>
                  <a:lnTo>
                    <a:pt x="73139" y="469328"/>
                  </a:lnTo>
                  <a:lnTo>
                    <a:pt x="73139" y="467804"/>
                  </a:lnTo>
                  <a:lnTo>
                    <a:pt x="73139" y="466280"/>
                  </a:lnTo>
                  <a:lnTo>
                    <a:pt x="71615" y="464756"/>
                  </a:lnTo>
                  <a:lnTo>
                    <a:pt x="71615" y="463232"/>
                  </a:lnTo>
                  <a:lnTo>
                    <a:pt x="71615" y="461708"/>
                  </a:lnTo>
                  <a:lnTo>
                    <a:pt x="70091" y="460171"/>
                  </a:lnTo>
                  <a:lnTo>
                    <a:pt x="70091" y="458660"/>
                  </a:lnTo>
                  <a:lnTo>
                    <a:pt x="68554" y="457136"/>
                  </a:lnTo>
                  <a:lnTo>
                    <a:pt x="68554" y="455612"/>
                  </a:lnTo>
                  <a:lnTo>
                    <a:pt x="68554" y="454088"/>
                  </a:lnTo>
                  <a:lnTo>
                    <a:pt x="68554" y="452564"/>
                  </a:lnTo>
                  <a:lnTo>
                    <a:pt x="67030" y="452564"/>
                  </a:lnTo>
                  <a:lnTo>
                    <a:pt x="67030" y="451040"/>
                  </a:lnTo>
                  <a:lnTo>
                    <a:pt x="67030" y="449516"/>
                  </a:lnTo>
                  <a:lnTo>
                    <a:pt x="67030" y="447992"/>
                  </a:lnTo>
                  <a:lnTo>
                    <a:pt x="65506" y="447992"/>
                  </a:lnTo>
                  <a:lnTo>
                    <a:pt x="65506" y="446468"/>
                  </a:lnTo>
                  <a:lnTo>
                    <a:pt x="65506" y="444944"/>
                  </a:lnTo>
                  <a:lnTo>
                    <a:pt x="63982" y="443420"/>
                  </a:lnTo>
                  <a:lnTo>
                    <a:pt x="63982" y="441896"/>
                  </a:lnTo>
                  <a:lnTo>
                    <a:pt x="62471" y="440372"/>
                  </a:lnTo>
                  <a:lnTo>
                    <a:pt x="62471" y="438848"/>
                  </a:lnTo>
                  <a:lnTo>
                    <a:pt x="62471" y="437324"/>
                  </a:lnTo>
                  <a:lnTo>
                    <a:pt x="60947" y="435813"/>
                  </a:lnTo>
                  <a:lnTo>
                    <a:pt x="60947" y="434276"/>
                  </a:lnTo>
                  <a:lnTo>
                    <a:pt x="60947" y="432752"/>
                  </a:lnTo>
                  <a:lnTo>
                    <a:pt x="59423" y="432752"/>
                  </a:lnTo>
                  <a:lnTo>
                    <a:pt x="59423" y="431228"/>
                  </a:lnTo>
                  <a:lnTo>
                    <a:pt x="59423" y="429704"/>
                  </a:lnTo>
                  <a:lnTo>
                    <a:pt x="57899" y="428180"/>
                  </a:lnTo>
                  <a:lnTo>
                    <a:pt x="57899" y="426656"/>
                  </a:lnTo>
                  <a:lnTo>
                    <a:pt x="56362" y="425145"/>
                  </a:lnTo>
                  <a:lnTo>
                    <a:pt x="56362" y="423621"/>
                  </a:lnTo>
                  <a:lnTo>
                    <a:pt x="56362" y="422084"/>
                  </a:lnTo>
                  <a:lnTo>
                    <a:pt x="54838" y="422084"/>
                  </a:lnTo>
                  <a:lnTo>
                    <a:pt x="54838" y="420560"/>
                  </a:lnTo>
                  <a:lnTo>
                    <a:pt x="54838" y="419036"/>
                  </a:lnTo>
                  <a:lnTo>
                    <a:pt x="53327" y="417512"/>
                  </a:lnTo>
                  <a:lnTo>
                    <a:pt x="53327" y="415988"/>
                  </a:lnTo>
                  <a:lnTo>
                    <a:pt x="51803" y="414477"/>
                  </a:lnTo>
                  <a:lnTo>
                    <a:pt x="51803" y="412953"/>
                  </a:lnTo>
                  <a:lnTo>
                    <a:pt x="51803" y="411429"/>
                  </a:lnTo>
                  <a:lnTo>
                    <a:pt x="50279" y="409892"/>
                  </a:lnTo>
                  <a:lnTo>
                    <a:pt x="50279" y="408368"/>
                  </a:lnTo>
                  <a:lnTo>
                    <a:pt x="48755" y="406844"/>
                  </a:lnTo>
                  <a:lnTo>
                    <a:pt x="48755" y="405320"/>
                  </a:lnTo>
                  <a:lnTo>
                    <a:pt x="47231" y="403809"/>
                  </a:lnTo>
                  <a:lnTo>
                    <a:pt x="47231" y="402285"/>
                  </a:lnTo>
                  <a:lnTo>
                    <a:pt x="47231" y="400761"/>
                  </a:lnTo>
                  <a:lnTo>
                    <a:pt x="45707" y="399237"/>
                  </a:lnTo>
                  <a:lnTo>
                    <a:pt x="45707" y="397713"/>
                  </a:lnTo>
                  <a:lnTo>
                    <a:pt x="45707" y="396176"/>
                  </a:lnTo>
                  <a:lnTo>
                    <a:pt x="44183" y="396176"/>
                  </a:lnTo>
                  <a:lnTo>
                    <a:pt x="44183" y="394652"/>
                  </a:lnTo>
                  <a:lnTo>
                    <a:pt x="42659" y="393141"/>
                  </a:lnTo>
                  <a:lnTo>
                    <a:pt x="42659" y="391617"/>
                  </a:lnTo>
                  <a:lnTo>
                    <a:pt x="42659" y="390093"/>
                  </a:lnTo>
                  <a:lnTo>
                    <a:pt x="41135" y="390093"/>
                  </a:lnTo>
                  <a:lnTo>
                    <a:pt x="41135" y="388569"/>
                  </a:lnTo>
                  <a:lnTo>
                    <a:pt x="41135" y="387045"/>
                  </a:lnTo>
                  <a:lnTo>
                    <a:pt x="39611" y="385521"/>
                  </a:lnTo>
                  <a:lnTo>
                    <a:pt x="39611" y="383984"/>
                  </a:lnTo>
                  <a:lnTo>
                    <a:pt x="39611" y="382473"/>
                  </a:lnTo>
                  <a:lnTo>
                    <a:pt x="38087" y="380949"/>
                  </a:lnTo>
                  <a:lnTo>
                    <a:pt x="36563" y="379425"/>
                  </a:lnTo>
                  <a:lnTo>
                    <a:pt x="36563" y="377901"/>
                  </a:lnTo>
                  <a:lnTo>
                    <a:pt x="36563" y="376377"/>
                  </a:lnTo>
                  <a:lnTo>
                    <a:pt x="35039" y="374853"/>
                  </a:lnTo>
                  <a:lnTo>
                    <a:pt x="35039" y="373329"/>
                  </a:lnTo>
                  <a:lnTo>
                    <a:pt x="35039" y="371792"/>
                  </a:lnTo>
                  <a:lnTo>
                    <a:pt x="33515" y="370281"/>
                  </a:lnTo>
                  <a:lnTo>
                    <a:pt x="33515" y="368757"/>
                  </a:lnTo>
                  <a:lnTo>
                    <a:pt x="32004" y="367233"/>
                  </a:lnTo>
                  <a:lnTo>
                    <a:pt x="32004" y="365709"/>
                  </a:lnTo>
                  <a:lnTo>
                    <a:pt x="32004" y="364185"/>
                  </a:lnTo>
                  <a:lnTo>
                    <a:pt x="30467" y="362661"/>
                  </a:lnTo>
                  <a:lnTo>
                    <a:pt x="30467" y="361137"/>
                  </a:lnTo>
                  <a:lnTo>
                    <a:pt x="28943" y="359613"/>
                  </a:lnTo>
                  <a:lnTo>
                    <a:pt x="28943" y="358089"/>
                  </a:lnTo>
                  <a:lnTo>
                    <a:pt x="28943" y="356565"/>
                  </a:lnTo>
                  <a:lnTo>
                    <a:pt x="27419" y="356565"/>
                  </a:lnTo>
                  <a:lnTo>
                    <a:pt x="27419" y="355041"/>
                  </a:lnTo>
                  <a:lnTo>
                    <a:pt x="27419" y="353517"/>
                  </a:lnTo>
                  <a:lnTo>
                    <a:pt x="25895" y="351993"/>
                  </a:lnTo>
                  <a:lnTo>
                    <a:pt x="25895" y="350469"/>
                  </a:lnTo>
                  <a:lnTo>
                    <a:pt x="25895" y="348957"/>
                  </a:lnTo>
                  <a:lnTo>
                    <a:pt x="24371" y="347433"/>
                  </a:lnTo>
                  <a:lnTo>
                    <a:pt x="24371" y="345897"/>
                  </a:lnTo>
                  <a:lnTo>
                    <a:pt x="24371" y="344373"/>
                  </a:lnTo>
                  <a:lnTo>
                    <a:pt x="22847" y="342849"/>
                  </a:lnTo>
                  <a:lnTo>
                    <a:pt x="22847" y="341325"/>
                  </a:lnTo>
                  <a:lnTo>
                    <a:pt x="21336" y="341325"/>
                  </a:lnTo>
                  <a:lnTo>
                    <a:pt x="21336" y="339801"/>
                  </a:lnTo>
                  <a:lnTo>
                    <a:pt x="21336" y="338277"/>
                  </a:lnTo>
                  <a:lnTo>
                    <a:pt x="21336" y="336765"/>
                  </a:lnTo>
                  <a:lnTo>
                    <a:pt x="19812" y="335241"/>
                  </a:lnTo>
                  <a:lnTo>
                    <a:pt x="19812" y="333705"/>
                  </a:lnTo>
                  <a:lnTo>
                    <a:pt x="19812" y="332181"/>
                  </a:lnTo>
                  <a:lnTo>
                    <a:pt x="18275" y="330657"/>
                  </a:lnTo>
                  <a:lnTo>
                    <a:pt x="18275" y="329133"/>
                  </a:lnTo>
                  <a:lnTo>
                    <a:pt x="16751" y="327609"/>
                  </a:lnTo>
                  <a:lnTo>
                    <a:pt x="16751" y="326097"/>
                  </a:lnTo>
                  <a:lnTo>
                    <a:pt x="16751" y="324573"/>
                  </a:lnTo>
                  <a:lnTo>
                    <a:pt x="15227" y="323049"/>
                  </a:lnTo>
                  <a:lnTo>
                    <a:pt x="15227" y="321525"/>
                  </a:lnTo>
                  <a:lnTo>
                    <a:pt x="15227" y="319989"/>
                  </a:lnTo>
                  <a:lnTo>
                    <a:pt x="13703" y="318465"/>
                  </a:lnTo>
                  <a:lnTo>
                    <a:pt x="13703" y="316941"/>
                  </a:lnTo>
                  <a:lnTo>
                    <a:pt x="12179" y="315429"/>
                  </a:lnTo>
                  <a:lnTo>
                    <a:pt x="12179" y="313905"/>
                  </a:lnTo>
                  <a:lnTo>
                    <a:pt x="12179" y="312381"/>
                  </a:lnTo>
                  <a:lnTo>
                    <a:pt x="12179" y="310857"/>
                  </a:lnTo>
                  <a:lnTo>
                    <a:pt x="10668" y="310857"/>
                  </a:lnTo>
                  <a:lnTo>
                    <a:pt x="10668" y="309333"/>
                  </a:lnTo>
                  <a:lnTo>
                    <a:pt x="10668" y="307797"/>
                  </a:lnTo>
                  <a:lnTo>
                    <a:pt x="10668" y="306273"/>
                  </a:lnTo>
                  <a:lnTo>
                    <a:pt x="9144" y="304761"/>
                  </a:lnTo>
                  <a:lnTo>
                    <a:pt x="9144" y="303237"/>
                  </a:lnTo>
                  <a:lnTo>
                    <a:pt x="9144" y="301713"/>
                  </a:lnTo>
                  <a:lnTo>
                    <a:pt x="9144" y="300189"/>
                  </a:lnTo>
                  <a:lnTo>
                    <a:pt x="7620" y="298665"/>
                  </a:lnTo>
                  <a:lnTo>
                    <a:pt x="7620" y="297141"/>
                  </a:lnTo>
                  <a:lnTo>
                    <a:pt x="6083" y="295605"/>
                  </a:lnTo>
                  <a:lnTo>
                    <a:pt x="6083" y="294093"/>
                  </a:lnTo>
                  <a:lnTo>
                    <a:pt x="6083" y="292569"/>
                  </a:lnTo>
                  <a:lnTo>
                    <a:pt x="6083" y="291045"/>
                  </a:lnTo>
                  <a:lnTo>
                    <a:pt x="4559" y="289521"/>
                  </a:lnTo>
                  <a:lnTo>
                    <a:pt x="4559" y="287997"/>
                  </a:lnTo>
                  <a:lnTo>
                    <a:pt x="4559" y="286473"/>
                  </a:lnTo>
                  <a:lnTo>
                    <a:pt x="4559" y="284949"/>
                  </a:lnTo>
                  <a:lnTo>
                    <a:pt x="4559" y="283425"/>
                  </a:lnTo>
                  <a:lnTo>
                    <a:pt x="3035" y="281901"/>
                  </a:lnTo>
                  <a:lnTo>
                    <a:pt x="3035" y="280377"/>
                  </a:lnTo>
                  <a:lnTo>
                    <a:pt x="3035" y="278853"/>
                  </a:lnTo>
                  <a:lnTo>
                    <a:pt x="3035" y="277329"/>
                  </a:lnTo>
                  <a:lnTo>
                    <a:pt x="1511" y="275805"/>
                  </a:lnTo>
                  <a:lnTo>
                    <a:pt x="1511" y="262089"/>
                  </a:lnTo>
                  <a:lnTo>
                    <a:pt x="0" y="262089"/>
                  </a:lnTo>
                  <a:lnTo>
                    <a:pt x="0" y="251421"/>
                  </a:lnTo>
                  <a:lnTo>
                    <a:pt x="1511" y="249910"/>
                  </a:lnTo>
                  <a:lnTo>
                    <a:pt x="1511" y="236194"/>
                  </a:lnTo>
                  <a:lnTo>
                    <a:pt x="3035" y="234670"/>
                  </a:lnTo>
                  <a:lnTo>
                    <a:pt x="3035" y="233146"/>
                  </a:lnTo>
                  <a:lnTo>
                    <a:pt x="3035" y="231609"/>
                  </a:lnTo>
                  <a:lnTo>
                    <a:pt x="3035" y="230085"/>
                  </a:lnTo>
                  <a:lnTo>
                    <a:pt x="4559" y="228561"/>
                  </a:lnTo>
                  <a:lnTo>
                    <a:pt x="4559" y="220954"/>
                  </a:lnTo>
                  <a:lnTo>
                    <a:pt x="6083" y="219417"/>
                  </a:lnTo>
                  <a:lnTo>
                    <a:pt x="6083" y="217893"/>
                  </a:lnTo>
                  <a:lnTo>
                    <a:pt x="6083" y="216382"/>
                  </a:lnTo>
                  <a:lnTo>
                    <a:pt x="6083" y="214858"/>
                  </a:lnTo>
                  <a:lnTo>
                    <a:pt x="6083" y="213334"/>
                  </a:lnTo>
                  <a:lnTo>
                    <a:pt x="7620" y="211810"/>
                  </a:lnTo>
                  <a:lnTo>
                    <a:pt x="7620" y="210286"/>
                  </a:lnTo>
                  <a:lnTo>
                    <a:pt x="9144" y="208762"/>
                  </a:lnTo>
                  <a:lnTo>
                    <a:pt x="9144" y="207225"/>
                  </a:lnTo>
                  <a:lnTo>
                    <a:pt x="9144" y="205714"/>
                  </a:lnTo>
                  <a:lnTo>
                    <a:pt x="9144" y="204190"/>
                  </a:lnTo>
                  <a:lnTo>
                    <a:pt x="9144" y="202666"/>
                  </a:lnTo>
                  <a:lnTo>
                    <a:pt x="10668" y="201142"/>
                  </a:lnTo>
                  <a:lnTo>
                    <a:pt x="10668" y="199618"/>
                  </a:lnTo>
                  <a:lnTo>
                    <a:pt x="10668" y="198094"/>
                  </a:lnTo>
                  <a:lnTo>
                    <a:pt x="10668" y="196570"/>
                  </a:lnTo>
                  <a:lnTo>
                    <a:pt x="12179" y="195046"/>
                  </a:lnTo>
                  <a:lnTo>
                    <a:pt x="12179" y="193522"/>
                  </a:lnTo>
                  <a:lnTo>
                    <a:pt x="12179" y="191998"/>
                  </a:lnTo>
                  <a:lnTo>
                    <a:pt x="12179" y="190474"/>
                  </a:lnTo>
                  <a:lnTo>
                    <a:pt x="13703" y="188950"/>
                  </a:lnTo>
                  <a:lnTo>
                    <a:pt x="13703" y="187426"/>
                  </a:lnTo>
                  <a:lnTo>
                    <a:pt x="13703" y="185902"/>
                  </a:lnTo>
                  <a:lnTo>
                    <a:pt x="15227" y="184391"/>
                  </a:lnTo>
                  <a:lnTo>
                    <a:pt x="15227" y="182867"/>
                  </a:lnTo>
                  <a:lnTo>
                    <a:pt x="15227" y="181330"/>
                  </a:lnTo>
                  <a:lnTo>
                    <a:pt x="15227" y="179806"/>
                  </a:lnTo>
                  <a:lnTo>
                    <a:pt x="16751" y="179806"/>
                  </a:lnTo>
                  <a:lnTo>
                    <a:pt x="16751" y="178282"/>
                  </a:lnTo>
                  <a:lnTo>
                    <a:pt x="16751" y="176758"/>
                  </a:lnTo>
                  <a:lnTo>
                    <a:pt x="16751" y="175234"/>
                  </a:lnTo>
                  <a:lnTo>
                    <a:pt x="18275" y="173723"/>
                  </a:lnTo>
                  <a:lnTo>
                    <a:pt x="18275" y="172199"/>
                  </a:lnTo>
                  <a:lnTo>
                    <a:pt x="19812" y="170675"/>
                  </a:lnTo>
                  <a:lnTo>
                    <a:pt x="19812" y="169138"/>
                  </a:lnTo>
                  <a:lnTo>
                    <a:pt x="19812" y="167614"/>
                  </a:lnTo>
                  <a:lnTo>
                    <a:pt x="21336" y="166090"/>
                  </a:lnTo>
                  <a:lnTo>
                    <a:pt x="21336" y="164566"/>
                  </a:lnTo>
                  <a:lnTo>
                    <a:pt x="21336" y="163042"/>
                  </a:lnTo>
                  <a:lnTo>
                    <a:pt x="22847" y="161531"/>
                  </a:lnTo>
                  <a:lnTo>
                    <a:pt x="22847" y="160007"/>
                  </a:lnTo>
                  <a:lnTo>
                    <a:pt x="24371" y="160007"/>
                  </a:lnTo>
                  <a:lnTo>
                    <a:pt x="24371" y="158483"/>
                  </a:lnTo>
                  <a:lnTo>
                    <a:pt x="24371" y="156946"/>
                  </a:lnTo>
                  <a:lnTo>
                    <a:pt x="25895" y="155422"/>
                  </a:lnTo>
                  <a:lnTo>
                    <a:pt x="25895" y="153898"/>
                  </a:lnTo>
                  <a:lnTo>
                    <a:pt x="25895" y="152374"/>
                  </a:lnTo>
                  <a:lnTo>
                    <a:pt x="27419" y="150863"/>
                  </a:lnTo>
                  <a:lnTo>
                    <a:pt x="27419" y="149339"/>
                  </a:lnTo>
                  <a:lnTo>
                    <a:pt x="28943" y="147815"/>
                  </a:lnTo>
                  <a:lnTo>
                    <a:pt x="28943" y="146291"/>
                  </a:lnTo>
                  <a:lnTo>
                    <a:pt x="30467" y="146291"/>
                  </a:lnTo>
                  <a:lnTo>
                    <a:pt x="30467" y="144767"/>
                  </a:lnTo>
                  <a:lnTo>
                    <a:pt x="30467" y="143230"/>
                  </a:lnTo>
                  <a:lnTo>
                    <a:pt x="32004" y="141706"/>
                  </a:lnTo>
                  <a:lnTo>
                    <a:pt x="32004" y="140195"/>
                  </a:lnTo>
                  <a:lnTo>
                    <a:pt x="33515" y="138671"/>
                  </a:lnTo>
                  <a:lnTo>
                    <a:pt x="35039" y="137147"/>
                  </a:lnTo>
                  <a:lnTo>
                    <a:pt x="35039" y="135623"/>
                  </a:lnTo>
                  <a:lnTo>
                    <a:pt x="35039" y="134099"/>
                  </a:lnTo>
                  <a:lnTo>
                    <a:pt x="36563" y="134099"/>
                  </a:lnTo>
                  <a:lnTo>
                    <a:pt x="36563" y="132575"/>
                  </a:lnTo>
                  <a:lnTo>
                    <a:pt x="36563" y="131038"/>
                  </a:lnTo>
                  <a:lnTo>
                    <a:pt x="38087" y="131038"/>
                  </a:lnTo>
                  <a:lnTo>
                    <a:pt x="38087" y="129527"/>
                  </a:lnTo>
                  <a:lnTo>
                    <a:pt x="39611" y="128003"/>
                  </a:lnTo>
                  <a:lnTo>
                    <a:pt x="39611" y="126479"/>
                  </a:lnTo>
                  <a:lnTo>
                    <a:pt x="41135" y="124955"/>
                  </a:lnTo>
                  <a:lnTo>
                    <a:pt x="41135" y="123431"/>
                  </a:lnTo>
                  <a:lnTo>
                    <a:pt x="42659" y="121907"/>
                  </a:lnTo>
                  <a:lnTo>
                    <a:pt x="42659" y="120383"/>
                  </a:lnTo>
                  <a:lnTo>
                    <a:pt x="44183" y="118846"/>
                  </a:lnTo>
                  <a:lnTo>
                    <a:pt x="45707" y="117335"/>
                  </a:lnTo>
                  <a:lnTo>
                    <a:pt x="45707" y="115811"/>
                  </a:lnTo>
                  <a:lnTo>
                    <a:pt x="45707" y="114287"/>
                  </a:lnTo>
                  <a:lnTo>
                    <a:pt x="47231" y="114287"/>
                  </a:lnTo>
                  <a:lnTo>
                    <a:pt x="47231" y="112763"/>
                  </a:lnTo>
                  <a:lnTo>
                    <a:pt x="47231" y="111239"/>
                  </a:lnTo>
                  <a:lnTo>
                    <a:pt x="48755" y="109715"/>
                  </a:lnTo>
                  <a:lnTo>
                    <a:pt x="48755" y="108191"/>
                  </a:lnTo>
                  <a:lnTo>
                    <a:pt x="50279" y="106680"/>
                  </a:lnTo>
                  <a:lnTo>
                    <a:pt x="50279" y="105143"/>
                  </a:lnTo>
                  <a:lnTo>
                    <a:pt x="51803" y="105143"/>
                  </a:lnTo>
                  <a:lnTo>
                    <a:pt x="51803" y="103619"/>
                  </a:lnTo>
                  <a:lnTo>
                    <a:pt x="51803" y="102095"/>
                  </a:lnTo>
                  <a:lnTo>
                    <a:pt x="51803" y="100571"/>
                  </a:lnTo>
                  <a:lnTo>
                    <a:pt x="53327" y="100571"/>
                  </a:lnTo>
                  <a:lnTo>
                    <a:pt x="53327" y="99047"/>
                  </a:lnTo>
                  <a:lnTo>
                    <a:pt x="54838" y="99047"/>
                  </a:lnTo>
                  <a:lnTo>
                    <a:pt x="54838" y="97523"/>
                  </a:lnTo>
                  <a:lnTo>
                    <a:pt x="54838" y="96012"/>
                  </a:lnTo>
                  <a:lnTo>
                    <a:pt x="56362" y="94488"/>
                  </a:lnTo>
                  <a:lnTo>
                    <a:pt x="56362" y="92951"/>
                  </a:lnTo>
                  <a:lnTo>
                    <a:pt x="56362" y="91427"/>
                  </a:lnTo>
                  <a:lnTo>
                    <a:pt x="57899" y="91427"/>
                  </a:lnTo>
                  <a:lnTo>
                    <a:pt x="57899" y="89903"/>
                  </a:lnTo>
                  <a:lnTo>
                    <a:pt x="57899" y="88379"/>
                  </a:lnTo>
                  <a:lnTo>
                    <a:pt x="57899" y="86855"/>
                  </a:lnTo>
                  <a:lnTo>
                    <a:pt x="59423" y="86855"/>
                  </a:lnTo>
                  <a:lnTo>
                    <a:pt x="59423" y="85344"/>
                  </a:lnTo>
                  <a:lnTo>
                    <a:pt x="60947" y="83820"/>
                  </a:lnTo>
                  <a:lnTo>
                    <a:pt x="60947" y="82296"/>
                  </a:lnTo>
                  <a:lnTo>
                    <a:pt x="60947" y="80759"/>
                  </a:lnTo>
                  <a:lnTo>
                    <a:pt x="62471" y="79235"/>
                  </a:lnTo>
                  <a:lnTo>
                    <a:pt x="62471" y="77711"/>
                  </a:lnTo>
                  <a:lnTo>
                    <a:pt x="62471" y="76187"/>
                  </a:lnTo>
                  <a:lnTo>
                    <a:pt x="63982" y="74676"/>
                  </a:lnTo>
                  <a:lnTo>
                    <a:pt x="63982" y="73152"/>
                  </a:lnTo>
                  <a:lnTo>
                    <a:pt x="65506" y="71628"/>
                  </a:lnTo>
                  <a:lnTo>
                    <a:pt x="65506" y="70104"/>
                  </a:lnTo>
                  <a:lnTo>
                    <a:pt x="65506" y="68580"/>
                  </a:lnTo>
                  <a:lnTo>
                    <a:pt x="67030" y="67043"/>
                  </a:lnTo>
                  <a:lnTo>
                    <a:pt x="67030" y="65519"/>
                  </a:lnTo>
                  <a:lnTo>
                    <a:pt x="67030" y="64008"/>
                  </a:lnTo>
                  <a:lnTo>
                    <a:pt x="67030" y="62484"/>
                  </a:lnTo>
                  <a:lnTo>
                    <a:pt x="68554" y="60960"/>
                  </a:lnTo>
                  <a:lnTo>
                    <a:pt x="68554" y="59436"/>
                  </a:lnTo>
                  <a:lnTo>
                    <a:pt x="68554" y="57912"/>
                  </a:lnTo>
                  <a:lnTo>
                    <a:pt x="70091" y="56388"/>
                  </a:lnTo>
                  <a:lnTo>
                    <a:pt x="70091" y="54851"/>
                  </a:lnTo>
                  <a:lnTo>
                    <a:pt x="71615" y="53327"/>
                  </a:lnTo>
                  <a:lnTo>
                    <a:pt x="71615" y="51816"/>
                  </a:lnTo>
                  <a:lnTo>
                    <a:pt x="71615" y="50292"/>
                  </a:lnTo>
                  <a:lnTo>
                    <a:pt x="71615" y="48768"/>
                  </a:lnTo>
                  <a:lnTo>
                    <a:pt x="73139" y="48768"/>
                  </a:lnTo>
                  <a:lnTo>
                    <a:pt x="73139" y="47244"/>
                  </a:lnTo>
                  <a:lnTo>
                    <a:pt x="73139" y="45720"/>
                  </a:lnTo>
                  <a:lnTo>
                    <a:pt x="73139" y="44196"/>
                  </a:lnTo>
                  <a:lnTo>
                    <a:pt x="74650" y="42659"/>
                  </a:lnTo>
                  <a:lnTo>
                    <a:pt x="74650" y="41148"/>
                  </a:lnTo>
                  <a:lnTo>
                    <a:pt x="74650" y="39624"/>
                  </a:lnTo>
                  <a:lnTo>
                    <a:pt x="76174" y="39624"/>
                  </a:lnTo>
                  <a:lnTo>
                    <a:pt x="76174" y="38100"/>
                  </a:lnTo>
                  <a:lnTo>
                    <a:pt x="76174" y="36576"/>
                  </a:lnTo>
                  <a:lnTo>
                    <a:pt x="76174" y="35052"/>
                  </a:lnTo>
                  <a:lnTo>
                    <a:pt x="77698" y="33528"/>
                  </a:lnTo>
                  <a:lnTo>
                    <a:pt x="77698" y="32004"/>
                  </a:lnTo>
                  <a:lnTo>
                    <a:pt x="77698" y="30480"/>
                  </a:lnTo>
                  <a:lnTo>
                    <a:pt x="77698" y="28956"/>
                  </a:lnTo>
                  <a:lnTo>
                    <a:pt x="79222" y="28956"/>
                  </a:lnTo>
                  <a:lnTo>
                    <a:pt x="79222" y="27432"/>
                  </a:lnTo>
                  <a:lnTo>
                    <a:pt x="79222" y="25908"/>
                  </a:lnTo>
                  <a:lnTo>
                    <a:pt x="80746" y="25908"/>
                  </a:lnTo>
                  <a:lnTo>
                    <a:pt x="80746" y="24384"/>
                  </a:lnTo>
                  <a:lnTo>
                    <a:pt x="80746" y="22860"/>
                  </a:lnTo>
                  <a:lnTo>
                    <a:pt x="80746" y="21336"/>
                  </a:lnTo>
                  <a:lnTo>
                    <a:pt x="80746" y="19824"/>
                  </a:lnTo>
                  <a:lnTo>
                    <a:pt x="82283" y="19824"/>
                  </a:lnTo>
                  <a:lnTo>
                    <a:pt x="82283" y="18300"/>
                  </a:lnTo>
                  <a:lnTo>
                    <a:pt x="82283" y="16764"/>
                  </a:lnTo>
                  <a:lnTo>
                    <a:pt x="82283" y="15240"/>
                  </a:lnTo>
                  <a:lnTo>
                    <a:pt x="83807" y="13716"/>
                  </a:lnTo>
                  <a:lnTo>
                    <a:pt x="83807" y="12192"/>
                  </a:lnTo>
                  <a:lnTo>
                    <a:pt x="83807" y="10668"/>
                  </a:lnTo>
                  <a:lnTo>
                    <a:pt x="83807" y="9144"/>
                  </a:lnTo>
                  <a:lnTo>
                    <a:pt x="85318" y="9144"/>
                  </a:lnTo>
                  <a:lnTo>
                    <a:pt x="85318" y="7632"/>
                  </a:lnTo>
                  <a:lnTo>
                    <a:pt x="85318" y="6108"/>
                  </a:lnTo>
                  <a:lnTo>
                    <a:pt x="86842" y="4572"/>
                  </a:lnTo>
                  <a:lnTo>
                    <a:pt x="86842" y="3048"/>
                  </a:lnTo>
                  <a:lnTo>
                    <a:pt x="86842" y="1524"/>
                  </a:lnTo>
                  <a:lnTo>
                    <a:pt x="86842" y="0"/>
                  </a:lnTo>
                  <a:lnTo>
                    <a:pt x="115785" y="0"/>
                  </a:lnTo>
                  <a:lnTo>
                    <a:pt x="117309" y="0"/>
                  </a:lnTo>
                  <a:lnTo>
                    <a:pt x="117309" y="1524"/>
                  </a:lnTo>
                  <a:lnTo>
                    <a:pt x="117309" y="3048"/>
                  </a:lnTo>
                  <a:lnTo>
                    <a:pt x="117309" y="4572"/>
                  </a:lnTo>
                  <a:lnTo>
                    <a:pt x="117309" y="6108"/>
                  </a:lnTo>
                  <a:lnTo>
                    <a:pt x="118833" y="6108"/>
                  </a:lnTo>
                  <a:lnTo>
                    <a:pt x="118833" y="7632"/>
                  </a:lnTo>
                  <a:lnTo>
                    <a:pt x="118833" y="9144"/>
                  </a:lnTo>
                  <a:lnTo>
                    <a:pt x="118833" y="10668"/>
                  </a:lnTo>
                  <a:lnTo>
                    <a:pt x="118833" y="12192"/>
                  </a:lnTo>
                  <a:lnTo>
                    <a:pt x="120370" y="13716"/>
                  </a:lnTo>
                  <a:lnTo>
                    <a:pt x="120370" y="15240"/>
                  </a:lnTo>
                  <a:lnTo>
                    <a:pt x="121894" y="15240"/>
                  </a:lnTo>
                  <a:lnTo>
                    <a:pt x="121894" y="16764"/>
                  </a:lnTo>
                  <a:lnTo>
                    <a:pt x="121894" y="18300"/>
                  </a:lnTo>
                  <a:lnTo>
                    <a:pt x="121894" y="19824"/>
                  </a:lnTo>
                  <a:lnTo>
                    <a:pt x="121894" y="21336"/>
                  </a:lnTo>
                  <a:lnTo>
                    <a:pt x="123418" y="21336"/>
                  </a:lnTo>
                  <a:lnTo>
                    <a:pt x="123418" y="22860"/>
                  </a:lnTo>
                  <a:lnTo>
                    <a:pt x="123418" y="24384"/>
                  </a:lnTo>
                  <a:lnTo>
                    <a:pt x="123418" y="25908"/>
                  </a:lnTo>
                  <a:lnTo>
                    <a:pt x="124942" y="27432"/>
                  </a:lnTo>
                  <a:lnTo>
                    <a:pt x="124942" y="28956"/>
                  </a:lnTo>
                  <a:lnTo>
                    <a:pt x="126453" y="30480"/>
                  </a:lnTo>
                  <a:lnTo>
                    <a:pt x="126453" y="32004"/>
                  </a:lnTo>
                  <a:lnTo>
                    <a:pt x="126453" y="33528"/>
                  </a:lnTo>
                  <a:lnTo>
                    <a:pt x="126453" y="35052"/>
                  </a:lnTo>
                  <a:lnTo>
                    <a:pt x="127977" y="36576"/>
                  </a:lnTo>
                  <a:lnTo>
                    <a:pt x="127977" y="38100"/>
                  </a:lnTo>
                  <a:lnTo>
                    <a:pt x="127977" y="39624"/>
                  </a:lnTo>
                  <a:lnTo>
                    <a:pt x="127977" y="41148"/>
                  </a:lnTo>
                  <a:lnTo>
                    <a:pt x="129501" y="41148"/>
                  </a:lnTo>
                  <a:lnTo>
                    <a:pt x="129501" y="42659"/>
                  </a:lnTo>
                  <a:lnTo>
                    <a:pt x="129501" y="44196"/>
                  </a:lnTo>
                  <a:lnTo>
                    <a:pt x="129501" y="45720"/>
                  </a:lnTo>
                  <a:lnTo>
                    <a:pt x="131025" y="47244"/>
                  </a:lnTo>
                  <a:lnTo>
                    <a:pt x="131025" y="48768"/>
                  </a:lnTo>
                  <a:lnTo>
                    <a:pt x="132549" y="50292"/>
                  </a:lnTo>
                  <a:lnTo>
                    <a:pt x="132549" y="51816"/>
                  </a:lnTo>
                  <a:lnTo>
                    <a:pt x="132549" y="53327"/>
                  </a:lnTo>
                  <a:lnTo>
                    <a:pt x="132549" y="54851"/>
                  </a:lnTo>
                  <a:lnTo>
                    <a:pt x="134086" y="54851"/>
                  </a:lnTo>
                  <a:lnTo>
                    <a:pt x="134086" y="56388"/>
                  </a:lnTo>
                  <a:lnTo>
                    <a:pt x="134086" y="57912"/>
                  </a:lnTo>
                  <a:lnTo>
                    <a:pt x="134086" y="59436"/>
                  </a:lnTo>
                  <a:lnTo>
                    <a:pt x="135610" y="60960"/>
                  </a:lnTo>
                  <a:lnTo>
                    <a:pt x="135610" y="62484"/>
                  </a:lnTo>
                  <a:lnTo>
                    <a:pt x="137121" y="64008"/>
                  </a:lnTo>
                  <a:lnTo>
                    <a:pt x="137121" y="65519"/>
                  </a:lnTo>
                  <a:lnTo>
                    <a:pt x="137121" y="67043"/>
                  </a:lnTo>
                  <a:lnTo>
                    <a:pt x="137121" y="68580"/>
                  </a:lnTo>
                  <a:lnTo>
                    <a:pt x="138645" y="68580"/>
                  </a:lnTo>
                  <a:lnTo>
                    <a:pt x="138645" y="70104"/>
                  </a:lnTo>
                  <a:lnTo>
                    <a:pt x="138645" y="71628"/>
                  </a:lnTo>
                  <a:lnTo>
                    <a:pt x="138645" y="73152"/>
                  </a:lnTo>
                  <a:lnTo>
                    <a:pt x="140169" y="74676"/>
                  </a:lnTo>
                  <a:lnTo>
                    <a:pt x="140169" y="76187"/>
                  </a:lnTo>
                  <a:lnTo>
                    <a:pt x="141693" y="77711"/>
                  </a:lnTo>
                  <a:lnTo>
                    <a:pt x="141693" y="79235"/>
                  </a:lnTo>
                  <a:lnTo>
                    <a:pt x="141693" y="80759"/>
                  </a:lnTo>
                  <a:lnTo>
                    <a:pt x="143217" y="80759"/>
                  </a:lnTo>
                  <a:lnTo>
                    <a:pt x="143217" y="82296"/>
                  </a:lnTo>
                  <a:lnTo>
                    <a:pt x="143217" y="83820"/>
                  </a:lnTo>
                  <a:lnTo>
                    <a:pt x="143217" y="85344"/>
                  </a:lnTo>
                  <a:lnTo>
                    <a:pt x="144741" y="85344"/>
                  </a:lnTo>
                  <a:lnTo>
                    <a:pt x="144741" y="86855"/>
                  </a:lnTo>
                  <a:lnTo>
                    <a:pt x="144741" y="88379"/>
                  </a:lnTo>
                  <a:lnTo>
                    <a:pt x="146278" y="89903"/>
                  </a:lnTo>
                  <a:lnTo>
                    <a:pt x="146278" y="91427"/>
                  </a:lnTo>
                  <a:lnTo>
                    <a:pt x="147789" y="92951"/>
                  </a:lnTo>
                  <a:lnTo>
                    <a:pt x="147789" y="94488"/>
                  </a:lnTo>
                  <a:lnTo>
                    <a:pt x="149313" y="96012"/>
                  </a:lnTo>
                  <a:lnTo>
                    <a:pt x="149313" y="97523"/>
                  </a:lnTo>
                  <a:lnTo>
                    <a:pt x="149313" y="99047"/>
                  </a:lnTo>
                  <a:lnTo>
                    <a:pt x="150837" y="100571"/>
                  </a:lnTo>
                  <a:lnTo>
                    <a:pt x="152361" y="102095"/>
                  </a:lnTo>
                  <a:lnTo>
                    <a:pt x="152361" y="103619"/>
                  </a:lnTo>
                  <a:lnTo>
                    <a:pt x="152361" y="105143"/>
                  </a:lnTo>
                  <a:lnTo>
                    <a:pt x="153885" y="106680"/>
                  </a:lnTo>
                  <a:lnTo>
                    <a:pt x="153885" y="108191"/>
                  </a:lnTo>
                  <a:lnTo>
                    <a:pt x="155409" y="109715"/>
                  </a:lnTo>
                  <a:lnTo>
                    <a:pt x="155409" y="111239"/>
                  </a:lnTo>
                  <a:lnTo>
                    <a:pt x="156921" y="111239"/>
                  </a:lnTo>
                  <a:lnTo>
                    <a:pt x="156921" y="112763"/>
                  </a:lnTo>
                  <a:lnTo>
                    <a:pt x="156921" y="114287"/>
                  </a:lnTo>
                  <a:lnTo>
                    <a:pt x="158457" y="114287"/>
                  </a:lnTo>
                  <a:lnTo>
                    <a:pt x="158457" y="115811"/>
                  </a:lnTo>
                  <a:lnTo>
                    <a:pt x="158457" y="117335"/>
                  </a:lnTo>
                  <a:lnTo>
                    <a:pt x="159981" y="118846"/>
                  </a:lnTo>
                  <a:lnTo>
                    <a:pt x="159981" y="120383"/>
                  </a:lnTo>
                  <a:lnTo>
                    <a:pt x="161505" y="120383"/>
                  </a:lnTo>
                  <a:lnTo>
                    <a:pt x="161505" y="121907"/>
                  </a:lnTo>
                  <a:lnTo>
                    <a:pt x="161505" y="123431"/>
                  </a:lnTo>
                  <a:lnTo>
                    <a:pt x="163029" y="124955"/>
                  </a:lnTo>
                  <a:lnTo>
                    <a:pt x="163029" y="126479"/>
                  </a:lnTo>
                  <a:lnTo>
                    <a:pt x="164553" y="126479"/>
                  </a:lnTo>
                  <a:lnTo>
                    <a:pt x="164553" y="128003"/>
                  </a:lnTo>
                  <a:lnTo>
                    <a:pt x="164553" y="129527"/>
                  </a:lnTo>
                  <a:lnTo>
                    <a:pt x="166077" y="131038"/>
                  </a:lnTo>
                  <a:lnTo>
                    <a:pt x="167589" y="132575"/>
                  </a:lnTo>
                  <a:lnTo>
                    <a:pt x="167589" y="134099"/>
                  </a:lnTo>
                  <a:lnTo>
                    <a:pt x="169113" y="135623"/>
                  </a:lnTo>
                  <a:lnTo>
                    <a:pt x="169113" y="137147"/>
                  </a:lnTo>
                  <a:lnTo>
                    <a:pt x="169113" y="138671"/>
                  </a:lnTo>
                  <a:lnTo>
                    <a:pt x="170649" y="138671"/>
                  </a:lnTo>
                  <a:lnTo>
                    <a:pt x="170649" y="140195"/>
                  </a:lnTo>
                  <a:lnTo>
                    <a:pt x="172173" y="140195"/>
                  </a:lnTo>
                  <a:lnTo>
                    <a:pt x="172173" y="141706"/>
                  </a:lnTo>
                  <a:lnTo>
                    <a:pt x="172173" y="143230"/>
                  </a:lnTo>
                  <a:lnTo>
                    <a:pt x="173697" y="144767"/>
                  </a:lnTo>
                  <a:lnTo>
                    <a:pt x="173697" y="146291"/>
                  </a:lnTo>
                  <a:lnTo>
                    <a:pt x="175221" y="146291"/>
                  </a:lnTo>
                  <a:lnTo>
                    <a:pt x="175221" y="147815"/>
                  </a:lnTo>
                  <a:lnTo>
                    <a:pt x="175221" y="149339"/>
                  </a:lnTo>
                  <a:lnTo>
                    <a:pt x="175221" y="150863"/>
                  </a:lnTo>
                  <a:lnTo>
                    <a:pt x="176745" y="150863"/>
                  </a:lnTo>
                  <a:lnTo>
                    <a:pt x="176745" y="152374"/>
                  </a:lnTo>
                  <a:lnTo>
                    <a:pt x="178257" y="153898"/>
                  </a:lnTo>
                  <a:lnTo>
                    <a:pt x="178257" y="155422"/>
                  </a:lnTo>
                  <a:lnTo>
                    <a:pt x="178257" y="156946"/>
                  </a:lnTo>
                  <a:lnTo>
                    <a:pt x="179781" y="156946"/>
                  </a:lnTo>
                  <a:lnTo>
                    <a:pt x="179781" y="158483"/>
                  </a:lnTo>
                  <a:lnTo>
                    <a:pt x="179781" y="160007"/>
                  </a:lnTo>
                  <a:lnTo>
                    <a:pt x="181305" y="161531"/>
                  </a:lnTo>
                  <a:lnTo>
                    <a:pt x="181305" y="163042"/>
                  </a:lnTo>
                  <a:lnTo>
                    <a:pt x="182829" y="164566"/>
                  </a:lnTo>
                  <a:lnTo>
                    <a:pt x="182829" y="166090"/>
                  </a:lnTo>
                  <a:lnTo>
                    <a:pt x="182829" y="167614"/>
                  </a:lnTo>
                  <a:lnTo>
                    <a:pt x="184365" y="169138"/>
                  </a:lnTo>
                  <a:lnTo>
                    <a:pt x="184365" y="170675"/>
                  </a:lnTo>
                  <a:lnTo>
                    <a:pt x="184365" y="172199"/>
                  </a:lnTo>
                  <a:lnTo>
                    <a:pt x="185889" y="172199"/>
                  </a:lnTo>
                  <a:lnTo>
                    <a:pt x="185889" y="173723"/>
                  </a:lnTo>
                  <a:lnTo>
                    <a:pt x="185889" y="175234"/>
                  </a:lnTo>
                  <a:lnTo>
                    <a:pt x="185889" y="176758"/>
                  </a:lnTo>
                  <a:lnTo>
                    <a:pt x="187413" y="178282"/>
                  </a:lnTo>
                  <a:lnTo>
                    <a:pt x="187413" y="179806"/>
                  </a:lnTo>
                  <a:lnTo>
                    <a:pt x="188925" y="181330"/>
                  </a:lnTo>
                  <a:lnTo>
                    <a:pt x="188925" y="182867"/>
                  </a:lnTo>
                  <a:lnTo>
                    <a:pt x="188925" y="184391"/>
                  </a:lnTo>
                  <a:lnTo>
                    <a:pt x="188925" y="185902"/>
                  </a:lnTo>
                  <a:lnTo>
                    <a:pt x="190449" y="185902"/>
                  </a:lnTo>
                  <a:lnTo>
                    <a:pt x="190449" y="187426"/>
                  </a:lnTo>
                  <a:lnTo>
                    <a:pt x="190449" y="188950"/>
                  </a:lnTo>
                  <a:lnTo>
                    <a:pt x="190449" y="190474"/>
                  </a:lnTo>
                  <a:lnTo>
                    <a:pt x="190449" y="191998"/>
                  </a:lnTo>
                  <a:lnTo>
                    <a:pt x="191973" y="191998"/>
                  </a:lnTo>
                  <a:lnTo>
                    <a:pt x="191973" y="193522"/>
                  </a:lnTo>
                  <a:lnTo>
                    <a:pt x="191973" y="195046"/>
                  </a:lnTo>
                  <a:lnTo>
                    <a:pt x="191973" y="196570"/>
                  </a:lnTo>
                  <a:lnTo>
                    <a:pt x="193497" y="196570"/>
                  </a:lnTo>
                  <a:lnTo>
                    <a:pt x="193497" y="198094"/>
                  </a:lnTo>
                  <a:lnTo>
                    <a:pt x="193497" y="199618"/>
                  </a:lnTo>
                  <a:lnTo>
                    <a:pt x="193497" y="201142"/>
                  </a:lnTo>
                  <a:lnTo>
                    <a:pt x="193497" y="202666"/>
                  </a:lnTo>
                  <a:lnTo>
                    <a:pt x="195021" y="204190"/>
                  </a:lnTo>
                  <a:lnTo>
                    <a:pt x="195021" y="205714"/>
                  </a:lnTo>
                  <a:lnTo>
                    <a:pt x="195021" y="207225"/>
                  </a:lnTo>
                  <a:lnTo>
                    <a:pt x="195021" y="208762"/>
                  </a:lnTo>
                  <a:lnTo>
                    <a:pt x="195021" y="210286"/>
                  </a:lnTo>
                  <a:lnTo>
                    <a:pt x="196557" y="210286"/>
                  </a:lnTo>
                  <a:lnTo>
                    <a:pt x="196557" y="211810"/>
                  </a:lnTo>
                  <a:lnTo>
                    <a:pt x="196557" y="213334"/>
                  </a:lnTo>
                  <a:lnTo>
                    <a:pt x="196557" y="214858"/>
                  </a:lnTo>
                  <a:lnTo>
                    <a:pt x="198069" y="216382"/>
                  </a:lnTo>
                  <a:lnTo>
                    <a:pt x="198069" y="217893"/>
                  </a:lnTo>
                  <a:lnTo>
                    <a:pt x="198069" y="219417"/>
                  </a:lnTo>
                  <a:lnTo>
                    <a:pt x="198069" y="220954"/>
                  </a:lnTo>
                  <a:lnTo>
                    <a:pt x="198069" y="222478"/>
                  </a:lnTo>
                  <a:lnTo>
                    <a:pt x="199593" y="222478"/>
                  </a:lnTo>
                  <a:lnTo>
                    <a:pt x="199593" y="230085"/>
                  </a:lnTo>
                  <a:lnTo>
                    <a:pt x="201117" y="231609"/>
                  </a:lnTo>
                  <a:lnTo>
                    <a:pt x="201117" y="242277"/>
                  </a:lnTo>
                  <a:lnTo>
                    <a:pt x="202641" y="242277"/>
                  </a:lnTo>
                  <a:lnTo>
                    <a:pt x="202641" y="269709"/>
                  </a:lnTo>
                  <a:lnTo>
                    <a:pt x="201117" y="271246"/>
                  </a:lnTo>
                  <a:lnTo>
                    <a:pt x="201117" y="280377"/>
                  </a:lnTo>
                  <a:lnTo>
                    <a:pt x="199593" y="281901"/>
                  </a:lnTo>
                  <a:lnTo>
                    <a:pt x="199593" y="283425"/>
                  </a:lnTo>
                  <a:lnTo>
                    <a:pt x="199593" y="284949"/>
                  </a:lnTo>
                  <a:lnTo>
                    <a:pt x="199593" y="286473"/>
                  </a:lnTo>
                  <a:lnTo>
                    <a:pt x="199593" y="287997"/>
                  </a:lnTo>
                  <a:lnTo>
                    <a:pt x="198069" y="289521"/>
                  </a:lnTo>
                  <a:lnTo>
                    <a:pt x="198069" y="291045"/>
                  </a:lnTo>
                  <a:lnTo>
                    <a:pt x="198069" y="292569"/>
                  </a:lnTo>
                  <a:lnTo>
                    <a:pt x="198069" y="294093"/>
                  </a:lnTo>
                  <a:lnTo>
                    <a:pt x="196557" y="295605"/>
                  </a:lnTo>
                  <a:lnTo>
                    <a:pt x="196557" y="297141"/>
                  </a:lnTo>
                  <a:lnTo>
                    <a:pt x="195021" y="298665"/>
                  </a:lnTo>
                  <a:lnTo>
                    <a:pt x="195021" y="300189"/>
                  </a:lnTo>
                  <a:lnTo>
                    <a:pt x="195021" y="301713"/>
                  </a:lnTo>
                  <a:lnTo>
                    <a:pt x="195021" y="303237"/>
                  </a:lnTo>
                  <a:lnTo>
                    <a:pt x="195021" y="304761"/>
                  </a:lnTo>
                  <a:lnTo>
                    <a:pt x="193497" y="304761"/>
                  </a:lnTo>
                  <a:lnTo>
                    <a:pt x="193497" y="306273"/>
                  </a:lnTo>
                  <a:lnTo>
                    <a:pt x="193497" y="307797"/>
                  </a:lnTo>
                  <a:lnTo>
                    <a:pt x="191973" y="309333"/>
                  </a:lnTo>
                  <a:lnTo>
                    <a:pt x="191973" y="310857"/>
                  </a:lnTo>
                  <a:lnTo>
                    <a:pt x="191973" y="312381"/>
                  </a:lnTo>
                  <a:lnTo>
                    <a:pt x="190449" y="313905"/>
                  </a:lnTo>
                  <a:lnTo>
                    <a:pt x="190449" y="315429"/>
                  </a:lnTo>
                  <a:lnTo>
                    <a:pt x="190449" y="316941"/>
                  </a:lnTo>
                  <a:lnTo>
                    <a:pt x="188925" y="318465"/>
                  </a:lnTo>
                  <a:lnTo>
                    <a:pt x="188925" y="319989"/>
                  </a:lnTo>
                  <a:lnTo>
                    <a:pt x="188925" y="321525"/>
                  </a:lnTo>
                  <a:lnTo>
                    <a:pt x="187413" y="323049"/>
                  </a:lnTo>
                  <a:lnTo>
                    <a:pt x="187413" y="324573"/>
                  </a:lnTo>
                  <a:lnTo>
                    <a:pt x="185889" y="326097"/>
                  </a:lnTo>
                  <a:lnTo>
                    <a:pt x="185889" y="327609"/>
                  </a:lnTo>
                  <a:lnTo>
                    <a:pt x="185889" y="329133"/>
                  </a:lnTo>
                  <a:lnTo>
                    <a:pt x="185889" y="330657"/>
                  </a:lnTo>
                  <a:lnTo>
                    <a:pt x="184365" y="330657"/>
                  </a:lnTo>
                  <a:lnTo>
                    <a:pt x="184365" y="332181"/>
                  </a:lnTo>
                  <a:lnTo>
                    <a:pt x="184365" y="333705"/>
                  </a:lnTo>
                  <a:lnTo>
                    <a:pt x="184365" y="335241"/>
                  </a:lnTo>
                  <a:lnTo>
                    <a:pt x="182829" y="335241"/>
                  </a:lnTo>
                  <a:lnTo>
                    <a:pt x="182829" y="336765"/>
                  </a:lnTo>
                  <a:lnTo>
                    <a:pt x="182829" y="338277"/>
                  </a:lnTo>
                  <a:lnTo>
                    <a:pt x="182829" y="339801"/>
                  </a:lnTo>
                  <a:lnTo>
                    <a:pt x="181305" y="341325"/>
                  </a:lnTo>
                  <a:lnTo>
                    <a:pt x="181305" y="342849"/>
                  </a:lnTo>
                  <a:lnTo>
                    <a:pt x="179781" y="342849"/>
                  </a:lnTo>
                  <a:lnTo>
                    <a:pt x="179781" y="344373"/>
                  </a:lnTo>
                  <a:lnTo>
                    <a:pt x="179781" y="345897"/>
                  </a:lnTo>
                  <a:lnTo>
                    <a:pt x="179781" y="347433"/>
                  </a:lnTo>
                  <a:lnTo>
                    <a:pt x="178257" y="347433"/>
                  </a:lnTo>
                  <a:lnTo>
                    <a:pt x="178257" y="348957"/>
                  </a:lnTo>
                  <a:lnTo>
                    <a:pt x="178257" y="350469"/>
                  </a:lnTo>
                  <a:lnTo>
                    <a:pt x="176745" y="351993"/>
                  </a:lnTo>
                  <a:lnTo>
                    <a:pt x="176745" y="353517"/>
                  </a:lnTo>
                  <a:lnTo>
                    <a:pt x="176745" y="355041"/>
                  </a:lnTo>
                  <a:lnTo>
                    <a:pt x="175221" y="355041"/>
                  </a:lnTo>
                  <a:lnTo>
                    <a:pt x="175221" y="356565"/>
                  </a:lnTo>
                  <a:lnTo>
                    <a:pt x="175221" y="358089"/>
                  </a:lnTo>
                  <a:lnTo>
                    <a:pt x="173697" y="359613"/>
                  </a:lnTo>
                  <a:lnTo>
                    <a:pt x="173697" y="361137"/>
                  </a:lnTo>
                  <a:lnTo>
                    <a:pt x="173697" y="362661"/>
                  </a:lnTo>
                  <a:lnTo>
                    <a:pt x="172173" y="362661"/>
                  </a:lnTo>
                  <a:lnTo>
                    <a:pt x="172173" y="364185"/>
                  </a:lnTo>
                  <a:lnTo>
                    <a:pt x="172173" y="365709"/>
                  </a:lnTo>
                  <a:lnTo>
                    <a:pt x="172173" y="367233"/>
                  </a:lnTo>
                  <a:lnTo>
                    <a:pt x="170649" y="367233"/>
                  </a:lnTo>
                  <a:lnTo>
                    <a:pt x="170649" y="368757"/>
                  </a:lnTo>
                  <a:lnTo>
                    <a:pt x="170649" y="370281"/>
                  </a:lnTo>
                  <a:lnTo>
                    <a:pt x="169113" y="370281"/>
                  </a:lnTo>
                  <a:lnTo>
                    <a:pt x="169113" y="371792"/>
                  </a:lnTo>
                  <a:lnTo>
                    <a:pt x="169113" y="373329"/>
                  </a:lnTo>
                  <a:lnTo>
                    <a:pt x="167589" y="374853"/>
                  </a:lnTo>
                  <a:lnTo>
                    <a:pt x="167589" y="376377"/>
                  </a:lnTo>
                  <a:lnTo>
                    <a:pt x="167589" y="377901"/>
                  </a:lnTo>
                  <a:lnTo>
                    <a:pt x="166077" y="379425"/>
                  </a:lnTo>
                  <a:lnTo>
                    <a:pt x="166077" y="380949"/>
                  </a:lnTo>
                  <a:lnTo>
                    <a:pt x="164553" y="380949"/>
                  </a:lnTo>
                  <a:lnTo>
                    <a:pt x="164553" y="382473"/>
                  </a:lnTo>
                  <a:lnTo>
                    <a:pt x="164553" y="383984"/>
                  </a:lnTo>
                  <a:lnTo>
                    <a:pt x="163029" y="385521"/>
                  </a:lnTo>
                  <a:lnTo>
                    <a:pt x="163029" y="387045"/>
                  </a:lnTo>
                  <a:lnTo>
                    <a:pt x="163029" y="388569"/>
                  </a:lnTo>
                  <a:lnTo>
                    <a:pt x="161505" y="390093"/>
                  </a:lnTo>
                  <a:lnTo>
                    <a:pt x="161505" y="391617"/>
                  </a:lnTo>
                  <a:lnTo>
                    <a:pt x="159981" y="393141"/>
                  </a:lnTo>
                  <a:lnTo>
                    <a:pt x="159981" y="394652"/>
                  </a:lnTo>
                  <a:lnTo>
                    <a:pt x="159981" y="396176"/>
                  </a:lnTo>
                  <a:lnTo>
                    <a:pt x="158457" y="396176"/>
                  </a:lnTo>
                  <a:lnTo>
                    <a:pt x="158457" y="397713"/>
                  </a:lnTo>
                  <a:lnTo>
                    <a:pt x="158457" y="399237"/>
                  </a:lnTo>
                  <a:lnTo>
                    <a:pt x="156921" y="399237"/>
                  </a:lnTo>
                  <a:lnTo>
                    <a:pt x="156921" y="400761"/>
                  </a:lnTo>
                  <a:lnTo>
                    <a:pt x="156921" y="402285"/>
                  </a:lnTo>
                  <a:lnTo>
                    <a:pt x="155409" y="403809"/>
                  </a:lnTo>
                  <a:lnTo>
                    <a:pt x="155409" y="405320"/>
                  </a:lnTo>
                  <a:lnTo>
                    <a:pt x="155409" y="406844"/>
                  </a:lnTo>
                  <a:lnTo>
                    <a:pt x="153885" y="406844"/>
                  </a:lnTo>
                  <a:lnTo>
                    <a:pt x="153885" y="408368"/>
                  </a:lnTo>
                  <a:lnTo>
                    <a:pt x="153885" y="409892"/>
                  </a:lnTo>
                  <a:lnTo>
                    <a:pt x="152361" y="411429"/>
                  </a:lnTo>
                  <a:lnTo>
                    <a:pt x="152361" y="412953"/>
                  </a:lnTo>
                  <a:lnTo>
                    <a:pt x="150837" y="414477"/>
                  </a:lnTo>
                  <a:lnTo>
                    <a:pt x="150837" y="415988"/>
                  </a:lnTo>
                  <a:lnTo>
                    <a:pt x="149313" y="417512"/>
                  </a:lnTo>
                  <a:lnTo>
                    <a:pt x="149313" y="419036"/>
                  </a:lnTo>
                  <a:lnTo>
                    <a:pt x="149313" y="420560"/>
                  </a:lnTo>
                  <a:lnTo>
                    <a:pt x="147789" y="422084"/>
                  </a:lnTo>
                  <a:lnTo>
                    <a:pt x="147789" y="423621"/>
                  </a:lnTo>
                  <a:lnTo>
                    <a:pt x="147789" y="425145"/>
                  </a:lnTo>
                  <a:lnTo>
                    <a:pt x="146278" y="425145"/>
                  </a:lnTo>
                  <a:lnTo>
                    <a:pt x="146278" y="426656"/>
                  </a:lnTo>
                  <a:lnTo>
                    <a:pt x="144741" y="428180"/>
                  </a:lnTo>
                  <a:lnTo>
                    <a:pt x="144741" y="429704"/>
                  </a:lnTo>
                  <a:lnTo>
                    <a:pt x="144741" y="431228"/>
                  </a:lnTo>
                  <a:lnTo>
                    <a:pt x="143217" y="432752"/>
                  </a:lnTo>
                  <a:lnTo>
                    <a:pt x="143217" y="434276"/>
                  </a:lnTo>
                  <a:lnTo>
                    <a:pt x="143217" y="435813"/>
                  </a:lnTo>
                  <a:lnTo>
                    <a:pt x="141693" y="435813"/>
                  </a:lnTo>
                  <a:lnTo>
                    <a:pt x="141693" y="437324"/>
                  </a:lnTo>
                  <a:lnTo>
                    <a:pt x="141693" y="438848"/>
                  </a:lnTo>
                  <a:lnTo>
                    <a:pt x="140169" y="440372"/>
                  </a:lnTo>
                  <a:lnTo>
                    <a:pt x="140169" y="441896"/>
                  </a:lnTo>
                  <a:lnTo>
                    <a:pt x="138645" y="443420"/>
                  </a:lnTo>
                  <a:lnTo>
                    <a:pt x="138645" y="444944"/>
                  </a:lnTo>
                  <a:lnTo>
                    <a:pt x="138645" y="446468"/>
                  </a:lnTo>
                  <a:lnTo>
                    <a:pt x="137121" y="447992"/>
                  </a:lnTo>
                  <a:lnTo>
                    <a:pt x="137121" y="449516"/>
                  </a:lnTo>
                  <a:lnTo>
                    <a:pt x="137121" y="451040"/>
                  </a:lnTo>
                  <a:lnTo>
                    <a:pt x="135610" y="452564"/>
                  </a:lnTo>
                  <a:lnTo>
                    <a:pt x="135610" y="454088"/>
                  </a:lnTo>
                  <a:lnTo>
                    <a:pt x="134086" y="455612"/>
                  </a:lnTo>
                  <a:lnTo>
                    <a:pt x="134086" y="457136"/>
                  </a:lnTo>
                  <a:lnTo>
                    <a:pt x="134086" y="458660"/>
                  </a:lnTo>
                  <a:lnTo>
                    <a:pt x="132549" y="460171"/>
                  </a:lnTo>
                  <a:lnTo>
                    <a:pt x="132549" y="461708"/>
                  </a:lnTo>
                  <a:lnTo>
                    <a:pt x="132549" y="463232"/>
                  </a:lnTo>
                  <a:lnTo>
                    <a:pt x="132549" y="464756"/>
                  </a:lnTo>
                  <a:lnTo>
                    <a:pt x="131025" y="464756"/>
                  </a:lnTo>
                  <a:lnTo>
                    <a:pt x="131025" y="466280"/>
                  </a:lnTo>
                  <a:lnTo>
                    <a:pt x="131025" y="467804"/>
                  </a:lnTo>
                  <a:lnTo>
                    <a:pt x="129501" y="467804"/>
                  </a:lnTo>
                  <a:lnTo>
                    <a:pt x="129501" y="469328"/>
                  </a:lnTo>
                  <a:lnTo>
                    <a:pt x="129501" y="470839"/>
                  </a:lnTo>
                  <a:lnTo>
                    <a:pt x="129501" y="472363"/>
                  </a:lnTo>
                  <a:lnTo>
                    <a:pt x="127977" y="473900"/>
                  </a:lnTo>
                  <a:lnTo>
                    <a:pt x="127977" y="475424"/>
                  </a:lnTo>
                  <a:lnTo>
                    <a:pt x="127977" y="476948"/>
                  </a:lnTo>
                  <a:lnTo>
                    <a:pt x="127977" y="478472"/>
                  </a:lnTo>
                  <a:lnTo>
                    <a:pt x="126453" y="479996"/>
                  </a:lnTo>
                  <a:lnTo>
                    <a:pt x="126453" y="481507"/>
                  </a:lnTo>
                  <a:lnTo>
                    <a:pt x="126453" y="483031"/>
                  </a:lnTo>
                  <a:lnTo>
                    <a:pt x="126453" y="484555"/>
                  </a:lnTo>
                  <a:lnTo>
                    <a:pt x="124942" y="486092"/>
                  </a:lnTo>
                  <a:lnTo>
                    <a:pt x="124942" y="487616"/>
                  </a:lnTo>
                  <a:lnTo>
                    <a:pt x="124942" y="489140"/>
                  </a:lnTo>
                  <a:lnTo>
                    <a:pt x="123418" y="490664"/>
                  </a:lnTo>
                  <a:lnTo>
                    <a:pt x="123418" y="492188"/>
                  </a:lnTo>
                  <a:lnTo>
                    <a:pt x="123418" y="493699"/>
                  </a:lnTo>
                  <a:lnTo>
                    <a:pt x="123418" y="495223"/>
                  </a:lnTo>
                  <a:lnTo>
                    <a:pt x="121894" y="496747"/>
                  </a:lnTo>
                  <a:lnTo>
                    <a:pt x="121894" y="504367"/>
                  </a:lnTo>
                  <a:lnTo>
                    <a:pt x="120370" y="504367"/>
                  </a:lnTo>
                  <a:lnTo>
                    <a:pt x="120370" y="505891"/>
                  </a:lnTo>
                  <a:lnTo>
                    <a:pt x="120370" y="507415"/>
                  </a:lnTo>
                  <a:lnTo>
                    <a:pt x="120370" y="508939"/>
                  </a:lnTo>
                  <a:lnTo>
                    <a:pt x="118833" y="510463"/>
                  </a:lnTo>
                  <a:lnTo>
                    <a:pt x="118833" y="512000"/>
                  </a:lnTo>
                  <a:lnTo>
                    <a:pt x="118833" y="513524"/>
                  </a:lnTo>
                  <a:lnTo>
                    <a:pt x="118833" y="515035"/>
                  </a:lnTo>
                  <a:lnTo>
                    <a:pt x="118833" y="516559"/>
                  </a:lnTo>
                  <a:lnTo>
                    <a:pt x="117309" y="516559"/>
                  </a:lnTo>
                  <a:lnTo>
                    <a:pt x="117309" y="524192"/>
                  </a:lnTo>
                  <a:lnTo>
                    <a:pt x="115785" y="525703"/>
                  </a:lnTo>
                  <a:lnTo>
                    <a:pt x="115785" y="527227"/>
                  </a:lnTo>
                  <a:lnTo>
                    <a:pt x="115785" y="528751"/>
                  </a:lnTo>
                  <a:lnTo>
                    <a:pt x="115785" y="530275"/>
                  </a:lnTo>
                  <a:lnTo>
                    <a:pt x="114274" y="530275"/>
                  </a:lnTo>
                  <a:lnTo>
                    <a:pt x="88366" y="530275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5391835" y="5877175"/>
              <a:ext cx="340360" cy="762000"/>
            </a:xfrm>
            <a:custGeom>
              <a:avLst/>
              <a:gdLst/>
              <a:ahLst/>
              <a:cxnLst/>
              <a:rect l="l" t="t" r="r" b="b"/>
              <a:pathLst>
                <a:path w="340360" h="762000">
                  <a:moveTo>
                    <a:pt x="170637" y="0"/>
                  </a:moveTo>
                  <a:lnTo>
                    <a:pt x="169113" y="0"/>
                  </a:lnTo>
                  <a:lnTo>
                    <a:pt x="167601" y="1523"/>
                  </a:lnTo>
                  <a:lnTo>
                    <a:pt x="167601" y="35051"/>
                  </a:lnTo>
                  <a:lnTo>
                    <a:pt x="166077" y="36575"/>
                  </a:lnTo>
                  <a:lnTo>
                    <a:pt x="166077" y="51815"/>
                  </a:lnTo>
                  <a:lnTo>
                    <a:pt x="164553" y="53327"/>
                  </a:lnTo>
                  <a:lnTo>
                    <a:pt x="164553" y="57899"/>
                  </a:lnTo>
                  <a:lnTo>
                    <a:pt x="163029" y="59423"/>
                  </a:lnTo>
                  <a:lnTo>
                    <a:pt x="163029" y="67043"/>
                  </a:lnTo>
                  <a:lnTo>
                    <a:pt x="161505" y="68567"/>
                  </a:lnTo>
                  <a:lnTo>
                    <a:pt x="161505" y="71615"/>
                  </a:lnTo>
                  <a:lnTo>
                    <a:pt x="159969" y="73151"/>
                  </a:lnTo>
                  <a:lnTo>
                    <a:pt x="159969" y="76187"/>
                  </a:lnTo>
                  <a:lnTo>
                    <a:pt x="158457" y="77711"/>
                  </a:lnTo>
                  <a:lnTo>
                    <a:pt x="158457" y="79235"/>
                  </a:lnTo>
                  <a:lnTo>
                    <a:pt x="156933" y="80759"/>
                  </a:lnTo>
                  <a:lnTo>
                    <a:pt x="156933" y="82283"/>
                  </a:lnTo>
                  <a:lnTo>
                    <a:pt x="155409" y="83807"/>
                  </a:lnTo>
                  <a:lnTo>
                    <a:pt x="155409" y="85343"/>
                  </a:lnTo>
                  <a:lnTo>
                    <a:pt x="152361" y="88379"/>
                  </a:lnTo>
                  <a:lnTo>
                    <a:pt x="152361" y="89903"/>
                  </a:lnTo>
                  <a:lnTo>
                    <a:pt x="150837" y="91427"/>
                  </a:lnTo>
                  <a:lnTo>
                    <a:pt x="150837" y="92951"/>
                  </a:lnTo>
                  <a:lnTo>
                    <a:pt x="144741" y="99047"/>
                  </a:lnTo>
                  <a:lnTo>
                    <a:pt x="144741" y="100571"/>
                  </a:lnTo>
                  <a:lnTo>
                    <a:pt x="141693" y="102095"/>
                  </a:lnTo>
                  <a:lnTo>
                    <a:pt x="141693" y="103619"/>
                  </a:lnTo>
                  <a:lnTo>
                    <a:pt x="131025" y="114287"/>
                  </a:lnTo>
                  <a:lnTo>
                    <a:pt x="129501" y="114287"/>
                  </a:lnTo>
                  <a:lnTo>
                    <a:pt x="124942" y="118846"/>
                  </a:lnTo>
                  <a:lnTo>
                    <a:pt x="123418" y="118846"/>
                  </a:lnTo>
                  <a:lnTo>
                    <a:pt x="118833" y="123431"/>
                  </a:lnTo>
                  <a:lnTo>
                    <a:pt x="117322" y="123431"/>
                  </a:lnTo>
                  <a:lnTo>
                    <a:pt x="112750" y="128003"/>
                  </a:lnTo>
                  <a:lnTo>
                    <a:pt x="109689" y="128003"/>
                  </a:lnTo>
                  <a:lnTo>
                    <a:pt x="106654" y="129527"/>
                  </a:lnTo>
                  <a:lnTo>
                    <a:pt x="105130" y="131038"/>
                  </a:lnTo>
                  <a:lnTo>
                    <a:pt x="102082" y="132562"/>
                  </a:lnTo>
                  <a:lnTo>
                    <a:pt x="100558" y="134086"/>
                  </a:lnTo>
                  <a:lnTo>
                    <a:pt x="94462" y="137147"/>
                  </a:lnTo>
                  <a:lnTo>
                    <a:pt x="92938" y="138671"/>
                  </a:lnTo>
                  <a:lnTo>
                    <a:pt x="80746" y="144754"/>
                  </a:lnTo>
                  <a:lnTo>
                    <a:pt x="79222" y="146278"/>
                  </a:lnTo>
                  <a:lnTo>
                    <a:pt x="70078" y="150863"/>
                  </a:lnTo>
                  <a:lnTo>
                    <a:pt x="68554" y="152374"/>
                  </a:lnTo>
                  <a:lnTo>
                    <a:pt x="63995" y="153898"/>
                  </a:lnTo>
                  <a:lnTo>
                    <a:pt x="60947" y="155422"/>
                  </a:lnTo>
                  <a:lnTo>
                    <a:pt x="59410" y="156946"/>
                  </a:lnTo>
                  <a:lnTo>
                    <a:pt x="25895" y="173710"/>
                  </a:lnTo>
                  <a:lnTo>
                    <a:pt x="24384" y="175234"/>
                  </a:lnTo>
                  <a:lnTo>
                    <a:pt x="15227" y="179806"/>
                  </a:lnTo>
                  <a:lnTo>
                    <a:pt x="12192" y="182854"/>
                  </a:lnTo>
                  <a:lnTo>
                    <a:pt x="9131" y="184378"/>
                  </a:lnTo>
                  <a:lnTo>
                    <a:pt x="7607" y="184378"/>
                  </a:lnTo>
                  <a:lnTo>
                    <a:pt x="6083" y="187426"/>
                  </a:lnTo>
                  <a:lnTo>
                    <a:pt x="4559" y="188950"/>
                  </a:lnTo>
                  <a:lnTo>
                    <a:pt x="3048" y="188950"/>
                  </a:lnTo>
                  <a:lnTo>
                    <a:pt x="3048" y="191998"/>
                  </a:lnTo>
                  <a:lnTo>
                    <a:pt x="1524" y="193522"/>
                  </a:lnTo>
                  <a:lnTo>
                    <a:pt x="0" y="193522"/>
                  </a:lnTo>
                  <a:lnTo>
                    <a:pt x="0" y="204190"/>
                  </a:lnTo>
                  <a:lnTo>
                    <a:pt x="1524" y="205714"/>
                  </a:lnTo>
                  <a:lnTo>
                    <a:pt x="1524" y="207225"/>
                  </a:lnTo>
                  <a:lnTo>
                    <a:pt x="3048" y="208749"/>
                  </a:lnTo>
                  <a:lnTo>
                    <a:pt x="3048" y="210273"/>
                  </a:lnTo>
                  <a:lnTo>
                    <a:pt x="4559" y="211810"/>
                  </a:lnTo>
                  <a:lnTo>
                    <a:pt x="4559" y="213334"/>
                  </a:lnTo>
                  <a:lnTo>
                    <a:pt x="7607" y="216382"/>
                  </a:lnTo>
                  <a:lnTo>
                    <a:pt x="7607" y="217893"/>
                  </a:lnTo>
                  <a:lnTo>
                    <a:pt x="9131" y="219417"/>
                  </a:lnTo>
                  <a:lnTo>
                    <a:pt x="9131" y="220941"/>
                  </a:lnTo>
                  <a:lnTo>
                    <a:pt x="13716" y="225526"/>
                  </a:lnTo>
                  <a:lnTo>
                    <a:pt x="13716" y="227050"/>
                  </a:lnTo>
                  <a:lnTo>
                    <a:pt x="15227" y="228561"/>
                  </a:lnTo>
                  <a:lnTo>
                    <a:pt x="15227" y="230085"/>
                  </a:lnTo>
                  <a:lnTo>
                    <a:pt x="19799" y="234657"/>
                  </a:lnTo>
                  <a:lnTo>
                    <a:pt x="19799" y="236181"/>
                  </a:lnTo>
                  <a:lnTo>
                    <a:pt x="27419" y="243801"/>
                  </a:lnTo>
                  <a:lnTo>
                    <a:pt x="27419" y="245325"/>
                  </a:lnTo>
                  <a:lnTo>
                    <a:pt x="33515" y="251421"/>
                  </a:lnTo>
                  <a:lnTo>
                    <a:pt x="33515" y="252945"/>
                  </a:lnTo>
                  <a:lnTo>
                    <a:pt x="39611" y="259041"/>
                  </a:lnTo>
                  <a:lnTo>
                    <a:pt x="41135" y="259041"/>
                  </a:lnTo>
                  <a:lnTo>
                    <a:pt x="42659" y="262089"/>
                  </a:lnTo>
                  <a:lnTo>
                    <a:pt x="45694" y="265137"/>
                  </a:lnTo>
                  <a:lnTo>
                    <a:pt x="47218" y="268185"/>
                  </a:lnTo>
                  <a:lnTo>
                    <a:pt x="48755" y="268185"/>
                  </a:lnTo>
                  <a:lnTo>
                    <a:pt x="50279" y="269709"/>
                  </a:lnTo>
                  <a:lnTo>
                    <a:pt x="51803" y="272745"/>
                  </a:lnTo>
                  <a:lnTo>
                    <a:pt x="53327" y="272745"/>
                  </a:lnTo>
                  <a:lnTo>
                    <a:pt x="54851" y="274269"/>
                  </a:lnTo>
                  <a:lnTo>
                    <a:pt x="56362" y="277329"/>
                  </a:lnTo>
                  <a:lnTo>
                    <a:pt x="57886" y="277329"/>
                  </a:lnTo>
                  <a:lnTo>
                    <a:pt x="91414" y="310845"/>
                  </a:lnTo>
                  <a:lnTo>
                    <a:pt x="91414" y="312369"/>
                  </a:lnTo>
                  <a:lnTo>
                    <a:pt x="95986" y="316941"/>
                  </a:lnTo>
                  <a:lnTo>
                    <a:pt x="95986" y="318465"/>
                  </a:lnTo>
                  <a:lnTo>
                    <a:pt x="100558" y="323037"/>
                  </a:lnTo>
                  <a:lnTo>
                    <a:pt x="100558" y="324561"/>
                  </a:lnTo>
                  <a:lnTo>
                    <a:pt x="102082" y="326097"/>
                  </a:lnTo>
                  <a:lnTo>
                    <a:pt x="102082" y="327609"/>
                  </a:lnTo>
                  <a:lnTo>
                    <a:pt x="105130" y="330657"/>
                  </a:lnTo>
                  <a:lnTo>
                    <a:pt x="106654" y="333705"/>
                  </a:lnTo>
                  <a:lnTo>
                    <a:pt x="106654" y="335229"/>
                  </a:lnTo>
                  <a:lnTo>
                    <a:pt x="108165" y="335229"/>
                  </a:lnTo>
                  <a:lnTo>
                    <a:pt x="109689" y="338277"/>
                  </a:lnTo>
                  <a:lnTo>
                    <a:pt x="111226" y="339801"/>
                  </a:lnTo>
                  <a:lnTo>
                    <a:pt x="111226" y="342849"/>
                  </a:lnTo>
                  <a:lnTo>
                    <a:pt x="112750" y="342849"/>
                  </a:lnTo>
                  <a:lnTo>
                    <a:pt x="114274" y="344373"/>
                  </a:lnTo>
                  <a:lnTo>
                    <a:pt x="115798" y="347421"/>
                  </a:lnTo>
                  <a:lnTo>
                    <a:pt x="117322" y="348945"/>
                  </a:lnTo>
                  <a:lnTo>
                    <a:pt x="117322" y="350456"/>
                  </a:lnTo>
                  <a:lnTo>
                    <a:pt x="120357" y="353517"/>
                  </a:lnTo>
                  <a:lnTo>
                    <a:pt x="120357" y="355041"/>
                  </a:lnTo>
                  <a:lnTo>
                    <a:pt x="121881" y="356565"/>
                  </a:lnTo>
                  <a:lnTo>
                    <a:pt x="121881" y="358089"/>
                  </a:lnTo>
                  <a:lnTo>
                    <a:pt x="124942" y="361124"/>
                  </a:lnTo>
                  <a:lnTo>
                    <a:pt x="124942" y="362648"/>
                  </a:lnTo>
                  <a:lnTo>
                    <a:pt x="126466" y="364185"/>
                  </a:lnTo>
                  <a:lnTo>
                    <a:pt x="126466" y="365709"/>
                  </a:lnTo>
                  <a:lnTo>
                    <a:pt x="127990" y="367233"/>
                  </a:lnTo>
                  <a:lnTo>
                    <a:pt x="127990" y="368757"/>
                  </a:lnTo>
                  <a:lnTo>
                    <a:pt x="129501" y="370281"/>
                  </a:lnTo>
                  <a:lnTo>
                    <a:pt x="129501" y="371792"/>
                  </a:lnTo>
                  <a:lnTo>
                    <a:pt x="131025" y="373316"/>
                  </a:lnTo>
                  <a:lnTo>
                    <a:pt x="131025" y="376377"/>
                  </a:lnTo>
                  <a:lnTo>
                    <a:pt x="132549" y="377901"/>
                  </a:lnTo>
                  <a:lnTo>
                    <a:pt x="132549" y="380949"/>
                  </a:lnTo>
                  <a:lnTo>
                    <a:pt x="135597" y="383984"/>
                  </a:lnTo>
                  <a:lnTo>
                    <a:pt x="135597" y="387032"/>
                  </a:lnTo>
                  <a:lnTo>
                    <a:pt x="137134" y="388556"/>
                  </a:lnTo>
                  <a:lnTo>
                    <a:pt x="137134" y="391617"/>
                  </a:lnTo>
                  <a:lnTo>
                    <a:pt x="138645" y="393141"/>
                  </a:lnTo>
                  <a:lnTo>
                    <a:pt x="138645" y="394652"/>
                  </a:lnTo>
                  <a:lnTo>
                    <a:pt x="140169" y="396176"/>
                  </a:lnTo>
                  <a:lnTo>
                    <a:pt x="140169" y="397700"/>
                  </a:lnTo>
                  <a:lnTo>
                    <a:pt x="141693" y="399224"/>
                  </a:lnTo>
                  <a:lnTo>
                    <a:pt x="141693" y="400748"/>
                  </a:lnTo>
                  <a:lnTo>
                    <a:pt x="143217" y="403809"/>
                  </a:lnTo>
                  <a:lnTo>
                    <a:pt x="143217" y="405320"/>
                  </a:lnTo>
                  <a:lnTo>
                    <a:pt x="144741" y="405320"/>
                  </a:lnTo>
                  <a:lnTo>
                    <a:pt x="144741" y="409892"/>
                  </a:lnTo>
                  <a:lnTo>
                    <a:pt x="146265" y="409892"/>
                  </a:lnTo>
                  <a:lnTo>
                    <a:pt x="146265" y="414477"/>
                  </a:lnTo>
                  <a:lnTo>
                    <a:pt x="147789" y="415988"/>
                  </a:lnTo>
                  <a:lnTo>
                    <a:pt x="147789" y="423608"/>
                  </a:lnTo>
                  <a:lnTo>
                    <a:pt x="149313" y="425132"/>
                  </a:lnTo>
                  <a:lnTo>
                    <a:pt x="149313" y="429704"/>
                  </a:lnTo>
                  <a:lnTo>
                    <a:pt x="150837" y="431228"/>
                  </a:lnTo>
                  <a:lnTo>
                    <a:pt x="150837" y="441896"/>
                  </a:lnTo>
                  <a:lnTo>
                    <a:pt x="152361" y="443420"/>
                  </a:lnTo>
                  <a:lnTo>
                    <a:pt x="152361" y="472363"/>
                  </a:lnTo>
                  <a:lnTo>
                    <a:pt x="153885" y="473887"/>
                  </a:lnTo>
                  <a:lnTo>
                    <a:pt x="153885" y="489127"/>
                  </a:lnTo>
                  <a:lnTo>
                    <a:pt x="155409" y="490664"/>
                  </a:lnTo>
                  <a:lnTo>
                    <a:pt x="155409" y="507415"/>
                  </a:lnTo>
                  <a:lnTo>
                    <a:pt x="156933" y="508939"/>
                  </a:lnTo>
                  <a:lnTo>
                    <a:pt x="156933" y="518083"/>
                  </a:lnTo>
                  <a:lnTo>
                    <a:pt x="158457" y="519607"/>
                  </a:lnTo>
                  <a:lnTo>
                    <a:pt x="158457" y="522655"/>
                  </a:lnTo>
                  <a:lnTo>
                    <a:pt x="159969" y="524179"/>
                  </a:lnTo>
                  <a:lnTo>
                    <a:pt x="159969" y="533323"/>
                  </a:lnTo>
                  <a:lnTo>
                    <a:pt x="161505" y="534847"/>
                  </a:lnTo>
                  <a:lnTo>
                    <a:pt x="161505" y="569887"/>
                  </a:lnTo>
                  <a:lnTo>
                    <a:pt x="163029" y="571411"/>
                  </a:lnTo>
                  <a:lnTo>
                    <a:pt x="163029" y="583603"/>
                  </a:lnTo>
                  <a:lnTo>
                    <a:pt x="164553" y="585127"/>
                  </a:lnTo>
                  <a:lnTo>
                    <a:pt x="164553" y="612559"/>
                  </a:lnTo>
                  <a:lnTo>
                    <a:pt x="166077" y="614070"/>
                  </a:lnTo>
                  <a:lnTo>
                    <a:pt x="166077" y="703973"/>
                  </a:lnTo>
                  <a:lnTo>
                    <a:pt x="167601" y="705510"/>
                  </a:lnTo>
                  <a:lnTo>
                    <a:pt x="167601" y="732942"/>
                  </a:lnTo>
                  <a:lnTo>
                    <a:pt x="166077" y="734453"/>
                  </a:lnTo>
                  <a:lnTo>
                    <a:pt x="166077" y="745121"/>
                  </a:lnTo>
                  <a:lnTo>
                    <a:pt x="167601" y="746645"/>
                  </a:lnTo>
                  <a:lnTo>
                    <a:pt x="167601" y="761885"/>
                  </a:lnTo>
                  <a:lnTo>
                    <a:pt x="172161" y="761885"/>
                  </a:lnTo>
                  <a:lnTo>
                    <a:pt x="172161" y="667410"/>
                  </a:lnTo>
                  <a:lnTo>
                    <a:pt x="173685" y="665886"/>
                  </a:lnTo>
                  <a:lnTo>
                    <a:pt x="173685" y="595795"/>
                  </a:lnTo>
                  <a:lnTo>
                    <a:pt x="175221" y="594271"/>
                  </a:lnTo>
                  <a:lnTo>
                    <a:pt x="175221" y="579043"/>
                  </a:lnTo>
                  <a:lnTo>
                    <a:pt x="176745" y="577507"/>
                  </a:lnTo>
                  <a:lnTo>
                    <a:pt x="176745" y="559219"/>
                  </a:lnTo>
                  <a:lnTo>
                    <a:pt x="178269" y="556183"/>
                  </a:lnTo>
                  <a:lnTo>
                    <a:pt x="178269" y="554659"/>
                  </a:lnTo>
                  <a:lnTo>
                    <a:pt x="176745" y="551599"/>
                  </a:lnTo>
                  <a:lnTo>
                    <a:pt x="176745" y="545515"/>
                  </a:lnTo>
                  <a:lnTo>
                    <a:pt x="178269" y="543991"/>
                  </a:lnTo>
                  <a:lnTo>
                    <a:pt x="178269" y="530275"/>
                  </a:lnTo>
                  <a:lnTo>
                    <a:pt x="179781" y="528751"/>
                  </a:lnTo>
                  <a:lnTo>
                    <a:pt x="179781" y="524179"/>
                  </a:lnTo>
                  <a:lnTo>
                    <a:pt x="181305" y="522655"/>
                  </a:lnTo>
                  <a:lnTo>
                    <a:pt x="181305" y="515035"/>
                  </a:lnTo>
                  <a:lnTo>
                    <a:pt x="182829" y="513511"/>
                  </a:lnTo>
                  <a:lnTo>
                    <a:pt x="182829" y="501319"/>
                  </a:lnTo>
                  <a:lnTo>
                    <a:pt x="184353" y="499795"/>
                  </a:lnTo>
                  <a:lnTo>
                    <a:pt x="184353" y="487603"/>
                  </a:lnTo>
                  <a:lnTo>
                    <a:pt x="185877" y="486079"/>
                  </a:lnTo>
                  <a:lnTo>
                    <a:pt x="185877" y="451027"/>
                  </a:lnTo>
                  <a:lnTo>
                    <a:pt x="187413" y="449503"/>
                  </a:lnTo>
                  <a:lnTo>
                    <a:pt x="187413" y="437311"/>
                  </a:lnTo>
                  <a:lnTo>
                    <a:pt x="188937" y="435800"/>
                  </a:lnTo>
                  <a:lnTo>
                    <a:pt x="188937" y="429704"/>
                  </a:lnTo>
                  <a:lnTo>
                    <a:pt x="190449" y="428180"/>
                  </a:lnTo>
                  <a:lnTo>
                    <a:pt x="190449" y="420560"/>
                  </a:lnTo>
                  <a:lnTo>
                    <a:pt x="191973" y="419036"/>
                  </a:lnTo>
                  <a:lnTo>
                    <a:pt x="191973" y="412940"/>
                  </a:lnTo>
                  <a:lnTo>
                    <a:pt x="193497" y="412940"/>
                  </a:lnTo>
                  <a:lnTo>
                    <a:pt x="193497" y="409892"/>
                  </a:lnTo>
                  <a:lnTo>
                    <a:pt x="195021" y="408368"/>
                  </a:lnTo>
                  <a:lnTo>
                    <a:pt x="195021" y="405320"/>
                  </a:lnTo>
                  <a:lnTo>
                    <a:pt x="196545" y="403809"/>
                  </a:lnTo>
                  <a:lnTo>
                    <a:pt x="196545" y="400748"/>
                  </a:lnTo>
                  <a:lnTo>
                    <a:pt x="198069" y="400748"/>
                  </a:lnTo>
                  <a:lnTo>
                    <a:pt x="198069" y="397700"/>
                  </a:lnTo>
                  <a:lnTo>
                    <a:pt x="199605" y="396176"/>
                  </a:lnTo>
                  <a:lnTo>
                    <a:pt x="199605" y="394652"/>
                  </a:lnTo>
                  <a:lnTo>
                    <a:pt x="201117" y="393141"/>
                  </a:lnTo>
                  <a:lnTo>
                    <a:pt x="201117" y="391617"/>
                  </a:lnTo>
                  <a:lnTo>
                    <a:pt x="202641" y="390093"/>
                  </a:lnTo>
                  <a:lnTo>
                    <a:pt x="202641" y="387032"/>
                  </a:lnTo>
                  <a:lnTo>
                    <a:pt x="204165" y="385508"/>
                  </a:lnTo>
                  <a:lnTo>
                    <a:pt x="204165" y="383984"/>
                  </a:lnTo>
                  <a:lnTo>
                    <a:pt x="205689" y="382460"/>
                  </a:lnTo>
                  <a:lnTo>
                    <a:pt x="205689" y="379425"/>
                  </a:lnTo>
                  <a:lnTo>
                    <a:pt x="207213" y="377901"/>
                  </a:lnTo>
                  <a:lnTo>
                    <a:pt x="207213" y="376377"/>
                  </a:lnTo>
                  <a:lnTo>
                    <a:pt x="208737" y="374840"/>
                  </a:lnTo>
                  <a:lnTo>
                    <a:pt x="208737" y="371792"/>
                  </a:lnTo>
                  <a:lnTo>
                    <a:pt x="211785" y="368757"/>
                  </a:lnTo>
                  <a:lnTo>
                    <a:pt x="211785" y="365709"/>
                  </a:lnTo>
                  <a:lnTo>
                    <a:pt x="213309" y="364185"/>
                  </a:lnTo>
                  <a:lnTo>
                    <a:pt x="213309" y="362648"/>
                  </a:lnTo>
                  <a:lnTo>
                    <a:pt x="216357" y="359613"/>
                  </a:lnTo>
                  <a:lnTo>
                    <a:pt x="216357" y="358089"/>
                  </a:lnTo>
                  <a:lnTo>
                    <a:pt x="217881" y="356565"/>
                  </a:lnTo>
                  <a:lnTo>
                    <a:pt x="217881" y="355041"/>
                  </a:lnTo>
                  <a:lnTo>
                    <a:pt x="219405" y="353517"/>
                  </a:lnTo>
                  <a:lnTo>
                    <a:pt x="219405" y="351993"/>
                  </a:lnTo>
                  <a:lnTo>
                    <a:pt x="222440" y="348945"/>
                  </a:lnTo>
                  <a:lnTo>
                    <a:pt x="222440" y="347421"/>
                  </a:lnTo>
                  <a:lnTo>
                    <a:pt x="223964" y="347421"/>
                  </a:lnTo>
                  <a:lnTo>
                    <a:pt x="225501" y="344373"/>
                  </a:lnTo>
                  <a:lnTo>
                    <a:pt x="225501" y="342849"/>
                  </a:lnTo>
                  <a:lnTo>
                    <a:pt x="227025" y="342849"/>
                  </a:lnTo>
                  <a:lnTo>
                    <a:pt x="228549" y="339801"/>
                  </a:lnTo>
                  <a:lnTo>
                    <a:pt x="228549" y="338277"/>
                  </a:lnTo>
                  <a:lnTo>
                    <a:pt x="230073" y="338277"/>
                  </a:lnTo>
                  <a:lnTo>
                    <a:pt x="231584" y="335229"/>
                  </a:lnTo>
                  <a:lnTo>
                    <a:pt x="233108" y="333705"/>
                  </a:lnTo>
                  <a:lnTo>
                    <a:pt x="233108" y="330657"/>
                  </a:lnTo>
                  <a:lnTo>
                    <a:pt x="234632" y="330657"/>
                  </a:lnTo>
                  <a:lnTo>
                    <a:pt x="234632" y="329133"/>
                  </a:lnTo>
                  <a:lnTo>
                    <a:pt x="237693" y="326097"/>
                  </a:lnTo>
                  <a:lnTo>
                    <a:pt x="237693" y="324561"/>
                  </a:lnTo>
                  <a:lnTo>
                    <a:pt x="240741" y="321513"/>
                  </a:lnTo>
                  <a:lnTo>
                    <a:pt x="240741" y="319989"/>
                  </a:lnTo>
                  <a:lnTo>
                    <a:pt x="243776" y="316941"/>
                  </a:lnTo>
                  <a:lnTo>
                    <a:pt x="243776" y="315429"/>
                  </a:lnTo>
                  <a:lnTo>
                    <a:pt x="249885" y="309321"/>
                  </a:lnTo>
                  <a:lnTo>
                    <a:pt x="249885" y="307797"/>
                  </a:lnTo>
                  <a:lnTo>
                    <a:pt x="252920" y="306273"/>
                  </a:lnTo>
                  <a:lnTo>
                    <a:pt x="252920" y="304761"/>
                  </a:lnTo>
                  <a:lnTo>
                    <a:pt x="259016" y="298653"/>
                  </a:lnTo>
                  <a:lnTo>
                    <a:pt x="262064" y="297129"/>
                  </a:lnTo>
                  <a:lnTo>
                    <a:pt x="263588" y="295605"/>
                  </a:lnTo>
                  <a:lnTo>
                    <a:pt x="263588" y="294093"/>
                  </a:lnTo>
                  <a:lnTo>
                    <a:pt x="265112" y="292569"/>
                  </a:lnTo>
                  <a:lnTo>
                    <a:pt x="268160" y="291045"/>
                  </a:lnTo>
                  <a:lnTo>
                    <a:pt x="281876" y="277329"/>
                  </a:lnTo>
                  <a:lnTo>
                    <a:pt x="283387" y="277329"/>
                  </a:lnTo>
                  <a:lnTo>
                    <a:pt x="284911" y="274269"/>
                  </a:lnTo>
                  <a:lnTo>
                    <a:pt x="286435" y="272745"/>
                  </a:lnTo>
                  <a:lnTo>
                    <a:pt x="287972" y="272745"/>
                  </a:lnTo>
                  <a:lnTo>
                    <a:pt x="289496" y="269709"/>
                  </a:lnTo>
                  <a:lnTo>
                    <a:pt x="289496" y="268185"/>
                  </a:lnTo>
                  <a:lnTo>
                    <a:pt x="292544" y="268185"/>
                  </a:lnTo>
                  <a:lnTo>
                    <a:pt x="292544" y="265137"/>
                  </a:lnTo>
                  <a:lnTo>
                    <a:pt x="294055" y="263613"/>
                  </a:lnTo>
                  <a:lnTo>
                    <a:pt x="295579" y="263613"/>
                  </a:lnTo>
                  <a:lnTo>
                    <a:pt x="297103" y="262089"/>
                  </a:lnTo>
                  <a:lnTo>
                    <a:pt x="298627" y="259041"/>
                  </a:lnTo>
                  <a:lnTo>
                    <a:pt x="300164" y="259041"/>
                  </a:lnTo>
                  <a:lnTo>
                    <a:pt x="300164" y="257517"/>
                  </a:lnTo>
                  <a:lnTo>
                    <a:pt x="303212" y="255993"/>
                  </a:lnTo>
                  <a:lnTo>
                    <a:pt x="303212" y="254469"/>
                  </a:lnTo>
                  <a:lnTo>
                    <a:pt x="309295" y="248373"/>
                  </a:lnTo>
                  <a:lnTo>
                    <a:pt x="309295" y="246849"/>
                  </a:lnTo>
                  <a:lnTo>
                    <a:pt x="315391" y="240753"/>
                  </a:lnTo>
                  <a:lnTo>
                    <a:pt x="315391" y="239242"/>
                  </a:lnTo>
                  <a:lnTo>
                    <a:pt x="319963" y="234657"/>
                  </a:lnTo>
                  <a:lnTo>
                    <a:pt x="319963" y="233133"/>
                  </a:lnTo>
                  <a:lnTo>
                    <a:pt x="324535" y="228561"/>
                  </a:lnTo>
                  <a:lnTo>
                    <a:pt x="324535" y="227050"/>
                  </a:lnTo>
                  <a:lnTo>
                    <a:pt x="329107" y="222465"/>
                  </a:lnTo>
                  <a:lnTo>
                    <a:pt x="329107" y="220941"/>
                  </a:lnTo>
                  <a:lnTo>
                    <a:pt x="330631" y="219417"/>
                  </a:lnTo>
                  <a:lnTo>
                    <a:pt x="330631" y="217893"/>
                  </a:lnTo>
                  <a:lnTo>
                    <a:pt x="333679" y="214858"/>
                  </a:lnTo>
                  <a:lnTo>
                    <a:pt x="333679" y="213334"/>
                  </a:lnTo>
                  <a:lnTo>
                    <a:pt x="335191" y="211810"/>
                  </a:lnTo>
                  <a:lnTo>
                    <a:pt x="335191" y="210273"/>
                  </a:lnTo>
                  <a:lnTo>
                    <a:pt x="336715" y="208749"/>
                  </a:lnTo>
                  <a:lnTo>
                    <a:pt x="336715" y="207225"/>
                  </a:lnTo>
                  <a:lnTo>
                    <a:pt x="338251" y="205714"/>
                  </a:lnTo>
                  <a:lnTo>
                    <a:pt x="338251" y="202666"/>
                  </a:lnTo>
                  <a:lnTo>
                    <a:pt x="339775" y="202666"/>
                  </a:lnTo>
                  <a:lnTo>
                    <a:pt x="339775" y="198081"/>
                  </a:lnTo>
                  <a:lnTo>
                    <a:pt x="338251" y="195046"/>
                  </a:lnTo>
                  <a:lnTo>
                    <a:pt x="338251" y="193522"/>
                  </a:lnTo>
                  <a:lnTo>
                    <a:pt x="336715" y="193522"/>
                  </a:lnTo>
                  <a:lnTo>
                    <a:pt x="336715" y="191998"/>
                  </a:lnTo>
                  <a:lnTo>
                    <a:pt x="335191" y="188950"/>
                  </a:lnTo>
                  <a:lnTo>
                    <a:pt x="330631" y="184378"/>
                  </a:lnTo>
                  <a:lnTo>
                    <a:pt x="329107" y="184378"/>
                  </a:lnTo>
                  <a:lnTo>
                    <a:pt x="326059" y="181330"/>
                  </a:lnTo>
                  <a:lnTo>
                    <a:pt x="319963" y="178282"/>
                  </a:lnTo>
                  <a:lnTo>
                    <a:pt x="318439" y="176758"/>
                  </a:lnTo>
                  <a:lnTo>
                    <a:pt x="309295" y="172186"/>
                  </a:lnTo>
                  <a:lnTo>
                    <a:pt x="307771" y="170662"/>
                  </a:lnTo>
                  <a:lnTo>
                    <a:pt x="265112" y="149339"/>
                  </a:lnTo>
                  <a:lnTo>
                    <a:pt x="263588" y="147802"/>
                  </a:lnTo>
                  <a:lnTo>
                    <a:pt x="251409" y="141706"/>
                  </a:lnTo>
                  <a:lnTo>
                    <a:pt x="249885" y="140195"/>
                  </a:lnTo>
                  <a:lnTo>
                    <a:pt x="243776" y="137147"/>
                  </a:lnTo>
                  <a:lnTo>
                    <a:pt x="242252" y="135610"/>
                  </a:lnTo>
                  <a:lnTo>
                    <a:pt x="233108" y="131038"/>
                  </a:lnTo>
                  <a:lnTo>
                    <a:pt x="231584" y="129527"/>
                  </a:lnTo>
                  <a:lnTo>
                    <a:pt x="228549" y="128003"/>
                  </a:lnTo>
                  <a:lnTo>
                    <a:pt x="227025" y="128003"/>
                  </a:lnTo>
                  <a:lnTo>
                    <a:pt x="223964" y="126479"/>
                  </a:lnTo>
                  <a:lnTo>
                    <a:pt x="222440" y="123431"/>
                  </a:lnTo>
                  <a:lnTo>
                    <a:pt x="219405" y="123431"/>
                  </a:lnTo>
                  <a:lnTo>
                    <a:pt x="217881" y="121894"/>
                  </a:lnTo>
                  <a:lnTo>
                    <a:pt x="216357" y="118846"/>
                  </a:lnTo>
                  <a:lnTo>
                    <a:pt x="214833" y="118846"/>
                  </a:lnTo>
                  <a:lnTo>
                    <a:pt x="211785" y="117335"/>
                  </a:lnTo>
                  <a:lnTo>
                    <a:pt x="210261" y="114287"/>
                  </a:lnTo>
                  <a:lnTo>
                    <a:pt x="208737" y="114287"/>
                  </a:lnTo>
                  <a:lnTo>
                    <a:pt x="191973" y="97510"/>
                  </a:lnTo>
                  <a:lnTo>
                    <a:pt x="191973" y="95999"/>
                  </a:lnTo>
                  <a:lnTo>
                    <a:pt x="187413" y="91427"/>
                  </a:lnTo>
                  <a:lnTo>
                    <a:pt x="187413" y="89903"/>
                  </a:lnTo>
                  <a:lnTo>
                    <a:pt x="185877" y="88379"/>
                  </a:lnTo>
                  <a:lnTo>
                    <a:pt x="185877" y="86855"/>
                  </a:lnTo>
                  <a:lnTo>
                    <a:pt x="182829" y="83807"/>
                  </a:lnTo>
                  <a:lnTo>
                    <a:pt x="182829" y="82283"/>
                  </a:lnTo>
                  <a:lnTo>
                    <a:pt x="181305" y="80759"/>
                  </a:lnTo>
                  <a:lnTo>
                    <a:pt x="181305" y="79235"/>
                  </a:lnTo>
                  <a:lnTo>
                    <a:pt x="179781" y="77711"/>
                  </a:lnTo>
                  <a:lnTo>
                    <a:pt x="179781" y="76187"/>
                  </a:lnTo>
                  <a:lnTo>
                    <a:pt x="178269" y="74675"/>
                  </a:lnTo>
                  <a:lnTo>
                    <a:pt x="178269" y="71615"/>
                  </a:lnTo>
                  <a:lnTo>
                    <a:pt x="176745" y="70091"/>
                  </a:lnTo>
                  <a:lnTo>
                    <a:pt x="176745" y="64007"/>
                  </a:lnTo>
                  <a:lnTo>
                    <a:pt x="175221" y="62483"/>
                  </a:lnTo>
                  <a:lnTo>
                    <a:pt x="175221" y="56375"/>
                  </a:lnTo>
                  <a:lnTo>
                    <a:pt x="173685" y="53327"/>
                  </a:lnTo>
                  <a:lnTo>
                    <a:pt x="173685" y="44183"/>
                  </a:lnTo>
                  <a:lnTo>
                    <a:pt x="172161" y="44183"/>
                  </a:lnTo>
                  <a:lnTo>
                    <a:pt x="172161" y="19811"/>
                  </a:lnTo>
                  <a:lnTo>
                    <a:pt x="170637" y="18287"/>
                  </a:lnTo>
                  <a:lnTo>
                    <a:pt x="170637" y="0"/>
                  </a:lnTo>
                  <a:close/>
                </a:path>
              </a:pathLst>
            </a:custGeom>
            <a:solidFill>
              <a:srgbClr val="00BEC4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5391835" y="5877175"/>
              <a:ext cx="340360" cy="762000"/>
            </a:xfrm>
            <a:custGeom>
              <a:avLst/>
              <a:gdLst/>
              <a:ahLst/>
              <a:cxnLst/>
              <a:rect l="l" t="t" r="r" b="b"/>
              <a:pathLst>
                <a:path w="340360" h="762000">
                  <a:moveTo>
                    <a:pt x="167601" y="761885"/>
                  </a:moveTo>
                  <a:lnTo>
                    <a:pt x="167601" y="760361"/>
                  </a:lnTo>
                  <a:lnTo>
                    <a:pt x="167601" y="746645"/>
                  </a:lnTo>
                  <a:lnTo>
                    <a:pt x="166077" y="745121"/>
                  </a:lnTo>
                  <a:lnTo>
                    <a:pt x="166077" y="734453"/>
                  </a:lnTo>
                  <a:lnTo>
                    <a:pt x="167601" y="732942"/>
                  </a:lnTo>
                  <a:lnTo>
                    <a:pt x="167601" y="705510"/>
                  </a:lnTo>
                  <a:lnTo>
                    <a:pt x="166077" y="703973"/>
                  </a:lnTo>
                  <a:lnTo>
                    <a:pt x="166077" y="614070"/>
                  </a:lnTo>
                  <a:lnTo>
                    <a:pt x="164553" y="612559"/>
                  </a:lnTo>
                  <a:lnTo>
                    <a:pt x="164553" y="585127"/>
                  </a:lnTo>
                  <a:lnTo>
                    <a:pt x="163029" y="583603"/>
                  </a:lnTo>
                  <a:lnTo>
                    <a:pt x="163029" y="571411"/>
                  </a:lnTo>
                  <a:lnTo>
                    <a:pt x="161505" y="569887"/>
                  </a:lnTo>
                  <a:lnTo>
                    <a:pt x="161505" y="534847"/>
                  </a:lnTo>
                  <a:lnTo>
                    <a:pt x="159969" y="533323"/>
                  </a:lnTo>
                  <a:lnTo>
                    <a:pt x="159969" y="524179"/>
                  </a:lnTo>
                  <a:lnTo>
                    <a:pt x="158457" y="522655"/>
                  </a:lnTo>
                  <a:lnTo>
                    <a:pt x="158457" y="521131"/>
                  </a:lnTo>
                  <a:lnTo>
                    <a:pt x="158457" y="519607"/>
                  </a:lnTo>
                  <a:lnTo>
                    <a:pt x="156933" y="518083"/>
                  </a:lnTo>
                  <a:lnTo>
                    <a:pt x="156933" y="508939"/>
                  </a:lnTo>
                  <a:lnTo>
                    <a:pt x="155409" y="507415"/>
                  </a:lnTo>
                  <a:lnTo>
                    <a:pt x="155409" y="490664"/>
                  </a:lnTo>
                  <a:lnTo>
                    <a:pt x="153885" y="489127"/>
                  </a:lnTo>
                  <a:lnTo>
                    <a:pt x="153885" y="473887"/>
                  </a:lnTo>
                  <a:lnTo>
                    <a:pt x="152361" y="472363"/>
                  </a:lnTo>
                  <a:lnTo>
                    <a:pt x="152361" y="443420"/>
                  </a:lnTo>
                  <a:lnTo>
                    <a:pt x="150837" y="441896"/>
                  </a:lnTo>
                  <a:lnTo>
                    <a:pt x="150837" y="431228"/>
                  </a:lnTo>
                  <a:lnTo>
                    <a:pt x="149313" y="429704"/>
                  </a:lnTo>
                  <a:lnTo>
                    <a:pt x="149313" y="428180"/>
                  </a:lnTo>
                  <a:lnTo>
                    <a:pt x="149313" y="426656"/>
                  </a:lnTo>
                  <a:lnTo>
                    <a:pt x="149313" y="425132"/>
                  </a:lnTo>
                  <a:lnTo>
                    <a:pt x="147789" y="423608"/>
                  </a:lnTo>
                  <a:lnTo>
                    <a:pt x="147789" y="415988"/>
                  </a:lnTo>
                  <a:lnTo>
                    <a:pt x="146265" y="414477"/>
                  </a:lnTo>
                  <a:lnTo>
                    <a:pt x="146265" y="412940"/>
                  </a:lnTo>
                  <a:lnTo>
                    <a:pt x="146265" y="409892"/>
                  </a:lnTo>
                  <a:lnTo>
                    <a:pt x="144741" y="409892"/>
                  </a:lnTo>
                  <a:lnTo>
                    <a:pt x="144741" y="408368"/>
                  </a:lnTo>
                  <a:lnTo>
                    <a:pt x="144741" y="405320"/>
                  </a:lnTo>
                  <a:lnTo>
                    <a:pt x="143217" y="405320"/>
                  </a:lnTo>
                  <a:lnTo>
                    <a:pt x="143217" y="403809"/>
                  </a:lnTo>
                  <a:lnTo>
                    <a:pt x="141693" y="400748"/>
                  </a:lnTo>
                  <a:lnTo>
                    <a:pt x="141693" y="399224"/>
                  </a:lnTo>
                  <a:lnTo>
                    <a:pt x="140169" y="397700"/>
                  </a:lnTo>
                  <a:lnTo>
                    <a:pt x="140169" y="396176"/>
                  </a:lnTo>
                  <a:lnTo>
                    <a:pt x="138645" y="394652"/>
                  </a:lnTo>
                  <a:lnTo>
                    <a:pt x="138645" y="393141"/>
                  </a:lnTo>
                  <a:lnTo>
                    <a:pt x="137134" y="391617"/>
                  </a:lnTo>
                  <a:lnTo>
                    <a:pt x="137134" y="390093"/>
                  </a:lnTo>
                  <a:lnTo>
                    <a:pt x="137134" y="388556"/>
                  </a:lnTo>
                  <a:lnTo>
                    <a:pt x="135597" y="387032"/>
                  </a:lnTo>
                  <a:lnTo>
                    <a:pt x="135597" y="385508"/>
                  </a:lnTo>
                  <a:lnTo>
                    <a:pt x="135597" y="383984"/>
                  </a:lnTo>
                  <a:lnTo>
                    <a:pt x="134073" y="382460"/>
                  </a:lnTo>
                  <a:lnTo>
                    <a:pt x="132549" y="380949"/>
                  </a:lnTo>
                  <a:lnTo>
                    <a:pt x="132549" y="379425"/>
                  </a:lnTo>
                  <a:lnTo>
                    <a:pt x="132549" y="377901"/>
                  </a:lnTo>
                  <a:lnTo>
                    <a:pt x="131025" y="376377"/>
                  </a:lnTo>
                  <a:lnTo>
                    <a:pt x="131025" y="374840"/>
                  </a:lnTo>
                  <a:lnTo>
                    <a:pt x="131025" y="373316"/>
                  </a:lnTo>
                  <a:lnTo>
                    <a:pt x="129501" y="371792"/>
                  </a:lnTo>
                  <a:lnTo>
                    <a:pt x="129501" y="370281"/>
                  </a:lnTo>
                  <a:lnTo>
                    <a:pt x="127990" y="368757"/>
                  </a:lnTo>
                  <a:lnTo>
                    <a:pt x="127990" y="367233"/>
                  </a:lnTo>
                  <a:lnTo>
                    <a:pt x="126466" y="365709"/>
                  </a:lnTo>
                  <a:lnTo>
                    <a:pt x="126466" y="364185"/>
                  </a:lnTo>
                  <a:lnTo>
                    <a:pt x="124942" y="362648"/>
                  </a:lnTo>
                  <a:lnTo>
                    <a:pt x="124942" y="361124"/>
                  </a:lnTo>
                  <a:lnTo>
                    <a:pt x="123418" y="359613"/>
                  </a:lnTo>
                  <a:lnTo>
                    <a:pt x="121881" y="358089"/>
                  </a:lnTo>
                  <a:lnTo>
                    <a:pt x="121881" y="356565"/>
                  </a:lnTo>
                  <a:lnTo>
                    <a:pt x="120357" y="355041"/>
                  </a:lnTo>
                  <a:lnTo>
                    <a:pt x="120357" y="353517"/>
                  </a:lnTo>
                  <a:lnTo>
                    <a:pt x="118833" y="351993"/>
                  </a:lnTo>
                  <a:lnTo>
                    <a:pt x="117322" y="350456"/>
                  </a:lnTo>
                  <a:lnTo>
                    <a:pt x="117322" y="348945"/>
                  </a:lnTo>
                  <a:lnTo>
                    <a:pt x="115798" y="347421"/>
                  </a:lnTo>
                  <a:lnTo>
                    <a:pt x="114274" y="344373"/>
                  </a:lnTo>
                  <a:lnTo>
                    <a:pt x="112750" y="342849"/>
                  </a:lnTo>
                  <a:lnTo>
                    <a:pt x="111226" y="342849"/>
                  </a:lnTo>
                  <a:lnTo>
                    <a:pt x="111226" y="339801"/>
                  </a:lnTo>
                  <a:lnTo>
                    <a:pt x="109689" y="338277"/>
                  </a:lnTo>
                  <a:lnTo>
                    <a:pt x="108165" y="335229"/>
                  </a:lnTo>
                  <a:lnTo>
                    <a:pt x="106654" y="335229"/>
                  </a:lnTo>
                  <a:lnTo>
                    <a:pt x="106654" y="333705"/>
                  </a:lnTo>
                  <a:lnTo>
                    <a:pt x="105130" y="330657"/>
                  </a:lnTo>
                  <a:lnTo>
                    <a:pt x="103606" y="329133"/>
                  </a:lnTo>
                  <a:lnTo>
                    <a:pt x="102082" y="327609"/>
                  </a:lnTo>
                  <a:lnTo>
                    <a:pt x="102082" y="326097"/>
                  </a:lnTo>
                  <a:lnTo>
                    <a:pt x="100558" y="324561"/>
                  </a:lnTo>
                  <a:lnTo>
                    <a:pt x="100558" y="323037"/>
                  </a:lnTo>
                  <a:lnTo>
                    <a:pt x="99034" y="321513"/>
                  </a:lnTo>
                  <a:lnTo>
                    <a:pt x="97497" y="319989"/>
                  </a:lnTo>
                  <a:lnTo>
                    <a:pt x="95986" y="318465"/>
                  </a:lnTo>
                  <a:lnTo>
                    <a:pt x="95986" y="316941"/>
                  </a:lnTo>
                  <a:lnTo>
                    <a:pt x="94462" y="315429"/>
                  </a:lnTo>
                  <a:lnTo>
                    <a:pt x="92938" y="313905"/>
                  </a:lnTo>
                  <a:lnTo>
                    <a:pt x="91414" y="312369"/>
                  </a:lnTo>
                  <a:lnTo>
                    <a:pt x="91414" y="310845"/>
                  </a:lnTo>
                  <a:lnTo>
                    <a:pt x="89890" y="309321"/>
                  </a:lnTo>
                  <a:lnTo>
                    <a:pt x="88366" y="307797"/>
                  </a:lnTo>
                  <a:lnTo>
                    <a:pt x="86842" y="306273"/>
                  </a:lnTo>
                  <a:lnTo>
                    <a:pt x="85318" y="304761"/>
                  </a:lnTo>
                  <a:lnTo>
                    <a:pt x="83794" y="303237"/>
                  </a:lnTo>
                  <a:lnTo>
                    <a:pt x="82270" y="301713"/>
                  </a:lnTo>
                  <a:lnTo>
                    <a:pt x="80746" y="300189"/>
                  </a:lnTo>
                  <a:lnTo>
                    <a:pt x="79222" y="298653"/>
                  </a:lnTo>
                  <a:lnTo>
                    <a:pt x="77698" y="297129"/>
                  </a:lnTo>
                  <a:lnTo>
                    <a:pt x="76174" y="295605"/>
                  </a:lnTo>
                  <a:lnTo>
                    <a:pt x="74663" y="294093"/>
                  </a:lnTo>
                  <a:lnTo>
                    <a:pt x="73139" y="292569"/>
                  </a:lnTo>
                  <a:lnTo>
                    <a:pt x="71602" y="291045"/>
                  </a:lnTo>
                  <a:lnTo>
                    <a:pt x="70078" y="289521"/>
                  </a:lnTo>
                  <a:lnTo>
                    <a:pt x="68554" y="287997"/>
                  </a:lnTo>
                  <a:lnTo>
                    <a:pt x="67030" y="286461"/>
                  </a:lnTo>
                  <a:lnTo>
                    <a:pt x="65519" y="284937"/>
                  </a:lnTo>
                  <a:lnTo>
                    <a:pt x="63995" y="283425"/>
                  </a:lnTo>
                  <a:lnTo>
                    <a:pt x="62471" y="281901"/>
                  </a:lnTo>
                  <a:lnTo>
                    <a:pt x="60947" y="280377"/>
                  </a:lnTo>
                  <a:lnTo>
                    <a:pt x="59410" y="278853"/>
                  </a:lnTo>
                  <a:lnTo>
                    <a:pt x="57886" y="277329"/>
                  </a:lnTo>
                  <a:lnTo>
                    <a:pt x="56362" y="277329"/>
                  </a:lnTo>
                  <a:lnTo>
                    <a:pt x="54851" y="274269"/>
                  </a:lnTo>
                  <a:lnTo>
                    <a:pt x="53327" y="272745"/>
                  </a:lnTo>
                  <a:lnTo>
                    <a:pt x="51803" y="272745"/>
                  </a:lnTo>
                  <a:lnTo>
                    <a:pt x="50279" y="269709"/>
                  </a:lnTo>
                  <a:lnTo>
                    <a:pt x="48755" y="268185"/>
                  </a:lnTo>
                  <a:lnTo>
                    <a:pt x="47218" y="268185"/>
                  </a:lnTo>
                  <a:lnTo>
                    <a:pt x="45694" y="265137"/>
                  </a:lnTo>
                  <a:lnTo>
                    <a:pt x="44183" y="263613"/>
                  </a:lnTo>
                  <a:lnTo>
                    <a:pt x="42659" y="262089"/>
                  </a:lnTo>
                  <a:lnTo>
                    <a:pt x="41135" y="259041"/>
                  </a:lnTo>
                  <a:lnTo>
                    <a:pt x="39611" y="259041"/>
                  </a:lnTo>
                  <a:lnTo>
                    <a:pt x="38087" y="257517"/>
                  </a:lnTo>
                  <a:lnTo>
                    <a:pt x="36563" y="255993"/>
                  </a:lnTo>
                  <a:lnTo>
                    <a:pt x="35039" y="254469"/>
                  </a:lnTo>
                  <a:lnTo>
                    <a:pt x="33515" y="252945"/>
                  </a:lnTo>
                  <a:lnTo>
                    <a:pt x="33515" y="251421"/>
                  </a:lnTo>
                  <a:lnTo>
                    <a:pt x="31991" y="249910"/>
                  </a:lnTo>
                  <a:lnTo>
                    <a:pt x="30467" y="248373"/>
                  </a:lnTo>
                  <a:lnTo>
                    <a:pt x="28943" y="246849"/>
                  </a:lnTo>
                  <a:lnTo>
                    <a:pt x="27419" y="245325"/>
                  </a:lnTo>
                  <a:lnTo>
                    <a:pt x="27419" y="243801"/>
                  </a:lnTo>
                  <a:lnTo>
                    <a:pt x="25895" y="242277"/>
                  </a:lnTo>
                  <a:lnTo>
                    <a:pt x="24384" y="240753"/>
                  </a:lnTo>
                  <a:lnTo>
                    <a:pt x="22860" y="239242"/>
                  </a:lnTo>
                  <a:lnTo>
                    <a:pt x="21323" y="237718"/>
                  </a:lnTo>
                  <a:lnTo>
                    <a:pt x="19799" y="236181"/>
                  </a:lnTo>
                  <a:lnTo>
                    <a:pt x="19799" y="234657"/>
                  </a:lnTo>
                  <a:lnTo>
                    <a:pt x="18275" y="233133"/>
                  </a:lnTo>
                  <a:lnTo>
                    <a:pt x="16751" y="231609"/>
                  </a:lnTo>
                  <a:lnTo>
                    <a:pt x="15227" y="230085"/>
                  </a:lnTo>
                  <a:lnTo>
                    <a:pt x="15227" y="228561"/>
                  </a:lnTo>
                  <a:lnTo>
                    <a:pt x="13716" y="227050"/>
                  </a:lnTo>
                  <a:lnTo>
                    <a:pt x="13716" y="225526"/>
                  </a:lnTo>
                  <a:lnTo>
                    <a:pt x="12192" y="223989"/>
                  </a:lnTo>
                  <a:lnTo>
                    <a:pt x="10668" y="222465"/>
                  </a:lnTo>
                  <a:lnTo>
                    <a:pt x="9131" y="220941"/>
                  </a:lnTo>
                  <a:lnTo>
                    <a:pt x="9131" y="219417"/>
                  </a:lnTo>
                  <a:lnTo>
                    <a:pt x="7607" y="217893"/>
                  </a:lnTo>
                  <a:lnTo>
                    <a:pt x="7607" y="216382"/>
                  </a:lnTo>
                  <a:lnTo>
                    <a:pt x="6083" y="214858"/>
                  </a:lnTo>
                  <a:lnTo>
                    <a:pt x="4559" y="213334"/>
                  </a:lnTo>
                  <a:lnTo>
                    <a:pt x="4559" y="211810"/>
                  </a:lnTo>
                  <a:lnTo>
                    <a:pt x="3048" y="210273"/>
                  </a:lnTo>
                  <a:lnTo>
                    <a:pt x="3048" y="208749"/>
                  </a:lnTo>
                  <a:lnTo>
                    <a:pt x="1524" y="207225"/>
                  </a:lnTo>
                  <a:lnTo>
                    <a:pt x="1524" y="205714"/>
                  </a:lnTo>
                  <a:lnTo>
                    <a:pt x="0" y="204190"/>
                  </a:lnTo>
                  <a:lnTo>
                    <a:pt x="0" y="202666"/>
                  </a:lnTo>
                  <a:lnTo>
                    <a:pt x="0" y="199618"/>
                  </a:lnTo>
                  <a:lnTo>
                    <a:pt x="0" y="198081"/>
                  </a:lnTo>
                  <a:lnTo>
                    <a:pt x="0" y="195046"/>
                  </a:lnTo>
                  <a:lnTo>
                    <a:pt x="0" y="193522"/>
                  </a:lnTo>
                  <a:lnTo>
                    <a:pt x="1524" y="193522"/>
                  </a:lnTo>
                  <a:lnTo>
                    <a:pt x="3048" y="191998"/>
                  </a:lnTo>
                  <a:lnTo>
                    <a:pt x="3048" y="188950"/>
                  </a:lnTo>
                  <a:lnTo>
                    <a:pt x="4559" y="188950"/>
                  </a:lnTo>
                  <a:lnTo>
                    <a:pt x="6083" y="187426"/>
                  </a:lnTo>
                  <a:lnTo>
                    <a:pt x="7607" y="184378"/>
                  </a:lnTo>
                  <a:lnTo>
                    <a:pt x="9131" y="184378"/>
                  </a:lnTo>
                  <a:lnTo>
                    <a:pt x="12192" y="182854"/>
                  </a:lnTo>
                  <a:lnTo>
                    <a:pt x="13716" y="181330"/>
                  </a:lnTo>
                  <a:lnTo>
                    <a:pt x="15227" y="179806"/>
                  </a:lnTo>
                  <a:lnTo>
                    <a:pt x="18275" y="178282"/>
                  </a:lnTo>
                  <a:lnTo>
                    <a:pt x="21323" y="176758"/>
                  </a:lnTo>
                  <a:lnTo>
                    <a:pt x="24384" y="175234"/>
                  </a:lnTo>
                  <a:lnTo>
                    <a:pt x="25895" y="173710"/>
                  </a:lnTo>
                  <a:lnTo>
                    <a:pt x="28943" y="172186"/>
                  </a:lnTo>
                  <a:lnTo>
                    <a:pt x="31991" y="170662"/>
                  </a:lnTo>
                  <a:lnTo>
                    <a:pt x="35039" y="169138"/>
                  </a:lnTo>
                  <a:lnTo>
                    <a:pt x="38087" y="167614"/>
                  </a:lnTo>
                  <a:lnTo>
                    <a:pt x="41135" y="166090"/>
                  </a:lnTo>
                  <a:lnTo>
                    <a:pt x="44183" y="164566"/>
                  </a:lnTo>
                  <a:lnTo>
                    <a:pt x="47218" y="163042"/>
                  </a:lnTo>
                  <a:lnTo>
                    <a:pt x="50279" y="161531"/>
                  </a:lnTo>
                  <a:lnTo>
                    <a:pt x="53327" y="159994"/>
                  </a:lnTo>
                  <a:lnTo>
                    <a:pt x="56362" y="158470"/>
                  </a:lnTo>
                  <a:lnTo>
                    <a:pt x="59410" y="156946"/>
                  </a:lnTo>
                  <a:lnTo>
                    <a:pt x="60947" y="155422"/>
                  </a:lnTo>
                  <a:lnTo>
                    <a:pt x="63995" y="153898"/>
                  </a:lnTo>
                  <a:lnTo>
                    <a:pt x="68554" y="152374"/>
                  </a:lnTo>
                  <a:lnTo>
                    <a:pt x="70078" y="150863"/>
                  </a:lnTo>
                  <a:lnTo>
                    <a:pt x="73139" y="149339"/>
                  </a:lnTo>
                  <a:lnTo>
                    <a:pt x="76174" y="147802"/>
                  </a:lnTo>
                  <a:lnTo>
                    <a:pt x="79222" y="146278"/>
                  </a:lnTo>
                  <a:lnTo>
                    <a:pt x="80746" y="144754"/>
                  </a:lnTo>
                  <a:lnTo>
                    <a:pt x="83794" y="143230"/>
                  </a:lnTo>
                  <a:lnTo>
                    <a:pt x="86842" y="141706"/>
                  </a:lnTo>
                  <a:lnTo>
                    <a:pt x="89890" y="140195"/>
                  </a:lnTo>
                  <a:lnTo>
                    <a:pt x="92938" y="138671"/>
                  </a:lnTo>
                  <a:lnTo>
                    <a:pt x="94462" y="137147"/>
                  </a:lnTo>
                  <a:lnTo>
                    <a:pt x="97497" y="135610"/>
                  </a:lnTo>
                  <a:lnTo>
                    <a:pt x="100558" y="134086"/>
                  </a:lnTo>
                  <a:lnTo>
                    <a:pt x="102082" y="132562"/>
                  </a:lnTo>
                  <a:lnTo>
                    <a:pt x="105130" y="131038"/>
                  </a:lnTo>
                  <a:lnTo>
                    <a:pt x="106654" y="129527"/>
                  </a:lnTo>
                  <a:lnTo>
                    <a:pt x="109689" y="128003"/>
                  </a:lnTo>
                  <a:lnTo>
                    <a:pt x="112750" y="128003"/>
                  </a:lnTo>
                  <a:lnTo>
                    <a:pt x="114274" y="126479"/>
                  </a:lnTo>
                  <a:lnTo>
                    <a:pt x="117322" y="123431"/>
                  </a:lnTo>
                  <a:lnTo>
                    <a:pt x="118833" y="123431"/>
                  </a:lnTo>
                  <a:lnTo>
                    <a:pt x="120357" y="121894"/>
                  </a:lnTo>
                  <a:lnTo>
                    <a:pt x="123418" y="118846"/>
                  </a:lnTo>
                  <a:lnTo>
                    <a:pt x="124942" y="118846"/>
                  </a:lnTo>
                  <a:lnTo>
                    <a:pt x="126466" y="117335"/>
                  </a:lnTo>
                  <a:lnTo>
                    <a:pt x="129501" y="114287"/>
                  </a:lnTo>
                  <a:lnTo>
                    <a:pt x="131025" y="114287"/>
                  </a:lnTo>
                  <a:lnTo>
                    <a:pt x="132549" y="112763"/>
                  </a:lnTo>
                  <a:lnTo>
                    <a:pt x="134073" y="111239"/>
                  </a:lnTo>
                  <a:lnTo>
                    <a:pt x="135597" y="109702"/>
                  </a:lnTo>
                  <a:lnTo>
                    <a:pt x="137134" y="108178"/>
                  </a:lnTo>
                  <a:lnTo>
                    <a:pt x="138645" y="106667"/>
                  </a:lnTo>
                  <a:lnTo>
                    <a:pt x="140169" y="105143"/>
                  </a:lnTo>
                  <a:lnTo>
                    <a:pt x="141693" y="103619"/>
                  </a:lnTo>
                  <a:lnTo>
                    <a:pt x="141693" y="102095"/>
                  </a:lnTo>
                  <a:lnTo>
                    <a:pt x="144741" y="100571"/>
                  </a:lnTo>
                  <a:lnTo>
                    <a:pt x="144741" y="99047"/>
                  </a:lnTo>
                  <a:lnTo>
                    <a:pt x="146265" y="97510"/>
                  </a:lnTo>
                  <a:lnTo>
                    <a:pt x="147789" y="95999"/>
                  </a:lnTo>
                  <a:lnTo>
                    <a:pt x="149313" y="94475"/>
                  </a:lnTo>
                  <a:lnTo>
                    <a:pt x="150837" y="92951"/>
                  </a:lnTo>
                  <a:lnTo>
                    <a:pt x="150837" y="91427"/>
                  </a:lnTo>
                  <a:lnTo>
                    <a:pt x="152361" y="89903"/>
                  </a:lnTo>
                  <a:lnTo>
                    <a:pt x="152361" y="88379"/>
                  </a:lnTo>
                  <a:lnTo>
                    <a:pt x="153885" y="86855"/>
                  </a:lnTo>
                  <a:lnTo>
                    <a:pt x="155409" y="85343"/>
                  </a:lnTo>
                  <a:lnTo>
                    <a:pt x="155409" y="83807"/>
                  </a:lnTo>
                  <a:lnTo>
                    <a:pt x="156933" y="82283"/>
                  </a:lnTo>
                  <a:lnTo>
                    <a:pt x="156933" y="80759"/>
                  </a:lnTo>
                  <a:lnTo>
                    <a:pt x="158457" y="79235"/>
                  </a:lnTo>
                  <a:lnTo>
                    <a:pt x="158457" y="77711"/>
                  </a:lnTo>
                  <a:lnTo>
                    <a:pt x="159969" y="76187"/>
                  </a:lnTo>
                  <a:lnTo>
                    <a:pt x="159969" y="74675"/>
                  </a:lnTo>
                  <a:lnTo>
                    <a:pt x="159969" y="73151"/>
                  </a:lnTo>
                  <a:lnTo>
                    <a:pt x="161505" y="71615"/>
                  </a:lnTo>
                  <a:lnTo>
                    <a:pt x="161505" y="70091"/>
                  </a:lnTo>
                  <a:lnTo>
                    <a:pt x="161505" y="68567"/>
                  </a:lnTo>
                  <a:lnTo>
                    <a:pt x="163029" y="67043"/>
                  </a:lnTo>
                  <a:lnTo>
                    <a:pt x="163029" y="65519"/>
                  </a:lnTo>
                  <a:lnTo>
                    <a:pt x="163029" y="64007"/>
                  </a:lnTo>
                  <a:lnTo>
                    <a:pt x="163029" y="62483"/>
                  </a:lnTo>
                  <a:lnTo>
                    <a:pt x="163029" y="60959"/>
                  </a:lnTo>
                  <a:lnTo>
                    <a:pt x="163029" y="59423"/>
                  </a:lnTo>
                  <a:lnTo>
                    <a:pt x="164553" y="57899"/>
                  </a:lnTo>
                  <a:lnTo>
                    <a:pt x="164553" y="56375"/>
                  </a:lnTo>
                  <a:lnTo>
                    <a:pt x="164553" y="53327"/>
                  </a:lnTo>
                  <a:lnTo>
                    <a:pt x="166077" y="51815"/>
                  </a:lnTo>
                  <a:lnTo>
                    <a:pt x="166077" y="36575"/>
                  </a:lnTo>
                  <a:lnTo>
                    <a:pt x="167601" y="35051"/>
                  </a:lnTo>
                  <a:lnTo>
                    <a:pt x="167601" y="1523"/>
                  </a:lnTo>
                  <a:lnTo>
                    <a:pt x="169113" y="0"/>
                  </a:lnTo>
                  <a:lnTo>
                    <a:pt x="170637" y="0"/>
                  </a:lnTo>
                  <a:lnTo>
                    <a:pt x="170637" y="1523"/>
                  </a:lnTo>
                  <a:lnTo>
                    <a:pt x="170637" y="3047"/>
                  </a:lnTo>
                  <a:lnTo>
                    <a:pt x="170637" y="18287"/>
                  </a:lnTo>
                  <a:lnTo>
                    <a:pt x="172161" y="19811"/>
                  </a:lnTo>
                  <a:lnTo>
                    <a:pt x="172161" y="44183"/>
                  </a:lnTo>
                  <a:lnTo>
                    <a:pt x="173685" y="44183"/>
                  </a:lnTo>
                  <a:lnTo>
                    <a:pt x="173685" y="47243"/>
                  </a:lnTo>
                  <a:lnTo>
                    <a:pt x="173685" y="48767"/>
                  </a:lnTo>
                  <a:lnTo>
                    <a:pt x="173685" y="51815"/>
                  </a:lnTo>
                  <a:lnTo>
                    <a:pt x="173685" y="53327"/>
                  </a:lnTo>
                  <a:lnTo>
                    <a:pt x="175221" y="56375"/>
                  </a:lnTo>
                  <a:lnTo>
                    <a:pt x="175221" y="57899"/>
                  </a:lnTo>
                  <a:lnTo>
                    <a:pt x="175221" y="59423"/>
                  </a:lnTo>
                  <a:lnTo>
                    <a:pt x="175221" y="60959"/>
                  </a:lnTo>
                  <a:lnTo>
                    <a:pt x="175221" y="62483"/>
                  </a:lnTo>
                  <a:lnTo>
                    <a:pt x="176745" y="64007"/>
                  </a:lnTo>
                  <a:lnTo>
                    <a:pt x="176745" y="65519"/>
                  </a:lnTo>
                  <a:lnTo>
                    <a:pt x="176745" y="67043"/>
                  </a:lnTo>
                  <a:lnTo>
                    <a:pt x="176745" y="68567"/>
                  </a:lnTo>
                  <a:lnTo>
                    <a:pt x="176745" y="70091"/>
                  </a:lnTo>
                  <a:lnTo>
                    <a:pt x="178269" y="71615"/>
                  </a:lnTo>
                  <a:lnTo>
                    <a:pt x="178269" y="73151"/>
                  </a:lnTo>
                  <a:lnTo>
                    <a:pt x="178269" y="74675"/>
                  </a:lnTo>
                  <a:lnTo>
                    <a:pt x="179781" y="76187"/>
                  </a:lnTo>
                  <a:lnTo>
                    <a:pt x="179781" y="77711"/>
                  </a:lnTo>
                  <a:lnTo>
                    <a:pt x="181305" y="79235"/>
                  </a:lnTo>
                  <a:lnTo>
                    <a:pt x="181305" y="80759"/>
                  </a:lnTo>
                  <a:lnTo>
                    <a:pt x="182829" y="82283"/>
                  </a:lnTo>
                  <a:lnTo>
                    <a:pt x="182829" y="83807"/>
                  </a:lnTo>
                  <a:lnTo>
                    <a:pt x="184353" y="85343"/>
                  </a:lnTo>
                  <a:lnTo>
                    <a:pt x="185877" y="86855"/>
                  </a:lnTo>
                  <a:lnTo>
                    <a:pt x="185877" y="88379"/>
                  </a:lnTo>
                  <a:lnTo>
                    <a:pt x="187413" y="89903"/>
                  </a:lnTo>
                  <a:lnTo>
                    <a:pt x="187413" y="91427"/>
                  </a:lnTo>
                  <a:lnTo>
                    <a:pt x="188937" y="92951"/>
                  </a:lnTo>
                  <a:lnTo>
                    <a:pt x="190449" y="94475"/>
                  </a:lnTo>
                  <a:lnTo>
                    <a:pt x="191973" y="95999"/>
                  </a:lnTo>
                  <a:lnTo>
                    <a:pt x="191973" y="97510"/>
                  </a:lnTo>
                  <a:lnTo>
                    <a:pt x="193497" y="99047"/>
                  </a:lnTo>
                  <a:lnTo>
                    <a:pt x="195021" y="100571"/>
                  </a:lnTo>
                  <a:lnTo>
                    <a:pt x="196545" y="102095"/>
                  </a:lnTo>
                  <a:lnTo>
                    <a:pt x="198069" y="103619"/>
                  </a:lnTo>
                  <a:lnTo>
                    <a:pt x="199605" y="105143"/>
                  </a:lnTo>
                  <a:lnTo>
                    <a:pt x="201117" y="106667"/>
                  </a:lnTo>
                  <a:lnTo>
                    <a:pt x="202641" y="108178"/>
                  </a:lnTo>
                  <a:lnTo>
                    <a:pt x="204165" y="109702"/>
                  </a:lnTo>
                  <a:lnTo>
                    <a:pt x="205689" y="111239"/>
                  </a:lnTo>
                  <a:lnTo>
                    <a:pt x="207213" y="112763"/>
                  </a:lnTo>
                  <a:lnTo>
                    <a:pt x="208737" y="114287"/>
                  </a:lnTo>
                  <a:lnTo>
                    <a:pt x="210261" y="114287"/>
                  </a:lnTo>
                  <a:lnTo>
                    <a:pt x="211785" y="117335"/>
                  </a:lnTo>
                  <a:lnTo>
                    <a:pt x="214833" y="118846"/>
                  </a:lnTo>
                  <a:lnTo>
                    <a:pt x="216357" y="118846"/>
                  </a:lnTo>
                  <a:lnTo>
                    <a:pt x="217881" y="121894"/>
                  </a:lnTo>
                  <a:lnTo>
                    <a:pt x="219405" y="123431"/>
                  </a:lnTo>
                  <a:lnTo>
                    <a:pt x="222440" y="123431"/>
                  </a:lnTo>
                  <a:lnTo>
                    <a:pt x="223964" y="126479"/>
                  </a:lnTo>
                  <a:lnTo>
                    <a:pt x="227025" y="128003"/>
                  </a:lnTo>
                  <a:lnTo>
                    <a:pt x="228549" y="128003"/>
                  </a:lnTo>
                  <a:lnTo>
                    <a:pt x="231584" y="129527"/>
                  </a:lnTo>
                  <a:lnTo>
                    <a:pt x="233108" y="131038"/>
                  </a:lnTo>
                  <a:lnTo>
                    <a:pt x="236156" y="132562"/>
                  </a:lnTo>
                  <a:lnTo>
                    <a:pt x="239217" y="134086"/>
                  </a:lnTo>
                  <a:lnTo>
                    <a:pt x="242252" y="135610"/>
                  </a:lnTo>
                  <a:lnTo>
                    <a:pt x="243776" y="137147"/>
                  </a:lnTo>
                  <a:lnTo>
                    <a:pt x="246824" y="138671"/>
                  </a:lnTo>
                  <a:lnTo>
                    <a:pt x="249885" y="140195"/>
                  </a:lnTo>
                  <a:lnTo>
                    <a:pt x="251409" y="141706"/>
                  </a:lnTo>
                  <a:lnTo>
                    <a:pt x="254444" y="143230"/>
                  </a:lnTo>
                  <a:lnTo>
                    <a:pt x="257492" y="144754"/>
                  </a:lnTo>
                  <a:lnTo>
                    <a:pt x="260540" y="146278"/>
                  </a:lnTo>
                  <a:lnTo>
                    <a:pt x="263588" y="147802"/>
                  </a:lnTo>
                  <a:lnTo>
                    <a:pt x="265112" y="149339"/>
                  </a:lnTo>
                  <a:lnTo>
                    <a:pt x="268160" y="150863"/>
                  </a:lnTo>
                  <a:lnTo>
                    <a:pt x="271208" y="152374"/>
                  </a:lnTo>
                  <a:lnTo>
                    <a:pt x="274243" y="153898"/>
                  </a:lnTo>
                  <a:lnTo>
                    <a:pt x="277304" y="155422"/>
                  </a:lnTo>
                  <a:lnTo>
                    <a:pt x="280352" y="156946"/>
                  </a:lnTo>
                  <a:lnTo>
                    <a:pt x="283387" y="158470"/>
                  </a:lnTo>
                  <a:lnTo>
                    <a:pt x="286435" y="159994"/>
                  </a:lnTo>
                  <a:lnTo>
                    <a:pt x="289496" y="161531"/>
                  </a:lnTo>
                  <a:lnTo>
                    <a:pt x="292544" y="163042"/>
                  </a:lnTo>
                  <a:lnTo>
                    <a:pt x="295579" y="164566"/>
                  </a:lnTo>
                  <a:lnTo>
                    <a:pt x="298627" y="166090"/>
                  </a:lnTo>
                  <a:lnTo>
                    <a:pt x="301688" y="167614"/>
                  </a:lnTo>
                  <a:lnTo>
                    <a:pt x="304723" y="169138"/>
                  </a:lnTo>
                  <a:lnTo>
                    <a:pt x="307771" y="170662"/>
                  </a:lnTo>
                  <a:lnTo>
                    <a:pt x="309295" y="172186"/>
                  </a:lnTo>
                  <a:lnTo>
                    <a:pt x="312343" y="173710"/>
                  </a:lnTo>
                  <a:lnTo>
                    <a:pt x="315391" y="175234"/>
                  </a:lnTo>
                  <a:lnTo>
                    <a:pt x="318439" y="176758"/>
                  </a:lnTo>
                  <a:lnTo>
                    <a:pt x="319963" y="178282"/>
                  </a:lnTo>
                  <a:lnTo>
                    <a:pt x="323011" y="179806"/>
                  </a:lnTo>
                  <a:lnTo>
                    <a:pt x="326059" y="181330"/>
                  </a:lnTo>
                  <a:lnTo>
                    <a:pt x="327583" y="182854"/>
                  </a:lnTo>
                  <a:lnTo>
                    <a:pt x="329107" y="184378"/>
                  </a:lnTo>
                  <a:lnTo>
                    <a:pt x="330631" y="184378"/>
                  </a:lnTo>
                  <a:lnTo>
                    <a:pt x="333679" y="187426"/>
                  </a:lnTo>
                  <a:lnTo>
                    <a:pt x="335191" y="188950"/>
                  </a:lnTo>
                  <a:lnTo>
                    <a:pt x="336715" y="191998"/>
                  </a:lnTo>
                  <a:lnTo>
                    <a:pt x="336715" y="193522"/>
                  </a:lnTo>
                  <a:lnTo>
                    <a:pt x="338251" y="193522"/>
                  </a:lnTo>
                  <a:lnTo>
                    <a:pt x="338251" y="195046"/>
                  </a:lnTo>
                  <a:lnTo>
                    <a:pt x="339775" y="198081"/>
                  </a:lnTo>
                  <a:lnTo>
                    <a:pt x="339775" y="199618"/>
                  </a:lnTo>
                  <a:lnTo>
                    <a:pt x="339775" y="202666"/>
                  </a:lnTo>
                  <a:lnTo>
                    <a:pt x="338251" y="202666"/>
                  </a:lnTo>
                  <a:lnTo>
                    <a:pt x="338251" y="204190"/>
                  </a:lnTo>
                  <a:lnTo>
                    <a:pt x="338251" y="205714"/>
                  </a:lnTo>
                  <a:lnTo>
                    <a:pt x="336715" y="207225"/>
                  </a:lnTo>
                  <a:lnTo>
                    <a:pt x="336715" y="208749"/>
                  </a:lnTo>
                  <a:lnTo>
                    <a:pt x="335191" y="210273"/>
                  </a:lnTo>
                  <a:lnTo>
                    <a:pt x="335191" y="211810"/>
                  </a:lnTo>
                  <a:lnTo>
                    <a:pt x="333679" y="213334"/>
                  </a:lnTo>
                  <a:lnTo>
                    <a:pt x="333679" y="214858"/>
                  </a:lnTo>
                  <a:lnTo>
                    <a:pt x="332155" y="216382"/>
                  </a:lnTo>
                  <a:lnTo>
                    <a:pt x="330631" y="217893"/>
                  </a:lnTo>
                  <a:lnTo>
                    <a:pt x="330631" y="219417"/>
                  </a:lnTo>
                  <a:lnTo>
                    <a:pt x="329107" y="220941"/>
                  </a:lnTo>
                  <a:lnTo>
                    <a:pt x="329107" y="222465"/>
                  </a:lnTo>
                  <a:lnTo>
                    <a:pt x="327583" y="223989"/>
                  </a:lnTo>
                  <a:lnTo>
                    <a:pt x="326059" y="225526"/>
                  </a:lnTo>
                  <a:lnTo>
                    <a:pt x="324535" y="227050"/>
                  </a:lnTo>
                  <a:lnTo>
                    <a:pt x="324535" y="228561"/>
                  </a:lnTo>
                  <a:lnTo>
                    <a:pt x="323011" y="230085"/>
                  </a:lnTo>
                  <a:lnTo>
                    <a:pt x="321487" y="231609"/>
                  </a:lnTo>
                  <a:lnTo>
                    <a:pt x="319963" y="233133"/>
                  </a:lnTo>
                  <a:lnTo>
                    <a:pt x="319963" y="234657"/>
                  </a:lnTo>
                  <a:lnTo>
                    <a:pt x="318439" y="236181"/>
                  </a:lnTo>
                  <a:lnTo>
                    <a:pt x="316915" y="237718"/>
                  </a:lnTo>
                  <a:lnTo>
                    <a:pt x="315391" y="239242"/>
                  </a:lnTo>
                  <a:lnTo>
                    <a:pt x="315391" y="240753"/>
                  </a:lnTo>
                  <a:lnTo>
                    <a:pt x="313880" y="242277"/>
                  </a:lnTo>
                  <a:lnTo>
                    <a:pt x="312343" y="243801"/>
                  </a:lnTo>
                  <a:lnTo>
                    <a:pt x="310819" y="245325"/>
                  </a:lnTo>
                  <a:lnTo>
                    <a:pt x="309295" y="246849"/>
                  </a:lnTo>
                  <a:lnTo>
                    <a:pt x="309295" y="248373"/>
                  </a:lnTo>
                  <a:lnTo>
                    <a:pt x="307771" y="249910"/>
                  </a:lnTo>
                  <a:lnTo>
                    <a:pt x="306247" y="251421"/>
                  </a:lnTo>
                  <a:lnTo>
                    <a:pt x="304723" y="252945"/>
                  </a:lnTo>
                  <a:lnTo>
                    <a:pt x="303212" y="254469"/>
                  </a:lnTo>
                  <a:lnTo>
                    <a:pt x="303212" y="255993"/>
                  </a:lnTo>
                  <a:lnTo>
                    <a:pt x="300164" y="257517"/>
                  </a:lnTo>
                  <a:lnTo>
                    <a:pt x="300164" y="259041"/>
                  </a:lnTo>
                  <a:lnTo>
                    <a:pt x="298627" y="259041"/>
                  </a:lnTo>
                  <a:lnTo>
                    <a:pt x="297103" y="262089"/>
                  </a:lnTo>
                  <a:lnTo>
                    <a:pt x="295579" y="263613"/>
                  </a:lnTo>
                  <a:lnTo>
                    <a:pt x="294055" y="263613"/>
                  </a:lnTo>
                  <a:lnTo>
                    <a:pt x="292544" y="265137"/>
                  </a:lnTo>
                  <a:lnTo>
                    <a:pt x="292544" y="268185"/>
                  </a:lnTo>
                  <a:lnTo>
                    <a:pt x="289496" y="268185"/>
                  </a:lnTo>
                  <a:lnTo>
                    <a:pt x="289496" y="269709"/>
                  </a:lnTo>
                  <a:lnTo>
                    <a:pt x="287972" y="272745"/>
                  </a:lnTo>
                  <a:lnTo>
                    <a:pt x="286435" y="272745"/>
                  </a:lnTo>
                  <a:lnTo>
                    <a:pt x="284911" y="274269"/>
                  </a:lnTo>
                  <a:lnTo>
                    <a:pt x="283387" y="277329"/>
                  </a:lnTo>
                  <a:lnTo>
                    <a:pt x="281876" y="277329"/>
                  </a:lnTo>
                  <a:lnTo>
                    <a:pt x="280352" y="278853"/>
                  </a:lnTo>
                  <a:lnTo>
                    <a:pt x="278828" y="280377"/>
                  </a:lnTo>
                  <a:lnTo>
                    <a:pt x="277304" y="281901"/>
                  </a:lnTo>
                  <a:lnTo>
                    <a:pt x="275780" y="283425"/>
                  </a:lnTo>
                  <a:lnTo>
                    <a:pt x="274243" y="284937"/>
                  </a:lnTo>
                  <a:lnTo>
                    <a:pt x="272719" y="286461"/>
                  </a:lnTo>
                  <a:lnTo>
                    <a:pt x="271208" y="287997"/>
                  </a:lnTo>
                  <a:lnTo>
                    <a:pt x="269684" y="289521"/>
                  </a:lnTo>
                  <a:lnTo>
                    <a:pt x="268160" y="291045"/>
                  </a:lnTo>
                  <a:lnTo>
                    <a:pt x="265112" y="292569"/>
                  </a:lnTo>
                  <a:lnTo>
                    <a:pt x="263588" y="294093"/>
                  </a:lnTo>
                  <a:lnTo>
                    <a:pt x="263588" y="295605"/>
                  </a:lnTo>
                  <a:lnTo>
                    <a:pt x="262064" y="297129"/>
                  </a:lnTo>
                  <a:lnTo>
                    <a:pt x="259016" y="298653"/>
                  </a:lnTo>
                  <a:lnTo>
                    <a:pt x="257492" y="300189"/>
                  </a:lnTo>
                  <a:lnTo>
                    <a:pt x="255968" y="301713"/>
                  </a:lnTo>
                  <a:lnTo>
                    <a:pt x="254444" y="303237"/>
                  </a:lnTo>
                  <a:lnTo>
                    <a:pt x="252920" y="304761"/>
                  </a:lnTo>
                  <a:lnTo>
                    <a:pt x="252920" y="306273"/>
                  </a:lnTo>
                  <a:lnTo>
                    <a:pt x="249885" y="307797"/>
                  </a:lnTo>
                  <a:lnTo>
                    <a:pt x="249885" y="309321"/>
                  </a:lnTo>
                  <a:lnTo>
                    <a:pt x="248348" y="310845"/>
                  </a:lnTo>
                  <a:lnTo>
                    <a:pt x="246824" y="312369"/>
                  </a:lnTo>
                  <a:lnTo>
                    <a:pt x="245300" y="313905"/>
                  </a:lnTo>
                  <a:lnTo>
                    <a:pt x="243776" y="315429"/>
                  </a:lnTo>
                  <a:lnTo>
                    <a:pt x="243776" y="316941"/>
                  </a:lnTo>
                  <a:lnTo>
                    <a:pt x="242252" y="318465"/>
                  </a:lnTo>
                  <a:lnTo>
                    <a:pt x="240741" y="319989"/>
                  </a:lnTo>
                  <a:lnTo>
                    <a:pt x="240741" y="321513"/>
                  </a:lnTo>
                  <a:lnTo>
                    <a:pt x="239217" y="323037"/>
                  </a:lnTo>
                  <a:lnTo>
                    <a:pt x="237693" y="324561"/>
                  </a:lnTo>
                  <a:lnTo>
                    <a:pt x="237693" y="326097"/>
                  </a:lnTo>
                  <a:lnTo>
                    <a:pt x="236156" y="327609"/>
                  </a:lnTo>
                  <a:lnTo>
                    <a:pt x="234632" y="329133"/>
                  </a:lnTo>
                  <a:lnTo>
                    <a:pt x="234632" y="330657"/>
                  </a:lnTo>
                  <a:lnTo>
                    <a:pt x="233108" y="330657"/>
                  </a:lnTo>
                  <a:lnTo>
                    <a:pt x="233108" y="333705"/>
                  </a:lnTo>
                  <a:lnTo>
                    <a:pt x="231584" y="335229"/>
                  </a:lnTo>
                  <a:lnTo>
                    <a:pt x="230073" y="338277"/>
                  </a:lnTo>
                  <a:lnTo>
                    <a:pt x="228549" y="338277"/>
                  </a:lnTo>
                  <a:lnTo>
                    <a:pt x="228549" y="339801"/>
                  </a:lnTo>
                  <a:lnTo>
                    <a:pt x="227025" y="342849"/>
                  </a:lnTo>
                  <a:lnTo>
                    <a:pt x="225501" y="342849"/>
                  </a:lnTo>
                  <a:lnTo>
                    <a:pt x="225501" y="344373"/>
                  </a:lnTo>
                  <a:lnTo>
                    <a:pt x="223964" y="347421"/>
                  </a:lnTo>
                  <a:lnTo>
                    <a:pt x="222440" y="347421"/>
                  </a:lnTo>
                  <a:lnTo>
                    <a:pt x="222440" y="348945"/>
                  </a:lnTo>
                  <a:lnTo>
                    <a:pt x="220929" y="350456"/>
                  </a:lnTo>
                  <a:lnTo>
                    <a:pt x="219405" y="351993"/>
                  </a:lnTo>
                  <a:lnTo>
                    <a:pt x="219405" y="353517"/>
                  </a:lnTo>
                  <a:lnTo>
                    <a:pt x="217881" y="355041"/>
                  </a:lnTo>
                  <a:lnTo>
                    <a:pt x="217881" y="356565"/>
                  </a:lnTo>
                  <a:lnTo>
                    <a:pt x="216357" y="358089"/>
                  </a:lnTo>
                  <a:lnTo>
                    <a:pt x="216357" y="359613"/>
                  </a:lnTo>
                  <a:lnTo>
                    <a:pt x="214833" y="361124"/>
                  </a:lnTo>
                  <a:lnTo>
                    <a:pt x="213309" y="362648"/>
                  </a:lnTo>
                  <a:lnTo>
                    <a:pt x="213309" y="364185"/>
                  </a:lnTo>
                  <a:lnTo>
                    <a:pt x="211785" y="365709"/>
                  </a:lnTo>
                  <a:lnTo>
                    <a:pt x="211785" y="367233"/>
                  </a:lnTo>
                  <a:lnTo>
                    <a:pt x="211785" y="368757"/>
                  </a:lnTo>
                  <a:lnTo>
                    <a:pt x="210261" y="370281"/>
                  </a:lnTo>
                  <a:lnTo>
                    <a:pt x="208737" y="371792"/>
                  </a:lnTo>
                  <a:lnTo>
                    <a:pt x="208737" y="373316"/>
                  </a:lnTo>
                  <a:lnTo>
                    <a:pt x="208737" y="374840"/>
                  </a:lnTo>
                  <a:lnTo>
                    <a:pt x="207213" y="376377"/>
                  </a:lnTo>
                  <a:lnTo>
                    <a:pt x="207213" y="377901"/>
                  </a:lnTo>
                  <a:lnTo>
                    <a:pt x="205689" y="379425"/>
                  </a:lnTo>
                  <a:lnTo>
                    <a:pt x="205689" y="380949"/>
                  </a:lnTo>
                  <a:lnTo>
                    <a:pt x="205689" y="382460"/>
                  </a:lnTo>
                  <a:lnTo>
                    <a:pt x="204165" y="383984"/>
                  </a:lnTo>
                  <a:lnTo>
                    <a:pt x="204165" y="385508"/>
                  </a:lnTo>
                  <a:lnTo>
                    <a:pt x="202641" y="387032"/>
                  </a:lnTo>
                  <a:lnTo>
                    <a:pt x="202641" y="388556"/>
                  </a:lnTo>
                  <a:lnTo>
                    <a:pt x="202641" y="390093"/>
                  </a:lnTo>
                  <a:lnTo>
                    <a:pt x="201117" y="391617"/>
                  </a:lnTo>
                  <a:lnTo>
                    <a:pt x="201117" y="393141"/>
                  </a:lnTo>
                  <a:lnTo>
                    <a:pt x="199605" y="394652"/>
                  </a:lnTo>
                  <a:lnTo>
                    <a:pt x="199605" y="396176"/>
                  </a:lnTo>
                  <a:lnTo>
                    <a:pt x="198069" y="397700"/>
                  </a:lnTo>
                  <a:lnTo>
                    <a:pt x="198069" y="399224"/>
                  </a:lnTo>
                  <a:lnTo>
                    <a:pt x="198069" y="400748"/>
                  </a:lnTo>
                  <a:lnTo>
                    <a:pt x="196545" y="400748"/>
                  </a:lnTo>
                  <a:lnTo>
                    <a:pt x="196545" y="403809"/>
                  </a:lnTo>
                  <a:lnTo>
                    <a:pt x="195021" y="405320"/>
                  </a:lnTo>
                  <a:lnTo>
                    <a:pt x="195021" y="408368"/>
                  </a:lnTo>
                  <a:lnTo>
                    <a:pt x="193497" y="409892"/>
                  </a:lnTo>
                  <a:lnTo>
                    <a:pt x="193497" y="412940"/>
                  </a:lnTo>
                  <a:lnTo>
                    <a:pt x="191973" y="412940"/>
                  </a:lnTo>
                  <a:lnTo>
                    <a:pt x="191973" y="414477"/>
                  </a:lnTo>
                  <a:lnTo>
                    <a:pt x="191973" y="415988"/>
                  </a:lnTo>
                  <a:lnTo>
                    <a:pt x="191973" y="417512"/>
                  </a:lnTo>
                  <a:lnTo>
                    <a:pt x="191973" y="419036"/>
                  </a:lnTo>
                  <a:lnTo>
                    <a:pt x="190449" y="420560"/>
                  </a:lnTo>
                  <a:lnTo>
                    <a:pt x="190449" y="428180"/>
                  </a:lnTo>
                  <a:lnTo>
                    <a:pt x="188937" y="429704"/>
                  </a:lnTo>
                  <a:lnTo>
                    <a:pt x="188937" y="431228"/>
                  </a:lnTo>
                  <a:lnTo>
                    <a:pt x="188937" y="432752"/>
                  </a:lnTo>
                  <a:lnTo>
                    <a:pt x="188937" y="434276"/>
                  </a:lnTo>
                  <a:lnTo>
                    <a:pt x="188937" y="435800"/>
                  </a:lnTo>
                  <a:lnTo>
                    <a:pt x="187413" y="437311"/>
                  </a:lnTo>
                  <a:lnTo>
                    <a:pt x="187413" y="449503"/>
                  </a:lnTo>
                  <a:lnTo>
                    <a:pt x="185877" y="451027"/>
                  </a:lnTo>
                  <a:lnTo>
                    <a:pt x="185877" y="486079"/>
                  </a:lnTo>
                  <a:lnTo>
                    <a:pt x="184353" y="487603"/>
                  </a:lnTo>
                  <a:lnTo>
                    <a:pt x="184353" y="499795"/>
                  </a:lnTo>
                  <a:lnTo>
                    <a:pt x="182829" y="501319"/>
                  </a:lnTo>
                  <a:lnTo>
                    <a:pt x="182829" y="513511"/>
                  </a:lnTo>
                  <a:lnTo>
                    <a:pt x="181305" y="515035"/>
                  </a:lnTo>
                  <a:lnTo>
                    <a:pt x="181305" y="522655"/>
                  </a:lnTo>
                  <a:lnTo>
                    <a:pt x="179781" y="524179"/>
                  </a:lnTo>
                  <a:lnTo>
                    <a:pt x="179781" y="525691"/>
                  </a:lnTo>
                  <a:lnTo>
                    <a:pt x="179781" y="527215"/>
                  </a:lnTo>
                  <a:lnTo>
                    <a:pt x="179781" y="528751"/>
                  </a:lnTo>
                  <a:lnTo>
                    <a:pt x="178269" y="530275"/>
                  </a:lnTo>
                  <a:lnTo>
                    <a:pt x="178269" y="543991"/>
                  </a:lnTo>
                  <a:lnTo>
                    <a:pt x="176745" y="545515"/>
                  </a:lnTo>
                  <a:lnTo>
                    <a:pt x="176745" y="547027"/>
                  </a:lnTo>
                  <a:lnTo>
                    <a:pt x="176745" y="548551"/>
                  </a:lnTo>
                  <a:lnTo>
                    <a:pt x="176745" y="550075"/>
                  </a:lnTo>
                  <a:lnTo>
                    <a:pt x="176745" y="551599"/>
                  </a:lnTo>
                  <a:lnTo>
                    <a:pt x="178269" y="554659"/>
                  </a:lnTo>
                  <a:lnTo>
                    <a:pt x="178269" y="556183"/>
                  </a:lnTo>
                  <a:lnTo>
                    <a:pt x="176745" y="559219"/>
                  </a:lnTo>
                  <a:lnTo>
                    <a:pt x="176745" y="560743"/>
                  </a:lnTo>
                  <a:lnTo>
                    <a:pt x="176745" y="577507"/>
                  </a:lnTo>
                  <a:lnTo>
                    <a:pt x="175221" y="579043"/>
                  </a:lnTo>
                  <a:lnTo>
                    <a:pt x="175221" y="594271"/>
                  </a:lnTo>
                  <a:lnTo>
                    <a:pt x="173685" y="595795"/>
                  </a:lnTo>
                  <a:lnTo>
                    <a:pt x="173685" y="665886"/>
                  </a:lnTo>
                  <a:lnTo>
                    <a:pt x="172161" y="667410"/>
                  </a:lnTo>
                  <a:lnTo>
                    <a:pt x="172161" y="761885"/>
                  </a:lnTo>
                  <a:lnTo>
                    <a:pt x="167601" y="761885"/>
                  </a:lnTo>
                </a:path>
              </a:pathLst>
            </a:custGeom>
            <a:ln w="761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5774265" y="5922009"/>
              <a:ext cx="347980" cy="796290"/>
            </a:xfrm>
            <a:custGeom>
              <a:avLst/>
              <a:gdLst/>
              <a:ahLst/>
              <a:cxnLst/>
              <a:rect l="l" t="t" r="r" b="b"/>
              <a:pathLst>
                <a:path w="347979" h="796290">
                  <a:moveTo>
                    <a:pt x="173697" y="748029"/>
                  </a:moveTo>
                  <a:lnTo>
                    <a:pt x="172173" y="749299"/>
                  </a:lnTo>
                  <a:lnTo>
                    <a:pt x="172173" y="796289"/>
                  </a:lnTo>
                  <a:lnTo>
                    <a:pt x="173697" y="796289"/>
                  </a:lnTo>
                  <a:lnTo>
                    <a:pt x="173697" y="748029"/>
                  </a:lnTo>
                  <a:close/>
                </a:path>
                <a:path w="347979" h="796290">
                  <a:moveTo>
                    <a:pt x="251409" y="294639"/>
                  </a:moveTo>
                  <a:lnTo>
                    <a:pt x="94475" y="294639"/>
                  </a:lnTo>
                  <a:lnTo>
                    <a:pt x="95999" y="295909"/>
                  </a:lnTo>
                  <a:lnTo>
                    <a:pt x="97510" y="298449"/>
                  </a:lnTo>
                  <a:lnTo>
                    <a:pt x="102082" y="303529"/>
                  </a:lnTo>
                  <a:lnTo>
                    <a:pt x="102082" y="304799"/>
                  </a:lnTo>
                  <a:lnTo>
                    <a:pt x="105143" y="306069"/>
                  </a:lnTo>
                  <a:lnTo>
                    <a:pt x="105143" y="307339"/>
                  </a:lnTo>
                  <a:lnTo>
                    <a:pt x="106667" y="309879"/>
                  </a:lnTo>
                  <a:lnTo>
                    <a:pt x="106667" y="311149"/>
                  </a:lnTo>
                  <a:lnTo>
                    <a:pt x="111226" y="314959"/>
                  </a:lnTo>
                  <a:lnTo>
                    <a:pt x="111226" y="317499"/>
                  </a:lnTo>
                  <a:lnTo>
                    <a:pt x="114274" y="320039"/>
                  </a:lnTo>
                  <a:lnTo>
                    <a:pt x="114274" y="321309"/>
                  </a:lnTo>
                  <a:lnTo>
                    <a:pt x="117335" y="325119"/>
                  </a:lnTo>
                  <a:lnTo>
                    <a:pt x="117335" y="326389"/>
                  </a:lnTo>
                  <a:lnTo>
                    <a:pt x="120370" y="328929"/>
                  </a:lnTo>
                  <a:lnTo>
                    <a:pt x="120370" y="330199"/>
                  </a:lnTo>
                  <a:lnTo>
                    <a:pt x="124942" y="335279"/>
                  </a:lnTo>
                  <a:lnTo>
                    <a:pt x="124942" y="336549"/>
                  </a:lnTo>
                  <a:lnTo>
                    <a:pt x="126466" y="337819"/>
                  </a:lnTo>
                  <a:lnTo>
                    <a:pt x="126466" y="340359"/>
                  </a:lnTo>
                  <a:lnTo>
                    <a:pt x="131038" y="344169"/>
                  </a:lnTo>
                  <a:lnTo>
                    <a:pt x="131038" y="345439"/>
                  </a:lnTo>
                  <a:lnTo>
                    <a:pt x="132562" y="347979"/>
                  </a:lnTo>
                  <a:lnTo>
                    <a:pt x="132562" y="349249"/>
                  </a:lnTo>
                  <a:lnTo>
                    <a:pt x="134086" y="350519"/>
                  </a:lnTo>
                  <a:lnTo>
                    <a:pt x="134086" y="351789"/>
                  </a:lnTo>
                  <a:lnTo>
                    <a:pt x="135610" y="353059"/>
                  </a:lnTo>
                  <a:lnTo>
                    <a:pt x="135610" y="355599"/>
                  </a:lnTo>
                  <a:lnTo>
                    <a:pt x="137134" y="356869"/>
                  </a:lnTo>
                  <a:lnTo>
                    <a:pt x="137134" y="360679"/>
                  </a:lnTo>
                  <a:lnTo>
                    <a:pt x="138658" y="364489"/>
                  </a:lnTo>
                  <a:lnTo>
                    <a:pt x="138658" y="365759"/>
                  </a:lnTo>
                  <a:lnTo>
                    <a:pt x="140169" y="368299"/>
                  </a:lnTo>
                  <a:lnTo>
                    <a:pt x="140169" y="374649"/>
                  </a:lnTo>
                  <a:lnTo>
                    <a:pt x="141706" y="375919"/>
                  </a:lnTo>
                  <a:lnTo>
                    <a:pt x="141706" y="382269"/>
                  </a:lnTo>
                  <a:lnTo>
                    <a:pt x="143230" y="383539"/>
                  </a:lnTo>
                  <a:lnTo>
                    <a:pt x="143230" y="386079"/>
                  </a:lnTo>
                  <a:lnTo>
                    <a:pt x="144754" y="387349"/>
                  </a:lnTo>
                  <a:lnTo>
                    <a:pt x="144754" y="389889"/>
                  </a:lnTo>
                  <a:lnTo>
                    <a:pt x="146278" y="391159"/>
                  </a:lnTo>
                  <a:lnTo>
                    <a:pt x="146278" y="394969"/>
                  </a:lnTo>
                  <a:lnTo>
                    <a:pt x="147802" y="396239"/>
                  </a:lnTo>
                  <a:lnTo>
                    <a:pt x="147802" y="398779"/>
                  </a:lnTo>
                  <a:lnTo>
                    <a:pt x="149313" y="401319"/>
                  </a:lnTo>
                  <a:lnTo>
                    <a:pt x="149313" y="403859"/>
                  </a:lnTo>
                  <a:lnTo>
                    <a:pt x="150837" y="405129"/>
                  </a:lnTo>
                  <a:lnTo>
                    <a:pt x="150837" y="411479"/>
                  </a:lnTo>
                  <a:lnTo>
                    <a:pt x="152361" y="412749"/>
                  </a:lnTo>
                  <a:lnTo>
                    <a:pt x="152361" y="425449"/>
                  </a:lnTo>
                  <a:lnTo>
                    <a:pt x="153898" y="426719"/>
                  </a:lnTo>
                  <a:lnTo>
                    <a:pt x="153898" y="434339"/>
                  </a:lnTo>
                  <a:lnTo>
                    <a:pt x="155422" y="435609"/>
                  </a:lnTo>
                  <a:lnTo>
                    <a:pt x="155422" y="440689"/>
                  </a:lnTo>
                  <a:lnTo>
                    <a:pt x="156946" y="441959"/>
                  </a:lnTo>
                  <a:lnTo>
                    <a:pt x="156946" y="444499"/>
                  </a:lnTo>
                  <a:lnTo>
                    <a:pt x="158470" y="447039"/>
                  </a:lnTo>
                  <a:lnTo>
                    <a:pt x="158470" y="448309"/>
                  </a:lnTo>
                  <a:lnTo>
                    <a:pt x="159981" y="449579"/>
                  </a:lnTo>
                  <a:lnTo>
                    <a:pt x="159981" y="452119"/>
                  </a:lnTo>
                  <a:lnTo>
                    <a:pt x="161505" y="454659"/>
                  </a:lnTo>
                  <a:lnTo>
                    <a:pt x="161505" y="457199"/>
                  </a:lnTo>
                  <a:lnTo>
                    <a:pt x="163029" y="458469"/>
                  </a:lnTo>
                  <a:lnTo>
                    <a:pt x="163029" y="463549"/>
                  </a:lnTo>
                  <a:lnTo>
                    <a:pt x="164553" y="464819"/>
                  </a:lnTo>
                  <a:lnTo>
                    <a:pt x="164553" y="467359"/>
                  </a:lnTo>
                  <a:lnTo>
                    <a:pt x="166090" y="469899"/>
                  </a:lnTo>
                  <a:lnTo>
                    <a:pt x="166090" y="477519"/>
                  </a:lnTo>
                  <a:lnTo>
                    <a:pt x="167614" y="478789"/>
                  </a:lnTo>
                  <a:lnTo>
                    <a:pt x="167614" y="500379"/>
                  </a:lnTo>
                  <a:lnTo>
                    <a:pt x="169138" y="500379"/>
                  </a:lnTo>
                  <a:lnTo>
                    <a:pt x="169138" y="553719"/>
                  </a:lnTo>
                  <a:lnTo>
                    <a:pt x="170649" y="554989"/>
                  </a:lnTo>
                  <a:lnTo>
                    <a:pt x="170649" y="633729"/>
                  </a:lnTo>
                  <a:lnTo>
                    <a:pt x="172173" y="634999"/>
                  </a:lnTo>
                  <a:lnTo>
                    <a:pt x="172173" y="709929"/>
                  </a:lnTo>
                  <a:lnTo>
                    <a:pt x="173697" y="709929"/>
                  </a:lnTo>
                  <a:lnTo>
                    <a:pt x="173697" y="680719"/>
                  </a:lnTo>
                  <a:lnTo>
                    <a:pt x="175221" y="679449"/>
                  </a:lnTo>
                  <a:lnTo>
                    <a:pt x="175221" y="618489"/>
                  </a:lnTo>
                  <a:lnTo>
                    <a:pt x="176745" y="617219"/>
                  </a:lnTo>
                  <a:lnTo>
                    <a:pt x="176745" y="524509"/>
                  </a:lnTo>
                  <a:lnTo>
                    <a:pt x="178269" y="523239"/>
                  </a:lnTo>
                  <a:lnTo>
                    <a:pt x="178269" y="481329"/>
                  </a:lnTo>
                  <a:lnTo>
                    <a:pt x="179793" y="480059"/>
                  </a:lnTo>
                  <a:lnTo>
                    <a:pt x="179793" y="473709"/>
                  </a:lnTo>
                  <a:lnTo>
                    <a:pt x="181317" y="472439"/>
                  </a:lnTo>
                  <a:lnTo>
                    <a:pt x="181317" y="466089"/>
                  </a:lnTo>
                  <a:lnTo>
                    <a:pt x="182841" y="464819"/>
                  </a:lnTo>
                  <a:lnTo>
                    <a:pt x="182841" y="459739"/>
                  </a:lnTo>
                  <a:lnTo>
                    <a:pt x="184365" y="458469"/>
                  </a:lnTo>
                  <a:lnTo>
                    <a:pt x="184365" y="457199"/>
                  </a:lnTo>
                  <a:lnTo>
                    <a:pt x="185889" y="455929"/>
                  </a:lnTo>
                  <a:lnTo>
                    <a:pt x="185889" y="452119"/>
                  </a:lnTo>
                  <a:lnTo>
                    <a:pt x="187413" y="450849"/>
                  </a:lnTo>
                  <a:lnTo>
                    <a:pt x="187413" y="448309"/>
                  </a:lnTo>
                  <a:lnTo>
                    <a:pt x="188937" y="447039"/>
                  </a:lnTo>
                  <a:lnTo>
                    <a:pt x="188937" y="441959"/>
                  </a:lnTo>
                  <a:lnTo>
                    <a:pt x="190449" y="441959"/>
                  </a:lnTo>
                  <a:lnTo>
                    <a:pt x="190449" y="440689"/>
                  </a:lnTo>
                  <a:lnTo>
                    <a:pt x="191985" y="439419"/>
                  </a:lnTo>
                  <a:lnTo>
                    <a:pt x="191985" y="431799"/>
                  </a:lnTo>
                  <a:lnTo>
                    <a:pt x="193509" y="429259"/>
                  </a:lnTo>
                  <a:lnTo>
                    <a:pt x="193509" y="414019"/>
                  </a:lnTo>
                  <a:lnTo>
                    <a:pt x="195033" y="412749"/>
                  </a:lnTo>
                  <a:lnTo>
                    <a:pt x="195033" y="408939"/>
                  </a:lnTo>
                  <a:lnTo>
                    <a:pt x="196557" y="406399"/>
                  </a:lnTo>
                  <a:lnTo>
                    <a:pt x="196557" y="402589"/>
                  </a:lnTo>
                  <a:lnTo>
                    <a:pt x="198081" y="401319"/>
                  </a:lnTo>
                  <a:lnTo>
                    <a:pt x="198081" y="397509"/>
                  </a:lnTo>
                  <a:lnTo>
                    <a:pt x="199605" y="396239"/>
                  </a:lnTo>
                  <a:lnTo>
                    <a:pt x="199605" y="394969"/>
                  </a:lnTo>
                  <a:lnTo>
                    <a:pt x="201117" y="393699"/>
                  </a:lnTo>
                  <a:lnTo>
                    <a:pt x="201117" y="389889"/>
                  </a:lnTo>
                  <a:lnTo>
                    <a:pt x="202641" y="388619"/>
                  </a:lnTo>
                  <a:lnTo>
                    <a:pt x="202641" y="383539"/>
                  </a:lnTo>
                  <a:lnTo>
                    <a:pt x="204177" y="382269"/>
                  </a:lnTo>
                  <a:lnTo>
                    <a:pt x="204177" y="379729"/>
                  </a:lnTo>
                  <a:lnTo>
                    <a:pt x="205701" y="378459"/>
                  </a:lnTo>
                  <a:lnTo>
                    <a:pt x="205701" y="372109"/>
                  </a:lnTo>
                  <a:lnTo>
                    <a:pt x="207225" y="372109"/>
                  </a:lnTo>
                  <a:lnTo>
                    <a:pt x="207225" y="364489"/>
                  </a:lnTo>
                  <a:lnTo>
                    <a:pt x="208749" y="364489"/>
                  </a:lnTo>
                  <a:lnTo>
                    <a:pt x="208749" y="359409"/>
                  </a:lnTo>
                  <a:lnTo>
                    <a:pt x="210273" y="356869"/>
                  </a:lnTo>
                  <a:lnTo>
                    <a:pt x="210273" y="355599"/>
                  </a:lnTo>
                  <a:lnTo>
                    <a:pt x="211785" y="353059"/>
                  </a:lnTo>
                  <a:lnTo>
                    <a:pt x="211785" y="351789"/>
                  </a:lnTo>
                  <a:lnTo>
                    <a:pt x="213309" y="350519"/>
                  </a:lnTo>
                  <a:lnTo>
                    <a:pt x="213309" y="349249"/>
                  </a:lnTo>
                  <a:lnTo>
                    <a:pt x="216357" y="345439"/>
                  </a:lnTo>
                  <a:lnTo>
                    <a:pt x="216357" y="344169"/>
                  </a:lnTo>
                  <a:lnTo>
                    <a:pt x="217893" y="342899"/>
                  </a:lnTo>
                  <a:lnTo>
                    <a:pt x="217893" y="341629"/>
                  </a:lnTo>
                  <a:lnTo>
                    <a:pt x="219417" y="340359"/>
                  </a:lnTo>
                  <a:lnTo>
                    <a:pt x="219417" y="337819"/>
                  </a:lnTo>
                  <a:lnTo>
                    <a:pt x="223977" y="334009"/>
                  </a:lnTo>
                  <a:lnTo>
                    <a:pt x="223977" y="332739"/>
                  </a:lnTo>
                  <a:lnTo>
                    <a:pt x="227025" y="328929"/>
                  </a:lnTo>
                  <a:lnTo>
                    <a:pt x="227025" y="327659"/>
                  </a:lnTo>
                  <a:lnTo>
                    <a:pt x="231609" y="322579"/>
                  </a:lnTo>
                  <a:lnTo>
                    <a:pt x="231609" y="321309"/>
                  </a:lnTo>
                  <a:lnTo>
                    <a:pt x="233121" y="320039"/>
                  </a:lnTo>
                  <a:lnTo>
                    <a:pt x="233121" y="318769"/>
                  </a:lnTo>
                  <a:lnTo>
                    <a:pt x="237693" y="313689"/>
                  </a:lnTo>
                  <a:lnTo>
                    <a:pt x="237693" y="312419"/>
                  </a:lnTo>
                  <a:lnTo>
                    <a:pt x="239217" y="311149"/>
                  </a:lnTo>
                  <a:lnTo>
                    <a:pt x="239217" y="309879"/>
                  </a:lnTo>
                  <a:lnTo>
                    <a:pt x="243789" y="304799"/>
                  </a:lnTo>
                  <a:lnTo>
                    <a:pt x="243789" y="303529"/>
                  </a:lnTo>
                  <a:lnTo>
                    <a:pt x="246837" y="302259"/>
                  </a:lnTo>
                  <a:lnTo>
                    <a:pt x="246837" y="299719"/>
                  </a:lnTo>
                  <a:lnTo>
                    <a:pt x="248361" y="298449"/>
                  </a:lnTo>
                  <a:lnTo>
                    <a:pt x="249885" y="295909"/>
                  </a:lnTo>
                  <a:lnTo>
                    <a:pt x="251409" y="294639"/>
                  </a:lnTo>
                  <a:close/>
                </a:path>
                <a:path w="347979" h="796290">
                  <a:moveTo>
                    <a:pt x="257505" y="289559"/>
                  </a:moveTo>
                  <a:lnTo>
                    <a:pt x="89890" y="289559"/>
                  </a:lnTo>
                  <a:lnTo>
                    <a:pt x="91427" y="290829"/>
                  </a:lnTo>
                  <a:lnTo>
                    <a:pt x="92951" y="294639"/>
                  </a:lnTo>
                  <a:lnTo>
                    <a:pt x="252920" y="294639"/>
                  </a:lnTo>
                  <a:lnTo>
                    <a:pt x="254457" y="290829"/>
                  </a:lnTo>
                  <a:lnTo>
                    <a:pt x="257505" y="289559"/>
                  </a:lnTo>
                  <a:close/>
                </a:path>
                <a:path w="347979" h="796290">
                  <a:moveTo>
                    <a:pt x="319976" y="236219"/>
                  </a:moveTo>
                  <a:lnTo>
                    <a:pt x="25895" y="236219"/>
                  </a:lnTo>
                  <a:lnTo>
                    <a:pt x="27432" y="238759"/>
                  </a:lnTo>
                  <a:lnTo>
                    <a:pt x="30480" y="242569"/>
                  </a:lnTo>
                  <a:lnTo>
                    <a:pt x="33528" y="243839"/>
                  </a:lnTo>
                  <a:lnTo>
                    <a:pt x="39611" y="250189"/>
                  </a:lnTo>
                  <a:lnTo>
                    <a:pt x="42672" y="251459"/>
                  </a:lnTo>
                  <a:lnTo>
                    <a:pt x="50279" y="259079"/>
                  </a:lnTo>
                  <a:lnTo>
                    <a:pt x="53340" y="260349"/>
                  </a:lnTo>
                  <a:lnTo>
                    <a:pt x="59423" y="266699"/>
                  </a:lnTo>
                  <a:lnTo>
                    <a:pt x="62471" y="267969"/>
                  </a:lnTo>
                  <a:lnTo>
                    <a:pt x="65532" y="271779"/>
                  </a:lnTo>
                  <a:lnTo>
                    <a:pt x="68567" y="273049"/>
                  </a:lnTo>
                  <a:lnTo>
                    <a:pt x="71615" y="275589"/>
                  </a:lnTo>
                  <a:lnTo>
                    <a:pt x="74663" y="276859"/>
                  </a:lnTo>
                  <a:lnTo>
                    <a:pt x="77711" y="280669"/>
                  </a:lnTo>
                  <a:lnTo>
                    <a:pt x="80759" y="281939"/>
                  </a:lnTo>
                  <a:lnTo>
                    <a:pt x="88366" y="289559"/>
                  </a:lnTo>
                  <a:lnTo>
                    <a:pt x="259029" y="289559"/>
                  </a:lnTo>
                  <a:lnTo>
                    <a:pt x="260553" y="287019"/>
                  </a:lnTo>
                  <a:lnTo>
                    <a:pt x="263588" y="283209"/>
                  </a:lnTo>
                  <a:lnTo>
                    <a:pt x="266636" y="281939"/>
                  </a:lnTo>
                  <a:lnTo>
                    <a:pt x="274256" y="275589"/>
                  </a:lnTo>
                  <a:lnTo>
                    <a:pt x="277304" y="274319"/>
                  </a:lnTo>
                  <a:lnTo>
                    <a:pt x="297116" y="257809"/>
                  </a:lnTo>
                  <a:lnTo>
                    <a:pt x="300164" y="256539"/>
                  </a:lnTo>
                  <a:lnTo>
                    <a:pt x="310832" y="245109"/>
                  </a:lnTo>
                  <a:lnTo>
                    <a:pt x="313880" y="243839"/>
                  </a:lnTo>
                  <a:lnTo>
                    <a:pt x="318452" y="238759"/>
                  </a:lnTo>
                  <a:lnTo>
                    <a:pt x="319976" y="236219"/>
                  </a:lnTo>
                  <a:close/>
                </a:path>
                <a:path w="347979" h="796290">
                  <a:moveTo>
                    <a:pt x="298640" y="153669"/>
                  </a:moveTo>
                  <a:lnTo>
                    <a:pt x="47231" y="153669"/>
                  </a:lnTo>
                  <a:lnTo>
                    <a:pt x="44196" y="154939"/>
                  </a:lnTo>
                  <a:lnTo>
                    <a:pt x="41148" y="158749"/>
                  </a:lnTo>
                  <a:lnTo>
                    <a:pt x="35052" y="161289"/>
                  </a:lnTo>
                  <a:lnTo>
                    <a:pt x="33528" y="162559"/>
                  </a:lnTo>
                  <a:lnTo>
                    <a:pt x="24384" y="167639"/>
                  </a:lnTo>
                  <a:lnTo>
                    <a:pt x="22860" y="168909"/>
                  </a:lnTo>
                  <a:lnTo>
                    <a:pt x="19812" y="170179"/>
                  </a:lnTo>
                  <a:lnTo>
                    <a:pt x="18288" y="172719"/>
                  </a:lnTo>
                  <a:lnTo>
                    <a:pt x="15240" y="173989"/>
                  </a:lnTo>
                  <a:lnTo>
                    <a:pt x="3060" y="185419"/>
                  </a:lnTo>
                  <a:lnTo>
                    <a:pt x="3060" y="187959"/>
                  </a:lnTo>
                  <a:lnTo>
                    <a:pt x="0" y="190499"/>
                  </a:lnTo>
                  <a:lnTo>
                    <a:pt x="0" y="204469"/>
                  </a:lnTo>
                  <a:lnTo>
                    <a:pt x="1524" y="205739"/>
                  </a:lnTo>
                  <a:lnTo>
                    <a:pt x="1524" y="207009"/>
                  </a:lnTo>
                  <a:lnTo>
                    <a:pt x="3060" y="208279"/>
                  </a:lnTo>
                  <a:lnTo>
                    <a:pt x="3060" y="210819"/>
                  </a:lnTo>
                  <a:lnTo>
                    <a:pt x="4572" y="212089"/>
                  </a:lnTo>
                  <a:lnTo>
                    <a:pt x="4572" y="213359"/>
                  </a:lnTo>
                  <a:lnTo>
                    <a:pt x="6096" y="214629"/>
                  </a:lnTo>
                  <a:lnTo>
                    <a:pt x="7620" y="218439"/>
                  </a:lnTo>
                  <a:lnTo>
                    <a:pt x="10668" y="220979"/>
                  </a:lnTo>
                  <a:lnTo>
                    <a:pt x="12192" y="223519"/>
                  </a:lnTo>
                  <a:lnTo>
                    <a:pt x="13716" y="223519"/>
                  </a:lnTo>
                  <a:lnTo>
                    <a:pt x="16764" y="228599"/>
                  </a:lnTo>
                  <a:lnTo>
                    <a:pt x="24384" y="236219"/>
                  </a:lnTo>
                  <a:lnTo>
                    <a:pt x="321500" y="236219"/>
                  </a:lnTo>
                  <a:lnTo>
                    <a:pt x="326059" y="231139"/>
                  </a:lnTo>
                  <a:lnTo>
                    <a:pt x="329107" y="229869"/>
                  </a:lnTo>
                  <a:lnTo>
                    <a:pt x="330644" y="228599"/>
                  </a:lnTo>
                  <a:lnTo>
                    <a:pt x="330644" y="226059"/>
                  </a:lnTo>
                  <a:lnTo>
                    <a:pt x="333692" y="223519"/>
                  </a:lnTo>
                  <a:lnTo>
                    <a:pt x="335203" y="220979"/>
                  </a:lnTo>
                  <a:lnTo>
                    <a:pt x="338251" y="218439"/>
                  </a:lnTo>
                  <a:lnTo>
                    <a:pt x="339775" y="218439"/>
                  </a:lnTo>
                  <a:lnTo>
                    <a:pt x="339775" y="214629"/>
                  </a:lnTo>
                  <a:lnTo>
                    <a:pt x="342836" y="212089"/>
                  </a:lnTo>
                  <a:lnTo>
                    <a:pt x="342836" y="210819"/>
                  </a:lnTo>
                  <a:lnTo>
                    <a:pt x="344360" y="208279"/>
                  </a:lnTo>
                  <a:lnTo>
                    <a:pt x="344360" y="207009"/>
                  </a:lnTo>
                  <a:lnTo>
                    <a:pt x="345871" y="205739"/>
                  </a:lnTo>
                  <a:lnTo>
                    <a:pt x="345871" y="200659"/>
                  </a:lnTo>
                  <a:lnTo>
                    <a:pt x="347395" y="199389"/>
                  </a:lnTo>
                  <a:lnTo>
                    <a:pt x="347395" y="195579"/>
                  </a:lnTo>
                  <a:lnTo>
                    <a:pt x="345871" y="193039"/>
                  </a:lnTo>
                  <a:lnTo>
                    <a:pt x="345871" y="190499"/>
                  </a:lnTo>
                  <a:lnTo>
                    <a:pt x="344360" y="189229"/>
                  </a:lnTo>
                  <a:lnTo>
                    <a:pt x="344360" y="187959"/>
                  </a:lnTo>
                  <a:lnTo>
                    <a:pt x="341299" y="184149"/>
                  </a:lnTo>
                  <a:lnTo>
                    <a:pt x="341299" y="182879"/>
                  </a:lnTo>
                  <a:lnTo>
                    <a:pt x="336727" y="177799"/>
                  </a:lnTo>
                  <a:lnTo>
                    <a:pt x="333692" y="176529"/>
                  </a:lnTo>
                  <a:lnTo>
                    <a:pt x="324548" y="168909"/>
                  </a:lnTo>
                  <a:lnTo>
                    <a:pt x="315391" y="165099"/>
                  </a:lnTo>
                  <a:lnTo>
                    <a:pt x="313880" y="162559"/>
                  </a:lnTo>
                  <a:lnTo>
                    <a:pt x="304736" y="158749"/>
                  </a:lnTo>
                  <a:lnTo>
                    <a:pt x="301688" y="154939"/>
                  </a:lnTo>
                  <a:lnTo>
                    <a:pt x="298640" y="153669"/>
                  </a:lnTo>
                  <a:close/>
                </a:path>
                <a:path w="347979" h="796290">
                  <a:moveTo>
                    <a:pt x="287972" y="147319"/>
                  </a:moveTo>
                  <a:lnTo>
                    <a:pt x="59423" y="147319"/>
                  </a:lnTo>
                  <a:lnTo>
                    <a:pt x="53340" y="151129"/>
                  </a:lnTo>
                  <a:lnTo>
                    <a:pt x="50279" y="153669"/>
                  </a:lnTo>
                  <a:lnTo>
                    <a:pt x="295592" y="153669"/>
                  </a:lnTo>
                  <a:lnTo>
                    <a:pt x="294068" y="151129"/>
                  </a:lnTo>
                  <a:lnTo>
                    <a:pt x="287972" y="147319"/>
                  </a:lnTo>
                  <a:close/>
                </a:path>
                <a:path w="347979" h="796290">
                  <a:moveTo>
                    <a:pt x="208749" y="83819"/>
                  </a:moveTo>
                  <a:lnTo>
                    <a:pt x="137134" y="83819"/>
                  </a:lnTo>
                  <a:lnTo>
                    <a:pt x="135610" y="85089"/>
                  </a:lnTo>
                  <a:lnTo>
                    <a:pt x="134086" y="88899"/>
                  </a:lnTo>
                  <a:lnTo>
                    <a:pt x="124942" y="97789"/>
                  </a:lnTo>
                  <a:lnTo>
                    <a:pt x="121894" y="99059"/>
                  </a:lnTo>
                  <a:lnTo>
                    <a:pt x="120370" y="100329"/>
                  </a:lnTo>
                  <a:lnTo>
                    <a:pt x="120370" y="101599"/>
                  </a:lnTo>
                  <a:lnTo>
                    <a:pt x="117335" y="104139"/>
                  </a:lnTo>
                  <a:lnTo>
                    <a:pt x="105143" y="115569"/>
                  </a:lnTo>
                  <a:lnTo>
                    <a:pt x="102082" y="116839"/>
                  </a:lnTo>
                  <a:lnTo>
                    <a:pt x="94475" y="124459"/>
                  </a:lnTo>
                  <a:lnTo>
                    <a:pt x="89890" y="128269"/>
                  </a:lnTo>
                  <a:lnTo>
                    <a:pt x="86842" y="129539"/>
                  </a:lnTo>
                  <a:lnTo>
                    <a:pt x="79235" y="135889"/>
                  </a:lnTo>
                  <a:lnTo>
                    <a:pt x="76187" y="137159"/>
                  </a:lnTo>
                  <a:lnTo>
                    <a:pt x="74663" y="138429"/>
                  </a:lnTo>
                  <a:lnTo>
                    <a:pt x="68567" y="142239"/>
                  </a:lnTo>
                  <a:lnTo>
                    <a:pt x="67043" y="143509"/>
                  </a:lnTo>
                  <a:lnTo>
                    <a:pt x="63995" y="144779"/>
                  </a:lnTo>
                  <a:lnTo>
                    <a:pt x="60947" y="147319"/>
                  </a:lnTo>
                  <a:lnTo>
                    <a:pt x="284924" y="147319"/>
                  </a:lnTo>
                  <a:lnTo>
                    <a:pt x="283400" y="144779"/>
                  </a:lnTo>
                  <a:lnTo>
                    <a:pt x="274256" y="139699"/>
                  </a:lnTo>
                  <a:lnTo>
                    <a:pt x="272745" y="138429"/>
                  </a:lnTo>
                  <a:lnTo>
                    <a:pt x="269697" y="137159"/>
                  </a:lnTo>
                  <a:lnTo>
                    <a:pt x="268173" y="135889"/>
                  </a:lnTo>
                  <a:lnTo>
                    <a:pt x="265112" y="134619"/>
                  </a:lnTo>
                  <a:lnTo>
                    <a:pt x="262077" y="130809"/>
                  </a:lnTo>
                  <a:lnTo>
                    <a:pt x="259029" y="129539"/>
                  </a:lnTo>
                  <a:lnTo>
                    <a:pt x="257505" y="128269"/>
                  </a:lnTo>
                  <a:lnTo>
                    <a:pt x="254457" y="126999"/>
                  </a:lnTo>
                  <a:lnTo>
                    <a:pt x="251409" y="123189"/>
                  </a:lnTo>
                  <a:lnTo>
                    <a:pt x="248361" y="121919"/>
                  </a:lnTo>
                  <a:lnTo>
                    <a:pt x="242265" y="115569"/>
                  </a:lnTo>
                  <a:lnTo>
                    <a:pt x="239217" y="114299"/>
                  </a:lnTo>
                  <a:lnTo>
                    <a:pt x="216357" y="91439"/>
                  </a:lnTo>
                  <a:lnTo>
                    <a:pt x="213309" y="90169"/>
                  </a:lnTo>
                  <a:lnTo>
                    <a:pt x="211785" y="88899"/>
                  </a:lnTo>
                  <a:lnTo>
                    <a:pt x="210273" y="85089"/>
                  </a:lnTo>
                  <a:lnTo>
                    <a:pt x="208749" y="83819"/>
                  </a:lnTo>
                  <a:close/>
                </a:path>
                <a:path w="347979" h="796290">
                  <a:moveTo>
                    <a:pt x="202641" y="77469"/>
                  </a:moveTo>
                  <a:lnTo>
                    <a:pt x="144754" y="77469"/>
                  </a:lnTo>
                  <a:lnTo>
                    <a:pt x="141706" y="78739"/>
                  </a:lnTo>
                  <a:lnTo>
                    <a:pt x="140169" y="82549"/>
                  </a:lnTo>
                  <a:lnTo>
                    <a:pt x="140169" y="83819"/>
                  </a:lnTo>
                  <a:lnTo>
                    <a:pt x="207225" y="83819"/>
                  </a:lnTo>
                  <a:lnTo>
                    <a:pt x="205701" y="82549"/>
                  </a:lnTo>
                  <a:lnTo>
                    <a:pt x="204177" y="78739"/>
                  </a:lnTo>
                  <a:lnTo>
                    <a:pt x="202641" y="77469"/>
                  </a:lnTo>
                  <a:close/>
                </a:path>
                <a:path w="347979" h="796290">
                  <a:moveTo>
                    <a:pt x="175221" y="0"/>
                  </a:moveTo>
                  <a:lnTo>
                    <a:pt x="172173" y="0"/>
                  </a:lnTo>
                  <a:lnTo>
                    <a:pt x="172173" y="12699"/>
                  </a:lnTo>
                  <a:lnTo>
                    <a:pt x="170649" y="13969"/>
                  </a:lnTo>
                  <a:lnTo>
                    <a:pt x="170649" y="22859"/>
                  </a:lnTo>
                  <a:lnTo>
                    <a:pt x="169138" y="24129"/>
                  </a:lnTo>
                  <a:lnTo>
                    <a:pt x="169138" y="29209"/>
                  </a:lnTo>
                  <a:lnTo>
                    <a:pt x="167614" y="30479"/>
                  </a:lnTo>
                  <a:lnTo>
                    <a:pt x="167614" y="35559"/>
                  </a:lnTo>
                  <a:lnTo>
                    <a:pt x="166090" y="36829"/>
                  </a:lnTo>
                  <a:lnTo>
                    <a:pt x="166090" y="39369"/>
                  </a:lnTo>
                  <a:lnTo>
                    <a:pt x="164553" y="40639"/>
                  </a:lnTo>
                  <a:lnTo>
                    <a:pt x="164553" y="43179"/>
                  </a:lnTo>
                  <a:lnTo>
                    <a:pt x="163029" y="44449"/>
                  </a:lnTo>
                  <a:lnTo>
                    <a:pt x="163029" y="46989"/>
                  </a:lnTo>
                  <a:lnTo>
                    <a:pt x="161505" y="48259"/>
                  </a:lnTo>
                  <a:lnTo>
                    <a:pt x="161505" y="52069"/>
                  </a:lnTo>
                  <a:lnTo>
                    <a:pt x="159981" y="53339"/>
                  </a:lnTo>
                  <a:lnTo>
                    <a:pt x="159981" y="54609"/>
                  </a:lnTo>
                  <a:lnTo>
                    <a:pt x="158470" y="55879"/>
                  </a:lnTo>
                  <a:lnTo>
                    <a:pt x="158470" y="58419"/>
                  </a:lnTo>
                  <a:lnTo>
                    <a:pt x="156946" y="59689"/>
                  </a:lnTo>
                  <a:lnTo>
                    <a:pt x="156946" y="60959"/>
                  </a:lnTo>
                  <a:lnTo>
                    <a:pt x="155422" y="62229"/>
                  </a:lnTo>
                  <a:lnTo>
                    <a:pt x="155422" y="63499"/>
                  </a:lnTo>
                  <a:lnTo>
                    <a:pt x="152361" y="67309"/>
                  </a:lnTo>
                  <a:lnTo>
                    <a:pt x="152361" y="68579"/>
                  </a:lnTo>
                  <a:lnTo>
                    <a:pt x="146278" y="74929"/>
                  </a:lnTo>
                  <a:lnTo>
                    <a:pt x="146278" y="77469"/>
                  </a:lnTo>
                  <a:lnTo>
                    <a:pt x="201117" y="77469"/>
                  </a:lnTo>
                  <a:lnTo>
                    <a:pt x="199605" y="74929"/>
                  </a:lnTo>
                  <a:lnTo>
                    <a:pt x="196557" y="71119"/>
                  </a:lnTo>
                  <a:lnTo>
                    <a:pt x="196557" y="69849"/>
                  </a:lnTo>
                  <a:lnTo>
                    <a:pt x="191985" y="66039"/>
                  </a:lnTo>
                  <a:lnTo>
                    <a:pt x="191985" y="63499"/>
                  </a:lnTo>
                  <a:lnTo>
                    <a:pt x="188937" y="60959"/>
                  </a:lnTo>
                  <a:lnTo>
                    <a:pt x="188937" y="58419"/>
                  </a:lnTo>
                  <a:lnTo>
                    <a:pt x="187413" y="55879"/>
                  </a:lnTo>
                  <a:lnTo>
                    <a:pt x="187413" y="54609"/>
                  </a:lnTo>
                  <a:lnTo>
                    <a:pt x="185889" y="53339"/>
                  </a:lnTo>
                  <a:lnTo>
                    <a:pt x="185889" y="50799"/>
                  </a:lnTo>
                  <a:lnTo>
                    <a:pt x="184365" y="48259"/>
                  </a:lnTo>
                  <a:lnTo>
                    <a:pt x="184365" y="46989"/>
                  </a:lnTo>
                  <a:lnTo>
                    <a:pt x="182841" y="45719"/>
                  </a:lnTo>
                  <a:lnTo>
                    <a:pt x="182841" y="43179"/>
                  </a:lnTo>
                  <a:lnTo>
                    <a:pt x="181317" y="40639"/>
                  </a:lnTo>
                  <a:lnTo>
                    <a:pt x="181317" y="38099"/>
                  </a:lnTo>
                  <a:lnTo>
                    <a:pt x="179793" y="36829"/>
                  </a:lnTo>
                  <a:lnTo>
                    <a:pt x="179793" y="35559"/>
                  </a:lnTo>
                  <a:lnTo>
                    <a:pt x="178269" y="33019"/>
                  </a:lnTo>
                  <a:lnTo>
                    <a:pt x="178269" y="29209"/>
                  </a:lnTo>
                  <a:lnTo>
                    <a:pt x="176745" y="27939"/>
                  </a:lnTo>
                  <a:lnTo>
                    <a:pt x="176745" y="17779"/>
                  </a:lnTo>
                  <a:lnTo>
                    <a:pt x="175221" y="15239"/>
                  </a:lnTo>
                  <a:lnTo>
                    <a:pt x="175221" y="0"/>
                  </a:lnTo>
                  <a:close/>
                </a:path>
              </a:pathLst>
            </a:custGeom>
            <a:solidFill>
              <a:srgbClr val="C67B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5774265" y="5921362"/>
              <a:ext cx="347980" cy="797560"/>
            </a:xfrm>
            <a:custGeom>
              <a:avLst/>
              <a:gdLst/>
              <a:ahLst/>
              <a:cxnLst/>
              <a:rect l="l" t="t" r="r" b="b"/>
              <a:pathLst>
                <a:path w="347979" h="797559">
                  <a:moveTo>
                    <a:pt x="172173" y="796937"/>
                  </a:moveTo>
                  <a:lnTo>
                    <a:pt x="172173" y="795413"/>
                  </a:lnTo>
                  <a:lnTo>
                    <a:pt x="172173" y="749693"/>
                  </a:lnTo>
                  <a:lnTo>
                    <a:pt x="173697" y="748169"/>
                  </a:lnTo>
                  <a:lnTo>
                    <a:pt x="173697" y="710082"/>
                  </a:lnTo>
                  <a:lnTo>
                    <a:pt x="172173" y="710082"/>
                  </a:lnTo>
                  <a:lnTo>
                    <a:pt x="172173" y="635406"/>
                  </a:lnTo>
                  <a:lnTo>
                    <a:pt x="170649" y="633895"/>
                  </a:lnTo>
                  <a:lnTo>
                    <a:pt x="170649" y="554659"/>
                  </a:lnTo>
                  <a:lnTo>
                    <a:pt x="169138" y="553135"/>
                  </a:lnTo>
                  <a:lnTo>
                    <a:pt x="169138" y="499808"/>
                  </a:lnTo>
                  <a:lnTo>
                    <a:pt x="167614" y="499808"/>
                  </a:lnTo>
                  <a:lnTo>
                    <a:pt x="167614" y="478472"/>
                  </a:lnTo>
                  <a:lnTo>
                    <a:pt x="166090" y="476948"/>
                  </a:lnTo>
                  <a:lnTo>
                    <a:pt x="166090" y="469328"/>
                  </a:lnTo>
                  <a:lnTo>
                    <a:pt x="164553" y="467804"/>
                  </a:lnTo>
                  <a:lnTo>
                    <a:pt x="164553" y="466280"/>
                  </a:lnTo>
                  <a:lnTo>
                    <a:pt x="164553" y="464756"/>
                  </a:lnTo>
                  <a:lnTo>
                    <a:pt x="163029" y="463232"/>
                  </a:lnTo>
                  <a:lnTo>
                    <a:pt x="163029" y="461708"/>
                  </a:lnTo>
                  <a:lnTo>
                    <a:pt x="163029" y="460171"/>
                  </a:lnTo>
                  <a:lnTo>
                    <a:pt x="163029" y="458660"/>
                  </a:lnTo>
                  <a:lnTo>
                    <a:pt x="161505" y="457136"/>
                  </a:lnTo>
                  <a:lnTo>
                    <a:pt x="161505" y="455612"/>
                  </a:lnTo>
                  <a:lnTo>
                    <a:pt x="161505" y="454088"/>
                  </a:lnTo>
                  <a:lnTo>
                    <a:pt x="159981" y="452564"/>
                  </a:lnTo>
                  <a:lnTo>
                    <a:pt x="159981" y="451040"/>
                  </a:lnTo>
                  <a:lnTo>
                    <a:pt x="159981" y="449516"/>
                  </a:lnTo>
                  <a:lnTo>
                    <a:pt x="158470" y="447979"/>
                  </a:lnTo>
                  <a:lnTo>
                    <a:pt x="158470" y="446468"/>
                  </a:lnTo>
                  <a:lnTo>
                    <a:pt x="156946" y="444944"/>
                  </a:lnTo>
                  <a:lnTo>
                    <a:pt x="156946" y="441896"/>
                  </a:lnTo>
                  <a:lnTo>
                    <a:pt x="155422" y="440372"/>
                  </a:lnTo>
                  <a:lnTo>
                    <a:pt x="155422" y="438848"/>
                  </a:lnTo>
                  <a:lnTo>
                    <a:pt x="155422" y="435800"/>
                  </a:lnTo>
                  <a:lnTo>
                    <a:pt x="153898" y="434276"/>
                  </a:lnTo>
                  <a:lnTo>
                    <a:pt x="153898" y="431228"/>
                  </a:lnTo>
                  <a:lnTo>
                    <a:pt x="153898" y="429704"/>
                  </a:lnTo>
                  <a:lnTo>
                    <a:pt x="153898" y="426656"/>
                  </a:lnTo>
                  <a:lnTo>
                    <a:pt x="152361" y="425145"/>
                  </a:lnTo>
                  <a:lnTo>
                    <a:pt x="152361" y="423608"/>
                  </a:lnTo>
                  <a:lnTo>
                    <a:pt x="152361" y="412953"/>
                  </a:lnTo>
                  <a:lnTo>
                    <a:pt x="150837" y="411429"/>
                  </a:lnTo>
                  <a:lnTo>
                    <a:pt x="150837" y="409892"/>
                  </a:lnTo>
                  <a:lnTo>
                    <a:pt x="150837" y="408368"/>
                  </a:lnTo>
                  <a:lnTo>
                    <a:pt x="150837" y="406844"/>
                  </a:lnTo>
                  <a:lnTo>
                    <a:pt x="150837" y="405320"/>
                  </a:lnTo>
                  <a:lnTo>
                    <a:pt x="149313" y="403796"/>
                  </a:lnTo>
                  <a:lnTo>
                    <a:pt x="149313" y="402285"/>
                  </a:lnTo>
                  <a:lnTo>
                    <a:pt x="149313" y="400761"/>
                  </a:lnTo>
                  <a:lnTo>
                    <a:pt x="147802" y="399237"/>
                  </a:lnTo>
                  <a:lnTo>
                    <a:pt x="147802" y="397700"/>
                  </a:lnTo>
                  <a:lnTo>
                    <a:pt x="147802" y="396176"/>
                  </a:lnTo>
                  <a:lnTo>
                    <a:pt x="146278" y="394652"/>
                  </a:lnTo>
                  <a:lnTo>
                    <a:pt x="146278" y="393128"/>
                  </a:lnTo>
                  <a:lnTo>
                    <a:pt x="146278" y="391617"/>
                  </a:lnTo>
                  <a:lnTo>
                    <a:pt x="144754" y="390093"/>
                  </a:lnTo>
                  <a:lnTo>
                    <a:pt x="144754" y="388569"/>
                  </a:lnTo>
                  <a:lnTo>
                    <a:pt x="144754" y="387045"/>
                  </a:lnTo>
                  <a:lnTo>
                    <a:pt x="143230" y="385508"/>
                  </a:lnTo>
                  <a:lnTo>
                    <a:pt x="143230" y="383984"/>
                  </a:lnTo>
                  <a:lnTo>
                    <a:pt x="141706" y="382460"/>
                  </a:lnTo>
                  <a:lnTo>
                    <a:pt x="141706" y="380949"/>
                  </a:lnTo>
                  <a:lnTo>
                    <a:pt x="141706" y="379425"/>
                  </a:lnTo>
                  <a:lnTo>
                    <a:pt x="141706" y="377901"/>
                  </a:lnTo>
                  <a:lnTo>
                    <a:pt x="141706" y="376377"/>
                  </a:lnTo>
                  <a:lnTo>
                    <a:pt x="140169" y="374853"/>
                  </a:lnTo>
                  <a:lnTo>
                    <a:pt x="140169" y="371792"/>
                  </a:lnTo>
                  <a:lnTo>
                    <a:pt x="140169" y="370281"/>
                  </a:lnTo>
                  <a:lnTo>
                    <a:pt x="140169" y="368757"/>
                  </a:lnTo>
                  <a:lnTo>
                    <a:pt x="138658" y="365709"/>
                  </a:lnTo>
                  <a:lnTo>
                    <a:pt x="138658" y="364185"/>
                  </a:lnTo>
                  <a:lnTo>
                    <a:pt x="137134" y="361137"/>
                  </a:lnTo>
                  <a:lnTo>
                    <a:pt x="137134" y="359613"/>
                  </a:lnTo>
                  <a:lnTo>
                    <a:pt x="137134" y="356565"/>
                  </a:lnTo>
                  <a:lnTo>
                    <a:pt x="135610" y="355041"/>
                  </a:lnTo>
                  <a:lnTo>
                    <a:pt x="135610" y="353517"/>
                  </a:lnTo>
                  <a:lnTo>
                    <a:pt x="134086" y="351993"/>
                  </a:lnTo>
                  <a:lnTo>
                    <a:pt x="134086" y="350469"/>
                  </a:lnTo>
                  <a:lnTo>
                    <a:pt x="132562" y="348957"/>
                  </a:lnTo>
                  <a:lnTo>
                    <a:pt x="132562" y="347421"/>
                  </a:lnTo>
                  <a:lnTo>
                    <a:pt x="131038" y="345897"/>
                  </a:lnTo>
                  <a:lnTo>
                    <a:pt x="131038" y="344373"/>
                  </a:lnTo>
                  <a:lnTo>
                    <a:pt x="129514" y="342849"/>
                  </a:lnTo>
                  <a:lnTo>
                    <a:pt x="127990" y="341325"/>
                  </a:lnTo>
                  <a:lnTo>
                    <a:pt x="126466" y="339801"/>
                  </a:lnTo>
                  <a:lnTo>
                    <a:pt x="126466" y="338277"/>
                  </a:lnTo>
                  <a:lnTo>
                    <a:pt x="124942" y="336765"/>
                  </a:lnTo>
                  <a:lnTo>
                    <a:pt x="124942" y="335241"/>
                  </a:lnTo>
                  <a:lnTo>
                    <a:pt x="123418" y="333705"/>
                  </a:lnTo>
                  <a:lnTo>
                    <a:pt x="121894" y="332181"/>
                  </a:lnTo>
                  <a:lnTo>
                    <a:pt x="120370" y="330657"/>
                  </a:lnTo>
                  <a:lnTo>
                    <a:pt x="120370" y="329133"/>
                  </a:lnTo>
                  <a:lnTo>
                    <a:pt x="118846" y="327609"/>
                  </a:lnTo>
                  <a:lnTo>
                    <a:pt x="117335" y="326097"/>
                  </a:lnTo>
                  <a:lnTo>
                    <a:pt x="117335" y="324573"/>
                  </a:lnTo>
                  <a:lnTo>
                    <a:pt x="115811" y="323049"/>
                  </a:lnTo>
                  <a:lnTo>
                    <a:pt x="114274" y="321513"/>
                  </a:lnTo>
                  <a:lnTo>
                    <a:pt x="114274" y="319989"/>
                  </a:lnTo>
                  <a:lnTo>
                    <a:pt x="112750" y="318465"/>
                  </a:lnTo>
                  <a:lnTo>
                    <a:pt x="111226" y="316941"/>
                  </a:lnTo>
                  <a:lnTo>
                    <a:pt x="111226" y="315429"/>
                  </a:lnTo>
                  <a:lnTo>
                    <a:pt x="109702" y="313905"/>
                  </a:lnTo>
                  <a:lnTo>
                    <a:pt x="108178" y="312381"/>
                  </a:lnTo>
                  <a:lnTo>
                    <a:pt x="106667" y="310857"/>
                  </a:lnTo>
                  <a:lnTo>
                    <a:pt x="106667" y="309321"/>
                  </a:lnTo>
                  <a:lnTo>
                    <a:pt x="105143" y="307797"/>
                  </a:lnTo>
                  <a:lnTo>
                    <a:pt x="105143" y="306273"/>
                  </a:lnTo>
                  <a:lnTo>
                    <a:pt x="102082" y="304761"/>
                  </a:lnTo>
                  <a:lnTo>
                    <a:pt x="102082" y="303237"/>
                  </a:lnTo>
                  <a:lnTo>
                    <a:pt x="100558" y="301713"/>
                  </a:lnTo>
                  <a:lnTo>
                    <a:pt x="99034" y="300189"/>
                  </a:lnTo>
                  <a:lnTo>
                    <a:pt x="97510" y="298665"/>
                  </a:lnTo>
                  <a:lnTo>
                    <a:pt x="95999" y="295605"/>
                  </a:lnTo>
                  <a:lnTo>
                    <a:pt x="94475" y="294081"/>
                  </a:lnTo>
                  <a:lnTo>
                    <a:pt x="92951" y="294081"/>
                  </a:lnTo>
                  <a:lnTo>
                    <a:pt x="91427" y="291045"/>
                  </a:lnTo>
                  <a:lnTo>
                    <a:pt x="89890" y="289521"/>
                  </a:lnTo>
                  <a:lnTo>
                    <a:pt x="88366" y="289521"/>
                  </a:lnTo>
                  <a:lnTo>
                    <a:pt x="85331" y="286473"/>
                  </a:lnTo>
                  <a:lnTo>
                    <a:pt x="83807" y="284949"/>
                  </a:lnTo>
                  <a:lnTo>
                    <a:pt x="82283" y="283413"/>
                  </a:lnTo>
                  <a:lnTo>
                    <a:pt x="80759" y="281901"/>
                  </a:lnTo>
                  <a:lnTo>
                    <a:pt x="77711" y="280377"/>
                  </a:lnTo>
                  <a:lnTo>
                    <a:pt x="76187" y="278853"/>
                  </a:lnTo>
                  <a:lnTo>
                    <a:pt x="74663" y="277329"/>
                  </a:lnTo>
                  <a:lnTo>
                    <a:pt x="71615" y="275805"/>
                  </a:lnTo>
                  <a:lnTo>
                    <a:pt x="70091" y="274281"/>
                  </a:lnTo>
                  <a:lnTo>
                    <a:pt x="68567" y="272757"/>
                  </a:lnTo>
                  <a:lnTo>
                    <a:pt x="65532" y="271233"/>
                  </a:lnTo>
                  <a:lnTo>
                    <a:pt x="63995" y="269709"/>
                  </a:lnTo>
                  <a:lnTo>
                    <a:pt x="62471" y="268185"/>
                  </a:lnTo>
                  <a:lnTo>
                    <a:pt x="59423" y="266661"/>
                  </a:lnTo>
                  <a:lnTo>
                    <a:pt x="57899" y="265137"/>
                  </a:lnTo>
                  <a:lnTo>
                    <a:pt x="56375" y="263613"/>
                  </a:lnTo>
                  <a:lnTo>
                    <a:pt x="54864" y="262089"/>
                  </a:lnTo>
                  <a:lnTo>
                    <a:pt x="53340" y="260578"/>
                  </a:lnTo>
                  <a:lnTo>
                    <a:pt x="50279" y="259041"/>
                  </a:lnTo>
                  <a:lnTo>
                    <a:pt x="48755" y="257517"/>
                  </a:lnTo>
                  <a:lnTo>
                    <a:pt x="47231" y="255993"/>
                  </a:lnTo>
                  <a:lnTo>
                    <a:pt x="45707" y="254469"/>
                  </a:lnTo>
                  <a:lnTo>
                    <a:pt x="44196" y="252945"/>
                  </a:lnTo>
                  <a:lnTo>
                    <a:pt x="42672" y="251421"/>
                  </a:lnTo>
                  <a:lnTo>
                    <a:pt x="39611" y="249910"/>
                  </a:lnTo>
                  <a:lnTo>
                    <a:pt x="38087" y="248386"/>
                  </a:lnTo>
                  <a:lnTo>
                    <a:pt x="36563" y="246862"/>
                  </a:lnTo>
                  <a:lnTo>
                    <a:pt x="35052" y="245325"/>
                  </a:lnTo>
                  <a:lnTo>
                    <a:pt x="33528" y="243801"/>
                  </a:lnTo>
                  <a:lnTo>
                    <a:pt x="30480" y="242277"/>
                  </a:lnTo>
                  <a:lnTo>
                    <a:pt x="28956" y="240753"/>
                  </a:lnTo>
                  <a:lnTo>
                    <a:pt x="27432" y="239242"/>
                  </a:lnTo>
                  <a:lnTo>
                    <a:pt x="25895" y="236194"/>
                  </a:lnTo>
                  <a:lnTo>
                    <a:pt x="24384" y="236194"/>
                  </a:lnTo>
                  <a:lnTo>
                    <a:pt x="22860" y="234670"/>
                  </a:lnTo>
                  <a:lnTo>
                    <a:pt x="21336" y="233133"/>
                  </a:lnTo>
                  <a:lnTo>
                    <a:pt x="19812" y="231609"/>
                  </a:lnTo>
                  <a:lnTo>
                    <a:pt x="18288" y="230085"/>
                  </a:lnTo>
                  <a:lnTo>
                    <a:pt x="16764" y="228561"/>
                  </a:lnTo>
                  <a:lnTo>
                    <a:pt x="15240" y="225526"/>
                  </a:lnTo>
                  <a:lnTo>
                    <a:pt x="13716" y="224002"/>
                  </a:lnTo>
                  <a:lnTo>
                    <a:pt x="12192" y="224002"/>
                  </a:lnTo>
                  <a:lnTo>
                    <a:pt x="10668" y="220941"/>
                  </a:lnTo>
                  <a:lnTo>
                    <a:pt x="9144" y="219417"/>
                  </a:lnTo>
                  <a:lnTo>
                    <a:pt x="7620" y="217893"/>
                  </a:lnTo>
                  <a:lnTo>
                    <a:pt x="6096" y="214858"/>
                  </a:lnTo>
                  <a:lnTo>
                    <a:pt x="4572" y="213334"/>
                  </a:lnTo>
                  <a:lnTo>
                    <a:pt x="4572" y="211810"/>
                  </a:lnTo>
                  <a:lnTo>
                    <a:pt x="3060" y="210286"/>
                  </a:lnTo>
                  <a:lnTo>
                    <a:pt x="3060" y="208762"/>
                  </a:lnTo>
                  <a:lnTo>
                    <a:pt x="1524" y="207225"/>
                  </a:lnTo>
                  <a:lnTo>
                    <a:pt x="1524" y="205714"/>
                  </a:lnTo>
                  <a:lnTo>
                    <a:pt x="0" y="204190"/>
                  </a:lnTo>
                  <a:lnTo>
                    <a:pt x="0" y="190474"/>
                  </a:lnTo>
                  <a:lnTo>
                    <a:pt x="1524" y="188950"/>
                  </a:lnTo>
                  <a:lnTo>
                    <a:pt x="3060" y="187426"/>
                  </a:lnTo>
                  <a:lnTo>
                    <a:pt x="3060" y="185902"/>
                  </a:lnTo>
                  <a:lnTo>
                    <a:pt x="4572" y="184378"/>
                  </a:lnTo>
                  <a:lnTo>
                    <a:pt x="6096" y="182854"/>
                  </a:lnTo>
                  <a:lnTo>
                    <a:pt x="7620" y="181330"/>
                  </a:lnTo>
                  <a:lnTo>
                    <a:pt x="9144" y="179806"/>
                  </a:lnTo>
                  <a:lnTo>
                    <a:pt x="10668" y="178282"/>
                  </a:lnTo>
                  <a:lnTo>
                    <a:pt x="12192" y="176758"/>
                  </a:lnTo>
                  <a:lnTo>
                    <a:pt x="13716" y="175234"/>
                  </a:lnTo>
                  <a:lnTo>
                    <a:pt x="15240" y="173710"/>
                  </a:lnTo>
                  <a:lnTo>
                    <a:pt x="18288" y="172199"/>
                  </a:lnTo>
                  <a:lnTo>
                    <a:pt x="19812" y="170662"/>
                  </a:lnTo>
                  <a:lnTo>
                    <a:pt x="22860" y="169138"/>
                  </a:lnTo>
                  <a:lnTo>
                    <a:pt x="24384" y="167614"/>
                  </a:lnTo>
                  <a:lnTo>
                    <a:pt x="27432" y="166090"/>
                  </a:lnTo>
                  <a:lnTo>
                    <a:pt x="30480" y="164566"/>
                  </a:lnTo>
                  <a:lnTo>
                    <a:pt x="33528" y="163042"/>
                  </a:lnTo>
                  <a:lnTo>
                    <a:pt x="35052" y="161531"/>
                  </a:lnTo>
                  <a:lnTo>
                    <a:pt x="38087" y="160007"/>
                  </a:lnTo>
                  <a:lnTo>
                    <a:pt x="41148" y="158483"/>
                  </a:lnTo>
                  <a:lnTo>
                    <a:pt x="44196" y="155422"/>
                  </a:lnTo>
                  <a:lnTo>
                    <a:pt x="47231" y="153898"/>
                  </a:lnTo>
                  <a:lnTo>
                    <a:pt x="50279" y="153898"/>
                  </a:lnTo>
                  <a:lnTo>
                    <a:pt x="53340" y="150863"/>
                  </a:lnTo>
                  <a:lnTo>
                    <a:pt x="56375" y="149339"/>
                  </a:lnTo>
                  <a:lnTo>
                    <a:pt x="59423" y="147815"/>
                  </a:lnTo>
                  <a:lnTo>
                    <a:pt x="60947" y="147815"/>
                  </a:lnTo>
                  <a:lnTo>
                    <a:pt x="63995" y="144754"/>
                  </a:lnTo>
                  <a:lnTo>
                    <a:pt x="67043" y="143230"/>
                  </a:lnTo>
                  <a:lnTo>
                    <a:pt x="68567" y="141706"/>
                  </a:lnTo>
                  <a:lnTo>
                    <a:pt x="71615" y="140195"/>
                  </a:lnTo>
                  <a:lnTo>
                    <a:pt x="74663" y="138671"/>
                  </a:lnTo>
                  <a:lnTo>
                    <a:pt x="76187" y="137147"/>
                  </a:lnTo>
                  <a:lnTo>
                    <a:pt x="79235" y="135623"/>
                  </a:lnTo>
                  <a:lnTo>
                    <a:pt x="80759" y="134099"/>
                  </a:lnTo>
                  <a:lnTo>
                    <a:pt x="83807" y="132562"/>
                  </a:lnTo>
                  <a:lnTo>
                    <a:pt x="85331" y="131038"/>
                  </a:lnTo>
                  <a:lnTo>
                    <a:pt x="86842" y="129527"/>
                  </a:lnTo>
                  <a:lnTo>
                    <a:pt x="89890" y="128003"/>
                  </a:lnTo>
                  <a:lnTo>
                    <a:pt x="91427" y="126479"/>
                  </a:lnTo>
                  <a:lnTo>
                    <a:pt x="94475" y="124955"/>
                  </a:lnTo>
                  <a:lnTo>
                    <a:pt x="95999" y="123431"/>
                  </a:lnTo>
                  <a:lnTo>
                    <a:pt x="97510" y="121907"/>
                  </a:lnTo>
                  <a:lnTo>
                    <a:pt x="99034" y="120383"/>
                  </a:lnTo>
                  <a:lnTo>
                    <a:pt x="100558" y="118846"/>
                  </a:lnTo>
                  <a:lnTo>
                    <a:pt x="102082" y="117335"/>
                  </a:lnTo>
                  <a:lnTo>
                    <a:pt x="105143" y="115811"/>
                  </a:lnTo>
                  <a:lnTo>
                    <a:pt x="106667" y="114287"/>
                  </a:lnTo>
                  <a:lnTo>
                    <a:pt x="108178" y="112763"/>
                  </a:lnTo>
                  <a:lnTo>
                    <a:pt x="109702" y="111239"/>
                  </a:lnTo>
                  <a:lnTo>
                    <a:pt x="111226" y="109715"/>
                  </a:lnTo>
                  <a:lnTo>
                    <a:pt x="112750" y="108191"/>
                  </a:lnTo>
                  <a:lnTo>
                    <a:pt x="114274" y="106667"/>
                  </a:lnTo>
                  <a:lnTo>
                    <a:pt x="115811" y="105143"/>
                  </a:lnTo>
                  <a:lnTo>
                    <a:pt x="117335" y="103619"/>
                  </a:lnTo>
                  <a:lnTo>
                    <a:pt x="120370" y="102095"/>
                  </a:lnTo>
                  <a:lnTo>
                    <a:pt x="120370" y="100571"/>
                  </a:lnTo>
                  <a:lnTo>
                    <a:pt x="121894" y="99047"/>
                  </a:lnTo>
                  <a:lnTo>
                    <a:pt x="124942" y="97523"/>
                  </a:lnTo>
                  <a:lnTo>
                    <a:pt x="126466" y="96011"/>
                  </a:lnTo>
                  <a:lnTo>
                    <a:pt x="127990" y="94475"/>
                  </a:lnTo>
                  <a:lnTo>
                    <a:pt x="129514" y="92951"/>
                  </a:lnTo>
                  <a:lnTo>
                    <a:pt x="131038" y="91427"/>
                  </a:lnTo>
                  <a:lnTo>
                    <a:pt x="132562" y="89903"/>
                  </a:lnTo>
                  <a:lnTo>
                    <a:pt x="134086" y="88379"/>
                  </a:lnTo>
                  <a:lnTo>
                    <a:pt x="135610" y="85343"/>
                  </a:lnTo>
                  <a:lnTo>
                    <a:pt x="137134" y="83819"/>
                  </a:lnTo>
                  <a:lnTo>
                    <a:pt x="140169" y="83819"/>
                  </a:lnTo>
                  <a:lnTo>
                    <a:pt x="140169" y="82295"/>
                  </a:lnTo>
                  <a:lnTo>
                    <a:pt x="141706" y="79235"/>
                  </a:lnTo>
                  <a:lnTo>
                    <a:pt x="144754" y="77711"/>
                  </a:lnTo>
                  <a:lnTo>
                    <a:pt x="146278" y="77711"/>
                  </a:lnTo>
                  <a:lnTo>
                    <a:pt x="146278" y="74663"/>
                  </a:lnTo>
                  <a:lnTo>
                    <a:pt x="147802" y="73151"/>
                  </a:lnTo>
                  <a:lnTo>
                    <a:pt x="149313" y="71627"/>
                  </a:lnTo>
                  <a:lnTo>
                    <a:pt x="150837" y="70103"/>
                  </a:lnTo>
                  <a:lnTo>
                    <a:pt x="152361" y="68567"/>
                  </a:lnTo>
                  <a:lnTo>
                    <a:pt x="152361" y="67043"/>
                  </a:lnTo>
                  <a:lnTo>
                    <a:pt x="153898" y="65519"/>
                  </a:lnTo>
                  <a:lnTo>
                    <a:pt x="155422" y="63995"/>
                  </a:lnTo>
                  <a:lnTo>
                    <a:pt x="155422" y="62483"/>
                  </a:lnTo>
                  <a:lnTo>
                    <a:pt x="156946" y="60959"/>
                  </a:lnTo>
                  <a:lnTo>
                    <a:pt x="156946" y="59435"/>
                  </a:lnTo>
                  <a:lnTo>
                    <a:pt x="158470" y="57911"/>
                  </a:lnTo>
                  <a:lnTo>
                    <a:pt x="158470" y="56375"/>
                  </a:lnTo>
                  <a:lnTo>
                    <a:pt x="159981" y="54851"/>
                  </a:lnTo>
                  <a:lnTo>
                    <a:pt x="159981" y="53327"/>
                  </a:lnTo>
                  <a:lnTo>
                    <a:pt x="161505" y="51815"/>
                  </a:lnTo>
                  <a:lnTo>
                    <a:pt x="161505" y="50291"/>
                  </a:lnTo>
                  <a:lnTo>
                    <a:pt x="161505" y="48767"/>
                  </a:lnTo>
                  <a:lnTo>
                    <a:pt x="163029" y="47243"/>
                  </a:lnTo>
                  <a:lnTo>
                    <a:pt x="163029" y="45719"/>
                  </a:lnTo>
                  <a:lnTo>
                    <a:pt x="163029" y="44195"/>
                  </a:lnTo>
                  <a:lnTo>
                    <a:pt x="164553" y="42659"/>
                  </a:lnTo>
                  <a:lnTo>
                    <a:pt x="164553" y="41147"/>
                  </a:lnTo>
                  <a:lnTo>
                    <a:pt x="166090" y="39623"/>
                  </a:lnTo>
                  <a:lnTo>
                    <a:pt x="166090" y="38099"/>
                  </a:lnTo>
                  <a:lnTo>
                    <a:pt x="166090" y="36575"/>
                  </a:lnTo>
                  <a:lnTo>
                    <a:pt x="167614" y="35051"/>
                  </a:lnTo>
                  <a:lnTo>
                    <a:pt x="167614" y="33527"/>
                  </a:lnTo>
                  <a:lnTo>
                    <a:pt x="167614" y="32003"/>
                  </a:lnTo>
                  <a:lnTo>
                    <a:pt x="167614" y="30479"/>
                  </a:lnTo>
                  <a:lnTo>
                    <a:pt x="169138" y="28955"/>
                  </a:lnTo>
                  <a:lnTo>
                    <a:pt x="169138" y="27431"/>
                  </a:lnTo>
                  <a:lnTo>
                    <a:pt x="169138" y="25907"/>
                  </a:lnTo>
                  <a:lnTo>
                    <a:pt x="169138" y="24383"/>
                  </a:lnTo>
                  <a:lnTo>
                    <a:pt x="170649" y="22859"/>
                  </a:lnTo>
                  <a:lnTo>
                    <a:pt x="170649" y="19824"/>
                  </a:lnTo>
                  <a:lnTo>
                    <a:pt x="170649" y="18287"/>
                  </a:lnTo>
                  <a:lnTo>
                    <a:pt x="170649" y="15239"/>
                  </a:lnTo>
                  <a:lnTo>
                    <a:pt x="170649" y="13715"/>
                  </a:lnTo>
                  <a:lnTo>
                    <a:pt x="172173" y="12191"/>
                  </a:lnTo>
                  <a:lnTo>
                    <a:pt x="172173" y="0"/>
                  </a:lnTo>
                  <a:lnTo>
                    <a:pt x="175221" y="0"/>
                  </a:lnTo>
                  <a:lnTo>
                    <a:pt x="175221" y="15239"/>
                  </a:lnTo>
                  <a:lnTo>
                    <a:pt x="176745" y="18287"/>
                  </a:lnTo>
                  <a:lnTo>
                    <a:pt x="176745" y="27431"/>
                  </a:lnTo>
                  <a:lnTo>
                    <a:pt x="178269" y="28955"/>
                  </a:lnTo>
                  <a:lnTo>
                    <a:pt x="178269" y="30479"/>
                  </a:lnTo>
                  <a:lnTo>
                    <a:pt x="178269" y="32003"/>
                  </a:lnTo>
                  <a:lnTo>
                    <a:pt x="178269" y="33527"/>
                  </a:lnTo>
                  <a:lnTo>
                    <a:pt x="179793" y="35051"/>
                  </a:lnTo>
                  <a:lnTo>
                    <a:pt x="179793" y="36575"/>
                  </a:lnTo>
                  <a:lnTo>
                    <a:pt x="181317" y="38099"/>
                  </a:lnTo>
                  <a:lnTo>
                    <a:pt x="181317" y="39623"/>
                  </a:lnTo>
                  <a:lnTo>
                    <a:pt x="181317" y="41147"/>
                  </a:lnTo>
                  <a:lnTo>
                    <a:pt x="182841" y="42659"/>
                  </a:lnTo>
                  <a:lnTo>
                    <a:pt x="182841" y="44195"/>
                  </a:lnTo>
                  <a:lnTo>
                    <a:pt x="182841" y="45719"/>
                  </a:lnTo>
                  <a:lnTo>
                    <a:pt x="184365" y="47243"/>
                  </a:lnTo>
                  <a:lnTo>
                    <a:pt x="184365" y="48767"/>
                  </a:lnTo>
                  <a:lnTo>
                    <a:pt x="185889" y="50291"/>
                  </a:lnTo>
                  <a:lnTo>
                    <a:pt x="185889" y="51815"/>
                  </a:lnTo>
                  <a:lnTo>
                    <a:pt x="185889" y="53327"/>
                  </a:lnTo>
                  <a:lnTo>
                    <a:pt x="187413" y="54851"/>
                  </a:lnTo>
                  <a:lnTo>
                    <a:pt x="187413" y="56375"/>
                  </a:lnTo>
                  <a:lnTo>
                    <a:pt x="188937" y="57911"/>
                  </a:lnTo>
                  <a:lnTo>
                    <a:pt x="188937" y="59435"/>
                  </a:lnTo>
                  <a:lnTo>
                    <a:pt x="188937" y="60959"/>
                  </a:lnTo>
                  <a:lnTo>
                    <a:pt x="190449" y="62483"/>
                  </a:lnTo>
                  <a:lnTo>
                    <a:pt x="191985" y="63995"/>
                  </a:lnTo>
                  <a:lnTo>
                    <a:pt x="191985" y="65519"/>
                  </a:lnTo>
                  <a:lnTo>
                    <a:pt x="193509" y="67043"/>
                  </a:lnTo>
                  <a:lnTo>
                    <a:pt x="195033" y="68567"/>
                  </a:lnTo>
                  <a:lnTo>
                    <a:pt x="196557" y="70103"/>
                  </a:lnTo>
                  <a:lnTo>
                    <a:pt x="196557" y="71627"/>
                  </a:lnTo>
                  <a:lnTo>
                    <a:pt x="198081" y="73151"/>
                  </a:lnTo>
                  <a:lnTo>
                    <a:pt x="199605" y="74663"/>
                  </a:lnTo>
                  <a:lnTo>
                    <a:pt x="201117" y="77711"/>
                  </a:lnTo>
                  <a:lnTo>
                    <a:pt x="202641" y="77711"/>
                  </a:lnTo>
                  <a:lnTo>
                    <a:pt x="204177" y="79235"/>
                  </a:lnTo>
                  <a:lnTo>
                    <a:pt x="205701" y="82295"/>
                  </a:lnTo>
                  <a:lnTo>
                    <a:pt x="207225" y="83819"/>
                  </a:lnTo>
                  <a:lnTo>
                    <a:pt x="208749" y="83819"/>
                  </a:lnTo>
                  <a:lnTo>
                    <a:pt x="210273" y="85343"/>
                  </a:lnTo>
                  <a:lnTo>
                    <a:pt x="211785" y="88379"/>
                  </a:lnTo>
                  <a:lnTo>
                    <a:pt x="213309" y="89903"/>
                  </a:lnTo>
                  <a:lnTo>
                    <a:pt x="216357" y="91427"/>
                  </a:lnTo>
                  <a:lnTo>
                    <a:pt x="217893" y="92951"/>
                  </a:lnTo>
                  <a:lnTo>
                    <a:pt x="219417" y="94475"/>
                  </a:lnTo>
                  <a:lnTo>
                    <a:pt x="220941" y="96011"/>
                  </a:lnTo>
                  <a:lnTo>
                    <a:pt x="222453" y="97523"/>
                  </a:lnTo>
                  <a:lnTo>
                    <a:pt x="223977" y="99047"/>
                  </a:lnTo>
                  <a:lnTo>
                    <a:pt x="225501" y="100571"/>
                  </a:lnTo>
                  <a:lnTo>
                    <a:pt x="227025" y="102095"/>
                  </a:lnTo>
                  <a:lnTo>
                    <a:pt x="228549" y="103619"/>
                  </a:lnTo>
                  <a:lnTo>
                    <a:pt x="230085" y="105143"/>
                  </a:lnTo>
                  <a:lnTo>
                    <a:pt x="231609" y="106667"/>
                  </a:lnTo>
                  <a:lnTo>
                    <a:pt x="233121" y="108191"/>
                  </a:lnTo>
                  <a:lnTo>
                    <a:pt x="234645" y="109715"/>
                  </a:lnTo>
                  <a:lnTo>
                    <a:pt x="236169" y="111239"/>
                  </a:lnTo>
                  <a:lnTo>
                    <a:pt x="237693" y="112763"/>
                  </a:lnTo>
                  <a:lnTo>
                    <a:pt x="239217" y="114287"/>
                  </a:lnTo>
                  <a:lnTo>
                    <a:pt x="242265" y="115811"/>
                  </a:lnTo>
                  <a:lnTo>
                    <a:pt x="243789" y="117335"/>
                  </a:lnTo>
                  <a:lnTo>
                    <a:pt x="245313" y="118846"/>
                  </a:lnTo>
                  <a:lnTo>
                    <a:pt x="246837" y="120383"/>
                  </a:lnTo>
                  <a:lnTo>
                    <a:pt x="248361" y="121907"/>
                  </a:lnTo>
                  <a:lnTo>
                    <a:pt x="251409" y="123431"/>
                  </a:lnTo>
                  <a:lnTo>
                    <a:pt x="252920" y="124955"/>
                  </a:lnTo>
                  <a:lnTo>
                    <a:pt x="254457" y="126479"/>
                  </a:lnTo>
                  <a:lnTo>
                    <a:pt x="257505" y="128003"/>
                  </a:lnTo>
                  <a:lnTo>
                    <a:pt x="259029" y="129527"/>
                  </a:lnTo>
                  <a:lnTo>
                    <a:pt x="262077" y="131038"/>
                  </a:lnTo>
                  <a:lnTo>
                    <a:pt x="263588" y="132562"/>
                  </a:lnTo>
                  <a:lnTo>
                    <a:pt x="265112" y="134099"/>
                  </a:lnTo>
                  <a:lnTo>
                    <a:pt x="268173" y="135623"/>
                  </a:lnTo>
                  <a:lnTo>
                    <a:pt x="269697" y="137147"/>
                  </a:lnTo>
                  <a:lnTo>
                    <a:pt x="272745" y="138671"/>
                  </a:lnTo>
                  <a:lnTo>
                    <a:pt x="274256" y="140195"/>
                  </a:lnTo>
                  <a:lnTo>
                    <a:pt x="277304" y="141706"/>
                  </a:lnTo>
                  <a:lnTo>
                    <a:pt x="280365" y="143230"/>
                  </a:lnTo>
                  <a:lnTo>
                    <a:pt x="283400" y="144754"/>
                  </a:lnTo>
                  <a:lnTo>
                    <a:pt x="284924" y="147815"/>
                  </a:lnTo>
                  <a:lnTo>
                    <a:pt x="287972" y="147815"/>
                  </a:lnTo>
                  <a:lnTo>
                    <a:pt x="291020" y="149339"/>
                  </a:lnTo>
                  <a:lnTo>
                    <a:pt x="294068" y="150863"/>
                  </a:lnTo>
                  <a:lnTo>
                    <a:pt x="295592" y="153898"/>
                  </a:lnTo>
                  <a:lnTo>
                    <a:pt x="298640" y="153898"/>
                  </a:lnTo>
                  <a:lnTo>
                    <a:pt x="301688" y="155422"/>
                  </a:lnTo>
                  <a:lnTo>
                    <a:pt x="304736" y="158483"/>
                  </a:lnTo>
                  <a:lnTo>
                    <a:pt x="307784" y="160007"/>
                  </a:lnTo>
                  <a:lnTo>
                    <a:pt x="310832" y="161531"/>
                  </a:lnTo>
                  <a:lnTo>
                    <a:pt x="313880" y="163042"/>
                  </a:lnTo>
                  <a:lnTo>
                    <a:pt x="315391" y="164566"/>
                  </a:lnTo>
                  <a:lnTo>
                    <a:pt x="318452" y="166090"/>
                  </a:lnTo>
                  <a:lnTo>
                    <a:pt x="321500" y="167614"/>
                  </a:lnTo>
                  <a:lnTo>
                    <a:pt x="324548" y="169138"/>
                  </a:lnTo>
                  <a:lnTo>
                    <a:pt x="326059" y="170662"/>
                  </a:lnTo>
                  <a:lnTo>
                    <a:pt x="329107" y="172199"/>
                  </a:lnTo>
                  <a:lnTo>
                    <a:pt x="330644" y="173710"/>
                  </a:lnTo>
                  <a:lnTo>
                    <a:pt x="332168" y="175234"/>
                  </a:lnTo>
                  <a:lnTo>
                    <a:pt x="333692" y="176758"/>
                  </a:lnTo>
                  <a:lnTo>
                    <a:pt x="336727" y="178282"/>
                  </a:lnTo>
                  <a:lnTo>
                    <a:pt x="338251" y="179806"/>
                  </a:lnTo>
                  <a:lnTo>
                    <a:pt x="339775" y="181330"/>
                  </a:lnTo>
                  <a:lnTo>
                    <a:pt x="341299" y="182854"/>
                  </a:lnTo>
                  <a:lnTo>
                    <a:pt x="341299" y="184378"/>
                  </a:lnTo>
                  <a:lnTo>
                    <a:pt x="342836" y="185902"/>
                  </a:lnTo>
                  <a:lnTo>
                    <a:pt x="344360" y="187426"/>
                  </a:lnTo>
                  <a:lnTo>
                    <a:pt x="344360" y="188950"/>
                  </a:lnTo>
                  <a:lnTo>
                    <a:pt x="345871" y="190474"/>
                  </a:lnTo>
                  <a:lnTo>
                    <a:pt x="345871" y="191998"/>
                  </a:lnTo>
                  <a:lnTo>
                    <a:pt x="345871" y="193522"/>
                  </a:lnTo>
                  <a:lnTo>
                    <a:pt x="347395" y="195046"/>
                  </a:lnTo>
                  <a:lnTo>
                    <a:pt x="347395" y="196570"/>
                  </a:lnTo>
                  <a:lnTo>
                    <a:pt x="347395" y="198094"/>
                  </a:lnTo>
                  <a:lnTo>
                    <a:pt x="347395" y="199618"/>
                  </a:lnTo>
                  <a:lnTo>
                    <a:pt x="345871" y="201142"/>
                  </a:lnTo>
                  <a:lnTo>
                    <a:pt x="345871" y="202666"/>
                  </a:lnTo>
                  <a:lnTo>
                    <a:pt x="345871" y="204190"/>
                  </a:lnTo>
                  <a:lnTo>
                    <a:pt x="345871" y="205714"/>
                  </a:lnTo>
                  <a:lnTo>
                    <a:pt x="344360" y="207225"/>
                  </a:lnTo>
                  <a:lnTo>
                    <a:pt x="344360" y="208762"/>
                  </a:lnTo>
                  <a:lnTo>
                    <a:pt x="342836" y="210286"/>
                  </a:lnTo>
                  <a:lnTo>
                    <a:pt x="342836" y="211810"/>
                  </a:lnTo>
                  <a:lnTo>
                    <a:pt x="341299" y="213334"/>
                  </a:lnTo>
                  <a:lnTo>
                    <a:pt x="339775" y="214858"/>
                  </a:lnTo>
                  <a:lnTo>
                    <a:pt x="339775" y="217893"/>
                  </a:lnTo>
                  <a:lnTo>
                    <a:pt x="338251" y="217893"/>
                  </a:lnTo>
                  <a:lnTo>
                    <a:pt x="336727" y="219417"/>
                  </a:lnTo>
                  <a:lnTo>
                    <a:pt x="335203" y="220941"/>
                  </a:lnTo>
                  <a:lnTo>
                    <a:pt x="333692" y="224002"/>
                  </a:lnTo>
                  <a:lnTo>
                    <a:pt x="330644" y="225526"/>
                  </a:lnTo>
                  <a:lnTo>
                    <a:pt x="330644" y="228561"/>
                  </a:lnTo>
                  <a:lnTo>
                    <a:pt x="329107" y="230085"/>
                  </a:lnTo>
                  <a:lnTo>
                    <a:pt x="326059" y="231609"/>
                  </a:lnTo>
                  <a:lnTo>
                    <a:pt x="324548" y="233133"/>
                  </a:lnTo>
                  <a:lnTo>
                    <a:pt x="323024" y="234670"/>
                  </a:lnTo>
                  <a:lnTo>
                    <a:pt x="321500" y="236194"/>
                  </a:lnTo>
                  <a:lnTo>
                    <a:pt x="319976" y="236194"/>
                  </a:lnTo>
                  <a:lnTo>
                    <a:pt x="318452" y="239242"/>
                  </a:lnTo>
                  <a:lnTo>
                    <a:pt x="316915" y="240753"/>
                  </a:lnTo>
                  <a:lnTo>
                    <a:pt x="315391" y="242277"/>
                  </a:lnTo>
                  <a:lnTo>
                    <a:pt x="313880" y="243801"/>
                  </a:lnTo>
                  <a:lnTo>
                    <a:pt x="310832" y="245325"/>
                  </a:lnTo>
                  <a:lnTo>
                    <a:pt x="309308" y="246862"/>
                  </a:lnTo>
                  <a:lnTo>
                    <a:pt x="307784" y="248386"/>
                  </a:lnTo>
                  <a:lnTo>
                    <a:pt x="306260" y="249910"/>
                  </a:lnTo>
                  <a:lnTo>
                    <a:pt x="304736" y="251421"/>
                  </a:lnTo>
                  <a:lnTo>
                    <a:pt x="303212" y="252945"/>
                  </a:lnTo>
                  <a:lnTo>
                    <a:pt x="301688" y="254469"/>
                  </a:lnTo>
                  <a:lnTo>
                    <a:pt x="300164" y="255993"/>
                  </a:lnTo>
                  <a:lnTo>
                    <a:pt x="297116" y="257517"/>
                  </a:lnTo>
                  <a:lnTo>
                    <a:pt x="295592" y="259041"/>
                  </a:lnTo>
                  <a:lnTo>
                    <a:pt x="294068" y="260578"/>
                  </a:lnTo>
                  <a:lnTo>
                    <a:pt x="292557" y="262089"/>
                  </a:lnTo>
                  <a:lnTo>
                    <a:pt x="289496" y="263613"/>
                  </a:lnTo>
                  <a:lnTo>
                    <a:pt x="287972" y="265137"/>
                  </a:lnTo>
                  <a:lnTo>
                    <a:pt x="286448" y="266661"/>
                  </a:lnTo>
                  <a:lnTo>
                    <a:pt x="284924" y="268185"/>
                  </a:lnTo>
                  <a:lnTo>
                    <a:pt x="283400" y="269709"/>
                  </a:lnTo>
                  <a:lnTo>
                    <a:pt x="280365" y="271233"/>
                  </a:lnTo>
                  <a:lnTo>
                    <a:pt x="278828" y="272757"/>
                  </a:lnTo>
                  <a:lnTo>
                    <a:pt x="277304" y="274281"/>
                  </a:lnTo>
                  <a:lnTo>
                    <a:pt x="274256" y="275805"/>
                  </a:lnTo>
                  <a:lnTo>
                    <a:pt x="272745" y="277329"/>
                  </a:lnTo>
                  <a:lnTo>
                    <a:pt x="269697" y="278853"/>
                  </a:lnTo>
                  <a:lnTo>
                    <a:pt x="268173" y="280377"/>
                  </a:lnTo>
                  <a:lnTo>
                    <a:pt x="266636" y="281901"/>
                  </a:lnTo>
                  <a:lnTo>
                    <a:pt x="263588" y="283413"/>
                  </a:lnTo>
                  <a:lnTo>
                    <a:pt x="262077" y="284949"/>
                  </a:lnTo>
                  <a:lnTo>
                    <a:pt x="260553" y="286473"/>
                  </a:lnTo>
                  <a:lnTo>
                    <a:pt x="259029" y="289521"/>
                  </a:lnTo>
                  <a:lnTo>
                    <a:pt x="257505" y="289521"/>
                  </a:lnTo>
                  <a:lnTo>
                    <a:pt x="254457" y="291045"/>
                  </a:lnTo>
                  <a:lnTo>
                    <a:pt x="252920" y="294081"/>
                  </a:lnTo>
                  <a:lnTo>
                    <a:pt x="251409" y="294081"/>
                  </a:lnTo>
                  <a:lnTo>
                    <a:pt x="249885" y="295605"/>
                  </a:lnTo>
                  <a:lnTo>
                    <a:pt x="248361" y="298665"/>
                  </a:lnTo>
                  <a:lnTo>
                    <a:pt x="246837" y="300189"/>
                  </a:lnTo>
                  <a:lnTo>
                    <a:pt x="246837" y="301713"/>
                  </a:lnTo>
                  <a:lnTo>
                    <a:pt x="243789" y="303237"/>
                  </a:lnTo>
                  <a:lnTo>
                    <a:pt x="243789" y="304761"/>
                  </a:lnTo>
                  <a:lnTo>
                    <a:pt x="242265" y="306273"/>
                  </a:lnTo>
                  <a:lnTo>
                    <a:pt x="240741" y="307797"/>
                  </a:lnTo>
                  <a:lnTo>
                    <a:pt x="239217" y="309321"/>
                  </a:lnTo>
                  <a:lnTo>
                    <a:pt x="239217" y="310857"/>
                  </a:lnTo>
                  <a:lnTo>
                    <a:pt x="237693" y="312381"/>
                  </a:lnTo>
                  <a:lnTo>
                    <a:pt x="237693" y="313905"/>
                  </a:lnTo>
                  <a:lnTo>
                    <a:pt x="236169" y="315429"/>
                  </a:lnTo>
                  <a:lnTo>
                    <a:pt x="234645" y="316941"/>
                  </a:lnTo>
                  <a:lnTo>
                    <a:pt x="233121" y="318465"/>
                  </a:lnTo>
                  <a:lnTo>
                    <a:pt x="233121" y="319989"/>
                  </a:lnTo>
                  <a:lnTo>
                    <a:pt x="231609" y="321513"/>
                  </a:lnTo>
                  <a:lnTo>
                    <a:pt x="231609" y="323049"/>
                  </a:lnTo>
                  <a:lnTo>
                    <a:pt x="230085" y="324573"/>
                  </a:lnTo>
                  <a:lnTo>
                    <a:pt x="228549" y="326097"/>
                  </a:lnTo>
                  <a:lnTo>
                    <a:pt x="227025" y="327609"/>
                  </a:lnTo>
                  <a:lnTo>
                    <a:pt x="227025" y="329133"/>
                  </a:lnTo>
                  <a:lnTo>
                    <a:pt x="225501" y="330657"/>
                  </a:lnTo>
                  <a:lnTo>
                    <a:pt x="223977" y="332181"/>
                  </a:lnTo>
                  <a:lnTo>
                    <a:pt x="223977" y="333705"/>
                  </a:lnTo>
                  <a:lnTo>
                    <a:pt x="222453" y="335241"/>
                  </a:lnTo>
                  <a:lnTo>
                    <a:pt x="220941" y="336765"/>
                  </a:lnTo>
                  <a:lnTo>
                    <a:pt x="219417" y="338277"/>
                  </a:lnTo>
                  <a:lnTo>
                    <a:pt x="219417" y="339801"/>
                  </a:lnTo>
                  <a:lnTo>
                    <a:pt x="217893" y="341325"/>
                  </a:lnTo>
                  <a:lnTo>
                    <a:pt x="217893" y="342849"/>
                  </a:lnTo>
                  <a:lnTo>
                    <a:pt x="216357" y="344373"/>
                  </a:lnTo>
                  <a:lnTo>
                    <a:pt x="216357" y="345897"/>
                  </a:lnTo>
                  <a:lnTo>
                    <a:pt x="214833" y="347421"/>
                  </a:lnTo>
                  <a:lnTo>
                    <a:pt x="213309" y="348957"/>
                  </a:lnTo>
                  <a:lnTo>
                    <a:pt x="213309" y="350469"/>
                  </a:lnTo>
                  <a:lnTo>
                    <a:pt x="211785" y="351993"/>
                  </a:lnTo>
                  <a:lnTo>
                    <a:pt x="211785" y="353517"/>
                  </a:lnTo>
                  <a:lnTo>
                    <a:pt x="210273" y="355041"/>
                  </a:lnTo>
                  <a:lnTo>
                    <a:pt x="210273" y="356565"/>
                  </a:lnTo>
                  <a:lnTo>
                    <a:pt x="208749" y="359613"/>
                  </a:lnTo>
                  <a:lnTo>
                    <a:pt x="208749" y="361137"/>
                  </a:lnTo>
                  <a:lnTo>
                    <a:pt x="208749" y="364185"/>
                  </a:lnTo>
                  <a:lnTo>
                    <a:pt x="207225" y="364185"/>
                  </a:lnTo>
                  <a:lnTo>
                    <a:pt x="207225" y="365709"/>
                  </a:lnTo>
                  <a:lnTo>
                    <a:pt x="207225" y="368757"/>
                  </a:lnTo>
                  <a:lnTo>
                    <a:pt x="207225" y="370281"/>
                  </a:lnTo>
                  <a:lnTo>
                    <a:pt x="207225" y="371792"/>
                  </a:lnTo>
                  <a:lnTo>
                    <a:pt x="205701" y="371792"/>
                  </a:lnTo>
                  <a:lnTo>
                    <a:pt x="205701" y="374853"/>
                  </a:lnTo>
                  <a:lnTo>
                    <a:pt x="205701" y="376377"/>
                  </a:lnTo>
                  <a:lnTo>
                    <a:pt x="205701" y="377901"/>
                  </a:lnTo>
                  <a:lnTo>
                    <a:pt x="204177" y="379425"/>
                  </a:lnTo>
                  <a:lnTo>
                    <a:pt x="204177" y="380949"/>
                  </a:lnTo>
                  <a:lnTo>
                    <a:pt x="204177" y="382460"/>
                  </a:lnTo>
                  <a:lnTo>
                    <a:pt x="202641" y="383984"/>
                  </a:lnTo>
                  <a:lnTo>
                    <a:pt x="202641" y="385508"/>
                  </a:lnTo>
                  <a:lnTo>
                    <a:pt x="202641" y="387045"/>
                  </a:lnTo>
                  <a:lnTo>
                    <a:pt x="202641" y="388569"/>
                  </a:lnTo>
                  <a:lnTo>
                    <a:pt x="201117" y="390093"/>
                  </a:lnTo>
                  <a:lnTo>
                    <a:pt x="201117" y="391617"/>
                  </a:lnTo>
                  <a:lnTo>
                    <a:pt x="201117" y="393128"/>
                  </a:lnTo>
                  <a:lnTo>
                    <a:pt x="199605" y="394652"/>
                  </a:lnTo>
                  <a:lnTo>
                    <a:pt x="199605" y="396176"/>
                  </a:lnTo>
                  <a:lnTo>
                    <a:pt x="198081" y="397700"/>
                  </a:lnTo>
                  <a:lnTo>
                    <a:pt x="198081" y="399237"/>
                  </a:lnTo>
                  <a:lnTo>
                    <a:pt x="198081" y="400761"/>
                  </a:lnTo>
                  <a:lnTo>
                    <a:pt x="196557" y="402285"/>
                  </a:lnTo>
                  <a:lnTo>
                    <a:pt x="196557" y="403796"/>
                  </a:lnTo>
                  <a:lnTo>
                    <a:pt x="196557" y="405320"/>
                  </a:lnTo>
                  <a:lnTo>
                    <a:pt x="196557" y="406844"/>
                  </a:lnTo>
                  <a:lnTo>
                    <a:pt x="195033" y="408368"/>
                  </a:lnTo>
                  <a:lnTo>
                    <a:pt x="195033" y="409892"/>
                  </a:lnTo>
                  <a:lnTo>
                    <a:pt x="195033" y="411429"/>
                  </a:lnTo>
                  <a:lnTo>
                    <a:pt x="195033" y="412953"/>
                  </a:lnTo>
                  <a:lnTo>
                    <a:pt x="193509" y="414477"/>
                  </a:lnTo>
                  <a:lnTo>
                    <a:pt x="193509" y="429704"/>
                  </a:lnTo>
                  <a:lnTo>
                    <a:pt x="191985" y="431228"/>
                  </a:lnTo>
                  <a:lnTo>
                    <a:pt x="191985" y="434276"/>
                  </a:lnTo>
                  <a:lnTo>
                    <a:pt x="191985" y="435800"/>
                  </a:lnTo>
                  <a:lnTo>
                    <a:pt x="191985" y="438848"/>
                  </a:lnTo>
                  <a:lnTo>
                    <a:pt x="190449" y="440372"/>
                  </a:lnTo>
                  <a:lnTo>
                    <a:pt x="190449" y="441896"/>
                  </a:lnTo>
                  <a:lnTo>
                    <a:pt x="188937" y="441896"/>
                  </a:lnTo>
                  <a:lnTo>
                    <a:pt x="188937" y="444944"/>
                  </a:lnTo>
                  <a:lnTo>
                    <a:pt x="188937" y="446468"/>
                  </a:lnTo>
                  <a:lnTo>
                    <a:pt x="187413" y="447979"/>
                  </a:lnTo>
                  <a:lnTo>
                    <a:pt x="187413" y="449516"/>
                  </a:lnTo>
                  <a:lnTo>
                    <a:pt x="187413" y="451040"/>
                  </a:lnTo>
                  <a:lnTo>
                    <a:pt x="185889" y="452564"/>
                  </a:lnTo>
                  <a:lnTo>
                    <a:pt x="185889" y="454088"/>
                  </a:lnTo>
                  <a:lnTo>
                    <a:pt x="185889" y="455612"/>
                  </a:lnTo>
                  <a:lnTo>
                    <a:pt x="184365" y="457136"/>
                  </a:lnTo>
                  <a:lnTo>
                    <a:pt x="184365" y="458660"/>
                  </a:lnTo>
                  <a:lnTo>
                    <a:pt x="182841" y="460171"/>
                  </a:lnTo>
                  <a:lnTo>
                    <a:pt x="182841" y="461708"/>
                  </a:lnTo>
                  <a:lnTo>
                    <a:pt x="182841" y="463232"/>
                  </a:lnTo>
                  <a:lnTo>
                    <a:pt x="182841" y="464756"/>
                  </a:lnTo>
                  <a:lnTo>
                    <a:pt x="181317" y="466280"/>
                  </a:lnTo>
                  <a:lnTo>
                    <a:pt x="181317" y="467804"/>
                  </a:lnTo>
                  <a:lnTo>
                    <a:pt x="181317" y="469328"/>
                  </a:lnTo>
                  <a:lnTo>
                    <a:pt x="181317" y="470839"/>
                  </a:lnTo>
                  <a:lnTo>
                    <a:pt x="181317" y="472363"/>
                  </a:lnTo>
                  <a:lnTo>
                    <a:pt x="179793" y="473887"/>
                  </a:lnTo>
                  <a:lnTo>
                    <a:pt x="179793" y="475424"/>
                  </a:lnTo>
                  <a:lnTo>
                    <a:pt x="179793" y="476948"/>
                  </a:lnTo>
                  <a:lnTo>
                    <a:pt x="179793" y="478472"/>
                  </a:lnTo>
                  <a:lnTo>
                    <a:pt x="179793" y="479996"/>
                  </a:lnTo>
                  <a:lnTo>
                    <a:pt x="178269" y="481507"/>
                  </a:lnTo>
                  <a:lnTo>
                    <a:pt x="178269" y="522655"/>
                  </a:lnTo>
                  <a:lnTo>
                    <a:pt x="176745" y="524179"/>
                  </a:lnTo>
                  <a:lnTo>
                    <a:pt x="176745" y="617131"/>
                  </a:lnTo>
                  <a:lnTo>
                    <a:pt x="175221" y="618655"/>
                  </a:lnTo>
                  <a:lnTo>
                    <a:pt x="175221" y="679602"/>
                  </a:lnTo>
                  <a:lnTo>
                    <a:pt x="173697" y="681126"/>
                  </a:lnTo>
                  <a:lnTo>
                    <a:pt x="173697" y="796937"/>
                  </a:lnTo>
                  <a:lnTo>
                    <a:pt x="172173" y="796937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5" name="object 15"/>
          <p:cNvSpPr txBox="1"/>
          <p:nvPr/>
        </p:nvSpPr>
        <p:spPr>
          <a:xfrm>
            <a:off x="5667114" y="5672566"/>
            <a:ext cx="174625" cy="17907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000" dirty="0">
                <a:latin typeface="Arial"/>
                <a:cs typeface="Arial"/>
              </a:rPr>
              <a:t>*</a:t>
            </a:r>
            <a:r>
              <a:rPr sz="1000" spc="-10" dirty="0">
                <a:latin typeface="Arial"/>
                <a:cs typeface="Arial"/>
              </a:rPr>
              <a:t>*</a:t>
            </a:r>
            <a:r>
              <a:rPr sz="1000" dirty="0">
                <a:latin typeface="Arial"/>
                <a:cs typeface="Arial"/>
              </a:rPr>
              <a:t>*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16" name="object 16"/>
          <p:cNvGrpSpPr/>
          <p:nvPr/>
        </p:nvGrpSpPr>
        <p:grpSpPr>
          <a:xfrm>
            <a:off x="4533252" y="5600614"/>
            <a:ext cx="1650364" cy="1373505"/>
            <a:chOff x="4533252" y="5600614"/>
            <a:chExt cx="1650364" cy="1373505"/>
          </a:xfrm>
        </p:grpSpPr>
        <p:sp>
          <p:nvSpPr>
            <p:cNvPr id="17" name="object 17"/>
            <p:cNvSpPr/>
            <p:nvPr/>
          </p:nvSpPr>
          <p:spPr>
            <a:xfrm>
              <a:off x="5947965" y="5826899"/>
              <a:ext cx="0" cy="30480"/>
            </a:xfrm>
            <a:custGeom>
              <a:avLst/>
              <a:gdLst/>
              <a:ahLst/>
              <a:cxnLst/>
              <a:rect l="l" t="t" r="r" b="b"/>
              <a:pathLst>
                <a:path h="30479">
                  <a:moveTo>
                    <a:pt x="0" y="30467"/>
                  </a:moveTo>
                  <a:lnTo>
                    <a:pt x="0" y="30467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5560945" y="5826893"/>
              <a:ext cx="387350" cy="0"/>
            </a:xfrm>
            <a:custGeom>
              <a:avLst/>
              <a:gdLst/>
              <a:ahLst/>
              <a:cxnLst/>
              <a:rect l="l" t="t" r="r" b="b"/>
              <a:pathLst>
                <a:path w="387350">
                  <a:moveTo>
                    <a:pt x="387019" y="0"/>
                  </a:moveTo>
                  <a:lnTo>
                    <a:pt x="387019" y="0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5560950" y="5826893"/>
              <a:ext cx="0" cy="30480"/>
            </a:xfrm>
            <a:custGeom>
              <a:avLst/>
              <a:gdLst/>
              <a:ahLst/>
              <a:cxnLst/>
              <a:rect l="l" t="t" r="r" b="b"/>
              <a:pathLst>
                <a:path h="30479">
                  <a:moveTo>
                    <a:pt x="0" y="0"/>
                  </a:moveTo>
                  <a:lnTo>
                    <a:pt x="0" y="0"/>
                  </a:lnTo>
                  <a:lnTo>
                    <a:pt x="0" y="30467"/>
                  </a:lnTo>
                </a:path>
              </a:pathLst>
            </a:custGeom>
            <a:ln w="762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4556869" y="5604424"/>
              <a:ext cx="1623060" cy="1345565"/>
            </a:xfrm>
            <a:custGeom>
              <a:avLst/>
              <a:gdLst/>
              <a:ahLst/>
              <a:cxnLst/>
              <a:rect l="l" t="t" r="r" b="b"/>
              <a:pathLst>
                <a:path w="1623060" h="1345565">
                  <a:moveTo>
                    <a:pt x="0" y="1345488"/>
                  </a:moveTo>
                  <a:lnTo>
                    <a:pt x="1622691" y="1345488"/>
                  </a:lnTo>
                  <a:lnTo>
                    <a:pt x="1622691" y="0"/>
                  </a:lnTo>
                  <a:lnTo>
                    <a:pt x="0" y="0"/>
                  </a:lnTo>
                  <a:lnTo>
                    <a:pt x="0" y="1345488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4537062" y="6884379"/>
              <a:ext cx="20320" cy="0"/>
            </a:xfrm>
            <a:custGeom>
              <a:avLst/>
              <a:gdLst/>
              <a:ahLst/>
              <a:cxnLst/>
              <a:rect l="l" t="t" r="r" b="b"/>
              <a:pathLst>
                <a:path w="20320">
                  <a:moveTo>
                    <a:pt x="0" y="0"/>
                  </a:moveTo>
                  <a:lnTo>
                    <a:pt x="0" y="0"/>
                  </a:lnTo>
                  <a:lnTo>
                    <a:pt x="19812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4537062" y="6640587"/>
              <a:ext cx="20320" cy="0"/>
            </a:xfrm>
            <a:custGeom>
              <a:avLst/>
              <a:gdLst/>
              <a:ahLst/>
              <a:cxnLst/>
              <a:rect l="l" t="t" r="r" b="b"/>
              <a:pathLst>
                <a:path w="20320">
                  <a:moveTo>
                    <a:pt x="0" y="0"/>
                  </a:moveTo>
                  <a:lnTo>
                    <a:pt x="0" y="0"/>
                  </a:lnTo>
                  <a:lnTo>
                    <a:pt x="19812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4537062" y="6396781"/>
              <a:ext cx="20320" cy="0"/>
            </a:xfrm>
            <a:custGeom>
              <a:avLst/>
              <a:gdLst/>
              <a:ahLst/>
              <a:cxnLst/>
              <a:rect l="l" t="t" r="r" b="b"/>
              <a:pathLst>
                <a:path w="20320">
                  <a:moveTo>
                    <a:pt x="0" y="0"/>
                  </a:moveTo>
                  <a:lnTo>
                    <a:pt x="0" y="0"/>
                  </a:lnTo>
                  <a:lnTo>
                    <a:pt x="19812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4537062" y="6152975"/>
              <a:ext cx="20320" cy="0"/>
            </a:xfrm>
            <a:custGeom>
              <a:avLst/>
              <a:gdLst/>
              <a:ahLst/>
              <a:cxnLst/>
              <a:rect l="l" t="t" r="r" b="b"/>
              <a:pathLst>
                <a:path w="20320">
                  <a:moveTo>
                    <a:pt x="0" y="0"/>
                  </a:moveTo>
                  <a:lnTo>
                    <a:pt x="0" y="0"/>
                  </a:lnTo>
                  <a:lnTo>
                    <a:pt x="19812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4537062" y="5909171"/>
              <a:ext cx="20320" cy="0"/>
            </a:xfrm>
            <a:custGeom>
              <a:avLst/>
              <a:gdLst/>
              <a:ahLst/>
              <a:cxnLst/>
              <a:rect l="l" t="t" r="r" b="b"/>
              <a:pathLst>
                <a:path w="20320">
                  <a:moveTo>
                    <a:pt x="0" y="0"/>
                  </a:moveTo>
                  <a:lnTo>
                    <a:pt x="0" y="0"/>
                  </a:lnTo>
                  <a:lnTo>
                    <a:pt x="19812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4537062" y="5665378"/>
              <a:ext cx="20320" cy="0"/>
            </a:xfrm>
            <a:custGeom>
              <a:avLst/>
              <a:gdLst/>
              <a:ahLst/>
              <a:cxnLst/>
              <a:rect l="l" t="t" r="r" b="b"/>
              <a:pathLst>
                <a:path w="20320">
                  <a:moveTo>
                    <a:pt x="0" y="0"/>
                  </a:moveTo>
                  <a:lnTo>
                    <a:pt x="0" y="0"/>
                  </a:lnTo>
                  <a:lnTo>
                    <a:pt x="19812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4788457" y="6949908"/>
              <a:ext cx="0" cy="20320"/>
            </a:xfrm>
            <a:custGeom>
              <a:avLst/>
              <a:gdLst/>
              <a:ahLst/>
              <a:cxnLst/>
              <a:rect l="l" t="t" r="r" b="b"/>
              <a:pathLst>
                <a:path h="20320">
                  <a:moveTo>
                    <a:pt x="0" y="19812"/>
                  </a:moveTo>
                  <a:lnTo>
                    <a:pt x="0" y="19812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5175473" y="6949908"/>
              <a:ext cx="0" cy="20320"/>
            </a:xfrm>
            <a:custGeom>
              <a:avLst/>
              <a:gdLst/>
              <a:ahLst/>
              <a:cxnLst/>
              <a:rect l="l" t="t" r="r" b="b"/>
              <a:pathLst>
                <a:path h="20320">
                  <a:moveTo>
                    <a:pt x="0" y="19812"/>
                  </a:moveTo>
                  <a:lnTo>
                    <a:pt x="0" y="19812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5560950" y="6949908"/>
              <a:ext cx="0" cy="20320"/>
            </a:xfrm>
            <a:custGeom>
              <a:avLst/>
              <a:gdLst/>
              <a:ahLst/>
              <a:cxnLst/>
              <a:rect l="l" t="t" r="r" b="b"/>
              <a:pathLst>
                <a:path h="20320">
                  <a:moveTo>
                    <a:pt x="0" y="19812"/>
                  </a:moveTo>
                  <a:lnTo>
                    <a:pt x="0" y="19812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5947965" y="6949908"/>
              <a:ext cx="0" cy="20320"/>
            </a:xfrm>
            <a:custGeom>
              <a:avLst/>
              <a:gdLst/>
              <a:ahLst/>
              <a:cxnLst/>
              <a:rect l="l" t="t" r="r" b="b"/>
              <a:pathLst>
                <a:path h="20320">
                  <a:moveTo>
                    <a:pt x="0" y="19812"/>
                  </a:moveTo>
                  <a:lnTo>
                    <a:pt x="0" y="19812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" name="object 31"/>
          <p:cNvSpPr txBox="1"/>
          <p:nvPr/>
        </p:nvSpPr>
        <p:spPr>
          <a:xfrm>
            <a:off x="4420828" y="6068655"/>
            <a:ext cx="82550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dirty="0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4335484" y="5824756"/>
            <a:ext cx="167640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0</a:t>
            </a:r>
            <a:r>
              <a:rPr sz="800" dirty="0">
                <a:latin typeface="Arial"/>
                <a:cs typeface="Arial"/>
              </a:rPr>
              <a:t>.5</a:t>
            </a:r>
            <a:endParaRPr sz="800">
              <a:latin typeface="Arial"/>
              <a:cs typeface="Arial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4335484" y="5581060"/>
            <a:ext cx="167640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1</a:t>
            </a:r>
            <a:r>
              <a:rPr sz="800" dirty="0">
                <a:latin typeface="Arial"/>
                <a:cs typeface="Arial"/>
              </a:rPr>
              <a:t>.0</a:t>
            </a:r>
            <a:endParaRPr sz="800">
              <a:latin typeface="Arial"/>
              <a:cs typeface="Arial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4302000" y="6312453"/>
            <a:ext cx="20129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-0</a:t>
            </a:r>
            <a:r>
              <a:rPr sz="800" dirty="0">
                <a:latin typeface="Arial"/>
                <a:cs typeface="Arial"/>
              </a:rPr>
              <a:t>.5</a:t>
            </a:r>
            <a:endParaRPr sz="800">
              <a:latin typeface="Arial"/>
              <a:cs typeface="Arial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4302102" y="6556352"/>
            <a:ext cx="20129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-1</a:t>
            </a:r>
            <a:r>
              <a:rPr sz="800" dirty="0">
                <a:latin typeface="Arial"/>
                <a:cs typeface="Arial"/>
              </a:rPr>
              <a:t>.0</a:t>
            </a:r>
            <a:endParaRPr sz="800">
              <a:latin typeface="Arial"/>
              <a:cs typeface="Arial"/>
            </a:endParaRPr>
          </a:p>
        </p:txBody>
      </p:sp>
      <p:sp>
        <p:nvSpPr>
          <p:cNvPr id="36" name="object 36"/>
          <p:cNvSpPr txBox="1"/>
          <p:nvPr/>
        </p:nvSpPr>
        <p:spPr>
          <a:xfrm>
            <a:off x="4302205" y="6800150"/>
            <a:ext cx="20129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-1</a:t>
            </a:r>
            <a:r>
              <a:rPr sz="800" dirty="0">
                <a:latin typeface="Arial"/>
                <a:cs typeface="Arial"/>
              </a:rPr>
              <a:t>.5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37" name="object 37"/>
          <p:cNvGrpSpPr/>
          <p:nvPr/>
        </p:nvGrpSpPr>
        <p:grpSpPr>
          <a:xfrm>
            <a:off x="4416687" y="6992573"/>
            <a:ext cx="1650364" cy="645160"/>
            <a:chOff x="4416687" y="6992573"/>
            <a:chExt cx="1650364" cy="645160"/>
          </a:xfrm>
        </p:grpSpPr>
        <p:sp>
          <p:nvSpPr>
            <p:cNvPr id="38" name="object 38"/>
            <p:cNvSpPr/>
            <p:nvPr/>
          </p:nvSpPr>
          <p:spPr>
            <a:xfrm>
              <a:off x="5132794" y="7013905"/>
              <a:ext cx="508000" cy="490855"/>
            </a:xfrm>
            <a:custGeom>
              <a:avLst/>
              <a:gdLst/>
              <a:ahLst/>
              <a:cxnLst/>
              <a:rect l="l" t="t" r="r" b="b"/>
              <a:pathLst>
                <a:path w="508000" h="490854">
                  <a:moveTo>
                    <a:pt x="70091" y="463232"/>
                  </a:moveTo>
                  <a:lnTo>
                    <a:pt x="65519" y="449516"/>
                  </a:lnTo>
                  <a:lnTo>
                    <a:pt x="63995" y="447992"/>
                  </a:lnTo>
                  <a:lnTo>
                    <a:pt x="62471" y="446468"/>
                  </a:lnTo>
                  <a:lnTo>
                    <a:pt x="53327" y="440372"/>
                  </a:lnTo>
                  <a:lnTo>
                    <a:pt x="48755" y="438848"/>
                  </a:lnTo>
                  <a:lnTo>
                    <a:pt x="41148" y="438848"/>
                  </a:lnTo>
                  <a:lnTo>
                    <a:pt x="36563" y="440372"/>
                  </a:lnTo>
                  <a:lnTo>
                    <a:pt x="32004" y="443420"/>
                  </a:lnTo>
                  <a:lnTo>
                    <a:pt x="28956" y="446468"/>
                  </a:lnTo>
                  <a:lnTo>
                    <a:pt x="25895" y="447992"/>
                  </a:lnTo>
                  <a:lnTo>
                    <a:pt x="24384" y="451040"/>
                  </a:lnTo>
                  <a:lnTo>
                    <a:pt x="22860" y="455612"/>
                  </a:lnTo>
                  <a:lnTo>
                    <a:pt x="22860" y="458660"/>
                  </a:lnTo>
                  <a:lnTo>
                    <a:pt x="12192" y="441896"/>
                  </a:lnTo>
                  <a:lnTo>
                    <a:pt x="32004" y="422084"/>
                  </a:lnTo>
                  <a:lnTo>
                    <a:pt x="25895" y="415988"/>
                  </a:lnTo>
                  <a:lnTo>
                    <a:pt x="0" y="441896"/>
                  </a:lnTo>
                  <a:lnTo>
                    <a:pt x="21336" y="472376"/>
                  </a:lnTo>
                  <a:lnTo>
                    <a:pt x="28956" y="467804"/>
                  </a:lnTo>
                  <a:lnTo>
                    <a:pt x="27419" y="463232"/>
                  </a:lnTo>
                  <a:lnTo>
                    <a:pt x="28956" y="460184"/>
                  </a:lnTo>
                  <a:lnTo>
                    <a:pt x="29464" y="458660"/>
                  </a:lnTo>
                  <a:lnTo>
                    <a:pt x="30480" y="455612"/>
                  </a:lnTo>
                  <a:lnTo>
                    <a:pt x="35039" y="451040"/>
                  </a:lnTo>
                  <a:lnTo>
                    <a:pt x="41148" y="447992"/>
                  </a:lnTo>
                  <a:lnTo>
                    <a:pt x="47231" y="447992"/>
                  </a:lnTo>
                  <a:lnTo>
                    <a:pt x="53327" y="451040"/>
                  </a:lnTo>
                  <a:lnTo>
                    <a:pt x="56375" y="454088"/>
                  </a:lnTo>
                  <a:lnTo>
                    <a:pt x="60947" y="463232"/>
                  </a:lnTo>
                  <a:lnTo>
                    <a:pt x="60947" y="472376"/>
                  </a:lnTo>
                  <a:lnTo>
                    <a:pt x="59423" y="475411"/>
                  </a:lnTo>
                  <a:lnTo>
                    <a:pt x="57899" y="476935"/>
                  </a:lnTo>
                  <a:lnTo>
                    <a:pt x="54864" y="478459"/>
                  </a:lnTo>
                  <a:lnTo>
                    <a:pt x="53327" y="479996"/>
                  </a:lnTo>
                  <a:lnTo>
                    <a:pt x="50279" y="481520"/>
                  </a:lnTo>
                  <a:lnTo>
                    <a:pt x="45707" y="481520"/>
                  </a:lnTo>
                  <a:lnTo>
                    <a:pt x="39611" y="478459"/>
                  </a:lnTo>
                  <a:lnTo>
                    <a:pt x="38087" y="476935"/>
                  </a:lnTo>
                  <a:lnTo>
                    <a:pt x="32004" y="484568"/>
                  </a:lnTo>
                  <a:lnTo>
                    <a:pt x="35039" y="487603"/>
                  </a:lnTo>
                  <a:lnTo>
                    <a:pt x="39611" y="489127"/>
                  </a:lnTo>
                  <a:lnTo>
                    <a:pt x="42672" y="489127"/>
                  </a:lnTo>
                  <a:lnTo>
                    <a:pt x="47231" y="490651"/>
                  </a:lnTo>
                  <a:lnTo>
                    <a:pt x="51803" y="489127"/>
                  </a:lnTo>
                  <a:lnTo>
                    <a:pt x="54864" y="487603"/>
                  </a:lnTo>
                  <a:lnTo>
                    <a:pt x="59423" y="486079"/>
                  </a:lnTo>
                  <a:lnTo>
                    <a:pt x="70091" y="467804"/>
                  </a:lnTo>
                  <a:lnTo>
                    <a:pt x="70091" y="463232"/>
                  </a:lnTo>
                  <a:close/>
                </a:path>
                <a:path w="508000" h="490854">
                  <a:moveTo>
                    <a:pt x="117335" y="425132"/>
                  </a:moveTo>
                  <a:lnTo>
                    <a:pt x="83807" y="420560"/>
                  </a:lnTo>
                  <a:lnTo>
                    <a:pt x="83578" y="419036"/>
                  </a:lnTo>
                  <a:lnTo>
                    <a:pt x="79235" y="390080"/>
                  </a:lnTo>
                  <a:lnTo>
                    <a:pt x="71615" y="397700"/>
                  </a:lnTo>
                  <a:lnTo>
                    <a:pt x="74663" y="411416"/>
                  </a:lnTo>
                  <a:lnTo>
                    <a:pt x="74663" y="419036"/>
                  </a:lnTo>
                  <a:lnTo>
                    <a:pt x="71615" y="419036"/>
                  </a:lnTo>
                  <a:lnTo>
                    <a:pt x="68567" y="417525"/>
                  </a:lnTo>
                  <a:lnTo>
                    <a:pt x="53327" y="414464"/>
                  </a:lnTo>
                  <a:lnTo>
                    <a:pt x="45707" y="422084"/>
                  </a:lnTo>
                  <a:lnTo>
                    <a:pt x="76187" y="428180"/>
                  </a:lnTo>
                  <a:lnTo>
                    <a:pt x="82283" y="460184"/>
                  </a:lnTo>
                  <a:lnTo>
                    <a:pt x="89890" y="452564"/>
                  </a:lnTo>
                  <a:lnTo>
                    <a:pt x="85331" y="428180"/>
                  </a:lnTo>
                  <a:lnTo>
                    <a:pt x="89890" y="429717"/>
                  </a:lnTo>
                  <a:lnTo>
                    <a:pt x="109702" y="434276"/>
                  </a:lnTo>
                  <a:lnTo>
                    <a:pt x="114795" y="428180"/>
                  </a:lnTo>
                  <a:lnTo>
                    <a:pt x="117335" y="425132"/>
                  </a:lnTo>
                  <a:close/>
                </a:path>
                <a:path w="508000" h="490854">
                  <a:moveTo>
                    <a:pt x="129514" y="365709"/>
                  </a:moveTo>
                  <a:lnTo>
                    <a:pt x="123418" y="359613"/>
                  </a:lnTo>
                  <a:lnTo>
                    <a:pt x="99034" y="383997"/>
                  </a:lnTo>
                  <a:lnTo>
                    <a:pt x="83807" y="368757"/>
                  </a:lnTo>
                  <a:lnTo>
                    <a:pt x="111226" y="341337"/>
                  </a:lnTo>
                  <a:lnTo>
                    <a:pt x="105143" y="335229"/>
                  </a:lnTo>
                  <a:lnTo>
                    <a:pt x="70091" y="368757"/>
                  </a:lnTo>
                  <a:lnTo>
                    <a:pt x="121894" y="420560"/>
                  </a:lnTo>
                  <a:lnTo>
                    <a:pt x="129514" y="414464"/>
                  </a:lnTo>
                  <a:lnTo>
                    <a:pt x="105143" y="390080"/>
                  </a:lnTo>
                  <a:lnTo>
                    <a:pt x="111226" y="383997"/>
                  </a:lnTo>
                  <a:lnTo>
                    <a:pt x="129514" y="365709"/>
                  </a:lnTo>
                  <a:close/>
                </a:path>
                <a:path w="508000" h="490854">
                  <a:moveTo>
                    <a:pt x="208749" y="335229"/>
                  </a:moveTo>
                  <a:lnTo>
                    <a:pt x="201790" y="332181"/>
                  </a:lnTo>
                  <a:lnTo>
                    <a:pt x="172173" y="319227"/>
                  </a:lnTo>
                  <a:lnTo>
                    <a:pt x="172173" y="329145"/>
                  </a:lnTo>
                  <a:lnTo>
                    <a:pt x="153885" y="347421"/>
                  </a:lnTo>
                  <a:lnTo>
                    <a:pt x="144754" y="326085"/>
                  </a:lnTo>
                  <a:lnTo>
                    <a:pt x="141693" y="318477"/>
                  </a:lnTo>
                  <a:lnTo>
                    <a:pt x="137134" y="313893"/>
                  </a:lnTo>
                  <a:lnTo>
                    <a:pt x="143230" y="316953"/>
                  </a:lnTo>
                  <a:lnTo>
                    <a:pt x="152361" y="320001"/>
                  </a:lnTo>
                  <a:lnTo>
                    <a:pt x="172173" y="329145"/>
                  </a:lnTo>
                  <a:lnTo>
                    <a:pt x="172173" y="319227"/>
                  </a:lnTo>
                  <a:lnTo>
                    <a:pt x="159981" y="313893"/>
                  </a:lnTo>
                  <a:lnTo>
                    <a:pt x="135610" y="303237"/>
                  </a:lnTo>
                  <a:lnTo>
                    <a:pt x="127990" y="310845"/>
                  </a:lnTo>
                  <a:lnTo>
                    <a:pt x="159981" y="382473"/>
                  </a:lnTo>
                  <a:lnTo>
                    <a:pt x="167614" y="376364"/>
                  </a:lnTo>
                  <a:lnTo>
                    <a:pt x="158470" y="355041"/>
                  </a:lnTo>
                  <a:lnTo>
                    <a:pt x="165582" y="347421"/>
                  </a:lnTo>
                  <a:lnTo>
                    <a:pt x="179793" y="332181"/>
                  </a:lnTo>
                  <a:lnTo>
                    <a:pt x="201117" y="342861"/>
                  </a:lnTo>
                  <a:lnTo>
                    <a:pt x="208749" y="335229"/>
                  </a:lnTo>
                  <a:close/>
                </a:path>
                <a:path w="508000" h="490854">
                  <a:moveTo>
                    <a:pt x="243789" y="280377"/>
                  </a:moveTo>
                  <a:lnTo>
                    <a:pt x="242252" y="277329"/>
                  </a:lnTo>
                  <a:lnTo>
                    <a:pt x="240741" y="271233"/>
                  </a:lnTo>
                  <a:lnTo>
                    <a:pt x="237693" y="268185"/>
                  </a:lnTo>
                  <a:lnTo>
                    <a:pt x="236169" y="265150"/>
                  </a:lnTo>
                  <a:lnTo>
                    <a:pt x="236169" y="287985"/>
                  </a:lnTo>
                  <a:lnTo>
                    <a:pt x="234645" y="292569"/>
                  </a:lnTo>
                  <a:lnTo>
                    <a:pt x="233121" y="295617"/>
                  </a:lnTo>
                  <a:lnTo>
                    <a:pt x="230073" y="300177"/>
                  </a:lnTo>
                  <a:lnTo>
                    <a:pt x="228549" y="301701"/>
                  </a:lnTo>
                  <a:lnTo>
                    <a:pt x="227025" y="304761"/>
                  </a:lnTo>
                  <a:lnTo>
                    <a:pt x="214833" y="315429"/>
                  </a:lnTo>
                  <a:lnTo>
                    <a:pt x="175221" y="275805"/>
                  </a:lnTo>
                  <a:lnTo>
                    <a:pt x="187413" y="265150"/>
                  </a:lnTo>
                  <a:lnTo>
                    <a:pt x="188937" y="262089"/>
                  </a:lnTo>
                  <a:lnTo>
                    <a:pt x="195033" y="259041"/>
                  </a:lnTo>
                  <a:lnTo>
                    <a:pt x="196557" y="257517"/>
                  </a:lnTo>
                  <a:lnTo>
                    <a:pt x="199605" y="255993"/>
                  </a:lnTo>
                  <a:lnTo>
                    <a:pt x="205701" y="255993"/>
                  </a:lnTo>
                  <a:lnTo>
                    <a:pt x="208749" y="257517"/>
                  </a:lnTo>
                  <a:lnTo>
                    <a:pt x="211785" y="257517"/>
                  </a:lnTo>
                  <a:lnTo>
                    <a:pt x="216357" y="260565"/>
                  </a:lnTo>
                  <a:lnTo>
                    <a:pt x="219417" y="263613"/>
                  </a:lnTo>
                  <a:lnTo>
                    <a:pt x="223977" y="266661"/>
                  </a:lnTo>
                  <a:lnTo>
                    <a:pt x="228549" y="272757"/>
                  </a:lnTo>
                  <a:lnTo>
                    <a:pt x="231597" y="275805"/>
                  </a:lnTo>
                  <a:lnTo>
                    <a:pt x="233121" y="278853"/>
                  </a:lnTo>
                  <a:lnTo>
                    <a:pt x="234645" y="283425"/>
                  </a:lnTo>
                  <a:lnTo>
                    <a:pt x="234645" y="286473"/>
                  </a:lnTo>
                  <a:lnTo>
                    <a:pt x="236169" y="287985"/>
                  </a:lnTo>
                  <a:lnTo>
                    <a:pt x="236169" y="265150"/>
                  </a:lnTo>
                  <a:lnTo>
                    <a:pt x="227025" y="255993"/>
                  </a:lnTo>
                  <a:lnTo>
                    <a:pt x="223977" y="254482"/>
                  </a:lnTo>
                  <a:lnTo>
                    <a:pt x="220941" y="251421"/>
                  </a:lnTo>
                  <a:lnTo>
                    <a:pt x="216357" y="249897"/>
                  </a:lnTo>
                  <a:lnTo>
                    <a:pt x="213309" y="248373"/>
                  </a:lnTo>
                  <a:lnTo>
                    <a:pt x="208749" y="246849"/>
                  </a:lnTo>
                  <a:lnTo>
                    <a:pt x="199605" y="246849"/>
                  </a:lnTo>
                  <a:lnTo>
                    <a:pt x="196557" y="248373"/>
                  </a:lnTo>
                  <a:lnTo>
                    <a:pt x="193509" y="248373"/>
                  </a:lnTo>
                  <a:lnTo>
                    <a:pt x="190461" y="251421"/>
                  </a:lnTo>
                  <a:lnTo>
                    <a:pt x="188937" y="251421"/>
                  </a:lnTo>
                  <a:lnTo>
                    <a:pt x="185889" y="254482"/>
                  </a:lnTo>
                  <a:lnTo>
                    <a:pt x="182841" y="255993"/>
                  </a:lnTo>
                  <a:lnTo>
                    <a:pt x="181317" y="259041"/>
                  </a:lnTo>
                  <a:lnTo>
                    <a:pt x="163029" y="277329"/>
                  </a:lnTo>
                  <a:lnTo>
                    <a:pt x="214833" y="329145"/>
                  </a:lnTo>
                  <a:lnTo>
                    <a:pt x="227495" y="315429"/>
                  </a:lnTo>
                  <a:lnTo>
                    <a:pt x="233121" y="309321"/>
                  </a:lnTo>
                  <a:lnTo>
                    <a:pt x="237693" y="304761"/>
                  </a:lnTo>
                  <a:lnTo>
                    <a:pt x="240741" y="300177"/>
                  </a:lnTo>
                  <a:lnTo>
                    <a:pt x="242252" y="295617"/>
                  </a:lnTo>
                  <a:lnTo>
                    <a:pt x="243789" y="292569"/>
                  </a:lnTo>
                  <a:lnTo>
                    <a:pt x="243789" y="280377"/>
                  </a:lnTo>
                  <a:close/>
                </a:path>
                <a:path w="508000" h="490854">
                  <a:moveTo>
                    <a:pt x="266636" y="278853"/>
                  </a:moveTo>
                  <a:lnTo>
                    <a:pt x="228549" y="210286"/>
                  </a:lnTo>
                  <a:lnTo>
                    <a:pt x="223977" y="214858"/>
                  </a:lnTo>
                  <a:lnTo>
                    <a:pt x="262077" y="283425"/>
                  </a:lnTo>
                  <a:lnTo>
                    <a:pt x="266636" y="278853"/>
                  </a:lnTo>
                  <a:close/>
                </a:path>
                <a:path w="508000" h="490854">
                  <a:moveTo>
                    <a:pt x="309321" y="234657"/>
                  </a:moveTo>
                  <a:lnTo>
                    <a:pt x="308635" y="233146"/>
                  </a:lnTo>
                  <a:lnTo>
                    <a:pt x="277317" y="163042"/>
                  </a:lnTo>
                  <a:lnTo>
                    <a:pt x="269697" y="169138"/>
                  </a:lnTo>
                  <a:lnTo>
                    <a:pt x="294068" y="220954"/>
                  </a:lnTo>
                  <a:lnTo>
                    <a:pt x="295592" y="227037"/>
                  </a:lnTo>
                  <a:lnTo>
                    <a:pt x="300177" y="233146"/>
                  </a:lnTo>
                  <a:lnTo>
                    <a:pt x="287985" y="227037"/>
                  </a:lnTo>
                  <a:lnTo>
                    <a:pt x="237705" y="202653"/>
                  </a:lnTo>
                  <a:lnTo>
                    <a:pt x="230085" y="210286"/>
                  </a:lnTo>
                  <a:lnTo>
                    <a:pt x="301701" y="242277"/>
                  </a:lnTo>
                  <a:lnTo>
                    <a:pt x="309321" y="234657"/>
                  </a:lnTo>
                  <a:close/>
                </a:path>
                <a:path w="508000" h="490854">
                  <a:moveTo>
                    <a:pt x="358063" y="172186"/>
                  </a:moveTo>
                  <a:lnTo>
                    <a:pt x="355028" y="166090"/>
                  </a:lnTo>
                  <a:lnTo>
                    <a:pt x="347408" y="170662"/>
                  </a:lnTo>
                  <a:lnTo>
                    <a:pt x="350456" y="176758"/>
                  </a:lnTo>
                  <a:lnTo>
                    <a:pt x="350456" y="181330"/>
                  </a:lnTo>
                  <a:lnTo>
                    <a:pt x="347408" y="187426"/>
                  </a:lnTo>
                  <a:lnTo>
                    <a:pt x="345871" y="188937"/>
                  </a:lnTo>
                  <a:lnTo>
                    <a:pt x="342836" y="190461"/>
                  </a:lnTo>
                  <a:lnTo>
                    <a:pt x="341312" y="191998"/>
                  </a:lnTo>
                  <a:lnTo>
                    <a:pt x="338264" y="193522"/>
                  </a:lnTo>
                  <a:lnTo>
                    <a:pt x="335216" y="193522"/>
                  </a:lnTo>
                  <a:lnTo>
                    <a:pt x="332168" y="191998"/>
                  </a:lnTo>
                  <a:lnTo>
                    <a:pt x="327596" y="191998"/>
                  </a:lnTo>
                  <a:lnTo>
                    <a:pt x="324561" y="188937"/>
                  </a:lnTo>
                  <a:lnTo>
                    <a:pt x="321513" y="187426"/>
                  </a:lnTo>
                  <a:lnTo>
                    <a:pt x="327939" y="181330"/>
                  </a:lnTo>
                  <a:lnTo>
                    <a:pt x="350456" y="159994"/>
                  </a:lnTo>
                  <a:lnTo>
                    <a:pt x="348932" y="158470"/>
                  </a:lnTo>
                  <a:lnTo>
                    <a:pt x="348932" y="156946"/>
                  </a:lnTo>
                  <a:lnTo>
                    <a:pt x="345897" y="155435"/>
                  </a:lnTo>
                  <a:lnTo>
                    <a:pt x="342836" y="153911"/>
                  </a:lnTo>
                  <a:lnTo>
                    <a:pt x="338264" y="150850"/>
                  </a:lnTo>
                  <a:lnTo>
                    <a:pt x="338264" y="161518"/>
                  </a:lnTo>
                  <a:lnTo>
                    <a:pt x="316928" y="181330"/>
                  </a:lnTo>
                  <a:lnTo>
                    <a:pt x="315404" y="178269"/>
                  </a:lnTo>
                  <a:lnTo>
                    <a:pt x="313893" y="176758"/>
                  </a:lnTo>
                  <a:lnTo>
                    <a:pt x="312369" y="173710"/>
                  </a:lnTo>
                  <a:lnTo>
                    <a:pt x="312369" y="167614"/>
                  </a:lnTo>
                  <a:lnTo>
                    <a:pt x="313893" y="164566"/>
                  </a:lnTo>
                  <a:lnTo>
                    <a:pt x="315404" y="163042"/>
                  </a:lnTo>
                  <a:lnTo>
                    <a:pt x="316928" y="159994"/>
                  </a:lnTo>
                  <a:lnTo>
                    <a:pt x="319976" y="158470"/>
                  </a:lnTo>
                  <a:lnTo>
                    <a:pt x="321513" y="156946"/>
                  </a:lnTo>
                  <a:lnTo>
                    <a:pt x="324561" y="155435"/>
                  </a:lnTo>
                  <a:lnTo>
                    <a:pt x="329120" y="155435"/>
                  </a:lnTo>
                  <a:lnTo>
                    <a:pt x="330644" y="156946"/>
                  </a:lnTo>
                  <a:lnTo>
                    <a:pt x="332168" y="156946"/>
                  </a:lnTo>
                  <a:lnTo>
                    <a:pt x="335216" y="158470"/>
                  </a:lnTo>
                  <a:lnTo>
                    <a:pt x="338264" y="161518"/>
                  </a:lnTo>
                  <a:lnTo>
                    <a:pt x="338264" y="150850"/>
                  </a:lnTo>
                  <a:lnTo>
                    <a:pt x="329120" y="147802"/>
                  </a:lnTo>
                  <a:lnTo>
                    <a:pt x="324561" y="147802"/>
                  </a:lnTo>
                  <a:lnTo>
                    <a:pt x="319976" y="149326"/>
                  </a:lnTo>
                  <a:lnTo>
                    <a:pt x="315404" y="152374"/>
                  </a:lnTo>
                  <a:lnTo>
                    <a:pt x="312369" y="155435"/>
                  </a:lnTo>
                  <a:lnTo>
                    <a:pt x="307784" y="158470"/>
                  </a:lnTo>
                  <a:lnTo>
                    <a:pt x="304736" y="167614"/>
                  </a:lnTo>
                  <a:lnTo>
                    <a:pt x="304736" y="178269"/>
                  </a:lnTo>
                  <a:lnTo>
                    <a:pt x="333692" y="202653"/>
                  </a:lnTo>
                  <a:lnTo>
                    <a:pt x="347408" y="198094"/>
                  </a:lnTo>
                  <a:lnTo>
                    <a:pt x="350456" y="193522"/>
                  </a:lnTo>
                  <a:lnTo>
                    <a:pt x="356539" y="187426"/>
                  </a:lnTo>
                  <a:lnTo>
                    <a:pt x="358063" y="182854"/>
                  </a:lnTo>
                  <a:lnTo>
                    <a:pt x="358063" y="172186"/>
                  </a:lnTo>
                  <a:close/>
                </a:path>
                <a:path w="508000" h="490854">
                  <a:moveTo>
                    <a:pt x="376364" y="77711"/>
                  </a:moveTo>
                  <a:lnTo>
                    <a:pt x="368731" y="71615"/>
                  </a:lnTo>
                  <a:lnTo>
                    <a:pt x="362648" y="77711"/>
                  </a:lnTo>
                  <a:lnTo>
                    <a:pt x="370255" y="85331"/>
                  </a:lnTo>
                  <a:lnTo>
                    <a:pt x="376364" y="77711"/>
                  </a:lnTo>
                  <a:close/>
                </a:path>
                <a:path w="508000" h="490854">
                  <a:moveTo>
                    <a:pt x="405307" y="138658"/>
                  </a:moveTo>
                  <a:lnTo>
                    <a:pt x="382460" y="115811"/>
                  </a:lnTo>
                  <a:lnTo>
                    <a:pt x="380923" y="114274"/>
                  </a:lnTo>
                  <a:lnTo>
                    <a:pt x="377875" y="112750"/>
                  </a:lnTo>
                  <a:lnTo>
                    <a:pt x="376364" y="109715"/>
                  </a:lnTo>
                  <a:lnTo>
                    <a:pt x="373316" y="108191"/>
                  </a:lnTo>
                  <a:lnTo>
                    <a:pt x="371792" y="108191"/>
                  </a:lnTo>
                  <a:lnTo>
                    <a:pt x="368731" y="106667"/>
                  </a:lnTo>
                  <a:lnTo>
                    <a:pt x="364172" y="106667"/>
                  </a:lnTo>
                  <a:lnTo>
                    <a:pt x="362648" y="108191"/>
                  </a:lnTo>
                  <a:lnTo>
                    <a:pt x="359600" y="108191"/>
                  </a:lnTo>
                  <a:lnTo>
                    <a:pt x="358063" y="109715"/>
                  </a:lnTo>
                  <a:lnTo>
                    <a:pt x="355028" y="111239"/>
                  </a:lnTo>
                  <a:lnTo>
                    <a:pt x="353504" y="112750"/>
                  </a:lnTo>
                  <a:lnTo>
                    <a:pt x="350456" y="117335"/>
                  </a:lnTo>
                  <a:lnTo>
                    <a:pt x="348932" y="120383"/>
                  </a:lnTo>
                  <a:lnTo>
                    <a:pt x="347408" y="124942"/>
                  </a:lnTo>
                  <a:lnTo>
                    <a:pt x="347408" y="129527"/>
                  </a:lnTo>
                  <a:lnTo>
                    <a:pt x="329120" y="111239"/>
                  </a:lnTo>
                  <a:lnTo>
                    <a:pt x="323037" y="117335"/>
                  </a:lnTo>
                  <a:lnTo>
                    <a:pt x="374840" y="169138"/>
                  </a:lnTo>
                  <a:lnTo>
                    <a:pt x="380923" y="163042"/>
                  </a:lnTo>
                  <a:lnTo>
                    <a:pt x="359600" y="141719"/>
                  </a:lnTo>
                  <a:lnTo>
                    <a:pt x="356539" y="137134"/>
                  </a:lnTo>
                  <a:lnTo>
                    <a:pt x="355028" y="134099"/>
                  </a:lnTo>
                  <a:lnTo>
                    <a:pt x="353504" y="132575"/>
                  </a:lnTo>
                  <a:lnTo>
                    <a:pt x="353504" y="129527"/>
                  </a:lnTo>
                  <a:lnTo>
                    <a:pt x="353504" y="126466"/>
                  </a:lnTo>
                  <a:lnTo>
                    <a:pt x="355028" y="123431"/>
                  </a:lnTo>
                  <a:lnTo>
                    <a:pt x="361124" y="117335"/>
                  </a:lnTo>
                  <a:lnTo>
                    <a:pt x="364172" y="115811"/>
                  </a:lnTo>
                  <a:lnTo>
                    <a:pt x="367207" y="115811"/>
                  </a:lnTo>
                  <a:lnTo>
                    <a:pt x="370255" y="117335"/>
                  </a:lnTo>
                  <a:lnTo>
                    <a:pt x="371792" y="118859"/>
                  </a:lnTo>
                  <a:lnTo>
                    <a:pt x="374840" y="120383"/>
                  </a:lnTo>
                  <a:lnTo>
                    <a:pt x="399211" y="144767"/>
                  </a:lnTo>
                  <a:lnTo>
                    <a:pt x="405307" y="138658"/>
                  </a:lnTo>
                  <a:close/>
                </a:path>
                <a:path w="508000" h="490854">
                  <a:moveTo>
                    <a:pt x="420535" y="123431"/>
                  </a:moveTo>
                  <a:lnTo>
                    <a:pt x="383971" y="85331"/>
                  </a:lnTo>
                  <a:lnTo>
                    <a:pt x="376364" y="91427"/>
                  </a:lnTo>
                  <a:lnTo>
                    <a:pt x="414451" y="129527"/>
                  </a:lnTo>
                  <a:lnTo>
                    <a:pt x="420535" y="123431"/>
                  </a:lnTo>
                  <a:close/>
                </a:path>
                <a:path w="508000" h="490854">
                  <a:moveTo>
                    <a:pt x="452539" y="76187"/>
                  </a:moveTo>
                  <a:lnTo>
                    <a:pt x="451015" y="73139"/>
                  </a:lnTo>
                  <a:lnTo>
                    <a:pt x="447979" y="70091"/>
                  </a:lnTo>
                  <a:lnTo>
                    <a:pt x="441871" y="74663"/>
                  </a:lnTo>
                  <a:lnTo>
                    <a:pt x="443395" y="77711"/>
                  </a:lnTo>
                  <a:lnTo>
                    <a:pt x="443395" y="79235"/>
                  </a:lnTo>
                  <a:lnTo>
                    <a:pt x="444919" y="82283"/>
                  </a:lnTo>
                  <a:lnTo>
                    <a:pt x="444919" y="86855"/>
                  </a:lnTo>
                  <a:lnTo>
                    <a:pt x="443395" y="89890"/>
                  </a:lnTo>
                  <a:lnTo>
                    <a:pt x="440347" y="92951"/>
                  </a:lnTo>
                  <a:lnTo>
                    <a:pt x="438823" y="95999"/>
                  </a:lnTo>
                  <a:lnTo>
                    <a:pt x="435787" y="95999"/>
                  </a:lnTo>
                  <a:lnTo>
                    <a:pt x="432727" y="97523"/>
                  </a:lnTo>
                  <a:lnTo>
                    <a:pt x="426643" y="97523"/>
                  </a:lnTo>
                  <a:lnTo>
                    <a:pt x="423595" y="95999"/>
                  </a:lnTo>
                  <a:lnTo>
                    <a:pt x="420535" y="92951"/>
                  </a:lnTo>
                  <a:lnTo>
                    <a:pt x="415975" y="89890"/>
                  </a:lnTo>
                  <a:lnTo>
                    <a:pt x="412927" y="85331"/>
                  </a:lnTo>
                  <a:lnTo>
                    <a:pt x="409879" y="82283"/>
                  </a:lnTo>
                  <a:lnTo>
                    <a:pt x="408343" y="79235"/>
                  </a:lnTo>
                  <a:lnTo>
                    <a:pt x="408343" y="73139"/>
                  </a:lnTo>
                  <a:lnTo>
                    <a:pt x="409879" y="70091"/>
                  </a:lnTo>
                  <a:lnTo>
                    <a:pt x="409879" y="67056"/>
                  </a:lnTo>
                  <a:lnTo>
                    <a:pt x="414451" y="62471"/>
                  </a:lnTo>
                  <a:lnTo>
                    <a:pt x="415975" y="62471"/>
                  </a:lnTo>
                  <a:lnTo>
                    <a:pt x="417499" y="60947"/>
                  </a:lnTo>
                  <a:lnTo>
                    <a:pt x="423595" y="60947"/>
                  </a:lnTo>
                  <a:lnTo>
                    <a:pt x="426643" y="62471"/>
                  </a:lnTo>
                  <a:lnTo>
                    <a:pt x="428155" y="63995"/>
                  </a:lnTo>
                  <a:lnTo>
                    <a:pt x="430593" y="60947"/>
                  </a:lnTo>
                  <a:lnTo>
                    <a:pt x="434251" y="56388"/>
                  </a:lnTo>
                  <a:lnTo>
                    <a:pt x="431203" y="54864"/>
                  </a:lnTo>
                  <a:lnTo>
                    <a:pt x="426643" y="53340"/>
                  </a:lnTo>
                  <a:lnTo>
                    <a:pt x="423595" y="51803"/>
                  </a:lnTo>
                  <a:lnTo>
                    <a:pt x="420535" y="53340"/>
                  </a:lnTo>
                  <a:lnTo>
                    <a:pt x="417499" y="53340"/>
                  </a:lnTo>
                  <a:lnTo>
                    <a:pt x="412927" y="54864"/>
                  </a:lnTo>
                  <a:lnTo>
                    <a:pt x="409879" y="56388"/>
                  </a:lnTo>
                  <a:lnTo>
                    <a:pt x="406831" y="59423"/>
                  </a:lnTo>
                  <a:lnTo>
                    <a:pt x="405307" y="62471"/>
                  </a:lnTo>
                  <a:lnTo>
                    <a:pt x="402259" y="63995"/>
                  </a:lnTo>
                  <a:lnTo>
                    <a:pt x="400735" y="67056"/>
                  </a:lnTo>
                  <a:lnTo>
                    <a:pt x="400735" y="70091"/>
                  </a:lnTo>
                  <a:lnTo>
                    <a:pt x="399211" y="73139"/>
                  </a:lnTo>
                  <a:lnTo>
                    <a:pt x="399211" y="77711"/>
                  </a:lnTo>
                  <a:lnTo>
                    <a:pt x="400735" y="80759"/>
                  </a:lnTo>
                  <a:lnTo>
                    <a:pt x="400735" y="83807"/>
                  </a:lnTo>
                  <a:lnTo>
                    <a:pt x="402259" y="86855"/>
                  </a:lnTo>
                  <a:lnTo>
                    <a:pt x="405307" y="89890"/>
                  </a:lnTo>
                  <a:lnTo>
                    <a:pt x="406831" y="92951"/>
                  </a:lnTo>
                  <a:lnTo>
                    <a:pt x="414451" y="100571"/>
                  </a:lnTo>
                  <a:lnTo>
                    <a:pt x="419011" y="103619"/>
                  </a:lnTo>
                  <a:lnTo>
                    <a:pt x="423595" y="105143"/>
                  </a:lnTo>
                  <a:lnTo>
                    <a:pt x="429679" y="106667"/>
                  </a:lnTo>
                  <a:lnTo>
                    <a:pt x="438823" y="103619"/>
                  </a:lnTo>
                  <a:lnTo>
                    <a:pt x="441871" y="102082"/>
                  </a:lnTo>
                  <a:lnTo>
                    <a:pt x="446443" y="99047"/>
                  </a:lnTo>
                  <a:lnTo>
                    <a:pt x="447967" y="97523"/>
                  </a:lnTo>
                  <a:lnTo>
                    <a:pt x="449491" y="95999"/>
                  </a:lnTo>
                  <a:lnTo>
                    <a:pt x="451015" y="91427"/>
                  </a:lnTo>
                  <a:lnTo>
                    <a:pt x="452539" y="88379"/>
                  </a:lnTo>
                  <a:lnTo>
                    <a:pt x="452539" y="76187"/>
                  </a:lnTo>
                  <a:close/>
                </a:path>
                <a:path w="508000" h="490854">
                  <a:moveTo>
                    <a:pt x="473875" y="70091"/>
                  </a:moveTo>
                  <a:lnTo>
                    <a:pt x="422071" y="18288"/>
                  </a:lnTo>
                  <a:lnTo>
                    <a:pt x="415975" y="24384"/>
                  </a:lnTo>
                  <a:lnTo>
                    <a:pt x="466255" y="76187"/>
                  </a:lnTo>
                  <a:lnTo>
                    <a:pt x="473875" y="70091"/>
                  </a:lnTo>
                  <a:close/>
                </a:path>
                <a:path w="508000" h="490854">
                  <a:moveTo>
                    <a:pt x="507390" y="24384"/>
                  </a:moveTo>
                  <a:lnTo>
                    <a:pt x="505866" y="19812"/>
                  </a:lnTo>
                  <a:lnTo>
                    <a:pt x="504342" y="16764"/>
                  </a:lnTo>
                  <a:lnTo>
                    <a:pt x="496722" y="22860"/>
                  </a:lnTo>
                  <a:lnTo>
                    <a:pt x="498259" y="27432"/>
                  </a:lnTo>
                  <a:lnTo>
                    <a:pt x="498259" y="33528"/>
                  </a:lnTo>
                  <a:lnTo>
                    <a:pt x="495198" y="39611"/>
                  </a:lnTo>
                  <a:lnTo>
                    <a:pt x="492150" y="42672"/>
                  </a:lnTo>
                  <a:lnTo>
                    <a:pt x="489115" y="44196"/>
                  </a:lnTo>
                  <a:lnTo>
                    <a:pt x="479971" y="44196"/>
                  </a:lnTo>
                  <a:lnTo>
                    <a:pt x="473875" y="41148"/>
                  </a:lnTo>
                  <a:lnTo>
                    <a:pt x="470814" y="38087"/>
                  </a:lnTo>
                  <a:lnTo>
                    <a:pt x="475373" y="33528"/>
                  </a:lnTo>
                  <a:lnTo>
                    <a:pt x="498259" y="10668"/>
                  </a:lnTo>
                  <a:lnTo>
                    <a:pt x="495198" y="7620"/>
                  </a:lnTo>
                  <a:lnTo>
                    <a:pt x="492150" y="4572"/>
                  </a:lnTo>
                  <a:lnTo>
                    <a:pt x="487591" y="1524"/>
                  </a:lnTo>
                  <a:lnTo>
                    <a:pt x="486067" y="1028"/>
                  </a:lnTo>
                  <a:lnTo>
                    <a:pt x="486067" y="12192"/>
                  </a:lnTo>
                  <a:lnTo>
                    <a:pt x="466255" y="33528"/>
                  </a:lnTo>
                  <a:lnTo>
                    <a:pt x="463207" y="30480"/>
                  </a:lnTo>
                  <a:lnTo>
                    <a:pt x="461683" y="27432"/>
                  </a:lnTo>
                  <a:lnTo>
                    <a:pt x="461683" y="16764"/>
                  </a:lnTo>
                  <a:lnTo>
                    <a:pt x="463207" y="13716"/>
                  </a:lnTo>
                  <a:lnTo>
                    <a:pt x="466255" y="12192"/>
                  </a:lnTo>
                  <a:lnTo>
                    <a:pt x="467779" y="9144"/>
                  </a:lnTo>
                  <a:lnTo>
                    <a:pt x="470814" y="7620"/>
                  </a:lnTo>
                  <a:lnTo>
                    <a:pt x="479971" y="7620"/>
                  </a:lnTo>
                  <a:lnTo>
                    <a:pt x="481482" y="9144"/>
                  </a:lnTo>
                  <a:lnTo>
                    <a:pt x="484530" y="10668"/>
                  </a:lnTo>
                  <a:lnTo>
                    <a:pt x="486067" y="12192"/>
                  </a:lnTo>
                  <a:lnTo>
                    <a:pt x="486067" y="1028"/>
                  </a:lnTo>
                  <a:lnTo>
                    <a:pt x="483006" y="0"/>
                  </a:lnTo>
                  <a:lnTo>
                    <a:pt x="467779" y="0"/>
                  </a:lnTo>
                  <a:lnTo>
                    <a:pt x="464731" y="3048"/>
                  </a:lnTo>
                  <a:lnTo>
                    <a:pt x="460159" y="6096"/>
                  </a:lnTo>
                  <a:lnTo>
                    <a:pt x="454063" y="15240"/>
                  </a:lnTo>
                  <a:lnTo>
                    <a:pt x="452539" y="19812"/>
                  </a:lnTo>
                  <a:lnTo>
                    <a:pt x="452539" y="24384"/>
                  </a:lnTo>
                  <a:lnTo>
                    <a:pt x="481482" y="53340"/>
                  </a:lnTo>
                  <a:lnTo>
                    <a:pt x="486067" y="53340"/>
                  </a:lnTo>
                  <a:lnTo>
                    <a:pt x="490626" y="51803"/>
                  </a:lnTo>
                  <a:lnTo>
                    <a:pt x="499783" y="45720"/>
                  </a:lnTo>
                  <a:lnTo>
                    <a:pt x="500786" y="44196"/>
                  </a:lnTo>
                  <a:lnTo>
                    <a:pt x="502818" y="41148"/>
                  </a:lnTo>
                  <a:lnTo>
                    <a:pt x="507390" y="32004"/>
                  </a:lnTo>
                  <a:lnTo>
                    <a:pt x="507390" y="24384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9" name="object 3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416687" y="7202844"/>
              <a:ext cx="170649" cy="172199"/>
            </a:xfrm>
            <a:prstGeom prst="rect">
              <a:avLst/>
            </a:prstGeom>
          </p:spPr>
        </p:pic>
        <p:sp>
          <p:nvSpPr>
            <p:cNvPr id="40" name="object 40"/>
            <p:cNvSpPr/>
            <p:nvPr/>
          </p:nvSpPr>
          <p:spPr>
            <a:xfrm>
              <a:off x="4550753" y="6992581"/>
              <a:ext cx="1516380" cy="645160"/>
            </a:xfrm>
            <a:custGeom>
              <a:avLst/>
              <a:gdLst/>
              <a:ahLst/>
              <a:cxnLst/>
              <a:rect l="l" t="t" r="r" b="b"/>
              <a:pathLst>
                <a:path w="1516379" h="645159">
                  <a:moveTo>
                    <a:pt x="79248" y="234657"/>
                  </a:moveTo>
                  <a:lnTo>
                    <a:pt x="77889" y="231622"/>
                  </a:lnTo>
                  <a:lnTo>
                    <a:pt x="47244" y="163042"/>
                  </a:lnTo>
                  <a:lnTo>
                    <a:pt x="41148" y="169138"/>
                  </a:lnTo>
                  <a:lnTo>
                    <a:pt x="63995" y="220941"/>
                  </a:lnTo>
                  <a:lnTo>
                    <a:pt x="67056" y="227037"/>
                  </a:lnTo>
                  <a:lnTo>
                    <a:pt x="70091" y="231622"/>
                  </a:lnTo>
                  <a:lnTo>
                    <a:pt x="63995" y="228561"/>
                  </a:lnTo>
                  <a:lnTo>
                    <a:pt x="59423" y="227037"/>
                  </a:lnTo>
                  <a:lnTo>
                    <a:pt x="7620" y="202653"/>
                  </a:lnTo>
                  <a:lnTo>
                    <a:pt x="0" y="210273"/>
                  </a:lnTo>
                  <a:lnTo>
                    <a:pt x="71615" y="240753"/>
                  </a:lnTo>
                  <a:lnTo>
                    <a:pt x="79248" y="234657"/>
                  </a:lnTo>
                  <a:close/>
                </a:path>
                <a:path w="1516379" h="645159">
                  <a:moveTo>
                    <a:pt x="129527" y="175234"/>
                  </a:moveTo>
                  <a:lnTo>
                    <a:pt x="128003" y="172186"/>
                  </a:lnTo>
                  <a:lnTo>
                    <a:pt x="128003" y="169138"/>
                  </a:lnTo>
                  <a:lnTo>
                    <a:pt x="126466" y="164566"/>
                  </a:lnTo>
                  <a:lnTo>
                    <a:pt x="118859" y="170662"/>
                  </a:lnTo>
                  <a:lnTo>
                    <a:pt x="120383" y="175234"/>
                  </a:lnTo>
                  <a:lnTo>
                    <a:pt x="120383" y="182854"/>
                  </a:lnTo>
                  <a:lnTo>
                    <a:pt x="118859" y="184378"/>
                  </a:lnTo>
                  <a:lnTo>
                    <a:pt x="115811" y="188937"/>
                  </a:lnTo>
                  <a:lnTo>
                    <a:pt x="114274" y="190461"/>
                  </a:lnTo>
                  <a:lnTo>
                    <a:pt x="111226" y="191998"/>
                  </a:lnTo>
                  <a:lnTo>
                    <a:pt x="108191" y="191998"/>
                  </a:lnTo>
                  <a:lnTo>
                    <a:pt x="105143" y="193522"/>
                  </a:lnTo>
                  <a:lnTo>
                    <a:pt x="92951" y="187426"/>
                  </a:lnTo>
                  <a:lnTo>
                    <a:pt x="98729" y="181330"/>
                  </a:lnTo>
                  <a:lnTo>
                    <a:pt x="120383" y="158470"/>
                  </a:lnTo>
                  <a:lnTo>
                    <a:pt x="118859" y="158470"/>
                  </a:lnTo>
                  <a:lnTo>
                    <a:pt x="118859" y="156946"/>
                  </a:lnTo>
                  <a:lnTo>
                    <a:pt x="117348" y="155435"/>
                  </a:lnTo>
                  <a:lnTo>
                    <a:pt x="114274" y="152374"/>
                  </a:lnTo>
                  <a:lnTo>
                    <a:pt x="109715" y="149326"/>
                  </a:lnTo>
                  <a:lnTo>
                    <a:pt x="108191" y="148945"/>
                  </a:lnTo>
                  <a:lnTo>
                    <a:pt x="108191" y="159994"/>
                  </a:lnTo>
                  <a:lnTo>
                    <a:pt x="86855" y="181330"/>
                  </a:lnTo>
                  <a:lnTo>
                    <a:pt x="83807" y="175234"/>
                  </a:lnTo>
                  <a:lnTo>
                    <a:pt x="82283" y="173710"/>
                  </a:lnTo>
                  <a:lnTo>
                    <a:pt x="82283" y="167614"/>
                  </a:lnTo>
                  <a:lnTo>
                    <a:pt x="85331" y="161518"/>
                  </a:lnTo>
                  <a:lnTo>
                    <a:pt x="89903" y="156946"/>
                  </a:lnTo>
                  <a:lnTo>
                    <a:pt x="92951" y="156946"/>
                  </a:lnTo>
                  <a:lnTo>
                    <a:pt x="95999" y="155435"/>
                  </a:lnTo>
                  <a:lnTo>
                    <a:pt x="100558" y="155435"/>
                  </a:lnTo>
                  <a:lnTo>
                    <a:pt x="103619" y="156946"/>
                  </a:lnTo>
                  <a:lnTo>
                    <a:pt x="105143" y="158470"/>
                  </a:lnTo>
                  <a:lnTo>
                    <a:pt x="108191" y="159994"/>
                  </a:lnTo>
                  <a:lnTo>
                    <a:pt x="108191" y="148945"/>
                  </a:lnTo>
                  <a:lnTo>
                    <a:pt x="103619" y="147802"/>
                  </a:lnTo>
                  <a:lnTo>
                    <a:pt x="94475" y="147802"/>
                  </a:lnTo>
                  <a:lnTo>
                    <a:pt x="85331" y="150850"/>
                  </a:lnTo>
                  <a:lnTo>
                    <a:pt x="82283" y="155435"/>
                  </a:lnTo>
                  <a:lnTo>
                    <a:pt x="79248" y="158470"/>
                  </a:lnTo>
                  <a:lnTo>
                    <a:pt x="76187" y="163042"/>
                  </a:lnTo>
                  <a:lnTo>
                    <a:pt x="74663" y="167614"/>
                  </a:lnTo>
                  <a:lnTo>
                    <a:pt x="74663" y="176758"/>
                  </a:lnTo>
                  <a:lnTo>
                    <a:pt x="99047" y="201129"/>
                  </a:lnTo>
                  <a:lnTo>
                    <a:pt x="108191" y="201129"/>
                  </a:lnTo>
                  <a:lnTo>
                    <a:pt x="112750" y="199605"/>
                  </a:lnTo>
                  <a:lnTo>
                    <a:pt x="121894" y="193522"/>
                  </a:lnTo>
                  <a:lnTo>
                    <a:pt x="124942" y="190461"/>
                  </a:lnTo>
                  <a:lnTo>
                    <a:pt x="126466" y="185902"/>
                  </a:lnTo>
                  <a:lnTo>
                    <a:pt x="129527" y="179806"/>
                  </a:lnTo>
                  <a:lnTo>
                    <a:pt x="129527" y="175234"/>
                  </a:lnTo>
                  <a:close/>
                </a:path>
                <a:path w="1516379" h="645159">
                  <a:moveTo>
                    <a:pt x="146278" y="77711"/>
                  </a:moveTo>
                  <a:lnTo>
                    <a:pt x="140195" y="70091"/>
                  </a:lnTo>
                  <a:lnTo>
                    <a:pt x="132562" y="77711"/>
                  </a:lnTo>
                  <a:lnTo>
                    <a:pt x="140195" y="83807"/>
                  </a:lnTo>
                  <a:lnTo>
                    <a:pt x="146278" y="77711"/>
                  </a:lnTo>
                  <a:close/>
                </a:path>
                <a:path w="1516379" h="645159">
                  <a:moveTo>
                    <a:pt x="175221" y="138658"/>
                  </a:moveTo>
                  <a:lnTo>
                    <a:pt x="153809" y="115811"/>
                  </a:lnTo>
                  <a:lnTo>
                    <a:pt x="152361" y="114274"/>
                  </a:lnTo>
                  <a:lnTo>
                    <a:pt x="149326" y="111226"/>
                  </a:lnTo>
                  <a:lnTo>
                    <a:pt x="143230" y="108191"/>
                  </a:lnTo>
                  <a:lnTo>
                    <a:pt x="141706" y="106667"/>
                  </a:lnTo>
                  <a:lnTo>
                    <a:pt x="132562" y="106667"/>
                  </a:lnTo>
                  <a:lnTo>
                    <a:pt x="131038" y="108191"/>
                  </a:lnTo>
                  <a:lnTo>
                    <a:pt x="128003" y="109715"/>
                  </a:lnTo>
                  <a:lnTo>
                    <a:pt x="126466" y="111226"/>
                  </a:lnTo>
                  <a:lnTo>
                    <a:pt x="123418" y="112750"/>
                  </a:lnTo>
                  <a:lnTo>
                    <a:pt x="120383" y="115811"/>
                  </a:lnTo>
                  <a:lnTo>
                    <a:pt x="117335" y="124942"/>
                  </a:lnTo>
                  <a:lnTo>
                    <a:pt x="117335" y="129527"/>
                  </a:lnTo>
                  <a:lnTo>
                    <a:pt x="99047" y="111226"/>
                  </a:lnTo>
                  <a:lnTo>
                    <a:pt x="92951" y="117335"/>
                  </a:lnTo>
                  <a:lnTo>
                    <a:pt x="144754" y="169138"/>
                  </a:lnTo>
                  <a:lnTo>
                    <a:pt x="150850" y="161518"/>
                  </a:lnTo>
                  <a:lnTo>
                    <a:pt x="131038" y="141719"/>
                  </a:lnTo>
                  <a:lnTo>
                    <a:pt x="128003" y="140182"/>
                  </a:lnTo>
                  <a:lnTo>
                    <a:pt x="124942" y="134086"/>
                  </a:lnTo>
                  <a:lnTo>
                    <a:pt x="123418" y="129527"/>
                  </a:lnTo>
                  <a:lnTo>
                    <a:pt x="123418" y="127990"/>
                  </a:lnTo>
                  <a:lnTo>
                    <a:pt x="124942" y="126466"/>
                  </a:lnTo>
                  <a:lnTo>
                    <a:pt x="124942" y="121907"/>
                  </a:lnTo>
                  <a:lnTo>
                    <a:pt x="129527" y="117335"/>
                  </a:lnTo>
                  <a:lnTo>
                    <a:pt x="132562" y="117335"/>
                  </a:lnTo>
                  <a:lnTo>
                    <a:pt x="134086" y="115811"/>
                  </a:lnTo>
                  <a:lnTo>
                    <a:pt x="138658" y="115811"/>
                  </a:lnTo>
                  <a:lnTo>
                    <a:pt x="140195" y="117335"/>
                  </a:lnTo>
                  <a:lnTo>
                    <a:pt x="143230" y="118859"/>
                  </a:lnTo>
                  <a:lnTo>
                    <a:pt x="169138" y="144767"/>
                  </a:lnTo>
                  <a:lnTo>
                    <a:pt x="175221" y="138658"/>
                  </a:lnTo>
                  <a:close/>
                </a:path>
                <a:path w="1516379" h="645159">
                  <a:moveTo>
                    <a:pt x="190461" y="121907"/>
                  </a:moveTo>
                  <a:lnTo>
                    <a:pt x="153898" y="85331"/>
                  </a:lnTo>
                  <a:lnTo>
                    <a:pt x="147802" y="91427"/>
                  </a:lnTo>
                  <a:lnTo>
                    <a:pt x="184365" y="127990"/>
                  </a:lnTo>
                  <a:lnTo>
                    <a:pt x="190461" y="121907"/>
                  </a:lnTo>
                  <a:close/>
                </a:path>
                <a:path w="1516379" h="645159">
                  <a:moveTo>
                    <a:pt x="223989" y="83807"/>
                  </a:moveTo>
                  <a:lnTo>
                    <a:pt x="222465" y="80759"/>
                  </a:lnTo>
                  <a:lnTo>
                    <a:pt x="222465" y="76187"/>
                  </a:lnTo>
                  <a:lnTo>
                    <a:pt x="220941" y="73139"/>
                  </a:lnTo>
                  <a:lnTo>
                    <a:pt x="219417" y="68567"/>
                  </a:lnTo>
                  <a:lnTo>
                    <a:pt x="211797" y="74663"/>
                  </a:lnTo>
                  <a:lnTo>
                    <a:pt x="213321" y="76187"/>
                  </a:lnTo>
                  <a:lnTo>
                    <a:pt x="214833" y="79235"/>
                  </a:lnTo>
                  <a:lnTo>
                    <a:pt x="214833" y="88379"/>
                  </a:lnTo>
                  <a:lnTo>
                    <a:pt x="213321" y="91427"/>
                  </a:lnTo>
                  <a:lnTo>
                    <a:pt x="211797" y="92951"/>
                  </a:lnTo>
                  <a:lnTo>
                    <a:pt x="205701" y="95999"/>
                  </a:lnTo>
                  <a:lnTo>
                    <a:pt x="204177" y="97523"/>
                  </a:lnTo>
                  <a:lnTo>
                    <a:pt x="201129" y="97523"/>
                  </a:lnTo>
                  <a:lnTo>
                    <a:pt x="196557" y="95999"/>
                  </a:lnTo>
                  <a:lnTo>
                    <a:pt x="190461" y="92951"/>
                  </a:lnTo>
                  <a:lnTo>
                    <a:pt x="182854" y="85331"/>
                  </a:lnTo>
                  <a:lnTo>
                    <a:pt x="179806" y="79235"/>
                  </a:lnTo>
                  <a:lnTo>
                    <a:pt x="178282" y="74663"/>
                  </a:lnTo>
                  <a:lnTo>
                    <a:pt x="178282" y="71615"/>
                  </a:lnTo>
                  <a:lnTo>
                    <a:pt x="179806" y="68567"/>
                  </a:lnTo>
                  <a:lnTo>
                    <a:pt x="181330" y="67056"/>
                  </a:lnTo>
                  <a:lnTo>
                    <a:pt x="182854" y="63995"/>
                  </a:lnTo>
                  <a:lnTo>
                    <a:pt x="185889" y="60947"/>
                  </a:lnTo>
                  <a:lnTo>
                    <a:pt x="196557" y="60947"/>
                  </a:lnTo>
                  <a:lnTo>
                    <a:pt x="199605" y="62471"/>
                  </a:lnTo>
                  <a:lnTo>
                    <a:pt x="200748" y="60947"/>
                  </a:lnTo>
                  <a:lnTo>
                    <a:pt x="204177" y="56388"/>
                  </a:lnTo>
                  <a:lnTo>
                    <a:pt x="201129" y="53340"/>
                  </a:lnTo>
                  <a:lnTo>
                    <a:pt x="198081" y="53340"/>
                  </a:lnTo>
                  <a:lnTo>
                    <a:pt x="193509" y="51803"/>
                  </a:lnTo>
                  <a:lnTo>
                    <a:pt x="190461" y="51803"/>
                  </a:lnTo>
                  <a:lnTo>
                    <a:pt x="181330" y="56388"/>
                  </a:lnTo>
                  <a:lnTo>
                    <a:pt x="173697" y="63995"/>
                  </a:lnTo>
                  <a:lnTo>
                    <a:pt x="170662" y="70091"/>
                  </a:lnTo>
                  <a:lnTo>
                    <a:pt x="170662" y="79235"/>
                  </a:lnTo>
                  <a:lnTo>
                    <a:pt x="195033" y="105143"/>
                  </a:lnTo>
                  <a:lnTo>
                    <a:pt x="204177" y="105143"/>
                  </a:lnTo>
                  <a:lnTo>
                    <a:pt x="213321" y="102082"/>
                  </a:lnTo>
                  <a:lnTo>
                    <a:pt x="216369" y="99047"/>
                  </a:lnTo>
                  <a:lnTo>
                    <a:pt x="217385" y="97523"/>
                  </a:lnTo>
                  <a:lnTo>
                    <a:pt x="219417" y="94475"/>
                  </a:lnTo>
                  <a:lnTo>
                    <a:pt x="222465" y="88379"/>
                  </a:lnTo>
                  <a:lnTo>
                    <a:pt x="223989" y="83807"/>
                  </a:lnTo>
                  <a:close/>
                </a:path>
                <a:path w="1516379" h="645159">
                  <a:moveTo>
                    <a:pt x="243801" y="70091"/>
                  </a:moveTo>
                  <a:lnTo>
                    <a:pt x="191998" y="18288"/>
                  </a:lnTo>
                  <a:lnTo>
                    <a:pt x="185889" y="24371"/>
                  </a:lnTo>
                  <a:lnTo>
                    <a:pt x="237693" y="76187"/>
                  </a:lnTo>
                  <a:lnTo>
                    <a:pt x="243801" y="70091"/>
                  </a:lnTo>
                  <a:close/>
                </a:path>
                <a:path w="1516379" h="645159">
                  <a:moveTo>
                    <a:pt x="277304" y="28956"/>
                  </a:moveTo>
                  <a:lnTo>
                    <a:pt x="275793" y="24371"/>
                  </a:lnTo>
                  <a:lnTo>
                    <a:pt x="275793" y="21336"/>
                  </a:lnTo>
                  <a:lnTo>
                    <a:pt x="274269" y="16764"/>
                  </a:lnTo>
                  <a:lnTo>
                    <a:pt x="266649" y="22860"/>
                  </a:lnTo>
                  <a:lnTo>
                    <a:pt x="266649" y="25895"/>
                  </a:lnTo>
                  <a:lnTo>
                    <a:pt x="268173" y="27432"/>
                  </a:lnTo>
                  <a:lnTo>
                    <a:pt x="268173" y="33528"/>
                  </a:lnTo>
                  <a:lnTo>
                    <a:pt x="266649" y="36563"/>
                  </a:lnTo>
                  <a:lnTo>
                    <a:pt x="265125" y="38087"/>
                  </a:lnTo>
                  <a:lnTo>
                    <a:pt x="263601" y="41148"/>
                  </a:lnTo>
                  <a:lnTo>
                    <a:pt x="262077" y="42672"/>
                  </a:lnTo>
                  <a:lnTo>
                    <a:pt x="259029" y="44196"/>
                  </a:lnTo>
                  <a:lnTo>
                    <a:pt x="255981" y="44196"/>
                  </a:lnTo>
                  <a:lnTo>
                    <a:pt x="252933" y="45720"/>
                  </a:lnTo>
                  <a:lnTo>
                    <a:pt x="249885" y="44196"/>
                  </a:lnTo>
                  <a:lnTo>
                    <a:pt x="246837" y="44196"/>
                  </a:lnTo>
                  <a:lnTo>
                    <a:pt x="242277" y="41148"/>
                  </a:lnTo>
                  <a:lnTo>
                    <a:pt x="239217" y="39611"/>
                  </a:lnTo>
                  <a:lnTo>
                    <a:pt x="245300" y="33528"/>
                  </a:lnTo>
                  <a:lnTo>
                    <a:pt x="268173" y="10668"/>
                  </a:lnTo>
                  <a:lnTo>
                    <a:pt x="266649" y="10668"/>
                  </a:lnTo>
                  <a:lnTo>
                    <a:pt x="266649" y="9144"/>
                  </a:lnTo>
                  <a:lnTo>
                    <a:pt x="263601" y="7620"/>
                  </a:lnTo>
                  <a:lnTo>
                    <a:pt x="260553" y="6096"/>
                  </a:lnTo>
                  <a:lnTo>
                    <a:pt x="255981" y="3048"/>
                  </a:lnTo>
                  <a:lnTo>
                    <a:pt x="255981" y="12192"/>
                  </a:lnTo>
                  <a:lnTo>
                    <a:pt x="234645" y="33528"/>
                  </a:lnTo>
                  <a:lnTo>
                    <a:pt x="231609" y="27432"/>
                  </a:lnTo>
                  <a:lnTo>
                    <a:pt x="230085" y="25895"/>
                  </a:lnTo>
                  <a:lnTo>
                    <a:pt x="230085" y="19812"/>
                  </a:lnTo>
                  <a:lnTo>
                    <a:pt x="231609" y="16764"/>
                  </a:lnTo>
                  <a:lnTo>
                    <a:pt x="233133" y="15240"/>
                  </a:lnTo>
                  <a:lnTo>
                    <a:pt x="234645" y="12192"/>
                  </a:lnTo>
                  <a:lnTo>
                    <a:pt x="243801" y="7620"/>
                  </a:lnTo>
                  <a:lnTo>
                    <a:pt x="246837" y="7620"/>
                  </a:lnTo>
                  <a:lnTo>
                    <a:pt x="248361" y="9144"/>
                  </a:lnTo>
                  <a:lnTo>
                    <a:pt x="251409" y="9144"/>
                  </a:lnTo>
                  <a:lnTo>
                    <a:pt x="252933" y="10668"/>
                  </a:lnTo>
                  <a:lnTo>
                    <a:pt x="255981" y="12192"/>
                  </a:lnTo>
                  <a:lnTo>
                    <a:pt x="255981" y="3048"/>
                  </a:lnTo>
                  <a:lnTo>
                    <a:pt x="251409" y="0"/>
                  </a:lnTo>
                  <a:lnTo>
                    <a:pt x="242277" y="0"/>
                  </a:lnTo>
                  <a:lnTo>
                    <a:pt x="233133" y="3048"/>
                  </a:lnTo>
                  <a:lnTo>
                    <a:pt x="230085" y="7620"/>
                  </a:lnTo>
                  <a:lnTo>
                    <a:pt x="225501" y="10668"/>
                  </a:lnTo>
                  <a:lnTo>
                    <a:pt x="222465" y="19812"/>
                  </a:lnTo>
                  <a:lnTo>
                    <a:pt x="222465" y="30480"/>
                  </a:lnTo>
                  <a:lnTo>
                    <a:pt x="225501" y="35052"/>
                  </a:lnTo>
                  <a:lnTo>
                    <a:pt x="227025" y="39611"/>
                  </a:lnTo>
                  <a:lnTo>
                    <a:pt x="236169" y="48755"/>
                  </a:lnTo>
                  <a:lnTo>
                    <a:pt x="240741" y="51803"/>
                  </a:lnTo>
                  <a:lnTo>
                    <a:pt x="245313" y="53340"/>
                  </a:lnTo>
                  <a:lnTo>
                    <a:pt x="255981" y="53340"/>
                  </a:lnTo>
                  <a:lnTo>
                    <a:pt x="260553" y="51803"/>
                  </a:lnTo>
                  <a:lnTo>
                    <a:pt x="269697" y="45720"/>
                  </a:lnTo>
                  <a:lnTo>
                    <a:pt x="271221" y="42672"/>
                  </a:lnTo>
                  <a:lnTo>
                    <a:pt x="274269" y="39611"/>
                  </a:lnTo>
                  <a:lnTo>
                    <a:pt x="275793" y="35052"/>
                  </a:lnTo>
                  <a:lnTo>
                    <a:pt x="277304" y="32004"/>
                  </a:lnTo>
                  <a:lnTo>
                    <a:pt x="277304" y="28956"/>
                  </a:lnTo>
                  <a:close/>
                </a:path>
                <a:path w="1516379" h="645159">
                  <a:moveTo>
                    <a:pt x="283413" y="474141"/>
                  </a:moveTo>
                  <a:lnTo>
                    <a:pt x="281914" y="471601"/>
                  </a:lnTo>
                  <a:lnTo>
                    <a:pt x="245313" y="409371"/>
                  </a:lnTo>
                  <a:lnTo>
                    <a:pt x="239217" y="416991"/>
                  </a:lnTo>
                  <a:lnTo>
                    <a:pt x="263601" y="457631"/>
                  </a:lnTo>
                  <a:lnTo>
                    <a:pt x="268173" y="463981"/>
                  </a:lnTo>
                  <a:lnTo>
                    <a:pt x="272745" y="471601"/>
                  </a:lnTo>
                  <a:lnTo>
                    <a:pt x="266649" y="466521"/>
                  </a:lnTo>
                  <a:lnTo>
                    <a:pt x="262077" y="463981"/>
                  </a:lnTo>
                  <a:lnTo>
                    <a:pt x="249885" y="456361"/>
                  </a:lnTo>
                  <a:lnTo>
                    <a:pt x="235521" y="448741"/>
                  </a:lnTo>
                  <a:lnTo>
                    <a:pt x="216369" y="438581"/>
                  </a:lnTo>
                  <a:lnTo>
                    <a:pt x="208749" y="447471"/>
                  </a:lnTo>
                  <a:lnTo>
                    <a:pt x="233133" y="491921"/>
                  </a:lnTo>
                  <a:lnTo>
                    <a:pt x="236169" y="494461"/>
                  </a:lnTo>
                  <a:lnTo>
                    <a:pt x="237693" y="499541"/>
                  </a:lnTo>
                  <a:lnTo>
                    <a:pt x="240753" y="503351"/>
                  </a:lnTo>
                  <a:lnTo>
                    <a:pt x="228561" y="494461"/>
                  </a:lnTo>
                  <a:lnTo>
                    <a:pt x="185889" y="469061"/>
                  </a:lnTo>
                  <a:lnTo>
                    <a:pt x="179806" y="475411"/>
                  </a:lnTo>
                  <a:lnTo>
                    <a:pt x="245313" y="513511"/>
                  </a:lnTo>
                  <a:lnTo>
                    <a:pt x="251409" y="507161"/>
                  </a:lnTo>
                  <a:lnTo>
                    <a:pt x="249237" y="503351"/>
                  </a:lnTo>
                  <a:lnTo>
                    <a:pt x="222465" y="456361"/>
                  </a:lnTo>
                  <a:lnTo>
                    <a:pt x="217893" y="448741"/>
                  </a:lnTo>
                  <a:lnTo>
                    <a:pt x="219417" y="448741"/>
                  </a:lnTo>
                  <a:lnTo>
                    <a:pt x="220941" y="450011"/>
                  </a:lnTo>
                  <a:lnTo>
                    <a:pt x="227025" y="453821"/>
                  </a:lnTo>
                  <a:lnTo>
                    <a:pt x="277304" y="481761"/>
                  </a:lnTo>
                  <a:lnTo>
                    <a:pt x="283413" y="474141"/>
                  </a:lnTo>
                  <a:close/>
                </a:path>
                <a:path w="1516379" h="645159">
                  <a:moveTo>
                    <a:pt x="326072" y="432231"/>
                  </a:moveTo>
                  <a:lnTo>
                    <a:pt x="286893" y="394131"/>
                  </a:lnTo>
                  <a:lnTo>
                    <a:pt x="280365" y="387781"/>
                  </a:lnTo>
                  <a:lnTo>
                    <a:pt x="297116" y="370001"/>
                  </a:lnTo>
                  <a:lnTo>
                    <a:pt x="291033" y="363651"/>
                  </a:lnTo>
                  <a:lnTo>
                    <a:pt x="249885" y="404291"/>
                  </a:lnTo>
                  <a:lnTo>
                    <a:pt x="255981" y="410641"/>
                  </a:lnTo>
                  <a:lnTo>
                    <a:pt x="272745" y="394131"/>
                  </a:lnTo>
                  <a:lnTo>
                    <a:pt x="318452" y="439851"/>
                  </a:lnTo>
                  <a:lnTo>
                    <a:pt x="326072" y="432231"/>
                  </a:lnTo>
                  <a:close/>
                </a:path>
                <a:path w="1516379" h="645159">
                  <a:moveTo>
                    <a:pt x="350443" y="409371"/>
                  </a:moveTo>
                  <a:lnTo>
                    <a:pt x="312356" y="342061"/>
                  </a:lnTo>
                  <a:lnTo>
                    <a:pt x="306273" y="347141"/>
                  </a:lnTo>
                  <a:lnTo>
                    <a:pt x="344360" y="415721"/>
                  </a:lnTo>
                  <a:lnTo>
                    <a:pt x="350443" y="409371"/>
                  </a:lnTo>
                  <a:close/>
                </a:path>
                <a:path w="1516379" h="645159">
                  <a:moveTo>
                    <a:pt x="409879" y="334441"/>
                  </a:moveTo>
                  <a:lnTo>
                    <a:pt x="402805" y="328091"/>
                  </a:lnTo>
                  <a:lnTo>
                    <a:pt x="390055" y="316661"/>
                  </a:lnTo>
                  <a:lnTo>
                    <a:pt x="368744" y="336981"/>
                  </a:lnTo>
                  <a:lnTo>
                    <a:pt x="374827" y="343331"/>
                  </a:lnTo>
                  <a:lnTo>
                    <a:pt x="390055" y="328091"/>
                  </a:lnTo>
                  <a:lnTo>
                    <a:pt x="399211" y="336981"/>
                  </a:lnTo>
                  <a:lnTo>
                    <a:pt x="399211" y="340791"/>
                  </a:lnTo>
                  <a:lnTo>
                    <a:pt x="397687" y="342061"/>
                  </a:lnTo>
                  <a:lnTo>
                    <a:pt x="396163" y="348411"/>
                  </a:lnTo>
                  <a:lnTo>
                    <a:pt x="393115" y="354761"/>
                  </a:lnTo>
                  <a:lnTo>
                    <a:pt x="380923" y="364921"/>
                  </a:lnTo>
                  <a:lnTo>
                    <a:pt x="377875" y="366191"/>
                  </a:lnTo>
                  <a:lnTo>
                    <a:pt x="364159" y="366191"/>
                  </a:lnTo>
                  <a:lnTo>
                    <a:pt x="359587" y="364921"/>
                  </a:lnTo>
                  <a:lnTo>
                    <a:pt x="353491" y="359841"/>
                  </a:lnTo>
                  <a:lnTo>
                    <a:pt x="348919" y="357301"/>
                  </a:lnTo>
                  <a:lnTo>
                    <a:pt x="347408" y="354761"/>
                  </a:lnTo>
                  <a:lnTo>
                    <a:pt x="344360" y="350951"/>
                  </a:lnTo>
                  <a:lnTo>
                    <a:pt x="341312" y="343331"/>
                  </a:lnTo>
                  <a:lnTo>
                    <a:pt x="339775" y="340791"/>
                  </a:lnTo>
                  <a:lnTo>
                    <a:pt x="339775" y="328091"/>
                  </a:lnTo>
                  <a:lnTo>
                    <a:pt x="341312" y="326821"/>
                  </a:lnTo>
                  <a:lnTo>
                    <a:pt x="341312" y="324281"/>
                  </a:lnTo>
                  <a:lnTo>
                    <a:pt x="347408" y="317931"/>
                  </a:lnTo>
                  <a:lnTo>
                    <a:pt x="351967" y="312851"/>
                  </a:lnTo>
                  <a:lnTo>
                    <a:pt x="361111" y="310311"/>
                  </a:lnTo>
                  <a:lnTo>
                    <a:pt x="364159" y="310311"/>
                  </a:lnTo>
                  <a:lnTo>
                    <a:pt x="373303" y="312851"/>
                  </a:lnTo>
                  <a:lnTo>
                    <a:pt x="374827" y="310311"/>
                  </a:lnTo>
                  <a:lnTo>
                    <a:pt x="377875" y="305231"/>
                  </a:lnTo>
                  <a:lnTo>
                    <a:pt x="368744" y="301421"/>
                  </a:lnTo>
                  <a:lnTo>
                    <a:pt x="356552" y="301421"/>
                  </a:lnTo>
                  <a:lnTo>
                    <a:pt x="330644" y="328091"/>
                  </a:lnTo>
                  <a:lnTo>
                    <a:pt x="330644" y="342061"/>
                  </a:lnTo>
                  <a:lnTo>
                    <a:pt x="333692" y="350951"/>
                  </a:lnTo>
                  <a:lnTo>
                    <a:pt x="339775" y="359841"/>
                  </a:lnTo>
                  <a:lnTo>
                    <a:pt x="350443" y="371271"/>
                  </a:lnTo>
                  <a:lnTo>
                    <a:pt x="364159" y="375081"/>
                  </a:lnTo>
                  <a:lnTo>
                    <a:pt x="373303" y="375081"/>
                  </a:lnTo>
                  <a:lnTo>
                    <a:pt x="379412" y="373811"/>
                  </a:lnTo>
                  <a:lnTo>
                    <a:pt x="382447" y="372541"/>
                  </a:lnTo>
                  <a:lnTo>
                    <a:pt x="387019" y="371271"/>
                  </a:lnTo>
                  <a:lnTo>
                    <a:pt x="394335" y="366191"/>
                  </a:lnTo>
                  <a:lnTo>
                    <a:pt x="396163" y="364921"/>
                  </a:lnTo>
                  <a:lnTo>
                    <a:pt x="400723" y="357301"/>
                  </a:lnTo>
                  <a:lnTo>
                    <a:pt x="405307" y="350951"/>
                  </a:lnTo>
                  <a:lnTo>
                    <a:pt x="406831" y="347141"/>
                  </a:lnTo>
                  <a:lnTo>
                    <a:pt x="406831" y="343331"/>
                  </a:lnTo>
                  <a:lnTo>
                    <a:pt x="409879" y="334441"/>
                  </a:lnTo>
                  <a:close/>
                </a:path>
                <a:path w="1516379" h="645159">
                  <a:moveTo>
                    <a:pt x="449491" y="301421"/>
                  </a:moveTo>
                  <a:lnTo>
                    <a:pt x="447967" y="297611"/>
                  </a:lnTo>
                  <a:lnTo>
                    <a:pt x="447967" y="295071"/>
                  </a:lnTo>
                  <a:lnTo>
                    <a:pt x="446443" y="289991"/>
                  </a:lnTo>
                  <a:lnTo>
                    <a:pt x="444919" y="287451"/>
                  </a:lnTo>
                  <a:lnTo>
                    <a:pt x="440347" y="282562"/>
                  </a:lnTo>
                  <a:lnTo>
                    <a:pt x="440347" y="297611"/>
                  </a:lnTo>
                  <a:lnTo>
                    <a:pt x="440347" y="305231"/>
                  </a:lnTo>
                  <a:lnTo>
                    <a:pt x="438823" y="309041"/>
                  </a:lnTo>
                  <a:lnTo>
                    <a:pt x="438823" y="310311"/>
                  </a:lnTo>
                  <a:lnTo>
                    <a:pt x="434251" y="314121"/>
                  </a:lnTo>
                  <a:lnTo>
                    <a:pt x="428155" y="317931"/>
                  </a:lnTo>
                  <a:lnTo>
                    <a:pt x="425107" y="317931"/>
                  </a:lnTo>
                  <a:lnTo>
                    <a:pt x="422059" y="316661"/>
                  </a:lnTo>
                  <a:lnTo>
                    <a:pt x="417499" y="314121"/>
                  </a:lnTo>
                  <a:lnTo>
                    <a:pt x="414439" y="312851"/>
                  </a:lnTo>
                  <a:lnTo>
                    <a:pt x="411391" y="310311"/>
                  </a:lnTo>
                  <a:lnTo>
                    <a:pt x="408355" y="305231"/>
                  </a:lnTo>
                  <a:lnTo>
                    <a:pt x="405307" y="302691"/>
                  </a:lnTo>
                  <a:lnTo>
                    <a:pt x="403771" y="298881"/>
                  </a:lnTo>
                  <a:lnTo>
                    <a:pt x="403771" y="289991"/>
                  </a:lnTo>
                  <a:lnTo>
                    <a:pt x="405307" y="287451"/>
                  </a:lnTo>
                  <a:lnTo>
                    <a:pt x="409879" y="282371"/>
                  </a:lnTo>
                  <a:lnTo>
                    <a:pt x="415963" y="279831"/>
                  </a:lnTo>
                  <a:lnTo>
                    <a:pt x="419023" y="279831"/>
                  </a:lnTo>
                  <a:lnTo>
                    <a:pt x="425107" y="282371"/>
                  </a:lnTo>
                  <a:lnTo>
                    <a:pt x="429679" y="283641"/>
                  </a:lnTo>
                  <a:lnTo>
                    <a:pt x="438823" y="295071"/>
                  </a:lnTo>
                  <a:lnTo>
                    <a:pt x="440347" y="297611"/>
                  </a:lnTo>
                  <a:lnTo>
                    <a:pt x="440347" y="282562"/>
                  </a:lnTo>
                  <a:lnTo>
                    <a:pt x="437807" y="279831"/>
                  </a:lnTo>
                  <a:lnTo>
                    <a:pt x="434251" y="276021"/>
                  </a:lnTo>
                  <a:lnTo>
                    <a:pt x="429679" y="273481"/>
                  </a:lnTo>
                  <a:lnTo>
                    <a:pt x="425107" y="272211"/>
                  </a:lnTo>
                  <a:lnTo>
                    <a:pt x="414439" y="272211"/>
                  </a:lnTo>
                  <a:lnTo>
                    <a:pt x="409879" y="273481"/>
                  </a:lnTo>
                  <a:lnTo>
                    <a:pt x="399211" y="282371"/>
                  </a:lnTo>
                  <a:lnTo>
                    <a:pt x="394639" y="289991"/>
                  </a:lnTo>
                  <a:lnTo>
                    <a:pt x="394639" y="301421"/>
                  </a:lnTo>
                  <a:lnTo>
                    <a:pt x="423583" y="326821"/>
                  </a:lnTo>
                  <a:lnTo>
                    <a:pt x="437299" y="321741"/>
                  </a:lnTo>
                  <a:lnTo>
                    <a:pt x="441858" y="319201"/>
                  </a:lnTo>
                  <a:lnTo>
                    <a:pt x="442493" y="317931"/>
                  </a:lnTo>
                  <a:lnTo>
                    <a:pt x="449491" y="303961"/>
                  </a:lnTo>
                  <a:lnTo>
                    <a:pt x="449491" y="301421"/>
                  </a:lnTo>
                  <a:close/>
                </a:path>
                <a:path w="1516379" h="645159">
                  <a:moveTo>
                    <a:pt x="487578" y="260781"/>
                  </a:moveTo>
                  <a:lnTo>
                    <a:pt x="486562" y="258241"/>
                  </a:lnTo>
                  <a:lnTo>
                    <a:pt x="486054" y="256971"/>
                  </a:lnTo>
                  <a:lnTo>
                    <a:pt x="479958" y="250621"/>
                  </a:lnTo>
                  <a:lnTo>
                    <a:pt x="475386" y="249351"/>
                  </a:lnTo>
                  <a:lnTo>
                    <a:pt x="472351" y="249351"/>
                  </a:lnTo>
                  <a:lnTo>
                    <a:pt x="467779" y="250621"/>
                  </a:lnTo>
                  <a:lnTo>
                    <a:pt x="466242" y="250621"/>
                  </a:lnTo>
                  <a:lnTo>
                    <a:pt x="460159" y="253161"/>
                  </a:lnTo>
                  <a:lnTo>
                    <a:pt x="454050" y="258241"/>
                  </a:lnTo>
                  <a:lnTo>
                    <a:pt x="451015" y="259511"/>
                  </a:lnTo>
                  <a:lnTo>
                    <a:pt x="449491" y="259511"/>
                  </a:lnTo>
                  <a:lnTo>
                    <a:pt x="449491" y="260781"/>
                  </a:lnTo>
                  <a:lnTo>
                    <a:pt x="443395" y="260781"/>
                  </a:lnTo>
                  <a:lnTo>
                    <a:pt x="440347" y="258241"/>
                  </a:lnTo>
                  <a:lnTo>
                    <a:pt x="440347" y="251891"/>
                  </a:lnTo>
                  <a:lnTo>
                    <a:pt x="447967" y="244271"/>
                  </a:lnTo>
                  <a:lnTo>
                    <a:pt x="451015" y="243001"/>
                  </a:lnTo>
                  <a:lnTo>
                    <a:pt x="455587" y="243001"/>
                  </a:lnTo>
                  <a:lnTo>
                    <a:pt x="458635" y="244271"/>
                  </a:lnTo>
                  <a:lnTo>
                    <a:pt x="459854" y="243001"/>
                  </a:lnTo>
                  <a:lnTo>
                    <a:pt x="464718" y="237921"/>
                  </a:lnTo>
                  <a:lnTo>
                    <a:pt x="460159" y="235381"/>
                  </a:lnTo>
                  <a:lnTo>
                    <a:pt x="457111" y="234111"/>
                  </a:lnTo>
                  <a:lnTo>
                    <a:pt x="452526" y="234111"/>
                  </a:lnTo>
                  <a:lnTo>
                    <a:pt x="451015" y="235381"/>
                  </a:lnTo>
                  <a:lnTo>
                    <a:pt x="447967" y="235381"/>
                  </a:lnTo>
                  <a:lnTo>
                    <a:pt x="446443" y="236651"/>
                  </a:lnTo>
                  <a:lnTo>
                    <a:pt x="443395" y="237921"/>
                  </a:lnTo>
                  <a:lnTo>
                    <a:pt x="437299" y="244271"/>
                  </a:lnTo>
                  <a:lnTo>
                    <a:pt x="432727" y="251891"/>
                  </a:lnTo>
                  <a:lnTo>
                    <a:pt x="432727" y="260781"/>
                  </a:lnTo>
                  <a:lnTo>
                    <a:pt x="435775" y="267131"/>
                  </a:lnTo>
                  <a:lnTo>
                    <a:pt x="438823" y="268401"/>
                  </a:lnTo>
                  <a:lnTo>
                    <a:pt x="443395" y="270941"/>
                  </a:lnTo>
                  <a:lnTo>
                    <a:pt x="451015" y="270941"/>
                  </a:lnTo>
                  <a:lnTo>
                    <a:pt x="452526" y="268401"/>
                  </a:lnTo>
                  <a:lnTo>
                    <a:pt x="458635" y="265861"/>
                  </a:lnTo>
                  <a:lnTo>
                    <a:pt x="463194" y="263321"/>
                  </a:lnTo>
                  <a:lnTo>
                    <a:pt x="466255" y="260781"/>
                  </a:lnTo>
                  <a:lnTo>
                    <a:pt x="467779" y="259511"/>
                  </a:lnTo>
                  <a:lnTo>
                    <a:pt x="472351" y="259511"/>
                  </a:lnTo>
                  <a:lnTo>
                    <a:pt x="473862" y="258241"/>
                  </a:lnTo>
                  <a:lnTo>
                    <a:pt x="478434" y="263321"/>
                  </a:lnTo>
                  <a:lnTo>
                    <a:pt x="478434" y="270941"/>
                  </a:lnTo>
                  <a:lnTo>
                    <a:pt x="476910" y="273481"/>
                  </a:lnTo>
                  <a:lnTo>
                    <a:pt x="473862" y="274751"/>
                  </a:lnTo>
                  <a:lnTo>
                    <a:pt x="467779" y="279831"/>
                  </a:lnTo>
                  <a:lnTo>
                    <a:pt x="461683" y="279831"/>
                  </a:lnTo>
                  <a:lnTo>
                    <a:pt x="458635" y="278561"/>
                  </a:lnTo>
                  <a:lnTo>
                    <a:pt x="457111" y="276021"/>
                  </a:lnTo>
                  <a:lnTo>
                    <a:pt x="451015" y="283641"/>
                  </a:lnTo>
                  <a:lnTo>
                    <a:pt x="455587" y="286181"/>
                  </a:lnTo>
                  <a:lnTo>
                    <a:pt x="461683" y="288721"/>
                  </a:lnTo>
                  <a:lnTo>
                    <a:pt x="466242" y="288721"/>
                  </a:lnTo>
                  <a:lnTo>
                    <a:pt x="472351" y="286181"/>
                  </a:lnTo>
                  <a:lnTo>
                    <a:pt x="475386" y="282371"/>
                  </a:lnTo>
                  <a:lnTo>
                    <a:pt x="479958" y="279831"/>
                  </a:lnTo>
                  <a:lnTo>
                    <a:pt x="483006" y="274751"/>
                  </a:lnTo>
                  <a:lnTo>
                    <a:pt x="484530" y="273481"/>
                  </a:lnTo>
                  <a:lnTo>
                    <a:pt x="486054" y="270941"/>
                  </a:lnTo>
                  <a:lnTo>
                    <a:pt x="486054" y="268401"/>
                  </a:lnTo>
                  <a:lnTo>
                    <a:pt x="487578" y="265861"/>
                  </a:lnTo>
                  <a:lnTo>
                    <a:pt x="487578" y="260781"/>
                  </a:lnTo>
                  <a:close/>
                </a:path>
                <a:path w="1516379" h="645159">
                  <a:moveTo>
                    <a:pt x="524141" y="225221"/>
                  </a:moveTo>
                  <a:lnTo>
                    <a:pt x="522630" y="221411"/>
                  </a:lnTo>
                  <a:lnTo>
                    <a:pt x="522630" y="220141"/>
                  </a:lnTo>
                  <a:lnTo>
                    <a:pt x="514997" y="212521"/>
                  </a:lnTo>
                  <a:lnTo>
                    <a:pt x="508914" y="212521"/>
                  </a:lnTo>
                  <a:lnTo>
                    <a:pt x="504329" y="213791"/>
                  </a:lnTo>
                  <a:lnTo>
                    <a:pt x="502818" y="213791"/>
                  </a:lnTo>
                  <a:lnTo>
                    <a:pt x="496722" y="217601"/>
                  </a:lnTo>
                  <a:lnTo>
                    <a:pt x="492150" y="220141"/>
                  </a:lnTo>
                  <a:lnTo>
                    <a:pt x="490626" y="221411"/>
                  </a:lnTo>
                  <a:lnTo>
                    <a:pt x="487578" y="222681"/>
                  </a:lnTo>
                  <a:lnTo>
                    <a:pt x="486054" y="222681"/>
                  </a:lnTo>
                  <a:lnTo>
                    <a:pt x="486054" y="225221"/>
                  </a:lnTo>
                  <a:lnTo>
                    <a:pt x="479958" y="225221"/>
                  </a:lnTo>
                  <a:lnTo>
                    <a:pt x="476910" y="221411"/>
                  </a:lnTo>
                  <a:lnTo>
                    <a:pt x="476910" y="215061"/>
                  </a:lnTo>
                  <a:lnTo>
                    <a:pt x="484530" y="207441"/>
                  </a:lnTo>
                  <a:lnTo>
                    <a:pt x="487578" y="206171"/>
                  </a:lnTo>
                  <a:lnTo>
                    <a:pt x="492150" y="206171"/>
                  </a:lnTo>
                  <a:lnTo>
                    <a:pt x="493674" y="207441"/>
                  </a:lnTo>
                  <a:lnTo>
                    <a:pt x="496722" y="207441"/>
                  </a:lnTo>
                  <a:lnTo>
                    <a:pt x="497865" y="206171"/>
                  </a:lnTo>
                  <a:lnTo>
                    <a:pt x="501294" y="202361"/>
                  </a:lnTo>
                  <a:lnTo>
                    <a:pt x="496722" y="198551"/>
                  </a:lnTo>
                  <a:lnTo>
                    <a:pt x="493674" y="197281"/>
                  </a:lnTo>
                  <a:lnTo>
                    <a:pt x="489102" y="197281"/>
                  </a:lnTo>
                  <a:lnTo>
                    <a:pt x="487578" y="198551"/>
                  </a:lnTo>
                  <a:lnTo>
                    <a:pt x="484530" y="198551"/>
                  </a:lnTo>
                  <a:lnTo>
                    <a:pt x="473862" y="207441"/>
                  </a:lnTo>
                  <a:lnTo>
                    <a:pt x="469303" y="215061"/>
                  </a:lnTo>
                  <a:lnTo>
                    <a:pt x="469303" y="225221"/>
                  </a:lnTo>
                  <a:lnTo>
                    <a:pt x="472351" y="230301"/>
                  </a:lnTo>
                  <a:lnTo>
                    <a:pt x="475386" y="232841"/>
                  </a:lnTo>
                  <a:lnTo>
                    <a:pt x="479958" y="234111"/>
                  </a:lnTo>
                  <a:lnTo>
                    <a:pt x="487578" y="234111"/>
                  </a:lnTo>
                  <a:lnTo>
                    <a:pt x="489102" y="232841"/>
                  </a:lnTo>
                  <a:lnTo>
                    <a:pt x="495198" y="229031"/>
                  </a:lnTo>
                  <a:lnTo>
                    <a:pt x="499770" y="226491"/>
                  </a:lnTo>
                  <a:lnTo>
                    <a:pt x="502818" y="225221"/>
                  </a:lnTo>
                  <a:lnTo>
                    <a:pt x="504329" y="222681"/>
                  </a:lnTo>
                  <a:lnTo>
                    <a:pt x="507390" y="222681"/>
                  </a:lnTo>
                  <a:lnTo>
                    <a:pt x="508914" y="221411"/>
                  </a:lnTo>
                  <a:lnTo>
                    <a:pt x="510438" y="221411"/>
                  </a:lnTo>
                  <a:lnTo>
                    <a:pt x="513486" y="222681"/>
                  </a:lnTo>
                  <a:lnTo>
                    <a:pt x="514997" y="226491"/>
                  </a:lnTo>
                  <a:lnTo>
                    <a:pt x="514997" y="234111"/>
                  </a:lnTo>
                  <a:lnTo>
                    <a:pt x="513486" y="236651"/>
                  </a:lnTo>
                  <a:lnTo>
                    <a:pt x="510438" y="237921"/>
                  </a:lnTo>
                  <a:lnTo>
                    <a:pt x="508914" y="240461"/>
                  </a:lnTo>
                  <a:lnTo>
                    <a:pt x="505866" y="241731"/>
                  </a:lnTo>
                  <a:lnTo>
                    <a:pt x="504329" y="243001"/>
                  </a:lnTo>
                  <a:lnTo>
                    <a:pt x="498246" y="243001"/>
                  </a:lnTo>
                  <a:lnTo>
                    <a:pt x="495198" y="241731"/>
                  </a:lnTo>
                  <a:lnTo>
                    <a:pt x="493674" y="240461"/>
                  </a:lnTo>
                  <a:lnTo>
                    <a:pt x="487578" y="248081"/>
                  </a:lnTo>
                  <a:lnTo>
                    <a:pt x="492150" y="249351"/>
                  </a:lnTo>
                  <a:lnTo>
                    <a:pt x="498246" y="251891"/>
                  </a:lnTo>
                  <a:lnTo>
                    <a:pt x="502818" y="251891"/>
                  </a:lnTo>
                  <a:lnTo>
                    <a:pt x="508914" y="249351"/>
                  </a:lnTo>
                  <a:lnTo>
                    <a:pt x="511962" y="245541"/>
                  </a:lnTo>
                  <a:lnTo>
                    <a:pt x="516521" y="243001"/>
                  </a:lnTo>
                  <a:lnTo>
                    <a:pt x="518045" y="241731"/>
                  </a:lnTo>
                  <a:lnTo>
                    <a:pt x="519582" y="237921"/>
                  </a:lnTo>
                  <a:lnTo>
                    <a:pt x="522630" y="234111"/>
                  </a:lnTo>
                  <a:lnTo>
                    <a:pt x="524141" y="229031"/>
                  </a:lnTo>
                  <a:lnTo>
                    <a:pt x="524141" y="225221"/>
                  </a:lnTo>
                  <a:close/>
                </a:path>
                <a:path w="1516379" h="645159">
                  <a:moveTo>
                    <a:pt x="560717" y="221411"/>
                  </a:moveTo>
                  <a:lnTo>
                    <a:pt x="559193" y="217601"/>
                  </a:lnTo>
                  <a:lnTo>
                    <a:pt x="559193" y="213791"/>
                  </a:lnTo>
                  <a:lnTo>
                    <a:pt x="557669" y="212521"/>
                  </a:lnTo>
                  <a:lnTo>
                    <a:pt x="556145" y="207441"/>
                  </a:lnTo>
                  <a:lnTo>
                    <a:pt x="554621" y="204901"/>
                  </a:lnTo>
                  <a:lnTo>
                    <a:pt x="552246" y="199821"/>
                  </a:lnTo>
                  <a:lnTo>
                    <a:pt x="530237" y="152831"/>
                  </a:lnTo>
                  <a:lnTo>
                    <a:pt x="524141" y="159181"/>
                  </a:lnTo>
                  <a:lnTo>
                    <a:pt x="537857" y="188391"/>
                  </a:lnTo>
                  <a:lnTo>
                    <a:pt x="543966" y="199821"/>
                  </a:lnTo>
                  <a:lnTo>
                    <a:pt x="537857" y="196011"/>
                  </a:lnTo>
                  <a:lnTo>
                    <a:pt x="533298" y="194741"/>
                  </a:lnTo>
                  <a:lnTo>
                    <a:pt x="502818" y="180771"/>
                  </a:lnTo>
                  <a:lnTo>
                    <a:pt x="496722" y="187121"/>
                  </a:lnTo>
                  <a:lnTo>
                    <a:pt x="548525" y="209981"/>
                  </a:lnTo>
                  <a:lnTo>
                    <a:pt x="548525" y="212521"/>
                  </a:lnTo>
                  <a:lnTo>
                    <a:pt x="550049" y="213791"/>
                  </a:lnTo>
                  <a:lnTo>
                    <a:pt x="551573" y="217601"/>
                  </a:lnTo>
                  <a:lnTo>
                    <a:pt x="551573" y="222681"/>
                  </a:lnTo>
                  <a:lnTo>
                    <a:pt x="548525" y="227761"/>
                  </a:lnTo>
                  <a:lnTo>
                    <a:pt x="547001" y="227761"/>
                  </a:lnTo>
                  <a:lnTo>
                    <a:pt x="545477" y="230301"/>
                  </a:lnTo>
                  <a:lnTo>
                    <a:pt x="551573" y="235381"/>
                  </a:lnTo>
                  <a:lnTo>
                    <a:pt x="554621" y="234111"/>
                  </a:lnTo>
                  <a:lnTo>
                    <a:pt x="559193" y="229031"/>
                  </a:lnTo>
                  <a:lnTo>
                    <a:pt x="560717" y="225221"/>
                  </a:lnTo>
                  <a:lnTo>
                    <a:pt x="560717" y="221411"/>
                  </a:lnTo>
                  <a:close/>
                </a:path>
                <a:path w="1516379" h="645159">
                  <a:moveTo>
                    <a:pt x="595769" y="149021"/>
                  </a:moveTo>
                  <a:lnTo>
                    <a:pt x="589661" y="136321"/>
                  </a:lnTo>
                  <a:lnTo>
                    <a:pt x="588137" y="135051"/>
                  </a:lnTo>
                  <a:lnTo>
                    <a:pt x="588137" y="154101"/>
                  </a:lnTo>
                  <a:lnTo>
                    <a:pt x="588137" y="157911"/>
                  </a:lnTo>
                  <a:lnTo>
                    <a:pt x="586613" y="160451"/>
                  </a:lnTo>
                  <a:lnTo>
                    <a:pt x="586613" y="161721"/>
                  </a:lnTo>
                  <a:lnTo>
                    <a:pt x="585101" y="165531"/>
                  </a:lnTo>
                  <a:lnTo>
                    <a:pt x="578993" y="168071"/>
                  </a:lnTo>
                  <a:lnTo>
                    <a:pt x="569861" y="168071"/>
                  </a:lnTo>
                  <a:lnTo>
                    <a:pt x="566801" y="166801"/>
                  </a:lnTo>
                  <a:lnTo>
                    <a:pt x="560717" y="160451"/>
                  </a:lnTo>
                  <a:lnTo>
                    <a:pt x="557669" y="157911"/>
                  </a:lnTo>
                  <a:lnTo>
                    <a:pt x="553097" y="150291"/>
                  </a:lnTo>
                  <a:lnTo>
                    <a:pt x="553097" y="146481"/>
                  </a:lnTo>
                  <a:lnTo>
                    <a:pt x="553097" y="141401"/>
                  </a:lnTo>
                  <a:lnTo>
                    <a:pt x="554621" y="137591"/>
                  </a:lnTo>
                  <a:lnTo>
                    <a:pt x="556145" y="136321"/>
                  </a:lnTo>
                  <a:lnTo>
                    <a:pt x="557669" y="133781"/>
                  </a:lnTo>
                  <a:lnTo>
                    <a:pt x="560717" y="133781"/>
                  </a:lnTo>
                  <a:lnTo>
                    <a:pt x="563765" y="131241"/>
                  </a:lnTo>
                  <a:lnTo>
                    <a:pt x="566801" y="131241"/>
                  </a:lnTo>
                  <a:lnTo>
                    <a:pt x="580517" y="138861"/>
                  </a:lnTo>
                  <a:lnTo>
                    <a:pt x="583577" y="143941"/>
                  </a:lnTo>
                  <a:lnTo>
                    <a:pt x="586613" y="150291"/>
                  </a:lnTo>
                  <a:lnTo>
                    <a:pt x="588137" y="154101"/>
                  </a:lnTo>
                  <a:lnTo>
                    <a:pt x="588137" y="135051"/>
                  </a:lnTo>
                  <a:lnTo>
                    <a:pt x="583565" y="131241"/>
                  </a:lnTo>
                  <a:lnTo>
                    <a:pt x="580517" y="128701"/>
                  </a:lnTo>
                  <a:lnTo>
                    <a:pt x="571385" y="123621"/>
                  </a:lnTo>
                  <a:lnTo>
                    <a:pt x="562241" y="123621"/>
                  </a:lnTo>
                  <a:lnTo>
                    <a:pt x="559193" y="126161"/>
                  </a:lnTo>
                  <a:lnTo>
                    <a:pt x="556145" y="126161"/>
                  </a:lnTo>
                  <a:lnTo>
                    <a:pt x="548525" y="133781"/>
                  </a:lnTo>
                  <a:lnTo>
                    <a:pt x="545477" y="142671"/>
                  </a:lnTo>
                  <a:lnTo>
                    <a:pt x="545477" y="143941"/>
                  </a:lnTo>
                  <a:lnTo>
                    <a:pt x="547001" y="146481"/>
                  </a:lnTo>
                  <a:lnTo>
                    <a:pt x="540905" y="142671"/>
                  </a:lnTo>
                  <a:lnTo>
                    <a:pt x="536333" y="146481"/>
                  </a:lnTo>
                  <a:lnTo>
                    <a:pt x="588137" y="198551"/>
                  </a:lnTo>
                  <a:lnTo>
                    <a:pt x="594245" y="192201"/>
                  </a:lnTo>
                  <a:lnTo>
                    <a:pt x="575957" y="174421"/>
                  </a:lnTo>
                  <a:lnTo>
                    <a:pt x="583577" y="174421"/>
                  </a:lnTo>
                  <a:lnTo>
                    <a:pt x="586613" y="173151"/>
                  </a:lnTo>
                  <a:lnTo>
                    <a:pt x="589661" y="169341"/>
                  </a:lnTo>
                  <a:lnTo>
                    <a:pt x="590423" y="168071"/>
                  </a:lnTo>
                  <a:lnTo>
                    <a:pt x="591185" y="166801"/>
                  </a:lnTo>
                  <a:lnTo>
                    <a:pt x="594245" y="165531"/>
                  </a:lnTo>
                  <a:lnTo>
                    <a:pt x="595769" y="159181"/>
                  </a:lnTo>
                  <a:lnTo>
                    <a:pt x="595769" y="149021"/>
                  </a:lnTo>
                  <a:close/>
                </a:path>
                <a:path w="1516379" h="645159">
                  <a:moveTo>
                    <a:pt x="635381" y="34721"/>
                  </a:moveTo>
                  <a:lnTo>
                    <a:pt x="627748" y="27101"/>
                  </a:lnTo>
                  <a:lnTo>
                    <a:pt x="621665" y="32181"/>
                  </a:lnTo>
                  <a:lnTo>
                    <a:pt x="629272" y="39801"/>
                  </a:lnTo>
                  <a:lnTo>
                    <a:pt x="635381" y="34721"/>
                  </a:lnTo>
                  <a:close/>
                </a:path>
                <a:path w="1516379" h="645159">
                  <a:moveTo>
                    <a:pt x="636905" y="108381"/>
                  </a:moveTo>
                  <a:lnTo>
                    <a:pt x="635381" y="105841"/>
                  </a:lnTo>
                  <a:lnTo>
                    <a:pt x="633857" y="100761"/>
                  </a:lnTo>
                  <a:lnTo>
                    <a:pt x="626237" y="107111"/>
                  </a:lnTo>
                  <a:lnTo>
                    <a:pt x="627748" y="110921"/>
                  </a:lnTo>
                  <a:lnTo>
                    <a:pt x="627748" y="118541"/>
                  </a:lnTo>
                  <a:lnTo>
                    <a:pt x="626237" y="121081"/>
                  </a:lnTo>
                  <a:lnTo>
                    <a:pt x="626237" y="122351"/>
                  </a:lnTo>
                  <a:lnTo>
                    <a:pt x="624713" y="126161"/>
                  </a:lnTo>
                  <a:lnTo>
                    <a:pt x="618604" y="128701"/>
                  </a:lnTo>
                  <a:lnTo>
                    <a:pt x="615569" y="128701"/>
                  </a:lnTo>
                  <a:lnTo>
                    <a:pt x="612521" y="129971"/>
                  </a:lnTo>
                  <a:lnTo>
                    <a:pt x="609473" y="128701"/>
                  </a:lnTo>
                  <a:lnTo>
                    <a:pt x="606425" y="128701"/>
                  </a:lnTo>
                  <a:lnTo>
                    <a:pt x="600329" y="123621"/>
                  </a:lnTo>
                  <a:lnTo>
                    <a:pt x="605320" y="118541"/>
                  </a:lnTo>
                  <a:lnTo>
                    <a:pt x="627748" y="95681"/>
                  </a:lnTo>
                  <a:lnTo>
                    <a:pt x="624103" y="91871"/>
                  </a:lnTo>
                  <a:lnTo>
                    <a:pt x="621665" y="89331"/>
                  </a:lnTo>
                  <a:lnTo>
                    <a:pt x="617080" y="88061"/>
                  </a:lnTo>
                  <a:lnTo>
                    <a:pt x="617080" y="96951"/>
                  </a:lnTo>
                  <a:lnTo>
                    <a:pt x="595769" y="118541"/>
                  </a:lnTo>
                  <a:lnTo>
                    <a:pt x="592709" y="114731"/>
                  </a:lnTo>
                  <a:lnTo>
                    <a:pt x="592709" y="112191"/>
                  </a:lnTo>
                  <a:lnTo>
                    <a:pt x="591185" y="110921"/>
                  </a:lnTo>
                  <a:lnTo>
                    <a:pt x="591185" y="100761"/>
                  </a:lnTo>
                  <a:lnTo>
                    <a:pt x="592709" y="98221"/>
                  </a:lnTo>
                  <a:lnTo>
                    <a:pt x="595769" y="96951"/>
                  </a:lnTo>
                  <a:lnTo>
                    <a:pt x="597281" y="95681"/>
                  </a:lnTo>
                  <a:lnTo>
                    <a:pt x="603377" y="91871"/>
                  </a:lnTo>
                  <a:lnTo>
                    <a:pt x="609473" y="91871"/>
                  </a:lnTo>
                  <a:lnTo>
                    <a:pt x="610997" y="93141"/>
                  </a:lnTo>
                  <a:lnTo>
                    <a:pt x="617080" y="96951"/>
                  </a:lnTo>
                  <a:lnTo>
                    <a:pt x="617080" y="88061"/>
                  </a:lnTo>
                  <a:lnTo>
                    <a:pt x="612521" y="84251"/>
                  </a:lnTo>
                  <a:lnTo>
                    <a:pt x="601853" y="84251"/>
                  </a:lnTo>
                  <a:lnTo>
                    <a:pt x="582053" y="104571"/>
                  </a:lnTo>
                  <a:lnTo>
                    <a:pt x="582053" y="108381"/>
                  </a:lnTo>
                  <a:lnTo>
                    <a:pt x="606425" y="137591"/>
                  </a:lnTo>
                  <a:lnTo>
                    <a:pt x="615569" y="137591"/>
                  </a:lnTo>
                  <a:lnTo>
                    <a:pt x="620141" y="136321"/>
                  </a:lnTo>
                  <a:lnTo>
                    <a:pt x="629272" y="129971"/>
                  </a:lnTo>
                  <a:lnTo>
                    <a:pt x="632333" y="127431"/>
                  </a:lnTo>
                  <a:lnTo>
                    <a:pt x="636905" y="116001"/>
                  </a:lnTo>
                  <a:lnTo>
                    <a:pt x="636905" y="108381"/>
                  </a:lnTo>
                  <a:close/>
                </a:path>
                <a:path w="1516379" h="645159">
                  <a:moveTo>
                    <a:pt x="667372" y="90601"/>
                  </a:moveTo>
                  <a:lnTo>
                    <a:pt x="661276" y="85521"/>
                  </a:lnTo>
                  <a:lnTo>
                    <a:pt x="658241" y="89331"/>
                  </a:lnTo>
                  <a:lnTo>
                    <a:pt x="656704" y="90601"/>
                  </a:lnTo>
                  <a:lnTo>
                    <a:pt x="653656" y="90601"/>
                  </a:lnTo>
                  <a:lnTo>
                    <a:pt x="652132" y="89331"/>
                  </a:lnTo>
                  <a:lnTo>
                    <a:pt x="650608" y="89331"/>
                  </a:lnTo>
                  <a:lnTo>
                    <a:pt x="649084" y="88061"/>
                  </a:lnTo>
                  <a:lnTo>
                    <a:pt x="634860" y="72821"/>
                  </a:lnTo>
                  <a:lnTo>
                    <a:pt x="627748" y="65201"/>
                  </a:lnTo>
                  <a:lnTo>
                    <a:pt x="632637" y="60121"/>
                  </a:lnTo>
                  <a:lnTo>
                    <a:pt x="633857" y="58851"/>
                  </a:lnTo>
                  <a:lnTo>
                    <a:pt x="629272" y="53771"/>
                  </a:lnTo>
                  <a:lnTo>
                    <a:pt x="623189" y="60121"/>
                  </a:lnTo>
                  <a:lnTo>
                    <a:pt x="609473" y="47421"/>
                  </a:lnTo>
                  <a:lnTo>
                    <a:pt x="607949" y="57581"/>
                  </a:lnTo>
                  <a:lnTo>
                    <a:pt x="617080" y="66471"/>
                  </a:lnTo>
                  <a:lnTo>
                    <a:pt x="612521" y="70281"/>
                  </a:lnTo>
                  <a:lnTo>
                    <a:pt x="617080" y="76631"/>
                  </a:lnTo>
                  <a:lnTo>
                    <a:pt x="621665" y="72821"/>
                  </a:lnTo>
                  <a:lnTo>
                    <a:pt x="642988" y="93141"/>
                  </a:lnTo>
                  <a:lnTo>
                    <a:pt x="646049" y="95681"/>
                  </a:lnTo>
                  <a:lnTo>
                    <a:pt x="647573" y="98221"/>
                  </a:lnTo>
                  <a:lnTo>
                    <a:pt x="649084" y="98221"/>
                  </a:lnTo>
                  <a:lnTo>
                    <a:pt x="650608" y="99491"/>
                  </a:lnTo>
                  <a:lnTo>
                    <a:pt x="656704" y="99491"/>
                  </a:lnTo>
                  <a:lnTo>
                    <a:pt x="659752" y="98221"/>
                  </a:lnTo>
                  <a:lnTo>
                    <a:pt x="665848" y="93141"/>
                  </a:lnTo>
                  <a:lnTo>
                    <a:pt x="667372" y="90601"/>
                  </a:lnTo>
                  <a:close/>
                </a:path>
                <a:path w="1516379" h="645159">
                  <a:moveTo>
                    <a:pt x="679551" y="77901"/>
                  </a:moveTo>
                  <a:lnTo>
                    <a:pt x="642988" y="42341"/>
                  </a:lnTo>
                  <a:lnTo>
                    <a:pt x="635381" y="47421"/>
                  </a:lnTo>
                  <a:lnTo>
                    <a:pt x="673468" y="84251"/>
                  </a:lnTo>
                  <a:lnTo>
                    <a:pt x="679551" y="77901"/>
                  </a:lnTo>
                  <a:close/>
                </a:path>
                <a:path w="1516379" h="645159">
                  <a:moveTo>
                    <a:pt x="719175" y="38531"/>
                  </a:moveTo>
                  <a:lnTo>
                    <a:pt x="696328" y="15671"/>
                  </a:lnTo>
                  <a:lnTo>
                    <a:pt x="694791" y="13131"/>
                  </a:lnTo>
                  <a:lnTo>
                    <a:pt x="691743" y="9321"/>
                  </a:lnTo>
                  <a:lnTo>
                    <a:pt x="690219" y="9321"/>
                  </a:lnTo>
                  <a:lnTo>
                    <a:pt x="684136" y="6781"/>
                  </a:lnTo>
                  <a:lnTo>
                    <a:pt x="678040" y="6781"/>
                  </a:lnTo>
                  <a:lnTo>
                    <a:pt x="676516" y="8051"/>
                  </a:lnTo>
                  <a:lnTo>
                    <a:pt x="671944" y="9321"/>
                  </a:lnTo>
                  <a:lnTo>
                    <a:pt x="665848" y="15671"/>
                  </a:lnTo>
                  <a:lnTo>
                    <a:pt x="662800" y="20751"/>
                  </a:lnTo>
                  <a:lnTo>
                    <a:pt x="662800" y="30911"/>
                  </a:lnTo>
                  <a:lnTo>
                    <a:pt x="658241" y="24561"/>
                  </a:lnTo>
                  <a:lnTo>
                    <a:pt x="652132" y="30911"/>
                  </a:lnTo>
                  <a:lnTo>
                    <a:pt x="688708" y="69011"/>
                  </a:lnTo>
                  <a:lnTo>
                    <a:pt x="696328" y="62661"/>
                  </a:lnTo>
                  <a:lnTo>
                    <a:pt x="671944" y="38531"/>
                  </a:lnTo>
                  <a:lnTo>
                    <a:pt x="668896" y="32181"/>
                  </a:lnTo>
                  <a:lnTo>
                    <a:pt x="668896" y="30911"/>
                  </a:lnTo>
                  <a:lnTo>
                    <a:pt x="668896" y="23291"/>
                  </a:lnTo>
                  <a:lnTo>
                    <a:pt x="674992" y="16941"/>
                  </a:lnTo>
                  <a:lnTo>
                    <a:pt x="678040" y="15671"/>
                  </a:lnTo>
                  <a:lnTo>
                    <a:pt x="681075" y="15671"/>
                  </a:lnTo>
                  <a:lnTo>
                    <a:pt x="687184" y="19481"/>
                  </a:lnTo>
                  <a:lnTo>
                    <a:pt x="713079" y="44881"/>
                  </a:lnTo>
                  <a:lnTo>
                    <a:pt x="719175" y="38531"/>
                  </a:lnTo>
                  <a:close/>
                </a:path>
                <a:path w="1516379" h="645159">
                  <a:moveTo>
                    <a:pt x="947724" y="617880"/>
                  </a:moveTo>
                  <a:lnTo>
                    <a:pt x="943152" y="603910"/>
                  </a:lnTo>
                  <a:lnTo>
                    <a:pt x="941628" y="602640"/>
                  </a:lnTo>
                  <a:lnTo>
                    <a:pt x="932484" y="595020"/>
                  </a:lnTo>
                  <a:lnTo>
                    <a:pt x="927912" y="593750"/>
                  </a:lnTo>
                  <a:lnTo>
                    <a:pt x="918768" y="593750"/>
                  </a:lnTo>
                  <a:lnTo>
                    <a:pt x="914209" y="595020"/>
                  </a:lnTo>
                  <a:lnTo>
                    <a:pt x="902017" y="605180"/>
                  </a:lnTo>
                  <a:lnTo>
                    <a:pt x="900493" y="610260"/>
                  </a:lnTo>
                  <a:lnTo>
                    <a:pt x="900493" y="612800"/>
                  </a:lnTo>
                  <a:lnTo>
                    <a:pt x="889825" y="596290"/>
                  </a:lnTo>
                  <a:lnTo>
                    <a:pt x="909624" y="577240"/>
                  </a:lnTo>
                  <a:lnTo>
                    <a:pt x="903541" y="570890"/>
                  </a:lnTo>
                  <a:lnTo>
                    <a:pt x="877633" y="595020"/>
                  </a:lnTo>
                  <a:lnTo>
                    <a:pt x="900493" y="626770"/>
                  </a:lnTo>
                  <a:lnTo>
                    <a:pt x="906589" y="622960"/>
                  </a:lnTo>
                  <a:lnTo>
                    <a:pt x="906589" y="615340"/>
                  </a:lnTo>
                  <a:lnTo>
                    <a:pt x="907351" y="612800"/>
                  </a:lnTo>
                  <a:lnTo>
                    <a:pt x="908100" y="610260"/>
                  </a:lnTo>
                  <a:lnTo>
                    <a:pt x="912685" y="605180"/>
                  </a:lnTo>
                  <a:lnTo>
                    <a:pt x="918768" y="602640"/>
                  </a:lnTo>
                  <a:lnTo>
                    <a:pt x="924877" y="602640"/>
                  </a:lnTo>
                  <a:lnTo>
                    <a:pt x="930960" y="605180"/>
                  </a:lnTo>
                  <a:lnTo>
                    <a:pt x="934008" y="608990"/>
                  </a:lnTo>
                  <a:lnTo>
                    <a:pt x="935532" y="611530"/>
                  </a:lnTo>
                  <a:lnTo>
                    <a:pt x="938580" y="615340"/>
                  </a:lnTo>
                  <a:lnTo>
                    <a:pt x="938580" y="617880"/>
                  </a:lnTo>
                  <a:lnTo>
                    <a:pt x="940104" y="620420"/>
                  </a:lnTo>
                  <a:lnTo>
                    <a:pt x="938580" y="624230"/>
                  </a:lnTo>
                  <a:lnTo>
                    <a:pt x="938580" y="626770"/>
                  </a:lnTo>
                  <a:lnTo>
                    <a:pt x="937069" y="628040"/>
                  </a:lnTo>
                  <a:lnTo>
                    <a:pt x="935532" y="631850"/>
                  </a:lnTo>
                  <a:lnTo>
                    <a:pt x="932484" y="633120"/>
                  </a:lnTo>
                  <a:lnTo>
                    <a:pt x="930960" y="634390"/>
                  </a:lnTo>
                  <a:lnTo>
                    <a:pt x="927912" y="635660"/>
                  </a:lnTo>
                  <a:lnTo>
                    <a:pt x="923340" y="635660"/>
                  </a:lnTo>
                  <a:lnTo>
                    <a:pt x="920292" y="634390"/>
                  </a:lnTo>
                  <a:lnTo>
                    <a:pt x="918768" y="633120"/>
                  </a:lnTo>
                  <a:lnTo>
                    <a:pt x="915733" y="631850"/>
                  </a:lnTo>
                  <a:lnTo>
                    <a:pt x="909624" y="639470"/>
                  </a:lnTo>
                  <a:lnTo>
                    <a:pt x="912685" y="642010"/>
                  </a:lnTo>
                  <a:lnTo>
                    <a:pt x="917244" y="643280"/>
                  </a:lnTo>
                  <a:lnTo>
                    <a:pt x="920292" y="643280"/>
                  </a:lnTo>
                  <a:lnTo>
                    <a:pt x="924877" y="644550"/>
                  </a:lnTo>
                  <a:lnTo>
                    <a:pt x="929436" y="643280"/>
                  </a:lnTo>
                  <a:lnTo>
                    <a:pt x="932484" y="642010"/>
                  </a:lnTo>
                  <a:lnTo>
                    <a:pt x="937069" y="640740"/>
                  </a:lnTo>
                  <a:lnTo>
                    <a:pt x="942149" y="635660"/>
                  </a:lnTo>
                  <a:lnTo>
                    <a:pt x="944676" y="633120"/>
                  </a:lnTo>
                  <a:lnTo>
                    <a:pt x="946200" y="626770"/>
                  </a:lnTo>
                  <a:lnTo>
                    <a:pt x="947724" y="622960"/>
                  </a:lnTo>
                  <a:lnTo>
                    <a:pt x="947724" y="617880"/>
                  </a:lnTo>
                  <a:close/>
                </a:path>
                <a:path w="1516379" h="645159">
                  <a:moveTo>
                    <a:pt x="994956" y="579780"/>
                  </a:moveTo>
                  <a:lnTo>
                    <a:pt x="961440" y="574700"/>
                  </a:lnTo>
                  <a:lnTo>
                    <a:pt x="961250" y="573430"/>
                  </a:lnTo>
                  <a:lnTo>
                    <a:pt x="956868" y="544220"/>
                  </a:lnTo>
                  <a:lnTo>
                    <a:pt x="949248" y="550570"/>
                  </a:lnTo>
                  <a:lnTo>
                    <a:pt x="952296" y="565810"/>
                  </a:lnTo>
                  <a:lnTo>
                    <a:pt x="952296" y="570890"/>
                  </a:lnTo>
                  <a:lnTo>
                    <a:pt x="953820" y="573430"/>
                  </a:lnTo>
                  <a:lnTo>
                    <a:pt x="950772" y="572160"/>
                  </a:lnTo>
                  <a:lnTo>
                    <a:pt x="946200" y="572160"/>
                  </a:lnTo>
                  <a:lnTo>
                    <a:pt x="932484" y="569620"/>
                  </a:lnTo>
                  <a:lnTo>
                    <a:pt x="923340" y="577240"/>
                  </a:lnTo>
                  <a:lnTo>
                    <a:pt x="955344" y="582320"/>
                  </a:lnTo>
                  <a:lnTo>
                    <a:pt x="959904" y="615340"/>
                  </a:lnTo>
                  <a:lnTo>
                    <a:pt x="967536" y="606450"/>
                  </a:lnTo>
                  <a:lnTo>
                    <a:pt x="962964" y="582320"/>
                  </a:lnTo>
                  <a:lnTo>
                    <a:pt x="987348" y="588670"/>
                  </a:lnTo>
                  <a:lnTo>
                    <a:pt x="992784" y="582320"/>
                  </a:lnTo>
                  <a:lnTo>
                    <a:pt x="994956" y="579780"/>
                  </a:lnTo>
                  <a:close/>
                </a:path>
                <a:path w="1516379" h="645159">
                  <a:moveTo>
                    <a:pt x="1008672" y="520090"/>
                  </a:moveTo>
                  <a:lnTo>
                    <a:pt x="1002576" y="513740"/>
                  </a:lnTo>
                  <a:lnTo>
                    <a:pt x="978204" y="539140"/>
                  </a:lnTo>
                  <a:lnTo>
                    <a:pt x="961440" y="523900"/>
                  </a:lnTo>
                  <a:lnTo>
                    <a:pt x="988872" y="494690"/>
                  </a:lnTo>
                  <a:lnTo>
                    <a:pt x="982764" y="488340"/>
                  </a:lnTo>
                  <a:lnTo>
                    <a:pt x="949248" y="523900"/>
                  </a:lnTo>
                  <a:lnTo>
                    <a:pt x="1001052" y="574700"/>
                  </a:lnTo>
                  <a:lnTo>
                    <a:pt x="1007148" y="569620"/>
                  </a:lnTo>
                  <a:lnTo>
                    <a:pt x="984288" y="544220"/>
                  </a:lnTo>
                  <a:lnTo>
                    <a:pt x="989418" y="539140"/>
                  </a:lnTo>
                  <a:lnTo>
                    <a:pt x="1008672" y="520090"/>
                  </a:lnTo>
                  <a:close/>
                </a:path>
                <a:path w="1516379" h="645159">
                  <a:moveTo>
                    <a:pt x="1086370" y="488340"/>
                  </a:moveTo>
                  <a:lnTo>
                    <a:pt x="1083386" y="487070"/>
                  </a:lnTo>
                  <a:lnTo>
                    <a:pt x="1049807" y="472782"/>
                  </a:lnTo>
                  <a:lnTo>
                    <a:pt x="1049807" y="483260"/>
                  </a:lnTo>
                  <a:lnTo>
                    <a:pt x="1031519" y="502310"/>
                  </a:lnTo>
                  <a:lnTo>
                    <a:pt x="1022375" y="480720"/>
                  </a:lnTo>
                  <a:lnTo>
                    <a:pt x="1019340" y="473100"/>
                  </a:lnTo>
                  <a:lnTo>
                    <a:pt x="1017816" y="470560"/>
                  </a:lnTo>
                  <a:lnTo>
                    <a:pt x="1022375" y="471830"/>
                  </a:lnTo>
                  <a:lnTo>
                    <a:pt x="1025436" y="473100"/>
                  </a:lnTo>
                  <a:lnTo>
                    <a:pt x="1030008" y="474370"/>
                  </a:lnTo>
                  <a:lnTo>
                    <a:pt x="1049807" y="483260"/>
                  </a:lnTo>
                  <a:lnTo>
                    <a:pt x="1049807" y="472782"/>
                  </a:lnTo>
                  <a:lnTo>
                    <a:pt x="1038644" y="468020"/>
                  </a:lnTo>
                  <a:lnTo>
                    <a:pt x="1014768" y="457860"/>
                  </a:lnTo>
                  <a:lnTo>
                    <a:pt x="1007148" y="465480"/>
                  </a:lnTo>
                  <a:lnTo>
                    <a:pt x="1039152" y="536600"/>
                  </a:lnTo>
                  <a:lnTo>
                    <a:pt x="1045235" y="528980"/>
                  </a:lnTo>
                  <a:lnTo>
                    <a:pt x="1036091" y="508660"/>
                  </a:lnTo>
                  <a:lnTo>
                    <a:pt x="1042365" y="502310"/>
                  </a:lnTo>
                  <a:lnTo>
                    <a:pt x="1057427" y="487070"/>
                  </a:lnTo>
                  <a:lnTo>
                    <a:pt x="1078763" y="497230"/>
                  </a:lnTo>
                  <a:lnTo>
                    <a:pt x="1086370" y="488340"/>
                  </a:lnTo>
                  <a:close/>
                </a:path>
                <a:path w="1516379" h="645159">
                  <a:moveTo>
                    <a:pt x="1122946" y="437540"/>
                  </a:moveTo>
                  <a:lnTo>
                    <a:pt x="1121422" y="432460"/>
                  </a:lnTo>
                  <a:lnTo>
                    <a:pt x="1116850" y="422300"/>
                  </a:lnTo>
                  <a:lnTo>
                    <a:pt x="1113802" y="419252"/>
                  </a:lnTo>
                  <a:lnTo>
                    <a:pt x="1113802" y="441350"/>
                  </a:lnTo>
                  <a:lnTo>
                    <a:pt x="1113802" y="442620"/>
                  </a:lnTo>
                  <a:lnTo>
                    <a:pt x="1112278" y="447700"/>
                  </a:lnTo>
                  <a:lnTo>
                    <a:pt x="1110754" y="450240"/>
                  </a:lnTo>
                  <a:lnTo>
                    <a:pt x="1110754" y="451510"/>
                  </a:lnTo>
                  <a:lnTo>
                    <a:pt x="1109230" y="455320"/>
                  </a:lnTo>
                  <a:lnTo>
                    <a:pt x="1106182" y="456590"/>
                  </a:lnTo>
                  <a:lnTo>
                    <a:pt x="1104658" y="459130"/>
                  </a:lnTo>
                  <a:lnTo>
                    <a:pt x="1093990" y="470560"/>
                  </a:lnTo>
                  <a:lnTo>
                    <a:pt x="1054379" y="429920"/>
                  </a:lnTo>
                  <a:lnTo>
                    <a:pt x="1069619" y="414680"/>
                  </a:lnTo>
                  <a:lnTo>
                    <a:pt x="1072654" y="413410"/>
                  </a:lnTo>
                  <a:lnTo>
                    <a:pt x="1074178" y="412140"/>
                  </a:lnTo>
                  <a:lnTo>
                    <a:pt x="1077239" y="410870"/>
                  </a:lnTo>
                  <a:lnTo>
                    <a:pt x="1083322" y="410870"/>
                  </a:lnTo>
                  <a:lnTo>
                    <a:pt x="1086370" y="412140"/>
                  </a:lnTo>
                  <a:lnTo>
                    <a:pt x="1090955" y="412140"/>
                  </a:lnTo>
                  <a:lnTo>
                    <a:pt x="1101623" y="421030"/>
                  </a:lnTo>
                  <a:lnTo>
                    <a:pt x="1104658" y="424840"/>
                  </a:lnTo>
                  <a:lnTo>
                    <a:pt x="1106182" y="427380"/>
                  </a:lnTo>
                  <a:lnTo>
                    <a:pt x="1110754" y="432460"/>
                  </a:lnTo>
                  <a:lnTo>
                    <a:pt x="1112278" y="437540"/>
                  </a:lnTo>
                  <a:lnTo>
                    <a:pt x="1113802" y="441350"/>
                  </a:lnTo>
                  <a:lnTo>
                    <a:pt x="1113802" y="419252"/>
                  </a:lnTo>
                  <a:lnTo>
                    <a:pt x="1109230" y="414680"/>
                  </a:lnTo>
                  <a:lnTo>
                    <a:pt x="1106182" y="410870"/>
                  </a:lnTo>
                  <a:lnTo>
                    <a:pt x="1101623" y="407060"/>
                  </a:lnTo>
                  <a:lnTo>
                    <a:pt x="1095514" y="404520"/>
                  </a:lnTo>
                  <a:lnTo>
                    <a:pt x="1090955" y="403250"/>
                  </a:lnTo>
                  <a:lnTo>
                    <a:pt x="1087907" y="401980"/>
                  </a:lnTo>
                  <a:lnTo>
                    <a:pt x="1077239" y="401980"/>
                  </a:lnTo>
                  <a:lnTo>
                    <a:pt x="1068095" y="405790"/>
                  </a:lnTo>
                  <a:lnTo>
                    <a:pt x="1066571" y="405790"/>
                  </a:lnTo>
                  <a:lnTo>
                    <a:pt x="1040676" y="432460"/>
                  </a:lnTo>
                  <a:lnTo>
                    <a:pt x="1092479" y="483260"/>
                  </a:lnTo>
                  <a:lnTo>
                    <a:pt x="1104671" y="470560"/>
                  </a:lnTo>
                  <a:lnTo>
                    <a:pt x="1116850" y="457860"/>
                  </a:lnTo>
                  <a:lnTo>
                    <a:pt x="1122946" y="447700"/>
                  </a:lnTo>
                  <a:lnTo>
                    <a:pt x="1122946" y="437540"/>
                  </a:lnTo>
                  <a:close/>
                </a:path>
                <a:path w="1516379" h="645159">
                  <a:moveTo>
                    <a:pt x="1144282" y="433730"/>
                  </a:moveTo>
                  <a:lnTo>
                    <a:pt x="1106182" y="365150"/>
                  </a:lnTo>
                  <a:lnTo>
                    <a:pt x="1101623" y="368960"/>
                  </a:lnTo>
                  <a:lnTo>
                    <a:pt x="1139710" y="437540"/>
                  </a:lnTo>
                  <a:lnTo>
                    <a:pt x="1144282" y="433730"/>
                  </a:lnTo>
                  <a:close/>
                </a:path>
                <a:path w="1516379" h="645159">
                  <a:moveTo>
                    <a:pt x="1203706" y="357530"/>
                  </a:moveTo>
                  <a:lnTo>
                    <a:pt x="1197102" y="351180"/>
                  </a:lnTo>
                  <a:lnTo>
                    <a:pt x="1183894" y="338480"/>
                  </a:lnTo>
                  <a:lnTo>
                    <a:pt x="1162558" y="360070"/>
                  </a:lnTo>
                  <a:lnTo>
                    <a:pt x="1168654" y="366420"/>
                  </a:lnTo>
                  <a:lnTo>
                    <a:pt x="1183894" y="351180"/>
                  </a:lnTo>
                  <a:lnTo>
                    <a:pt x="1193038" y="360070"/>
                  </a:lnTo>
                  <a:lnTo>
                    <a:pt x="1193038" y="365150"/>
                  </a:lnTo>
                  <a:lnTo>
                    <a:pt x="1191514" y="367690"/>
                  </a:lnTo>
                  <a:lnTo>
                    <a:pt x="1191514" y="371500"/>
                  </a:lnTo>
                  <a:lnTo>
                    <a:pt x="1186929" y="376580"/>
                  </a:lnTo>
                  <a:lnTo>
                    <a:pt x="1183894" y="381660"/>
                  </a:lnTo>
                  <a:lnTo>
                    <a:pt x="1177798" y="386740"/>
                  </a:lnTo>
                  <a:lnTo>
                    <a:pt x="1171702" y="389280"/>
                  </a:lnTo>
                  <a:lnTo>
                    <a:pt x="1168654" y="389280"/>
                  </a:lnTo>
                  <a:lnTo>
                    <a:pt x="1165618" y="390550"/>
                  </a:lnTo>
                  <a:lnTo>
                    <a:pt x="1161034" y="389280"/>
                  </a:lnTo>
                  <a:lnTo>
                    <a:pt x="1157986" y="389280"/>
                  </a:lnTo>
                  <a:lnTo>
                    <a:pt x="1154950" y="388010"/>
                  </a:lnTo>
                  <a:lnTo>
                    <a:pt x="1150366" y="384200"/>
                  </a:lnTo>
                  <a:lnTo>
                    <a:pt x="1147318" y="382930"/>
                  </a:lnTo>
                  <a:lnTo>
                    <a:pt x="1141234" y="376580"/>
                  </a:lnTo>
                  <a:lnTo>
                    <a:pt x="1139710" y="374040"/>
                  </a:lnTo>
                  <a:lnTo>
                    <a:pt x="1135126" y="367690"/>
                  </a:lnTo>
                  <a:lnTo>
                    <a:pt x="1133614" y="363880"/>
                  </a:lnTo>
                  <a:lnTo>
                    <a:pt x="1133614" y="353720"/>
                  </a:lnTo>
                  <a:lnTo>
                    <a:pt x="1135126" y="352450"/>
                  </a:lnTo>
                  <a:lnTo>
                    <a:pt x="1135126" y="349910"/>
                  </a:lnTo>
                  <a:lnTo>
                    <a:pt x="1136650" y="346100"/>
                  </a:lnTo>
                  <a:lnTo>
                    <a:pt x="1142758" y="341020"/>
                  </a:lnTo>
                  <a:lnTo>
                    <a:pt x="1145794" y="337210"/>
                  </a:lnTo>
                  <a:lnTo>
                    <a:pt x="1150366" y="334670"/>
                  </a:lnTo>
                  <a:lnTo>
                    <a:pt x="1153426" y="333400"/>
                  </a:lnTo>
                  <a:lnTo>
                    <a:pt x="1159510" y="333400"/>
                  </a:lnTo>
                  <a:lnTo>
                    <a:pt x="1168654" y="335940"/>
                  </a:lnTo>
                  <a:lnTo>
                    <a:pt x="1170178" y="333400"/>
                  </a:lnTo>
                  <a:lnTo>
                    <a:pt x="1173226" y="328320"/>
                  </a:lnTo>
                  <a:lnTo>
                    <a:pt x="1170178" y="327050"/>
                  </a:lnTo>
                  <a:lnTo>
                    <a:pt x="1165618" y="325780"/>
                  </a:lnTo>
                  <a:lnTo>
                    <a:pt x="1162558" y="323240"/>
                  </a:lnTo>
                  <a:lnTo>
                    <a:pt x="1154950" y="323240"/>
                  </a:lnTo>
                  <a:lnTo>
                    <a:pt x="1148842" y="327050"/>
                  </a:lnTo>
                  <a:lnTo>
                    <a:pt x="1145794" y="327050"/>
                  </a:lnTo>
                  <a:lnTo>
                    <a:pt x="1136650" y="334670"/>
                  </a:lnTo>
                  <a:lnTo>
                    <a:pt x="1132090" y="337210"/>
                  </a:lnTo>
                  <a:lnTo>
                    <a:pt x="1129042" y="342290"/>
                  </a:lnTo>
                  <a:lnTo>
                    <a:pt x="1124458" y="356260"/>
                  </a:lnTo>
                  <a:lnTo>
                    <a:pt x="1124458" y="365150"/>
                  </a:lnTo>
                  <a:lnTo>
                    <a:pt x="1125994" y="368960"/>
                  </a:lnTo>
                  <a:lnTo>
                    <a:pt x="1129042" y="374040"/>
                  </a:lnTo>
                  <a:lnTo>
                    <a:pt x="1130566" y="379120"/>
                  </a:lnTo>
                  <a:lnTo>
                    <a:pt x="1133614" y="382930"/>
                  </a:lnTo>
                  <a:lnTo>
                    <a:pt x="1141234" y="390550"/>
                  </a:lnTo>
                  <a:lnTo>
                    <a:pt x="1145794" y="394360"/>
                  </a:lnTo>
                  <a:lnTo>
                    <a:pt x="1150366" y="395630"/>
                  </a:lnTo>
                  <a:lnTo>
                    <a:pt x="1154950" y="398170"/>
                  </a:lnTo>
                  <a:lnTo>
                    <a:pt x="1173226" y="398170"/>
                  </a:lnTo>
                  <a:lnTo>
                    <a:pt x="1177798" y="395630"/>
                  </a:lnTo>
                  <a:lnTo>
                    <a:pt x="1182370" y="394360"/>
                  </a:lnTo>
                  <a:lnTo>
                    <a:pt x="1186942" y="390550"/>
                  </a:lnTo>
                  <a:lnTo>
                    <a:pt x="1189990" y="388010"/>
                  </a:lnTo>
                  <a:lnTo>
                    <a:pt x="1194562" y="381660"/>
                  </a:lnTo>
                  <a:lnTo>
                    <a:pt x="1199121" y="374040"/>
                  </a:lnTo>
                  <a:lnTo>
                    <a:pt x="1202182" y="366420"/>
                  </a:lnTo>
                  <a:lnTo>
                    <a:pt x="1202182" y="361340"/>
                  </a:lnTo>
                  <a:lnTo>
                    <a:pt x="1203706" y="357530"/>
                  </a:lnTo>
                  <a:close/>
                </a:path>
                <a:path w="1516379" h="645159">
                  <a:moveTo>
                    <a:pt x="1243317" y="318160"/>
                  </a:moveTo>
                  <a:lnTo>
                    <a:pt x="1241793" y="314350"/>
                  </a:lnTo>
                  <a:lnTo>
                    <a:pt x="1238732" y="310540"/>
                  </a:lnTo>
                  <a:lnTo>
                    <a:pt x="1237221" y="306730"/>
                  </a:lnTo>
                  <a:lnTo>
                    <a:pt x="1235697" y="305206"/>
                  </a:lnTo>
                  <a:lnTo>
                    <a:pt x="1235697" y="325780"/>
                  </a:lnTo>
                  <a:lnTo>
                    <a:pt x="1234173" y="328320"/>
                  </a:lnTo>
                  <a:lnTo>
                    <a:pt x="1234173" y="330860"/>
                  </a:lnTo>
                  <a:lnTo>
                    <a:pt x="1231125" y="335940"/>
                  </a:lnTo>
                  <a:lnTo>
                    <a:pt x="1221981" y="341020"/>
                  </a:lnTo>
                  <a:lnTo>
                    <a:pt x="1215898" y="341020"/>
                  </a:lnTo>
                  <a:lnTo>
                    <a:pt x="1212837" y="338480"/>
                  </a:lnTo>
                  <a:lnTo>
                    <a:pt x="1208265" y="335940"/>
                  </a:lnTo>
                  <a:lnTo>
                    <a:pt x="1205230" y="333400"/>
                  </a:lnTo>
                  <a:lnTo>
                    <a:pt x="1199121" y="325780"/>
                  </a:lnTo>
                  <a:lnTo>
                    <a:pt x="1197597" y="321970"/>
                  </a:lnTo>
                  <a:lnTo>
                    <a:pt x="1197597" y="315620"/>
                  </a:lnTo>
                  <a:lnTo>
                    <a:pt x="1202182" y="306730"/>
                  </a:lnTo>
                  <a:lnTo>
                    <a:pt x="1205230" y="305460"/>
                  </a:lnTo>
                  <a:lnTo>
                    <a:pt x="1206741" y="304190"/>
                  </a:lnTo>
                  <a:lnTo>
                    <a:pt x="1217409" y="304190"/>
                  </a:lnTo>
                  <a:lnTo>
                    <a:pt x="1223505" y="306730"/>
                  </a:lnTo>
                  <a:lnTo>
                    <a:pt x="1232649" y="318160"/>
                  </a:lnTo>
                  <a:lnTo>
                    <a:pt x="1234173" y="320700"/>
                  </a:lnTo>
                  <a:lnTo>
                    <a:pt x="1235697" y="325780"/>
                  </a:lnTo>
                  <a:lnTo>
                    <a:pt x="1235697" y="305206"/>
                  </a:lnTo>
                  <a:lnTo>
                    <a:pt x="1234681" y="304190"/>
                  </a:lnTo>
                  <a:lnTo>
                    <a:pt x="1229601" y="299110"/>
                  </a:lnTo>
                  <a:lnTo>
                    <a:pt x="1223505" y="296570"/>
                  </a:lnTo>
                  <a:lnTo>
                    <a:pt x="1218933" y="295300"/>
                  </a:lnTo>
                  <a:lnTo>
                    <a:pt x="1209789" y="295300"/>
                  </a:lnTo>
                  <a:lnTo>
                    <a:pt x="1205230" y="296570"/>
                  </a:lnTo>
                  <a:lnTo>
                    <a:pt x="1200645" y="299110"/>
                  </a:lnTo>
                  <a:lnTo>
                    <a:pt x="1194562" y="305460"/>
                  </a:lnTo>
                  <a:lnTo>
                    <a:pt x="1189990" y="313080"/>
                  </a:lnTo>
                  <a:lnTo>
                    <a:pt x="1189990" y="318160"/>
                  </a:lnTo>
                  <a:lnTo>
                    <a:pt x="1188453" y="320700"/>
                  </a:lnTo>
                  <a:lnTo>
                    <a:pt x="1189990" y="323240"/>
                  </a:lnTo>
                  <a:lnTo>
                    <a:pt x="1191514" y="328320"/>
                  </a:lnTo>
                  <a:lnTo>
                    <a:pt x="1194562" y="334670"/>
                  </a:lnTo>
                  <a:lnTo>
                    <a:pt x="1199121" y="338480"/>
                  </a:lnTo>
                  <a:lnTo>
                    <a:pt x="1203706" y="343560"/>
                  </a:lnTo>
                  <a:lnTo>
                    <a:pt x="1212837" y="348640"/>
                  </a:lnTo>
                  <a:lnTo>
                    <a:pt x="1243317" y="329590"/>
                  </a:lnTo>
                  <a:lnTo>
                    <a:pt x="1243317" y="318160"/>
                  </a:lnTo>
                  <a:close/>
                </a:path>
                <a:path w="1516379" h="645159">
                  <a:moveTo>
                    <a:pt x="1281404" y="283870"/>
                  </a:moveTo>
                  <a:lnTo>
                    <a:pt x="1279880" y="280060"/>
                  </a:lnTo>
                  <a:lnTo>
                    <a:pt x="1278369" y="277520"/>
                  </a:lnTo>
                  <a:lnTo>
                    <a:pt x="1273784" y="273710"/>
                  </a:lnTo>
                  <a:lnTo>
                    <a:pt x="1272260" y="273710"/>
                  </a:lnTo>
                  <a:lnTo>
                    <a:pt x="1270736" y="272440"/>
                  </a:lnTo>
                  <a:lnTo>
                    <a:pt x="1266177" y="272440"/>
                  </a:lnTo>
                  <a:lnTo>
                    <a:pt x="1263116" y="273710"/>
                  </a:lnTo>
                  <a:lnTo>
                    <a:pt x="1260068" y="273710"/>
                  </a:lnTo>
                  <a:lnTo>
                    <a:pt x="1258557" y="274980"/>
                  </a:lnTo>
                  <a:lnTo>
                    <a:pt x="1253985" y="277520"/>
                  </a:lnTo>
                  <a:lnTo>
                    <a:pt x="1247889" y="281330"/>
                  </a:lnTo>
                  <a:lnTo>
                    <a:pt x="1246365" y="282600"/>
                  </a:lnTo>
                  <a:lnTo>
                    <a:pt x="1244841" y="282600"/>
                  </a:lnTo>
                  <a:lnTo>
                    <a:pt x="1243317" y="283870"/>
                  </a:lnTo>
                  <a:lnTo>
                    <a:pt x="1237221" y="283870"/>
                  </a:lnTo>
                  <a:lnTo>
                    <a:pt x="1234173" y="281330"/>
                  </a:lnTo>
                  <a:lnTo>
                    <a:pt x="1234173" y="277520"/>
                  </a:lnTo>
                  <a:lnTo>
                    <a:pt x="1235697" y="276250"/>
                  </a:lnTo>
                  <a:lnTo>
                    <a:pt x="1235697" y="273710"/>
                  </a:lnTo>
                  <a:lnTo>
                    <a:pt x="1244841" y="266090"/>
                  </a:lnTo>
                  <a:lnTo>
                    <a:pt x="1250924" y="266090"/>
                  </a:lnTo>
                  <a:lnTo>
                    <a:pt x="1253985" y="267360"/>
                  </a:lnTo>
                  <a:lnTo>
                    <a:pt x="1254899" y="266090"/>
                  </a:lnTo>
                  <a:lnTo>
                    <a:pt x="1258557" y="261010"/>
                  </a:lnTo>
                  <a:lnTo>
                    <a:pt x="1255509" y="258470"/>
                  </a:lnTo>
                  <a:lnTo>
                    <a:pt x="1252461" y="258470"/>
                  </a:lnTo>
                  <a:lnTo>
                    <a:pt x="1250924" y="257200"/>
                  </a:lnTo>
                  <a:lnTo>
                    <a:pt x="1247889" y="257200"/>
                  </a:lnTo>
                  <a:lnTo>
                    <a:pt x="1243317" y="258470"/>
                  </a:lnTo>
                  <a:lnTo>
                    <a:pt x="1238732" y="261010"/>
                  </a:lnTo>
                  <a:lnTo>
                    <a:pt x="1231125" y="268630"/>
                  </a:lnTo>
                  <a:lnTo>
                    <a:pt x="1226553" y="277520"/>
                  </a:lnTo>
                  <a:lnTo>
                    <a:pt x="1226553" y="281330"/>
                  </a:lnTo>
                  <a:lnTo>
                    <a:pt x="1228077" y="283870"/>
                  </a:lnTo>
                  <a:lnTo>
                    <a:pt x="1228077" y="287680"/>
                  </a:lnTo>
                  <a:lnTo>
                    <a:pt x="1231125" y="290220"/>
                  </a:lnTo>
                  <a:lnTo>
                    <a:pt x="1237221" y="292760"/>
                  </a:lnTo>
                  <a:lnTo>
                    <a:pt x="1244841" y="292760"/>
                  </a:lnTo>
                  <a:lnTo>
                    <a:pt x="1247889" y="291490"/>
                  </a:lnTo>
                  <a:lnTo>
                    <a:pt x="1249400" y="290220"/>
                  </a:lnTo>
                  <a:lnTo>
                    <a:pt x="1253985" y="288950"/>
                  </a:lnTo>
                  <a:lnTo>
                    <a:pt x="1257033" y="287680"/>
                  </a:lnTo>
                  <a:lnTo>
                    <a:pt x="1260068" y="283870"/>
                  </a:lnTo>
                  <a:lnTo>
                    <a:pt x="1263116" y="282600"/>
                  </a:lnTo>
                  <a:lnTo>
                    <a:pt x="1270736" y="282600"/>
                  </a:lnTo>
                  <a:lnTo>
                    <a:pt x="1273784" y="285140"/>
                  </a:lnTo>
                  <a:lnTo>
                    <a:pt x="1273784" y="291490"/>
                  </a:lnTo>
                  <a:lnTo>
                    <a:pt x="1272260" y="292760"/>
                  </a:lnTo>
                  <a:lnTo>
                    <a:pt x="1270736" y="296570"/>
                  </a:lnTo>
                  <a:lnTo>
                    <a:pt x="1269212" y="297840"/>
                  </a:lnTo>
                  <a:lnTo>
                    <a:pt x="1266177" y="299110"/>
                  </a:lnTo>
                  <a:lnTo>
                    <a:pt x="1261592" y="302920"/>
                  </a:lnTo>
                  <a:lnTo>
                    <a:pt x="1255509" y="302920"/>
                  </a:lnTo>
                  <a:lnTo>
                    <a:pt x="1253985" y="300380"/>
                  </a:lnTo>
                  <a:lnTo>
                    <a:pt x="1250924" y="299110"/>
                  </a:lnTo>
                  <a:lnTo>
                    <a:pt x="1246365" y="306730"/>
                  </a:lnTo>
                  <a:lnTo>
                    <a:pt x="1252461" y="310540"/>
                  </a:lnTo>
                  <a:lnTo>
                    <a:pt x="1257033" y="311810"/>
                  </a:lnTo>
                  <a:lnTo>
                    <a:pt x="1260068" y="311810"/>
                  </a:lnTo>
                  <a:lnTo>
                    <a:pt x="1266177" y="308000"/>
                  </a:lnTo>
                  <a:lnTo>
                    <a:pt x="1270736" y="306730"/>
                  </a:lnTo>
                  <a:lnTo>
                    <a:pt x="1273784" y="304190"/>
                  </a:lnTo>
                  <a:lnTo>
                    <a:pt x="1274699" y="302920"/>
                  </a:lnTo>
                  <a:lnTo>
                    <a:pt x="1278369" y="297840"/>
                  </a:lnTo>
                  <a:lnTo>
                    <a:pt x="1279880" y="296570"/>
                  </a:lnTo>
                  <a:lnTo>
                    <a:pt x="1279880" y="292760"/>
                  </a:lnTo>
                  <a:lnTo>
                    <a:pt x="1281404" y="291490"/>
                  </a:lnTo>
                  <a:lnTo>
                    <a:pt x="1281404" y="283870"/>
                  </a:lnTo>
                  <a:close/>
                </a:path>
                <a:path w="1516379" h="645159">
                  <a:moveTo>
                    <a:pt x="1317980" y="247040"/>
                  </a:moveTo>
                  <a:lnTo>
                    <a:pt x="1316456" y="243230"/>
                  </a:lnTo>
                  <a:lnTo>
                    <a:pt x="1310347" y="236880"/>
                  </a:lnTo>
                  <a:lnTo>
                    <a:pt x="1307312" y="235610"/>
                  </a:lnTo>
                  <a:lnTo>
                    <a:pt x="1301203" y="235610"/>
                  </a:lnTo>
                  <a:lnTo>
                    <a:pt x="1299692" y="236880"/>
                  </a:lnTo>
                  <a:lnTo>
                    <a:pt x="1296644" y="236880"/>
                  </a:lnTo>
                  <a:lnTo>
                    <a:pt x="1290548" y="241960"/>
                  </a:lnTo>
                  <a:lnTo>
                    <a:pt x="1284452" y="244500"/>
                  </a:lnTo>
                  <a:lnTo>
                    <a:pt x="1282928" y="245770"/>
                  </a:lnTo>
                  <a:lnTo>
                    <a:pt x="1281404" y="245770"/>
                  </a:lnTo>
                  <a:lnTo>
                    <a:pt x="1279880" y="247040"/>
                  </a:lnTo>
                  <a:lnTo>
                    <a:pt x="1273784" y="247040"/>
                  </a:lnTo>
                  <a:lnTo>
                    <a:pt x="1270736" y="244500"/>
                  </a:lnTo>
                  <a:lnTo>
                    <a:pt x="1270736" y="241960"/>
                  </a:lnTo>
                  <a:lnTo>
                    <a:pt x="1272260" y="239420"/>
                  </a:lnTo>
                  <a:lnTo>
                    <a:pt x="1272260" y="236880"/>
                  </a:lnTo>
                  <a:lnTo>
                    <a:pt x="1273784" y="235610"/>
                  </a:lnTo>
                  <a:lnTo>
                    <a:pt x="1276832" y="234340"/>
                  </a:lnTo>
                  <a:lnTo>
                    <a:pt x="1278369" y="231800"/>
                  </a:lnTo>
                  <a:lnTo>
                    <a:pt x="1281404" y="229260"/>
                  </a:lnTo>
                  <a:lnTo>
                    <a:pt x="1287500" y="229260"/>
                  </a:lnTo>
                  <a:lnTo>
                    <a:pt x="1290548" y="230530"/>
                  </a:lnTo>
                  <a:lnTo>
                    <a:pt x="1291767" y="229260"/>
                  </a:lnTo>
                  <a:lnTo>
                    <a:pt x="1296644" y="224180"/>
                  </a:lnTo>
                  <a:lnTo>
                    <a:pt x="1293596" y="222910"/>
                  </a:lnTo>
                  <a:lnTo>
                    <a:pt x="1292072" y="221640"/>
                  </a:lnTo>
                  <a:lnTo>
                    <a:pt x="1287500" y="220370"/>
                  </a:lnTo>
                  <a:lnTo>
                    <a:pt x="1284452" y="220370"/>
                  </a:lnTo>
                  <a:lnTo>
                    <a:pt x="1279880" y="221640"/>
                  </a:lnTo>
                  <a:lnTo>
                    <a:pt x="1275308" y="224180"/>
                  </a:lnTo>
                  <a:lnTo>
                    <a:pt x="1272260" y="226720"/>
                  </a:lnTo>
                  <a:lnTo>
                    <a:pt x="1270736" y="229260"/>
                  </a:lnTo>
                  <a:lnTo>
                    <a:pt x="1267701" y="231800"/>
                  </a:lnTo>
                  <a:lnTo>
                    <a:pt x="1266177" y="235610"/>
                  </a:lnTo>
                  <a:lnTo>
                    <a:pt x="1264653" y="236880"/>
                  </a:lnTo>
                  <a:lnTo>
                    <a:pt x="1264653" y="238150"/>
                  </a:lnTo>
                  <a:lnTo>
                    <a:pt x="1263116" y="241960"/>
                  </a:lnTo>
                  <a:lnTo>
                    <a:pt x="1263116" y="244500"/>
                  </a:lnTo>
                  <a:lnTo>
                    <a:pt x="1264653" y="247040"/>
                  </a:lnTo>
                  <a:lnTo>
                    <a:pt x="1264653" y="250850"/>
                  </a:lnTo>
                  <a:lnTo>
                    <a:pt x="1267701" y="253390"/>
                  </a:lnTo>
                  <a:lnTo>
                    <a:pt x="1270736" y="254660"/>
                  </a:lnTo>
                  <a:lnTo>
                    <a:pt x="1272260" y="257200"/>
                  </a:lnTo>
                  <a:lnTo>
                    <a:pt x="1281404" y="257200"/>
                  </a:lnTo>
                  <a:lnTo>
                    <a:pt x="1285976" y="253390"/>
                  </a:lnTo>
                  <a:lnTo>
                    <a:pt x="1290548" y="252120"/>
                  </a:lnTo>
                  <a:lnTo>
                    <a:pt x="1293596" y="249580"/>
                  </a:lnTo>
                  <a:lnTo>
                    <a:pt x="1297660" y="247040"/>
                  </a:lnTo>
                  <a:lnTo>
                    <a:pt x="1299692" y="245770"/>
                  </a:lnTo>
                  <a:lnTo>
                    <a:pt x="1307312" y="245770"/>
                  </a:lnTo>
                  <a:lnTo>
                    <a:pt x="1310347" y="249580"/>
                  </a:lnTo>
                  <a:lnTo>
                    <a:pt x="1310347" y="254660"/>
                  </a:lnTo>
                  <a:lnTo>
                    <a:pt x="1307312" y="259740"/>
                  </a:lnTo>
                  <a:lnTo>
                    <a:pt x="1305788" y="261010"/>
                  </a:lnTo>
                  <a:lnTo>
                    <a:pt x="1302740" y="262280"/>
                  </a:lnTo>
                  <a:lnTo>
                    <a:pt x="1301203" y="264820"/>
                  </a:lnTo>
                  <a:lnTo>
                    <a:pt x="1298168" y="266090"/>
                  </a:lnTo>
                  <a:lnTo>
                    <a:pt x="1292072" y="266090"/>
                  </a:lnTo>
                  <a:lnTo>
                    <a:pt x="1287500" y="262280"/>
                  </a:lnTo>
                  <a:lnTo>
                    <a:pt x="1282928" y="269900"/>
                  </a:lnTo>
                  <a:lnTo>
                    <a:pt x="1289024" y="273710"/>
                  </a:lnTo>
                  <a:lnTo>
                    <a:pt x="1293596" y="274980"/>
                  </a:lnTo>
                  <a:lnTo>
                    <a:pt x="1296644" y="274980"/>
                  </a:lnTo>
                  <a:lnTo>
                    <a:pt x="1299692" y="273710"/>
                  </a:lnTo>
                  <a:lnTo>
                    <a:pt x="1304264" y="272440"/>
                  </a:lnTo>
                  <a:lnTo>
                    <a:pt x="1310347" y="267360"/>
                  </a:lnTo>
                  <a:lnTo>
                    <a:pt x="1311262" y="266090"/>
                  </a:lnTo>
                  <a:lnTo>
                    <a:pt x="1314919" y="261010"/>
                  </a:lnTo>
                  <a:lnTo>
                    <a:pt x="1316456" y="259740"/>
                  </a:lnTo>
                  <a:lnTo>
                    <a:pt x="1316456" y="257200"/>
                  </a:lnTo>
                  <a:lnTo>
                    <a:pt x="1317980" y="254660"/>
                  </a:lnTo>
                  <a:lnTo>
                    <a:pt x="1317980" y="247040"/>
                  </a:lnTo>
                  <a:close/>
                </a:path>
                <a:path w="1516379" h="645159">
                  <a:moveTo>
                    <a:pt x="1356067" y="241960"/>
                  </a:moveTo>
                  <a:lnTo>
                    <a:pt x="1354543" y="238150"/>
                  </a:lnTo>
                  <a:lnTo>
                    <a:pt x="1354543" y="236880"/>
                  </a:lnTo>
                  <a:lnTo>
                    <a:pt x="1351495" y="230530"/>
                  </a:lnTo>
                  <a:lnTo>
                    <a:pt x="1349971" y="226720"/>
                  </a:lnTo>
                  <a:lnTo>
                    <a:pt x="1347749" y="221640"/>
                  </a:lnTo>
                  <a:lnTo>
                    <a:pt x="1327111" y="174650"/>
                  </a:lnTo>
                  <a:lnTo>
                    <a:pt x="1319504" y="181000"/>
                  </a:lnTo>
                  <a:lnTo>
                    <a:pt x="1333207" y="211480"/>
                  </a:lnTo>
                  <a:lnTo>
                    <a:pt x="1336255" y="215290"/>
                  </a:lnTo>
                  <a:lnTo>
                    <a:pt x="1339303" y="221640"/>
                  </a:lnTo>
                  <a:lnTo>
                    <a:pt x="1334731" y="219100"/>
                  </a:lnTo>
                  <a:lnTo>
                    <a:pt x="1328648" y="215290"/>
                  </a:lnTo>
                  <a:lnTo>
                    <a:pt x="1299692" y="201320"/>
                  </a:lnTo>
                  <a:lnTo>
                    <a:pt x="1292072" y="208940"/>
                  </a:lnTo>
                  <a:lnTo>
                    <a:pt x="1343875" y="231800"/>
                  </a:lnTo>
                  <a:lnTo>
                    <a:pt x="1343875" y="234340"/>
                  </a:lnTo>
                  <a:lnTo>
                    <a:pt x="1345399" y="234340"/>
                  </a:lnTo>
                  <a:lnTo>
                    <a:pt x="1345399" y="236880"/>
                  </a:lnTo>
                  <a:lnTo>
                    <a:pt x="1346923" y="238150"/>
                  </a:lnTo>
                  <a:lnTo>
                    <a:pt x="1346923" y="247040"/>
                  </a:lnTo>
                  <a:lnTo>
                    <a:pt x="1345399" y="249580"/>
                  </a:lnTo>
                  <a:lnTo>
                    <a:pt x="1342351" y="250850"/>
                  </a:lnTo>
                  <a:lnTo>
                    <a:pt x="1340840" y="252120"/>
                  </a:lnTo>
                  <a:lnTo>
                    <a:pt x="1346923" y="257200"/>
                  </a:lnTo>
                  <a:lnTo>
                    <a:pt x="1354543" y="250850"/>
                  </a:lnTo>
                  <a:lnTo>
                    <a:pt x="1356067" y="247040"/>
                  </a:lnTo>
                  <a:lnTo>
                    <a:pt x="1356067" y="241960"/>
                  </a:lnTo>
                  <a:close/>
                </a:path>
                <a:path w="1516379" h="645159">
                  <a:moveTo>
                    <a:pt x="1392643" y="177190"/>
                  </a:moveTo>
                  <a:lnTo>
                    <a:pt x="1391119" y="174650"/>
                  </a:lnTo>
                  <a:lnTo>
                    <a:pt x="1391119" y="168300"/>
                  </a:lnTo>
                  <a:lnTo>
                    <a:pt x="1385011" y="158140"/>
                  </a:lnTo>
                  <a:lnTo>
                    <a:pt x="1383487" y="156870"/>
                  </a:lnTo>
                  <a:lnTo>
                    <a:pt x="1383487" y="173380"/>
                  </a:lnTo>
                  <a:lnTo>
                    <a:pt x="1383487" y="182270"/>
                  </a:lnTo>
                  <a:lnTo>
                    <a:pt x="1381975" y="184810"/>
                  </a:lnTo>
                  <a:lnTo>
                    <a:pt x="1375867" y="189890"/>
                  </a:lnTo>
                  <a:lnTo>
                    <a:pt x="1372819" y="191160"/>
                  </a:lnTo>
                  <a:lnTo>
                    <a:pt x="1369783" y="191160"/>
                  </a:lnTo>
                  <a:lnTo>
                    <a:pt x="1366735" y="189890"/>
                  </a:lnTo>
                  <a:lnTo>
                    <a:pt x="1362163" y="188620"/>
                  </a:lnTo>
                  <a:lnTo>
                    <a:pt x="1356067" y="183540"/>
                  </a:lnTo>
                  <a:lnTo>
                    <a:pt x="1353019" y="178460"/>
                  </a:lnTo>
                  <a:lnTo>
                    <a:pt x="1349971" y="175920"/>
                  </a:lnTo>
                  <a:lnTo>
                    <a:pt x="1348447" y="173380"/>
                  </a:lnTo>
                  <a:lnTo>
                    <a:pt x="1348447" y="168300"/>
                  </a:lnTo>
                  <a:lnTo>
                    <a:pt x="1348447" y="161950"/>
                  </a:lnTo>
                  <a:lnTo>
                    <a:pt x="1349971" y="159410"/>
                  </a:lnTo>
                  <a:lnTo>
                    <a:pt x="1353019" y="155600"/>
                  </a:lnTo>
                  <a:lnTo>
                    <a:pt x="1356067" y="154330"/>
                  </a:lnTo>
                  <a:lnTo>
                    <a:pt x="1365199" y="154330"/>
                  </a:lnTo>
                  <a:lnTo>
                    <a:pt x="1368259" y="155600"/>
                  </a:lnTo>
                  <a:lnTo>
                    <a:pt x="1371307" y="159410"/>
                  </a:lnTo>
                  <a:lnTo>
                    <a:pt x="1375867" y="161950"/>
                  </a:lnTo>
                  <a:lnTo>
                    <a:pt x="1381975" y="169570"/>
                  </a:lnTo>
                  <a:lnTo>
                    <a:pt x="1383487" y="173380"/>
                  </a:lnTo>
                  <a:lnTo>
                    <a:pt x="1383487" y="156870"/>
                  </a:lnTo>
                  <a:lnTo>
                    <a:pt x="1381975" y="155600"/>
                  </a:lnTo>
                  <a:lnTo>
                    <a:pt x="1379943" y="154330"/>
                  </a:lnTo>
                  <a:lnTo>
                    <a:pt x="1375867" y="151790"/>
                  </a:lnTo>
                  <a:lnTo>
                    <a:pt x="1369783" y="146710"/>
                  </a:lnTo>
                  <a:lnTo>
                    <a:pt x="1366735" y="146710"/>
                  </a:lnTo>
                  <a:lnTo>
                    <a:pt x="1363675" y="145440"/>
                  </a:lnTo>
                  <a:lnTo>
                    <a:pt x="1360639" y="145440"/>
                  </a:lnTo>
                  <a:lnTo>
                    <a:pt x="1357591" y="146710"/>
                  </a:lnTo>
                  <a:lnTo>
                    <a:pt x="1354543" y="146710"/>
                  </a:lnTo>
                  <a:lnTo>
                    <a:pt x="1351495" y="147980"/>
                  </a:lnTo>
                  <a:lnTo>
                    <a:pt x="1349971" y="150520"/>
                  </a:lnTo>
                  <a:lnTo>
                    <a:pt x="1346923" y="151790"/>
                  </a:lnTo>
                  <a:lnTo>
                    <a:pt x="1345399" y="154330"/>
                  </a:lnTo>
                  <a:lnTo>
                    <a:pt x="1343875" y="155600"/>
                  </a:lnTo>
                  <a:lnTo>
                    <a:pt x="1340840" y="163220"/>
                  </a:lnTo>
                  <a:lnTo>
                    <a:pt x="1342351" y="168300"/>
                  </a:lnTo>
                  <a:lnTo>
                    <a:pt x="1337779" y="163220"/>
                  </a:lnTo>
                  <a:lnTo>
                    <a:pt x="1331683" y="169570"/>
                  </a:lnTo>
                  <a:lnTo>
                    <a:pt x="1383487" y="221640"/>
                  </a:lnTo>
                  <a:lnTo>
                    <a:pt x="1389583" y="215290"/>
                  </a:lnTo>
                  <a:lnTo>
                    <a:pt x="1371307" y="197510"/>
                  </a:lnTo>
                  <a:lnTo>
                    <a:pt x="1374343" y="197510"/>
                  </a:lnTo>
                  <a:lnTo>
                    <a:pt x="1378927" y="196240"/>
                  </a:lnTo>
                  <a:lnTo>
                    <a:pt x="1385011" y="191160"/>
                  </a:lnTo>
                  <a:lnTo>
                    <a:pt x="1388059" y="189890"/>
                  </a:lnTo>
                  <a:lnTo>
                    <a:pt x="1389583" y="186080"/>
                  </a:lnTo>
                  <a:lnTo>
                    <a:pt x="1391119" y="181000"/>
                  </a:lnTo>
                  <a:lnTo>
                    <a:pt x="1392643" y="177190"/>
                  </a:lnTo>
                  <a:close/>
                </a:path>
                <a:path w="1516379" h="645159">
                  <a:moveTo>
                    <a:pt x="1430731" y="55270"/>
                  </a:moveTo>
                  <a:lnTo>
                    <a:pt x="1423111" y="48920"/>
                  </a:lnTo>
                  <a:lnTo>
                    <a:pt x="1417015" y="55270"/>
                  </a:lnTo>
                  <a:lnTo>
                    <a:pt x="1424622" y="62890"/>
                  </a:lnTo>
                  <a:lnTo>
                    <a:pt x="1430731" y="55270"/>
                  </a:lnTo>
                  <a:close/>
                </a:path>
                <a:path w="1516379" h="645159">
                  <a:moveTo>
                    <a:pt x="1432255" y="131470"/>
                  </a:moveTo>
                  <a:lnTo>
                    <a:pt x="1429207" y="123850"/>
                  </a:lnTo>
                  <a:lnTo>
                    <a:pt x="1421587" y="130200"/>
                  </a:lnTo>
                  <a:lnTo>
                    <a:pt x="1423111" y="135280"/>
                  </a:lnTo>
                  <a:lnTo>
                    <a:pt x="1424622" y="136550"/>
                  </a:lnTo>
                  <a:lnTo>
                    <a:pt x="1424622" y="139090"/>
                  </a:lnTo>
                  <a:lnTo>
                    <a:pt x="1423111" y="140360"/>
                  </a:lnTo>
                  <a:lnTo>
                    <a:pt x="1423111" y="144170"/>
                  </a:lnTo>
                  <a:lnTo>
                    <a:pt x="1420063" y="146710"/>
                  </a:lnTo>
                  <a:lnTo>
                    <a:pt x="1413954" y="150520"/>
                  </a:lnTo>
                  <a:lnTo>
                    <a:pt x="1412443" y="151790"/>
                  </a:lnTo>
                  <a:lnTo>
                    <a:pt x="1404823" y="151790"/>
                  </a:lnTo>
                  <a:lnTo>
                    <a:pt x="1398727" y="147980"/>
                  </a:lnTo>
                  <a:lnTo>
                    <a:pt x="1395679" y="145440"/>
                  </a:lnTo>
                  <a:lnTo>
                    <a:pt x="1400670" y="140360"/>
                  </a:lnTo>
                  <a:lnTo>
                    <a:pt x="1423111" y="117500"/>
                  </a:lnTo>
                  <a:lnTo>
                    <a:pt x="1423111" y="116230"/>
                  </a:lnTo>
                  <a:lnTo>
                    <a:pt x="1421587" y="116230"/>
                  </a:lnTo>
                  <a:lnTo>
                    <a:pt x="1420063" y="114960"/>
                  </a:lnTo>
                  <a:lnTo>
                    <a:pt x="1412443" y="108610"/>
                  </a:lnTo>
                  <a:lnTo>
                    <a:pt x="1412443" y="120040"/>
                  </a:lnTo>
                  <a:lnTo>
                    <a:pt x="1391119" y="140360"/>
                  </a:lnTo>
                  <a:lnTo>
                    <a:pt x="1388059" y="137820"/>
                  </a:lnTo>
                  <a:lnTo>
                    <a:pt x="1388059" y="135280"/>
                  </a:lnTo>
                  <a:lnTo>
                    <a:pt x="1386535" y="131470"/>
                  </a:lnTo>
                  <a:lnTo>
                    <a:pt x="1386535" y="125120"/>
                  </a:lnTo>
                  <a:lnTo>
                    <a:pt x="1388059" y="122580"/>
                  </a:lnTo>
                  <a:lnTo>
                    <a:pt x="1388059" y="121310"/>
                  </a:lnTo>
                  <a:lnTo>
                    <a:pt x="1391119" y="117500"/>
                  </a:lnTo>
                  <a:lnTo>
                    <a:pt x="1394155" y="116230"/>
                  </a:lnTo>
                  <a:lnTo>
                    <a:pt x="1395679" y="114960"/>
                  </a:lnTo>
                  <a:lnTo>
                    <a:pt x="1406347" y="114960"/>
                  </a:lnTo>
                  <a:lnTo>
                    <a:pt x="1409395" y="116230"/>
                  </a:lnTo>
                  <a:lnTo>
                    <a:pt x="1412443" y="120040"/>
                  </a:lnTo>
                  <a:lnTo>
                    <a:pt x="1412443" y="108610"/>
                  </a:lnTo>
                  <a:lnTo>
                    <a:pt x="1403299" y="106070"/>
                  </a:lnTo>
                  <a:lnTo>
                    <a:pt x="1398727" y="107340"/>
                  </a:lnTo>
                  <a:lnTo>
                    <a:pt x="1394155" y="107340"/>
                  </a:lnTo>
                  <a:lnTo>
                    <a:pt x="1385011" y="113690"/>
                  </a:lnTo>
                  <a:lnTo>
                    <a:pt x="1381975" y="117500"/>
                  </a:lnTo>
                  <a:lnTo>
                    <a:pt x="1378927" y="127660"/>
                  </a:lnTo>
                  <a:lnTo>
                    <a:pt x="1378927" y="136550"/>
                  </a:lnTo>
                  <a:lnTo>
                    <a:pt x="1406347" y="160680"/>
                  </a:lnTo>
                  <a:lnTo>
                    <a:pt x="1412443" y="159410"/>
                  </a:lnTo>
                  <a:lnTo>
                    <a:pt x="1417015" y="158140"/>
                  </a:lnTo>
                  <a:lnTo>
                    <a:pt x="1420063" y="155600"/>
                  </a:lnTo>
                  <a:lnTo>
                    <a:pt x="1424622" y="153060"/>
                  </a:lnTo>
                  <a:lnTo>
                    <a:pt x="1425384" y="151790"/>
                  </a:lnTo>
                  <a:lnTo>
                    <a:pt x="1427670" y="147980"/>
                  </a:lnTo>
                  <a:lnTo>
                    <a:pt x="1430731" y="145440"/>
                  </a:lnTo>
                  <a:lnTo>
                    <a:pt x="1432255" y="142900"/>
                  </a:lnTo>
                  <a:lnTo>
                    <a:pt x="1432255" y="131470"/>
                  </a:lnTo>
                  <a:close/>
                </a:path>
                <a:path w="1516379" h="645159">
                  <a:moveTo>
                    <a:pt x="1462722" y="112420"/>
                  </a:moveTo>
                  <a:lnTo>
                    <a:pt x="1456626" y="107340"/>
                  </a:lnTo>
                  <a:lnTo>
                    <a:pt x="1452054" y="112420"/>
                  </a:lnTo>
                  <a:lnTo>
                    <a:pt x="1447482" y="112420"/>
                  </a:lnTo>
                  <a:lnTo>
                    <a:pt x="1445958" y="108610"/>
                  </a:lnTo>
                  <a:lnTo>
                    <a:pt x="1429829" y="93370"/>
                  </a:lnTo>
                  <a:lnTo>
                    <a:pt x="1423111" y="87020"/>
                  </a:lnTo>
                  <a:lnTo>
                    <a:pt x="1427683" y="83210"/>
                  </a:lnTo>
                  <a:lnTo>
                    <a:pt x="1429207" y="81940"/>
                  </a:lnTo>
                  <a:lnTo>
                    <a:pt x="1424622" y="76860"/>
                  </a:lnTo>
                  <a:lnTo>
                    <a:pt x="1418539" y="83210"/>
                  </a:lnTo>
                  <a:lnTo>
                    <a:pt x="1404823" y="69240"/>
                  </a:lnTo>
                  <a:lnTo>
                    <a:pt x="1403299" y="79400"/>
                  </a:lnTo>
                  <a:lnTo>
                    <a:pt x="1412443" y="89560"/>
                  </a:lnTo>
                  <a:lnTo>
                    <a:pt x="1407871" y="93370"/>
                  </a:lnTo>
                  <a:lnTo>
                    <a:pt x="1412443" y="98450"/>
                  </a:lnTo>
                  <a:lnTo>
                    <a:pt x="1417015" y="93370"/>
                  </a:lnTo>
                  <a:lnTo>
                    <a:pt x="1442923" y="120040"/>
                  </a:lnTo>
                  <a:lnTo>
                    <a:pt x="1445958" y="121310"/>
                  </a:lnTo>
                  <a:lnTo>
                    <a:pt x="1447482" y="122580"/>
                  </a:lnTo>
                  <a:lnTo>
                    <a:pt x="1452054" y="122580"/>
                  </a:lnTo>
                  <a:lnTo>
                    <a:pt x="1453578" y="121310"/>
                  </a:lnTo>
                  <a:lnTo>
                    <a:pt x="1455115" y="121310"/>
                  </a:lnTo>
                  <a:lnTo>
                    <a:pt x="1461198" y="114960"/>
                  </a:lnTo>
                  <a:lnTo>
                    <a:pt x="1462722" y="112420"/>
                  </a:lnTo>
                  <a:close/>
                </a:path>
                <a:path w="1516379" h="645159">
                  <a:moveTo>
                    <a:pt x="1474914" y="100990"/>
                  </a:moveTo>
                  <a:lnTo>
                    <a:pt x="1438338" y="62890"/>
                  </a:lnTo>
                  <a:lnTo>
                    <a:pt x="1432255" y="69240"/>
                  </a:lnTo>
                  <a:lnTo>
                    <a:pt x="1468818" y="107340"/>
                  </a:lnTo>
                  <a:lnTo>
                    <a:pt x="1474914" y="100990"/>
                  </a:lnTo>
                  <a:close/>
                </a:path>
                <a:path w="1516379" h="645159">
                  <a:moveTo>
                    <a:pt x="1516049" y="60350"/>
                  </a:moveTo>
                  <a:lnTo>
                    <a:pt x="1494472" y="38760"/>
                  </a:lnTo>
                  <a:lnTo>
                    <a:pt x="1493202" y="37490"/>
                  </a:lnTo>
                  <a:lnTo>
                    <a:pt x="1490141" y="36220"/>
                  </a:lnTo>
                  <a:lnTo>
                    <a:pt x="1485582" y="31140"/>
                  </a:lnTo>
                  <a:lnTo>
                    <a:pt x="1479486" y="28600"/>
                  </a:lnTo>
                  <a:lnTo>
                    <a:pt x="1474914" y="28600"/>
                  </a:lnTo>
                  <a:lnTo>
                    <a:pt x="1471866" y="29870"/>
                  </a:lnTo>
                  <a:lnTo>
                    <a:pt x="1467294" y="31140"/>
                  </a:lnTo>
                  <a:lnTo>
                    <a:pt x="1464246" y="33680"/>
                  </a:lnTo>
                  <a:lnTo>
                    <a:pt x="1458150" y="43840"/>
                  </a:lnTo>
                  <a:lnTo>
                    <a:pt x="1458150" y="52730"/>
                  </a:lnTo>
                  <a:lnTo>
                    <a:pt x="1453578" y="47650"/>
                  </a:lnTo>
                  <a:lnTo>
                    <a:pt x="1447482" y="54000"/>
                  </a:lnTo>
                  <a:lnTo>
                    <a:pt x="1485582" y="90830"/>
                  </a:lnTo>
                  <a:lnTo>
                    <a:pt x="1491665" y="84480"/>
                  </a:lnTo>
                  <a:lnTo>
                    <a:pt x="1470342" y="64160"/>
                  </a:lnTo>
                  <a:lnTo>
                    <a:pt x="1467294" y="60350"/>
                  </a:lnTo>
                  <a:lnTo>
                    <a:pt x="1464246" y="54000"/>
                  </a:lnTo>
                  <a:lnTo>
                    <a:pt x="1464246" y="52730"/>
                  </a:lnTo>
                  <a:lnTo>
                    <a:pt x="1464246" y="47650"/>
                  </a:lnTo>
                  <a:lnTo>
                    <a:pt x="1465757" y="46380"/>
                  </a:lnTo>
                  <a:lnTo>
                    <a:pt x="1470342" y="38760"/>
                  </a:lnTo>
                  <a:lnTo>
                    <a:pt x="1479486" y="38760"/>
                  </a:lnTo>
                  <a:lnTo>
                    <a:pt x="1482534" y="40030"/>
                  </a:lnTo>
                  <a:lnTo>
                    <a:pt x="1487093" y="43840"/>
                  </a:lnTo>
                  <a:lnTo>
                    <a:pt x="1508429" y="66700"/>
                  </a:lnTo>
                  <a:lnTo>
                    <a:pt x="1516049" y="6035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1" name="object 41"/>
          <p:cNvSpPr txBox="1"/>
          <p:nvPr/>
        </p:nvSpPr>
        <p:spPr>
          <a:xfrm>
            <a:off x="4569947" y="5620683"/>
            <a:ext cx="679450" cy="2698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H</a:t>
            </a:r>
            <a:r>
              <a:rPr sz="800" dirty="0">
                <a:latin typeface="Arial"/>
                <a:cs typeface="Arial"/>
              </a:rPr>
              <a:t>i</a:t>
            </a:r>
            <a:r>
              <a:rPr sz="800" spc="-5" dirty="0">
                <a:latin typeface="Arial"/>
                <a:cs typeface="Arial"/>
              </a:rPr>
              <a:t>ppo</a:t>
            </a:r>
            <a:r>
              <a:rPr sz="800" spc="5" dirty="0">
                <a:latin typeface="Arial"/>
                <a:cs typeface="Arial"/>
              </a:rPr>
              <a:t>c</a:t>
            </a:r>
            <a:r>
              <a:rPr sz="800" spc="-5" dirty="0">
                <a:latin typeface="Arial"/>
                <a:cs typeface="Arial"/>
              </a:rPr>
              <a:t>a</a:t>
            </a:r>
            <a:r>
              <a:rPr sz="800" spc="10" dirty="0">
                <a:latin typeface="Arial"/>
                <a:cs typeface="Arial"/>
              </a:rPr>
              <a:t>m</a:t>
            </a:r>
            <a:r>
              <a:rPr sz="800" spc="-5" dirty="0">
                <a:latin typeface="Arial"/>
                <a:cs typeface="Arial"/>
              </a:rPr>
              <a:t>pu</a:t>
            </a:r>
            <a:r>
              <a:rPr sz="800" spc="5" dirty="0">
                <a:latin typeface="Arial"/>
                <a:cs typeface="Arial"/>
              </a:rPr>
              <a:t>s</a:t>
            </a:r>
            <a:r>
              <a:rPr sz="800" dirty="0">
                <a:latin typeface="Arial"/>
                <a:cs typeface="Arial"/>
              </a:rPr>
              <a:t>,  Stage</a:t>
            </a:r>
            <a:r>
              <a:rPr sz="800" spc="-20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1</a:t>
            </a:r>
            <a:r>
              <a:rPr sz="800" spc="-2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DAM</a:t>
            </a:r>
            <a:endParaRPr sz="800">
              <a:latin typeface="Arial"/>
              <a:cs typeface="Arial"/>
            </a:endParaRPr>
          </a:p>
        </p:txBody>
      </p:sp>
      <p:sp>
        <p:nvSpPr>
          <p:cNvPr id="42" name="object 42"/>
          <p:cNvSpPr txBox="1"/>
          <p:nvPr/>
        </p:nvSpPr>
        <p:spPr>
          <a:xfrm>
            <a:off x="2877778" y="5680524"/>
            <a:ext cx="149225" cy="1435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1110"/>
              </a:lnSpc>
            </a:pPr>
            <a:r>
              <a:rPr sz="1000" spc="-10" dirty="0">
                <a:latin typeface="Arial"/>
                <a:cs typeface="Arial"/>
              </a:rPr>
              <a:t>*</a:t>
            </a:r>
            <a:r>
              <a:rPr sz="1000" dirty="0">
                <a:latin typeface="Arial"/>
                <a:cs typeface="Arial"/>
              </a:rPr>
              <a:t>**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43" name="object 43"/>
          <p:cNvGrpSpPr/>
          <p:nvPr/>
        </p:nvGrpSpPr>
        <p:grpSpPr>
          <a:xfrm>
            <a:off x="1715998" y="5573184"/>
            <a:ext cx="1732914" cy="1417955"/>
            <a:chOff x="1715998" y="5573184"/>
            <a:chExt cx="1732914" cy="1417955"/>
          </a:xfrm>
        </p:grpSpPr>
        <p:sp>
          <p:nvSpPr>
            <p:cNvPr id="44" name="object 44"/>
            <p:cNvSpPr/>
            <p:nvPr/>
          </p:nvSpPr>
          <p:spPr>
            <a:xfrm>
              <a:off x="1719808" y="5576989"/>
              <a:ext cx="1725295" cy="1414145"/>
            </a:xfrm>
            <a:custGeom>
              <a:avLst/>
              <a:gdLst/>
              <a:ahLst/>
              <a:cxnLst/>
              <a:rect l="l" t="t" r="r" b="b"/>
              <a:pathLst>
                <a:path w="1725295" h="1414145">
                  <a:moveTo>
                    <a:pt x="1724787" y="0"/>
                  </a:moveTo>
                  <a:lnTo>
                    <a:pt x="0" y="0"/>
                  </a:lnTo>
                  <a:lnTo>
                    <a:pt x="0" y="1414068"/>
                  </a:lnTo>
                  <a:lnTo>
                    <a:pt x="1724787" y="1414068"/>
                  </a:lnTo>
                  <a:lnTo>
                    <a:pt x="1724787" y="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5" name="object 45"/>
            <p:cNvSpPr/>
            <p:nvPr/>
          </p:nvSpPr>
          <p:spPr>
            <a:xfrm>
              <a:off x="1719808" y="5576994"/>
              <a:ext cx="1725295" cy="0"/>
            </a:xfrm>
            <a:custGeom>
              <a:avLst/>
              <a:gdLst/>
              <a:ahLst/>
              <a:cxnLst/>
              <a:rect l="l" t="t" r="r" b="b"/>
              <a:pathLst>
                <a:path w="1725295">
                  <a:moveTo>
                    <a:pt x="1724787" y="0"/>
                  </a:moveTo>
                  <a:lnTo>
                    <a:pt x="0" y="0"/>
                  </a:lnTo>
                </a:path>
              </a:pathLst>
            </a:custGeom>
            <a:ln w="7620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6" name="object 46"/>
            <p:cNvSpPr/>
            <p:nvPr/>
          </p:nvSpPr>
          <p:spPr>
            <a:xfrm>
              <a:off x="1829503" y="6451633"/>
              <a:ext cx="312420" cy="451484"/>
            </a:xfrm>
            <a:custGeom>
              <a:avLst/>
              <a:gdLst/>
              <a:ahLst/>
              <a:cxnLst/>
              <a:rect l="l" t="t" r="r" b="b"/>
              <a:pathLst>
                <a:path w="312419" h="451484">
                  <a:moveTo>
                    <a:pt x="202653" y="0"/>
                  </a:moveTo>
                  <a:lnTo>
                    <a:pt x="109702" y="0"/>
                  </a:lnTo>
                  <a:lnTo>
                    <a:pt x="109702" y="1524"/>
                  </a:lnTo>
                  <a:lnTo>
                    <a:pt x="108191" y="3060"/>
                  </a:lnTo>
                  <a:lnTo>
                    <a:pt x="106667" y="3060"/>
                  </a:lnTo>
                  <a:lnTo>
                    <a:pt x="106667" y="4584"/>
                  </a:lnTo>
                  <a:lnTo>
                    <a:pt x="105143" y="4584"/>
                  </a:lnTo>
                  <a:lnTo>
                    <a:pt x="103606" y="6096"/>
                  </a:lnTo>
                  <a:lnTo>
                    <a:pt x="103606" y="7620"/>
                  </a:lnTo>
                  <a:lnTo>
                    <a:pt x="102095" y="7620"/>
                  </a:lnTo>
                  <a:lnTo>
                    <a:pt x="99047" y="10668"/>
                  </a:lnTo>
                  <a:lnTo>
                    <a:pt x="97523" y="10668"/>
                  </a:lnTo>
                  <a:lnTo>
                    <a:pt x="95999" y="12192"/>
                  </a:lnTo>
                  <a:lnTo>
                    <a:pt x="95999" y="13716"/>
                  </a:lnTo>
                  <a:lnTo>
                    <a:pt x="94475" y="13716"/>
                  </a:lnTo>
                  <a:lnTo>
                    <a:pt x="92951" y="15252"/>
                  </a:lnTo>
                  <a:lnTo>
                    <a:pt x="91427" y="15252"/>
                  </a:lnTo>
                  <a:lnTo>
                    <a:pt x="91427" y="16764"/>
                  </a:lnTo>
                  <a:lnTo>
                    <a:pt x="89903" y="18288"/>
                  </a:lnTo>
                  <a:lnTo>
                    <a:pt x="88379" y="18288"/>
                  </a:lnTo>
                  <a:lnTo>
                    <a:pt x="86855" y="19812"/>
                  </a:lnTo>
                  <a:lnTo>
                    <a:pt x="85331" y="19812"/>
                  </a:lnTo>
                  <a:lnTo>
                    <a:pt x="85331" y="21336"/>
                  </a:lnTo>
                  <a:lnTo>
                    <a:pt x="83807" y="22860"/>
                  </a:lnTo>
                  <a:lnTo>
                    <a:pt x="82283" y="22860"/>
                  </a:lnTo>
                  <a:lnTo>
                    <a:pt x="80759" y="24384"/>
                  </a:lnTo>
                  <a:lnTo>
                    <a:pt x="79235" y="24384"/>
                  </a:lnTo>
                  <a:lnTo>
                    <a:pt x="76187" y="27432"/>
                  </a:lnTo>
                  <a:lnTo>
                    <a:pt x="74663" y="27432"/>
                  </a:lnTo>
                  <a:lnTo>
                    <a:pt x="70091" y="32004"/>
                  </a:lnTo>
                  <a:lnTo>
                    <a:pt x="68567" y="32004"/>
                  </a:lnTo>
                  <a:lnTo>
                    <a:pt x="67055" y="33528"/>
                  </a:lnTo>
                  <a:lnTo>
                    <a:pt x="65519" y="33528"/>
                  </a:lnTo>
                  <a:lnTo>
                    <a:pt x="65519" y="35052"/>
                  </a:lnTo>
                  <a:lnTo>
                    <a:pt x="63995" y="35052"/>
                  </a:lnTo>
                  <a:lnTo>
                    <a:pt x="60959" y="38100"/>
                  </a:lnTo>
                  <a:lnTo>
                    <a:pt x="59423" y="38100"/>
                  </a:lnTo>
                  <a:lnTo>
                    <a:pt x="59423" y="39611"/>
                  </a:lnTo>
                  <a:lnTo>
                    <a:pt x="57899" y="39611"/>
                  </a:lnTo>
                  <a:lnTo>
                    <a:pt x="54863" y="42672"/>
                  </a:lnTo>
                  <a:lnTo>
                    <a:pt x="51803" y="44196"/>
                  </a:lnTo>
                  <a:lnTo>
                    <a:pt x="50291" y="45720"/>
                  </a:lnTo>
                  <a:lnTo>
                    <a:pt x="48767" y="45720"/>
                  </a:lnTo>
                  <a:lnTo>
                    <a:pt x="47243" y="47244"/>
                  </a:lnTo>
                  <a:lnTo>
                    <a:pt x="47243" y="48768"/>
                  </a:lnTo>
                  <a:lnTo>
                    <a:pt x="45719" y="48768"/>
                  </a:lnTo>
                  <a:lnTo>
                    <a:pt x="41147" y="53340"/>
                  </a:lnTo>
                  <a:lnTo>
                    <a:pt x="39623" y="53340"/>
                  </a:lnTo>
                  <a:lnTo>
                    <a:pt x="39623" y="54864"/>
                  </a:lnTo>
                  <a:lnTo>
                    <a:pt x="38099" y="54864"/>
                  </a:lnTo>
                  <a:lnTo>
                    <a:pt x="33527" y="59436"/>
                  </a:lnTo>
                  <a:lnTo>
                    <a:pt x="32003" y="59436"/>
                  </a:lnTo>
                  <a:lnTo>
                    <a:pt x="32003" y="60947"/>
                  </a:lnTo>
                  <a:lnTo>
                    <a:pt x="30479" y="60947"/>
                  </a:lnTo>
                  <a:lnTo>
                    <a:pt x="28955" y="62471"/>
                  </a:lnTo>
                  <a:lnTo>
                    <a:pt x="28955" y="63995"/>
                  </a:lnTo>
                  <a:lnTo>
                    <a:pt x="27431" y="63995"/>
                  </a:lnTo>
                  <a:lnTo>
                    <a:pt x="24383" y="67056"/>
                  </a:lnTo>
                  <a:lnTo>
                    <a:pt x="24383" y="68580"/>
                  </a:lnTo>
                  <a:lnTo>
                    <a:pt x="22859" y="68580"/>
                  </a:lnTo>
                  <a:lnTo>
                    <a:pt x="18287" y="73139"/>
                  </a:lnTo>
                  <a:lnTo>
                    <a:pt x="18287" y="74663"/>
                  </a:lnTo>
                  <a:lnTo>
                    <a:pt x="16763" y="74663"/>
                  </a:lnTo>
                  <a:lnTo>
                    <a:pt x="16763" y="76187"/>
                  </a:lnTo>
                  <a:lnTo>
                    <a:pt x="15239" y="76187"/>
                  </a:lnTo>
                  <a:lnTo>
                    <a:pt x="15239" y="77711"/>
                  </a:lnTo>
                  <a:lnTo>
                    <a:pt x="13715" y="77711"/>
                  </a:lnTo>
                  <a:lnTo>
                    <a:pt x="13715" y="79248"/>
                  </a:lnTo>
                  <a:lnTo>
                    <a:pt x="12191" y="80772"/>
                  </a:lnTo>
                  <a:lnTo>
                    <a:pt x="12191" y="82283"/>
                  </a:lnTo>
                  <a:lnTo>
                    <a:pt x="10667" y="82283"/>
                  </a:lnTo>
                  <a:lnTo>
                    <a:pt x="10667" y="83807"/>
                  </a:lnTo>
                  <a:lnTo>
                    <a:pt x="9143" y="85331"/>
                  </a:lnTo>
                  <a:lnTo>
                    <a:pt x="9143" y="86855"/>
                  </a:lnTo>
                  <a:lnTo>
                    <a:pt x="6095" y="89903"/>
                  </a:lnTo>
                  <a:lnTo>
                    <a:pt x="6095" y="92951"/>
                  </a:lnTo>
                  <a:lnTo>
                    <a:pt x="4584" y="92951"/>
                  </a:lnTo>
                  <a:lnTo>
                    <a:pt x="4584" y="95999"/>
                  </a:lnTo>
                  <a:lnTo>
                    <a:pt x="3047" y="95999"/>
                  </a:lnTo>
                  <a:lnTo>
                    <a:pt x="3047" y="99047"/>
                  </a:lnTo>
                  <a:lnTo>
                    <a:pt x="1523" y="100571"/>
                  </a:lnTo>
                  <a:lnTo>
                    <a:pt x="1523" y="108191"/>
                  </a:lnTo>
                  <a:lnTo>
                    <a:pt x="0" y="108191"/>
                  </a:lnTo>
                  <a:lnTo>
                    <a:pt x="0" y="127990"/>
                  </a:lnTo>
                  <a:lnTo>
                    <a:pt x="1523" y="127990"/>
                  </a:lnTo>
                  <a:lnTo>
                    <a:pt x="1523" y="137147"/>
                  </a:lnTo>
                  <a:lnTo>
                    <a:pt x="3047" y="138658"/>
                  </a:lnTo>
                  <a:lnTo>
                    <a:pt x="3047" y="141719"/>
                  </a:lnTo>
                  <a:lnTo>
                    <a:pt x="4584" y="143243"/>
                  </a:lnTo>
                  <a:lnTo>
                    <a:pt x="4584" y="147815"/>
                  </a:lnTo>
                  <a:lnTo>
                    <a:pt x="6095" y="149326"/>
                  </a:lnTo>
                  <a:lnTo>
                    <a:pt x="6095" y="153911"/>
                  </a:lnTo>
                  <a:lnTo>
                    <a:pt x="7619" y="155435"/>
                  </a:lnTo>
                  <a:lnTo>
                    <a:pt x="7619" y="158483"/>
                  </a:lnTo>
                  <a:lnTo>
                    <a:pt x="9143" y="158483"/>
                  </a:lnTo>
                  <a:lnTo>
                    <a:pt x="9143" y="163042"/>
                  </a:lnTo>
                  <a:lnTo>
                    <a:pt x="10667" y="164566"/>
                  </a:lnTo>
                  <a:lnTo>
                    <a:pt x="10667" y="167627"/>
                  </a:lnTo>
                  <a:lnTo>
                    <a:pt x="12191" y="169151"/>
                  </a:lnTo>
                  <a:lnTo>
                    <a:pt x="12191" y="170662"/>
                  </a:lnTo>
                  <a:lnTo>
                    <a:pt x="13715" y="172186"/>
                  </a:lnTo>
                  <a:lnTo>
                    <a:pt x="13715" y="175234"/>
                  </a:lnTo>
                  <a:lnTo>
                    <a:pt x="15239" y="176758"/>
                  </a:lnTo>
                  <a:lnTo>
                    <a:pt x="15239" y="179819"/>
                  </a:lnTo>
                  <a:lnTo>
                    <a:pt x="16763" y="179819"/>
                  </a:lnTo>
                  <a:lnTo>
                    <a:pt x="16763" y="184378"/>
                  </a:lnTo>
                  <a:lnTo>
                    <a:pt x="18287" y="184378"/>
                  </a:lnTo>
                  <a:lnTo>
                    <a:pt x="18287" y="185902"/>
                  </a:lnTo>
                  <a:lnTo>
                    <a:pt x="19811" y="187426"/>
                  </a:lnTo>
                  <a:lnTo>
                    <a:pt x="19811" y="190474"/>
                  </a:lnTo>
                  <a:lnTo>
                    <a:pt x="21335" y="191998"/>
                  </a:lnTo>
                  <a:lnTo>
                    <a:pt x="21335" y="195046"/>
                  </a:lnTo>
                  <a:lnTo>
                    <a:pt x="22859" y="195046"/>
                  </a:lnTo>
                  <a:lnTo>
                    <a:pt x="22859" y="196570"/>
                  </a:lnTo>
                  <a:lnTo>
                    <a:pt x="24383" y="198094"/>
                  </a:lnTo>
                  <a:lnTo>
                    <a:pt x="24383" y="201142"/>
                  </a:lnTo>
                  <a:lnTo>
                    <a:pt x="25907" y="201142"/>
                  </a:lnTo>
                  <a:lnTo>
                    <a:pt x="25907" y="204190"/>
                  </a:lnTo>
                  <a:lnTo>
                    <a:pt x="28955" y="207238"/>
                  </a:lnTo>
                  <a:lnTo>
                    <a:pt x="28955" y="210286"/>
                  </a:lnTo>
                  <a:lnTo>
                    <a:pt x="30479" y="210286"/>
                  </a:lnTo>
                  <a:lnTo>
                    <a:pt x="30479" y="213334"/>
                  </a:lnTo>
                  <a:lnTo>
                    <a:pt x="32003" y="214845"/>
                  </a:lnTo>
                  <a:lnTo>
                    <a:pt x="32003" y="216369"/>
                  </a:lnTo>
                  <a:lnTo>
                    <a:pt x="33527" y="216369"/>
                  </a:lnTo>
                  <a:lnTo>
                    <a:pt x="33527" y="217906"/>
                  </a:lnTo>
                  <a:lnTo>
                    <a:pt x="35051" y="219430"/>
                  </a:lnTo>
                  <a:lnTo>
                    <a:pt x="35051" y="220954"/>
                  </a:lnTo>
                  <a:lnTo>
                    <a:pt x="36575" y="222478"/>
                  </a:lnTo>
                  <a:lnTo>
                    <a:pt x="36575" y="224002"/>
                  </a:lnTo>
                  <a:lnTo>
                    <a:pt x="38099" y="225513"/>
                  </a:lnTo>
                  <a:lnTo>
                    <a:pt x="38099" y="227037"/>
                  </a:lnTo>
                  <a:lnTo>
                    <a:pt x="39623" y="227037"/>
                  </a:lnTo>
                  <a:lnTo>
                    <a:pt x="39623" y="228561"/>
                  </a:lnTo>
                  <a:lnTo>
                    <a:pt x="41147" y="230098"/>
                  </a:lnTo>
                  <a:lnTo>
                    <a:pt x="41147" y="231622"/>
                  </a:lnTo>
                  <a:lnTo>
                    <a:pt x="42671" y="231622"/>
                  </a:lnTo>
                  <a:lnTo>
                    <a:pt x="42671" y="233146"/>
                  </a:lnTo>
                  <a:lnTo>
                    <a:pt x="44195" y="234670"/>
                  </a:lnTo>
                  <a:lnTo>
                    <a:pt x="44195" y="236181"/>
                  </a:lnTo>
                  <a:lnTo>
                    <a:pt x="45719" y="236181"/>
                  </a:lnTo>
                  <a:lnTo>
                    <a:pt x="45719" y="239229"/>
                  </a:lnTo>
                  <a:lnTo>
                    <a:pt x="47243" y="240753"/>
                  </a:lnTo>
                  <a:lnTo>
                    <a:pt x="47243" y="242290"/>
                  </a:lnTo>
                  <a:lnTo>
                    <a:pt x="50291" y="245338"/>
                  </a:lnTo>
                  <a:lnTo>
                    <a:pt x="50291" y="246862"/>
                  </a:lnTo>
                  <a:lnTo>
                    <a:pt x="51803" y="246862"/>
                  </a:lnTo>
                  <a:lnTo>
                    <a:pt x="51803" y="249897"/>
                  </a:lnTo>
                  <a:lnTo>
                    <a:pt x="53327" y="249897"/>
                  </a:lnTo>
                  <a:lnTo>
                    <a:pt x="53327" y="251421"/>
                  </a:lnTo>
                  <a:lnTo>
                    <a:pt x="54863" y="251421"/>
                  </a:lnTo>
                  <a:lnTo>
                    <a:pt x="54863" y="254469"/>
                  </a:lnTo>
                  <a:lnTo>
                    <a:pt x="56387" y="254469"/>
                  </a:lnTo>
                  <a:lnTo>
                    <a:pt x="56387" y="256006"/>
                  </a:lnTo>
                  <a:lnTo>
                    <a:pt x="57899" y="257530"/>
                  </a:lnTo>
                  <a:lnTo>
                    <a:pt x="57899" y="259041"/>
                  </a:lnTo>
                  <a:lnTo>
                    <a:pt x="59423" y="259041"/>
                  </a:lnTo>
                  <a:lnTo>
                    <a:pt x="59423" y="260565"/>
                  </a:lnTo>
                  <a:lnTo>
                    <a:pt x="60959" y="262089"/>
                  </a:lnTo>
                  <a:lnTo>
                    <a:pt x="60959" y="263613"/>
                  </a:lnTo>
                  <a:lnTo>
                    <a:pt x="62471" y="265137"/>
                  </a:lnTo>
                  <a:lnTo>
                    <a:pt x="62471" y="266661"/>
                  </a:lnTo>
                  <a:lnTo>
                    <a:pt x="63995" y="266661"/>
                  </a:lnTo>
                  <a:lnTo>
                    <a:pt x="63995" y="268198"/>
                  </a:lnTo>
                  <a:lnTo>
                    <a:pt x="65519" y="268198"/>
                  </a:lnTo>
                  <a:lnTo>
                    <a:pt x="65519" y="271233"/>
                  </a:lnTo>
                  <a:lnTo>
                    <a:pt x="67055" y="271233"/>
                  </a:lnTo>
                  <a:lnTo>
                    <a:pt x="67055" y="272757"/>
                  </a:lnTo>
                  <a:lnTo>
                    <a:pt x="71615" y="277329"/>
                  </a:lnTo>
                  <a:lnTo>
                    <a:pt x="71615" y="278853"/>
                  </a:lnTo>
                  <a:lnTo>
                    <a:pt x="74663" y="281901"/>
                  </a:lnTo>
                  <a:lnTo>
                    <a:pt x="74663" y="283425"/>
                  </a:lnTo>
                  <a:lnTo>
                    <a:pt x="76187" y="284949"/>
                  </a:lnTo>
                  <a:lnTo>
                    <a:pt x="76187" y="286473"/>
                  </a:lnTo>
                  <a:lnTo>
                    <a:pt x="77711" y="286473"/>
                  </a:lnTo>
                  <a:lnTo>
                    <a:pt x="77711" y="289521"/>
                  </a:lnTo>
                  <a:lnTo>
                    <a:pt x="79235" y="289521"/>
                  </a:lnTo>
                  <a:lnTo>
                    <a:pt x="79235" y="291033"/>
                  </a:lnTo>
                  <a:lnTo>
                    <a:pt x="80759" y="291033"/>
                  </a:lnTo>
                  <a:lnTo>
                    <a:pt x="80759" y="294093"/>
                  </a:lnTo>
                  <a:lnTo>
                    <a:pt x="82283" y="294093"/>
                  </a:lnTo>
                  <a:lnTo>
                    <a:pt x="82283" y="295617"/>
                  </a:lnTo>
                  <a:lnTo>
                    <a:pt x="85331" y="298665"/>
                  </a:lnTo>
                  <a:lnTo>
                    <a:pt x="85331" y="301701"/>
                  </a:lnTo>
                  <a:lnTo>
                    <a:pt x="86855" y="301701"/>
                  </a:lnTo>
                  <a:lnTo>
                    <a:pt x="86855" y="304749"/>
                  </a:lnTo>
                  <a:lnTo>
                    <a:pt x="88379" y="304749"/>
                  </a:lnTo>
                  <a:lnTo>
                    <a:pt x="88379" y="306285"/>
                  </a:lnTo>
                  <a:lnTo>
                    <a:pt x="89903" y="306285"/>
                  </a:lnTo>
                  <a:lnTo>
                    <a:pt x="89903" y="309333"/>
                  </a:lnTo>
                  <a:lnTo>
                    <a:pt x="91427" y="309333"/>
                  </a:lnTo>
                  <a:lnTo>
                    <a:pt x="91427" y="310857"/>
                  </a:lnTo>
                  <a:lnTo>
                    <a:pt x="92951" y="312369"/>
                  </a:lnTo>
                  <a:lnTo>
                    <a:pt x="92951" y="313893"/>
                  </a:lnTo>
                  <a:lnTo>
                    <a:pt x="94475" y="315417"/>
                  </a:lnTo>
                  <a:lnTo>
                    <a:pt x="94475" y="316941"/>
                  </a:lnTo>
                  <a:lnTo>
                    <a:pt x="95999" y="316941"/>
                  </a:lnTo>
                  <a:lnTo>
                    <a:pt x="95999" y="318477"/>
                  </a:lnTo>
                  <a:lnTo>
                    <a:pt x="97523" y="320001"/>
                  </a:lnTo>
                  <a:lnTo>
                    <a:pt x="97523" y="321525"/>
                  </a:lnTo>
                  <a:lnTo>
                    <a:pt x="99047" y="323037"/>
                  </a:lnTo>
                  <a:lnTo>
                    <a:pt x="99047" y="324561"/>
                  </a:lnTo>
                  <a:lnTo>
                    <a:pt x="100571" y="324561"/>
                  </a:lnTo>
                  <a:lnTo>
                    <a:pt x="100571" y="326085"/>
                  </a:lnTo>
                  <a:lnTo>
                    <a:pt x="102095" y="327609"/>
                  </a:lnTo>
                  <a:lnTo>
                    <a:pt x="102095" y="330657"/>
                  </a:lnTo>
                  <a:lnTo>
                    <a:pt x="103606" y="330657"/>
                  </a:lnTo>
                  <a:lnTo>
                    <a:pt x="103606" y="332193"/>
                  </a:lnTo>
                  <a:lnTo>
                    <a:pt x="105143" y="333717"/>
                  </a:lnTo>
                  <a:lnTo>
                    <a:pt x="105143" y="335229"/>
                  </a:lnTo>
                  <a:lnTo>
                    <a:pt x="106667" y="336753"/>
                  </a:lnTo>
                  <a:lnTo>
                    <a:pt x="106667" y="339801"/>
                  </a:lnTo>
                  <a:lnTo>
                    <a:pt x="108191" y="341325"/>
                  </a:lnTo>
                  <a:lnTo>
                    <a:pt x="108191" y="344385"/>
                  </a:lnTo>
                  <a:lnTo>
                    <a:pt x="109702" y="344385"/>
                  </a:lnTo>
                  <a:lnTo>
                    <a:pt x="109702" y="345897"/>
                  </a:lnTo>
                  <a:lnTo>
                    <a:pt x="111239" y="347421"/>
                  </a:lnTo>
                  <a:lnTo>
                    <a:pt x="111239" y="350469"/>
                  </a:lnTo>
                  <a:lnTo>
                    <a:pt x="112763" y="351993"/>
                  </a:lnTo>
                  <a:lnTo>
                    <a:pt x="112763" y="355041"/>
                  </a:lnTo>
                  <a:lnTo>
                    <a:pt x="114274" y="356577"/>
                  </a:lnTo>
                  <a:lnTo>
                    <a:pt x="114274" y="359613"/>
                  </a:lnTo>
                  <a:lnTo>
                    <a:pt x="115798" y="359613"/>
                  </a:lnTo>
                  <a:lnTo>
                    <a:pt x="115798" y="364185"/>
                  </a:lnTo>
                  <a:lnTo>
                    <a:pt x="117335" y="364185"/>
                  </a:lnTo>
                  <a:lnTo>
                    <a:pt x="117335" y="370281"/>
                  </a:lnTo>
                  <a:lnTo>
                    <a:pt x="118859" y="370281"/>
                  </a:lnTo>
                  <a:lnTo>
                    <a:pt x="118859" y="374853"/>
                  </a:lnTo>
                  <a:lnTo>
                    <a:pt x="120370" y="376377"/>
                  </a:lnTo>
                  <a:lnTo>
                    <a:pt x="120370" y="382473"/>
                  </a:lnTo>
                  <a:lnTo>
                    <a:pt x="121894" y="383997"/>
                  </a:lnTo>
                  <a:lnTo>
                    <a:pt x="121894" y="393128"/>
                  </a:lnTo>
                  <a:lnTo>
                    <a:pt x="123431" y="394665"/>
                  </a:lnTo>
                  <a:lnTo>
                    <a:pt x="123431" y="402272"/>
                  </a:lnTo>
                  <a:lnTo>
                    <a:pt x="124942" y="403796"/>
                  </a:lnTo>
                  <a:lnTo>
                    <a:pt x="124942" y="408381"/>
                  </a:lnTo>
                  <a:lnTo>
                    <a:pt x="126466" y="409905"/>
                  </a:lnTo>
                  <a:lnTo>
                    <a:pt x="126466" y="417512"/>
                  </a:lnTo>
                  <a:lnTo>
                    <a:pt x="127990" y="419036"/>
                  </a:lnTo>
                  <a:lnTo>
                    <a:pt x="127990" y="425132"/>
                  </a:lnTo>
                  <a:lnTo>
                    <a:pt x="129514" y="426656"/>
                  </a:lnTo>
                  <a:lnTo>
                    <a:pt x="129514" y="431228"/>
                  </a:lnTo>
                  <a:lnTo>
                    <a:pt x="131038" y="431228"/>
                  </a:lnTo>
                  <a:lnTo>
                    <a:pt x="131038" y="437324"/>
                  </a:lnTo>
                  <a:lnTo>
                    <a:pt x="132562" y="437324"/>
                  </a:lnTo>
                  <a:lnTo>
                    <a:pt x="132562" y="443420"/>
                  </a:lnTo>
                  <a:lnTo>
                    <a:pt x="134086" y="444944"/>
                  </a:lnTo>
                  <a:lnTo>
                    <a:pt x="134086" y="447992"/>
                  </a:lnTo>
                  <a:lnTo>
                    <a:pt x="135610" y="449516"/>
                  </a:lnTo>
                  <a:lnTo>
                    <a:pt x="135610" y="451040"/>
                  </a:lnTo>
                  <a:lnTo>
                    <a:pt x="176745" y="451040"/>
                  </a:lnTo>
                  <a:lnTo>
                    <a:pt x="178269" y="449516"/>
                  </a:lnTo>
                  <a:lnTo>
                    <a:pt x="178269" y="444944"/>
                  </a:lnTo>
                  <a:lnTo>
                    <a:pt x="179793" y="443420"/>
                  </a:lnTo>
                  <a:lnTo>
                    <a:pt x="179793" y="440372"/>
                  </a:lnTo>
                  <a:lnTo>
                    <a:pt x="181317" y="440372"/>
                  </a:lnTo>
                  <a:lnTo>
                    <a:pt x="181317" y="432752"/>
                  </a:lnTo>
                  <a:lnTo>
                    <a:pt x="182841" y="432752"/>
                  </a:lnTo>
                  <a:lnTo>
                    <a:pt x="182841" y="426656"/>
                  </a:lnTo>
                  <a:lnTo>
                    <a:pt x="184365" y="426656"/>
                  </a:lnTo>
                  <a:lnTo>
                    <a:pt x="184365" y="419036"/>
                  </a:lnTo>
                  <a:lnTo>
                    <a:pt x="185889" y="417512"/>
                  </a:lnTo>
                  <a:lnTo>
                    <a:pt x="185889" y="412940"/>
                  </a:lnTo>
                  <a:lnTo>
                    <a:pt x="187413" y="412940"/>
                  </a:lnTo>
                  <a:lnTo>
                    <a:pt x="187413" y="403796"/>
                  </a:lnTo>
                  <a:lnTo>
                    <a:pt x="188937" y="402272"/>
                  </a:lnTo>
                  <a:lnTo>
                    <a:pt x="188937" y="394665"/>
                  </a:lnTo>
                  <a:lnTo>
                    <a:pt x="190461" y="393128"/>
                  </a:lnTo>
                  <a:lnTo>
                    <a:pt x="190461" y="387045"/>
                  </a:lnTo>
                  <a:lnTo>
                    <a:pt x="191985" y="387045"/>
                  </a:lnTo>
                  <a:lnTo>
                    <a:pt x="191985" y="379412"/>
                  </a:lnTo>
                  <a:lnTo>
                    <a:pt x="193509" y="377901"/>
                  </a:lnTo>
                  <a:lnTo>
                    <a:pt x="193509" y="371805"/>
                  </a:lnTo>
                  <a:lnTo>
                    <a:pt x="195033" y="370281"/>
                  </a:lnTo>
                  <a:lnTo>
                    <a:pt x="195033" y="367233"/>
                  </a:lnTo>
                  <a:lnTo>
                    <a:pt x="196557" y="367233"/>
                  </a:lnTo>
                  <a:lnTo>
                    <a:pt x="196557" y="361137"/>
                  </a:lnTo>
                  <a:lnTo>
                    <a:pt x="198081" y="361137"/>
                  </a:lnTo>
                  <a:lnTo>
                    <a:pt x="198081" y="356577"/>
                  </a:lnTo>
                  <a:lnTo>
                    <a:pt x="199605" y="355041"/>
                  </a:lnTo>
                  <a:lnTo>
                    <a:pt x="199605" y="351993"/>
                  </a:lnTo>
                  <a:lnTo>
                    <a:pt x="201129" y="350469"/>
                  </a:lnTo>
                  <a:lnTo>
                    <a:pt x="201129" y="348945"/>
                  </a:lnTo>
                  <a:lnTo>
                    <a:pt x="202653" y="347421"/>
                  </a:lnTo>
                  <a:lnTo>
                    <a:pt x="202653" y="344385"/>
                  </a:lnTo>
                  <a:lnTo>
                    <a:pt x="204177" y="344385"/>
                  </a:lnTo>
                  <a:lnTo>
                    <a:pt x="204177" y="341325"/>
                  </a:lnTo>
                  <a:lnTo>
                    <a:pt x="205701" y="339801"/>
                  </a:lnTo>
                  <a:lnTo>
                    <a:pt x="205701" y="338277"/>
                  </a:lnTo>
                  <a:lnTo>
                    <a:pt x="207225" y="336753"/>
                  </a:lnTo>
                  <a:lnTo>
                    <a:pt x="207225" y="335229"/>
                  </a:lnTo>
                  <a:lnTo>
                    <a:pt x="208749" y="333717"/>
                  </a:lnTo>
                  <a:lnTo>
                    <a:pt x="208749" y="330657"/>
                  </a:lnTo>
                  <a:lnTo>
                    <a:pt x="210273" y="330657"/>
                  </a:lnTo>
                  <a:lnTo>
                    <a:pt x="210273" y="329133"/>
                  </a:lnTo>
                  <a:lnTo>
                    <a:pt x="211797" y="329133"/>
                  </a:lnTo>
                  <a:lnTo>
                    <a:pt x="211797" y="326085"/>
                  </a:lnTo>
                  <a:lnTo>
                    <a:pt x="213321" y="324561"/>
                  </a:lnTo>
                  <a:lnTo>
                    <a:pt x="213321" y="323037"/>
                  </a:lnTo>
                  <a:lnTo>
                    <a:pt x="214845" y="321525"/>
                  </a:lnTo>
                  <a:lnTo>
                    <a:pt x="214845" y="320001"/>
                  </a:lnTo>
                  <a:lnTo>
                    <a:pt x="217893" y="316941"/>
                  </a:lnTo>
                  <a:lnTo>
                    <a:pt x="217893" y="315417"/>
                  </a:lnTo>
                  <a:lnTo>
                    <a:pt x="219417" y="313893"/>
                  </a:lnTo>
                  <a:lnTo>
                    <a:pt x="219417" y="312369"/>
                  </a:lnTo>
                  <a:lnTo>
                    <a:pt x="222465" y="309333"/>
                  </a:lnTo>
                  <a:lnTo>
                    <a:pt x="222465" y="307809"/>
                  </a:lnTo>
                  <a:lnTo>
                    <a:pt x="223977" y="306285"/>
                  </a:lnTo>
                  <a:lnTo>
                    <a:pt x="223977" y="304749"/>
                  </a:lnTo>
                  <a:lnTo>
                    <a:pt x="225513" y="304749"/>
                  </a:lnTo>
                  <a:lnTo>
                    <a:pt x="225513" y="303225"/>
                  </a:lnTo>
                  <a:lnTo>
                    <a:pt x="227037" y="301701"/>
                  </a:lnTo>
                  <a:lnTo>
                    <a:pt x="227037" y="300189"/>
                  </a:lnTo>
                  <a:lnTo>
                    <a:pt x="228549" y="300189"/>
                  </a:lnTo>
                  <a:lnTo>
                    <a:pt x="228549" y="297141"/>
                  </a:lnTo>
                  <a:lnTo>
                    <a:pt x="233121" y="292557"/>
                  </a:lnTo>
                  <a:lnTo>
                    <a:pt x="233121" y="289521"/>
                  </a:lnTo>
                  <a:lnTo>
                    <a:pt x="234645" y="289521"/>
                  </a:lnTo>
                  <a:lnTo>
                    <a:pt x="234645" y="287997"/>
                  </a:lnTo>
                  <a:lnTo>
                    <a:pt x="237705" y="284949"/>
                  </a:lnTo>
                  <a:lnTo>
                    <a:pt x="237705" y="281901"/>
                  </a:lnTo>
                  <a:lnTo>
                    <a:pt x="239217" y="281901"/>
                  </a:lnTo>
                  <a:lnTo>
                    <a:pt x="239217" y="280377"/>
                  </a:lnTo>
                  <a:lnTo>
                    <a:pt x="240741" y="280377"/>
                  </a:lnTo>
                  <a:lnTo>
                    <a:pt x="240741" y="278853"/>
                  </a:lnTo>
                  <a:lnTo>
                    <a:pt x="242265" y="278853"/>
                  </a:lnTo>
                  <a:lnTo>
                    <a:pt x="242265" y="275805"/>
                  </a:lnTo>
                  <a:lnTo>
                    <a:pt x="243789" y="275805"/>
                  </a:lnTo>
                  <a:lnTo>
                    <a:pt x="243789" y="274281"/>
                  </a:lnTo>
                  <a:lnTo>
                    <a:pt x="245313" y="272757"/>
                  </a:lnTo>
                  <a:lnTo>
                    <a:pt x="245313" y="271233"/>
                  </a:lnTo>
                  <a:lnTo>
                    <a:pt x="246837" y="271233"/>
                  </a:lnTo>
                  <a:lnTo>
                    <a:pt x="246837" y="269709"/>
                  </a:lnTo>
                  <a:lnTo>
                    <a:pt x="248361" y="268198"/>
                  </a:lnTo>
                  <a:lnTo>
                    <a:pt x="248361" y="266661"/>
                  </a:lnTo>
                  <a:lnTo>
                    <a:pt x="249885" y="266661"/>
                  </a:lnTo>
                  <a:lnTo>
                    <a:pt x="249885" y="265137"/>
                  </a:lnTo>
                  <a:lnTo>
                    <a:pt x="251409" y="263613"/>
                  </a:lnTo>
                  <a:lnTo>
                    <a:pt x="251409" y="262089"/>
                  </a:lnTo>
                  <a:lnTo>
                    <a:pt x="252933" y="262089"/>
                  </a:lnTo>
                  <a:lnTo>
                    <a:pt x="252933" y="260565"/>
                  </a:lnTo>
                  <a:lnTo>
                    <a:pt x="254457" y="259041"/>
                  </a:lnTo>
                  <a:lnTo>
                    <a:pt x="254457" y="257530"/>
                  </a:lnTo>
                  <a:lnTo>
                    <a:pt x="257505" y="254469"/>
                  </a:lnTo>
                  <a:lnTo>
                    <a:pt x="257505" y="252945"/>
                  </a:lnTo>
                  <a:lnTo>
                    <a:pt x="259029" y="251421"/>
                  </a:lnTo>
                  <a:lnTo>
                    <a:pt x="259029" y="249897"/>
                  </a:lnTo>
                  <a:lnTo>
                    <a:pt x="260553" y="249897"/>
                  </a:lnTo>
                  <a:lnTo>
                    <a:pt x="260553" y="246862"/>
                  </a:lnTo>
                  <a:lnTo>
                    <a:pt x="262077" y="246862"/>
                  </a:lnTo>
                  <a:lnTo>
                    <a:pt x="262077" y="245338"/>
                  </a:lnTo>
                  <a:lnTo>
                    <a:pt x="263601" y="245338"/>
                  </a:lnTo>
                  <a:lnTo>
                    <a:pt x="263601" y="243814"/>
                  </a:lnTo>
                  <a:lnTo>
                    <a:pt x="265125" y="242290"/>
                  </a:lnTo>
                  <a:lnTo>
                    <a:pt x="265125" y="240753"/>
                  </a:lnTo>
                  <a:lnTo>
                    <a:pt x="268173" y="237705"/>
                  </a:lnTo>
                  <a:lnTo>
                    <a:pt x="268173" y="234670"/>
                  </a:lnTo>
                  <a:lnTo>
                    <a:pt x="269697" y="234670"/>
                  </a:lnTo>
                  <a:lnTo>
                    <a:pt x="269697" y="231622"/>
                  </a:lnTo>
                  <a:lnTo>
                    <a:pt x="271221" y="231622"/>
                  </a:lnTo>
                  <a:lnTo>
                    <a:pt x="271221" y="230098"/>
                  </a:lnTo>
                  <a:lnTo>
                    <a:pt x="272745" y="230098"/>
                  </a:lnTo>
                  <a:lnTo>
                    <a:pt x="272745" y="228561"/>
                  </a:lnTo>
                  <a:lnTo>
                    <a:pt x="274256" y="227037"/>
                  </a:lnTo>
                  <a:lnTo>
                    <a:pt x="274256" y="225513"/>
                  </a:lnTo>
                  <a:lnTo>
                    <a:pt x="275793" y="224002"/>
                  </a:lnTo>
                  <a:lnTo>
                    <a:pt x="275793" y="222478"/>
                  </a:lnTo>
                  <a:lnTo>
                    <a:pt x="278841" y="219430"/>
                  </a:lnTo>
                  <a:lnTo>
                    <a:pt x="278841" y="217906"/>
                  </a:lnTo>
                  <a:lnTo>
                    <a:pt x="280352" y="216369"/>
                  </a:lnTo>
                  <a:lnTo>
                    <a:pt x="280352" y="214845"/>
                  </a:lnTo>
                  <a:lnTo>
                    <a:pt x="281889" y="213334"/>
                  </a:lnTo>
                  <a:lnTo>
                    <a:pt x="281889" y="211810"/>
                  </a:lnTo>
                  <a:lnTo>
                    <a:pt x="283413" y="211810"/>
                  </a:lnTo>
                  <a:lnTo>
                    <a:pt x="283413" y="208762"/>
                  </a:lnTo>
                  <a:lnTo>
                    <a:pt x="284924" y="208762"/>
                  </a:lnTo>
                  <a:lnTo>
                    <a:pt x="284924" y="205714"/>
                  </a:lnTo>
                  <a:lnTo>
                    <a:pt x="286448" y="204190"/>
                  </a:lnTo>
                  <a:lnTo>
                    <a:pt x="286448" y="202653"/>
                  </a:lnTo>
                  <a:lnTo>
                    <a:pt x="287985" y="201142"/>
                  </a:lnTo>
                  <a:lnTo>
                    <a:pt x="287985" y="199618"/>
                  </a:lnTo>
                  <a:lnTo>
                    <a:pt x="289509" y="198094"/>
                  </a:lnTo>
                  <a:lnTo>
                    <a:pt x="289509" y="195046"/>
                  </a:lnTo>
                  <a:lnTo>
                    <a:pt x="291020" y="195046"/>
                  </a:lnTo>
                  <a:lnTo>
                    <a:pt x="291020" y="191998"/>
                  </a:lnTo>
                  <a:lnTo>
                    <a:pt x="292544" y="190474"/>
                  </a:lnTo>
                  <a:lnTo>
                    <a:pt x="292544" y="188950"/>
                  </a:lnTo>
                  <a:lnTo>
                    <a:pt x="294081" y="188950"/>
                  </a:lnTo>
                  <a:lnTo>
                    <a:pt x="294081" y="184378"/>
                  </a:lnTo>
                  <a:lnTo>
                    <a:pt x="295592" y="184378"/>
                  </a:lnTo>
                  <a:lnTo>
                    <a:pt x="295592" y="181330"/>
                  </a:lnTo>
                  <a:lnTo>
                    <a:pt x="297116" y="179819"/>
                  </a:lnTo>
                  <a:lnTo>
                    <a:pt x="297116" y="178282"/>
                  </a:lnTo>
                  <a:lnTo>
                    <a:pt x="298640" y="176758"/>
                  </a:lnTo>
                  <a:lnTo>
                    <a:pt x="298640" y="173710"/>
                  </a:lnTo>
                  <a:lnTo>
                    <a:pt x="300164" y="172186"/>
                  </a:lnTo>
                  <a:lnTo>
                    <a:pt x="300164" y="169151"/>
                  </a:lnTo>
                  <a:lnTo>
                    <a:pt x="301688" y="167627"/>
                  </a:lnTo>
                  <a:lnTo>
                    <a:pt x="301688" y="166090"/>
                  </a:lnTo>
                  <a:lnTo>
                    <a:pt x="303212" y="164566"/>
                  </a:lnTo>
                  <a:lnTo>
                    <a:pt x="303212" y="159994"/>
                  </a:lnTo>
                  <a:lnTo>
                    <a:pt x="304736" y="159994"/>
                  </a:lnTo>
                  <a:lnTo>
                    <a:pt x="304736" y="155435"/>
                  </a:lnTo>
                  <a:lnTo>
                    <a:pt x="306260" y="153911"/>
                  </a:lnTo>
                  <a:lnTo>
                    <a:pt x="306260" y="149326"/>
                  </a:lnTo>
                  <a:lnTo>
                    <a:pt x="307784" y="149326"/>
                  </a:lnTo>
                  <a:lnTo>
                    <a:pt x="307784" y="144767"/>
                  </a:lnTo>
                  <a:lnTo>
                    <a:pt x="309308" y="144767"/>
                  </a:lnTo>
                  <a:lnTo>
                    <a:pt x="309308" y="138658"/>
                  </a:lnTo>
                  <a:lnTo>
                    <a:pt x="310832" y="137147"/>
                  </a:lnTo>
                  <a:lnTo>
                    <a:pt x="310832" y="127990"/>
                  </a:lnTo>
                  <a:lnTo>
                    <a:pt x="312356" y="127990"/>
                  </a:lnTo>
                  <a:lnTo>
                    <a:pt x="312356" y="108191"/>
                  </a:lnTo>
                  <a:lnTo>
                    <a:pt x="310832" y="108191"/>
                  </a:lnTo>
                  <a:lnTo>
                    <a:pt x="310832" y="100571"/>
                  </a:lnTo>
                  <a:lnTo>
                    <a:pt x="309308" y="99047"/>
                  </a:lnTo>
                  <a:lnTo>
                    <a:pt x="309308" y="95999"/>
                  </a:lnTo>
                  <a:lnTo>
                    <a:pt x="307784" y="94475"/>
                  </a:lnTo>
                  <a:lnTo>
                    <a:pt x="307784" y="92951"/>
                  </a:lnTo>
                  <a:lnTo>
                    <a:pt x="306260" y="92951"/>
                  </a:lnTo>
                  <a:lnTo>
                    <a:pt x="306260" y="89903"/>
                  </a:lnTo>
                  <a:lnTo>
                    <a:pt x="304736" y="88379"/>
                  </a:lnTo>
                  <a:lnTo>
                    <a:pt x="304736" y="86855"/>
                  </a:lnTo>
                  <a:lnTo>
                    <a:pt x="303212" y="85331"/>
                  </a:lnTo>
                  <a:lnTo>
                    <a:pt x="303212" y="83807"/>
                  </a:lnTo>
                  <a:lnTo>
                    <a:pt x="301688" y="82283"/>
                  </a:lnTo>
                  <a:lnTo>
                    <a:pt x="300164" y="82283"/>
                  </a:lnTo>
                  <a:lnTo>
                    <a:pt x="300164" y="79248"/>
                  </a:lnTo>
                  <a:lnTo>
                    <a:pt x="298640" y="79248"/>
                  </a:lnTo>
                  <a:lnTo>
                    <a:pt x="298640" y="77711"/>
                  </a:lnTo>
                  <a:lnTo>
                    <a:pt x="297116" y="76187"/>
                  </a:lnTo>
                  <a:lnTo>
                    <a:pt x="295592" y="76187"/>
                  </a:lnTo>
                  <a:lnTo>
                    <a:pt x="295592" y="74663"/>
                  </a:lnTo>
                  <a:lnTo>
                    <a:pt x="294081" y="74663"/>
                  </a:lnTo>
                  <a:lnTo>
                    <a:pt x="294081" y="73139"/>
                  </a:lnTo>
                  <a:lnTo>
                    <a:pt x="287985" y="67056"/>
                  </a:lnTo>
                  <a:lnTo>
                    <a:pt x="287985" y="65532"/>
                  </a:lnTo>
                  <a:lnTo>
                    <a:pt x="286448" y="65532"/>
                  </a:lnTo>
                  <a:lnTo>
                    <a:pt x="281889" y="60947"/>
                  </a:lnTo>
                  <a:lnTo>
                    <a:pt x="280352" y="60947"/>
                  </a:lnTo>
                  <a:lnTo>
                    <a:pt x="280352" y="59436"/>
                  </a:lnTo>
                  <a:lnTo>
                    <a:pt x="278841" y="59436"/>
                  </a:lnTo>
                  <a:lnTo>
                    <a:pt x="278841" y="57912"/>
                  </a:lnTo>
                  <a:lnTo>
                    <a:pt x="277317" y="57912"/>
                  </a:lnTo>
                  <a:lnTo>
                    <a:pt x="272745" y="53340"/>
                  </a:lnTo>
                  <a:lnTo>
                    <a:pt x="271221" y="53340"/>
                  </a:lnTo>
                  <a:lnTo>
                    <a:pt x="269697" y="51803"/>
                  </a:lnTo>
                  <a:lnTo>
                    <a:pt x="269697" y="50279"/>
                  </a:lnTo>
                  <a:lnTo>
                    <a:pt x="268173" y="50279"/>
                  </a:lnTo>
                  <a:lnTo>
                    <a:pt x="266649" y="48768"/>
                  </a:lnTo>
                  <a:lnTo>
                    <a:pt x="265125" y="48768"/>
                  </a:lnTo>
                  <a:lnTo>
                    <a:pt x="265125" y="47244"/>
                  </a:lnTo>
                  <a:lnTo>
                    <a:pt x="263601" y="45720"/>
                  </a:lnTo>
                  <a:lnTo>
                    <a:pt x="262077" y="45720"/>
                  </a:lnTo>
                  <a:lnTo>
                    <a:pt x="259029" y="42672"/>
                  </a:lnTo>
                  <a:lnTo>
                    <a:pt x="257505" y="42672"/>
                  </a:lnTo>
                  <a:lnTo>
                    <a:pt x="252933" y="38100"/>
                  </a:lnTo>
                  <a:lnTo>
                    <a:pt x="251409" y="38100"/>
                  </a:lnTo>
                  <a:lnTo>
                    <a:pt x="246837" y="33528"/>
                  </a:lnTo>
                  <a:lnTo>
                    <a:pt x="245313" y="33528"/>
                  </a:lnTo>
                  <a:lnTo>
                    <a:pt x="243789" y="32004"/>
                  </a:lnTo>
                  <a:lnTo>
                    <a:pt x="242265" y="32004"/>
                  </a:lnTo>
                  <a:lnTo>
                    <a:pt x="242265" y="30480"/>
                  </a:lnTo>
                  <a:lnTo>
                    <a:pt x="240741" y="30480"/>
                  </a:lnTo>
                  <a:lnTo>
                    <a:pt x="237705" y="27432"/>
                  </a:lnTo>
                  <a:lnTo>
                    <a:pt x="236169" y="27432"/>
                  </a:lnTo>
                  <a:lnTo>
                    <a:pt x="233121" y="24384"/>
                  </a:lnTo>
                  <a:lnTo>
                    <a:pt x="231609" y="24384"/>
                  </a:lnTo>
                  <a:lnTo>
                    <a:pt x="230073" y="22860"/>
                  </a:lnTo>
                  <a:lnTo>
                    <a:pt x="228549" y="22860"/>
                  </a:lnTo>
                  <a:lnTo>
                    <a:pt x="228549" y="21336"/>
                  </a:lnTo>
                  <a:lnTo>
                    <a:pt x="227037" y="19812"/>
                  </a:lnTo>
                  <a:lnTo>
                    <a:pt x="225513" y="19812"/>
                  </a:lnTo>
                  <a:lnTo>
                    <a:pt x="220941" y="15252"/>
                  </a:lnTo>
                  <a:lnTo>
                    <a:pt x="219417" y="15252"/>
                  </a:lnTo>
                  <a:lnTo>
                    <a:pt x="214845" y="10668"/>
                  </a:lnTo>
                  <a:lnTo>
                    <a:pt x="213321" y="10668"/>
                  </a:lnTo>
                  <a:lnTo>
                    <a:pt x="213321" y="9144"/>
                  </a:lnTo>
                  <a:lnTo>
                    <a:pt x="211797" y="9144"/>
                  </a:lnTo>
                  <a:lnTo>
                    <a:pt x="205701" y="3060"/>
                  </a:lnTo>
                  <a:lnTo>
                    <a:pt x="204177" y="3060"/>
                  </a:lnTo>
                  <a:lnTo>
                    <a:pt x="202653" y="1524"/>
                  </a:lnTo>
                  <a:lnTo>
                    <a:pt x="202653" y="0"/>
                  </a:lnTo>
                  <a:close/>
                </a:path>
              </a:pathLst>
            </a:custGeom>
            <a:solidFill>
              <a:srgbClr val="F8766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7" name="object 47"/>
            <p:cNvSpPr/>
            <p:nvPr/>
          </p:nvSpPr>
          <p:spPr>
            <a:xfrm>
              <a:off x="1829503" y="6451633"/>
              <a:ext cx="312420" cy="451484"/>
            </a:xfrm>
            <a:custGeom>
              <a:avLst/>
              <a:gdLst/>
              <a:ahLst/>
              <a:cxnLst/>
              <a:rect l="l" t="t" r="r" b="b"/>
              <a:pathLst>
                <a:path w="312419" h="451484">
                  <a:moveTo>
                    <a:pt x="135610" y="451040"/>
                  </a:moveTo>
                  <a:lnTo>
                    <a:pt x="135610" y="449516"/>
                  </a:lnTo>
                  <a:lnTo>
                    <a:pt x="134086" y="447992"/>
                  </a:lnTo>
                  <a:lnTo>
                    <a:pt x="134086" y="446468"/>
                  </a:lnTo>
                  <a:lnTo>
                    <a:pt x="134086" y="444944"/>
                  </a:lnTo>
                  <a:lnTo>
                    <a:pt x="132562" y="443420"/>
                  </a:lnTo>
                  <a:lnTo>
                    <a:pt x="132562" y="441896"/>
                  </a:lnTo>
                  <a:lnTo>
                    <a:pt x="132562" y="440372"/>
                  </a:lnTo>
                  <a:lnTo>
                    <a:pt x="132562" y="438848"/>
                  </a:lnTo>
                  <a:lnTo>
                    <a:pt x="132562" y="437324"/>
                  </a:lnTo>
                  <a:lnTo>
                    <a:pt x="131038" y="437324"/>
                  </a:lnTo>
                  <a:lnTo>
                    <a:pt x="131038" y="435800"/>
                  </a:lnTo>
                  <a:lnTo>
                    <a:pt x="131038" y="434276"/>
                  </a:lnTo>
                  <a:lnTo>
                    <a:pt x="131038" y="432752"/>
                  </a:lnTo>
                  <a:lnTo>
                    <a:pt x="131038" y="431228"/>
                  </a:lnTo>
                  <a:lnTo>
                    <a:pt x="129514" y="431228"/>
                  </a:lnTo>
                  <a:lnTo>
                    <a:pt x="129514" y="429704"/>
                  </a:lnTo>
                  <a:lnTo>
                    <a:pt x="129514" y="428180"/>
                  </a:lnTo>
                  <a:lnTo>
                    <a:pt x="129514" y="426656"/>
                  </a:lnTo>
                  <a:lnTo>
                    <a:pt x="127990" y="425132"/>
                  </a:lnTo>
                  <a:lnTo>
                    <a:pt x="127990" y="423608"/>
                  </a:lnTo>
                  <a:lnTo>
                    <a:pt x="127990" y="422084"/>
                  </a:lnTo>
                  <a:lnTo>
                    <a:pt x="127990" y="420573"/>
                  </a:lnTo>
                  <a:lnTo>
                    <a:pt x="127990" y="419036"/>
                  </a:lnTo>
                  <a:lnTo>
                    <a:pt x="126466" y="417512"/>
                  </a:lnTo>
                  <a:lnTo>
                    <a:pt x="126466" y="409905"/>
                  </a:lnTo>
                  <a:lnTo>
                    <a:pt x="124942" y="408381"/>
                  </a:lnTo>
                  <a:lnTo>
                    <a:pt x="124942" y="406857"/>
                  </a:lnTo>
                  <a:lnTo>
                    <a:pt x="124942" y="405320"/>
                  </a:lnTo>
                  <a:lnTo>
                    <a:pt x="124942" y="403796"/>
                  </a:lnTo>
                  <a:lnTo>
                    <a:pt x="123431" y="402272"/>
                  </a:lnTo>
                  <a:lnTo>
                    <a:pt x="123431" y="394665"/>
                  </a:lnTo>
                  <a:lnTo>
                    <a:pt x="121894" y="393128"/>
                  </a:lnTo>
                  <a:lnTo>
                    <a:pt x="121894" y="383997"/>
                  </a:lnTo>
                  <a:lnTo>
                    <a:pt x="120370" y="382473"/>
                  </a:lnTo>
                  <a:lnTo>
                    <a:pt x="120370" y="380936"/>
                  </a:lnTo>
                  <a:lnTo>
                    <a:pt x="120370" y="379412"/>
                  </a:lnTo>
                  <a:lnTo>
                    <a:pt x="120370" y="377901"/>
                  </a:lnTo>
                  <a:lnTo>
                    <a:pt x="120370" y="376377"/>
                  </a:lnTo>
                  <a:lnTo>
                    <a:pt x="118859" y="374853"/>
                  </a:lnTo>
                  <a:lnTo>
                    <a:pt x="118859" y="373329"/>
                  </a:lnTo>
                  <a:lnTo>
                    <a:pt x="118859" y="371805"/>
                  </a:lnTo>
                  <a:lnTo>
                    <a:pt x="118859" y="370281"/>
                  </a:lnTo>
                  <a:lnTo>
                    <a:pt x="117335" y="370281"/>
                  </a:lnTo>
                  <a:lnTo>
                    <a:pt x="117335" y="368757"/>
                  </a:lnTo>
                  <a:lnTo>
                    <a:pt x="117335" y="367233"/>
                  </a:lnTo>
                  <a:lnTo>
                    <a:pt x="117335" y="365709"/>
                  </a:lnTo>
                  <a:lnTo>
                    <a:pt x="117335" y="364185"/>
                  </a:lnTo>
                  <a:lnTo>
                    <a:pt x="115798" y="364185"/>
                  </a:lnTo>
                  <a:lnTo>
                    <a:pt x="115798" y="362661"/>
                  </a:lnTo>
                  <a:lnTo>
                    <a:pt x="115798" y="361137"/>
                  </a:lnTo>
                  <a:lnTo>
                    <a:pt x="115798" y="359613"/>
                  </a:lnTo>
                  <a:lnTo>
                    <a:pt x="114274" y="359613"/>
                  </a:lnTo>
                  <a:lnTo>
                    <a:pt x="114274" y="358089"/>
                  </a:lnTo>
                  <a:lnTo>
                    <a:pt x="114274" y="356577"/>
                  </a:lnTo>
                  <a:lnTo>
                    <a:pt x="112763" y="355041"/>
                  </a:lnTo>
                  <a:lnTo>
                    <a:pt x="112763" y="353517"/>
                  </a:lnTo>
                  <a:lnTo>
                    <a:pt x="112763" y="351993"/>
                  </a:lnTo>
                  <a:lnTo>
                    <a:pt x="111239" y="350469"/>
                  </a:lnTo>
                  <a:lnTo>
                    <a:pt x="111239" y="348945"/>
                  </a:lnTo>
                  <a:lnTo>
                    <a:pt x="111239" y="347421"/>
                  </a:lnTo>
                  <a:lnTo>
                    <a:pt x="109702" y="345897"/>
                  </a:lnTo>
                  <a:lnTo>
                    <a:pt x="109702" y="344385"/>
                  </a:lnTo>
                  <a:lnTo>
                    <a:pt x="108191" y="344385"/>
                  </a:lnTo>
                  <a:lnTo>
                    <a:pt x="108191" y="342849"/>
                  </a:lnTo>
                  <a:lnTo>
                    <a:pt x="108191" y="341325"/>
                  </a:lnTo>
                  <a:lnTo>
                    <a:pt x="106667" y="339801"/>
                  </a:lnTo>
                  <a:lnTo>
                    <a:pt x="106667" y="338277"/>
                  </a:lnTo>
                  <a:lnTo>
                    <a:pt x="106667" y="336753"/>
                  </a:lnTo>
                  <a:lnTo>
                    <a:pt x="105143" y="335229"/>
                  </a:lnTo>
                  <a:lnTo>
                    <a:pt x="105143" y="333717"/>
                  </a:lnTo>
                  <a:lnTo>
                    <a:pt x="103606" y="332193"/>
                  </a:lnTo>
                  <a:lnTo>
                    <a:pt x="103606" y="330657"/>
                  </a:lnTo>
                  <a:lnTo>
                    <a:pt x="102095" y="330657"/>
                  </a:lnTo>
                  <a:lnTo>
                    <a:pt x="102095" y="329133"/>
                  </a:lnTo>
                  <a:lnTo>
                    <a:pt x="102095" y="327609"/>
                  </a:lnTo>
                  <a:lnTo>
                    <a:pt x="100571" y="326085"/>
                  </a:lnTo>
                  <a:lnTo>
                    <a:pt x="100571" y="324561"/>
                  </a:lnTo>
                  <a:lnTo>
                    <a:pt x="99047" y="324561"/>
                  </a:lnTo>
                  <a:lnTo>
                    <a:pt x="99047" y="323037"/>
                  </a:lnTo>
                  <a:lnTo>
                    <a:pt x="97523" y="321525"/>
                  </a:lnTo>
                  <a:lnTo>
                    <a:pt x="97523" y="320001"/>
                  </a:lnTo>
                  <a:lnTo>
                    <a:pt x="95999" y="318477"/>
                  </a:lnTo>
                  <a:lnTo>
                    <a:pt x="95999" y="316941"/>
                  </a:lnTo>
                  <a:lnTo>
                    <a:pt x="94475" y="316941"/>
                  </a:lnTo>
                  <a:lnTo>
                    <a:pt x="94475" y="315417"/>
                  </a:lnTo>
                  <a:lnTo>
                    <a:pt x="92951" y="313893"/>
                  </a:lnTo>
                  <a:lnTo>
                    <a:pt x="92951" y="312369"/>
                  </a:lnTo>
                  <a:lnTo>
                    <a:pt x="91427" y="310857"/>
                  </a:lnTo>
                  <a:lnTo>
                    <a:pt x="91427" y="309333"/>
                  </a:lnTo>
                  <a:lnTo>
                    <a:pt x="89903" y="309333"/>
                  </a:lnTo>
                  <a:lnTo>
                    <a:pt x="89903" y="307809"/>
                  </a:lnTo>
                  <a:lnTo>
                    <a:pt x="89903" y="306285"/>
                  </a:lnTo>
                  <a:lnTo>
                    <a:pt x="88379" y="306285"/>
                  </a:lnTo>
                  <a:lnTo>
                    <a:pt x="88379" y="304749"/>
                  </a:lnTo>
                  <a:lnTo>
                    <a:pt x="86855" y="304749"/>
                  </a:lnTo>
                  <a:lnTo>
                    <a:pt x="86855" y="303225"/>
                  </a:lnTo>
                  <a:lnTo>
                    <a:pt x="86855" y="301701"/>
                  </a:lnTo>
                  <a:lnTo>
                    <a:pt x="85331" y="301701"/>
                  </a:lnTo>
                  <a:lnTo>
                    <a:pt x="85331" y="300189"/>
                  </a:lnTo>
                  <a:lnTo>
                    <a:pt x="85331" y="298665"/>
                  </a:lnTo>
                  <a:lnTo>
                    <a:pt x="83807" y="297141"/>
                  </a:lnTo>
                  <a:lnTo>
                    <a:pt x="82283" y="295617"/>
                  </a:lnTo>
                  <a:lnTo>
                    <a:pt x="82283" y="294093"/>
                  </a:lnTo>
                  <a:lnTo>
                    <a:pt x="80759" y="294093"/>
                  </a:lnTo>
                  <a:lnTo>
                    <a:pt x="80759" y="292557"/>
                  </a:lnTo>
                  <a:lnTo>
                    <a:pt x="80759" y="291033"/>
                  </a:lnTo>
                  <a:lnTo>
                    <a:pt x="79235" y="291033"/>
                  </a:lnTo>
                  <a:lnTo>
                    <a:pt x="79235" y="289521"/>
                  </a:lnTo>
                  <a:lnTo>
                    <a:pt x="77711" y="289521"/>
                  </a:lnTo>
                  <a:lnTo>
                    <a:pt x="77711" y="287997"/>
                  </a:lnTo>
                  <a:lnTo>
                    <a:pt x="77711" y="286473"/>
                  </a:lnTo>
                  <a:lnTo>
                    <a:pt x="76187" y="286473"/>
                  </a:lnTo>
                  <a:lnTo>
                    <a:pt x="76187" y="284949"/>
                  </a:lnTo>
                  <a:lnTo>
                    <a:pt x="74663" y="283425"/>
                  </a:lnTo>
                  <a:lnTo>
                    <a:pt x="74663" y="281901"/>
                  </a:lnTo>
                  <a:lnTo>
                    <a:pt x="73139" y="280377"/>
                  </a:lnTo>
                  <a:lnTo>
                    <a:pt x="71615" y="278853"/>
                  </a:lnTo>
                  <a:lnTo>
                    <a:pt x="71615" y="277329"/>
                  </a:lnTo>
                  <a:lnTo>
                    <a:pt x="70091" y="275805"/>
                  </a:lnTo>
                  <a:lnTo>
                    <a:pt x="68567" y="274281"/>
                  </a:lnTo>
                  <a:lnTo>
                    <a:pt x="67055" y="272757"/>
                  </a:lnTo>
                  <a:lnTo>
                    <a:pt x="67055" y="271233"/>
                  </a:lnTo>
                  <a:lnTo>
                    <a:pt x="65519" y="271233"/>
                  </a:lnTo>
                  <a:lnTo>
                    <a:pt x="65519" y="269709"/>
                  </a:lnTo>
                  <a:lnTo>
                    <a:pt x="65519" y="268198"/>
                  </a:lnTo>
                  <a:lnTo>
                    <a:pt x="63995" y="268198"/>
                  </a:lnTo>
                  <a:lnTo>
                    <a:pt x="63995" y="266661"/>
                  </a:lnTo>
                  <a:lnTo>
                    <a:pt x="62471" y="266661"/>
                  </a:lnTo>
                  <a:lnTo>
                    <a:pt x="62471" y="265137"/>
                  </a:lnTo>
                  <a:lnTo>
                    <a:pt x="60959" y="263613"/>
                  </a:lnTo>
                  <a:lnTo>
                    <a:pt x="60959" y="262089"/>
                  </a:lnTo>
                  <a:lnTo>
                    <a:pt x="59423" y="260565"/>
                  </a:lnTo>
                  <a:lnTo>
                    <a:pt x="59423" y="259041"/>
                  </a:lnTo>
                  <a:lnTo>
                    <a:pt x="57899" y="259041"/>
                  </a:lnTo>
                  <a:lnTo>
                    <a:pt x="57899" y="257530"/>
                  </a:lnTo>
                  <a:lnTo>
                    <a:pt x="56387" y="256006"/>
                  </a:lnTo>
                  <a:lnTo>
                    <a:pt x="56387" y="254469"/>
                  </a:lnTo>
                  <a:lnTo>
                    <a:pt x="54863" y="254469"/>
                  </a:lnTo>
                  <a:lnTo>
                    <a:pt x="54863" y="252945"/>
                  </a:lnTo>
                  <a:lnTo>
                    <a:pt x="54863" y="251421"/>
                  </a:lnTo>
                  <a:lnTo>
                    <a:pt x="53327" y="251421"/>
                  </a:lnTo>
                  <a:lnTo>
                    <a:pt x="53327" y="249897"/>
                  </a:lnTo>
                  <a:lnTo>
                    <a:pt x="51803" y="249897"/>
                  </a:lnTo>
                  <a:lnTo>
                    <a:pt x="51803" y="248373"/>
                  </a:lnTo>
                  <a:lnTo>
                    <a:pt x="51803" y="246862"/>
                  </a:lnTo>
                  <a:lnTo>
                    <a:pt x="50291" y="246862"/>
                  </a:lnTo>
                  <a:lnTo>
                    <a:pt x="50291" y="245338"/>
                  </a:lnTo>
                  <a:lnTo>
                    <a:pt x="48767" y="243814"/>
                  </a:lnTo>
                  <a:lnTo>
                    <a:pt x="47243" y="242290"/>
                  </a:lnTo>
                  <a:lnTo>
                    <a:pt x="47243" y="240753"/>
                  </a:lnTo>
                  <a:lnTo>
                    <a:pt x="45719" y="239229"/>
                  </a:lnTo>
                  <a:lnTo>
                    <a:pt x="45719" y="237705"/>
                  </a:lnTo>
                  <a:lnTo>
                    <a:pt x="45719" y="236181"/>
                  </a:lnTo>
                  <a:lnTo>
                    <a:pt x="44195" y="236181"/>
                  </a:lnTo>
                  <a:lnTo>
                    <a:pt x="44195" y="234670"/>
                  </a:lnTo>
                  <a:lnTo>
                    <a:pt x="42671" y="233146"/>
                  </a:lnTo>
                  <a:lnTo>
                    <a:pt x="42671" y="231622"/>
                  </a:lnTo>
                  <a:lnTo>
                    <a:pt x="41147" y="231622"/>
                  </a:lnTo>
                  <a:lnTo>
                    <a:pt x="41147" y="230098"/>
                  </a:lnTo>
                  <a:lnTo>
                    <a:pt x="39623" y="228561"/>
                  </a:lnTo>
                  <a:lnTo>
                    <a:pt x="39623" y="227037"/>
                  </a:lnTo>
                  <a:lnTo>
                    <a:pt x="38099" y="227037"/>
                  </a:lnTo>
                  <a:lnTo>
                    <a:pt x="38099" y="225513"/>
                  </a:lnTo>
                  <a:lnTo>
                    <a:pt x="36575" y="224002"/>
                  </a:lnTo>
                  <a:lnTo>
                    <a:pt x="36575" y="222478"/>
                  </a:lnTo>
                  <a:lnTo>
                    <a:pt x="35051" y="220954"/>
                  </a:lnTo>
                  <a:lnTo>
                    <a:pt x="35051" y="219430"/>
                  </a:lnTo>
                  <a:lnTo>
                    <a:pt x="33527" y="217906"/>
                  </a:lnTo>
                  <a:lnTo>
                    <a:pt x="33527" y="216369"/>
                  </a:lnTo>
                  <a:lnTo>
                    <a:pt x="32003" y="216369"/>
                  </a:lnTo>
                  <a:lnTo>
                    <a:pt x="32003" y="214845"/>
                  </a:lnTo>
                  <a:lnTo>
                    <a:pt x="30479" y="213334"/>
                  </a:lnTo>
                  <a:lnTo>
                    <a:pt x="30479" y="211810"/>
                  </a:lnTo>
                  <a:lnTo>
                    <a:pt x="30479" y="210286"/>
                  </a:lnTo>
                  <a:lnTo>
                    <a:pt x="28955" y="210286"/>
                  </a:lnTo>
                  <a:lnTo>
                    <a:pt x="28955" y="208762"/>
                  </a:lnTo>
                  <a:lnTo>
                    <a:pt x="28955" y="207238"/>
                  </a:lnTo>
                  <a:lnTo>
                    <a:pt x="27431" y="205714"/>
                  </a:lnTo>
                  <a:lnTo>
                    <a:pt x="25907" y="204190"/>
                  </a:lnTo>
                  <a:lnTo>
                    <a:pt x="25907" y="202653"/>
                  </a:lnTo>
                  <a:lnTo>
                    <a:pt x="25907" y="201142"/>
                  </a:lnTo>
                  <a:lnTo>
                    <a:pt x="24383" y="201142"/>
                  </a:lnTo>
                  <a:lnTo>
                    <a:pt x="24383" y="199618"/>
                  </a:lnTo>
                  <a:lnTo>
                    <a:pt x="24383" y="198094"/>
                  </a:lnTo>
                  <a:lnTo>
                    <a:pt x="22859" y="196570"/>
                  </a:lnTo>
                  <a:lnTo>
                    <a:pt x="22859" y="195046"/>
                  </a:lnTo>
                  <a:lnTo>
                    <a:pt x="21335" y="195046"/>
                  </a:lnTo>
                  <a:lnTo>
                    <a:pt x="21335" y="193522"/>
                  </a:lnTo>
                  <a:lnTo>
                    <a:pt x="21335" y="191998"/>
                  </a:lnTo>
                  <a:lnTo>
                    <a:pt x="19811" y="190474"/>
                  </a:lnTo>
                  <a:lnTo>
                    <a:pt x="19811" y="188950"/>
                  </a:lnTo>
                  <a:lnTo>
                    <a:pt x="19811" y="187426"/>
                  </a:lnTo>
                  <a:lnTo>
                    <a:pt x="18287" y="185902"/>
                  </a:lnTo>
                  <a:lnTo>
                    <a:pt x="18287" y="184378"/>
                  </a:lnTo>
                  <a:lnTo>
                    <a:pt x="16763" y="184378"/>
                  </a:lnTo>
                  <a:lnTo>
                    <a:pt x="16763" y="182854"/>
                  </a:lnTo>
                  <a:lnTo>
                    <a:pt x="16763" y="181330"/>
                  </a:lnTo>
                  <a:lnTo>
                    <a:pt x="16763" y="179819"/>
                  </a:lnTo>
                  <a:lnTo>
                    <a:pt x="15239" y="179819"/>
                  </a:lnTo>
                  <a:lnTo>
                    <a:pt x="15239" y="178282"/>
                  </a:lnTo>
                  <a:lnTo>
                    <a:pt x="15239" y="176758"/>
                  </a:lnTo>
                  <a:lnTo>
                    <a:pt x="13715" y="175234"/>
                  </a:lnTo>
                  <a:lnTo>
                    <a:pt x="13715" y="173710"/>
                  </a:lnTo>
                  <a:lnTo>
                    <a:pt x="13715" y="172186"/>
                  </a:lnTo>
                  <a:lnTo>
                    <a:pt x="12191" y="170662"/>
                  </a:lnTo>
                  <a:lnTo>
                    <a:pt x="12191" y="169151"/>
                  </a:lnTo>
                  <a:lnTo>
                    <a:pt x="10667" y="167627"/>
                  </a:lnTo>
                  <a:lnTo>
                    <a:pt x="10667" y="166090"/>
                  </a:lnTo>
                  <a:lnTo>
                    <a:pt x="10667" y="164566"/>
                  </a:lnTo>
                  <a:lnTo>
                    <a:pt x="9143" y="163042"/>
                  </a:lnTo>
                  <a:lnTo>
                    <a:pt x="9143" y="161518"/>
                  </a:lnTo>
                  <a:lnTo>
                    <a:pt x="9143" y="159994"/>
                  </a:lnTo>
                  <a:lnTo>
                    <a:pt x="9143" y="158483"/>
                  </a:lnTo>
                  <a:lnTo>
                    <a:pt x="7619" y="158483"/>
                  </a:lnTo>
                  <a:lnTo>
                    <a:pt x="7619" y="156959"/>
                  </a:lnTo>
                  <a:lnTo>
                    <a:pt x="7619" y="155435"/>
                  </a:lnTo>
                  <a:lnTo>
                    <a:pt x="6095" y="153911"/>
                  </a:lnTo>
                  <a:lnTo>
                    <a:pt x="6095" y="152374"/>
                  </a:lnTo>
                  <a:lnTo>
                    <a:pt x="6095" y="150850"/>
                  </a:lnTo>
                  <a:lnTo>
                    <a:pt x="6095" y="149326"/>
                  </a:lnTo>
                  <a:lnTo>
                    <a:pt x="4584" y="147815"/>
                  </a:lnTo>
                  <a:lnTo>
                    <a:pt x="4584" y="146291"/>
                  </a:lnTo>
                  <a:lnTo>
                    <a:pt x="4584" y="144767"/>
                  </a:lnTo>
                  <a:lnTo>
                    <a:pt x="4584" y="143243"/>
                  </a:lnTo>
                  <a:lnTo>
                    <a:pt x="3047" y="141719"/>
                  </a:lnTo>
                  <a:lnTo>
                    <a:pt x="3047" y="140182"/>
                  </a:lnTo>
                  <a:lnTo>
                    <a:pt x="3047" y="138658"/>
                  </a:lnTo>
                  <a:lnTo>
                    <a:pt x="1523" y="137147"/>
                  </a:lnTo>
                  <a:lnTo>
                    <a:pt x="1523" y="127990"/>
                  </a:lnTo>
                  <a:lnTo>
                    <a:pt x="0" y="127990"/>
                  </a:lnTo>
                  <a:lnTo>
                    <a:pt x="0" y="108191"/>
                  </a:lnTo>
                  <a:lnTo>
                    <a:pt x="1523" y="108191"/>
                  </a:lnTo>
                  <a:lnTo>
                    <a:pt x="1523" y="100571"/>
                  </a:lnTo>
                  <a:lnTo>
                    <a:pt x="3047" y="99047"/>
                  </a:lnTo>
                  <a:lnTo>
                    <a:pt x="3047" y="97523"/>
                  </a:lnTo>
                  <a:lnTo>
                    <a:pt x="3047" y="95999"/>
                  </a:lnTo>
                  <a:lnTo>
                    <a:pt x="4584" y="95999"/>
                  </a:lnTo>
                  <a:lnTo>
                    <a:pt x="4584" y="94475"/>
                  </a:lnTo>
                  <a:lnTo>
                    <a:pt x="4584" y="92951"/>
                  </a:lnTo>
                  <a:lnTo>
                    <a:pt x="6095" y="92951"/>
                  </a:lnTo>
                  <a:lnTo>
                    <a:pt x="6095" y="91440"/>
                  </a:lnTo>
                  <a:lnTo>
                    <a:pt x="6095" y="89903"/>
                  </a:lnTo>
                  <a:lnTo>
                    <a:pt x="7619" y="88379"/>
                  </a:lnTo>
                  <a:lnTo>
                    <a:pt x="9143" y="86855"/>
                  </a:lnTo>
                  <a:lnTo>
                    <a:pt x="9143" y="85331"/>
                  </a:lnTo>
                  <a:lnTo>
                    <a:pt x="10667" y="83807"/>
                  </a:lnTo>
                  <a:lnTo>
                    <a:pt x="10667" y="82283"/>
                  </a:lnTo>
                  <a:lnTo>
                    <a:pt x="12191" y="82283"/>
                  </a:lnTo>
                  <a:lnTo>
                    <a:pt x="12191" y="80772"/>
                  </a:lnTo>
                  <a:lnTo>
                    <a:pt x="13715" y="79248"/>
                  </a:lnTo>
                  <a:lnTo>
                    <a:pt x="13715" y="77711"/>
                  </a:lnTo>
                  <a:lnTo>
                    <a:pt x="15239" y="77711"/>
                  </a:lnTo>
                  <a:lnTo>
                    <a:pt x="15239" y="76187"/>
                  </a:lnTo>
                  <a:lnTo>
                    <a:pt x="16763" y="76187"/>
                  </a:lnTo>
                  <a:lnTo>
                    <a:pt x="16763" y="74663"/>
                  </a:lnTo>
                  <a:lnTo>
                    <a:pt x="18287" y="74663"/>
                  </a:lnTo>
                  <a:lnTo>
                    <a:pt x="18287" y="73139"/>
                  </a:lnTo>
                  <a:lnTo>
                    <a:pt x="19811" y="71615"/>
                  </a:lnTo>
                  <a:lnTo>
                    <a:pt x="21335" y="70104"/>
                  </a:lnTo>
                  <a:lnTo>
                    <a:pt x="22859" y="68580"/>
                  </a:lnTo>
                  <a:lnTo>
                    <a:pt x="24383" y="68580"/>
                  </a:lnTo>
                  <a:lnTo>
                    <a:pt x="24383" y="67056"/>
                  </a:lnTo>
                  <a:lnTo>
                    <a:pt x="25907" y="65532"/>
                  </a:lnTo>
                  <a:lnTo>
                    <a:pt x="27431" y="63995"/>
                  </a:lnTo>
                  <a:lnTo>
                    <a:pt x="28955" y="63995"/>
                  </a:lnTo>
                  <a:lnTo>
                    <a:pt x="28955" y="62471"/>
                  </a:lnTo>
                  <a:lnTo>
                    <a:pt x="30479" y="60947"/>
                  </a:lnTo>
                  <a:lnTo>
                    <a:pt x="32003" y="60947"/>
                  </a:lnTo>
                  <a:lnTo>
                    <a:pt x="32003" y="59436"/>
                  </a:lnTo>
                  <a:lnTo>
                    <a:pt x="33527" y="59436"/>
                  </a:lnTo>
                  <a:lnTo>
                    <a:pt x="35051" y="57912"/>
                  </a:lnTo>
                  <a:lnTo>
                    <a:pt x="36575" y="56388"/>
                  </a:lnTo>
                  <a:lnTo>
                    <a:pt x="38099" y="54864"/>
                  </a:lnTo>
                  <a:lnTo>
                    <a:pt x="39623" y="54864"/>
                  </a:lnTo>
                  <a:lnTo>
                    <a:pt x="39623" y="53340"/>
                  </a:lnTo>
                  <a:lnTo>
                    <a:pt x="41147" y="53340"/>
                  </a:lnTo>
                  <a:lnTo>
                    <a:pt x="42671" y="51803"/>
                  </a:lnTo>
                  <a:lnTo>
                    <a:pt x="44195" y="50279"/>
                  </a:lnTo>
                  <a:lnTo>
                    <a:pt x="45719" y="48768"/>
                  </a:lnTo>
                  <a:lnTo>
                    <a:pt x="47243" y="48768"/>
                  </a:lnTo>
                  <a:lnTo>
                    <a:pt x="47243" y="47244"/>
                  </a:lnTo>
                  <a:lnTo>
                    <a:pt x="48767" y="45720"/>
                  </a:lnTo>
                  <a:lnTo>
                    <a:pt x="50291" y="45720"/>
                  </a:lnTo>
                  <a:lnTo>
                    <a:pt x="51803" y="44196"/>
                  </a:lnTo>
                  <a:lnTo>
                    <a:pt x="54863" y="42672"/>
                  </a:lnTo>
                  <a:lnTo>
                    <a:pt x="56387" y="41148"/>
                  </a:lnTo>
                  <a:lnTo>
                    <a:pt x="57899" y="39611"/>
                  </a:lnTo>
                  <a:lnTo>
                    <a:pt x="59423" y="39611"/>
                  </a:lnTo>
                  <a:lnTo>
                    <a:pt x="59423" y="38100"/>
                  </a:lnTo>
                  <a:lnTo>
                    <a:pt x="60959" y="38100"/>
                  </a:lnTo>
                  <a:lnTo>
                    <a:pt x="62471" y="36576"/>
                  </a:lnTo>
                  <a:lnTo>
                    <a:pt x="63995" y="35052"/>
                  </a:lnTo>
                  <a:lnTo>
                    <a:pt x="65519" y="35052"/>
                  </a:lnTo>
                  <a:lnTo>
                    <a:pt x="65519" y="33528"/>
                  </a:lnTo>
                  <a:lnTo>
                    <a:pt x="67055" y="33528"/>
                  </a:lnTo>
                  <a:lnTo>
                    <a:pt x="68567" y="32004"/>
                  </a:lnTo>
                  <a:lnTo>
                    <a:pt x="70091" y="32004"/>
                  </a:lnTo>
                  <a:lnTo>
                    <a:pt x="71615" y="30480"/>
                  </a:lnTo>
                  <a:lnTo>
                    <a:pt x="73139" y="28956"/>
                  </a:lnTo>
                  <a:lnTo>
                    <a:pt x="74663" y="27432"/>
                  </a:lnTo>
                  <a:lnTo>
                    <a:pt x="76187" y="27432"/>
                  </a:lnTo>
                  <a:lnTo>
                    <a:pt x="77711" y="25908"/>
                  </a:lnTo>
                  <a:lnTo>
                    <a:pt x="79235" y="24384"/>
                  </a:lnTo>
                  <a:lnTo>
                    <a:pt x="80759" y="24384"/>
                  </a:lnTo>
                  <a:lnTo>
                    <a:pt x="82283" y="22860"/>
                  </a:lnTo>
                  <a:lnTo>
                    <a:pt x="83807" y="22860"/>
                  </a:lnTo>
                  <a:lnTo>
                    <a:pt x="85331" y="21336"/>
                  </a:lnTo>
                  <a:lnTo>
                    <a:pt x="85331" y="19812"/>
                  </a:lnTo>
                  <a:lnTo>
                    <a:pt x="86855" y="19812"/>
                  </a:lnTo>
                  <a:lnTo>
                    <a:pt x="88379" y="18288"/>
                  </a:lnTo>
                  <a:lnTo>
                    <a:pt x="89903" y="18288"/>
                  </a:lnTo>
                  <a:lnTo>
                    <a:pt x="91427" y="16764"/>
                  </a:lnTo>
                  <a:lnTo>
                    <a:pt x="91427" y="15252"/>
                  </a:lnTo>
                  <a:lnTo>
                    <a:pt x="92951" y="15252"/>
                  </a:lnTo>
                  <a:lnTo>
                    <a:pt x="94475" y="13716"/>
                  </a:lnTo>
                  <a:lnTo>
                    <a:pt x="95999" y="13716"/>
                  </a:lnTo>
                  <a:lnTo>
                    <a:pt x="95999" y="12192"/>
                  </a:lnTo>
                  <a:lnTo>
                    <a:pt x="97523" y="10668"/>
                  </a:lnTo>
                  <a:lnTo>
                    <a:pt x="99047" y="10668"/>
                  </a:lnTo>
                  <a:lnTo>
                    <a:pt x="100571" y="9144"/>
                  </a:lnTo>
                  <a:lnTo>
                    <a:pt x="102095" y="7620"/>
                  </a:lnTo>
                  <a:lnTo>
                    <a:pt x="103606" y="7620"/>
                  </a:lnTo>
                  <a:lnTo>
                    <a:pt x="103606" y="6096"/>
                  </a:lnTo>
                  <a:lnTo>
                    <a:pt x="105143" y="4584"/>
                  </a:lnTo>
                  <a:lnTo>
                    <a:pt x="106667" y="4584"/>
                  </a:lnTo>
                  <a:lnTo>
                    <a:pt x="106667" y="3060"/>
                  </a:lnTo>
                  <a:lnTo>
                    <a:pt x="108191" y="3060"/>
                  </a:lnTo>
                  <a:lnTo>
                    <a:pt x="109702" y="1524"/>
                  </a:lnTo>
                  <a:lnTo>
                    <a:pt x="109702" y="0"/>
                  </a:lnTo>
                  <a:lnTo>
                    <a:pt x="111239" y="0"/>
                  </a:lnTo>
                  <a:lnTo>
                    <a:pt x="201129" y="0"/>
                  </a:lnTo>
                  <a:lnTo>
                    <a:pt x="202653" y="0"/>
                  </a:lnTo>
                  <a:lnTo>
                    <a:pt x="202653" y="1524"/>
                  </a:lnTo>
                  <a:lnTo>
                    <a:pt x="204177" y="3060"/>
                  </a:lnTo>
                  <a:lnTo>
                    <a:pt x="205701" y="3060"/>
                  </a:lnTo>
                  <a:lnTo>
                    <a:pt x="207225" y="4584"/>
                  </a:lnTo>
                  <a:lnTo>
                    <a:pt x="208749" y="6096"/>
                  </a:lnTo>
                  <a:lnTo>
                    <a:pt x="210273" y="7620"/>
                  </a:lnTo>
                  <a:lnTo>
                    <a:pt x="211797" y="9144"/>
                  </a:lnTo>
                  <a:lnTo>
                    <a:pt x="213321" y="9144"/>
                  </a:lnTo>
                  <a:lnTo>
                    <a:pt x="213321" y="10668"/>
                  </a:lnTo>
                  <a:lnTo>
                    <a:pt x="214845" y="10668"/>
                  </a:lnTo>
                  <a:lnTo>
                    <a:pt x="216369" y="12192"/>
                  </a:lnTo>
                  <a:lnTo>
                    <a:pt x="217893" y="13716"/>
                  </a:lnTo>
                  <a:lnTo>
                    <a:pt x="219417" y="15252"/>
                  </a:lnTo>
                  <a:lnTo>
                    <a:pt x="220941" y="15252"/>
                  </a:lnTo>
                  <a:lnTo>
                    <a:pt x="222465" y="16764"/>
                  </a:lnTo>
                  <a:lnTo>
                    <a:pt x="223977" y="18288"/>
                  </a:lnTo>
                  <a:lnTo>
                    <a:pt x="225513" y="19812"/>
                  </a:lnTo>
                  <a:lnTo>
                    <a:pt x="227037" y="19812"/>
                  </a:lnTo>
                  <a:lnTo>
                    <a:pt x="228549" y="21336"/>
                  </a:lnTo>
                  <a:lnTo>
                    <a:pt x="228549" y="22860"/>
                  </a:lnTo>
                  <a:lnTo>
                    <a:pt x="230073" y="22860"/>
                  </a:lnTo>
                  <a:lnTo>
                    <a:pt x="231609" y="24384"/>
                  </a:lnTo>
                  <a:lnTo>
                    <a:pt x="233121" y="24384"/>
                  </a:lnTo>
                  <a:lnTo>
                    <a:pt x="234645" y="25908"/>
                  </a:lnTo>
                  <a:lnTo>
                    <a:pt x="236169" y="27432"/>
                  </a:lnTo>
                  <a:lnTo>
                    <a:pt x="237705" y="27432"/>
                  </a:lnTo>
                  <a:lnTo>
                    <a:pt x="239217" y="28956"/>
                  </a:lnTo>
                  <a:lnTo>
                    <a:pt x="240741" y="30480"/>
                  </a:lnTo>
                  <a:lnTo>
                    <a:pt x="242265" y="30480"/>
                  </a:lnTo>
                  <a:lnTo>
                    <a:pt x="242265" y="32004"/>
                  </a:lnTo>
                  <a:lnTo>
                    <a:pt x="243789" y="32004"/>
                  </a:lnTo>
                  <a:lnTo>
                    <a:pt x="245313" y="33528"/>
                  </a:lnTo>
                  <a:lnTo>
                    <a:pt x="246837" y="33528"/>
                  </a:lnTo>
                  <a:lnTo>
                    <a:pt x="248361" y="35052"/>
                  </a:lnTo>
                  <a:lnTo>
                    <a:pt x="249885" y="36576"/>
                  </a:lnTo>
                  <a:lnTo>
                    <a:pt x="251409" y="38100"/>
                  </a:lnTo>
                  <a:lnTo>
                    <a:pt x="252933" y="38100"/>
                  </a:lnTo>
                  <a:lnTo>
                    <a:pt x="254457" y="39611"/>
                  </a:lnTo>
                  <a:lnTo>
                    <a:pt x="255981" y="41148"/>
                  </a:lnTo>
                  <a:lnTo>
                    <a:pt x="257505" y="42672"/>
                  </a:lnTo>
                  <a:lnTo>
                    <a:pt x="259029" y="42672"/>
                  </a:lnTo>
                  <a:lnTo>
                    <a:pt x="260553" y="44196"/>
                  </a:lnTo>
                  <a:lnTo>
                    <a:pt x="262077" y="45720"/>
                  </a:lnTo>
                  <a:lnTo>
                    <a:pt x="263601" y="45720"/>
                  </a:lnTo>
                  <a:lnTo>
                    <a:pt x="265125" y="47244"/>
                  </a:lnTo>
                  <a:lnTo>
                    <a:pt x="265125" y="48768"/>
                  </a:lnTo>
                  <a:lnTo>
                    <a:pt x="266649" y="48768"/>
                  </a:lnTo>
                  <a:lnTo>
                    <a:pt x="268173" y="50279"/>
                  </a:lnTo>
                  <a:lnTo>
                    <a:pt x="269697" y="50279"/>
                  </a:lnTo>
                  <a:lnTo>
                    <a:pt x="269697" y="51803"/>
                  </a:lnTo>
                  <a:lnTo>
                    <a:pt x="271221" y="53340"/>
                  </a:lnTo>
                  <a:lnTo>
                    <a:pt x="272745" y="53340"/>
                  </a:lnTo>
                  <a:lnTo>
                    <a:pt x="274256" y="54864"/>
                  </a:lnTo>
                  <a:lnTo>
                    <a:pt x="275793" y="56388"/>
                  </a:lnTo>
                  <a:lnTo>
                    <a:pt x="277317" y="57912"/>
                  </a:lnTo>
                  <a:lnTo>
                    <a:pt x="278841" y="57912"/>
                  </a:lnTo>
                  <a:lnTo>
                    <a:pt x="278841" y="59436"/>
                  </a:lnTo>
                  <a:lnTo>
                    <a:pt x="280352" y="59436"/>
                  </a:lnTo>
                  <a:lnTo>
                    <a:pt x="280352" y="60947"/>
                  </a:lnTo>
                  <a:lnTo>
                    <a:pt x="281889" y="60947"/>
                  </a:lnTo>
                  <a:lnTo>
                    <a:pt x="283413" y="62471"/>
                  </a:lnTo>
                  <a:lnTo>
                    <a:pt x="284924" y="63995"/>
                  </a:lnTo>
                  <a:lnTo>
                    <a:pt x="286448" y="65532"/>
                  </a:lnTo>
                  <a:lnTo>
                    <a:pt x="287985" y="65532"/>
                  </a:lnTo>
                  <a:lnTo>
                    <a:pt x="287985" y="67056"/>
                  </a:lnTo>
                  <a:lnTo>
                    <a:pt x="289509" y="68580"/>
                  </a:lnTo>
                  <a:lnTo>
                    <a:pt x="291020" y="70104"/>
                  </a:lnTo>
                  <a:lnTo>
                    <a:pt x="292544" y="71615"/>
                  </a:lnTo>
                  <a:lnTo>
                    <a:pt x="294081" y="73139"/>
                  </a:lnTo>
                  <a:lnTo>
                    <a:pt x="294081" y="74663"/>
                  </a:lnTo>
                  <a:lnTo>
                    <a:pt x="295592" y="74663"/>
                  </a:lnTo>
                  <a:lnTo>
                    <a:pt x="295592" y="76187"/>
                  </a:lnTo>
                  <a:lnTo>
                    <a:pt x="297116" y="76187"/>
                  </a:lnTo>
                  <a:lnTo>
                    <a:pt x="298640" y="77711"/>
                  </a:lnTo>
                  <a:lnTo>
                    <a:pt x="298640" y="79248"/>
                  </a:lnTo>
                  <a:lnTo>
                    <a:pt x="300164" y="79248"/>
                  </a:lnTo>
                  <a:lnTo>
                    <a:pt x="300164" y="80772"/>
                  </a:lnTo>
                  <a:lnTo>
                    <a:pt x="300164" y="82283"/>
                  </a:lnTo>
                  <a:lnTo>
                    <a:pt x="301688" y="82283"/>
                  </a:lnTo>
                  <a:lnTo>
                    <a:pt x="303212" y="83807"/>
                  </a:lnTo>
                  <a:lnTo>
                    <a:pt x="303212" y="85331"/>
                  </a:lnTo>
                  <a:lnTo>
                    <a:pt x="304736" y="86855"/>
                  </a:lnTo>
                  <a:lnTo>
                    <a:pt x="304736" y="88379"/>
                  </a:lnTo>
                  <a:lnTo>
                    <a:pt x="306260" y="89903"/>
                  </a:lnTo>
                  <a:lnTo>
                    <a:pt x="306260" y="91440"/>
                  </a:lnTo>
                  <a:lnTo>
                    <a:pt x="306260" y="92951"/>
                  </a:lnTo>
                  <a:lnTo>
                    <a:pt x="307784" y="92951"/>
                  </a:lnTo>
                  <a:lnTo>
                    <a:pt x="307784" y="94475"/>
                  </a:lnTo>
                  <a:lnTo>
                    <a:pt x="309308" y="95999"/>
                  </a:lnTo>
                  <a:lnTo>
                    <a:pt x="309308" y="97523"/>
                  </a:lnTo>
                  <a:lnTo>
                    <a:pt x="309308" y="99047"/>
                  </a:lnTo>
                  <a:lnTo>
                    <a:pt x="310832" y="100571"/>
                  </a:lnTo>
                  <a:lnTo>
                    <a:pt x="310832" y="102095"/>
                  </a:lnTo>
                  <a:lnTo>
                    <a:pt x="310832" y="103632"/>
                  </a:lnTo>
                  <a:lnTo>
                    <a:pt x="310832" y="105143"/>
                  </a:lnTo>
                  <a:lnTo>
                    <a:pt x="310832" y="106667"/>
                  </a:lnTo>
                  <a:lnTo>
                    <a:pt x="310832" y="108191"/>
                  </a:lnTo>
                  <a:lnTo>
                    <a:pt x="312356" y="108191"/>
                  </a:lnTo>
                  <a:lnTo>
                    <a:pt x="312356" y="127990"/>
                  </a:lnTo>
                  <a:lnTo>
                    <a:pt x="310832" y="127990"/>
                  </a:lnTo>
                  <a:lnTo>
                    <a:pt x="310832" y="137147"/>
                  </a:lnTo>
                  <a:lnTo>
                    <a:pt x="309308" y="138658"/>
                  </a:lnTo>
                  <a:lnTo>
                    <a:pt x="309308" y="140182"/>
                  </a:lnTo>
                  <a:lnTo>
                    <a:pt x="309308" y="141719"/>
                  </a:lnTo>
                  <a:lnTo>
                    <a:pt x="309308" y="143243"/>
                  </a:lnTo>
                  <a:lnTo>
                    <a:pt x="309308" y="144767"/>
                  </a:lnTo>
                  <a:lnTo>
                    <a:pt x="307784" y="144767"/>
                  </a:lnTo>
                  <a:lnTo>
                    <a:pt x="307784" y="146291"/>
                  </a:lnTo>
                  <a:lnTo>
                    <a:pt x="307784" y="147815"/>
                  </a:lnTo>
                  <a:lnTo>
                    <a:pt x="307784" y="149326"/>
                  </a:lnTo>
                  <a:lnTo>
                    <a:pt x="306260" y="149326"/>
                  </a:lnTo>
                  <a:lnTo>
                    <a:pt x="306260" y="150850"/>
                  </a:lnTo>
                  <a:lnTo>
                    <a:pt x="306260" y="152374"/>
                  </a:lnTo>
                  <a:lnTo>
                    <a:pt x="306260" y="153911"/>
                  </a:lnTo>
                  <a:lnTo>
                    <a:pt x="304736" y="155435"/>
                  </a:lnTo>
                  <a:lnTo>
                    <a:pt x="304736" y="156959"/>
                  </a:lnTo>
                  <a:lnTo>
                    <a:pt x="304736" y="158483"/>
                  </a:lnTo>
                  <a:lnTo>
                    <a:pt x="304736" y="159994"/>
                  </a:lnTo>
                  <a:lnTo>
                    <a:pt x="303212" y="159994"/>
                  </a:lnTo>
                  <a:lnTo>
                    <a:pt x="303212" y="161518"/>
                  </a:lnTo>
                  <a:lnTo>
                    <a:pt x="303212" y="163042"/>
                  </a:lnTo>
                  <a:lnTo>
                    <a:pt x="303212" y="164566"/>
                  </a:lnTo>
                  <a:lnTo>
                    <a:pt x="301688" y="166090"/>
                  </a:lnTo>
                  <a:lnTo>
                    <a:pt x="301688" y="167627"/>
                  </a:lnTo>
                  <a:lnTo>
                    <a:pt x="300164" y="169151"/>
                  </a:lnTo>
                  <a:lnTo>
                    <a:pt x="300164" y="170662"/>
                  </a:lnTo>
                  <a:lnTo>
                    <a:pt x="300164" y="172186"/>
                  </a:lnTo>
                  <a:lnTo>
                    <a:pt x="298640" y="173710"/>
                  </a:lnTo>
                  <a:lnTo>
                    <a:pt x="298640" y="175234"/>
                  </a:lnTo>
                  <a:lnTo>
                    <a:pt x="298640" y="176758"/>
                  </a:lnTo>
                  <a:lnTo>
                    <a:pt x="297116" y="178282"/>
                  </a:lnTo>
                  <a:lnTo>
                    <a:pt x="297116" y="179819"/>
                  </a:lnTo>
                  <a:lnTo>
                    <a:pt x="295592" y="181330"/>
                  </a:lnTo>
                  <a:lnTo>
                    <a:pt x="295592" y="182854"/>
                  </a:lnTo>
                  <a:lnTo>
                    <a:pt x="295592" y="184378"/>
                  </a:lnTo>
                  <a:lnTo>
                    <a:pt x="294081" y="184378"/>
                  </a:lnTo>
                  <a:lnTo>
                    <a:pt x="294081" y="185902"/>
                  </a:lnTo>
                  <a:lnTo>
                    <a:pt x="294081" y="187426"/>
                  </a:lnTo>
                  <a:lnTo>
                    <a:pt x="294081" y="188950"/>
                  </a:lnTo>
                  <a:lnTo>
                    <a:pt x="292544" y="188950"/>
                  </a:lnTo>
                  <a:lnTo>
                    <a:pt x="292544" y="190474"/>
                  </a:lnTo>
                  <a:lnTo>
                    <a:pt x="291020" y="191998"/>
                  </a:lnTo>
                  <a:lnTo>
                    <a:pt x="291020" y="193522"/>
                  </a:lnTo>
                  <a:lnTo>
                    <a:pt x="291020" y="195046"/>
                  </a:lnTo>
                  <a:lnTo>
                    <a:pt x="289509" y="195046"/>
                  </a:lnTo>
                  <a:lnTo>
                    <a:pt x="289509" y="196570"/>
                  </a:lnTo>
                  <a:lnTo>
                    <a:pt x="289509" y="198094"/>
                  </a:lnTo>
                  <a:lnTo>
                    <a:pt x="287985" y="199618"/>
                  </a:lnTo>
                  <a:lnTo>
                    <a:pt x="287985" y="201142"/>
                  </a:lnTo>
                  <a:lnTo>
                    <a:pt x="286448" y="202653"/>
                  </a:lnTo>
                  <a:lnTo>
                    <a:pt x="286448" y="204190"/>
                  </a:lnTo>
                  <a:lnTo>
                    <a:pt x="284924" y="205714"/>
                  </a:lnTo>
                  <a:lnTo>
                    <a:pt x="284924" y="207238"/>
                  </a:lnTo>
                  <a:lnTo>
                    <a:pt x="284924" y="208762"/>
                  </a:lnTo>
                  <a:lnTo>
                    <a:pt x="283413" y="208762"/>
                  </a:lnTo>
                  <a:lnTo>
                    <a:pt x="283413" y="210286"/>
                  </a:lnTo>
                  <a:lnTo>
                    <a:pt x="283413" y="211810"/>
                  </a:lnTo>
                  <a:lnTo>
                    <a:pt x="281889" y="211810"/>
                  </a:lnTo>
                  <a:lnTo>
                    <a:pt x="281889" y="213334"/>
                  </a:lnTo>
                  <a:lnTo>
                    <a:pt x="280352" y="214845"/>
                  </a:lnTo>
                  <a:lnTo>
                    <a:pt x="280352" y="216369"/>
                  </a:lnTo>
                  <a:lnTo>
                    <a:pt x="278841" y="217906"/>
                  </a:lnTo>
                  <a:lnTo>
                    <a:pt x="278841" y="219430"/>
                  </a:lnTo>
                  <a:lnTo>
                    <a:pt x="277317" y="220954"/>
                  </a:lnTo>
                  <a:lnTo>
                    <a:pt x="275793" y="222478"/>
                  </a:lnTo>
                  <a:lnTo>
                    <a:pt x="275793" y="224002"/>
                  </a:lnTo>
                  <a:lnTo>
                    <a:pt x="274256" y="225513"/>
                  </a:lnTo>
                  <a:lnTo>
                    <a:pt x="274256" y="227037"/>
                  </a:lnTo>
                  <a:lnTo>
                    <a:pt x="272745" y="228561"/>
                  </a:lnTo>
                  <a:lnTo>
                    <a:pt x="272745" y="230098"/>
                  </a:lnTo>
                  <a:lnTo>
                    <a:pt x="271221" y="230098"/>
                  </a:lnTo>
                  <a:lnTo>
                    <a:pt x="271221" y="231622"/>
                  </a:lnTo>
                  <a:lnTo>
                    <a:pt x="269697" y="231622"/>
                  </a:lnTo>
                  <a:lnTo>
                    <a:pt x="269697" y="233146"/>
                  </a:lnTo>
                  <a:lnTo>
                    <a:pt x="269697" y="234670"/>
                  </a:lnTo>
                  <a:lnTo>
                    <a:pt x="268173" y="234670"/>
                  </a:lnTo>
                  <a:lnTo>
                    <a:pt x="268173" y="236181"/>
                  </a:lnTo>
                  <a:lnTo>
                    <a:pt x="268173" y="237705"/>
                  </a:lnTo>
                  <a:lnTo>
                    <a:pt x="266649" y="239229"/>
                  </a:lnTo>
                  <a:lnTo>
                    <a:pt x="265125" y="240753"/>
                  </a:lnTo>
                  <a:lnTo>
                    <a:pt x="265125" y="242290"/>
                  </a:lnTo>
                  <a:lnTo>
                    <a:pt x="263601" y="243814"/>
                  </a:lnTo>
                  <a:lnTo>
                    <a:pt x="263601" y="245338"/>
                  </a:lnTo>
                  <a:lnTo>
                    <a:pt x="262077" y="245338"/>
                  </a:lnTo>
                  <a:lnTo>
                    <a:pt x="262077" y="246862"/>
                  </a:lnTo>
                  <a:lnTo>
                    <a:pt x="260553" y="246862"/>
                  </a:lnTo>
                  <a:lnTo>
                    <a:pt x="260553" y="248373"/>
                  </a:lnTo>
                  <a:lnTo>
                    <a:pt x="260553" y="249897"/>
                  </a:lnTo>
                  <a:lnTo>
                    <a:pt x="259029" y="249897"/>
                  </a:lnTo>
                  <a:lnTo>
                    <a:pt x="259029" y="251421"/>
                  </a:lnTo>
                  <a:lnTo>
                    <a:pt x="257505" y="252945"/>
                  </a:lnTo>
                  <a:lnTo>
                    <a:pt x="257505" y="254469"/>
                  </a:lnTo>
                  <a:lnTo>
                    <a:pt x="255981" y="256006"/>
                  </a:lnTo>
                  <a:lnTo>
                    <a:pt x="254457" y="257530"/>
                  </a:lnTo>
                  <a:lnTo>
                    <a:pt x="254457" y="259041"/>
                  </a:lnTo>
                  <a:lnTo>
                    <a:pt x="252933" y="260565"/>
                  </a:lnTo>
                  <a:lnTo>
                    <a:pt x="252933" y="262089"/>
                  </a:lnTo>
                  <a:lnTo>
                    <a:pt x="251409" y="262089"/>
                  </a:lnTo>
                  <a:lnTo>
                    <a:pt x="251409" y="263613"/>
                  </a:lnTo>
                  <a:lnTo>
                    <a:pt x="249885" y="265137"/>
                  </a:lnTo>
                  <a:lnTo>
                    <a:pt x="249885" y="266661"/>
                  </a:lnTo>
                  <a:lnTo>
                    <a:pt x="248361" y="266661"/>
                  </a:lnTo>
                  <a:lnTo>
                    <a:pt x="248361" y="268198"/>
                  </a:lnTo>
                  <a:lnTo>
                    <a:pt x="246837" y="269709"/>
                  </a:lnTo>
                  <a:lnTo>
                    <a:pt x="246837" y="271233"/>
                  </a:lnTo>
                  <a:lnTo>
                    <a:pt x="245313" y="271233"/>
                  </a:lnTo>
                  <a:lnTo>
                    <a:pt x="245313" y="272757"/>
                  </a:lnTo>
                  <a:lnTo>
                    <a:pt x="243789" y="274281"/>
                  </a:lnTo>
                  <a:lnTo>
                    <a:pt x="243789" y="275805"/>
                  </a:lnTo>
                  <a:lnTo>
                    <a:pt x="242265" y="275805"/>
                  </a:lnTo>
                  <a:lnTo>
                    <a:pt x="242265" y="277329"/>
                  </a:lnTo>
                  <a:lnTo>
                    <a:pt x="242265" y="278853"/>
                  </a:lnTo>
                  <a:lnTo>
                    <a:pt x="240741" y="278853"/>
                  </a:lnTo>
                  <a:lnTo>
                    <a:pt x="240741" y="280377"/>
                  </a:lnTo>
                  <a:lnTo>
                    <a:pt x="239217" y="280377"/>
                  </a:lnTo>
                  <a:lnTo>
                    <a:pt x="239217" y="281901"/>
                  </a:lnTo>
                  <a:lnTo>
                    <a:pt x="237705" y="281901"/>
                  </a:lnTo>
                  <a:lnTo>
                    <a:pt x="237705" y="283425"/>
                  </a:lnTo>
                  <a:lnTo>
                    <a:pt x="237705" y="284949"/>
                  </a:lnTo>
                  <a:lnTo>
                    <a:pt x="236169" y="286473"/>
                  </a:lnTo>
                  <a:lnTo>
                    <a:pt x="234645" y="287997"/>
                  </a:lnTo>
                  <a:lnTo>
                    <a:pt x="234645" y="289521"/>
                  </a:lnTo>
                  <a:lnTo>
                    <a:pt x="233121" y="289521"/>
                  </a:lnTo>
                  <a:lnTo>
                    <a:pt x="233121" y="291033"/>
                  </a:lnTo>
                  <a:lnTo>
                    <a:pt x="233121" y="292557"/>
                  </a:lnTo>
                  <a:lnTo>
                    <a:pt x="231609" y="294093"/>
                  </a:lnTo>
                  <a:lnTo>
                    <a:pt x="230073" y="295617"/>
                  </a:lnTo>
                  <a:lnTo>
                    <a:pt x="228549" y="297141"/>
                  </a:lnTo>
                  <a:lnTo>
                    <a:pt x="228549" y="298665"/>
                  </a:lnTo>
                  <a:lnTo>
                    <a:pt x="228549" y="300189"/>
                  </a:lnTo>
                  <a:lnTo>
                    <a:pt x="227037" y="300189"/>
                  </a:lnTo>
                  <a:lnTo>
                    <a:pt x="227037" y="301701"/>
                  </a:lnTo>
                  <a:lnTo>
                    <a:pt x="225513" y="303225"/>
                  </a:lnTo>
                  <a:lnTo>
                    <a:pt x="225513" y="304749"/>
                  </a:lnTo>
                  <a:lnTo>
                    <a:pt x="223977" y="304749"/>
                  </a:lnTo>
                  <a:lnTo>
                    <a:pt x="223977" y="306285"/>
                  </a:lnTo>
                  <a:lnTo>
                    <a:pt x="222465" y="307809"/>
                  </a:lnTo>
                  <a:lnTo>
                    <a:pt x="222465" y="309333"/>
                  </a:lnTo>
                  <a:lnTo>
                    <a:pt x="220941" y="310857"/>
                  </a:lnTo>
                  <a:lnTo>
                    <a:pt x="219417" y="312369"/>
                  </a:lnTo>
                  <a:lnTo>
                    <a:pt x="219417" y="313893"/>
                  </a:lnTo>
                  <a:lnTo>
                    <a:pt x="217893" y="315417"/>
                  </a:lnTo>
                  <a:lnTo>
                    <a:pt x="217893" y="316941"/>
                  </a:lnTo>
                  <a:lnTo>
                    <a:pt x="216369" y="318477"/>
                  </a:lnTo>
                  <a:lnTo>
                    <a:pt x="214845" y="320001"/>
                  </a:lnTo>
                  <a:lnTo>
                    <a:pt x="214845" y="321525"/>
                  </a:lnTo>
                  <a:lnTo>
                    <a:pt x="213321" y="323037"/>
                  </a:lnTo>
                  <a:lnTo>
                    <a:pt x="213321" y="324561"/>
                  </a:lnTo>
                  <a:lnTo>
                    <a:pt x="211797" y="326085"/>
                  </a:lnTo>
                  <a:lnTo>
                    <a:pt x="211797" y="327609"/>
                  </a:lnTo>
                  <a:lnTo>
                    <a:pt x="211797" y="329133"/>
                  </a:lnTo>
                  <a:lnTo>
                    <a:pt x="210273" y="329133"/>
                  </a:lnTo>
                  <a:lnTo>
                    <a:pt x="210273" y="330657"/>
                  </a:lnTo>
                  <a:lnTo>
                    <a:pt x="208749" y="330657"/>
                  </a:lnTo>
                  <a:lnTo>
                    <a:pt x="208749" y="332193"/>
                  </a:lnTo>
                  <a:lnTo>
                    <a:pt x="208749" y="333717"/>
                  </a:lnTo>
                  <a:lnTo>
                    <a:pt x="207225" y="335229"/>
                  </a:lnTo>
                  <a:lnTo>
                    <a:pt x="207225" y="336753"/>
                  </a:lnTo>
                  <a:lnTo>
                    <a:pt x="205701" y="338277"/>
                  </a:lnTo>
                  <a:lnTo>
                    <a:pt x="205701" y="339801"/>
                  </a:lnTo>
                  <a:lnTo>
                    <a:pt x="204177" y="341325"/>
                  </a:lnTo>
                  <a:lnTo>
                    <a:pt x="204177" y="342849"/>
                  </a:lnTo>
                  <a:lnTo>
                    <a:pt x="204177" y="344385"/>
                  </a:lnTo>
                  <a:lnTo>
                    <a:pt x="202653" y="344385"/>
                  </a:lnTo>
                  <a:lnTo>
                    <a:pt x="202653" y="345897"/>
                  </a:lnTo>
                  <a:lnTo>
                    <a:pt x="202653" y="347421"/>
                  </a:lnTo>
                  <a:lnTo>
                    <a:pt x="201129" y="348945"/>
                  </a:lnTo>
                  <a:lnTo>
                    <a:pt x="201129" y="350469"/>
                  </a:lnTo>
                  <a:lnTo>
                    <a:pt x="199605" y="351993"/>
                  </a:lnTo>
                  <a:lnTo>
                    <a:pt x="199605" y="353517"/>
                  </a:lnTo>
                  <a:lnTo>
                    <a:pt x="199605" y="355041"/>
                  </a:lnTo>
                  <a:lnTo>
                    <a:pt x="198081" y="356577"/>
                  </a:lnTo>
                  <a:lnTo>
                    <a:pt x="198081" y="358089"/>
                  </a:lnTo>
                  <a:lnTo>
                    <a:pt x="198081" y="359613"/>
                  </a:lnTo>
                  <a:lnTo>
                    <a:pt x="198081" y="361137"/>
                  </a:lnTo>
                  <a:lnTo>
                    <a:pt x="196557" y="361137"/>
                  </a:lnTo>
                  <a:lnTo>
                    <a:pt x="196557" y="362661"/>
                  </a:lnTo>
                  <a:lnTo>
                    <a:pt x="196557" y="364185"/>
                  </a:lnTo>
                  <a:lnTo>
                    <a:pt x="196557" y="365709"/>
                  </a:lnTo>
                  <a:lnTo>
                    <a:pt x="196557" y="367233"/>
                  </a:lnTo>
                  <a:lnTo>
                    <a:pt x="195033" y="367233"/>
                  </a:lnTo>
                  <a:lnTo>
                    <a:pt x="195033" y="368757"/>
                  </a:lnTo>
                  <a:lnTo>
                    <a:pt x="195033" y="370281"/>
                  </a:lnTo>
                  <a:lnTo>
                    <a:pt x="193509" y="371805"/>
                  </a:lnTo>
                  <a:lnTo>
                    <a:pt x="193509" y="373329"/>
                  </a:lnTo>
                  <a:lnTo>
                    <a:pt x="193509" y="374853"/>
                  </a:lnTo>
                  <a:lnTo>
                    <a:pt x="193509" y="376377"/>
                  </a:lnTo>
                  <a:lnTo>
                    <a:pt x="193509" y="377901"/>
                  </a:lnTo>
                  <a:lnTo>
                    <a:pt x="191985" y="379412"/>
                  </a:lnTo>
                  <a:lnTo>
                    <a:pt x="191985" y="387045"/>
                  </a:lnTo>
                  <a:lnTo>
                    <a:pt x="190461" y="387045"/>
                  </a:lnTo>
                  <a:lnTo>
                    <a:pt x="190461" y="388569"/>
                  </a:lnTo>
                  <a:lnTo>
                    <a:pt x="190461" y="390080"/>
                  </a:lnTo>
                  <a:lnTo>
                    <a:pt x="190461" y="391604"/>
                  </a:lnTo>
                  <a:lnTo>
                    <a:pt x="190461" y="393128"/>
                  </a:lnTo>
                  <a:lnTo>
                    <a:pt x="188937" y="394665"/>
                  </a:lnTo>
                  <a:lnTo>
                    <a:pt x="188937" y="402272"/>
                  </a:lnTo>
                  <a:lnTo>
                    <a:pt x="187413" y="403796"/>
                  </a:lnTo>
                  <a:lnTo>
                    <a:pt x="187413" y="412940"/>
                  </a:lnTo>
                  <a:lnTo>
                    <a:pt x="185889" y="412940"/>
                  </a:lnTo>
                  <a:lnTo>
                    <a:pt x="185889" y="414464"/>
                  </a:lnTo>
                  <a:lnTo>
                    <a:pt x="185889" y="415988"/>
                  </a:lnTo>
                  <a:lnTo>
                    <a:pt x="185889" y="417512"/>
                  </a:lnTo>
                  <a:lnTo>
                    <a:pt x="184365" y="419036"/>
                  </a:lnTo>
                  <a:lnTo>
                    <a:pt x="184365" y="426656"/>
                  </a:lnTo>
                  <a:lnTo>
                    <a:pt x="182841" y="426656"/>
                  </a:lnTo>
                  <a:lnTo>
                    <a:pt x="182841" y="428180"/>
                  </a:lnTo>
                  <a:lnTo>
                    <a:pt x="182841" y="429704"/>
                  </a:lnTo>
                  <a:lnTo>
                    <a:pt x="182841" y="431228"/>
                  </a:lnTo>
                  <a:lnTo>
                    <a:pt x="182841" y="432752"/>
                  </a:lnTo>
                  <a:lnTo>
                    <a:pt x="181317" y="432752"/>
                  </a:lnTo>
                  <a:lnTo>
                    <a:pt x="181317" y="440372"/>
                  </a:lnTo>
                  <a:lnTo>
                    <a:pt x="179793" y="440372"/>
                  </a:lnTo>
                  <a:lnTo>
                    <a:pt x="179793" y="441896"/>
                  </a:lnTo>
                  <a:lnTo>
                    <a:pt x="179793" y="443420"/>
                  </a:lnTo>
                  <a:lnTo>
                    <a:pt x="178269" y="444944"/>
                  </a:lnTo>
                  <a:lnTo>
                    <a:pt x="178269" y="446468"/>
                  </a:lnTo>
                  <a:lnTo>
                    <a:pt x="178269" y="447992"/>
                  </a:lnTo>
                  <a:lnTo>
                    <a:pt x="178269" y="449516"/>
                  </a:lnTo>
                  <a:lnTo>
                    <a:pt x="176745" y="451040"/>
                  </a:lnTo>
                  <a:lnTo>
                    <a:pt x="135610" y="45104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2245474" y="6386113"/>
              <a:ext cx="254635" cy="454659"/>
            </a:xfrm>
            <a:custGeom>
              <a:avLst/>
              <a:gdLst/>
              <a:ahLst/>
              <a:cxnLst/>
              <a:rect l="l" t="t" r="r" b="b"/>
              <a:pathLst>
                <a:path w="254635" h="454659">
                  <a:moveTo>
                    <a:pt x="167601" y="0"/>
                  </a:moveTo>
                  <a:lnTo>
                    <a:pt x="85318" y="0"/>
                  </a:lnTo>
                  <a:lnTo>
                    <a:pt x="85318" y="3048"/>
                  </a:lnTo>
                  <a:lnTo>
                    <a:pt x="82270" y="6096"/>
                  </a:lnTo>
                  <a:lnTo>
                    <a:pt x="82270" y="7620"/>
                  </a:lnTo>
                  <a:lnTo>
                    <a:pt x="80746" y="7620"/>
                  </a:lnTo>
                  <a:lnTo>
                    <a:pt x="80746" y="9144"/>
                  </a:lnTo>
                  <a:lnTo>
                    <a:pt x="79222" y="10668"/>
                  </a:lnTo>
                  <a:lnTo>
                    <a:pt x="79222" y="12192"/>
                  </a:lnTo>
                  <a:lnTo>
                    <a:pt x="77698" y="12192"/>
                  </a:lnTo>
                  <a:lnTo>
                    <a:pt x="77698" y="13716"/>
                  </a:lnTo>
                  <a:lnTo>
                    <a:pt x="76174" y="15240"/>
                  </a:lnTo>
                  <a:lnTo>
                    <a:pt x="76174" y="16751"/>
                  </a:lnTo>
                  <a:lnTo>
                    <a:pt x="73126" y="19812"/>
                  </a:lnTo>
                  <a:lnTo>
                    <a:pt x="73126" y="21336"/>
                  </a:lnTo>
                  <a:lnTo>
                    <a:pt x="71602" y="22860"/>
                  </a:lnTo>
                  <a:lnTo>
                    <a:pt x="71602" y="24384"/>
                  </a:lnTo>
                  <a:lnTo>
                    <a:pt x="70091" y="24384"/>
                  </a:lnTo>
                  <a:lnTo>
                    <a:pt x="70091" y="25908"/>
                  </a:lnTo>
                  <a:lnTo>
                    <a:pt x="68567" y="27419"/>
                  </a:lnTo>
                  <a:lnTo>
                    <a:pt x="68567" y="28943"/>
                  </a:lnTo>
                  <a:lnTo>
                    <a:pt x="67030" y="28943"/>
                  </a:lnTo>
                  <a:lnTo>
                    <a:pt x="67030" y="30480"/>
                  </a:lnTo>
                  <a:lnTo>
                    <a:pt x="65506" y="30480"/>
                  </a:lnTo>
                  <a:lnTo>
                    <a:pt x="65506" y="33528"/>
                  </a:lnTo>
                  <a:lnTo>
                    <a:pt x="63995" y="33528"/>
                  </a:lnTo>
                  <a:lnTo>
                    <a:pt x="63995" y="35052"/>
                  </a:lnTo>
                  <a:lnTo>
                    <a:pt x="62471" y="35052"/>
                  </a:lnTo>
                  <a:lnTo>
                    <a:pt x="62471" y="38087"/>
                  </a:lnTo>
                  <a:lnTo>
                    <a:pt x="60934" y="38087"/>
                  </a:lnTo>
                  <a:lnTo>
                    <a:pt x="60934" y="39611"/>
                  </a:lnTo>
                  <a:lnTo>
                    <a:pt x="57899" y="42659"/>
                  </a:lnTo>
                  <a:lnTo>
                    <a:pt x="57899" y="44196"/>
                  </a:lnTo>
                  <a:lnTo>
                    <a:pt x="56375" y="44196"/>
                  </a:lnTo>
                  <a:lnTo>
                    <a:pt x="56375" y="45720"/>
                  </a:lnTo>
                  <a:lnTo>
                    <a:pt x="54838" y="47244"/>
                  </a:lnTo>
                  <a:lnTo>
                    <a:pt x="54838" y="48755"/>
                  </a:lnTo>
                  <a:lnTo>
                    <a:pt x="53327" y="50279"/>
                  </a:lnTo>
                  <a:lnTo>
                    <a:pt x="51803" y="50279"/>
                  </a:lnTo>
                  <a:lnTo>
                    <a:pt x="51803" y="53327"/>
                  </a:lnTo>
                  <a:lnTo>
                    <a:pt x="50279" y="53327"/>
                  </a:lnTo>
                  <a:lnTo>
                    <a:pt x="50279" y="54851"/>
                  </a:lnTo>
                  <a:lnTo>
                    <a:pt x="48755" y="56388"/>
                  </a:lnTo>
                  <a:lnTo>
                    <a:pt x="47231" y="56388"/>
                  </a:lnTo>
                  <a:lnTo>
                    <a:pt x="47231" y="59436"/>
                  </a:lnTo>
                  <a:lnTo>
                    <a:pt x="45707" y="59436"/>
                  </a:lnTo>
                  <a:lnTo>
                    <a:pt x="45707" y="60947"/>
                  </a:lnTo>
                  <a:lnTo>
                    <a:pt x="42659" y="63995"/>
                  </a:lnTo>
                  <a:lnTo>
                    <a:pt x="42659" y="65519"/>
                  </a:lnTo>
                  <a:lnTo>
                    <a:pt x="41135" y="65519"/>
                  </a:lnTo>
                  <a:lnTo>
                    <a:pt x="41135" y="68580"/>
                  </a:lnTo>
                  <a:lnTo>
                    <a:pt x="39611" y="68580"/>
                  </a:lnTo>
                  <a:lnTo>
                    <a:pt x="39611" y="70104"/>
                  </a:lnTo>
                  <a:lnTo>
                    <a:pt x="38087" y="70104"/>
                  </a:lnTo>
                  <a:lnTo>
                    <a:pt x="38087" y="71615"/>
                  </a:lnTo>
                  <a:lnTo>
                    <a:pt x="35039" y="74663"/>
                  </a:lnTo>
                  <a:lnTo>
                    <a:pt x="35039" y="76187"/>
                  </a:lnTo>
                  <a:lnTo>
                    <a:pt x="33515" y="76187"/>
                  </a:lnTo>
                  <a:lnTo>
                    <a:pt x="33515" y="77711"/>
                  </a:lnTo>
                  <a:lnTo>
                    <a:pt x="30467" y="80759"/>
                  </a:lnTo>
                  <a:lnTo>
                    <a:pt x="30467" y="82283"/>
                  </a:lnTo>
                  <a:lnTo>
                    <a:pt x="25895" y="86855"/>
                  </a:lnTo>
                  <a:lnTo>
                    <a:pt x="25895" y="88379"/>
                  </a:lnTo>
                  <a:lnTo>
                    <a:pt x="24371" y="89903"/>
                  </a:lnTo>
                  <a:lnTo>
                    <a:pt x="24371" y="91427"/>
                  </a:lnTo>
                  <a:lnTo>
                    <a:pt x="22847" y="91427"/>
                  </a:lnTo>
                  <a:lnTo>
                    <a:pt x="22847" y="92938"/>
                  </a:lnTo>
                  <a:lnTo>
                    <a:pt x="21323" y="94475"/>
                  </a:lnTo>
                  <a:lnTo>
                    <a:pt x="21323" y="95999"/>
                  </a:lnTo>
                  <a:lnTo>
                    <a:pt x="19799" y="95999"/>
                  </a:lnTo>
                  <a:lnTo>
                    <a:pt x="19799" y="97523"/>
                  </a:lnTo>
                  <a:lnTo>
                    <a:pt x="16751" y="100571"/>
                  </a:lnTo>
                  <a:lnTo>
                    <a:pt x="16751" y="102095"/>
                  </a:lnTo>
                  <a:lnTo>
                    <a:pt x="15227" y="102095"/>
                  </a:lnTo>
                  <a:lnTo>
                    <a:pt x="15227" y="105130"/>
                  </a:lnTo>
                  <a:lnTo>
                    <a:pt x="13703" y="105130"/>
                  </a:lnTo>
                  <a:lnTo>
                    <a:pt x="13703" y="106667"/>
                  </a:lnTo>
                  <a:lnTo>
                    <a:pt x="12191" y="106667"/>
                  </a:lnTo>
                  <a:lnTo>
                    <a:pt x="12191" y="109715"/>
                  </a:lnTo>
                  <a:lnTo>
                    <a:pt x="10655" y="111239"/>
                  </a:lnTo>
                  <a:lnTo>
                    <a:pt x="10655" y="112763"/>
                  </a:lnTo>
                  <a:lnTo>
                    <a:pt x="9131" y="112763"/>
                  </a:lnTo>
                  <a:lnTo>
                    <a:pt x="9131" y="115798"/>
                  </a:lnTo>
                  <a:lnTo>
                    <a:pt x="7619" y="117322"/>
                  </a:lnTo>
                  <a:lnTo>
                    <a:pt x="7619" y="118859"/>
                  </a:lnTo>
                  <a:lnTo>
                    <a:pt x="6095" y="118859"/>
                  </a:lnTo>
                  <a:lnTo>
                    <a:pt x="6095" y="121907"/>
                  </a:lnTo>
                  <a:lnTo>
                    <a:pt x="4559" y="123431"/>
                  </a:lnTo>
                  <a:lnTo>
                    <a:pt x="4559" y="126466"/>
                  </a:lnTo>
                  <a:lnTo>
                    <a:pt x="3047" y="127990"/>
                  </a:lnTo>
                  <a:lnTo>
                    <a:pt x="3047" y="129514"/>
                  </a:lnTo>
                  <a:lnTo>
                    <a:pt x="1523" y="131038"/>
                  </a:lnTo>
                  <a:lnTo>
                    <a:pt x="1523" y="135623"/>
                  </a:lnTo>
                  <a:lnTo>
                    <a:pt x="0" y="137134"/>
                  </a:lnTo>
                  <a:lnTo>
                    <a:pt x="0" y="164566"/>
                  </a:lnTo>
                  <a:lnTo>
                    <a:pt x="1523" y="166090"/>
                  </a:lnTo>
                  <a:lnTo>
                    <a:pt x="1523" y="170662"/>
                  </a:lnTo>
                  <a:lnTo>
                    <a:pt x="3047" y="172186"/>
                  </a:lnTo>
                  <a:lnTo>
                    <a:pt x="3047" y="175234"/>
                  </a:lnTo>
                  <a:lnTo>
                    <a:pt x="4559" y="175234"/>
                  </a:lnTo>
                  <a:lnTo>
                    <a:pt x="4559" y="179806"/>
                  </a:lnTo>
                  <a:lnTo>
                    <a:pt x="6095" y="179806"/>
                  </a:lnTo>
                  <a:lnTo>
                    <a:pt x="6095" y="182854"/>
                  </a:lnTo>
                  <a:lnTo>
                    <a:pt x="7619" y="184378"/>
                  </a:lnTo>
                  <a:lnTo>
                    <a:pt x="7619" y="185902"/>
                  </a:lnTo>
                  <a:lnTo>
                    <a:pt x="9131" y="185902"/>
                  </a:lnTo>
                  <a:lnTo>
                    <a:pt x="9131" y="188950"/>
                  </a:lnTo>
                  <a:lnTo>
                    <a:pt x="10655" y="190474"/>
                  </a:lnTo>
                  <a:lnTo>
                    <a:pt x="10655" y="193509"/>
                  </a:lnTo>
                  <a:lnTo>
                    <a:pt x="12191" y="193509"/>
                  </a:lnTo>
                  <a:lnTo>
                    <a:pt x="12191" y="195046"/>
                  </a:lnTo>
                  <a:lnTo>
                    <a:pt x="13703" y="196570"/>
                  </a:lnTo>
                  <a:lnTo>
                    <a:pt x="13703" y="198094"/>
                  </a:lnTo>
                  <a:lnTo>
                    <a:pt x="15227" y="199618"/>
                  </a:lnTo>
                  <a:lnTo>
                    <a:pt x="15227" y="201142"/>
                  </a:lnTo>
                  <a:lnTo>
                    <a:pt x="16751" y="201142"/>
                  </a:lnTo>
                  <a:lnTo>
                    <a:pt x="16751" y="204177"/>
                  </a:lnTo>
                  <a:lnTo>
                    <a:pt x="19799" y="207238"/>
                  </a:lnTo>
                  <a:lnTo>
                    <a:pt x="19799" y="208762"/>
                  </a:lnTo>
                  <a:lnTo>
                    <a:pt x="21323" y="210286"/>
                  </a:lnTo>
                  <a:lnTo>
                    <a:pt x="21323" y="211810"/>
                  </a:lnTo>
                  <a:lnTo>
                    <a:pt x="22847" y="213334"/>
                  </a:lnTo>
                  <a:lnTo>
                    <a:pt x="22847" y="214845"/>
                  </a:lnTo>
                  <a:lnTo>
                    <a:pt x="24371" y="214845"/>
                  </a:lnTo>
                  <a:lnTo>
                    <a:pt x="24371" y="216369"/>
                  </a:lnTo>
                  <a:lnTo>
                    <a:pt x="25895" y="217893"/>
                  </a:lnTo>
                  <a:lnTo>
                    <a:pt x="25895" y="220954"/>
                  </a:lnTo>
                  <a:lnTo>
                    <a:pt x="27419" y="220954"/>
                  </a:lnTo>
                  <a:lnTo>
                    <a:pt x="27419" y="222478"/>
                  </a:lnTo>
                  <a:lnTo>
                    <a:pt x="28943" y="224002"/>
                  </a:lnTo>
                  <a:lnTo>
                    <a:pt x="28943" y="225513"/>
                  </a:lnTo>
                  <a:lnTo>
                    <a:pt x="30467" y="227037"/>
                  </a:lnTo>
                  <a:lnTo>
                    <a:pt x="30467" y="228561"/>
                  </a:lnTo>
                  <a:lnTo>
                    <a:pt x="31991" y="230085"/>
                  </a:lnTo>
                  <a:lnTo>
                    <a:pt x="31991" y="233146"/>
                  </a:lnTo>
                  <a:lnTo>
                    <a:pt x="33515" y="233146"/>
                  </a:lnTo>
                  <a:lnTo>
                    <a:pt x="33515" y="234670"/>
                  </a:lnTo>
                  <a:lnTo>
                    <a:pt x="35039" y="236181"/>
                  </a:lnTo>
                  <a:lnTo>
                    <a:pt x="35039" y="239229"/>
                  </a:lnTo>
                  <a:lnTo>
                    <a:pt x="36563" y="239229"/>
                  </a:lnTo>
                  <a:lnTo>
                    <a:pt x="36563" y="243801"/>
                  </a:lnTo>
                  <a:lnTo>
                    <a:pt x="38087" y="243801"/>
                  </a:lnTo>
                  <a:lnTo>
                    <a:pt x="38087" y="246849"/>
                  </a:lnTo>
                  <a:lnTo>
                    <a:pt x="39611" y="246849"/>
                  </a:lnTo>
                  <a:lnTo>
                    <a:pt x="39611" y="251421"/>
                  </a:lnTo>
                  <a:lnTo>
                    <a:pt x="41135" y="252945"/>
                  </a:lnTo>
                  <a:lnTo>
                    <a:pt x="41135" y="260565"/>
                  </a:lnTo>
                  <a:lnTo>
                    <a:pt x="42659" y="260565"/>
                  </a:lnTo>
                  <a:lnTo>
                    <a:pt x="42659" y="297141"/>
                  </a:lnTo>
                  <a:lnTo>
                    <a:pt x="41135" y="297141"/>
                  </a:lnTo>
                  <a:lnTo>
                    <a:pt x="41135" y="306273"/>
                  </a:lnTo>
                  <a:lnTo>
                    <a:pt x="39611" y="307797"/>
                  </a:lnTo>
                  <a:lnTo>
                    <a:pt x="39611" y="315417"/>
                  </a:lnTo>
                  <a:lnTo>
                    <a:pt x="38087" y="316941"/>
                  </a:lnTo>
                  <a:lnTo>
                    <a:pt x="38087" y="323049"/>
                  </a:lnTo>
                  <a:lnTo>
                    <a:pt x="36563" y="323049"/>
                  </a:lnTo>
                  <a:lnTo>
                    <a:pt x="36563" y="333705"/>
                  </a:lnTo>
                  <a:lnTo>
                    <a:pt x="35039" y="333705"/>
                  </a:lnTo>
                  <a:lnTo>
                    <a:pt x="35039" y="361137"/>
                  </a:lnTo>
                  <a:lnTo>
                    <a:pt x="36563" y="361137"/>
                  </a:lnTo>
                  <a:lnTo>
                    <a:pt x="36563" y="370268"/>
                  </a:lnTo>
                  <a:lnTo>
                    <a:pt x="38087" y="370268"/>
                  </a:lnTo>
                  <a:lnTo>
                    <a:pt x="38087" y="373329"/>
                  </a:lnTo>
                  <a:lnTo>
                    <a:pt x="39611" y="374853"/>
                  </a:lnTo>
                  <a:lnTo>
                    <a:pt x="39611" y="379412"/>
                  </a:lnTo>
                  <a:lnTo>
                    <a:pt x="41135" y="379412"/>
                  </a:lnTo>
                  <a:lnTo>
                    <a:pt x="41135" y="382460"/>
                  </a:lnTo>
                  <a:lnTo>
                    <a:pt x="42659" y="383984"/>
                  </a:lnTo>
                  <a:lnTo>
                    <a:pt x="42659" y="387045"/>
                  </a:lnTo>
                  <a:lnTo>
                    <a:pt x="44183" y="388556"/>
                  </a:lnTo>
                  <a:lnTo>
                    <a:pt x="44183" y="390080"/>
                  </a:lnTo>
                  <a:lnTo>
                    <a:pt x="45707" y="390080"/>
                  </a:lnTo>
                  <a:lnTo>
                    <a:pt x="45707" y="393128"/>
                  </a:lnTo>
                  <a:lnTo>
                    <a:pt x="47231" y="394652"/>
                  </a:lnTo>
                  <a:lnTo>
                    <a:pt x="47231" y="396176"/>
                  </a:lnTo>
                  <a:lnTo>
                    <a:pt x="50279" y="399237"/>
                  </a:lnTo>
                  <a:lnTo>
                    <a:pt x="50279" y="400748"/>
                  </a:lnTo>
                  <a:lnTo>
                    <a:pt x="51803" y="402272"/>
                  </a:lnTo>
                  <a:lnTo>
                    <a:pt x="51803" y="405320"/>
                  </a:lnTo>
                  <a:lnTo>
                    <a:pt x="53327" y="405320"/>
                  </a:lnTo>
                  <a:lnTo>
                    <a:pt x="53327" y="406844"/>
                  </a:lnTo>
                  <a:lnTo>
                    <a:pt x="54838" y="406844"/>
                  </a:lnTo>
                  <a:lnTo>
                    <a:pt x="54838" y="409905"/>
                  </a:lnTo>
                  <a:lnTo>
                    <a:pt x="56375" y="409905"/>
                  </a:lnTo>
                  <a:lnTo>
                    <a:pt x="56375" y="411416"/>
                  </a:lnTo>
                  <a:lnTo>
                    <a:pt x="57899" y="412940"/>
                  </a:lnTo>
                  <a:lnTo>
                    <a:pt x="57899" y="414464"/>
                  </a:lnTo>
                  <a:lnTo>
                    <a:pt x="62471" y="419036"/>
                  </a:lnTo>
                  <a:lnTo>
                    <a:pt x="62471" y="420560"/>
                  </a:lnTo>
                  <a:lnTo>
                    <a:pt x="65506" y="423608"/>
                  </a:lnTo>
                  <a:lnTo>
                    <a:pt x="65506" y="425132"/>
                  </a:lnTo>
                  <a:lnTo>
                    <a:pt x="70091" y="429704"/>
                  </a:lnTo>
                  <a:lnTo>
                    <a:pt x="70091" y="431228"/>
                  </a:lnTo>
                  <a:lnTo>
                    <a:pt x="73126" y="434263"/>
                  </a:lnTo>
                  <a:lnTo>
                    <a:pt x="73126" y="435800"/>
                  </a:lnTo>
                  <a:lnTo>
                    <a:pt x="76174" y="438848"/>
                  </a:lnTo>
                  <a:lnTo>
                    <a:pt x="76174" y="440372"/>
                  </a:lnTo>
                  <a:lnTo>
                    <a:pt x="80746" y="444931"/>
                  </a:lnTo>
                  <a:lnTo>
                    <a:pt x="80746" y="446455"/>
                  </a:lnTo>
                  <a:lnTo>
                    <a:pt x="82270" y="447992"/>
                  </a:lnTo>
                  <a:lnTo>
                    <a:pt x="82270" y="449516"/>
                  </a:lnTo>
                  <a:lnTo>
                    <a:pt x="83794" y="449516"/>
                  </a:lnTo>
                  <a:lnTo>
                    <a:pt x="85318" y="451040"/>
                  </a:lnTo>
                  <a:lnTo>
                    <a:pt x="85318" y="452564"/>
                  </a:lnTo>
                  <a:lnTo>
                    <a:pt x="86842" y="454088"/>
                  </a:lnTo>
                  <a:lnTo>
                    <a:pt x="167601" y="454088"/>
                  </a:lnTo>
                  <a:lnTo>
                    <a:pt x="167601" y="452564"/>
                  </a:lnTo>
                  <a:lnTo>
                    <a:pt x="169125" y="451040"/>
                  </a:lnTo>
                  <a:lnTo>
                    <a:pt x="169125" y="449516"/>
                  </a:lnTo>
                  <a:lnTo>
                    <a:pt x="170649" y="449516"/>
                  </a:lnTo>
                  <a:lnTo>
                    <a:pt x="170649" y="447992"/>
                  </a:lnTo>
                  <a:lnTo>
                    <a:pt x="172173" y="447992"/>
                  </a:lnTo>
                  <a:lnTo>
                    <a:pt x="172173" y="444931"/>
                  </a:lnTo>
                  <a:lnTo>
                    <a:pt x="173685" y="444931"/>
                  </a:lnTo>
                  <a:lnTo>
                    <a:pt x="173685" y="443420"/>
                  </a:lnTo>
                  <a:lnTo>
                    <a:pt x="175209" y="443420"/>
                  </a:lnTo>
                  <a:lnTo>
                    <a:pt x="175209" y="441896"/>
                  </a:lnTo>
                  <a:lnTo>
                    <a:pt x="176745" y="441896"/>
                  </a:lnTo>
                  <a:lnTo>
                    <a:pt x="176745" y="438848"/>
                  </a:lnTo>
                  <a:lnTo>
                    <a:pt x="178269" y="438848"/>
                  </a:lnTo>
                  <a:lnTo>
                    <a:pt x="178269" y="437324"/>
                  </a:lnTo>
                  <a:lnTo>
                    <a:pt x="179781" y="435800"/>
                  </a:lnTo>
                  <a:lnTo>
                    <a:pt x="179781" y="434263"/>
                  </a:lnTo>
                  <a:lnTo>
                    <a:pt x="181305" y="434263"/>
                  </a:lnTo>
                  <a:lnTo>
                    <a:pt x="181305" y="432752"/>
                  </a:lnTo>
                  <a:lnTo>
                    <a:pt x="182841" y="432752"/>
                  </a:lnTo>
                  <a:lnTo>
                    <a:pt x="182841" y="431228"/>
                  </a:lnTo>
                  <a:lnTo>
                    <a:pt x="184353" y="429704"/>
                  </a:lnTo>
                  <a:lnTo>
                    <a:pt x="184353" y="428180"/>
                  </a:lnTo>
                  <a:lnTo>
                    <a:pt x="185877" y="428180"/>
                  </a:lnTo>
                  <a:lnTo>
                    <a:pt x="185877" y="426656"/>
                  </a:lnTo>
                  <a:lnTo>
                    <a:pt x="187401" y="426656"/>
                  </a:lnTo>
                  <a:lnTo>
                    <a:pt x="187401" y="425132"/>
                  </a:lnTo>
                  <a:lnTo>
                    <a:pt x="188937" y="423608"/>
                  </a:lnTo>
                  <a:lnTo>
                    <a:pt x="188937" y="422084"/>
                  </a:lnTo>
                  <a:lnTo>
                    <a:pt x="190449" y="420560"/>
                  </a:lnTo>
                  <a:lnTo>
                    <a:pt x="191973" y="420560"/>
                  </a:lnTo>
                  <a:lnTo>
                    <a:pt x="191973" y="417512"/>
                  </a:lnTo>
                  <a:lnTo>
                    <a:pt x="193497" y="417512"/>
                  </a:lnTo>
                  <a:lnTo>
                    <a:pt x="193497" y="415988"/>
                  </a:lnTo>
                  <a:lnTo>
                    <a:pt x="195021" y="414464"/>
                  </a:lnTo>
                  <a:lnTo>
                    <a:pt x="195021" y="412940"/>
                  </a:lnTo>
                  <a:lnTo>
                    <a:pt x="198069" y="409905"/>
                  </a:lnTo>
                  <a:lnTo>
                    <a:pt x="198069" y="408368"/>
                  </a:lnTo>
                  <a:lnTo>
                    <a:pt x="199593" y="406844"/>
                  </a:lnTo>
                  <a:lnTo>
                    <a:pt x="199593" y="405320"/>
                  </a:lnTo>
                  <a:lnTo>
                    <a:pt x="201117" y="405320"/>
                  </a:lnTo>
                  <a:lnTo>
                    <a:pt x="201117" y="403796"/>
                  </a:lnTo>
                  <a:lnTo>
                    <a:pt x="202641" y="402272"/>
                  </a:lnTo>
                  <a:lnTo>
                    <a:pt x="202641" y="400748"/>
                  </a:lnTo>
                  <a:lnTo>
                    <a:pt x="204165" y="400748"/>
                  </a:lnTo>
                  <a:lnTo>
                    <a:pt x="204165" y="397713"/>
                  </a:lnTo>
                  <a:lnTo>
                    <a:pt x="207213" y="394652"/>
                  </a:lnTo>
                  <a:lnTo>
                    <a:pt x="207213" y="391604"/>
                  </a:lnTo>
                  <a:lnTo>
                    <a:pt x="208737" y="391604"/>
                  </a:lnTo>
                  <a:lnTo>
                    <a:pt x="208737" y="388556"/>
                  </a:lnTo>
                  <a:lnTo>
                    <a:pt x="210261" y="387045"/>
                  </a:lnTo>
                  <a:lnTo>
                    <a:pt x="210261" y="385521"/>
                  </a:lnTo>
                  <a:lnTo>
                    <a:pt x="211785" y="385521"/>
                  </a:lnTo>
                  <a:lnTo>
                    <a:pt x="211785" y="382460"/>
                  </a:lnTo>
                  <a:lnTo>
                    <a:pt x="213309" y="380936"/>
                  </a:lnTo>
                  <a:lnTo>
                    <a:pt x="213309" y="376377"/>
                  </a:lnTo>
                  <a:lnTo>
                    <a:pt x="214833" y="376377"/>
                  </a:lnTo>
                  <a:lnTo>
                    <a:pt x="214833" y="371805"/>
                  </a:lnTo>
                  <a:lnTo>
                    <a:pt x="216357" y="370268"/>
                  </a:lnTo>
                  <a:lnTo>
                    <a:pt x="216357" y="365709"/>
                  </a:lnTo>
                  <a:lnTo>
                    <a:pt x="217881" y="365709"/>
                  </a:lnTo>
                  <a:lnTo>
                    <a:pt x="217881" y="329133"/>
                  </a:lnTo>
                  <a:lnTo>
                    <a:pt x="216357" y="327609"/>
                  </a:lnTo>
                  <a:lnTo>
                    <a:pt x="216357" y="321525"/>
                  </a:lnTo>
                  <a:lnTo>
                    <a:pt x="214833" y="321525"/>
                  </a:lnTo>
                  <a:lnTo>
                    <a:pt x="214833" y="312381"/>
                  </a:lnTo>
                  <a:lnTo>
                    <a:pt x="213309" y="312381"/>
                  </a:lnTo>
                  <a:lnTo>
                    <a:pt x="213309" y="303225"/>
                  </a:lnTo>
                  <a:lnTo>
                    <a:pt x="211785" y="301701"/>
                  </a:lnTo>
                  <a:lnTo>
                    <a:pt x="211785" y="291033"/>
                  </a:lnTo>
                  <a:lnTo>
                    <a:pt x="210261" y="291033"/>
                  </a:lnTo>
                  <a:lnTo>
                    <a:pt x="210261" y="265137"/>
                  </a:lnTo>
                  <a:lnTo>
                    <a:pt x="211785" y="265137"/>
                  </a:lnTo>
                  <a:lnTo>
                    <a:pt x="211785" y="255993"/>
                  </a:lnTo>
                  <a:lnTo>
                    <a:pt x="213309" y="255993"/>
                  </a:lnTo>
                  <a:lnTo>
                    <a:pt x="213309" y="249897"/>
                  </a:lnTo>
                  <a:lnTo>
                    <a:pt x="214833" y="248373"/>
                  </a:lnTo>
                  <a:lnTo>
                    <a:pt x="214833" y="245338"/>
                  </a:lnTo>
                  <a:lnTo>
                    <a:pt x="216357" y="243801"/>
                  </a:lnTo>
                  <a:lnTo>
                    <a:pt x="216357" y="240753"/>
                  </a:lnTo>
                  <a:lnTo>
                    <a:pt x="217881" y="240753"/>
                  </a:lnTo>
                  <a:lnTo>
                    <a:pt x="217881" y="236181"/>
                  </a:lnTo>
                  <a:lnTo>
                    <a:pt x="219405" y="236181"/>
                  </a:lnTo>
                  <a:lnTo>
                    <a:pt x="219405" y="233146"/>
                  </a:lnTo>
                  <a:lnTo>
                    <a:pt x="220929" y="233146"/>
                  </a:lnTo>
                  <a:lnTo>
                    <a:pt x="220929" y="231609"/>
                  </a:lnTo>
                  <a:lnTo>
                    <a:pt x="222453" y="231609"/>
                  </a:lnTo>
                  <a:lnTo>
                    <a:pt x="222453" y="228561"/>
                  </a:lnTo>
                  <a:lnTo>
                    <a:pt x="223977" y="227037"/>
                  </a:lnTo>
                  <a:lnTo>
                    <a:pt x="223977" y="224002"/>
                  </a:lnTo>
                  <a:lnTo>
                    <a:pt x="225488" y="224002"/>
                  </a:lnTo>
                  <a:lnTo>
                    <a:pt x="225488" y="222478"/>
                  </a:lnTo>
                  <a:lnTo>
                    <a:pt x="227025" y="220954"/>
                  </a:lnTo>
                  <a:lnTo>
                    <a:pt x="227025" y="219417"/>
                  </a:lnTo>
                  <a:lnTo>
                    <a:pt x="228549" y="217893"/>
                  </a:lnTo>
                  <a:lnTo>
                    <a:pt x="228549" y="216369"/>
                  </a:lnTo>
                  <a:lnTo>
                    <a:pt x="230073" y="216369"/>
                  </a:lnTo>
                  <a:lnTo>
                    <a:pt x="230073" y="213334"/>
                  </a:lnTo>
                  <a:lnTo>
                    <a:pt x="233121" y="210286"/>
                  </a:lnTo>
                  <a:lnTo>
                    <a:pt x="233121" y="207238"/>
                  </a:lnTo>
                  <a:lnTo>
                    <a:pt x="234645" y="207238"/>
                  </a:lnTo>
                  <a:lnTo>
                    <a:pt x="234645" y="205701"/>
                  </a:lnTo>
                  <a:lnTo>
                    <a:pt x="237680" y="202666"/>
                  </a:lnTo>
                  <a:lnTo>
                    <a:pt x="237680" y="199618"/>
                  </a:lnTo>
                  <a:lnTo>
                    <a:pt x="239217" y="199618"/>
                  </a:lnTo>
                  <a:lnTo>
                    <a:pt x="239217" y="196570"/>
                  </a:lnTo>
                  <a:lnTo>
                    <a:pt x="240741" y="196570"/>
                  </a:lnTo>
                  <a:lnTo>
                    <a:pt x="240741" y="195046"/>
                  </a:lnTo>
                  <a:lnTo>
                    <a:pt x="242252" y="193509"/>
                  </a:lnTo>
                  <a:lnTo>
                    <a:pt x="242252" y="191985"/>
                  </a:lnTo>
                  <a:lnTo>
                    <a:pt x="243776" y="190474"/>
                  </a:lnTo>
                  <a:lnTo>
                    <a:pt x="243776" y="188950"/>
                  </a:lnTo>
                  <a:lnTo>
                    <a:pt x="245313" y="187426"/>
                  </a:lnTo>
                  <a:lnTo>
                    <a:pt x="245313" y="184378"/>
                  </a:lnTo>
                  <a:lnTo>
                    <a:pt x="246824" y="184378"/>
                  </a:lnTo>
                  <a:lnTo>
                    <a:pt x="246824" y="181317"/>
                  </a:lnTo>
                  <a:lnTo>
                    <a:pt x="248348" y="181317"/>
                  </a:lnTo>
                  <a:lnTo>
                    <a:pt x="248348" y="176758"/>
                  </a:lnTo>
                  <a:lnTo>
                    <a:pt x="249872" y="176758"/>
                  </a:lnTo>
                  <a:lnTo>
                    <a:pt x="249872" y="173710"/>
                  </a:lnTo>
                  <a:lnTo>
                    <a:pt x="251396" y="172186"/>
                  </a:lnTo>
                  <a:lnTo>
                    <a:pt x="251396" y="169138"/>
                  </a:lnTo>
                  <a:lnTo>
                    <a:pt x="252920" y="167614"/>
                  </a:lnTo>
                  <a:lnTo>
                    <a:pt x="252920" y="159994"/>
                  </a:lnTo>
                  <a:lnTo>
                    <a:pt x="254444" y="159994"/>
                  </a:lnTo>
                  <a:lnTo>
                    <a:pt x="254444" y="141706"/>
                  </a:lnTo>
                  <a:lnTo>
                    <a:pt x="252920" y="141706"/>
                  </a:lnTo>
                  <a:lnTo>
                    <a:pt x="252920" y="134099"/>
                  </a:lnTo>
                  <a:lnTo>
                    <a:pt x="251396" y="132575"/>
                  </a:lnTo>
                  <a:lnTo>
                    <a:pt x="251396" y="129514"/>
                  </a:lnTo>
                  <a:lnTo>
                    <a:pt x="249872" y="129514"/>
                  </a:lnTo>
                  <a:lnTo>
                    <a:pt x="249872" y="124955"/>
                  </a:lnTo>
                  <a:lnTo>
                    <a:pt x="248348" y="124955"/>
                  </a:lnTo>
                  <a:lnTo>
                    <a:pt x="248348" y="121907"/>
                  </a:lnTo>
                  <a:lnTo>
                    <a:pt x="246824" y="120383"/>
                  </a:lnTo>
                  <a:lnTo>
                    <a:pt x="246824" y="118859"/>
                  </a:lnTo>
                  <a:lnTo>
                    <a:pt x="245313" y="117322"/>
                  </a:lnTo>
                  <a:lnTo>
                    <a:pt x="245313" y="115798"/>
                  </a:lnTo>
                  <a:lnTo>
                    <a:pt x="243776" y="114287"/>
                  </a:lnTo>
                  <a:lnTo>
                    <a:pt x="243776" y="112763"/>
                  </a:lnTo>
                  <a:lnTo>
                    <a:pt x="242252" y="111239"/>
                  </a:lnTo>
                  <a:lnTo>
                    <a:pt x="242252" y="109715"/>
                  </a:lnTo>
                  <a:lnTo>
                    <a:pt x="240741" y="108191"/>
                  </a:lnTo>
                  <a:lnTo>
                    <a:pt x="240741" y="106667"/>
                  </a:lnTo>
                  <a:lnTo>
                    <a:pt x="239217" y="106667"/>
                  </a:lnTo>
                  <a:lnTo>
                    <a:pt x="239217" y="105130"/>
                  </a:lnTo>
                  <a:lnTo>
                    <a:pt x="237680" y="103619"/>
                  </a:lnTo>
                  <a:lnTo>
                    <a:pt x="237680" y="102095"/>
                  </a:lnTo>
                  <a:lnTo>
                    <a:pt x="234645" y="99047"/>
                  </a:lnTo>
                  <a:lnTo>
                    <a:pt x="234645" y="97523"/>
                  </a:lnTo>
                  <a:lnTo>
                    <a:pt x="233121" y="95999"/>
                  </a:lnTo>
                  <a:lnTo>
                    <a:pt x="233121" y="94475"/>
                  </a:lnTo>
                  <a:lnTo>
                    <a:pt x="231584" y="94475"/>
                  </a:lnTo>
                  <a:lnTo>
                    <a:pt x="231584" y="92938"/>
                  </a:lnTo>
                  <a:lnTo>
                    <a:pt x="228549" y="89903"/>
                  </a:lnTo>
                  <a:lnTo>
                    <a:pt x="228549" y="88379"/>
                  </a:lnTo>
                  <a:lnTo>
                    <a:pt x="227025" y="88379"/>
                  </a:lnTo>
                  <a:lnTo>
                    <a:pt x="227025" y="85331"/>
                  </a:lnTo>
                  <a:lnTo>
                    <a:pt x="225488" y="85331"/>
                  </a:lnTo>
                  <a:lnTo>
                    <a:pt x="225488" y="83807"/>
                  </a:lnTo>
                  <a:lnTo>
                    <a:pt x="223977" y="83807"/>
                  </a:lnTo>
                  <a:lnTo>
                    <a:pt x="223977" y="82283"/>
                  </a:lnTo>
                  <a:lnTo>
                    <a:pt x="222453" y="80759"/>
                  </a:lnTo>
                  <a:lnTo>
                    <a:pt x="222453" y="79235"/>
                  </a:lnTo>
                  <a:lnTo>
                    <a:pt x="220929" y="79235"/>
                  </a:lnTo>
                  <a:lnTo>
                    <a:pt x="220929" y="77711"/>
                  </a:lnTo>
                  <a:lnTo>
                    <a:pt x="217881" y="74663"/>
                  </a:lnTo>
                  <a:lnTo>
                    <a:pt x="217881" y="73139"/>
                  </a:lnTo>
                  <a:lnTo>
                    <a:pt x="216357" y="73139"/>
                  </a:lnTo>
                  <a:lnTo>
                    <a:pt x="214833" y="71615"/>
                  </a:lnTo>
                  <a:lnTo>
                    <a:pt x="214833" y="70104"/>
                  </a:lnTo>
                  <a:lnTo>
                    <a:pt x="213309" y="68580"/>
                  </a:lnTo>
                  <a:lnTo>
                    <a:pt x="213309" y="67043"/>
                  </a:lnTo>
                  <a:lnTo>
                    <a:pt x="208737" y="62471"/>
                  </a:lnTo>
                  <a:lnTo>
                    <a:pt x="208737" y="60947"/>
                  </a:lnTo>
                  <a:lnTo>
                    <a:pt x="205689" y="57912"/>
                  </a:lnTo>
                  <a:lnTo>
                    <a:pt x="205689" y="56388"/>
                  </a:lnTo>
                  <a:lnTo>
                    <a:pt x="204165" y="56388"/>
                  </a:lnTo>
                  <a:lnTo>
                    <a:pt x="204165" y="54851"/>
                  </a:lnTo>
                  <a:lnTo>
                    <a:pt x="202641" y="54851"/>
                  </a:lnTo>
                  <a:lnTo>
                    <a:pt x="202641" y="53327"/>
                  </a:lnTo>
                  <a:lnTo>
                    <a:pt x="201117" y="51803"/>
                  </a:lnTo>
                  <a:lnTo>
                    <a:pt x="201117" y="50279"/>
                  </a:lnTo>
                  <a:lnTo>
                    <a:pt x="199593" y="50279"/>
                  </a:lnTo>
                  <a:lnTo>
                    <a:pt x="199593" y="48755"/>
                  </a:lnTo>
                  <a:lnTo>
                    <a:pt x="198069" y="47244"/>
                  </a:lnTo>
                  <a:lnTo>
                    <a:pt x="198069" y="45720"/>
                  </a:lnTo>
                  <a:lnTo>
                    <a:pt x="196545" y="45720"/>
                  </a:lnTo>
                  <a:lnTo>
                    <a:pt x="196545" y="44196"/>
                  </a:lnTo>
                  <a:lnTo>
                    <a:pt x="195021" y="44196"/>
                  </a:lnTo>
                  <a:lnTo>
                    <a:pt x="195021" y="41135"/>
                  </a:lnTo>
                  <a:lnTo>
                    <a:pt x="193497" y="41135"/>
                  </a:lnTo>
                  <a:lnTo>
                    <a:pt x="193497" y="39611"/>
                  </a:lnTo>
                  <a:lnTo>
                    <a:pt x="191973" y="39611"/>
                  </a:lnTo>
                  <a:lnTo>
                    <a:pt x="191973" y="38087"/>
                  </a:lnTo>
                  <a:lnTo>
                    <a:pt x="190449" y="36576"/>
                  </a:lnTo>
                  <a:lnTo>
                    <a:pt x="190449" y="35052"/>
                  </a:lnTo>
                  <a:lnTo>
                    <a:pt x="188937" y="35052"/>
                  </a:lnTo>
                  <a:lnTo>
                    <a:pt x="188937" y="33528"/>
                  </a:lnTo>
                  <a:lnTo>
                    <a:pt x="187401" y="32004"/>
                  </a:lnTo>
                  <a:lnTo>
                    <a:pt x="187401" y="30480"/>
                  </a:lnTo>
                  <a:lnTo>
                    <a:pt x="184353" y="27419"/>
                  </a:lnTo>
                  <a:lnTo>
                    <a:pt x="184353" y="25908"/>
                  </a:lnTo>
                  <a:lnTo>
                    <a:pt x="179781" y="21336"/>
                  </a:lnTo>
                  <a:lnTo>
                    <a:pt x="179781" y="19812"/>
                  </a:lnTo>
                  <a:lnTo>
                    <a:pt x="178269" y="18288"/>
                  </a:lnTo>
                  <a:lnTo>
                    <a:pt x="178269" y="16751"/>
                  </a:lnTo>
                  <a:lnTo>
                    <a:pt x="176745" y="16751"/>
                  </a:lnTo>
                  <a:lnTo>
                    <a:pt x="176745" y="13716"/>
                  </a:lnTo>
                  <a:lnTo>
                    <a:pt x="175209" y="13716"/>
                  </a:lnTo>
                  <a:lnTo>
                    <a:pt x="175209" y="12192"/>
                  </a:lnTo>
                  <a:lnTo>
                    <a:pt x="173685" y="12192"/>
                  </a:lnTo>
                  <a:lnTo>
                    <a:pt x="173685" y="9144"/>
                  </a:lnTo>
                  <a:lnTo>
                    <a:pt x="172173" y="9144"/>
                  </a:lnTo>
                  <a:lnTo>
                    <a:pt x="172173" y="6096"/>
                  </a:lnTo>
                  <a:lnTo>
                    <a:pt x="170649" y="6096"/>
                  </a:lnTo>
                  <a:lnTo>
                    <a:pt x="170649" y="4572"/>
                  </a:lnTo>
                  <a:lnTo>
                    <a:pt x="169125" y="4572"/>
                  </a:lnTo>
                  <a:lnTo>
                    <a:pt x="169125" y="1524"/>
                  </a:lnTo>
                  <a:lnTo>
                    <a:pt x="167601" y="1524"/>
                  </a:lnTo>
                  <a:lnTo>
                    <a:pt x="167601" y="0"/>
                  </a:lnTo>
                  <a:close/>
                </a:path>
              </a:pathLst>
            </a:custGeom>
            <a:solidFill>
              <a:srgbClr val="7BAD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9" name="object 49"/>
            <p:cNvSpPr/>
            <p:nvPr/>
          </p:nvSpPr>
          <p:spPr>
            <a:xfrm>
              <a:off x="2245474" y="6386113"/>
              <a:ext cx="254635" cy="454659"/>
            </a:xfrm>
            <a:custGeom>
              <a:avLst/>
              <a:gdLst/>
              <a:ahLst/>
              <a:cxnLst/>
              <a:rect l="l" t="t" r="r" b="b"/>
              <a:pathLst>
                <a:path w="254635" h="454659">
                  <a:moveTo>
                    <a:pt x="86842" y="454088"/>
                  </a:moveTo>
                  <a:lnTo>
                    <a:pt x="85318" y="452564"/>
                  </a:lnTo>
                  <a:lnTo>
                    <a:pt x="85318" y="451040"/>
                  </a:lnTo>
                  <a:lnTo>
                    <a:pt x="83794" y="449516"/>
                  </a:lnTo>
                  <a:lnTo>
                    <a:pt x="82270" y="449516"/>
                  </a:lnTo>
                  <a:lnTo>
                    <a:pt x="82270" y="447992"/>
                  </a:lnTo>
                  <a:lnTo>
                    <a:pt x="80746" y="446455"/>
                  </a:lnTo>
                  <a:lnTo>
                    <a:pt x="80746" y="444931"/>
                  </a:lnTo>
                  <a:lnTo>
                    <a:pt x="79222" y="443420"/>
                  </a:lnTo>
                  <a:lnTo>
                    <a:pt x="77698" y="441896"/>
                  </a:lnTo>
                  <a:lnTo>
                    <a:pt x="76174" y="440372"/>
                  </a:lnTo>
                  <a:lnTo>
                    <a:pt x="76174" y="438848"/>
                  </a:lnTo>
                  <a:lnTo>
                    <a:pt x="74663" y="437324"/>
                  </a:lnTo>
                  <a:lnTo>
                    <a:pt x="73126" y="435800"/>
                  </a:lnTo>
                  <a:lnTo>
                    <a:pt x="73126" y="434263"/>
                  </a:lnTo>
                  <a:lnTo>
                    <a:pt x="71602" y="432752"/>
                  </a:lnTo>
                  <a:lnTo>
                    <a:pt x="70091" y="431228"/>
                  </a:lnTo>
                  <a:lnTo>
                    <a:pt x="70091" y="429704"/>
                  </a:lnTo>
                  <a:lnTo>
                    <a:pt x="68567" y="428180"/>
                  </a:lnTo>
                  <a:lnTo>
                    <a:pt x="67030" y="426656"/>
                  </a:lnTo>
                  <a:lnTo>
                    <a:pt x="65506" y="425132"/>
                  </a:lnTo>
                  <a:lnTo>
                    <a:pt x="65506" y="423608"/>
                  </a:lnTo>
                  <a:lnTo>
                    <a:pt x="63995" y="422084"/>
                  </a:lnTo>
                  <a:lnTo>
                    <a:pt x="62471" y="420560"/>
                  </a:lnTo>
                  <a:lnTo>
                    <a:pt x="62471" y="419036"/>
                  </a:lnTo>
                  <a:lnTo>
                    <a:pt x="60934" y="417512"/>
                  </a:lnTo>
                  <a:lnTo>
                    <a:pt x="59423" y="415988"/>
                  </a:lnTo>
                  <a:lnTo>
                    <a:pt x="57899" y="414464"/>
                  </a:lnTo>
                  <a:lnTo>
                    <a:pt x="57899" y="412940"/>
                  </a:lnTo>
                  <a:lnTo>
                    <a:pt x="56375" y="411416"/>
                  </a:lnTo>
                  <a:lnTo>
                    <a:pt x="56375" y="409905"/>
                  </a:lnTo>
                  <a:lnTo>
                    <a:pt x="54838" y="409905"/>
                  </a:lnTo>
                  <a:lnTo>
                    <a:pt x="54838" y="408368"/>
                  </a:lnTo>
                  <a:lnTo>
                    <a:pt x="54838" y="406844"/>
                  </a:lnTo>
                  <a:lnTo>
                    <a:pt x="53327" y="406844"/>
                  </a:lnTo>
                  <a:lnTo>
                    <a:pt x="53327" y="405320"/>
                  </a:lnTo>
                  <a:lnTo>
                    <a:pt x="51803" y="405320"/>
                  </a:lnTo>
                  <a:lnTo>
                    <a:pt x="51803" y="403796"/>
                  </a:lnTo>
                  <a:lnTo>
                    <a:pt x="51803" y="402272"/>
                  </a:lnTo>
                  <a:lnTo>
                    <a:pt x="50279" y="400748"/>
                  </a:lnTo>
                  <a:lnTo>
                    <a:pt x="50279" y="399237"/>
                  </a:lnTo>
                  <a:lnTo>
                    <a:pt x="48755" y="397713"/>
                  </a:lnTo>
                  <a:lnTo>
                    <a:pt x="47231" y="396176"/>
                  </a:lnTo>
                  <a:lnTo>
                    <a:pt x="47231" y="394652"/>
                  </a:lnTo>
                  <a:lnTo>
                    <a:pt x="45707" y="393128"/>
                  </a:lnTo>
                  <a:lnTo>
                    <a:pt x="45707" y="391604"/>
                  </a:lnTo>
                  <a:lnTo>
                    <a:pt x="45707" y="390080"/>
                  </a:lnTo>
                  <a:lnTo>
                    <a:pt x="44183" y="390080"/>
                  </a:lnTo>
                  <a:lnTo>
                    <a:pt x="44183" y="388556"/>
                  </a:lnTo>
                  <a:lnTo>
                    <a:pt x="42659" y="387045"/>
                  </a:lnTo>
                  <a:lnTo>
                    <a:pt x="42659" y="385521"/>
                  </a:lnTo>
                  <a:lnTo>
                    <a:pt x="42659" y="383984"/>
                  </a:lnTo>
                  <a:lnTo>
                    <a:pt x="41135" y="382460"/>
                  </a:lnTo>
                  <a:lnTo>
                    <a:pt x="41135" y="380936"/>
                  </a:lnTo>
                  <a:lnTo>
                    <a:pt x="41135" y="379412"/>
                  </a:lnTo>
                  <a:lnTo>
                    <a:pt x="39611" y="379412"/>
                  </a:lnTo>
                  <a:lnTo>
                    <a:pt x="39611" y="377888"/>
                  </a:lnTo>
                  <a:lnTo>
                    <a:pt x="39611" y="376377"/>
                  </a:lnTo>
                  <a:lnTo>
                    <a:pt x="39611" y="374853"/>
                  </a:lnTo>
                  <a:lnTo>
                    <a:pt x="38087" y="373329"/>
                  </a:lnTo>
                  <a:lnTo>
                    <a:pt x="38087" y="371805"/>
                  </a:lnTo>
                  <a:lnTo>
                    <a:pt x="38087" y="370268"/>
                  </a:lnTo>
                  <a:lnTo>
                    <a:pt x="36563" y="370268"/>
                  </a:lnTo>
                  <a:lnTo>
                    <a:pt x="36563" y="361137"/>
                  </a:lnTo>
                  <a:lnTo>
                    <a:pt x="35039" y="361137"/>
                  </a:lnTo>
                  <a:lnTo>
                    <a:pt x="35039" y="333705"/>
                  </a:lnTo>
                  <a:lnTo>
                    <a:pt x="36563" y="333705"/>
                  </a:lnTo>
                  <a:lnTo>
                    <a:pt x="36563" y="323049"/>
                  </a:lnTo>
                  <a:lnTo>
                    <a:pt x="38087" y="323049"/>
                  </a:lnTo>
                  <a:lnTo>
                    <a:pt x="38087" y="321525"/>
                  </a:lnTo>
                  <a:lnTo>
                    <a:pt x="38087" y="319989"/>
                  </a:lnTo>
                  <a:lnTo>
                    <a:pt x="38087" y="318465"/>
                  </a:lnTo>
                  <a:lnTo>
                    <a:pt x="38087" y="316941"/>
                  </a:lnTo>
                  <a:lnTo>
                    <a:pt x="39611" y="315417"/>
                  </a:lnTo>
                  <a:lnTo>
                    <a:pt x="39611" y="307797"/>
                  </a:lnTo>
                  <a:lnTo>
                    <a:pt x="41135" y="306273"/>
                  </a:lnTo>
                  <a:lnTo>
                    <a:pt x="41135" y="297141"/>
                  </a:lnTo>
                  <a:lnTo>
                    <a:pt x="42659" y="297141"/>
                  </a:lnTo>
                  <a:lnTo>
                    <a:pt x="42659" y="260565"/>
                  </a:lnTo>
                  <a:lnTo>
                    <a:pt x="41135" y="260565"/>
                  </a:lnTo>
                  <a:lnTo>
                    <a:pt x="41135" y="252945"/>
                  </a:lnTo>
                  <a:lnTo>
                    <a:pt x="39611" y="251421"/>
                  </a:lnTo>
                  <a:lnTo>
                    <a:pt x="39611" y="249897"/>
                  </a:lnTo>
                  <a:lnTo>
                    <a:pt x="39611" y="248373"/>
                  </a:lnTo>
                  <a:lnTo>
                    <a:pt x="39611" y="246849"/>
                  </a:lnTo>
                  <a:lnTo>
                    <a:pt x="38087" y="246849"/>
                  </a:lnTo>
                  <a:lnTo>
                    <a:pt x="38087" y="245338"/>
                  </a:lnTo>
                  <a:lnTo>
                    <a:pt x="38087" y="243801"/>
                  </a:lnTo>
                  <a:lnTo>
                    <a:pt x="36563" y="243801"/>
                  </a:lnTo>
                  <a:lnTo>
                    <a:pt x="36563" y="242277"/>
                  </a:lnTo>
                  <a:lnTo>
                    <a:pt x="36563" y="240753"/>
                  </a:lnTo>
                  <a:lnTo>
                    <a:pt x="36563" y="239229"/>
                  </a:lnTo>
                  <a:lnTo>
                    <a:pt x="35039" y="239229"/>
                  </a:lnTo>
                  <a:lnTo>
                    <a:pt x="35039" y="237705"/>
                  </a:lnTo>
                  <a:lnTo>
                    <a:pt x="35039" y="236181"/>
                  </a:lnTo>
                  <a:lnTo>
                    <a:pt x="33515" y="234670"/>
                  </a:lnTo>
                  <a:lnTo>
                    <a:pt x="33515" y="233146"/>
                  </a:lnTo>
                  <a:lnTo>
                    <a:pt x="31991" y="233146"/>
                  </a:lnTo>
                  <a:lnTo>
                    <a:pt x="31991" y="231609"/>
                  </a:lnTo>
                  <a:lnTo>
                    <a:pt x="31991" y="230085"/>
                  </a:lnTo>
                  <a:lnTo>
                    <a:pt x="30467" y="228561"/>
                  </a:lnTo>
                  <a:lnTo>
                    <a:pt x="30467" y="227037"/>
                  </a:lnTo>
                  <a:lnTo>
                    <a:pt x="28943" y="225513"/>
                  </a:lnTo>
                  <a:lnTo>
                    <a:pt x="28943" y="224002"/>
                  </a:lnTo>
                  <a:lnTo>
                    <a:pt x="27419" y="222478"/>
                  </a:lnTo>
                  <a:lnTo>
                    <a:pt x="27419" y="220954"/>
                  </a:lnTo>
                  <a:lnTo>
                    <a:pt x="25895" y="220954"/>
                  </a:lnTo>
                  <a:lnTo>
                    <a:pt x="25895" y="219417"/>
                  </a:lnTo>
                  <a:lnTo>
                    <a:pt x="25895" y="217893"/>
                  </a:lnTo>
                  <a:lnTo>
                    <a:pt x="24371" y="216369"/>
                  </a:lnTo>
                  <a:lnTo>
                    <a:pt x="24371" y="214845"/>
                  </a:lnTo>
                  <a:lnTo>
                    <a:pt x="22847" y="214845"/>
                  </a:lnTo>
                  <a:lnTo>
                    <a:pt x="22847" y="213334"/>
                  </a:lnTo>
                  <a:lnTo>
                    <a:pt x="21323" y="211810"/>
                  </a:lnTo>
                  <a:lnTo>
                    <a:pt x="21323" y="210286"/>
                  </a:lnTo>
                  <a:lnTo>
                    <a:pt x="19799" y="208762"/>
                  </a:lnTo>
                  <a:lnTo>
                    <a:pt x="19799" y="207238"/>
                  </a:lnTo>
                  <a:lnTo>
                    <a:pt x="18287" y="205701"/>
                  </a:lnTo>
                  <a:lnTo>
                    <a:pt x="16751" y="204177"/>
                  </a:lnTo>
                  <a:lnTo>
                    <a:pt x="16751" y="202666"/>
                  </a:lnTo>
                  <a:lnTo>
                    <a:pt x="16751" y="201142"/>
                  </a:lnTo>
                  <a:lnTo>
                    <a:pt x="15227" y="201142"/>
                  </a:lnTo>
                  <a:lnTo>
                    <a:pt x="15227" y="199618"/>
                  </a:lnTo>
                  <a:lnTo>
                    <a:pt x="13703" y="198094"/>
                  </a:lnTo>
                  <a:lnTo>
                    <a:pt x="13703" y="196570"/>
                  </a:lnTo>
                  <a:lnTo>
                    <a:pt x="12191" y="195046"/>
                  </a:lnTo>
                  <a:lnTo>
                    <a:pt x="12191" y="193509"/>
                  </a:lnTo>
                  <a:lnTo>
                    <a:pt x="10655" y="193509"/>
                  </a:lnTo>
                  <a:lnTo>
                    <a:pt x="10655" y="191985"/>
                  </a:lnTo>
                  <a:lnTo>
                    <a:pt x="10655" y="190474"/>
                  </a:lnTo>
                  <a:lnTo>
                    <a:pt x="9131" y="188950"/>
                  </a:lnTo>
                  <a:lnTo>
                    <a:pt x="9131" y="187426"/>
                  </a:lnTo>
                  <a:lnTo>
                    <a:pt x="9131" y="185902"/>
                  </a:lnTo>
                  <a:lnTo>
                    <a:pt x="7619" y="185902"/>
                  </a:lnTo>
                  <a:lnTo>
                    <a:pt x="7619" y="184378"/>
                  </a:lnTo>
                  <a:lnTo>
                    <a:pt x="6095" y="182854"/>
                  </a:lnTo>
                  <a:lnTo>
                    <a:pt x="6095" y="181317"/>
                  </a:lnTo>
                  <a:lnTo>
                    <a:pt x="6095" y="179806"/>
                  </a:lnTo>
                  <a:lnTo>
                    <a:pt x="4559" y="179806"/>
                  </a:lnTo>
                  <a:lnTo>
                    <a:pt x="4559" y="178282"/>
                  </a:lnTo>
                  <a:lnTo>
                    <a:pt x="4559" y="176758"/>
                  </a:lnTo>
                  <a:lnTo>
                    <a:pt x="4559" y="175234"/>
                  </a:lnTo>
                  <a:lnTo>
                    <a:pt x="3047" y="175234"/>
                  </a:lnTo>
                  <a:lnTo>
                    <a:pt x="3047" y="173710"/>
                  </a:lnTo>
                  <a:lnTo>
                    <a:pt x="3047" y="172186"/>
                  </a:lnTo>
                  <a:lnTo>
                    <a:pt x="1523" y="170662"/>
                  </a:lnTo>
                  <a:lnTo>
                    <a:pt x="1523" y="169138"/>
                  </a:lnTo>
                  <a:lnTo>
                    <a:pt x="1523" y="167614"/>
                  </a:lnTo>
                  <a:lnTo>
                    <a:pt x="1523" y="166090"/>
                  </a:lnTo>
                  <a:lnTo>
                    <a:pt x="0" y="164566"/>
                  </a:lnTo>
                  <a:lnTo>
                    <a:pt x="0" y="137134"/>
                  </a:lnTo>
                  <a:lnTo>
                    <a:pt x="1523" y="135623"/>
                  </a:lnTo>
                  <a:lnTo>
                    <a:pt x="1523" y="134099"/>
                  </a:lnTo>
                  <a:lnTo>
                    <a:pt x="1523" y="132575"/>
                  </a:lnTo>
                  <a:lnTo>
                    <a:pt x="1523" y="131038"/>
                  </a:lnTo>
                  <a:lnTo>
                    <a:pt x="3047" y="129514"/>
                  </a:lnTo>
                  <a:lnTo>
                    <a:pt x="3047" y="127990"/>
                  </a:lnTo>
                  <a:lnTo>
                    <a:pt x="4559" y="126466"/>
                  </a:lnTo>
                  <a:lnTo>
                    <a:pt x="4559" y="124955"/>
                  </a:lnTo>
                  <a:lnTo>
                    <a:pt x="4559" y="123431"/>
                  </a:lnTo>
                  <a:lnTo>
                    <a:pt x="6095" y="121907"/>
                  </a:lnTo>
                  <a:lnTo>
                    <a:pt x="6095" y="120383"/>
                  </a:lnTo>
                  <a:lnTo>
                    <a:pt x="6095" y="118859"/>
                  </a:lnTo>
                  <a:lnTo>
                    <a:pt x="7619" y="118859"/>
                  </a:lnTo>
                  <a:lnTo>
                    <a:pt x="7619" y="117322"/>
                  </a:lnTo>
                  <a:lnTo>
                    <a:pt x="9131" y="115798"/>
                  </a:lnTo>
                  <a:lnTo>
                    <a:pt x="9131" y="114287"/>
                  </a:lnTo>
                  <a:lnTo>
                    <a:pt x="9131" y="112763"/>
                  </a:lnTo>
                  <a:lnTo>
                    <a:pt x="10655" y="112763"/>
                  </a:lnTo>
                  <a:lnTo>
                    <a:pt x="10655" y="111239"/>
                  </a:lnTo>
                  <a:lnTo>
                    <a:pt x="12191" y="109715"/>
                  </a:lnTo>
                  <a:lnTo>
                    <a:pt x="12191" y="108191"/>
                  </a:lnTo>
                  <a:lnTo>
                    <a:pt x="12191" y="106667"/>
                  </a:lnTo>
                  <a:lnTo>
                    <a:pt x="13703" y="106667"/>
                  </a:lnTo>
                  <a:lnTo>
                    <a:pt x="13703" y="105130"/>
                  </a:lnTo>
                  <a:lnTo>
                    <a:pt x="15227" y="105130"/>
                  </a:lnTo>
                  <a:lnTo>
                    <a:pt x="15227" y="103619"/>
                  </a:lnTo>
                  <a:lnTo>
                    <a:pt x="15227" y="102095"/>
                  </a:lnTo>
                  <a:lnTo>
                    <a:pt x="16751" y="102095"/>
                  </a:lnTo>
                  <a:lnTo>
                    <a:pt x="16751" y="100571"/>
                  </a:lnTo>
                  <a:lnTo>
                    <a:pt x="18287" y="99047"/>
                  </a:lnTo>
                  <a:lnTo>
                    <a:pt x="19799" y="97523"/>
                  </a:lnTo>
                  <a:lnTo>
                    <a:pt x="19799" y="95999"/>
                  </a:lnTo>
                  <a:lnTo>
                    <a:pt x="21323" y="95999"/>
                  </a:lnTo>
                  <a:lnTo>
                    <a:pt x="21323" y="94475"/>
                  </a:lnTo>
                  <a:lnTo>
                    <a:pt x="22847" y="92938"/>
                  </a:lnTo>
                  <a:lnTo>
                    <a:pt x="22847" y="91427"/>
                  </a:lnTo>
                  <a:lnTo>
                    <a:pt x="24371" y="91427"/>
                  </a:lnTo>
                  <a:lnTo>
                    <a:pt x="24371" y="89903"/>
                  </a:lnTo>
                  <a:lnTo>
                    <a:pt x="25895" y="88379"/>
                  </a:lnTo>
                  <a:lnTo>
                    <a:pt x="25895" y="86855"/>
                  </a:lnTo>
                  <a:lnTo>
                    <a:pt x="27419" y="85331"/>
                  </a:lnTo>
                  <a:lnTo>
                    <a:pt x="28943" y="83807"/>
                  </a:lnTo>
                  <a:lnTo>
                    <a:pt x="30467" y="82283"/>
                  </a:lnTo>
                  <a:lnTo>
                    <a:pt x="30467" y="80759"/>
                  </a:lnTo>
                  <a:lnTo>
                    <a:pt x="31991" y="79235"/>
                  </a:lnTo>
                  <a:lnTo>
                    <a:pt x="33515" y="77711"/>
                  </a:lnTo>
                  <a:lnTo>
                    <a:pt x="33515" y="76187"/>
                  </a:lnTo>
                  <a:lnTo>
                    <a:pt x="35039" y="76187"/>
                  </a:lnTo>
                  <a:lnTo>
                    <a:pt x="35039" y="74663"/>
                  </a:lnTo>
                  <a:lnTo>
                    <a:pt x="36563" y="73139"/>
                  </a:lnTo>
                  <a:lnTo>
                    <a:pt x="38087" y="71615"/>
                  </a:lnTo>
                  <a:lnTo>
                    <a:pt x="38087" y="70104"/>
                  </a:lnTo>
                  <a:lnTo>
                    <a:pt x="39611" y="70104"/>
                  </a:lnTo>
                  <a:lnTo>
                    <a:pt x="39611" y="68580"/>
                  </a:lnTo>
                  <a:lnTo>
                    <a:pt x="41135" y="68580"/>
                  </a:lnTo>
                  <a:lnTo>
                    <a:pt x="41135" y="67043"/>
                  </a:lnTo>
                  <a:lnTo>
                    <a:pt x="41135" y="65519"/>
                  </a:lnTo>
                  <a:lnTo>
                    <a:pt x="42659" y="65519"/>
                  </a:lnTo>
                  <a:lnTo>
                    <a:pt x="42659" y="63995"/>
                  </a:lnTo>
                  <a:lnTo>
                    <a:pt x="44183" y="62471"/>
                  </a:lnTo>
                  <a:lnTo>
                    <a:pt x="45707" y="60947"/>
                  </a:lnTo>
                  <a:lnTo>
                    <a:pt x="45707" y="59436"/>
                  </a:lnTo>
                  <a:lnTo>
                    <a:pt x="47231" y="59436"/>
                  </a:lnTo>
                  <a:lnTo>
                    <a:pt x="47231" y="57912"/>
                  </a:lnTo>
                  <a:lnTo>
                    <a:pt x="47231" y="56388"/>
                  </a:lnTo>
                  <a:lnTo>
                    <a:pt x="48755" y="56388"/>
                  </a:lnTo>
                  <a:lnTo>
                    <a:pt x="50279" y="54851"/>
                  </a:lnTo>
                  <a:lnTo>
                    <a:pt x="50279" y="53327"/>
                  </a:lnTo>
                  <a:lnTo>
                    <a:pt x="51803" y="53327"/>
                  </a:lnTo>
                  <a:lnTo>
                    <a:pt x="51803" y="51803"/>
                  </a:lnTo>
                  <a:lnTo>
                    <a:pt x="51803" y="50279"/>
                  </a:lnTo>
                  <a:lnTo>
                    <a:pt x="53327" y="50279"/>
                  </a:lnTo>
                  <a:lnTo>
                    <a:pt x="54838" y="48755"/>
                  </a:lnTo>
                  <a:lnTo>
                    <a:pt x="54838" y="47244"/>
                  </a:lnTo>
                  <a:lnTo>
                    <a:pt x="56375" y="45720"/>
                  </a:lnTo>
                  <a:lnTo>
                    <a:pt x="56375" y="44196"/>
                  </a:lnTo>
                  <a:lnTo>
                    <a:pt x="57899" y="44196"/>
                  </a:lnTo>
                  <a:lnTo>
                    <a:pt x="57899" y="42659"/>
                  </a:lnTo>
                  <a:lnTo>
                    <a:pt x="59423" y="41135"/>
                  </a:lnTo>
                  <a:lnTo>
                    <a:pt x="60934" y="39611"/>
                  </a:lnTo>
                  <a:lnTo>
                    <a:pt x="60934" y="38087"/>
                  </a:lnTo>
                  <a:lnTo>
                    <a:pt x="62471" y="38087"/>
                  </a:lnTo>
                  <a:lnTo>
                    <a:pt x="62471" y="36576"/>
                  </a:lnTo>
                  <a:lnTo>
                    <a:pt x="62471" y="35052"/>
                  </a:lnTo>
                  <a:lnTo>
                    <a:pt x="63995" y="35052"/>
                  </a:lnTo>
                  <a:lnTo>
                    <a:pt x="63995" y="33528"/>
                  </a:lnTo>
                  <a:lnTo>
                    <a:pt x="65506" y="33528"/>
                  </a:lnTo>
                  <a:lnTo>
                    <a:pt x="65506" y="32004"/>
                  </a:lnTo>
                  <a:lnTo>
                    <a:pt x="65506" y="30480"/>
                  </a:lnTo>
                  <a:lnTo>
                    <a:pt x="67030" y="30480"/>
                  </a:lnTo>
                  <a:lnTo>
                    <a:pt x="67030" y="28943"/>
                  </a:lnTo>
                  <a:lnTo>
                    <a:pt x="68567" y="28943"/>
                  </a:lnTo>
                  <a:lnTo>
                    <a:pt x="68567" y="27419"/>
                  </a:lnTo>
                  <a:lnTo>
                    <a:pt x="70091" y="25908"/>
                  </a:lnTo>
                  <a:lnTo>
                    <a:pt x="70091" y="24384"/>
                  </a:lnTo>
                  <a:lnTo>
                    <a:pt x="71602" y="24384"/>
                  </a:lnTo>
                  <a:lnTo>
                    <a:pt x="71602" y="22860"/>
                  </a:lnTo>
                  <a:lnTo>
                    <a:pt x="73126" y="21336"/>
                  </a:lnTo>
                  <a:lnTo>
                    <a:pt x="73126" y="19812"/>
                  </a:lnTo>
                  <a:lnTo>
                    <a:pt x="74663" y="18288"/>
                  </a:lnTo>
                  <a:lnTo>
                    <a:pt x="76174" y="16751"/>
                  </a:lnTo>
                  <a:lnTo>
                    <a:pt x="76174" y="15240"/>
                  </a:lnTo>
                  <a:lnTo>
                    <a:pt x="77698" y="13716"/>
                  </a:lnTo>
                  <a:lnTo>
                    <a:pt x="77698" y="12192"/>
                  </a:lnTo>
                  <a:lnTo>
                    <a:pt x="79222" y="12192"/>
                  </a:lnTo>
                  <a:lnTo>
                    <a:pt x="79222" y="10668"/>
                  </a:lnTo>
                  <a:lnTo>
                    <a:pt x="80746" y="9144"/>
                  </a:lnTo>
                  <a:lnTo>
                    <a:pt x="80746" y="7620"/>
                  </a:lnTo>
                  <a:lnTo>
                    <a:pt x="82270" y="7620"/>
                  </a:lnTo>
                  <a:lnTo>
                    <a:pt x="82270" y="6096"/>
                  </a:lnTo>
                  <a:lnTo>
                    <a:pt x="83794" y="4572"/>
                  </a:lnTo>
                  <a:lnTo>
                    <a:pt x="85318" y="3048"/>
                  </a:lnTo>
                  <a:lnTo>
                    <a:pt x="85318" y="1524"/>
                  </a:lnTo>
                  <a:lnTo>
                    <a:pt x="85318" y="0"/>
                  </a:lnTo>
                  <a:lnTo>
                    <a:pt x="86842" y="0"/>
                  </a:lnTo>
                  <a:lnTo>
                    <a:pt x="167601" y="0"/>
                  </a:lnTo>
                  <a:lnTo>
                    <a:pt x="167601" y="1524"/>
                  </a:lnTo>
                  <a:lnTo>
                    <a:pt x="169125" y="1524"/>
                  </a:lnTo>
                  <a:lnTo>
                    <a:pt x="169125" y="3048"/>
                  </a:lnTo>
                  <a:lnTo>
                    <a:pt x="169125" y="4572"/>
                  </a:lnTo>
                  <a:lnTo>
                    <a:pt x="170649" y="4572"/>
                  </a:lnTo>
                  <a:lnTo>
                    <a:pt x="170649" y="6096"/>
                  </a:lnTo>
                  <a:lnTo>
                    <a:pt x="172173" y="6096"/>
                  </a:lnTo>
                  <a:lnTo>
                    <a:pt x="172173" y="7620"/>
                  </a:lnTo>
                  <a:lnTo>
                    <a:pt x="172173" y="9144"/>
                  </a:lnTo>
                  <a:lnTo>
                    <a:pt x="173685" y="9144"/>
                  </a:lnTo>
                  <a:lnTo>
                    <a:pt x="173685" y="10668"/>
                  </a:lnTo>
                  <a:lnTo>
                    <a:pt x="173685" y="12192"/>
                  </a:lnTo>
                  <a:lnTo>
                    <a:pt x="175209" y="12192"/>
                  </a:lnTo>
                  <a:lnTo>
                    <a:pt x="175209" y="13716"/>
                  </a:lnTo>
                  <a:lnTo>
                    <a:pt x="176745" y="13716"/>
                  </a:lnTo>
                  <a:lnTo>
                    <a:pt x="176745" y="15240"/>
                  </a:lnTo>
                  <a:lnTo>
                    <a:pt x="176745" y="16751"/>
                  </a:lnTo>
                  <a:lnTo>
                    <a:pt x="178269" y="16751"/>
                  </a:lnTo>
                  <a:lnTo>
                    <a:pt x="178269" y="18288"/>
                  </a:lnTo>
                  <a:lnTo>
                    <a:pt x="179781" y="19812"/>
                  </a:lnTo>
                  <a:lnTo>
                    <a:pt x="179781" y="21336"/>
                  </a:lnTo>
                  <a:lnTo>
                    <a:pt x="181305" y="22860"/>
                  </a:lnTo>
                  <a:lnTo>
                    <a:pt x="182841" y="24384"/>
                  </a:lnTo>
                  <a:lnTo>
                    <a:pt x="184353" y="25908"/>
                  </a:lnTo>
                  <a:lnTo>
                    <a:pt x="184353" y="27419"/>
                  </a:lnTo>
                  <a:lnTo>
                    <a:pt x="185877" y="28943"/>
                  </a:lnTo>
                  <a:lnTo>
                    <a:pt x="187401" y="30480"/>
                  </a:lnTo>
                  <a:lnTo>
                    <a:pt x="187401" y="32004"/>
                  </a:lnTo>
                  <a:lnTo>
                    <a:pt x="188937" y="33528"/>
                  </a:lnTo>
                  <a:lnTo>
                    <a:pt x="188937" y="35052"/>
                  </a:lnTo>
                  <a:lnTo>
                    <a:pt x="190449" y="35052"/>
                  </a:lnTo>
                  <a:lnTo>
                    <a:pt x="190449" y="36576"/>
                  </a:lnTo>
                  <a:lnTo>
                    <a:pt x="191973" y="38087"/>
                  </a:lnTo>
                  <a:lnTo>
                    <a:pt x="191973" y="39611"/>
                  </a:lnTo>
                  <a:lnTo>
                    <a:pt x="193497" y="39611"/>
                  </a:lnTo>
                  <a:lnTo>
                    <a:pt x="193497" y="41135"/>
                  </a:lnTo>
                  <a:lnTo>
                    <a:pt x="195021" y="41135"/>
                  </a:lnTo>
                  <a:lnTo>
                    <a:pt x="195021" y="42659"/>
                  </a:lnTo>
                  <a:lnTo>
                    <a:pt x="195021" y="44196"/>
                  </a:lnTo>
                  <a:lnTo>
                    <a:pt x="196545" y="44196"/>
                  </a:lnTo>
                  <a:lnTo>
                    <a:pt x="196545" y="45720"/>
                  </a:lnTo>
                  <a:lnTo>
                    <a:pt x="198069" y="45720"/>
                  </a:lnTo>
                  <a:lnTo>
                    <a:pt x="198069" y="47244"/>
                  </a:lnTo>
                  <a:lnTo>
                    <a:pt x="199593" y="48755"/>
                  </a:lnTo>
                  <a:lnTo>
                    <a:pt x="199593" y="50279"/>
                  </a:lnTo>
                  <a:lnTo>
                    <a:pt x="201117" y="50279"/>
                  </a:lnTo>
                  <a:lnTo>
                    <a:pt x="201117" y="51803"/>
                  </a:lnTo>
                  <a:lnTo>
                    <a:pt x="202641" y="53327"/>
                  </a:lnTo>
                  <a:lnTo>
                    <a:pt x="202641" y="54851"/>
                  </a:lnTo>
                  <a:lnTo>
                    <a:pt x="204165" y="54851"/>
                  </a:lnTo>
                  <a:lnTo>
                    <a:pt x="204165" y="56388"/>
                  </a:lnTo>
                  <a:lnTo>
                    <a:pt x="205689" y="56388"/>
                  </a:lnTo>
                  <a:lnTo>
                    <a:pt x="205689" y="57912"/>
                  </a:lnTo>
                  <a:lnTo>
                    <a:pt x="207213" y="59436"/>
                  </a:lnTo>
                  <a:lnTo>
                    <a:pt x="208737" y="60947"/>
                  </a:lnTo>
                  <a:lnTo>
                    <a:pt x="208737" y="62471"/>
                  </a:lnTo>
                  <a:lnTo>
                    <a:pt x="210261" y="63995"/>
                  </a:lnTo>
                  <a:lnTo>
                    <a:pt x="211785" y="65519"/>
                  </a:lnTo>
                  <a:lnTo>
                    <a:pt x="213309" y="67043"/>
                  </a:lnTo>
                  <a:lnTo>
                    <a:pt x="213309" y="68580"/>
                  </a:lnTo>
                  <a:lnTo>
                    <a:pt x="214833" y="70104"/>
                  </a:lnTo>
                  <a:lnTo>
                    <a:pt x="214833" y="71615"/>
                  </a:lnTo>
                  <a:lnTo>
                    <a:pt x="216357" y="73139"/>
                  </a:lnTo>
                  <a:lnTo>
                    <a:pt x="217881" y="73139"/>
                  </a:lnTo>
                  <a:lnTo>
                    <a:pt x="217881" y="74663"/>
                  </a:lnTo>
                  <a:lnTo>
                    <a:pt x="219405" y="76187"/>
                  </a:lnTo>
                  <a:lnTo>
                    <a:pt x="220929" y="77711"/>
                  </a:lnTo>
                  <a:lnTo>
                    <a:pt x="220929" y="79235"/>
                  </a:lnTo>
                  <a:lnTo>
                    <a:pt x="222453" y="79235"/>
                  </a:lnTo>
                  <a:lnTo>
                    <a:pt x="222453" y="80759"/>
                  </a:lnTo>
                  <a:lnTo>
                    <a:pt x="223977" y="82283"/>
                  </a:lnTo>
                  <a:lnTo>
                    <a:pt x="223977" y="83807"/>
                  </a:lnTo>
                  <a:lnTo>
                    <a:pt x="225488" y="83807"/>
                  </a:lnTo>
                  <a:lnTo>
                    <a:pt x="225488" y="85331"/>
                  </a:lnTo>
                  <a:lnTo>
                    <a:pt x="227025" y="85331"/>
                  </a:lnTo>
                  <a:lnTo>
                    <a:pt x="227025" y="86855"/>
                  </a:lnTo>
                  <a:lnTo>
                    <a:pt x="227025" y="88379"/>
                  </a:lnTo>
                  <a:lnTo>
                    <a:pt x="228549" y="88379"/>
                  </a:lnTo>
                  <a:lnTo>
                    <a:pt x="228549" y="89903"/>
                  </a:lnTo>
                  <a:lnTo>
                    <a:pt x="230073" y="91427"/>
                  </a:lnTo>
                  <a:lnTo>
                    <a:pt x="231584" y="92938"/>
                  </a:lnTo>
                  <a:lnTo>
                    <a:pt x="231584" y="94475"/>
                  </a:lnTo>
                  <a:lnTo>
                    <a:pt x="233121" y="94475"/>
                  </a:lnTo>
                  <a:lnTo>
                    <a:pt x="233121" y="95999"/>
                  </a:lnTo>
                  <a:lnTo>
                    <a:pt x="234645" y="97523"/>
                  </a:lnTo>
                  <a:lnTo>
                    <a:pt x="234645" y="99047"/>
                  </a:lnTo>
                  <a:lnTo>
                    <a:pt x="236156" y="100571"/>
                  </a:lnTo>
                  <a:lnTo>
                    <a:pt x="237680" y="102095"/>
                  </a:lnTo>
                  <a:lnTo>
                    <a:pt x="237680" y="103619"/>
                  </a:lnTo>
                  <a:lnTo>
                    <a:pt x="239217" y="105130"/>
                  </a:lnTo>
                  <a:lnTo>
                    <a:pt x="239217" y="106667"/>
                  </a:lnTo>
                  <a:lnTo>
                    <a:pt x="240741" y="106667"/>
                  </a:lnTo>
                  <a:lnTo>
                    <a:pt x="240741" y="108191"/>
                  </a:lnTo>
                  <a:lnTo>
                    <a:pt x="242252" y="109715"/>
                  </a:lnTo>
                  <a:lnTo>
                    <a:pt x="242252" y="111239"/>
                  </a:lnTo>
                  <a:lnTo>
                    <a:pt x="243776" y="112763"/>
                  </a:lnTo>
                  <a:lnTo>
                    <a:pt x="243776" y="114287"/>
                  </a:lnTo>
                  <a:lnTo>
                    <a:pt x="245313" y="115798"/>
                  </a:lnTo>
                  <a:lnTo>
                    <a:pt x="245313" y="117322"/>
                  </a:lnTo>
                  <a:lnTo>
                    <a:pt x="246824" y="118859"/>
                  </a:lnTo>
                  <a:lnTo>
                    <a:pt x="246824" y="120383"/>
                  </a:lnTo>
                  <a:lnTo>
                    <a:pt x="248348" y="121907"/>
                  </a:lnTo>
                  <a:lnTo>
                    <a:pt x="248348" y="123431"/>
                  </a:lnTo>
                  <a:lnTo>
                    <a:pt x="248348" y="124955"/>
                  </a:lnTo>
                  <a:lnTo>
                    <a:pt x="249872" y="124955"/>
                  </a:lnTo>
                  <a:lnTo>
                    <a:pt x="249872" y="126466"/>
                  </a:lnTo>
                  <a:lnTo>
                    <a:pt x="249872" y="127990"/>
                  </a:lnTo>
                  <a:lnTo>
                    <a:pt x="249872" y="129514"/>
                  </a:lnTo>
                  <a:lnTo>
                    <a:pt x="251396" y="129514"/>
                  </a:lnTo>
                  <a:lnTo>
                    <a:pt x="251396" y="131038"/>
                  </a:lnTo>
                  <a:lnTo>
                    <a:pt x="251396" y="132575"/>
                  </a:lnTo>
                  <a:lnTo>
                    <a:pt x="252920" y="134099"/>
                  </a:lnTo>
                  <a:lnTo>
                    <a:pt x="252920" y="141706"/>
                  </a:lnTo>
                  <a:lnTo>
                    <a:pt x="254444" y="141706"/>
                  </a:lnTo>
                  <a:lnTo>
                    <a:pt x="254444" y="159994"/>
                  </a:lnTo>
                  <a:lnTo>
                    <a:pt x="252920" y="159994"/>
                  </a:lnTo>
                  <a:lnTo>
                    <a:pt x="252920" y="167614"/>
                  </a:lnTo>
                  <a:lnTo>
                    <a:pt x="251396" y="169138"/>
                  </a:lnTo>
                  <a:lnTo>
                    <a:pt x="251396" y="170662"/>
                  </a:lnTo>
                  <a:lnTo>
                    <a:pt x="251396" y="172186"/>
                  </a:lnTo>
                  <a:lnTo>
                    <a:pt x="249872" y="173710"/>
                  </a:lnTo>
                  <a:lnTo>
                    <a:pt x="249872" y="175234"/>
                  </a:lnTo>
                  <a:lnTo>
                    <a:pt x="249872" y="176758"/>
                  </a:lnTo>
                  <a:lnTo>
                    <a:pt x="248348" y="176758"/>
                  </a:lnTo>
                  <a:lnTo>
                    <a:pt x="248348" y="178282"/>
                  </a:lnTo>
                  <a:lnTo>
                    <a:pt x="248348" y="179806"/>
                  </a:lnTo>
                  <a:lnTo>
                    <a:pt x="248348" y="181317"/>
                  </a:lnTo>
                  <a:lnTo>
                    <a:pt x="246824" y="181317"/>
                  </a:lnTo>
                  <a:lnTo>
                    <a:pt x="246824" y="182854"/>
                  </a:lnTo>
                  <a:lnTo>
                    <a:pt x="246824" y="184378"/>
                  </a:lnTo>
                  <a:lnTo>
                    <a:pt x="245313" y="184378"/>
                  </a:lnTo>
                  <a:lnTo>
                    <a:pt x="245313" y="185902"/>
                  </a:lnTo>
                  <a:lnTo>
                    <a:pt x="245313" y="187426"/>
                  </a:lnTo>
                  <a:lnTo>
                    <a:pt x="243776" y="188950"/>
                  </a:lnTo>
                  <a:lnTo>
                    <a:pt x="243776" y="190474"/>
                  </a:lnTo>
                  <a:lnTo>
                    <a:pt x="242252" y="191985"/>
                  </a:lnTo>
                  <a:lnTo>
                    <a:pt x="242252" y="193509"/>
                  </a:lnTo>
                  <a:lnTo>
                    <a:pt x="240741" y="195046"/>
                  </a:lnTo>
                  <a:lnTo>
                    <a:pt x="240741" y="196570"/>
                  </a:lnTo>
                  <a:lnTo>
                    <a:pt x="239217" y="196570"/>
                  </a:lnTo>
                  <a:lnTo>
                    <a:pt x="239217" y="198094"/>
                  </a:lnTo>
                  <a:lnTo>
                    <a:pt x="239217" y="199618"/>
                  </a:lnTo>
                  <a:lnTo>
                    <a:pt x="237680" y="199618"/>
                  </a:lnTo>
                  <a:lnTo>
                    <a:pt x="237680" y="201142"/>
                  </a:lnTo>
                  <a:lnTo>
                    <a:pt x="237680" y="202666"/>
                  </a:lnTo>
                  <a:lnTo>
                    <a:pt x="236156" y="204177"/>
                  </a:lnTo>
                  <a:lnTo>
                    <a:pt x="234645" y="205701"/>
                  </a:lnTo>
                  <a:lnTo>
                    <a:pt x="234645" y="207238"/>
                  </a:lnTo>
                  <a:lnTo>
                    <a:pt x="233121" y="207238"/>
                  </a:lnTo>
                  <a:lnTo>
                    <a:pt x="233121" y="208762"/>
                  </a:lnTo>
                  <a:lnTo>
                    <a:pt x="233121" y="210286"/>
                  </a:lnTo>
                  <a:lnTo>
                    <a:pt x="231584" y="211810"/>
                  </a:lnTo>
                  <a:lnTo>
                    <a:pt x="230073" y="213334"/>
                  </a:lnTo>
                  <a:lnTo>
                    <a:pt x="230073" y="214845"/>
                  </a:lnTo>
                  <a:lnTo>
                    <a:pt x="230073" y="216369"/>
                  </a:lnTo>
                  <a:lnTo>
                    <a:pt x="228549" y="216369"/>
                  </a:lnTo>
                  <a:lnTo>
                    <a:pt x="228549" y="217893"/>
                  </a:lnTo>
                  <a:lnTo>
                    <a:pt x="227025" y="219417"/>
                  </a:lnTo>
                  <a:lnTo>
                    <a:pt x="227025" y="220954"/>
                  </a:lnTo>
                  <a:lnTo>
                    <a:pt x="225488" y="222478"/>
                  </a:lnTo>
                  <a:lnTo>
                    <a:pt x="225488" y="224002"/>
                  </a:lnTo>
                  <a:lnTo>
                    <a:pt x="223977" y="224002"/>
                  </a:lnTo>
                  <a:lnTo>
                    <a:pt x="223977" y="225513"/>
                  </a:lnTo>
                  <a:lnTo>
                    <a:pt x="223977" y="227037"/>
                  </a:lnTo>
                  <a:lnTo>
                    <a:pt x="222453" y="228561"/>
                  </a:lnTo>
                  <a:lnTo>
                    <a:pt x="222453" y="230085"/>
                  </a:lnTo>
                  <a:lnTo>
                    <a:pt x="222453" y="231609"/>
                  </a:lnTo>
                  <a:lnTo>
                    <a:pt x="220929" y="231609"/>
                  </a:lnTo>
                  <a:lnTo>
                    <a:pt x="220929" y="233146"/>
                  </a:lnTo>
                  <a:lnTo>
                    <a:pt x="219405" y="233146"/>
                  </a:lnTo>
                  <a:lnTo>
                    <a:pt x="219405" y="234670"/>
                  </a:lnTo>
                  <a:lnTo>
                    <a:pt x="219405" y="236181"/>
                  </a:lnTo>
                  <a:lnTo>
                    <a:pt x="217881" y="236181"/>
                  </a:lnTo>
                  <a:lnTo>
                    <a:pt x="217881" y="237705"/>
                  </a:lnTo>
                  <a:lnTo>
                    <a:pt x="217881" y="239229"/>
                  </a:lnTo>
                  <a:lnTo>
                    <a:pt x="217881" y="240753"/>
                  </a:lnTo>
                  <a:lnTo>
                    <a:pt x="216357" y="240753"/>
                  </a:lnTo>
                  <a:lnTo>
                    <a:pt x="216357" y="242277"/>
                  </a:lnTo>
                  <a:lnTo>
                    <a:pt x="216357" y="243801"/>
                  </a:lnTo>
                  <a:lnTo>
                    <a:pt x="214833" y="245338"/>
                  </a:lnTo>
                  <a:lnTo>
                    <a:pt x="214833" y="246849"/>
                  </a:lnTo>
                  <a:lnTo>
                    <a:pt x="214833" y="248373"/>
                  </a:lnTo>
                  <a:lnTo>
                    <a:pt x="213309" y="249897"/>
                  </a:lnTo>
                  <a:lnTo>
                    <a:pt x="213309" y="251421"/>
                  </a:lnTo>
                  <a:lnTo>
                    <a:pt x="213309" y="252945"/>
                  </a:lnTo>
                  <a:lnTo>
                    <a:pt x="213309" y="254469"/>
                  </a:lnTo>
                  <a:lnTo>
                    <a:pt x="213309" y="255993"/>
                  </a:lnTo>
                  <a:lnTo>
                    <a:pt x="211785" y="255993"/>
                  </a:lnTo>
                  <a:lnTo>
                    <a:pt x="211785" y="265137"/>
                  </a:lnTo>
                  <a:lnTo>
                    <a:pt x="210261" y="265137"/>
                  </a:lnTo>
                  <a:lnTo>
                    <a:pt x="210261" y="291033"/>
                  </a:lnTo>
                  <a:lnTo>
                    <a:pt x="211785" y="291033"/>
                  </a:lnTo>
                  <a:lnTo>
                    <a:pt x="211785" y="301701"/>
                  </a:lnTo>
                  <a:lnTo>
                    <a:pt x="213309" y="303225"/>
                  </a:lnTo>
                  <a:lnTo>
                    <a:pt x="213309" y="312381"/>
                  </a:lnTo>
                  <a:lnTo>
                    <a:pt x="214833" y="312381"/>
                  </a:lnTo>
                  <a:lnTo>
                    <a:pt x="214833" y="321525"/>
                  </a:lnTo>
                  <a:lnTo>
                    <a:pt x="216357" y="321525"/>
                  </a:lnTo>
                  <a:lnTo>
                    <a:pt x="216357" y="323049"/>
                  </a:lnTo>
                  <a:lnTo>
                    <a:pt x="216357" y="324561"/>
                  </a:lnTo>
                  <a:lnTo>
                    <a:pt x="216357" y="326085"/>
                  </a:lnTo>
                  <a:lnTo>
                    <a:pt x="216357" y="327609"/>
                  </a:lnTo>
                  <a:lnTo>
                    <a:pt x="217881" y="329133"/>
                  </a:lnTo>
                  <a:lnTo>
                    <a:pt x="217881" y="365709"/>
                  </a:lnTo>
                  <a:lnTo>
                    <a:pt x="216357" y="365709"/>
                  </a:lnTo>
                  <a:lnTo>
                    <a:pt x="216357" y="367220"/>
                  </a:lnTo>
                  <a:lnTo>
                    <a:pt x="216357" y="368744"/>
                  </a:lnTo>
                  <a:lnTo>
                    <a:pt x="216357" y="370268"/>
                  </a:lnTo>
                  <a:lnTo>
                    <a:pt x="214833" y="371805"/>
                  </a:lnTo>
                  <a:lnTo>
                    <a:pt x="214833" y="373329"/>
                  </a:lnTo>
                  <a:lnTo>
                    <a:pt x="214833" y="374853"/>
                  </a:lnTo>
                  <a:lnTo>
                    <a:pt x="214833" y="376377"/>
                  </a:lnTo>
                  <a:lnTo>
                    <a:pt x="213309" y="376377"/>
                  </a:lnTo>
                  <a:lnTo>
                    <a:pt x="213309" y="377888"/>
                  </a:lnTo>
                  <a:lnTo>
                    <a:pt x="213309" y="379412"/>
                  </a:lnTo>
                  <a:lnTo>
                    <a:pt x="213309" y="380936"/>
                  </a:lnTo>
                  <a:lnTo>
                    <a:pt x="211785" y="382460"/>
                  </a:lnTo>
                  <a:lnTo>
                    <a:pt x="211785" y="383984"/>
                  </a:lnTo>
                  <a:lnTo>
                    <a:pt x="211785" y="385521"/>
                  </a:lnTo>
                  <a:lnTo>
                    <a:pt x="210261" y="385521"/>
                  </a:lnTo>
                  <a:lnTo>
                    <a:pt x="210261" y="387045"/>
                  </a:lnTo>
                  <a:lnTo>
                    <a:pt x="208737" y="388556"/>
                  </a:lnTo>
                  <a:lnTo>
                    <a:pt x="208737" y="390080"/>
                  </a:lnTo>
                  <a:lnTo>
                    <a:pt x="208737" y="391604"/>
                  </a:lnTo>
                  <a:lnTo>
                    <a:pt x="207213" y="391604"/>
                  </a:lnTo>
                  <a:lnTo>
                    <a:pt x="207213" y="393128"/>
                  </a:lnTo>
                  <a:lnTo>
                    <a:pt x="207213" y="394652"/>
                  </a:lnTo>
                  <a:lnTo>
                    <a:pt x="205689" y="396176"/>
                  </a:lnTo>
                  <a:lnTo>
                    <a:pt x="204165" y="397713"/>
                  </a:lnTo>
                  <a:lnTo>
                    <a:pt x="204165" y="399237"/>
                  </a:lnTo>
                  <a:lnTo>
                    <a:pt x="204165" y="400748"/>
                  </a:lnTo>
                  <a:lnTo>
                    <a:pt x="202641" y="400748"/>
                  </a:lnTo>
                  <a:lnTo>
                    <a:pt x="202641" y="402272"/>
                  </a:lnTo>
                  <a:lnTo>
                    <a:pt x="201117" y="403796"/>
                  </a:lnTo>
                  <a:lnTo>
                    <a:pt x="201117" y="405320"/>
                  </a:lnTo>
                  <a:lnTo>
                    <a:pt x="199593" y="405320"/>
                  </a:lnTo>
                  <a:lnTo>
                    <a:pt x="199593" y="406844"/>
                  </a:lnTo>
                  <a:lnTo>
                    <a:pt x="198069" y="408368"/>
                  </a:lnTo>
                  <a:lnTo>
                    <a:pt x="198069" y="409905"/>
                  </a:lnTo>
                  <a:lnTo>
                    <a:pt x="196545" y="411416"/>
                  </a:lnTo>
                  <a:lnTo>
                    <a:pt x="195021" y="412940"/>
                  </a:lnTo>
                  <a:lnTo>
                    <a:pt x="195021" y="414464"/>
                  </a:lnTo>
                  <a:lnTo>
                    <a:pt x="193497" y="415988"/>
                  </a:lnTo>
                  <a:lnTo>
                    <a:pt x="193497" y="417512"/>
                  </a:lnTo>
                  <a:lnTo>
                    <a:pt x="191973" y="417512"/>
                  </a:lnTo>
                  <a:lnTo>
                    <a:pt x="191973" y="419036"/>
                  </a:lnTo>
                  <a:lnTo>
                    <a:pt x="191973" y="420560"/>
                  </a:lnTo>
                  <a:lnTo>
                    <a:pt x="190449" y="420560"/>
                  </a:lnTo>
                  <a:lnTo>
                    <a:pt x="188937" y="422084"/>
                  </a:lnTo>
                  <a:lnTo>
                    <a:pt x="188937" y="423608"/>
                  </a:lnTo>
                  <a:lnTo>
                    <a:pt x="187401" y="425132"/>
                  </a:lnTo>
                  <a:lnTo>
                    <a:pt x="187401" y="426656"/>
                  </a:lnTo>
                  <a:lnTo>
                    <a:pt x="185877" y="426656"/>
                  </a:lnTo>
                  <a:lnTo>
                    <a:pt x="185877" y="428180"/>
                  </a:lnTo>
                  <a:lnTo>
                    <a:pt x="184353" y="428180"/>
                  </a:lnTo>
                  <a:lnTo>
                    <a:pt x="184353" y="429704"/>
                  </a:lnTo>
                  <a:lnTo>
                    <a:pt x="182841" y="431228"/>
                  </a:lnTo>
                  <a:lnTo>
                    <a:pt x="182841" y="432752"/>
                  </a:lnTo>
                  <a:lnTo>
                    <a:pt x="181305" y="432752"/>
                  </a:lnTo>
                  <a:lnTo>
                    <a:pt x="181305" y="434263"/>
                  </a:lnTo>
                  <a:lnTo>
                    <a:pt x="179781" y="434263"/>
                  </a:lnTo>
                  <a:lnTo>
                    <a:pt x="179781" y="435800"/>
                  </a:lnTo>
                  <a:lnTo>
                    <a:pt x="178269" y="437324"/>
                  </a:lnTo>
                  <a:lnTo>
                    <a:pt x="178269" y="438848"/>
                  </a:lnTo>
                  <a:lnTo>
                    <a:pt x="176745" y="438848"/>
                  </a:lnTo>
                  <a:lnTo>
                    <a:pt x="176745" y="440372"/>
                  </a:lnTo>
                  <a:lnTo>
                    <a:pt x="176745" y="441896"/>
                  </a:lnTo>
                  <a:lnTo>
                    <a:pt x="175209" y="441896"/>
                  </a:lnTo>
                  <a:lnTo>
                    <a:pt x="175209" y="443420"/>
                  </a:lnTo>
                  <a:lnTo>
                    <a:pt x="173685" y="443420"/>
                  </a:lnTo>
                  <a:lnTo>
                    <a:pt x="173685" y="444931"/>
                  </a:lnTo>
                  <a:lnTo>
                    <a:pt x="172173" y="444931"/>
                  </a:lnTo>
                  <a:lnTo>
                    <a:pt x="172173" y="446455"/>
                  </a:lnTo>
                  <a:lnTo>
                    <a:pt x="172173" y="447992"/>
                  </a:lnTo>
                  <a:lnTo>
                    <a:pt x="170649" y="447992"/>
                  </a:lnTo>
                  <a:lnTo>
                    <a:pt x="170649" y="449516"/>
                  </a:lnTo>
                  <a:lnTo>
                    <a:pt x="169125" y="449516"/>
                  </a:lnTo>
                  <a:lnTo>
                    <a:pt x="169125" y="451040"/>
                  </a:lnTo>
                  <a:lnTo>
                    <a:pt x="167601" y="452564"/>
                  </a:lnTo>
                  <a:lnTo>
                    <a:pt x="167601" y="454088"/>
                  </a:lnTo>
                  <a:lnTo>
                    <a:pt x="166077" y="454088"/>
                  </a:lnTo>
                  <a:lnTo>
                    <a:pt x="86842" y="454088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0" name="object 50"/>
            <p:cNvSpPr/>
            <p:nvPr/>
          </p:nvSpPr>
          <p:spPr>
            <a:xfrm>
              <a:off x="2597436" y="5944222"/>
              <a:ext cx="323215" cy="913130"/>
            </a:xfrm>
            <a:custGeom>
              <a:avLst/>
              <a:gdLst/>
              <a:ahLst/>
              <a:cxnLst/>
              <a:rect l="l" t="t" r="r" b="b"/>
              <a:pathLst>
                <a:path w="323214" h="913129">
                  <a:moveTo>
                    <a:pt x="163029" y="0"/>
                  </a:moveTo>
                  <a:lnTo>
                    <a:pt x="159981" y="0"/>
                  </a:lnTo>
                  <a:lnTo>
                    <a:pt x="159981" y="4572"/>
                  </a:lnTo>
                  <a:lnTo>
                    <a:pt x="158457" y="6096"/>
                  </a:lnTo>
                  <a:lnTo>
                    <a:pt x="158457" y="15240"/>
                  </a:lnTo>
                  <a:lnTo>
                    <a:pt x="156933" y="18288"/>
                  </a:lnTo>
                  <a:lnTo>
                    <a:pt x="156933" y="24384"/>
                  </a:lnTo>
                  <a:lnTo>
                    <a:pt x="155409" y="25908"/>
                  </a:lnTo>
                  <a:lnTo>
                    <a:pt x="155409" y="31991"/>
                  </a:lnTo>
                  <a:lnTo>
                    <a:pt x="153885" y="33528"/>
                  </a:lnTo>
                  <a:lnTo>
                    <a:pt x="153885" y="35052"/>
                  </a:lnTo>
                  <a:lnTo>
                    <a:pt x="152361" y="38100"/>
                  </a:lnTo>
                  <a:lnTo>
                    <a:pt x="152361" y="41135"/>
                  </a:lnTo>
                  <a:lnTo>
                    <a:pt x="150837" y="42659"/>
                  </a:lnTo>
                  <a:lnTo>
                    <a:pt x="150837" y="44183"/>
                  </a:lnTo>
                  <a:lnTo>
                    <a:pt x="149313" y="45707"/>
                  </a:lnTo>
                  <a:lnTo>
                    <a:pt x="149313" y="50292"/>
                  </a:lnTo>
                  <a:lnTo>
                    <a:pt x="146265" y="53327"/>
                  </a:lnTo>
                  <a:lnTo>
                    <a:pt x="146265" y="54851"/>
                  </a:lnTo>
                  <a:lnTo>
                    <a:pt x="144741" y="57899"/>
                  </a:lnTo>
                  <a:lnTo>
                    <a:pt x="144741" y="59436"/>
                  </a:lnTo>
                  <a:lnTo>
                    <a:pt x="140169" y="63995"/>
                  </a:lnTo>
                  <a:lnTo>
                    <a:pt x="140169" y="65519"/>
                  </a:lnTo>
                  <a:lnTo>
                    <a:pt x="138645" y="68567"/>
                  </a:lnTo>
                  <a:lnTo>
                    <a:pt x="135610" y="71628"/>
                  </a:lnTo>
                  <a:lnTo>
                    <a:pt x="135610" y="73152"/>
                  </a:lnTo>
                  <a:lnTo>
                    <a:pt x="132549" y="76187"/>
                  </a:lnTo>
                  <a:lnTo>
                    <a:pt x="131038" y="79235"/>
                  </a:lnTo>
                  <a:lnTo>
                    <a:pt x="124942" y="85331"/>
                  </a:lnTo>
                  <a:lnTo>
                    <a:pt x="123418" y="88379"/>
                  </a:lnTo>
                  <a:lnTo>
                    <a:pt x="115798" y="95986"/>
                  </a:lnTo>
                  <a:lnTo>
                    <a:pt x="114274" y="99047"/>
                  </a:lnTo>
                  <a:lnTo>
                    <a:pt x="109702" y="103619"/>
                  </a:lnTo>
                  <a:lnTo>
                    <a:pt x="106654" y="105143"/>
                  </a:lnTo>
                  <a:lnTo>
                    <a:pt x="105130" y="106667"/>
                  </a:lnTo>
                  <a:lnTo>
                    <a:pt x="103606" y="109715"/>
                  </a:lnTo>
                  <a:lnTo>
                    <a:pt x="100558" y="111239"/>
                  </a:lnTo>
                  <a:lnTo>
                    <a:pt x="99034" y="112763"/>
                  </a:lnTo>
                  <a:lnTo>
                    <a:pt x="95986" y="114287"/>
                  </a:lnTo>
                  <a:lnTo>
                    <a:pt x="94462" y="115811"/>
                  </a:lnTo>
                  <a:lnTo>
                    <a:pt x="91414" y="117335"/>
                  </a:lnTo>
                  <a:lnTo>
                    <a:pt x="89890" y="120370"/>
                  </a:lnTo>
                  <a:lnTo>
                    <a:pt x="86842" y="121894"/>
                  </a:lnTo>
                  <a:lnTo>
                    <a:pt x="85331" y="123431"/>
                  </a:lnTo>
                  <a:lnTo>
                    <a:pt x="79235" y="126479"/>
                  </a:lnTo>
                  <a:lnTo>
                    <a:pt x="73139" y="132562"/>
                  </a:lnTo>
                  <a:lnTo>
                    <a:pt x="63995" y="137147"/>
                  </a:lnTo>
                  <a:lnTo>
                    <a:pt x="57899" y="143230"/>
                  </a:lnTo>
                  <a:lnTo>
                    <a:pt x="48755" y="147815"/>
                  </a:lnTo>
                  <a:lnTo>
                    <a:pt x="42659" y="153898"/>
                  </a:lnTo>
                  <a:lnTo>
                    <a:pt x="39611" y="155422"/>
                  </a:lnTo>
                  <a:lnTo>
                    <a:pt x="38087" y="156946"/>
                  </a:lnTo>
                  <a:lnTo>
                    <a:pt x="35039" y="158470"/>
                  </a:lnTo>
                  <a:lnTo>
                    <a:pt x="31991" y="161518"/>
                  </a:lnTo>
                  <a:lnTo>
                    <a:pt x="30467" y="164566"/>
                  </a:lnTo>
                  <a:lnTo>
                    <a:pt x="28943" y="166090"/>
                  </a:lnTo>
                  <a:lnTo>
                    <a:pt x="25895" y="167614"/>
                  </a:lnTo>
                  <a:lnTo>
                    <a:pt x="22860" y="170662"/>
                  </a:lnTo>
                  <a:lnTo>
                    <a:pt x="21336" y="173710"/>
                  </a:lnTo>
                  <a:lnTo>
                    <a:pt x="15240" y="179806"/>
                  </a:lnTo>
                  <a:lnTo>
                    <a:pt x="15240" y="181330"/>
                  </a:lnTo>
                  <a:lnTo>
                    <a:pt x="13703" y="184365"/>
                  </a:lnTo>
                  <a:lnTo>
                    <a:pt x="12192" y="185902"/>
                  </a:lnTo>
                  <a:lnTo>
                    <a:pt x="12192" y="187426"/>
                  </a:lnTo>
                  <a:lnTo>
                    <a:pt x="9144" y="190474"/>
                  </a:lnTo>
                  <a:lnTo>
                    <a:pt x="7620" y="193522"/>
                  </a:lnTo>
                  <a:lnTo>
                    <a:pt x="7620" y="195033"/>
                  </a:lnTo>
                  <a:lnTo>
                    <a:pt x="6096" y="196557"/>
                  </a:lnTo>
                  <a:lnTo>
                    <a:pt x="6096" y="198094"/>
                  </a:lnTo>
                  <a:lnTo>
                    <a:pt x="4572" y="199618"/>
                  </a:lnTo>
                  <a:lnTo>
                    <a:pt x="4572" y="201142"/>
                  </a:lnTo>
                  <a:lnTo>
                    <a:pt x="3048" y="204190"/>
                  </a:lnTo>
                  <a:lnTo>
                    <a:pt x="3048" y="207225"/>
                  </a:lnTo>
                  <a:lnTo>
                    <a:pt x="1524" y="208749"/>
                  </a:lnTo>
                  <a:lnTo>
                    <a:pt x="1524" y="211810"/>
                  </a:lnTo>
                  <a:lnTo>
                    <a:pt x="0" y="214858"/>
                  </a:lnTo>
                  <a:lnTo>
                    <a:pt x="0" y="228561"/>
                  </a:lnTo>
                  <a:lnTo>
                    <a:pt x="1524" y="230085"/>
                  </a:lnTo>
                  <a:lnTo>
                    <a:pt x="1524" y="234657"/>
                  </a:lnTo>
                  <a:lnTo>
                    <a:pt x="3048" y="236194"/>
                  </a:lnTo>
                  <a:lnTo>
                    <a:pt x="3048" y="237718"/>
                  </a:lnTo>
                  <a:lnTo>
                    <a:pt x="4572" y="239229"/>
                  </a:lnTo>
                  <a:lnTo>
                    <a:pt x="4572" y="240753"/>
                  </a:lnTo>
                  <a:lnTo>
                    <a:pt x="6096" y="243801"/>
                  </a:lnTo>
                  <a:lnTo>
                    <a:pt x="7620" y="245325"/>
                  </a:lnTo>
                  <a:lnTo>
                    <a:pt x="7620" y="246849"/>
                  </a:lnTo>
                  <a:lnTo>
                    <a:pt x="12192" y="251421"/>
                  </a:lnTo>
                  <a:lnTo>
                    <a:pt x="12192" y="254469"/>
                  </a:lnTo>
                  <a:lnTo>
                    <a:pt x="15240" y="257517"/>
                  </a:lnTo>
                  <a:lnTo>
                    <a:pt x="15240" y="259041"/>
                  </a:lnTo>
                  <a:lnTo>
                    <a:pt x="18275" y="260553"/>
                  </a:lnTo>
                  <a:lnTo>
                    <a:pt x="18275" y="262089"/>
                  </a:lnTo>
                  <a:lnTo>
                    <a:pt x="19799" y="265137"/>
                  </a:lnTo>
                  <a:lnTo>
                    <a:pt x="22860" y="268185"/>
                  </a:lnTo>
                  <a:lnTo>
                    <a:pt x="22860" y="269709"/>
                  </a:lnTo>
                  <a:lnTo>
                    <a:pt x="24371" y="271221"/>
                  </a:lnTo>
                  <a:lnTo>
                    <a:pt x="25895" y="274281"/>
                  </a:lnTo>
                  <a:lnTo>
                    <a:pt x="27419" y="275805"/>
                  </a:lnTo>
                  <a:lnTo>
                    <a:pt x="27419" y="277329"/>
                  </a:lnTo>
                  <a:lnTo>
                    <a:pt x="28943" y="278853"/>
                  </a:lnTo>
                  <a:lnTo>
                    <a:pt x="28943" y="280377"/>
                  </a:lnTo>
                  <a:lnTo>
                    <a:pt x="30467" y="281901"/>
                  </a:lnTo>
                  <a:lnTo>
                    <a:pt x="31991" y="284937"/>
                  </a:lnTo>
                  <a:lnTo>
                    <a:pt x="31991" y="286461"/>
                  </a:lnTo>
                  <a:lnTo>
                    <a:pt x="35039" y="289521"/>
                  </a:lnTo>
                  <a:lnTo>
                    <a:pt x="35039" y="291045"/>
                  </a:lnTo>
                  <a:lnTo>
                    <a:pt x="36563" y="292569"/>
                  </a:lnTo>
                  <a:lnTo>
                    <a:pt x="36563" y="294081"/>
                  </a:lnTo>
                  <a:lnTo>
                    <a:pt x="38087" y="297129"/>
                  </a:lnTo>
                  <a:lnTo>
                    <a:pt x="39611" y="298653"/>
                  </a:lnTo>
                  <a:lnTo>
                    <a:pt x="39611" y="300189"/>
                  </a:lnTo>
                  <a:lnTo>
                    <a:pt x="42659" y="303237"/>
                  </a:lnTo>
                  <a:lnTo>
                    <a:pt x="42659" y="306273"/>
                  </a:lnTo>
                  <a:lnTo>
                    <a:pt x="45707" y="309321"/>
                  </a:lnTo>
                  <a:lnTo>
                    <a:pt x="45707" y="310845"/>
                  </a:lnTo>
                  <a:lnTo>
                    <a:pt x="50279" y="315417"/>
                  </a:lnTo>
                  <a:lnTo>
                    <a:pt x="51803" y="318465"/>
                  </a:lnTo>
                  <a:lnTo>
                    <a:pt x="53327" y="319989"/>
                  </a:lnTo>
                  <a:lnTo>
                    <a:pt x="53327" y="321513"/>
                  </a:lnTo>
                  <a:lnTo>
                    <a:pt x="57899" y="326097"/>
                  </a:lnTo>
                  <a:lnTo>
                    <a:pt x="59423" y="329133"/>
                  </a:lnTo>
                  <a:lnTo>
                    <a:pt x="60947" y="330657"/>
                  </a:lnTo>
                  <a:lnTo>
                    <a:pt x="60947" y="332181"/>
                  </a:lnTo>
                  <a:lnTo>
                    <a:pt x="63995" y="333705"/>
                  </a:lnTo>
                  <a:lnTo>
                    <a:pt x="63995" y="335229"/>
                  </a:lnTo>
                  <a:lnTo>
                    <a:pt x="65519" y="336753"/>
                  </a:lnTo>
                  <a:lnTo>
                    <a:pt x="67043" y="339801"/>
                  </a:lnTo>
                  <a:lnTo>
                    <a:pt x="70078" y="342849"/>
                  </a:lnTo>
                  <a:lnTo>
                    <a:pt x="70078" y="344373"/>
                  </a:lnTo>
                  <a:lnTo>
                    <a:pt x="73139" y="347421"/>
                  </a:lnTo>
                  <a:lnTo>
                    <a:pt x="74663" y="350469"/>
                  </a:lnTo>
                  <a:lnTo>
                    <a:pt x="74663" y="351993"/>
                  </a:lnTo>
                  <a:lnTo>
                    <a:pt x="79235" y="356565"/>
                  </a:lnTo>
                  <a:lnTo>
                    <a:pt x="79235" y="359600"/>
                  </a:lnTo>
                  <a:lnTo>
                    <a:pt x="83794" y="364185"/>
                  </a:lnTo>
                  <a:lnTo>
                    <a:pt x="83794" y="365709"/>
                  </a:lnTo>
                  <a:lnTo>
                    <a:pt x="85331" y="367233"/>
                  </a:lnTo>
                  <a:lnTo>
                    <a:pt x="86842" y="370268"/>
                  </a:lnTo>
                  <a:lnTo>
                    <a:pt x="86842" y="371792"/>
                  </a:lnTo>
                  <a:lnTo>
                    <a:pt x="89890" y="374840"/>
                  </a:lnTo>
                  <a:lnTo>
                    <a:pt x="89890" y="376377"/>
                  </a:lnTo>
                  <a:lnTo>
                    <a:pt x="91414" y="379425"/>
                  </a:lnTo>
                  <a:lnTo>
                    <a:pt x="94462" y="382460"/>
                  </a:lnTo>
                  <a:lnTo>
                    <a:pt x="94462" y="383984"/>
                  </a:lnTo>
                  <a:lnTo>
                    <a:pt x="97510" y="387032"/>
                  </a:lnTo>
                  <a:lnTo>
                    <a:pt x="97510" y="390093"/>
                  </a:lnTo>
                  <a:lnTo>
                    <a:pt x="100558" y="393128"/>
                  </a:lnTo>
                  <a:lnTo>
                    <a:pt x="100558" y="394652"/>
                  </a:lnTo>
                  <a:lnTo>
                    <a:pt x="103606" y="397700"/>
                  </a:lnTo>
                  <a:lnTo>
                    <a:pt x="103606" y="400761"/>
                  </a:lnTo>
                  <a:lnTo>
                    <a:pt x="106654" y="403796"/>
                  </a:lnTo>
                  <a:lnTo>
                    <a:pt x="106654" y="405320"/>
                  </a:lnTo>
                  <a:lnTo>
                    <a:pt x="108178" y="406844"/>
                  </a:lnTo>
                  <a:lnTo>
                    <a:pt x="108178" y="409892"/>
                  </a:lnTo>
                  <a:lnTo>
                    <a:pt x="109702" y="411416"/>
                  </a:lnTo>
                  <a:lnTo>
                    <a:pt x="109702" y="412940"/>
                  </a:lnTo>
                  <a:lnTo>
                    <a:pt x="111226" y="414464"/>
                  </a:lnTo>
                  <a:lnTo>
                    <a:pt x="111226" y="417512"/>
                  </a:lnTo>
                  <a:lnTo>
                    <a:pt x="112750" y="420560"/>
                  </a:lnTo>
                  <a:lnTo>
                    <a:pt x="112750" y="422084"/>
                  </a:lnTo>
                  <a:lnTo>
                    <a:pt x="114274" y="423608"/>
                  </a:lnTo>
                  <a:lnTo>
                    <a:pt x="114274" y="426656"/>
                  </a:lnTo>
                  <a:lnTo>
                    <a:pt x="115798" y="429704"/>
                  </a:lnTo>
                  <a:lnTo>
                    <a:pt x="115798" y="434276"/>
                  </a:lnTo>
                  <a:lnTo>
                    <a:pt x="117322" y="435800"/>
                  </a:lnTo>
                  <a:lnTo>
                    <a:pt x="117322" y="440372"/>
                  </a:lnTo>
                  <a:lnTo>
                    <a:pt x="118846" y="441896"/>
                  </a:lnTo>
                  <a:lnTo>
                    <a:pt x="118846" y="447979"/>
                  </a:lnTo>
                  <a:lnTo>
                    <a:pt x="120370" y="451040"/>
                  </a:lnTo>
                  <a:lnTo>
                    <a:pt x="120370" y="455612"/>
                  </a:lnTo>
                  <a:lnTo>
                    <a:pt x="121881" y="457136"/>
                  </a:lnTo>
                  <a:lnTo>
                    <a:pt x="121881" y="463219"/>
                  </a:lnTo>
                  <a:lnTo>
                    <a:pt x="123418" y="464756"/>
                  </a:lnTo>
                  <a:lnTo>
                    <a:pt x="123418" y="467804"/>
                  </a:lnTo>
                  <a:lnTo>
                    <a:pt x="124942" y="469315"/>
                  </a:lnTo>
                  <a:lnTo>
                    <a:pt x="124942" y="475411"/>
                  </a:lnTo>
                  <a:lnTo>
                    <a:pt x="126466" y="476948"/>
                  </a:lnTo>
                  <a:lnTo>
                    <a:pt x="126466" y="484555"/>
                  </a:lnTo>
                  <a:lnTo>
                    <a:pt x="127977" y="486079"/>
                  </a:lnTo>
                  <a:lnTo>
                    <a:pt x="127977" y="490651"/>
                  </a:lnTo>
                  <a:lnTo>
                    <a:pt x="129514" y="493699"/>
                  </a:lnTo>
                  <a:lnTo>
                    <a:pt x="129514" y="501319"/>
                  </a:lnTo>
                  <a:lnTo>
                    <a:pt x="131038" y="502843"/>
                  </a:lnTo>
                  <a:lnTo>
                    <a:pt x="131038" y="511987"/>
                  </a:lnTo>
                  <a:lnTo>
                    <a:pt x="132549" y="515035"/>
                  </a:lnTo>
                  <a:lnTo>
                    <a:pt x="132549" y="518083"/>
                  </a:lnTo>
                  <a:lnTo>
                    <a:pt x="134073" y="519607"/>
                  </a:lnTo>
                  <a:lnTo>
                    <a:pt x="134073" y="525691"/>
                  </a:lnTo>
                  <a:lnTo>
                    <a:pt x="135610" y="527227"/>
                  </a:lnTo>
                  <a:lnTo>
                    <a:pt x="135610" y="533323"/>
                  </a:lnTo>
                  <a:lnTo>
                    <a:pt x="137134" y="536359"/>
                  </a:lnTo>
                  <a:lnTo>
                    <a:pt x="137134" y="540943"/>
                  </a:lnTo>
                  <a:lnTo>
                    <a:pt x="138645" y="542467"/>
                  </a:lnTo>
                  <a:lnTo>
                    <a:pt x="138645" y="548551"/>
                  </a:lnTo>
                  <a:lnTo>
                    <a:pt x="140169" y="550075"/>
                  </a:lnTo>
                  <a:lnTo>
                    <a:pt x="140169" y="559219"/>
                  </a:lnTo>
                  <a:lnTo>
                    <a:pt x="141706" y="560743"/>
                  </a:lnTo>
                  <a:lnTo>
                    <a:pt x="141706" y="568363"/>
                  </a:lnTo>
                  <a:lnTo>
                    <a:pt x="143217" y="569887"/>
                  </a:lnTo>
                  <a:lnTo>
                    <a:pt x="143217" y="575983"/>
                  </a:lnTo>
                  <a:lnTo>
                    <a:pt x="144741" y="577507"/>
                  </a:lnTo>
                  <a:lnTo>
                    <a:pt x="144741" y="586651"/>
                  </a:lnTo>
                  <a:lnTo>
                    <a:pt x="146265" y="588175"/>
                  </a:lnTo>
                  <a:lnTo>
                    <a:pt x="146265" y="597319"/>
                  </a:lnTo>
                  <a:lnTo>
                    <a:pt x="147789" y="598843"/>
                  </a:lnTo>
                  <a:lnTo>
                    <a:pt x="147789" y="603415"/>
                  </a:lnTo>
                  <a:lnTo>
                    <a:pt x="149313" y="606463"/>
                  </a:lnTo>
                  <a:lnTo>
                    <a:pt x="149313" y="626262"/>
                  </a:lnTo>
                  <a:lnTo>
                    <a:pt x="150837" y="627786"/>
                  </a:lnTo>
                  <a:lnTo>
                    <a:pt x="150837" y="655231"/>
                  </a:lnTo>
                  <a:lnTo>
                    <a:pt x="152361" y="656742"/>
                  </a:lnTo>
                  <a:lnTo>
                    <a:pt x="152361" y="673506"/>
                  </a:lnTo>
                  <a:lnTo>
                    <a:pt x="153885" y="675030"/>
                  </a:lnTo>
                  <a:lnTo>
                    <a:pt x="153885" y="684174"/>
                  </a:lnTo>
                  <a:lnTo>
                    <a:pt x="155409" y="685698"/>
                  </a:lnTo>
                  <a:lnTo>
                    <a:pt x="155409" y="755789"/>
                  </a:lnTo>
                  <a:lnTo>
                    <a:pt x="156933" y="757313"/>
                  </a:lnTo>
                  <a:lnTo>
                    <a:pt x="156933" y="796937"/>
                  </a:lnTo>
                  <a:lnTo>
                    <a:pt x="158457" y="798449"/>
                  </a:lnTo>
                  <a:lnTo>
                    <a:pt x="158457" y="821309"/>
                  </a:lnTo>
                  <a:lnTo>
                    <a:pt x="159981" y="822833"/>
                  </a:lnTo>
                  <a:lnTo>
                    <a:pt x="159981" y="912736"/>
                  </a:lnTo>
                  <a:lnTo>
                    <a:pt x="161505" y="912736"/>
                  </a:lnTo>
                  <a:lnTo>
                    <a:pt x="163029" y="911212"/>
                  </a:lnTo>
                  <a:lnTo>
                    <a:pt x="163029" y="816737"/>
                  </a:lnTo>
                  <a:lnTo>
                    <a:pt x="164553" y="815213"/>
                  </a:lnTo>
                  <a:lnTo>
                    <a:pt x="164553" y="781697"/>
                  </a:lnTo>
                  <a:lnTo>
                    <a:pt x="166077" y="778637"/>
                  </a:lnTo>
                  <a:lnTo>
                    <a:pt x="166077" y="697890"/>
                  </a:lnTo>
                  <a:lnTo>
                    <a:pt x="167601" y="696366"/>
                  </a:lnTo>
                  <a:lnTo>
                    <a:pt x="167601" y="678065"/>
                  </a:lnTo>
                  <a:lnTo>
                    <a:pt x="169125" y="676554"/>
                  </a:lnTo>
                  <a:lnTo>
                    <a:pt x="169125" y="665886"/>
                  </a:lnTo>
                  <a:lnTo>
                    <a:pt x="170649" y="664362"/>
                  </a:lnTo>
                  <a:lnTo>
                    <a:pt x="170649" y="644563"/>
                  </a:lnTo>
                  <a:lnTo>
                    <a:pt x="172173" y="643039"/>
                  </a:lnTo>
                  <a:lnTo>
                    <a:pt x="172173" y="615607"/>
                  </a:lnTo>
                  <a:lnTo>
                    <a:pt x="173697" y="612546"/>
                  </a:lnTo>
                  <a:lnTo>
                    <a:pt x="173697" y="603415"/>
                  </a:lnTo>
                  <a:lnTo>
                    <a:pt x="175221" y="601878"/>
                  </a:lnTo>
                  <a:lnTo>
                    <a:pt x="175221" y="592747"/>
                  </a:lnTo>
                  <a:lnTo>
                    <a:pt x="176745" y="591223"/>
                  </a:lnTo>
                  <a:lnTo>
                    <a:pt x="176745" y="582079"/>
                  </a:lnTo>
                  <a:lnTo>
                    <a:pt x="178269" y="580555"/>
                  </a:lnTo>
                  <a:lnTo>
                    <a:pt x="178269" y="575983"/>
                  </a:lnTo>
                  <a:lnTo>
                    <a:pt x="179793" y="572935"/>
                  </a:lnTo>
                  <a:lnTo>
                    <a:pt x="179793" y="565327"/>
                  </a:lnTo>
                  <a:lnTo>
                    <a:pt x="181317" y="562267"/>
                  </a:lnTo>
                  <a:lnTo>
                    <a:pt x="181317" y="556183"/>
                  </a:lnTo>
                  <a:lnTo>
                    <a:pt x="182841" y="553135"/>
                  </a:lnTo>
                  <a:lnTo>
                    <a:pt x="182841" y="545515"/>
                  </a:lnTo>
                  <a:lnTo>
                    <a:pt x="184353" y="542467"/>
                  </a:lnTo>
                  <a:lnTo>
                    <a:pt x="184353" y="539407"/>
                  </a:lnTo>
                  <a:lnTo>
                    <a:pt x="185889" y="537883"/>
                  </a:lnTo>
                  <a:lnTo>
                    <a:pt x="185889" y="531799"/>
                  </a:lnTo>
                  <a:lnTo>
                    <a:pt x="187413" y="530275"/>
                  </a:lnTo>
                  <a:lnTo>
                    <a:pt x="187413" y="522655"/>
                  </a:lnTo>
                  <a:lnTo>
                    <a:pt x="188937" y="521131"/>
                  </a:lnTo>
                  <a:lnTo>
                    <a:pt x="188937" y="518083"/>
                  </a:lnTo>
                  <a:lnTo>
                    <a:pt x="190449" y="516559"/>
                  </a:lnTo>
                  <a:lnTo>
                    <a:pt x="190449" y="508939"/>
                  </a:lnTo>
                  <a:lnTo>
                    <a:pt x="191985" y="507415"/>
                  </a:lnTo>
                  <a:lnTo>
                    <a:pt x="191985" y="498271"/>
                  </a:lnTo>
                  <a:lnTo>
                    <a:pt x="193509" y="496747"/>
                  </a:lnTo>
                  <a:lnTo>
                    <a:pt x="193509" y="490651"/>
                  </a:lnTo>
                  <a:lnTo>
                    <a:pt x="195021" y="489140"/>
                  </a:lnTo>
                  <a:lnTo>
                    <a:pt x="195021" y="483031"/>
                  </a:lnTo>
                  <a:lnTo>
                    <a:pt x="196545" y="479983"/>
                  </a:lnTo>
                  <a:lnTo>
                    <a:pt x="196545" y="473887"/>
                  </a:lnTo>
                  <a:lnTo>
                    <a:pt x="198081" y="472363"/>
                  </a:lnTo>
                  <a:lnTo>
                    <a:pt x="198081" y="466280"/>
                  </a:lnTo>
                  <a:lnTo>
                    <a:pt x="199593" y="464756"/>
                  </a:lnTo>
                  <a:lnTo>
                    <a:pt x="199593" y="461695"/>
                  </a:lnTo>
                  <a:lnTo>
                    <a:pt x="201117" y="458647"/>
                  </a:lnTo>
                  <a:lnTo>
                    <a:pt x="201117" y="454088"/>
                  </a:lnTo>
                  <a:lnTo>
                    <a:pt x="202641" y="452564"/>
                  </a:lnTo>
                  <a:lnTo>
                    <a:pt x="202641" y="446468"/>
                  </a:lnTo>
                  <a:lnTo>
                    <a:pt x="204165" y="444944"/>
                  </a:lnTo>
                  <a:lnTo>
                    <a:pt x="204165" y="441896"/>
                  </a:lnTo>
                  <a:lnTo>
                    <a:pt x="205689" y="440372"/>
                  </a:lnTo>
                  <a:lnTo>
                    <a:pt x="205689" y="432752"/>
                  </a:lnTo>
                  <a:lnTo>
                    <a:pt x="207213" y="431228"/>
                  </a:lnTo>
                  <a:lnTo>
                    <a:pt x="207213" y="425119"/>
                  </a:lnTo>
                  <a:lnTo>
                    <a:pt x="208737" y="423608"/>
                  </a:lnTo>
                  <a:lnTo>
                    <a:pt x="208737" y="422084"/>
                  </a:lnTo>
                  <a:lnTo>
                    <a:pt x="210261" y="420560"/>
                  </a:lnTo>
                  <a:lnTo>
                    <a:pt x="210261" y="415988"/>
                  </a:lnTo>
                  <a:lnTo>
                    <a:pt x="211785" y="414464"/>
                  </a:lnTo>
                  <a:lnTo>
                    <a:pt x="211785" y="412940"/>
                  </a:lnTo>
                  <a:lnTo>
                    <a:pt x="213309" y="411416"/>
                  </a:lnTo>
                  <a:lnTo>
                    <a:pt x="213309" y="409892"/>
                  </a:lnTo>
                  <a:lnTo>
                    <a:pt x="214833" y="406844"/>
                  </a:lnTo>
                  <a:lnTo>
                    <a:pt x="214833" y="405320"/>
                  </a:lnTo>
                  <a:lnTo>
                    <a:pt x="217881" y="402285"/>
                  </a:lnTo>
                  <a:lnTo>
                    <a:pt x="217881" y="400761"/>
                  </a:lnTo>
                  <a:lnTo>
                    <a:pt x="219405" y="397700"/>
                  </a:lnTo>
                  <a:lnTo>
                    <a:pt x="220929" y="396176"/>
                  </a:lnTo>
                  <a:lnTo>
                    <a:pt x="220929" y="394652"/>
                  </a:lnTo>
                  <a:lnTo>
                    <a:pt x="222453" y="393128"/>
                  </a:lnTo>
                  <a:lnTo>
                    <a:pt x="222453" y="391617"/>
                  </a:lnTo>
                  <a:lnTo>
                    <a:pt x="223977" y="390093"/>
                  </a:lnTo>
                  <a:lnTo>
                    <a:pt x="225501" y="387032"/>
                  </a:lnTo>
                  <a:lnTo>
                    <a:pt x="227025" y="385508"/>
                  </a:lnTo>
                  <a:lnTo>
                    <a:pt x="227025" y="383984"/>
                  </a:lnTo>
                  <a:lnTo>
                    <a:pt x="231597" y="379425"/>
                  </a:lnTo>
                  <a:lnTo>
                    <a:pt x="231597" y="376377"/>
                  </a:lnTo>
                  <a:lnTo>
                    <a:pt x="233121" y="374840"/>
                  </a:lnTo>
                  <a:lnTo>
                    <a:pt x="233121" y="373316"/>
                  </a:lnTo>
                  <a:lnTo>
                    <a:pt x="236169" y="370268"/>
                  </a:lnTo>
                  <a:lnTo>
                    <a:pt x="237693" y="367233"/>
                  </a:lnTo>
                  <a:lnTo>
                    <a:pt x="237693" y="365709"/>
                  </a:lnTo>
                  <a:lnTo>
                    <a:pt x="240728" y="362661"/>
                  </a:lnTo>
                  <a:lnTo>
                    <a:pt x="240728" y="361124"/>
                  </a:lnTo>
                  <a:lnTo>
                    <a:pt x="242265" y="359600"/>
                  </a:lnTo>
                  <a:lnTo>
                    <a:pt x="243789" y="356565"/>
                  </a:lnTo>
                  <a:lnTo>
                    <a:pt x="243789" y="355041"/>
                  </a:lnTo>
                  <a:lnTo>
                    <a:pt x="248348" y="350469"/>
                  </a:lnTo>
                  <a:lnTo>
                    <a:pt x="248348" y="347421"/>
                  </a:lnTo>
                  <a:lnTo>
                    <a:pt x="255981" y="339801"/>
                  </a:lnTo>
                  <a:lnTo>
                    <a:pt x="255981" y="336753"/>
                  </a:lnTo>
                  <a:lnTo>
                    <a:pt x="263588" y="329133"/>
                  </a:lnTo>
                  <a:lnTo>
                    <a:pt x="263588" y="326097"/>
                  </a:lnTo>
                  <a:lnTo>
                    <a:pt x="271208" y="318465"/>
                  </a:lnTo>
                  <a:lnTo>
                    <a:pt x="272732" y="315417"/>
                  </a:lnTo>
                  <a:lnTo>
                    <a:pt x="272732" y="313905"/>
                  </a:lnTo>
                  <a:lnTo>
                    <a:pt x="277304" y="309321"/>
                  </a:lnTo>
                  <a:lnTo>
                    <a:pt x="277304" y="307797"/>
                  </a:lnTo>
                  <a:lnTo>
                    <a:pt x="278828" y="306273"/>
                  </a:lnTo>
                  <a:lnTo>
                    <a:pt x="280352" y="303237"/>
                  </a:lnTo>
                  <a:lnTo>
                    <a:pt x="281876" y="301713"/>
                  </a:lnTo>
                  <a:lnTo>
                    <a:pt x="281876" y="300189"/>
                  </a:lnTo>
                  <a:lnTo>
                    <a:pt x="283400" y="298653"/>
                  </a:lnTo>
                  <a:lnTo>
                    <a:pt x="283400" y="297129"/>
                  </a:lnTo>
                  <a:lnTo>
                    <a:pt x="284924" y="294081"/>
                  </a:lnTo>
                  <a:lnTo>
                    <a:pt x="286448" y="292569"/>
                  </a:lnTo>
                  <a:lnTo>
                    <a:pt x="286448" y="291045"/>
                  </a:lnTo>
                  <a:lnTo>
                    <a:pt x="289496" y="287997"/>
                  </a:lnTo>
                  <a:lnTo>
                    <a:pt x="289496" y="286461"/>
                  </a:lnTo>
                  <a:lnTo>
                    <a:pt x="291020" y="284937"/>
                  </a:lnTo>
                  <a:lnTo>
                    <a:pt x="292544" y="281901"/>
                  </a:lnTo>
                  <a:lnTo>
                    <a:pt x="292544" y="280377"/>
                  </a:lnTo>
                  <a:lnTo>
                    <a:pt x="294068" y="278853"/>
                  </a:lnTo>
                  <a:lnTo>
                    <a:pt x="294068" y="277329"/>
                  </a:lnTo>
                  <a:lnTo>
                    <a:pt x="297116" y="274281"/>
                  </a:lnTo>
                  <a:lnTo>
                    <a:pt x="298627" y="271221"/>
                  </a:lnTo>
                  <a:lnTo>
                    <a:pt x="298627" y="269709"/>
                  </a:lnTo>
                  <a:lnTo>
                    <a:pt x="303199" y="265137"/>
                  </a:lnTo>
                  <a:lnTo>
                    <a:pt x="303199" y="262089"/>
                  </a:lnTo>
                  <a:lnTo>
                    <a:pt x="309295" y="255993"/>
                  </a:lnTo>
                  <a:lnTo>
                    <a:pt x="309295" y="254469"/>
                  </a:lnTo>
                  <a:lnTo>
                    <a:pt x="310819" y="251421"/>
                  </a:lnTo>
                  <a:lnTo>
                    <a:pt x="313867" y="248373"/>
                  </a:lnTo>
                  <a:lnTo>
                    <a:pt x="313867" y="246849"/>
                  </a:lnTo>
                  <a:lnTo>
                    <a:pt x="316915" y="243801"/>
                  </a:lnTo>
                  <a:lnTo>
                    <a:pt x="316915" y="240753"/>
                  </a:lnTo>
                  <a:lnTo>
                    <a:pt x="318439" y="239229"/>
                  </a:lnTo>
                  <a:lnTo>
                    <a:pt x="318439" y="237718"/>
                  </a:lnTo>
                  <a:lnTo>
                    <a:pt x="319963" y="236194"/>
                  </a:lnTo>
                  <a:lnTo>
                    <a:pt x="319963" y="231609"/>
                  </a:lnTo>
                  <a:lnTo>
                    <a:pt x="321487" y="230085"/>
                  </a:lnTo>
                  <a:lnTo>
                    <a:pt x="321487" y="225526"/>
                  </a:lnTo>
                  <a:lnTo>
                    <a:pt x="323011" y="224002"/>
                  </a:lnTo>
                  <a:lnTo>
                    <a:pt x="323011" y="220941"/>
                  </a:lnTo>
                  <a:lnTo>
                    <a:pt x="321487" y="219417"/>
                  </a:lnTo>
                  <a:lnTo>
                    <a:pt x="321487" y="211810"/>
                  </a:lnTo>
                  <a:lnTo>
                    <a:pt x="319963" y="210273"/>
                  </a:lnTo>
                  <a:lnTo>
                    <a:pt x="319963" y="207225"/>
                  </a:lnTo>
                  <a:lnTo>
                    <a:pt x="318439" y="205701"/>
                  </a:lnTo>
                  <a:lnTo>
                    <a:pt x="318439" y="201142"/>
                  </a:lnTo>
                  <a:lnTo>
                    <a:pt x="316915" y="199618"/>
                  </a:lnTo>
                  <a:lnTo>
                    <a:pt x="316915" y="198094"/>
                  </a:lnTo>
                  <a:lnTo>
                    <a:pt x="315391" y="196557"/>
                  </a:lnTo>
                  <a:lnTo>
                    <a:pt x="315391" y="195033"/>
                  </a:lnTo>
                  <a:lnTo>
                    <a:pt x="313867" y="193522"/>
                  </a:lnTo>
                  <a:lnTo>
                    <a:pt x="313867" y="190474"/>
                  </a:lnTo>
                  <a:lnTo>
                    <a:pt x="309295" y="185902"/>
                  </a:lnTo>
                  <a:lnTo>
                    <a:pt x="309295" y="184365"/>
                  </a:lnTo>
                  <a:lnTo>
                    <a:pt x="307771" y="181330"/>
                  </a:lnTo>
                  <a:lnTo>
                    <a:pt x="301688" y="175234"/>
                  </a:lnTo>
                  <a:lnTo>
                    <a:pt x="301688" y="173710"/>
                  </a:lnTo>
                  <a:lnTo>
                    <a:pt x="286448" y="158470"/>
                  </a:lnTo>
                  <a:lnTo>
                    <a:pt x="283400" y="156946"/>
                  </a:lnTo>
                  <a:lnTo>
                    <a:pt x="280352" y="153898"/>
                  </a:lnTo>
                  <a:lnTo>
                    <a:pt x="277304" y="152374"/>
                  </a:lnTo>
                  <a:lnTo>
                    <a:pt x="271208" y="146278"/>
                  </a:lnTo>
                  <a:lnTo>
                    <a:pt x="262064" y="141706"/>
                  </a:lnTo>
                  <a:lnTo>
                    <a:pt x="260540" y="138671"/>
                  </a:lnTo>
                  <a:lnTo>
                    <a:pt x="257492" y="137147"/>
                  </a:lnTo>
                  <a:lnTo>
                    <a:pt x="255981" y="135623"/>
                  </a:lnTo>
                  <a:lnTo>
                    <a:pt x="246824" y="131038"/>
                  </a:lnTo>
                  <a:lnTo>
                    <a:pt x="245313" y="128003"/>
                  </a:lnTo>
                  <a:lnTo>
                    <a:pt x="242265" y="126479"/>
                  </a:lnTo>
                  <a:lnTo>
                    <a:pt x="240728" y="124955"/>
                  </a:lnTo>
                  <a:lnTo>
                    <a:pt x="234645" y="121894"/>
                  </a:lnTo>
                  <a:lnTo>
                    <a:pt x="228549" y="115811"/>
                  </a:lnTo>
                  <a:lnTo>
                    <a:pt x="225501" y="114287"/>
                  </a:lnTo>
                  <a:lnTo>
                    <a:pt x="223977" y="112763"/>
                  </a:lnTo>
                  <a:lnTo>
                    <a:pt x="220929" y="111239"/>
                  </a:lnTo>
                  <a:lnTo>
                    <a:pt x="219405" y="109715"/>
                  </a:lnTo>
                  <a:lnTo>
                    <a:pt x="217881" y="106667"/>
                  </a:lnTo>
                  <a:lnTo>
                    <a:pt x="214833" y="105143"/>
                  </a:lnTo>
                  <a:lnTo>
                    <a:pt x="210261" y="100571"/>
                  </a:lnTo>
                  <a:lnTo>
                    <a:pt x="207213" y="99047"/>
                  </a:lnTo>
                  <a:lnTo>
                    <a:pt x="205689" y="95986"/>
                  </a:lnTo>
                  <a:lnTo>
                    <a:pt x="198081" y="88379"/>
                  </a:lnTo>
                  <a:lnTo>
                    <a:pt x="196545" y="85331"/>
                  </a:lnTo>
                  <a:lnTo>
                    <a:pt x="191985" y="80759"/>
                  </a:lnTo>
                  <a:lnTo>
                    <a:pt x="191985" y="79235"/>
                  </a:lnTo>
                  <a:lnTo>
                    <a:pt x="190449" y="76187"/>
                  </a:lnTo>
                  <a:lnTo>
                    <a:pt x="185889" y="71628"/>
                  </a:lnTo>
                  <a:lnTo>
                    <a:pt x="185889" y="70091"/>
                  </a:lnTo>
                  <a:lnTo>
                    <a:pt x="182841" y="68567"/>
                  </a:lnTo>
                  <a:lnTo>
                    <a:pt x="182841" y="65519"/>
                  </a:lnTo>
                  <a:lnTo>
                    <a:pt x="181317" y="63995"/>
                  </a:lnTo>
                  <a:lnTo>
                    <a:pt x="181317" y="62484"/>
                  </a:lnTo>
                  <a:lnTo>
                    <a:pt x="176745" y="57899"/>
                  </a:lnTo>
                  <a:lnTo>
                    <a:pt x="176745" y="54851"/>
                  </a:lnTo>
                  <a:lnTo>
                    <a:pt x="175221" y="53327"/>
                  </a:lnTo>
                  <a:lnTo>
                    <a:pt x="175221" y="51803"/>
                  </a:lnTo>
                  <a:lnTo>
                    <a:pt x="173697" y="50292"/>
                  </a:lnTo>
                  <a:lnTo>
                    <a:pt x="173697" y="48768"/>
                  </a:lnTo>
                  <a:lnTo>
                    <a:pt x="172173" y="45707"/>
                  </a:lnTo>
                  <a:lnTo>
                    <a:pt x="172173" y="44183"/>
                  </a:lnTo>
                  <a:lnTo>
                    <a:pt x="170649" y="42659"/>
                  </a:lnTo>
                  <a:lnTo>
                    <a:pt x="170649" y="39624"/>
                  </a:lnTo>
                  <a:lnTo>
                    <a:pt x="169125" y="38100"/>
                  </a:lnTo>
                  <a:lnTo>
                    <a:pt x="167601" y="35052"/>
                  </a:lnTo>
                  <a:lnTo>
                    <a:pt x="167601" y="30467"/>
                  </a:lnTo>
                  <a:lnTo>
                    <a:pt x="166077" y="28956"/>
                  </a:lnTo>
                  <a:lnTo>
                    <a:pt x="166077" y="22860"/>
                  </a:lnTo>
                  <a:lnTo>
                    <a:pt x="164553" y="21336"/>
                  </a:lnTo>
                  <a:lnTo>
                    <a:pt x="164553" y="10668"/>
                  </a:lnTo>
                  <a:lnTo>
                    <a:pt x="163029" y="9144"/>
                  </a:lnTo>
                  <a:lnTo>
                    <a:pt x="163029" y="0"/>
                  </a:lnTo>
                  <a:close/>
                </a:path>
              </a:pathLst>
            </a:custGeom>
            <a:solidFill>
              <a:srgbClr val="00BEC4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2597436" y="5944222"/>
              <a:ext cx="323215" cy="913130"/>
            </a:xfrm>
            <a:custGeom>
              <a:avLst/>
              <a:gdLst/>
              <a:ahLst/>
              <a:cxnLst/>
              <a:rect l="l" t="t" r="r" b="b"/>
              <a:pathLst>
                <a:path w="323214" h="913129">
                  <a:moveTo>
                    <a:pt x="159981" y="912736"/>
                  </a:moveTo>
                  <a:lnTo>
                    <a:pt x="159981" y="911212"/>
                  </a:lnTo>
                  <a:lnTo>
                    <a:pt x="159981" y="822833"/>
                  </a:lnTo>
                  <a:lnTo>
                    <a:pt x="158457" y="821309"/>
                  </a:lnTo>
                  <a:lnTo>
                    <a:pt x="158457" y="798449"/>
                  </a:lnTo>
                  <a:lnTo>
                    <a:pt x="156933" y="796937"/>
                  </a:lnTo>
                  <a:lnTo>
                    <a:pt x="156933" y="757313"/>
                  </a:lnTo>
                  <a:lnTo>
                    <a:pt x="155409" y="755789"/>
                  </a:lnTo>
                  <a:lnTo>
                    <a:pt x="155409" y="685698"/>
                  </a:lnTo>
                  <a:lnTo>
                    <a:pt x="153885" y="684174"/>
                  </a:lnTo>
                  <a:lnTo>
                    <a:pt x="153885" y="675030"/>
                  </a:lnTo>
                  <a:lnTo>
                    <a:pt x="152361" y="673506"/>
                  </a:lnTo>
                  <a:lnTo>
                    <a:pt x="152361" y="656742"/>
                  </a:lnTo>
                  <a:lnTo>
                    <a:pt x="150837" y="655231"/>
                  </a:lnTo>
                  <a:lnTo>
                    <a:pt x="150837" y="627786"/>
                  </a:lnTo>
                  <a:lnTo>
                    <a:pt x="149313" y="626262"/>
                  </a:lnTo>
                  <a:lnTo>
                    <a:pt x="149313" y="606463"/>
                  </a:lnTo>
                  <a:lnTo>
                    <a:pt x="147789" y="603415"/>
                  </a:lnTo>
                  <a:lnTo>
                    <a:pt x="147789" y="601878"/>
                  </a:lnTo>
                  <a:lnTo>
                    <a:pt x="147789" y="600354"/>
                  </a:lnTo>
                  <a:lnTo>
                    <a:pt x="147789" y="598843"/>
                  </a:lnTo>
                  <a:lnTo>
                    <a:pt x="146265" y="597319"/>
                  </a:lnTo>
                  <a:lnTo>
                    <a:pt x="146265" y="588175"/>
                  </a:lnTo>
                  <a:lnTo>
                    <a:pt x="144741" y="586651"/>
                  </a:lnTo>
                  <a:lnTo>
                    <a:pt x="144741" y="577507"/>
                  </a:lnTo>
                  <a:lnTo>
                    <a:pt x="143217" y="575983"/>
                  </a:lnTo>
                  <a:lnTo>
                    <a:pt x="143217" y="572935"/>
                  </a:lnTo>
                  <a:lnTo>
                    <a:pt x="143217" y="571411"/>
                  </a:lnTo>
                  <a:lnTo>
                    <a:pt x="143217" y="569887"/>
                  </a:lnTo>
                  <a:lnTo>
                    <a:pt x="141706" y="568363"/>
                  </a:lnTo>
                  <a:lnTo>
                    <a:pt x="141706" y="566851"/>
                  </a:lnTo>
                  <a:lnTo>
                    <a:pt x="141706" y="565327"/>
                  </a:lnTo>
                  <a:lnTo>
                    <a:pt x="141706" y="562267"/>
                  </a:lnTo>
                  <a:lnTo>
                    <a:pt x="141706" y="560743"/>
                  </a:lnTo>
                  <a:lnTo>
                    <a:pt x="140169" y="559219"/>
                  </a:lnTo>
                  <a:lnTo>
                    <a:pt x="140169" y="550075"/>
                  </a:lnTo>
                  <a:lnTo>
                    <a:pt x="138645" y="548551"/>
                  </a:lnTo>
                  <a:lnTo>
                    <a:pt x="138645" y="547027"/>
                  </a:lnTo>
                  <a:lnTo>
                    <a:pt x="138645" y="545515"/>
                  </a:lnTo>
                  <a:lnTo>
                    <a:pt x="138645" y="542467"/>
                  </a:lnTo>
                  <a:lnTo>
                    <a:pt x="137134" y="540943"/>
                  </a:lnTo>
                  <a:lnTo>
                    <a:pt x="137134" y="539407"/>
                  </a:lnTo>
                  <a:lnTo>
                    <a:pt x="137134" y="537883"/>
                  </a:lnTo>
                  <a:lnTo>
                    <a:pt x="137134" y="536359"/>
                  </a:lnTo>
                  <a:lnTo>
                    <a:pt x="135610" y="533323"/>
                  </a:lnTo>
                  <a:lnTo>
                    <a:pt x="135610" y="531799"/>
                  </a:lnTo>
                  <a:lnTo>
                    <a:pt x="135610" y="530275"/>
                  </a:lnTo>
                  <a:lnTo>
                    <a:pt x="135610" y="528751"/>
                  </a:lnTo>
                  <a:lnTo>
                    <a:pt x="135610" y="527227"/>
                  </a:lnTo>
                  <a:lnTo>
                    <a:pt x="134073" y="525691"/>
                  </a:lnTo>
                  <a:lnTo>
                    <a:pt x="134073" y="522655"/>
                  </a:lnTo>
                  <a:lnTo>
                    <a:pt x="134073" y="521131"/>
                  </a:lnTo>
                  <a:lnTo>
                    <a:pt x="134073" y="519607"/>
                  </a:lnTo>
                  <a:lnTo>
                    <a:pt x="132549" y="518083"/>
                  </a:lnTo>
                  <a:lnTo>
                    <a:pt x="132549" y="516559"/>
                  </a:lnTo>
                  <a:lnTo>
                    <a:pt x="132549" y="515035"/>
                  </a:lnTo>
                  <a:lnTo>
                    <a:pt x="131038" y="511987"/>
                  </a:lnTo>
                  <a:lnTo>
                    <a:pt x="131038" y="502843"/>
                  </a:lnTo>
                  <a:lnTo>
                    <a:pt x="129514" y="501319"/>
                  </a:lnTo>
                  <a:lnTo>
                    <a:pt x="129514" y="493699"/>
                  </a:lnTo>
                  <a:lnTo>
                    <a:pt x="127977" y="490651"/>
                  </a:lnTo>
                  <a:lnTo>
                    <a:pt x="127977" y="489140"/>
                  </a:lnTo>
                  <a:lnTo>
                    <a:pt x="127977" y="487603"/>
                  </a:lnTo>
                  <a:lnTo>
                    <a:pt x="127977" y="486079"/>
                  </a:lnTo>
                  <a:lnTo>
                    <a:pt x="126466" y="484555"/>
                  </a:lnTo>
                  <a:lnTo>
                    <a:pt x="126466" y="483031"/>
                  </a:lnTo>
                  <a:lnTo>
                    <a:pt x="126466" y="479983"/>
                  </a:lnTo>
                  <a:lnTo>
                    <a:pt x="126466" y="478472"/>
                  </a:lnTo>
                  <a:lnTo>
                    <a:pt x="126466" y="476948"/>
                  </a:lnTo>
                  <a:lnTo>
                    <a:pt x="124942" y="475411"/>
                  </a:lnTo>
                  <a:lnTo>
                    <a:pt x="124942" y="473887"/>
                  </a:lnTo>
                  <a:lnTo>
                    <a:pt x="124942" y="472363"/>
                  </a:lnTo>
                  <a:lnTo>
                    <a:pt x="124942" y="469315"/>
                  </a:lnTo>
                  <a:lnTo>
                    <a:pt x="123418" y="467804"/>
                  </a:lnTo>
                  <a:lnTo>
                    <a:pt x="123418" y="466280"/>
                  </a:lnTo>
                  <a:lnTo>
                    <a:pt x="123418" y="464756"/>
                  </a:lnTo>
                  <a:lnTo>
                    <a:pt x="121881" y="463219"/>
                  </a:lnTo>
                  <a:lnTo>
                    <a:pt x="121881" y="461695"/>
                  </a:lnTo>
                  <a:lnTo>
                    <a:pt x="121881" y="458647"/>
                  </a:lnTo>
                  <a:lnTo>
                    <a:pt x="121881" y="457136"/>
                  </a:lnTo>
                  <a:lnTo>
                    <a:pt x="120370" y="455612"/>
                  </a:lnTo>
                  <a:lnTo>
                    <a:pt x="120370" y="454088"/>
                  </a:lnTo>
                  <a:lnTo>
                    <a:pt x="120370" y="452564"/>
                  </a:lnTo>
                  <a:lnTo>
                    <a:pt x="120370" y="451040"/>
                  </a:lnTo>
                  <a:lnTo>
                    <a:pt x="118846" y="447979"/>
                  </a:lnTo>
                  <a:lnTo>
                    <a:pt x="118846" y="446468"/>
                  </a:lnTo>
                  <a:lnTo>
                    <a:pt x="118846" y="444944"/>
                  </a:lnTo>
                  <a:lnTo>
                    <a:pt x="118846" y="443420"/>
                  </a:lnTo>
                  <a:lnTo>
                    <a:pt x="118846" y="441896"/>
                  </a:lnTo>
                  <a:lnTo>
                    <a:pt x="117322" y="440372"/>
                  </a:lnTo>
                  <a:lnTo>
                    <a:pt x="117322" y="437311"/>
                  </a:lnTo>
                  <a:lnTo>
                    <a:pt x="117322" y="435800"/>
                  </a:lnTo>
                  <a:lnTo>
                    <a:pt x="115798" y="434276"/>
                  </a:lnTo>
                  <a:lnTo>
                    <a:pt x="115798" y="432752"/>
                  </a:lnTo>
                  <a:lnTo>
                    <a:pt x="115798" y="431228"/>
                  </a:lnTo>
                  <a:lnTo>
                    <a:pt x="115798" y="429704"/>
                  </a:lnTo>
                  <a:lnTo>
                    <a:pt x="114274" y="426656"/>
                  </a:lnTo>
                  <a:lnTo>
                    <a:pt x="114274" y="425119"/>
                  </a:lnTo>
                  <a:lnTo>
                    <a:pt x="114274" y="423608"/>
                  </a:lnTo>
                  <a:lnTo>
                    <a:pt x="112750" y="422084"/>
                  </a:lnTo>
                  <a:lnTo>
                    <a:pt x="112750" y="420560"/>
                  </a:lnTo>
                  <a:lnTo>
                    <a:pt x="111226" y="417512"/>
                  </a:lnTo>
                  <a:lnTo>
                    <a:pt x="111226" y="415988"/>
                  </a:lnTo>
                  <a:lnTo>
                    <a:pt x="111226" y="414464"/>
                  </a:lnTo>
                  <a:lnTo>
                    <a:pt x="109702" y="412940"/>
                  </a:lnTo>
                  <a:lnTo>
                    <a:pt x="109702" y="411416"/>
                  </a:lnTo>
                  <a:lnTo>
                    <a:pt x="108178" y="409892"/>
                  </a:lnTo>
                  <a:lnTo>
                    <a:pt x="108178" y="406844"/>
                  </a:lnTo>
                  <a:lnTo>
                    <a:pt x="106654" y="405320"/>
                  </a:lnTo>
                  <a:lnTo>
                    <a:pt x="106654" y="403796"/>
                  </a:lnTo>
                  <a:lnTo>
                    <a:pt x="105130" y="402285"/>
                  </a:lnTo>
                  <a:lnTo>
                    <a:pt x="103606" y="400761"/>
                  </a:lnTo>
                  <a:lnTo>
                    <a:pt x="103606" y="397700"/>
                  </a:lnTo>
                  <a:lnTo>
                    <a:pt x="102082" y="396176"/>
                  </a:lnTo>
                  <a:lnTo>
                    <a:pt x="100558" y="394652"/>
                  </a:lnTo>
                  <a:lnTo>
                    <a:pt x="100558" y="393128"/>
                  </a:lnTo>
                  <a:lnTo>
                    <a:pt x="99034" y="391617"/>
                  </a:lnTo>
                  <a:lnTo>
                    <a:pt x="97510" y="390093"/>
                  </a:lnTo>
                  <a:lnTo>
                    <a:pt x="97510" y="387032"/>
                  </a:lnTo>
                  <a:lnTo>
                    <a:pt x="95986" y="385508"/>
                  </a:lnTo>
                  <a:lnTo>
                    <a:pt x="94462" y="383984"/>
                  </a:lnTo>
                  <a:lnTo>
                    <a:pt x="94462" y="382460"/>
                  </a:lnTo>
                  <a:lnTo>
                    <a:pt x="92938" y="380936"/>
                  </a:lnTo>
                  <a:lnTo>
                    <a:pt x="91414" y="379425"/>
                  </a:lnTo>
                  <a:lnTo>
                    <a:pt x="89890" y="376377"/>
                  </a:lnTo>
                  <a:lnTo>
                    <a:pt x="89890" y="374840"/>
                  </a:lnTo>
                  <a:lnTo>
                    <a:pt x="88366" y="373316"/>
                  </a:lnTo>
                  <a:lnTo>
                    <a:pt x="86842" y="371792"/>
                  </a:lnTo>
                  <a:lnTo>
                    <a:pt x="86842" y="370268"/>
                  </a:lnTo>
                  <a:lnTo>
                    <a:pt x="85331" y="367233"/>
                  </a:lnTo>
                  <a:lnTo>
                    <a:pt x="83794" y="365709"/>
                  </a:lnTo>
                  <a:lnTo>
                    <a:pt x="83794" y="364185"/>
                  </a:lnTo>
                  <a:lnTo>
                    <a:pt x="82270" y="362661"/>
                  </a:lnTo>
                  <a:lnTo>
                    <a:pt x="80746" y="361124"/>
                  </a:lnTo>
                  <a:lnTo>
                    <a:pt x="79235" y="359600"/>
                  </a:lnTo>
                  <a:lnTo>
                    <a:pt x="79235" y="356565"/>
                  </a:lnTo>
                  <a:lnTo>
                    <a:pt x="77698" y="355041"/>
                  </a:lnTo>
                  <a:lnTo>
                    <a:pt x="76174" y="353517"/>
                  </a:lnTo>
                  <a:lnTo>
                    <a:pt x="74663" y="351993"/>
                  </a:lnTo>
                  <a:lnTo>
                    <a:pt x="74663" y="350469"/>
                  </a:lnTo>
                  <a:lnTo>
                    <a:pt x="73139" y="347421"/>
                  </a:lnTo>
                  <a:lnTo>
                    <a:pt x="71615" y="345897"/>
                  </a:lnTo>
                  <a:lnTo>
                    <a:pt x="70078" y="344373"/>
                  </a:lnTo>
                  <a:lnTo>
                    <a:pt x="70078" y="342849"/>
                  </a:lnTo>
                  <a:lnTo>
                    <a:pt x="68567" y="341325"/>
                  </a:lnTo>
                  <a:lnTo>
                    <a:pt x="67043" y="339801"/>
                  </a:lnTo>
                  <a:lnTo>
                    <a:pt x="65519" y="336753"/>
                  </a:lnTo>
                  <a:lnTo>
                    <a:pt x="63995" y="335229"/>
                  </a:lnTo>
                  <a:lnTo>
                    <a:pt x="63995" y="333705"/>
                  </a:lnTo>
                  <a:lnTo>
                    <a:pt x="60947" y="332181"/>
                  </a:lnTo>
                  <a:lnTo>
                    <a:pt x="60947" y="330657"/>
                  </a:lnTo>
                  <a:lnTo>
                    <a:pt x="59423" y="329133"/>
                  </a:lnTo>
                  <a:lnTo>
                    <a:pt x="57899" y="326097"/>
                  </a:lnTo>
                  <a:lnTo>
                    <a:pt x="56375" y="324561"/>
                  </a:lnTo>
                  <a:lnTo>
                    <a:pt x="54851" y="323037"/>
                  </a:lnTo>
                  <a:lnTo>
                    <a:pt x="53327" y="321513"/>
                  </a:lnTo>
                  <a:lnTo>
                    <a:pt x="53327" y="319989"/>
                  </a:lnTo>
                  <a:lnTo>
                    <a:pt x="51803" y="318465"/>
                  </a:lnTo>
                  <a:lnTo>
                    <a:pt x="50279" y="315417"/>
                  </a:lnTo>
                  <a:lnTo>
                    <a:pt x="48755" y="313905"/>
                  </a:lnTo>
                  <a:lnTo>
                    <a:pt x="47231" y="312381"/>
                  </a:lnTo>
                  <a:lnTo>
                    <a:pt x="45707" y="310845"/>
                  </a:lnTo>
                  <a:lnTo>
                    <a:pt x="45707" y="309321"/>
                  </a:lnTo>
                  <a:lnTo>
                    <a:pt x="44183" y="307797"/>
                  </a:lnTo>
                  <a:lnTo>
                    <a:pt x="42659" y="306273"/>
                  </a:lnTo>
                  <a:lnTo>
                    <a:pt x="42659" y="303237"/>
                  </a:lnTo>
                  <a:lnTo>
                    <a:pt x="41135" y="301713"/>
                  </a:lnTo>
                  <a:lnTo>
                    <a:pt x="39611" y="300189"/>
                  </a:lnTo>
                  <a:lnTo>
                    <a:pt x="39611" y="298653"/>
                  </a:lnTo>
                  <a:lnTo>
                    <a:pt x="38087" y="297129"/>
                  </a:lnTo>
                  <a:lnTo>
                    <a:pt x="36563" y="294081"/>
                  </a:lnTo>
                  <a:lnTo>
                    <a:pt x="36563" y="292569"/>
                  </a:lnTo>
                  <a:lnTo>
                    <a:pt x="35039" y="291045"/>
                  </a:lnTo>
                  <a:lnTo>
                    <a:pt x="35039" y="289521"/>
                  </a:lnTo>
                  <a:lnTo>
                    <a:pt x="33515" y="287997"/>
                  </a:lnTo>
                  <a:lnTo>
                    <a:pt x="31991" y="286461"/>
                  </a:lnTo>
                  <a:lnTo>
                    <a:pt x="31991" y="284937"/>
                  </a:lnTo>
                  <a:lnTo>
                    <a:pt x="30467" y="281901"/>
                  </a:lnTo>
                  <a:lnTo>
                    <a:pt x="28943" y="280377"/>
                  </a:lnTo>
                  <a:lnTo>
                    <a:pt x="28943" y="278853"/>
                  </a:lnTo>
                  <a:lnTo>
                    <a:pt x="27419" y="277329"/>
                  </a:lnTo>
                  <a:lnTo>
                    <a:pt x="27419" y="275805"/>
                  </a:lnTo>
                  <a:lnTo>
                    <a:pt x="25895" y="274281"/>
                  </a:lnTo>
                  <a:lnTo>
                    <a:pt x="24371" y="271221"/>
                  </a:lnTo>
                  <a:lnTo>
                    <a:pt x="22860" y="269709"/>
                  </a:lnTo>
                  <a:lnTo>
                    <a:pt x="22860" y="268185"/>
                  </a:lnTo>
                  <a:lnTo>
                    <a:pt x="21336" y="266661"/>
                  </a:lnTo>
                  <a:lnTo>
                    <a:pt x="19799" y="265137"/>
                  </a:lnTo>
                  <a:lnTo>
                    <a:pt x="18275" y="262089"/>
                  </a:lnTo>
                  <a:lnTo>
                    <a:pt x="18275" y="260553"/>
                  </a:lnTo>
                  <a:lnTo>
                    <a:pt x="15240" y="259041"/>
                  </a:lnTo>
                  <a:lnTo>
                    <a:pt x="15240" y="257517"/>
                  </a:lnTo>
                  <a:lnTo>
                    <a:pt x="13703" y="255993"/>
                  </a:lnTo>
                  <a:lnTo>
                    <a:pt x="12192" y="254469"/>
                  </a:lnTo>
                  <a:lnTo>
                    <a:pt x="12192" y="251421"/>
                  </a:lnTo>
                  <a:lnTo>
                    <a:pt x="10668" y="249897"/>
                  </a:lnTo>
                  <a:lnTo>
                    <a:pt x="9144" y="248373"/>
                  </a:lnTo>
                  <a:lnTo>
                    <a:pt x="7620" y="246849"/>
                  </a:lnTo>
                  <a:lnTo>
                    <a:pt x="7620" y="245325"/>
                  </a:lnTo>
                  <a:lnTo>
                    <a:pt x="6096" y="243801"/>
                  </a:lnTo>
                  <a:lnTo>
                    <a:pt x="4572" y="240753"/>
                  </a:lnTo>
                  <a:lnTo>
                    <a:pt x="4572" y="239229"/>
                  </a:lnTo>
                  <a:lnTo>
                    <a:pt x="3048" y="237718"/>
                  </a:lnTo>
                  <a:lnTo>
                    <a:pt x="3048" y="236194"/>
                  </a:lnTo>
                  <a:lnTo>
                    <a:pt x="1524" y="234657"/>
                  </a:lnTo>
                  <a:lnTo>
                    <a:pt x="1524" y="231609"/>
                  </a:lnTo>
                  <a:lnTo>
                    <a:pt x="1524" y="230085"/>
                  </a:lnTo>
                  <a:lnTo>
                    <a:pt x="0" y="228561"/>
                  </a:lnTo>
                  <a:lnTo>
                    <a:pt x="0" y="227050"/>
                  </a:lnTo>
                  <a:lnTo>
                    <a:pt x="0" y="214858"/>
                  </a:lnTo>
                  <a:lnTo>
                    <a:pt x="1524" y="211810"/>
                  </a:lnTo>
                  <a:lnTo>
                    <a:pt x="1524" y="210273"/>
                  </a:lnTo>
                  <a:lnTo>
                    <a:pt x="1524" y="208749"/>
                  </a:lnTo>
                  <a:lnTo>
                    <a:pt x="3048" y="207225"/>
                  </a:lnTo>
                  <a:lnTo>
                    <a:pt x="3048" y="205701"/>
                  </a:lnTo>
                  <a:lnTo>
                    <a:pt x="3048" y="204190"/>
                  </a:lnTo>
                  <a:lnTo>
                    <a:pt x="4572" y="201142"/>
                  </a:lnTo>
                  <a:lnTo>
                    <a:pt x="4572" y="199618"/>
                  </a:lnTo>
                  <a:lnTo>
                    <a:pt x="6096" y="198094"/>
                  </a:lnTo>
                  <a:lnTo>
                    <a:pt x="6096" y="196557"/>
                  </a:lnTo>
                  <a:lnTo>
                    <a:pt x="7620" y="195033"/>
                  </a:lnTo>
                  <a:lnTo>
                    <a:pt x="7620" y="193522"/>
                  </a:lnTo>
                  <a:lnTo>
                    <a:pt x="9144" y="190474"/>
                  </a:lnTo>
                  <a:lnTo>
                    <a:pt x="10668" y="188950"/>
                  </a:lnTo>
                  <a:lnTo>
                    <a:pt x="12192" y="187426"/>
                  </a:lnTo>
                  <a:lnTo>
                    <a:pt x="12192" y="185902"/>
                  </a:lnTo>
                  <a:lnTo>
                    <a:pt x="13703" y="184365"/>
                  </a:lnTo>
                  <a:lnTo>
                    <a:pt x="15240" y="181330"/>
                  </a:lnTo>
                  <a:lnTo>
                    <a:pt x="15240" y="179806"/>
                  </a:lnTo>
                  <a:lnTo>
                    <a:pt x="16764" y="178282"/>
                  </a:lnTo>
                  <a:lnTo>
                    <a:pt x="18275" y="176758"/>
                  </a:lnTo>
                  <a:lnTo>
                    <a:pt x="19799" y="175234"/>
                  </a:lnTo>
                  <a:lnTo>
                    <a:pt x="21336" y="173710"/>
                  </a:lnTo>
                  <a:lnTo>
                    <a:pt x="22860" y="170662"/>
                  </a:lnTo>
                  <a:lnTo>
                    <a:pt x="24371" y="169138"/>
                  </a:lnTo>
                  <a:lnTo>
                    <a:pt x="25895" y="167614"/>
                  </a:lnTo>
                  <a:lnTo>
                    <a:pt x="28943" y="166090"/>
                  </a:lnTo>
                  <a:lnTo>
                    <a:pt x="30467" y="164566"/>
                  </a:lnTo>
                  <a:lnTo>
                    <a:pt x="31991" y="161518"/>
                  </a:lnTo>
                  <a:lnTo>
                    <a:pt x="33515" y="159994"/>
                  </a:lnTo>
                  <a:lnTo>
                    <a:pt x="35039" y="158470"/>
                  </a:lnTo>
                  <a:lnTo>
                    <a:pt x="38087" y="156946"/>
                  </a:lnTo>
                  <a:lnTo>
                    <a:pt x="39611" y="155422"/>
                  </a:lnTo>
                  <a:lnTo>
                    <a:pt x="42659" y="153898"/>
                  </a:lnTo>
                  <a:lnTo>
                    <a:pt x="44183" y="152374"/>
                  </a:lnTo>
                  <a:lnTo>
                    <a:pt x="47231" y="149339"/>
                  </a:lnTo>
                  <a:lnTo>
                    <a:pt x="48755" y="147815"/>
                  </a:lnTo>
                  <a:lnTo>
                    <a:pt x="51803" y="146278"/>
                  </a:lnTo>
                  <a:lnTo>
                    <a:pt x="54851" y="144754"/>
                  </a:lnTo>
                  <a:lnTo>
                    <a:pt x="57899" y="143230"/>
                  </a:lnTo>
                  <a:lnTo>
                    <a:pt x="59423" y="141706"/>
                  </a:lnTo>
                  <a:lnTo>
                    <a:pt x="62471" y="138671"/>
                  </a:lnTo>
                  <a:lnTo>
                    <a:pt x="63995" y="137147"/>
                  </a:lnTo>
                  <a:lnTo>
                    <a:pt x="67043" y="135623"/>
                  </a:lnTo>
                  <a:lnTo>
                    <a:pt x="70078" y="134086"/>
                  </a:lnTo>
                  <a:lnTo>
                    <a:pt x="73139" y="132562"/>
                  </a:lnTo>
                  <a:lnTo>
                    <a:pt x="85331" y="123431"/>
                  </a:lnTo>
                  <a:lnTo>
                    <a:pt x="86842" y="121894"/>
                  </a:lnTo>
                  <a:lnTo>
                    <a:pt x="89890" y="120370"/>
                  </a:lnTo>
                  <a:lnTo>
                    <a:pt x="91414" y="117335"/>
                  </a:lnTo>
                  <a:lnTo>
                    <a:pt x="94462" y="115811"/>
                  </a:lnTo>
                  <a:lnTo>
                    <a:pt x="95986" y="114287"/>
                  </a:lnTo>
                  <a:lnTo>
                    <a:pt x="99034" y="112763"/>
                  </a:lnTo>
                  <a:lnTo>
                    <a:pt x="100558" y="111239"/>
                  </a:lnTo>
                  <a:lnTo>
                    <a:pt x="103606" y="109715"/>
                  </a:lnTo>
                  <a:lnTo>
                    <a:pt x="105130" y="106667"/>
                  </a:lnTo>
                  <a:lnTo>
                    <a:pt x="106654" y="105143"/>
                  </a:lnTo>
                  <a:lnTo>
                    <a:pt x="109702" y="103619"/>
                  </a:lnTo>
                  <a:lnTo>
                    <a:pt x="111226" y="102095"/>
                  </a:lnTo>
                  <a:lnTo>
                    <a:pt x="112750" y="100571"/>
                  </a:lnTo>
                  <a:lnTo>
                    <a:pt x="114274" y="99047"/>
                  </a:lnTo>
                  <a:lnTo>
                    <a:pt x="115798" y="95986"/>
                  </a:lnTo>
                  <a:lnTo>
                    <a:pt x="117322" y="94475"/>
                  </a:lnTo>
                  <a:lnTo>
                    <a:pt x="118846" y="92951"/>
                  </a:lnTo>
                  <a:lnTo>
                    <a:pt x="120370" y="91427"/>
                  </a:lnTo>
                  <a:lnTo>
                    <a:pt x="121881" y="89903"/>
                  </a:lnTo>
                  <a:lnTo>
                    <a:pt x="123418" y="88379"/>
                  </a:lnTo>
                  <a:lnTo>
                    <a:pt x="124942" y="85331"/>
                  </a:lnTo>
                  <a:lnTo>
                    <a:pt x="126466" y="83807"/>
                  </a:lnTo>
                  <a:lnTo>
                    <a:pt x="127977" y="82283"/>
                  </a:lnTo>
                  <a:lnTo>
                    <a:pt x="129514" y="80759"/>
                  </a:lnTo>
                  <a:lnTo>
                    <a:pt x="131038" y="79235"/>
                  </a:lnTo>
                  <a:lnTo>
                    <a:pt x="132549" y="76187"/>
                  </a:lnTo>
                  <a:lnTo>
                    <a:pt x="134073" y="74663"/>
                  </a:lnTo>
                  <a:lnTo>
                    <a:pt x="135610" y="73152"/>
                  </a:lnTo>
                  <a:lnTo>
                    <a:pt x="135610" y="71628"/>
                  </a:lnTo>
                  <a:lnTo>
                    <a:pt x="137134" y="70091"/>
                  </a:lnTo>
                  <a:lnTo>
                    <a:pt x="138645" y="68567"/>
                  </a:lnTo>
                  <a:lnTo>
                    <a:pt x="140169" y="65519"/>
                  </a:lnTo>
                  <a:lnTo>
                    <a:pt x="140169" y="63995"/>
                  </a:lnTo>
                  <a:lnTo>
                    <a:pt x="141706" y="62484"/>
                  </a:lnTo>
                  <a:lnTo>
                    <a:pt x="143217" y="60960"/>
                  </a:lnTo>
                  <a:lnTo>
                    <a:pt x="144741" y="59436"/>
                  </a:lnTo>
                  <a:lnTo>
                    <a:pt x="144741" y="57899"/>
                  </a:lnTo>
                  <a:lnTo>
                    <a:pt x="146265" y="54851"/>
                  </a:lnTo>
                  <a:lnTo>
                    <a:pt x="146265" y="53327"/>
                  </a:lnTo>
                  <a:lnTo>
                    <a:pt x="147789" y="51803"/>
                  </a:lnTo>
                  <a:lnTo>
                    <a:pt x="149313" y="50292"/>
                  </a:lnTo>
                  <a:lnTo>
                    <a:pt x="149313" y="48768"/>
                  </a:lnTo>
                  <a:lnTo>
                    <a:pt x="149313" y="45707"/>
                  </a:lnTo>
                  <a:lnTo>
                    <a:pt x="150837" y="44183"/>
                  </a:lnTo>
                  <a:lnTo>
                    <a:pt x="150837" y="42659"/>
                  </a:lnTo>
                  <a:lnTo>
                    <a:pt x="152361" y="41135"/>
                  </a:lnTo>
                  <a:lnTo>
                    <a:pt x="152361" y="39624"/>
                  </a:lnTo>
                  <a:lnTo>
                    <a:pt x="152361" y="38100"/>
                  </a:lnTo>
                  <a:lnTo>
                    <a:pt x="153885" y="35052"/>
                  </a:lnTo>
                  <a:lnTo>
                    <a:pt x="153885" y="33528"/>
                  </a:lnTo>
                  <a:lnTo>
                    <a:pt x="155409" y="31991"/>
                  </a:lnTo>
                  <a:lnTo>
                    <a:pt x="155409" y="30467"/>
                  </a:lnTo>
                  <a:lnTo>
                    <a:pt x="155409" y="28956"/>
                  </a:lnTo>
                  <a:lnTo>
                    <a:pt x="155409" y="25908"/>
                  </a:lnTo>
                  <a:lnTo>
                    <a:pt x="156933" y="24384"/>
                  </a:lnTo>
                  <a:lnTo>
                    <a:pt x="156933" y="22860"/>
                  </a:lnTo>
                  <a:lnTo>
                    <a:pt x="156933" y="21336"/>
                  </a:lnTo>
                  <a:lnTo>
                    <a:pt x="156933" y="19799"/>
                  </a:lnTo>
                  <a:lnTo>
                    <a:pt x="156933" y="18288"/>
                  </a:lnTo>
                  <a:lnTo>
                    <a:pt x="158457" y="15240"/>
                  </a:lnTo>
                  <a:lnTo>
                    <a:pt x="158457" y="6096"/>
                  </a:lnTo>
                  <a:lnTo>
                    <a:pt x="159981" y="4572"/>
                  </a:lnTo>
                  <a:lnTo>
                    <a:pt x="159981" y="3048"/>
                  </a:lnTo>
                  <a:lnTo>
                    <a:pt x="159981" y="1524"/>
                  </a:lnTo>
                  <a:lnTo>
                    <a:pt x="159981" y="0"/>
                  </a:lnTo>
                  <a:lnTo>
                    <a:pt x="163029" y="0"/>
                  </a:lnTo>
                  <a:lnTo>
                    <a:pt x="163029" y="9144"/>
                  </a:lnTo>
                  <a:lnTo>
                    <a:pt x="164553" y="10668"/>
                  </a:lnTo>
                  <a:lnTo>
                    <a:pt x="164553" y="21336"/>
                  </a:lnTo>
                  <a:lnTo>
                    <a:pt x="166077" y="22860"/>
                  </a:lnTo>
                  <a:lnTo>
                    <a:pt x="166077" y="24384"/>
                  </a:lnTo>
                  <a:lnTo>
                    <a:pt x="166077" y="25908"/>
                  </a:lnTo>
                  <a:lnTo>
                    <a:pt x="166077" y="28956"/>
                  </a:lnTo>
                  <a:lnTo>
                    <a:pt x="167601" y="30467"/>
                  </a:lnTo>
                  <a:lnTo>
                    <a:pt x="167601" y="31991"/>
                  </a:lnTo>
                  <a:lnTo>
                    <a:pt x="167601" y="33528"/>
                  </a:lnTo>
                  <a:lnTo>
                    <a:pt x="167601" y="35052"/>
                  </a:lnTo>
                  <a:lnTo>
                    <a:pt x="169125" y="38100"/>
                  </a:lnTo>
                  <a:lnTo>
                    <a:pt x="170649" y="39624"/>
                  </a:lnTo>
                  <a:lnTo>
                    <a:pt x="170649" y="41135"/>
                  </a:lnTo>
                  <a:lnTo>
                    <a:pt x="170649" y="42659"/>
                  </a:lnTo>
                  <a:lnTo>
                    <a:pt x="172173" y="44183"/>
                  </a:lnTo>
                  <a:lnTo>
                    <a:pt x="172173" y="45707"/>
                  </a:lnTo>
                  <a:lnTo>
                    <a:pt x="173697" y="48768"/>
                  </a:lnTo>
                  <a:lnTo>
                    <a:pt x="173697" y="50292"/>
                  </a:lnTo>
                  <a:lnTo>
                    <a:pt x="175221" y="51803"/>
                  </a:lnTo>
                  <a:lnTo>
                    <a:pt x="175221" y="53327"/>
                  </a:lnTo>
                  <a:lnTo>
                    <a:pt x="176745" y="54851"/>
                  </a:lnTo>
                  <a:lnTo>
                    <a:pt x="176745" y="57899"/>
                  </a:lnTo>
                  <a:lnTo>
                    <a:pt x="178269" y="59436"/>
                  </a:lnTo>
                  <a:lnTo>
                    <a:pt x="179793" y="60960"/>
                  </a:lnTo>
                  <a:lnTo>
                    <a:pt x="181317" y="62484"/>
                  </a:lnTo>
                  <a:lnTo>
                    <a:pt x="181317" y="63995"/>
                  </a:lnTo>
                  <a:lnTo>
                    <a:pt x="182841" y="65519"/>
                  </a:lnTo>
                  <a:lnTo>
                    <a:pt x="182841" y="68567"/>
                  </a:lnTo>
                  <a:lnTo>
                    <a:pt x="185889" y="70091"/>
                  </a:lnTo>
                  <a:lnTo>
                    <a:pt x="185889" y="71628"/>
                  </a:lnTo>
                  <a:lnTo>
                    <a:pt x="187413" y="73152"/>
                  </a:lnTo>
                  <a:lnTo>
                    <a:pt x="188937" y="74663"/>
                  </a:lnTo>
                  <a:lnTo>
                    <a:pt x="190449" y="76187"/>
                  </a:lnTo>
                  <a:lnTo>
                    <a:pt x="191985" y="79235"/>
                  </a:lnTo>
                  <a:lnTo>
                    <a:pt x="191985" y="80759"/>
                  </a:lnTo>
                  <a:lnTo>
                    <a:pt x="193509" y="82283"/>
                  </a:lnTo>
                  <a:lnTo>
                    <a:pt x="195021" y="83807"/>
                  </a:lnTo>
                  <a:lnTo>
                    <a:pt x="196545" y="85331"/>
                  </a:lnTo>
                  <a:lnTo>
                    <a:pt x="198081" y="88379"/>
                  </a:lnTo>
                  <a:lnTo>
                    <a:pt x="199593" y="89903"/>
                  </a:lnTo>
                  <a:lnTo>
                    <a:pt x="201117" y="91427"/>
                  </a:lnTo>
                  <a:lnTo>
                    <a:pt x="202641" y="92951"/>
                  </a:lnTo>
                  <a:lnTo>
                    <a:pt x="204165" y="94475"/>
                  </a:lnTo>
                  <a:lnTo>
                    <a:pt x="205689" y="95986"/>
                  </a:lnTo>
                  <a:lnTo>
                    <a:pt x="207213" y="99047"/>
                  </a:lnTo>
                  <a:lnTo>
                    <a:pt x="210261" y="100571"/>
                  </a:lnTo>
                  <a:lnTo>
                    <a:pt x="211785" y="102095"/>
                  </a:lnTo>
                  <a:lnTo>
                    <a:pt x="213309" y="103619"/>
                  </a:lnTo>
                  <a:lnTo>
                    <a:pt x="214833" y="105143"/>
                  </a:lnTo>
                  <a:lnTo>
                    <a:pt x="217881" y="106667"/>
                  </a:lnTo>
                  <a:lnTo>
                    <a:pt x="219405" y="109715"/>
                  </a:lnTo>
                  <a:lnTo>
                    <a:pt x="220929" y="111239"/>
                  </a:lnTo>
                  <a:lnTo>
                    <a:pt x="223977" y="112763"/>
                  </a:lnTo>
                  <a:lnTo>
                    <a:pt x="225501" y="114287"/>
                  </a:lnTo>
                  <a:lnTo>
                    <a:pt x="228549" y="115811"/>
                  </a:lnTo>
                  <a:lnTo>
                    <a:pt x="230073" y="117335"/>
                  </a:lnTo>
                  <a:lnTo>
                    <a:pt x="233121" y="120370"/>
                  </a:lnTo>
                  <a:lnTo>
                    <a:pt x="234645" y="121894"/>
                  </a:lnTo>
                  <a:lnTo>
                    <a:pt x="237693" y="123431"/>
                  </a:lnTo>
                  <a:lnTo>
                    <a:pt x="240728" y="124955"/>
                  </a:lnTo>
                  <a:lnTo>
                    <a:pt x="242265" y="126479"/>
                  </a:lnTo>
                  <a:lnTo>
                    <a:pt x="245313" y="128003"/>
                  </a:lnTo>
                  <a:lnTo>
                    <a:pt x="246824" y="131038"/>
                  </a:lnTo>
                  <a:lnTo>
                    <a:pt x="249885" y="132562"/>
                  </a:lnTo>
                  <a:lnTo>
                    <a:pt x="252920" y="134086"/>
                  </a:lnTo>
                  <a:lnTo>
                    <a:pt x="255981" y="135623"/>
                  </a:lnTo>
                  <a:lnTo>
                    <a:pt x="257492" y="137147"/>
                  </a:lnTo>
                  <a:lnTo>
                    <a:pt x="260540" y="138671"/>
                  </a:lnTo>
                  <a:lnTo>
                    <a:pt x="262064" y="141706"/>
                  </a:lnTo>
                  <a:lnTo>
                    <a:pt x="265112" y="143230"/>
                  </a:lnTo>
                  <a:lnTo>
                    <a:pt x="268160" y="144754"/>
                  </a:lnTo>
                  <a:lnTo>
                    <a:pt x="271208" y="146278"/>
                  </a:lnTo>
                  <a:lnTo>
                    <a:pt x="272732" y="147815"/>
                  </a:lnTo>
                  <a:lnTo>
                    <a:pt x="274256" y="149339"/>
                  </a:lnTo>
                  <a:lnTo>
                    <a:pt x="277304" y="152374"/>
                  </a:lnTo>
                  <a:lnTo>
                    <a:pt x="280352" y="153898"/>
                  </a:lnTo>
                  <a:lnTo>
                    <a:pt x="281876" y="155422"/>
                  </a:lnTo>
                  <a:lnTo>
                    <a:pt x="283400" y="156946"/>
                  </a:lnTo>
                  <a:lnTo>
                    <a:pt x="286448" y="158470"/>
                  </a:lnTo>
                  <a:lnTo>
                    <a:pt x="287972" y="159994"/>
                  </a:lnTo>
                  <a:lnTo>
                    <a:pt x="289496" y="161518"/>
                  </a:lnTo>
                  <a:lnTo>
                    <a:pt x="292544" y="164566"/>
                  </a:lnTo>
                  <a:lnTo>
                    <a:pt x="294068" y="166090"/>
                  </a:lnTo>
                  <a:lnTo>
                    <a:pt x="295592" y="167614"/>
                  </a:lnTo>
                  <a:lnTo>
                    <a:pt x="297116" y="169138"/>
                  </a:lnTo>
                  <a:lnTo>
                    <a:pt x="298627" y="170662"/>
                  </a:lnTo>
                  <a:lnTo>
                    <a:pt x="301688" y="173710"/>
                  </a:lnTo>
                  <a:lnTo>
                    <a:pt x="301688" y="175234"/>
                  </a:lnTo>
                  <a:lnTo>
                    <a:pt x="303199" y="176758"/>
                  </a:lnTo>
                  <a:lnTo>
                    <a:pt x="304723" y="178282"/>
                  </a:lnTo>
                  <a:lnTo>
                    <a:pt x="306260" y="179806"/>
                  </a:lnTo>
                  <a:lnTo>
                    <a:pt x="307771" y="181330"/>
                  </a:lnTo>
                  <a:lnTo>
                    <a:pt x="309295" y="184365"/>
                  </a:lnTo>
                  <a:lnTo>
                    <a:pt x="309295" y="185902"/>
                  </a:lnTo>
                  <a:lnTo>
                    <a:pt x="310819" y="187426"/>
                  </a:lnTo>
                  <a:lnTo>
                    <a:pt x="312356" y="188950"/>
                  </a:lnTo>
                  <a:lnTo>
                    <a:pt x="313867" y="190474"/>
                  </a:lnTo>
                  <a:lnTo>
                    <a:pt x="313867" y="193522"/>
                  </a:lnTo>
                  <a:lnTo>
                    <a:pt x="315391" y="195033"/>
                  </a:lnTo>
                  <a:lnTo>
                    <a:pt x="315391" y="196557"/>
                  </a:lnTo>
                  <a:lnTo>
                    <a:pt x="316915" y="198094"/>
                  </a:lnTo>
                  <a:lnTo>
                    <a:pt x="316915" y="199618"/>
                  </a:lnTo>
                  <a:lnTo>
                    <a:pt x="318439" y="201142"/>
                  </a:lnTo>
                  <a:lnTo>
                    <a:pt x="318439" y="204190"/>
                  </a:lnTo>
                  <a:lnTo>
                    <a:pt x="318439" y="205701"/>
                  </a:lnTo>
                  <a:lnTo>
                    <a:pt x="319963" y="207225"/>
                  </a:lnTo>
                  <a:lnTo>
                    <a:pt x="319963" y="208749"/>
                  </a:lnTo>
                  <a:lnTo>
                    <a:pt x="319963" y="210273"/>
                  </a:lnTo>
                  <a:lnTo>
                    <a:pt x="321487" y="211810"/>
                  </a:lnTo>
                  <a:lnTo>
                    <a:pt x="321487" y="214858"/>
                  </a:lnTo>
                  <a:lnTo>
                    <a:pt x="321487" y="216382"/>
                  </a:lnTo>
                  <a:lnTo>
                    <a:pt x="321487" y="217893"/>
                  </a:lnTo>
                  <a:lnTo>
                    <a:pt x="321487" y="219417"/>
                  </a:lnTo>
                  <a:lnTo>
                    <a:pt x="323011" y="220941"/>
                  </a:lnTo>
                  <a:lnTo>
                    <a:pt x="323011" y="224002"/>
                  </a:lnTo>
                  <a:lnTo>
                    <a:pt x="321487" y="225526"/>
                  </a:lnTo>
                  <a:lnTo>
                    <a:pt x="321487" y="227050"/>
                  </a:lnTo>
                  <a:lnTo>
                    <a:pt x="321487" y="228561"/>
                  </a:lnTo>
                  <a:lnTo>
                    <a:pt x="321487" y="230085"/>
                  </a:lnTo>
                  <a:lnTo>
                    <a:pt x="319963" y="231609"/>
                  </a:lnTo>
                  <a:lnTo>
                    <a:pt x="319963" y="234657"/>
                  </a:lnTo>
                  <a:lnTo>
                    <a:pt x="319963" y="236194"/>
                  </a:lnTo>
                  <a:lnTo>
                    <a:pt x="318439" y="237718"/>
                  </a:lnTo>
                  <a:lnTo>
                    <a:pt x="318439" y="239229"/>
                  </a:lnTo>
                  <a:lnTo>
                    <a:pt x="316915" y="240753"/>
                  </a:lnTo>
                  <a:lnTo>
                    <a:pt x="316915" y="243801"/>
                  </a:lnTo>
                  <a:lnTo>
                    <a:pt x="315391" y="245325"/>
                  </a:lnTo>
                  <a:lnTo>
                    <a:pt x="313867" y="246849"/>
                  </a:lnTo>
                  <a:lnTo>
                    <a:pt x="313867" y="248373"/>
                  </a:lnTo>
                  <a:lnTo>
                    <a:pt x="312356" y="249897"/>
                  </a:lnTo>
                  <a:lnTo>
                    <a:pt x="310819" y="251421"/>
                  </a:lnTo>
                  <a:lnTo>
                    <a:pt x="309295" y="254469"/>
                  </a:lnTo>
                  <a:lnTo>
                    <a:pt x="309295" y="255993"/>
                  </a:lnTo>
                  <a:lnTo>
                    <a:pt x="307771" y="257517"/>
                  </a:lnTo>
                  <a:lnTo>
                    <a:pt x="306260" y="259041"/>
                  </a:lnTo>
                  <a:lnTo>
                    <a:pt x="304723" y="260553"/>
                  </a:lnTo>
                  <a:lnTo>
                    <a:pt x="303199" y="262089"/>
                  </a:lnTo>
                  <a:lnTo>
                    <a:pt x="303199" y="265137"/>
                  </a:lnTo>
                  <a:lnTo>
                    <a:pt x="301688" y="266661"/>
                  </a:lnTo>
                  <a:lnTo>
                    <a:pt x="300164" y="268185"/>
                  </a:lnTo>
                  <a:lnTo>
                    <a:pt x="298627" y="269709"/>
                  </a:lnTo>
                  <a:lnTo>
                    <a:pt x="298627" y="271221"/>
                  </a:lnTo>
                  <a:lnTo>
                    <a:pt x="297116" y="274281"/>
                  </a:lnTo>
                  <a:lnTo>
                    <a:pt x="295592" y="275805"/>
                  </a:lnTo>
                  <a:lnTo>
                    <a:pt x="294068" y="277329"/>
                  </a:lnTo>
                  <a:lnTo>
                    <a:pt x="294068" y="278853"/>
                  </a:lnTo>
                  <a:lnTo>
                    <a:pt x="292544" y="280377"/>
                  </a:lnTo>
                  <a:lnTo>
                    <a:pt x="292544" y="281901"/>
                  </a:lnTo>
                  <a:lnTo>
                    <a:pt x="291020" y="284937"/>
                  </a:lnTo>
                  <a:lnTo>
                    <a:pt x="289496" y="286461"/>
                  </a:lnTo>
                  <a:lnTo>
                    <a:pt x="289496" y="287997"/>
                  </a:lnTo>
                  <a:lnTo>
                    <a:pt x="287972" y="289521"/>
                  </a:lnTo>
                  <a:lnTo>
                    <a:pt x="286448" y="291045"/>
                  </a:lnTo>
                  <a:lnTo>
                    <a:pt x="286448" y="292569"/>
                  </a:lnTo>
                  <a:lnTo>
                    <a:pt x="284924" y="294081"/>
                  </a:lnTo>
                  <a:lnTo>
                    <a:pt x="283400" y="297129"/>
                  </a:lnTo>
                  <a:lnTo>
                    <a:pt x="283400" y="298653"/>
                  </a:lnTo>
                  <a:lnTo>
                    <a:pt x="281876" y="300189"/>
                  </a:lnTo>
                  <a:lnTo>
                    <a:pt x="281876" y="301713"/>
                  </a:lnTo>
                  <a:lnTo>
                    <a:pt x="280352" y="303237"/>
                  </a:lnTo>
                  <a:lnTo>
                    <a:pt x="278828" y="306273"/>
                  </a:lnTo>
                  <a:lnTo>
                    <a:pt x="277304" y="307797"/>
                  </a:lnTo>
                  <a:lnTo>
                    <a:pt x="277304" y="309321"/>
                  </a:lnTo>
                  <a:lnTo>
                    <a:pt x="275780" y="310845"/>
                  </a:lnTo>
                  <a:lnTo>
                    <a:pt x="274256" y="312381"/>
                  </a:lnTo>
                  <a:lnTo>
                    <a:pt x="272732" y="313905"/>
                  </a:lnTo>
                  <a:lnTo>
                    <a:pt x="272732" y="315417"/>
                  </a:lnTo>
                  <a:lnTo>
                    <a:pt x="271208" y="318465"/>
                  </a:lnTo>
                  <a:lnTo>
                    <a:pt x="269684" y="319989"/>
                  </a:lnTo>
                  <a:lnTo>
                    <a:pt x="268160" y="321513"/>
                  </a:lnTo>
                  <a:lnTo>
                    <a:pt x="266636" y="323037"/>
                  </a:lnTo>
                  <a:lnTo>
                    <a:pt x="265112" y="324561"/>
                  </a:lnTo>
                  <a:lnTo>
                    <a:pt x="263588" y="326097"/>
                  </a:lnTo>
                  <a:lnTo>
                    <a:pt x="263588" y="329133"/>
                  </a:lnTo>
                  <a:lnTo>
                    <a:pt x="262064" y="330657"/>
                  </a:lnTo>
                  <a:lnTo>
                    <a:pt x="260540" y="332181"/>
                  </a:lnTo>
                  <a:lnTo>
                    <a:pt x="259016" y="333705"/>
                  </a:lnTo>
                  <a:lnTo>
                    <a:pt x="257492" y="335229"/>
                  </a:lnTo>
                  <a:lnTo>
                    <a:pt x="255981" y="336753"/>
                  </a:lnTo>
                  <a:lnTo>
                    <a:pt x="255981" y="339801"/>
                  </a:lnTo>
                  <a:lnTo>
                    <a:pt x="254444" y="341325"/>
                  </a:lnTo>
                  <a:lnTo>
                    <a:pt x="252920" y="342849"/>
                  </a:lnTo>
                  <a:lnTo>
                    <a:pt x="251396" y="344373"/>
                  </a:lnTo>
                  <a:lnTo>
                    <a:pt x="249885" y="345897"/>
                  </a:lnTo>
                  <a:lnTo>
                    <a:pt x="248348" y="347421"/>
                  </a:lnTo>
                  <a:lnTo>
                    <a:pt x="248348" y="350469"/>
                  </a:lnTo>
                  <a:lnTo>
                    <a:pt x="246824" y="351993"/>
                  </a:lnTo>
                  <a:lnTo>
                    <a:pt x="245313" y="353517"/>
                  </a:lnTo>
                  <a:lnTo>
                    <a:pt x="243789" y="355041"/>
                  </a:lnTo>
                  <a:lnTo>
                    <a:pt x="243789" y="356565"/>
                  </a:lnTo>
                  <a:lnTo>
                    <a:pt x="242265" y="359600"/>
                  </a:lnTo>
                  <a:lnTo>
                    <a:pt x="240728" y="361124"/>
                  </a:lnTo>
                  <a:lnTo>
                    <a:pt x="240728" y="362661"/>
                  </a:lnTo>
                  <a:lnTo>
                    <a:pt x="239217" y="364185"/>
                  </a:lnTo>
                  <a:lnTo>
                    <a:pt x="237693" y="365709"/>
                  </a:lnTo>
                  <a:lnTo>
                    <a:pt x="237693" y="367233"/>
                  </a:lnTo>
                  <a:lnTo>
                    <a:pt x="236169" y="370268"/>
                  </a:lnTo>
                  <a:lnTo>
                    <a:pt x="234645" y="371792"/>
                  </a:lnTo>
                  <a:lnTo>
                    <a:pt x="233121" y="373316"/>
                  </a:lnTo>
                  <a:lnTo>
                    <a:pt x="233121" y="374840"/>
                  </a:lnTo>
                  <a:lnTo>
                    <a:pt x="231597" y="376377"/>
                  </a:lnTo>
                  <a:lnTo>
                    <a:pt x="231597" y="379425"/>
                  </a:lnTo>
                  <a:lnTo>
                    <a:pt x="230073" y="380936"/>
                  </a:lnTo>
                  <a:lnTo>
                    <a:pt x="228549" y="382460"/>
                  </a:lnTo>
                  <a:lnTo>
                    <a:pt x="227025" y="383984"/>
                  </a:lnTo>
                  <a:lnTo>
                    <a:pt x="227025" y="385508"/>
                  </a:lnTo>
                  <a:lnTo>
                    <a:pt x="225501" y="387032"/>
                  </a:lnTo>
                  <a:lnTo>
                    <a:pt x="223977" y="390093"/>
                  </a:lnTo>
                  <a:lnTo>
                    <a:pt x="222453" y="391617"/>
                  </a:lnTo>
                  <a:lnTo>
                    <a:pt x="222453" y="393128"/>
                  </a:lnTo>
                  <a:lnTo>
                    <a:pt x="220929" y="394652"/>
                  </a:lnTo>
                  <a:lnTo>
                    <a:pt x="220929" y="396176"/>
                  </a:lnTo>
                  <a:lnTo>
                    <a:pt x="219405" y="397700"/>
                  </a:lnTo>
                  <a:lnTo>
                    <a:pt x="217881" y="400761"/>
                  </a:lnTo>
                  <a:lnTo>
                    <a:pt x="217881" y="402285"/>
                  </a:lnTo>
                  <a:lnTo>
                    <a:pt x="216357" y="403796"/>
                  </a:lnTo>
                  <a:lnTo>
                    <a:pt x="214833" y="405320"/>
                  </a:lnTo>
                  <a:lnTo>
                    <a:pt x="214833" y="406844"/>
                  </a:lnTo>
                  <a:lnTo>
                    <a:pt x="213309" y="409892"/>
                  </a:lnTo>
                  <a:lnTo>
                    <a:pt x="213309" y="411416"/>
                  </a:lnTo>
                  <a:lnTo>
                    <a:pt x="211785" y="412940"/>
                  </a:lnTo>
                  <a:lnTo>
                    <a:pt x="211785" y="414464"/>
                  </a:lnTo>
                  <a:lnTo>
                    <a:pt x="210261" y="415988"/>
                  </a:lnTo>
                  <a:lnTo>
                    <a:pt x="210261" y="417512"/>
                  </a:lnTo>
                  <a:lnTo>
                    <a:pt x="210261" y="420560"/>
                  </a:lnTo>
                  <a:lnTo>
                    <a:pt x="208737" y="422084"/>
                  </a:lnTo>
                  <a:lnTo>
                    <a:pt x="208737" y="423608"/>
                  </a:lnTo>
                  <a:lnTo>
                    <a:pt x="207213" y="425119"/>
                  </a:lnTo>
                  <a:lnTo>
                    <a:pt x="207213" y="426656"/>
                  </a:lnTo>
                  <a:lnTo>
                    <a:pt x="207213" y="429704"/>
                  </a:lnTo>
                  <a:lnTo>
                    <a:pt x="207213" y="431228"/>
                  </a:lnTo>
                  <a:lnTo>
                    <a:pt x="205689" y="432752"/>
                  </a:lnTo>
                  <a:lnTo>
                    <a:pt x="205689" y="434276"/>
                  </a:lnTo>
                  <a:lnTo>
                    <a:pt x="205689" y="435800"/>
                  </a:lnTo>
                  <a:lnTo>
                    <a:pt x="205689" y="437311"/>
                  </a:lnTo>
                  <a:lnTo>
                    <a:pt x="205689" y="440372"/>
                  </a:lnTo>
                  <a:lnTo>
                    <a:pt x="204165" y="441896"/>
                  </a:lnTo>
                  <a:lnTo>
                    <a:pt x="204165" y="443420"/>
                  </a:lnTo>
                  <a:lnTo>
                    <a:pt x="204165" y="444944"/>
                  </a:lnTo>
                  <a:lnTo>
                    <a:pt x="202641" y="446468"/>
                  </a:lnTo>
                  <a:lnTo>
                    <a:pt x="202641" y="447979"/>
                  </a:lnTo>
                  <a:lnTo>
                    <a:pt x="202641" y="451040"/>
                  </a:lnTo>
                  <a:lnTo>
                    <a:pt x="202641" y="452564"/>
                  </a:lnTo>
                  <a:lnTo>
                    <a:pt x="201117" y="454088"/>
                  </a:lnTo>
                  <a:lnTo>
                    <a:pt x="201117" y="455612"/>
                  </a:lnTo>
                  <a:lnTo>
                    <a:pt x="201117" y="457136"/>
                  </a:lnTo>
                  <a:lnTo>
                    <a:pt x="201117" y="458647"/>
                  </a:lnTo>
                  <a:lnTo>
                    <a:pt x="199593" y="461695"/>
                  </a:lnTo>
                  <a:lnTo>
                    <a:pt x="199593" y="463219"/>
                  </a:lnTo>
                  <a:lnTo>
                    <a:pt x="199593" y="464756"/>
                  </a:lnTo>
                  <a:lnTo>
                    <a:pt x="198081" y="466280"/>
                  </a:lnTo>
                  <a:lnTo>
                    <a:pt x="198081" y="467804"/>
                  </a:lnTo>
                  <a:lnTo>
                    <a:pt x="198081" y="469315"/>
                  </a:lnTo>
                  <a:lnTo>
                    <a:pt x="198081" y="472363"/>
                  </a:lnTo>
                  <a:lnTo>
                    <a:pt x="196545" y="473887"/>
                  </a:lnTo>
                  <a:lnTo>
                    <a:pt x="196545" y="475411"/>
                  </a:lnTo>
                  <a:lnTo>
                    <a:pt x="196545" y="476948"/>
                  </a:lnTo>
                  <a:lnTo>
                    <a:pt x="196545" y="478472"/>
                  </a:lnTo>
                  <a:lnTo>
                    <a:pt x="196545" y="479983"/>
                  </a:lnTo>
                  <a:lnTo>
                    <a:pt x="195021" y="483031"/>
                  </a:lnTo>
                  <a:lnTo>
                    <a:pt x="195021" y="484555"/>
                  </a:lnTo>
                  <a:lnTo>
                    <a:pt x="195021" y="486079"/>
                  </a:lnTo>
                  <a:lnTo>
                    <a:pt x="195021" y="487603"/>
                  </a:lnTo>
                  <a:lnTo>
                    <a:pt x="195021" y="489140"/>
                  </a:lnTo>
                  <a:lnTo>
                    <a:pt x="193509" y="490651"/>
                  </a:lnTo>
                  <a:lnTo>
                    <a:pt x="193509" y="493699"/>
                  </a:lnTo>
                  <a:lnTo>
                    <a:pt x="193509" y="495223"/>
                  </a:lnTo>
                  <a:lnTo>
                    <a:pt x="193509" y="496747"/>
                  </a:lnTo>
                  <a:lnTo>
                    <a:pt x="191985" y="498271"/>
                  </a:lnTo>
                  <a:lnTo>
                    <a:pt x="191985" y="507415"/>
                  </a:lnTo>
                  <a:lnTo>
                    <a:pt x="190449" y="508939"/>
                  </a:lnTo>
                  <a:lnTo>
                    <a:pt x="190449" y="510463"/>
                  </a:lnTo>
                  <a:lnTo>
                    <a:pt x="190449" y="511987"/>
                  </a:lnTo>
                  <a:lnTo>
                    <a:pt x="190449" y="515035"/>
                  </a:lnTo>
                  <a:lnTo>
                    <a:pt x="190449" y="516559"/>
                  </a:lnTo>
                  <a:lnTo>
                    <a:pt x="188937" y="518083"/>
                  </a:lnTo>
                  <a:lnTo>
                    <a:pt x="188937" y="519607"/>
                  </a:lnTo>
                  <a:lnTo>
                    <a:pt x="188937" y="521131"/>
                  </a:lnTo>
                  <a:lnTo>
                    <a:pt x="187413" y="522655"/>
                  </a:lnTo>
                  <a:lnTo>
                    <a:pt x="187413" y="525691"/>
                  </a:lnTo>
                  <a:lnTo>
                    <a:pt x="187413" y="527227"/>
                  </a:lnTo>
                  <a:lnTo>
                    <a:pt x="187413" y="528751"/>
                  </a:lnTo>
                  <a:lnTo>
                    <a:pt x="187413" y="530275"/>
                  </a:lnTo>
                  <a:lnTo>
                    <a:pt x="185889" y="531799"/>
                  </a:lnTo>
                  <a:lnTo>
                    <a:pt x="185889" y="533323"/>
                  </a:lnTo>
                  <a:lnTo>
                    <a:pt x="185889" y="536359"/>
                  </a:lnTo>
                  <a:lnTo>
                    <a:pt x="185889" y="537883"/>
                  </a:lnTo>
                  <a:lnTo>
                    <a:pt x="184353" y="539407"/>
                  </a:lnTo>
                  <a:lnTo>
                    <a:pt x="184353" y="540943"/>
                  </a:lnTo>
                  <a:lnTo>
                    <a:pt x="184353" y="542467"/>
                  </a:lnTo>
                  <a:lnTo>
                    <a:pt x="182841" y="545515"/>
                  </a:lnTo>
                  <a:lnTo>
                    <a:pt x="182841" y="553135"/>
                  </a:lnTo>
                  <a:lnTo>
                    <a:pt x="181317" y="556183"/>
                  </a:lnTo>
                  <a:lnTo>
                    <a:pt x="181317" y="557695"/>
                  </a:lnTo>
                  <a:lnTo>
                    <a:pt x="181317" y="559219"/>
                  </a:lnTo>
                  <a:lnTo>
                    <a:pt x="181317" y="560743"/>
                  </a:lnTo>
                  <a:lnTo>
                    <a:pt x="181317" y="562267"/>
                  </a:lnTo>
                  <a:lnTo>
                    <a:pt x="179793" y="565327"/>
                  </a:lnTo>
                  <a:lnTo>
                    <a:pt x="179793" y="572935"/>
                  </a:lnTo>
                  <a:lnTo>
                    <a:pt x="178269" y="575983"/>
                  </a:lnTo>
                  <a:lnTo>
                    <a:pt x="178269" y="577507"/>
                  </a:lnTo>
                  <a:lnTo>
                    <a:pt x="178269" y="579031"/>
                  </a:lnTo>
                  <a:lnTo>
                    <a:pt x="178269" y="580555"/>
                  </a:lnTo>
                  <a:lnTo>
                    <a:pt x="176745" y="582079"/>
                  </a:lnTo>
                  <a:lnTo>
                    <a:pt x="176745" y="591223"/>
                  </a:lnTo>
                  <a:lnTo>
                    <a:pt x="175221" y="592747"/>
                  </a:lnTo>
                  <a:lnTo>
                    <a:pt x="175221" y="601878"/>
                  </a:lnTo>
                  <a:lnTo>
                    <a:pt x="173697" y="603415"/>
                  </a:lnTo>
                  <a:lnTo>
                    <a:pt x="173697" y="612546"/>
                  </a:lnTo>
                  <a:lnTo>
                    <a:pt x="172173" y="615607"/>
                  </a:lnTo>
                  <a:lnTo>
                    <a:pt x="172173" y="643039"/>
                  </a:lnTo>
                  <a:lnTo>
                    <a:pt x="170649" y="644563"/>
                  </a:lnTo>
                  <a:lnTo>
                    <a:pt x="170649" y="664362"/>
                  </a:lnTo>
                  <a:lnTo>
                    <a:pt x="169125" y="665886"/>
                  </a:lnTo>
                  <a:lnTo>
                    <a:pt x="169125" y="676554"/>
                  </a:lnTo>
                  <a:lnTo>
                    <a:pt x="167601" y="678065"/>
                  </a:lnTo>
                  <a:lnTo>
                    <a:pt x="167601" y="696366"/>
                  </a:lnTo>
                  <a:lnTo>
                    <a:pt x="166077" y="697890"/>
                  </a:lnTo>
                  <a:lnTo>
                    <a:pt x="166077" y="778637"/>
                  </a:lnTo>
                  <a:lnTo>
                    <a:pt x="164553" y="781697"/>
                  </a:lnTo>
                  <a:lnTo>
                    <a:pt x="164553" y="815213"/>
                  </a:lnTo>
                  <a:lnTo>
                    <a:pt x="163029" y="816737"/>
                  </a:lnTo>
                  <a:lnTo>
                    <a:pt x="163029" y="911212"/>
                  </a:lnTo>
                  <a:lnTo>
                    <a:pt x="161505" y="912736"/>
                  </a:lnTo>
                  <a:lnTo>
                    <a:pt x="159981" y="912736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52"/>
            <p:cNvSpPr/>
            <p:nvPr/>
          </p:nvSpPr>
          <p:spPr>
            <a:xfrm>
              <a:off x="2970730" y="5863051"/>
              <a:ext cx="347980" cy="989330"/>
            </a:xfrm>
            <a:custGeom>
              <a:avLst/>
              <a:gdLst/>
              <a:ahLst/>
              <a:cxnLst/>
              <a:rect l="l" t="t" r="r" b="b"/>
              <a:pathLst>
                <a:path w="347979" h="989329">
                  <a:moveTo>
                    <a:pt x="173697" y="85090"/>
                  </a:moveTo>
                  <a:lnTo>
                    <a:pt x="173697" y="104140"/>
                  </a:lnTo>
                  <a:lnTo>
                    <a:pt x="172173" y="106680"/>
                  </a:lnTo>
                  <a:lnTo>
                    <a:pt x="172173" y="118110"/>
                  </a:lnTo>
                  <a:lnTo>
                    <a:pt x="170649" y="119380"/>
                  </a:lnTo>
                  <a:lnTo>
                    <a:pt x="170649" y="125730"/>
                  </a:lnTo>
                  <a:lnTo>
                    <a:pt x="169125" y="127000"/>
                  </a:lnTo>
                  <a:lnTo>
                    <a:pt x="169125" y="133350"/>
                  </a:lnTo>
                  <a:lnTo>
                    <a:pt x="167601" y="134620"/>
                  </a:lnTo>
                  <a:lnTo>
                    <a:pt x="167601" y="139700"/>
                  </a:lnTo>
                  <a:lnTo>
                    <a:pt x="166077" y="140970"/>
                  </a:lnTo>
                  <a:lnTo>
                    <a:pt x="166077" y="142240"/>
                  </a:lnTo>
                  <a:lnTo>
                    <a:pt x="164553" y="146050"/>
                  </a:lnTo>
                  <a:lnTo>
                    <a:pt x="164553" y="148590"/>
                  </a:lnTo>
                  <a:lnTo>
                    <a:pt x="163029" y="149860"/>
                  </a:lnTo>
                  <a:lnTo>
                    <a:pt x="163029" y="152400"/>
                  </a:lnTo>
                  <a:lnTo>
                    <a:pt x="161518" y="154940"/>
                  </a:lnTo>
                  <a:lnTo>
                    <a:pt x="161518" y="156210"/>
                  </a:lnTo>
                  <a:lnTo>
                    <a:pt x="159981" y="157480"/>
                  </a:lnTo>
                  <a:lnTo>
                    <a:pt x="158457" y="161290"/>
                  </a:lnTo>
                  <a:lnTo>
                    <a:pt x="158457" y="162560"/>
                  </a:lnTo>
                  <a:lnTo>
                    <a:pt x="156946" y="163830"/>
                  </a:lnTo>
                  <a:lnTo>
                    <a:pt x="156946" y="165100"/>
                  </a:lnTo>
                  <a:lnTo>
                    <a:pt x="155422" y="168910"/>
                  </a:lnTo>
                  <a:lnTo>
                    <a:pt x="153885" y="170180"/>
                  </a:lnTo>
                  <a:lnTo>
                    <a:pt x="153885" y="171450"/>
                  </a:lnTo>
                  <a:lnTo>
                    <a:pt x="152361" y="172720"/>
                  </a:lnTo>
                  <a:lnTo>
                    <a:pt x="150850" y="176530"/>
                  </a:lnTo>
                  <a:lnTo>
                    <a:pt x="149326" y="177800"/>
                  </a:lnTo>
                  <a:lnTo>
                    <a:pt x="149326" y="179070"/>
                  </a:lnTo>
                  <a:lnTo>
                    <a:pt x="147789" y="182880"/>
                  </a:lnTo>
                  <a:lnTo>
                    <a:pt x="147789" y="184150"/>
                  </a:lnTo>
                  <a:lnTo>
                    <a:pt x="144754" y="186690"/>
                  </a:lnTo>
                  <a:lnTo>
                    <a:pt x="143230" y="190500"/>
                  </a:lnTo>
                  <a:lnTo>
                    <a:pt x="141693" y="191770"/>
                  </a:lnTo>
                  <a:lnTo>
                    <a:pt x="141693" y="193040"/>
                  </a:lnTo>
                  <a:lnTo>
                    <a:pt x="140182" y="195580"/>
                  </a:lnTo>
                  <a:lnTo>
                    <a:pt x="135610" y="200660"/>
                  </a:lnTo>
                  <a:lnTo>
                    <a:pt x="134086" y="203200"/>
                  </a:lnTo>
                  <a:lnTo>
                    <a:pt x="129514" y="208280"/>
                  </a:lnTo>
                  <a:lnTo>
                    <a:pt x="126466" y="213360"/>
                  </a:lnTo>
                  <a:lnTo>
                    <a:pt x="123418" y="214630"/>
                  </a:lnTo>
                  <a:lnTo>
                    <a:pt x="121894" y="217170"/>
                  </a:lnTo>
                  <a:lnTo>
                    <a:pt x="118846" y="220980"/>
                  </a:lnTo>
                  <a:lnTo>
                    <a:pt x="115798" y="222250"/>
                  </a:lnTo>
                  <a:lnTo>
                    <a:pt x="114274" y="223520"/>
                  </a:lnTo>
                  <a:lnTo>
                    <a:pt x="112750" y="226060"/>
                  </a:lnTo>
                  <a:lnTo>
                    <a:pt x="105143" y="232410"/>
                  </a:lnTo>
                  <a:lnTo>
                    <a:pt x="99047" y="236220"/>
                  </a:lnTo>
                  <a:lnTo>
                    <a:pt x="94475" y="240030"/>
                  </a:lnTo>
                  <a:lnTo>
                    <a:pt x="88379" y="243840"/>
                  </a:lnTo>
                  <a:lnTo>
                    <a:pt x="86855" y="246380"/>
                  </a:lnTo>
                  <a:lnTo>
                    <a:pt x="82283" y="247650"/>
                  </a:lnTo>
                  <a:lnTo>
                    <a:pt x="77711" y="251460"/>
                  </a:lnTo>
                  <a:lnTo>
                    <a:pt x="73139" y="254000"/>
                  </a:lnTo>
                  <a:lnTo>
                    <a:pt x="71615" y="255270"/>
                  </a:lnTo>
                  <a:lnTo>
                    <a:pt x="67043" y="256540"/>
                  </a:lnTo>
                  <a:lnTo>
                    <a:pt x="62471" y="261620"/>
                  </a:lnTo>
                  <a:lnTo>
                    <a:pt x="57899" y="262890"/>
                  </a:lnTo>
                  <a:lnTo>
                    <a:pt x="53327" y="267970"/>
                  </a:lnTo>
                  <a:lnTo>
                    <a:pt x="44183" y="271780"/>
                  </a:lnTo>
                  <a:lnTo>
                    <a:pt x="39611" y="276860"/>
                  </a:lnTo>
                  <a:lnTo>
                    <a:pt x="36575" y="278130"/>
                  </a:lnTo>
                  <a:lnTo>
                    <a:pt x="35051" y="281940"/>
                  </a:lnTo>
                  <a:lnTo>
                    <a:pt x="32003" y="283210"/>
                  </a:lnTo>
                  <a:lnTo>
                    <a:pt x="27431" y="287020"/>
                  </a:lnTo>
                  <a:lnTo>
                    <a:pt x="25907" y="290830"/>
                  </a:lnTo>
                  <a:lnTo>
                    <a:pt x="22859" y="292100"/>
                  </a:lnTo>
                  <a:lnTo>
                    <a:pt x="22859" y="293370"/>
                  </a:lnTo>
                  <a:lnTo>
                    <a:pt x="21335" y="297180"/>
                  </a:lnTo>
                  <a:lnTo>
                    <a:pt x="16763" y="300990"/>
                  </a:lnTo>
                  <a:lnTo>
                    <a:pt x="15239" y="304800"/>
                  </a:lnTo>
                  <a:lnTo>
                    <a:pt x="15239" y="306070"/>
                  </a:lnTo>
                  <a:lnTo>
                    <a:pt x="12191" y="308610"/>
                  </a:lnTo>
                  <a:lnTo>
                    <a:pt x="12191" y="312420"/>
                  </a:lnTo>
                  <a:lnTo>
                    <a:pt x="9143" y="314960"/>
                  </a:lnTo>
                  <a:lnTo>
                    <a:pt x="7619" y="317500"/>
                  </a:lnTo>
                  <a:lnTo>
                    <a:pt x="7619" y="320040"/>
                  </a:lnTo>
                  <a:lnTo>
                    <a:pt x="6095" y="321310"/>
                  </a:lnTo>
                  <a:lnTo>
                    <a:pt x="6095" y="322580"/>
                  </a:lnTo>
                  <a:lnTo>
                    <a:pt x="4571" y="325120"/>
                  </a:lnTo>
                  <a:lnTo>
                    <a:pt x="4571" y="327660"/>
                  </a:lnTo>
                  <a:lnTo>
                    <a:pt x="3047" y="328930"/>
                  </a:lnTo>
                  <a:lnTo>
                    <a:pt x="3047" y="331470"/>
                  </a:lnTo>
                  <a:lnTo>
                    <a:pt x="1523" y="332740"/>
                  </a:lnTo>
                  <a:lnTo>
                    <a:pt x="1523" y="339090"/>
                  </a:lnTo>
                  <a:lnTo>
                    <a:pt x="0" y="340360"/>
                  </a:lnTo>
                  <a:lnTo>
                    <a:pt x="0" y="350520"/>
                  </a:lnTo>
                  <a:lnTo>
                    <a:pt x="1523" y="353060"/>
                  </a:lnTo>
                  <a:lnTo>
                    <a:pt x="1523" y="358140"/>
                  </a:lnTo>
                  <a:lnTo>
                    <a:pt x="3047" y="359410"/>
                  </a:lnTo>
                  <a:lnTo>
                    <a:pt x="4571" y="361950"/>
                  </a:lnTo>
                  <a:lnTo>
                    <a:pt x="4571" y="363220"/>
                  </a:lnTo>
                  <a:lnTo>
                    <a:pt x="6095" y="367030"/>
                  </a:lnTo>
                  <a:lnTo>
                    <a:pt x="6095" y="368300"/>
                  </a:lnTo>
                  <a:lnTo>
                    <a:pt x="10667" y="373380"/>
                  </a:lnTo>
                  <a:lnTo>
                    <a:pt x="12191" y="375920"/>
                  </a:lnTo>
                  <a:lnTo>
                    <a:pt x="15239" y="378460"/>
                  </a:lnTo>
                  <a:lnTo>
                    <a:pt x="16763" y="382270"/>
                  </a:lnTo>
                  <a:lnTo>
                    <a:pt x="27431" y="392430"/>
                  </a:lnTo>
                  <a:lnTo>
                    <a:pt x="30479" y="393700"/>
                  </a:lnTo>
                  <a:lnTo>
                    <a:pt x="32003" y="397510"/>
                  </a:lnTo>
                  <a:lnTo>
                    <a:pt x="33515" y="398780"/>
                  </a:lnTo>
                  <a:lnTo>
                    <a:pt x="36575" y="400050"/>
                  </a:lnTo>
                  <a:lnTo>
                    <a:pt x="38087" y="403860"/>
                  </a:lnTo>
                  <a:lnTo>
                    <a:pt x="41135" y="405130"/>
                  </a:lnTo>
                  <a:lnTo>
                    <a:pt x="65519" y="429260"/>
                  </a:lnTo>
                  <a:lnTo>
                    <a:pt x="68567" y="434340"/>
                  </a:lnTo>
                  <a:lnTo>
                    <a:pt x="71615" y="435610"/>
                  </a:lnTo>
                  <a:lnTo>
                    <a:pt x="73139" y="438150"/>
                  </a:lnTo>
                  <a:lnTo>
                    <a:pt x="77711" y="443230"/>
                  </a:lnTo>
                  <a:lnTo>
                    <a:pt x="77711" y="444500"/>
                  </a:lnTo>
                  <a:lnTo>
                    <a:pt x="80759" y="447040"/>
                  </a:lnTo>
                  <a:lnTo>
                    <a:pt x="80759" y="449580"/>
                  </a:lnTo>
                  <a:lnTo>
                    <a:pt x="82283" y="452120"/>
                  </a:lnTo>
                  <a:lnTo>
                    <a:pt x="86855" y="457200"/>
                  </a:lnTo>
                  <a:lnTo>
                    <a:pt x="86855" y="458470"/>
                  </a:lnTo>
                  <a:lnTo>
                    <a:pt x="88379" y="461010"/>
                  </a:lnTo>
                  <a:lnTo>
                    <a:pt x="91414" y="464820"/>
                  </a:lnTo>
                  <a:lnTo>
                    <a:pt x="92951" y="467360"/>
                  </a:lnTo>
                  <a:lnTo>
                    <a:pt x="92951" y="468630"/>
                  </a:lnTo>
                  <a:lnTo>
                    <a:pt x="95986" y="469900"/>
                  </a:lnTo>
                  <a:lnTo>
                    <a:pt x="95986" y="472440"/>
                  </a:lnTo>
                  <a:lnTo>
                    <a:pt x="97510" y="474980"/>
                  </a:lnTo>
                  <a:lnTo>
                    <a:pt x="99047" y="476250"/>
                  </a:lnTo>
                  <a:lnTo>
                    <a:pt x="99047" y="477520"/>
                  </a:lnTo>
                  <a:lnTo>
                    <a:pt x="102082" y="482600"/>
                  </a:lnTo>
                  <a:lnTo>
                    <a:pt x="102082" y="483870"/>
                  </a:lnTo>
                  <a:lnTo>
                    <a:pt x="103606" y="485140"/>
                  </a:lnTo>
                  <a:lnTo>
                    <a:pt x="105143" y="488950"/>
                  </a:lnTo>
                  <a:lnTo>
                    <a:pt x="106654" y="490220"/>
                  </a:lnTo>
                  <a:lnTo>
                    <a:pt x="106654" y="491490"/>
                  </a:lnTo>
                  <a:lnTo>
                    <a:pt x="108178" y="492760"/>
                  </a:lnTo>
                  <a:lnTo>
                    <a:pt x="108178" y="496570"/>
                  </a:lnTo>
                  <a:lnTo>
                    <a:pt x="109702" y="497840"/>
                  </a:lnTo>
                  <a:lnTo>
                    <a:pt x="109702" y="499110"/>
                  </a:lnTo>
                  <a:lnTo>
                    <a:pt x="111226" y="502920"/>
                  </a:lnTo>
                  <a:lnTo>
                    <a:pt x="111226" y="504190"/>
                  </a:lnTo>
                  <a:lnTo>
                    <a:pt x="112750" y="505460"/>
                  </a:lnTo>
                  <a:lnTo>
                    <a:pt x="112750" y="506730"/>
                  </a:lnTo>
                  <a:lnTo>
                    <a:pt x="114274" y="510540"/>
                  </a:lnTo>
                  <a:lnTo>
                    <a:pt x="115798" y="511810"/>
                  </a:lnTo>
                  <a:lnTo>
                    <a:pt x="115798" y="513080"/>
                  </a:lnTo>
                  <a:lnTo>
                    <a:pt x="117322" y="514350"/>
                  </a:lnTo>
                  <a:lnTo>
                    <a:pt x="118846" y="518160"/>
                  </a:lnTo>
                  <a:lnTo>
                    <a:pt x="118846" y="519430"/>
                  </a:lnTo>
                  <a:lnTo>
                    <a:pt x="120370" y="520700"/>
                  </a:lnTo>
                  <a:lnTo>
                    <a:pt x="121894" y="523240"/>
                  </a:lnTo>
                  <a:lnTo>
                    <a:pt x="126466" y="528320"/>
                  </a:lnTo>
                  <a:lnTo>
                    <a:pt x="126466" y="529590"/>
                  </a:lnTo>
                  <a:lnTo>
                    <a:pt x="127990" y="533400"/>
                  </a:lnTo>
                  <a:lnTo>
                    <a:pt x="129514" y="534670"/>
                  </a:lnTo>
                  <a:lnTo>
                    <a:pt x="131038" y="537210"/>
                  </a:lnTo>
                  <a:lnTo>
                    <a:pt x="132562" y="538480"/>
                  </a:lnTo>
                  <a:lnTo>
                    <a:pt x="132562" y="541020"/>
                  </a:lnTo>
                  <a:lnTo>
                    <a:pt x="135610" y="543560"/>
                  </a:lnTo>
                  <a:lnTo>
                    <a:pt x="137134" y="546100"/>
                  </a:lnTo>
                  <a:lnTo>
                    <a:pt x="137134" y="548640"/>
                  </a:lnTo>
                  <a:lnTo>
                    <a:pt x="138658" y="549910"/>
                  </a:lnTo>
                  <a:lnTo>
                    <a:pt x="138658" y="552450"/>
                  </a:lnTo>
                  <a:lnTo>
                    <a:pt x="141693" y="556260"/>
                  </a:lnTo>
                  <a:lnTo>
                    <a:pt x="141693" y="557530"/>
                  </a:lnTo>
                  <a:lnTo>
                    <a:pt x="143230" y="560070"/>
                  </a:lnTo>
                  <a:lnTo>
                    <a:pt x="143230" y="563880"/>
                  </a:lnTo>
                  <a:lnTo>
                    <a:pt x="144754" y="565150"/>
                  </a:lnTo>
                  <a:lnTo>
                    <a:pt x="144754" y="568960"/>
                  </a:lnTo>
                  <a:lnTo>
                    <a:pt x="146278" y="571500"/>
                  </a:lnTo>
                  <a:lnTo>
                    <a:pt x="146278" y="575310"/>
                  </a:lnTo>
                  <a:lnTo>
                    <a:pt x="147789" y="576580"/>
                  </a:lnTo>
                  <a:lnTo>
                    <a:pt x="147789" y="584200"/>
                  </a:lnTo>
                  <a:lnTo>
                    <a:pt x="149326" y="588010"/>
                  </a:lnTo>
                  <a:lnTo>
                    <a:pt x="149326" y="596900"/>
                  </a:lnTo>
                  <a:lnTo>
                    <a:pt x="150850" y="598170"/>
                  </a:lnTo>
                  <a:lnTo>
                    <a:pt x="150850" y="604520"/>
                  </a:lnTo>
                  <a:lnTo>
                    <a:pt x="152361" y="605790"/>
                  </a:lnTo>
                  <a:lnTo>
                    <a:pt x="152361" y="613410"/>
                  </a:lnTo>
                  <a:lnTo>
                    <a:pt x="153885" y="614680"/>
                  </a:lnTo>
                  <a:lnTo>
                    <a:pt x="153885" y="621030"/>
                  </a:lnTo>
                  <a:lnTo>
                    <a:pt x="155422" y="624840"/>
                  </a:lnTo>
                  <a:lnTo>
                    <a:pt x="155422" y="628650"/>
                  </a:lnTo>
                  <a:lnTo>
                    <a:pt x="156946" y="632460"/>
                  </a:lnTo>
                  <a:lnTo>
                    <a:pt x="156946" y="641350"/>
                  </a:lnTo>
                  <a:lnTo>
                    <a:pt x="158457" y="642620"/>
                  </a:lnTo>
                  <a:lnTo>
                    <a:pt x="158457" y="659130"/>
                  </a:lnTo>
                  <a:lnTo>
                    <a:pt x="159981" y="660400"/>
                  </a:lnTo>
                  <a:lnTo>
                    <a:pt x="159981" y="668020"/>
                  </a:lnTo>
                  <a:lnTo>
                    <a:pt x="161518" y="670560"/>
                  </a:lnTo>
                  <a:lnTo>
                    <a:pt x="161518" y="681990"/>
                  </a:lnTo>
                  <a:lnTo>
                    <a:pt x="163029" y="683260"/>
                  </a:lnTo>
                  <a:lnTo>
                    <a:pt x="163029" y="697230"/>
                  </a:lnTo>
                  <a:lnTo>
                    <a:pt x="164553" y="698500"/>
                  </a:lnTo>
                  <a:lnTo>
                    <a:pt x="164553" y="788670"/>
                  </a:lnTo>
                  <a:lnTo>
                    <a:pt x="166077" y="789940"/>
                  </a:lnTo>
                  <a:lnTo>
                    <a:pt x="166077" y="800100"/>
                  </a:lnTo>
                  <a:lnTo>
                    <a:pt x="167601" y="801370"/>
                  </a:lnTo>
                  <a:lnTo>
                    <a:pt x="167601" y="831850"/>
                  </a:lnTo>
                  <a:lnTo>
                    <a:pt x="169125" y="833120"/>
                  </a:lnTo>
                  <a:lnTo>
                    <a:pt x="169125" y="834390"/>
                  </a:lnTo>
                  <a:lnTo>
                    <a:pt x="167601" y="835660"/>
                  </a:lnTo>
                  <a:lnTo>
                    <a:pt x="167601" y="869950"/>
                  </a:lnTo>
                  <a:lnTo>
                    <a:pt x="169125" y="871220"/>
                  </a:lnTo>
                  <a:lnTo>
                    <a:pt x="169125" y="891540"/>
                  </a:lnTo>
                  <a:lnTo>
                    <a:pt x="170649" y="894080"/>
                  </a:lnTo>
                  <a:lnTo>
                    <a:pt x="170649" y="906780"/>
                  </a:lnTo>
                  <a:lnTo>
                    <a:pt x="172173" y="909320"/>
                  </a:lnTo>
                  <a:lnTo>
                    <a:pt x="172173" y="970280"/>
                  </a:lnTo>
                  <a:lnTo>
                    <a:pt x="173697" y="971550"/>
                  </a:lnTo>
                  <a:lnTo>
                    <a:pt x="173697" y="989330"/>
                  </a:lnTo>
                  <a:lnTo>
                    <a:pt x="175221" y="989330"/>
                  </a:lnTo>
                  <a:lnTo>
                    <a:pt x="175221" y="953770"/>
                  </a:lnTo>
                  <a:lnTo>
                    <a:pt x="176745" y="952500"/>
                  </a:lnTo>
                  <a:lnTo>
                    <a:pt x="176745" y="906780"/>
                  </a:lnTo>
                  <a:lnTo>
                    <a:pt x="178269" y="904240"/>
                  </a:lnTo>
                  <a:lnTo>
                    <a:pt x="178269" y="885190"/>
                  </a:lnTo>
                  <a:lnTo>
                    <a:pt x="179793" y="883920"/>
                  </a:lnTo>
                  <a:lnTo>
                    <a:pt x="179793" y="812800"/>
                  </a:lnTo>
                  <a:lnTo>
                    <a:pt x="181317" y="811530"/>
                  </a:lnTo>
                  <a:lnTo>
                    <a:pt x="181317" y="801370"/>
                  </a:lnTo>
                  <a:lnTo>
                    <a:pt x="182841" y="800100"/>
                  </a:lnTo>
                  <a:lnTo>
                    <a:pt x="182841" y="782320"/>
                  </a:lnTo>
                  <a:lnTo>
                    <a:pt x="184365" y="781050"/>
                  </a:lnTo>
                  <a:lnTo>
                    <a:pt x="184365" y="748030"/>
                  </a:lnTo>
                  <a:lnTo>
                    <a:pt x="182841" y="746760"/>
                  </a:lnTo>
                  <a:lnTo>
                    <a:pt x="182841" y="709930"/>
                  </a:lnTo>
                  <a:lnTo>
                    <a:pt x="184365" y="706120"/>
                  </a:lnTo>
                  <a:lnTo>
                    <a:pt x="184365" y="690880"/>
                  </a:lnTo>
                  <a:lnTo>
                    <a:pt x="185889" y="689610"/>
                  </a:lnTo>
                  <a:lnTo>
                    <a:pt x="185889" y="683260"/>
                  </a:lnTo>
                  <a:lnTo>
                    <a:pt x="187413" y="681990"/>
                  </a:lnTo>
                  <a:lnTo>
                    <a:pt x="187413" y="670560"/>
                  </a:lnTo>
                  <a:lnTo>
                    <a:pt x="188937" y="668020"/>
                  </a:lnTo>
                  <a:lnTo>
                    <a:pt x="188937" y="652780"/>
                  </a:lnTo>
                  <a:lnTo>
                    <a:pt x="190461" y="650240"/>
                  </a:lnTo>
                  <a:lnTo>
                    <a:pt x="190461" y="642620"/>
                  </a:lnTo>
                  <a:lnTo>
                    <a:pt x="191985" y="641350"/>
                  </a:lnTo>
                  <a:lnTo>
                    <a:pt x="191985" y="632460"/>
                  </a:lnTo>
                  <a:lnTo>
                    <a:pt x="193509" y="628650"/>
                  </a:lnTo>
                  <a:lnTo>
                    <a:pt x="193509" y="619760"/>
                  </a:lnTo>
                  <a:lnTo>
                    <a:pt x="195033" y="618490"/>
                  </a:lnTo>
                  <a:lnTo>
                    <a:pt x="195033" y="612140"/>
                  </a:lnTo>
                  <a:lnTo>
                    <a:pt x="196557" y="610870"/>
                  </a:lnTo>
                  <a:lnTo>
                    <a:pt x="196557" y="604520"/>
                  </a:lnTo>
                  <a:lnTo>
                    <a:pt x="198081" y="603250"/>
                  </a:lnTo>
                  <a:lnTo>
                    <a:pt x="198081" y="594360"/>
                  </a:lnTo>
                  <a:lnTo>
                    <a:pt x="199605" y="591820"/>
                  </a:lnTo>
                  <a:lnTo>
                    <a:pt x="199605" y="582930"/>
                  </a:lnTo>
                  <a:lnTo>
                    <a:pt x="201129" y="580390"/>
                  </a:lnTo>
                  <a:lnTo>
                    <a:pt x="201129" y="575310"/>
                  </a:lnTo>
                  <a:lnTo>
                    <a:pt x="202653" y="574040"/>
                  </a:lnTo>
                  <a:lnTo>
                    <a:pt x="202653" y="567690"/>
                  </a:lnTo>
                  <a:lnTo>
                    <a:pt x="204165" y="565150"/>
                  </a:lnTo>
                  <a:lnTo>
                    <a:pt x="204165" y="563880"/>
                  </a:lnTo>
                  <a:lnTo>
                    <a:pt x="205701" y="561340"/>
                  </a:lnTo>
                  <a:lnTo>
                    <a:pt x="205701" y="560070"/>
                  </a:lnTo>
                  <a:lnTo>
                    <a:pt x="207225" y="557530"/>
                  </a:lnTo>
                  <a:lnTo>
                    <a:pt x="207225" y="556260"/>
                  </a:lnTo>
                  <a:lnTo>
                    <a:pt x="208749" y="553720"/>
                  </a:lnTo>
                  <a:lnTo>
                    <a:pt x="208749" y="552450"/>
                  </a:lnTo>
                  <a:lnTo>
                    <a:pt x="210261" y="549910"/>
                  </a:lnTo>
                  <a:lnTo>
                    <a:pt x="210261" y="548640"/>
                  </a:lnTo>
                  <a:lnTo>
                    <a:pt x="213321" y="543560"/>
                  </a:lnTo>
                  <a:lnTo>
                    <a:pt x="214833" y="542290"/>
                  </a:lnTo>
                  <a:lnTo>
                    <a:pt x="214833" y="541020"/>
                  </a:lnTo>
                  <a:lnTo>
                    <a:pt x="217881" y="537210"/>
                  </a:lnTo>
                  <a:lnTo>
                    <a:pt x="219405" y="534670"/>
                  </a:lnTo>
                  <a:lnTo>
                    <a:pt x="219405" y="533400"/>
                  </a:lnTo>
                  <a:lnTo>
                    <a:pt x="222453" y="529590"/>
                  </a:lnTo>
                  <a:lnTo>
                    <a:pt x="222453" y="528320"/>
                  </a:lnTo>
                  <a:lnTo>
                    <a:pt x="225501" y="525780"/>
                  </a:lnTo>
                  <a:lnTo>
                    <a:pt x="225501" y="523240"/>
                  </a:lnTo>
                  <a:lnTo>
                    <a:pt x="228549" y="520700"/>
                  </a:lnTo>
                  <a:lnTo>
                    <a:pt x="228549" y="519430"/>
                  </a:lnTo>
                  <a:lnTo>
                    <a:pt x="230073" y="518160"/>
                  </a:lnTo>
                  <a:lnTo>
                    <a:pt x="230073" y="514350"/>
                  </a:lnTo>
                  <a:lnTo>
                    <a:pt x="234645" y="510540"/>
                  </a:lnTo>
                  <a:lnTo>
                    <a:pt x="234645" y="506730"/>
                  </a:lnTo>
                  <a:lnTo>
                    <a:pt x="237693" y="504190"/>
                  </a:lnTo>
                  <a:lnTo>
                    <a:pt x="237693" y="502920"/>
                  </a:lnTo>
                  <a:lnTo>
                    <a:pt x="239217" y="499110"/>
                  </a:lnTo>
                  <a:lnTo>
                    <a:pt x="239217" y="497840"/>
                  </a:lnTo>
                  <a:lnTo>
                    <a:pt x="240741" y="496570"/>
                  </a:lnTo>
                  <a:lnTo>
                    <a:pt x="240741" y="492760"/>
                  </a:lnTo>
                  <a:lnTo>
                    <a:pt x="242265" y="491490"/>
                  </a:lnTo>
                  <a:lnTo>
                    <a:pt x="242265" y="490220"/>
                  </a:lnTo>
                  <a:lnTo>
                    <a:pt x="243789" y="488950"/>
                  </a:lnTo>
                  <a:lnTo>
                    <a:pt x="245313" y="485140"/>
                  </a:lnTo>
                  <a:lnTo>
                    <a:pt x="245313" y="483870"/>
                  </a:lnTo>
                  <a:lnTo>
                    <a:pt x="246837" y="482600"/>
                  </a:lnTo>
                  <a:lnTo>
                    <a:pt x="248361" y="480060"/>
                  </a:lnTo>
                  <a:lnTo>
                    <a:pt x="248361" y="477520"/>
                  </a:lnTo>
                  <a:lnTo>
                    <a:pt x="251409" y="474980"/>
                  </a:lnTo>
                  <a:lnTo>
                    <a:pt x="252933" y="472440"/>
                  </a:lnTo>
                  <a:lnTo>
                    <a:pt x="252933" y="469900"/>
                  </a:lnTo>
                  <a:lnTo>
                    <a:pt x="255981" y="467360"/>
                  </a:lnTo>
                  <a:lnTo>
                    <a:pt x="259029" y="462280"/>
                  </a:lnTo>
                  <a:lnTo>
                    <a:pt x="259029" y="461010"/>
                  </a:lnTo>
                  <a:lnTo>
                    <a:pt x="260540" y="458470"/>
                  </a:lnTo>
                  <a:lnTo>
                    <a:pt x="266636" y="452120"/>
                  </a:lnTo>
                  <a:lnTo>
                    <a:pt x="268160" y="449580"/>
                  </a:lnTo>
                  <a:lnTo>
                    <a:pt x="268160" y="447040"/>
                  </a:lnTo>
                  <a:lnTo>
                    <a:pt x="269697" y="444500"/>
                  </a:lnTo>
                  <a:lnTo>
                    <a:pt x="275780" y="438150"/>
                  </a:lnTo>
                  <a:lnTo>
                    <a:pt x="277304" y="435610"/>
                  </a:lnTo>
                  <a:lnTo>
                    <a:pt x="280352" y="431800"/>
                  </a:lnTo>
                  <a:lnTo>
                    <a:pt x="281876" y="429260"/>
                  </a:lnTo>
                  <a:lnTo>
                    <a:pt x="284924" y="427990"/>
                  </a:lnTo>
                  <a:lnTo>
                    <a:pt x="287972" y="424180"/>
                  </a:lnTo>
                  <a:lnTo>
                    <a:pt x="289496" y="421640"/>
                  </a:lnTo>
                  <a:lnTo>
                    <a:pt x="291020" y="420370"/>
                  </a:lnTo>
                  <a:lnTo>
                    <a:pt x="294068" y="419100"/>
                  </a:lnTo>
                  <a:lnTo>
                    <a:pt x="307784" y="405130"/>
                  </a:lnTo>
                  <a:lnTo>
                    <a:pt x="310832" y="403860"/>
                  </a:lnTo>
                  <a:lnTo>
                    <a:pt x="312343" y="400050"/>
                  </a:lnTo>
                  <a:lnTo>
                    <a:pt x="313880" y="398780"/>
                  </a:lnTo>
                  <a:lnTo>
                    <a:pt x="316928" y="397510"/>
                  </a:lnTo>
                  <a:lnTo>
                    <a:pt x="318439" y="393700"/>
                  </a:lnTo>
                  <a:lnTo>
                    <a:pt x="319976" y="392430"/>
                  </a:lnTo>
                  <a:lnTo>
                    <a:pt x="323011" y="391160"/>
                  </a:lnTo>
                  <a:lnTo>
                    <a:pt x="324535" y="389890"/>
                  </a:lnTo>
                  <a:lnTo>
                    <a:pt x="326072" y="386080"/>
                  </a:lnTo>
                  <a:lnTo>
                    <a:pt x="329107" y="384810"/>
                  </a:lnTo>
                  <a:lnTo>
                    <a:pt x="332168" y="382270"/>
                  </a:lnTo>
                  <a:lnTo>
                    <a:pt x="333679" y="378460"/>
                  </a:lnTo>
                  <a:lnTo>
                    <a:pt x="336727" y="375920"/>
                  </a:lnTo>
                  <a:lnTo>
                    <a:pt x="338251" y="373380"/>
                  </a:lnTo>
                  <a:lnTo>
                    <a:pt x="341299" y="369570"/>
                  </a:lnTo>
                  <a:lnTo>
                    <a:pt x="341299" y="368300"/>
                  </a:lnTo>
                  <a:lnTo>
                    <a:pt x="342823" y="367030"/>
                  </a:lnTo>
                  <a:lnTo>
                    <a:pt x="344347" y="363220"/>
                  </a:lnTo>
                  <a:lnTo>
                    <a:pt x="344347" y="361950"/>
                  </a:lnTo>
                  <a:lnTo>
                    <a:pt x="345871" y="359410"/>
                  </a:lnTo>
                  <a:lnTo>
                    <a:pt x="345871" y="358140"/>
                  </a:lnTo>
                  <a:lnTo>
                    <a:pt x="347395" y="355600"/>
                  </a:lnTo>
                  <a:lnTo>
                    <a:pt x="347395" y="336550"/>
                  </a:lnTo>
                  <a:lnTo>
                    <a:pt x="345871" y="335280"/>
                  </a:lnTo>
                  <a:lnTo>
                    <a:pt x="345871" y="331470"/>
                  </a:lnTo>
                  <a:lnTo>
                    <a:pt x="344347" y="328930"/>
                  </a:lnTo>
                  <a:lnTo>
                    <a:pt x="344347" y="325120"/>
                  </a:lnTo>
                  <a:lnTo>
                    <a:pt x="342823" y="322580"/>
                  </a:lnTo>
                  <a:lnTo>
                    <a:pt x="341299" y="321310"/>
                  </a:lnTo>
                  <a:lnTo>
                    <a:pt x="341299" y="320040"/>
                  </a:lnTo>
                  <a:lnTo>
                    <a:pt x="339775" y="317500"/>
                  </a:lnTo>
                  <a:lnTo>
                    <a:pt x="339775" y="314960"/>
                  </a:lnTo>
                  <a:lnTo>
                    <a:pt x="336727" y="312420"/>
                  </a:lnTo>
                  <a:lnTo>
                    <a:pt x="335203" y="308610"/>
                  </a:lnTo>
                  <a:lnTo>
                    <a:pt x="335203" y="307340"/>
                  </a:lnTo>
                  <a:lnTo>
                    <a:pt x="332168" y="304800"/>
                  </a:lnTo>
                  <a:lnTo>
                    <a:pt x="330631" y="300990"/>
                  </a:lnTo>
                  <a:lnTo>
                    <a:pt x="330631" y="299720"/>
                  </a:lnTo>
                  <a:lnTo>
                    <a:pt x="327583" y="297180"/>
                  </a:lnTo>
                  <a:lnTo>
                    <a:pt x="326072" y="293370"/>
                  </a:lnTo>
                  <a:lnTo>
                    <a:pt x="323011" y="290830"/>
                  </a:lnTo>
                  <a:lnTo>
                    <a:pt x="321500" y="287020"/>
                  </a:lnTo>
                  <a:lnTo>
                    <a:pt x="319976" y="285750"/>
                  </a:lnTo>
                  <a:lnTo>
                    <a:pt x="316928" y="284480"/>
                  </a:lnTo>
                  <a:lnTo>
                    <a:pt x="309308" y="276860"/>
                  </a:lnTo>
                  <a:lnTo>
                    <a:pt x="306260" y="275590"/>
                  </a:lnTo>
                  <a:lnTo>
                    <a:pt x="304736" y="271780"/>
                  </a:lnTo>
                  <a:lnTo>
                    <a:pt x="295592" y="267970"/>
                  </a:lnTo>
                  <a:lnTo>
                    <a:pt x="292544" y="264160"/>
                  </a:lnTo>
                  <a:lnTo>
                    <a:pt x="286448" y="261620"/>
                  </a:lnTo>
                  <a:lnTo>
                    <a:pt x="283400" y="259080"/>
                  </a:lnTo>
                  <a:lnTo>
                    <a:pt x="274256" y="254000"/>
                  </a:lnTo>
                  <a:lnTo>
                    <a:pt x="271208" y="251460"/>
                  </a:lnTo>
                  <a:lnTo>
                    <a:pt x="262064" y="246380"/>
                  </a:lnTo>
                  <a:lnTo>
                    <a:pt x="251409" y="237490"/>
                  </a:lnTo>
                  <a:lnTo>
                    <a:pt x="245313" y="233680"/>
                  </a:lnTo>
                  <a:lnTo>
                    <a:pt x="243789" y="232410"/>
                  </a:lnTo>
                  <a:lnTo>
                    <a:pt x="240741" y="231140"/>
                  </a:lnTo>
                  <a:lnTo>
                    <a:pt x="239217" y="228600"/>
                  </a:lnTo>
                  <a:lnTo>
                    <a:pt x="236169" y="226060"/>
                  </a:lnTo>
                  <a:lnTo>
                    <a:pt x="234645" y="223520"/>
                  </a:lnTo>
                  <a:lnTo>
                    <a:pt x="231597" y="222250"/>
                  </a:lnTo>
                  <a:lnTo>
                    <a:pt x="228549" y="218440"/>
                  </a:lnTo>
                  <a:lnTo>
                    <a:pt x="225501" y="217170"/>
                  </a:lnTo>
                  <a:lnTo>
                    <a:pt x="223977" y="214630"/>
                  </a:lnTo>
                  <a:lnTo>
                    <a:pt x="220929" y="210820"/>
                  </a:lnTo>
                  <a:lnTo>
                    <a:pt x="219405" y="208280"/>
                  </a:lnTo>
                  <a:lnTo>
                    <a:pt x="214833" y="203200"/>
                  </a:lnTo>
                  <a:lnTo>
                    <a:pt x="213321" y="200660"/>
                  </a:lnTo>
                  <a:lnTo>
                    <a:pt x="208749" y="195580"/>
                  </a:lnTo>
                  <a:lnTo>
                    <a:pt x="207225" y="193040"/>
                  </a:lnTo>
                  <a:lnTo>
                    <a:pt x="207225" y="191770"/>
                  </a:lnTo>
                  <a:lnTo>
                    <a:pt x="204165" y="190500"/>
                  </a:lnTo>
                  <a:lnTo>
                    <a:pt x="204165" y="186690"/>
                  </a:lnTo>
                  <a:lnTo>
                    <a:pt x="199605" y="182880"/>
                  </a:lnTo>
                  <a:lnTo>
                    <a:pt x="199605" y="179070"/>
                  </a:lnTo>
                  <a:lnTo>
                    <a:pt x="196557" y="176530"/>
                  </a:lnTo>
                  <a:lnTo>
                    <a:pt x="196557" y="172720"/>
                  </a:lnTo>
                  <a:lnTo>
                    <a:pt x="193509" y="170180"/>
                  </a:lnTo>
                  <a:lnTo>
                    <a:pt x="193509" y="168910"/>
                  </a:lnTo>
                  <a:lnTo>
                    <a:pt x="191985" y="165100"/>
                  </a:lnTo>
                  <a:lnTo>
                    <a:pt x="191985" y="163830"/>
                  </a:lnTo>
                  <a:lnTo>
                    <a:pt x="188937" y="161290"/>
                  </a:lnTo>
                  <a:lnTo>
                    <a:pt x="188937" y="157480"/>
                  </a:lnTo>
                  <a:lnTo>
                    <a:pt x="187413" y="156210"/>
                  </a:lnTo>
                  <a:lnTo>
                    <a:pt x="187413" y="154940"/>
                  </a:lnTo>
                  <a:lnTo>
                    <a:pt x="184365" y="149860"/>
                  </a:lnTo>
                  <a:lnTo>
                    <a:pt x="184365" y="147320"/>
                  </a:lnTo>
                  <a:lnTo>
                    <a:pt x="182841" y="146050"/>
                  </a:lnTo>
                  <a:lnTo>
                    <a:pt x="182841" y="140970"/>
                  </a:lnTo>
                  <a:lnTo>
                    <a:pt x="181317" y="139700"/>
                  </a:lnTo>
                  <a:lnTo>
                    <a:pt x="181317" y="137160"/>
                  </a:lnTo>
                  <a:lnTo>
                    <a:pt x="179793" y="134620"/>
                  </a:lnTo>
                  <a:lnTo>
                    <a:pt x="179793" y="129540"/>
                  </a:lnTo>
                  <a:lnTo>
                    <a:pt x="178269" y="127000"/>
                  </a:lnTo>
                  <a:lnTo>
                    <a:pt x="178269" y="121920"/>
                  </a:lnTo>
                  <a:lnTo>
                    <a:pt x="176745" y="119380"/>
                  </a:lnTo>
                  <a:lnTo>
                    <a:pt x="176745" y="106680"/>
                  </a:lnTo>
                  <a:lnTo>
                    <a:pt x="175221" y="104140"/>
                  </a:lnTo>
                  <a:lnTo>
                    <a:pt x="175221" y="86360"/>
                  </a:lnTo>
                  <a:lnTo>
                    <a:pt x="173697" y="85090"/>
                  </a:lnTo>
                  <a:close/>
                </a:path>
                <a:path w="347979" h="989329">
                  <a:moveTo>
                    <a:pt x="175221" y="0"/>
                  </a:moveTo>
                  <a:lnTo>
                    <a:pt x="173697" y="0"/>
                  </a:lnTo>
                  <a:lnTo>
                    <a:pt x="173697" y="15240"/>
                  </a:lnTo>
                  <a:lnTo>
                    <a:pt x="175221" y="12700"/>
                  </a:lnTo>
                  <a:lnTo>
                    <a:pt x="175221" y="0"/>
                  </a:lnTo>
                  <a:close/>
                </a:path>
              </a:pathLst>
            </a:custGeom>
            <a:solidFill>
              <a:srgbClr val="C67B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3" name="object 53"/>
            <p:cNvSpPr/>
            <p:nvPr/>
          </p:nvSpPr>
          <p:spPr>
            <a:xfrm>
              <a:off x="2970730" y="5861946"/>
              <a:ext cx="347980" cy="990600"/>
            </a:xfrm>
            <a:custGeom>
              <a:avLst/>
              <a:gdLst/>
              <a:ahLst/>
              <a:cxnLst/>
              <a:rect l="l" t="t" r="r" b="b"/>
              <a:pathLst>
                <a:path w="347979" h="990600">
                  <a:moveTo>
                    <a:pt x="173697" y="990434"/>
                  </a:moveTo>
                  <a:lnTo>
                    <a:pt x="173697" y="988923"/>
                  </a:lnTo>
                  <a:lnTo>
                    <a:pt x="173697" y="972159"/>
                  </a:lnTo>
                  <a:lnTo>
                    <a:pt x="172173" y="970622"/>
                  </a:lnTo>
                  <a:lnTo>
                    <a:pt x="172173" y="909688"/>
                  </a:lnTo>
                  <a:lnTo>
                    <a:pt x="170649" y="906627"/>
                  </a:lnTo>
                  <a:lnTo>
                    <a:pt x="170649" y="894435"/>
                  </a:lnTo>
                  <a:lnTo>
                    <a:pt x="169125" y="891387"/>
                  </a:lnTo>
                  <a:lnTo>
                    <a:pt x="169125" y="871588"/>
                  </a:lnTo>
                  <a:lnTo>
                    <a:pt x="167601" y="870051"/>
                  </a:lnTo>
                  <a:lnTo>
                    <a:pt x="167601" y="836548"/>
                  </a:lnTo>
                  <a:lnTo>
                    <a:pt x="169125" y="835025"/>
                  </a:lnTo>
                  <a:lnTo>
                    <a:pt x="169125" y="833501"/>
                  </a:lnTo>
                  <a:lnTo>
                    <a:pt x="167601" y="831964"/>
                  </a:lnTo>
                  <a:lnTo>
                    <a:pt x="167601" y="828916"/>
                  </a:lnTo>
                  <a:lnTo>
                    <a:pt x="167601" y="801496"/>
                  </a:lnTo>
                  <a:lnTo>
                    <a:pt x="166077" y="799972"/>
                  </a:lnTo>
                  <a:lnTo>
                    <a:pt x="166077" y="790829"/>
                  </a:lnTo>
                  <a:lnTo>
                    <a:pt x="164553" y="789304"/>
                  </a:lnTo>
                  <a:lnTo>
                    <a:pt x="164553" y="699401"/>
                  </a:lnTo>
                  <a:lnTo>
                    <a:pt x="163029" y="697877"/>
                  </a:lnTo>
                  <a:lnTo>
                    <a:pt x="163029" y="684161"/>
                  </a:lnTo>
                  <a:lnTo>
                    <a:pt x="161518" y="682637"/>
                  </a:lnTo>
                  <a:lnTo>
                    <a:pt x="161518" y="670458"/>
                  </a:lnTo>
                  <a:lnTo>
                    <a:pt x="159981" y="668934"/>
                  </a:lnTo>
                  <a:lnTo>
                    <a:pt x="159981" y="665873"/>
                  </a:lnTo>
                  <a:lnTo>
                    <a:pt x="159981" y="664349"/>
                  </a:lnTo>
                  <a:lnTo>
                    <a:pt x="159981" y="662825"/>
                  </a:lnTo>
                  <a:lnTo>
                    <a:pt x="159981" y="661301"/>
                  </a:lnTo>
                  <a:lnTo>
                    <a:pt x="158457" y="659790"/>
                  </a:lnTo>
                  <a:lnTo>
                    <a:pt x="158457" y="643026"/>
                  </a:lnTo>
                  <a:lnTo>
                    <a:pt x="156946" y="641489"/>
                  </a:lnTo>
                  <a:lnTo>
                    <a:pt x="156946" y="632358"/>
                  </a:lnTo>
                  <a:lnTo>
                    <a:pt x="155422" y="629297"/>
                  </a:lnTo>
                  <a:lnTo>
                    <a:pt x="155422" y="627786"/>
                  </a:lnTo>
                  <a:lnTo>
                    <a:pt x="155422" y="626262"/>
                  </a:lnTo>
                  <a:lnTo>
                    <a:pt x="155422" y="624738"/>
                  </a:lnTo>
                  <a:lnTo>
                    <a:pt x="153885" y="621690"/>
                  </a:lnTo>
                  <a:lnTo>
                    <a:pt x="153885" y="620166"/>
                  </a:lnTo>
                  <a:lnTo>
                    <a:pt x="153885" y="618642"/>
                  </a:lnTo>
                  <a:lnTo>
                    <a:pt x="153885" y="615594"/>
                  </a:lnTo>
                  <a:lnTo>
                    <a:pt x="152361" y="614070"/>
                  </a:lnTo>
                  <a:lnTo>
                    <a:pt x="152361" y="612546"/>
                  </a:lnTo>
                  <a:lnTo>
                    <a:pt x="152361" y="611022"/>
                  </a:lnTo>
                  <a:lnTo>
                    <a:pt x="152361" y="607974"/>
                  </a:lnTo>
                  <a:lnTo>
                    <a:pt x="152361" y="606450"/>
                  </a:lnTo>
                  <a:lnTo>
                    <a:pt x="150850" y="604939"/>
                  </a:lnTo>
                  <a:lnTo>
                    <a:pt x="150850" y="603402"/>
                  </a:lnTo>
                  <a:lnTo>
                    <a:pt x="150850" y="600354"/>
                  </a:lnTo>
                  <a:lnTo>
                    <a:pt x="150850" y="598830"/>
                  </a:lnTo>
                  <a:lnTo>
                    <a:pt x="149326" y="597306"/>
                  </a:lnTo>
                  <a:lnTo>
                    <a:pt x="149326" y="588162"/>
                  </a:lnTo>
                  <a:lnTo>
                    <a:pt x="147789" y="585114"/>
                  </a:lnTo>
                  <a:lnTo>
                    <a:pt x="147789" y="583603"/>
                  </a:lnTo>
                  <a:lnTo>
                    <a:pt x="147789" y="580555"/>
                  </a:lnTo>
                  <a:lnTo>
                    <a:pt x="147789" y="579018"/>
                  </a:lnTo>
                  <a:lnTo>
                    <a:pt x="147789" y="577494"/>
                  </a:lnTo>
                  <a:lnTo>
                    <a:pt x="146278" y="575970"/>
                  </a:lnTo>
                  <a:lnTo>
                    <a:pt x="146278" y="574446"/>
                  </a:lnTo>
                  <a:lnTo>
                    <a:pt x="146278" y="571411"/>
                  </a:lnTo>
                  <a:lnTo>
                    <a:pt x="144754" y="569887"/>
                  </a:lnTo>
                  <a:lnTo>
                    <a:pt x="144754" y="568363"/>
                  </a:lnTo>
                  <a:lnTo>
                    <a:pt x="144754" y="565302"/>
                  </a:lnTo>
                  <a:lnTo>
                    <a:pt x="143230" y="563778"/>
                  </a:lnTo>
                  <a:lnTo>
                    <a:pt x="143230" y="562254"/>
                  </a:lnTo>
                  <a:lnTo>
                    <a:pt x="143230" y="560743"/>
                  </a:lnTo>
                  <a:lnTo>
                    <a:pt x="141693" y="557695"/>
                  </a:lnTo>
                  <a:lnTo>
                    <a:pt x="141693" y="556171"/>
                  </a:lnTo>
                  <a:lnTo>
                    <a:pt x="140182" y="554647"/>
                  </a:lnTo>
                  <a:lnTo>
                    <a:pt x="138658" y="553110"/>
                  </a:lnTo>
                  <a:lnTo>
                    <a:pt x="138658" y="550075"/>
                  </a:lnTo>
                  <a:lnTo>
                    <a:pt x="137134" y="548551"/>
                  </a:lnTo>
                  <a:lnTo>
                    <a:pt x="137134" y="547027"/>
                  </a:lnTo>
                  <a:lnTo>
                    <a:pt x="135610" y="543979"/>
                  </a:lnTo>
                  <a:lnTo>
                    <a:pt x="134086" y="542455"/>
                  </a:lnTo>
                  <a:lnTo>
                    <a:pt x="132562" y="540918"/>
                  </a:lnTo>
                  <a:lnTo>
                    <a:pt x="132562" y="539407"/>
                  </a:lnTo>
                  <a:lnTo>
                    <a:pt x="131038" y="537883"/>
                  </a:lnTo>
                  <a:lnTo>
                    <a:pt x="129514" y="534835"/>
                  </a:lnTo>
                  <a:lnTo>
                    <a:pt x="127990" y="533311"/>
                  </a:lnTo>
                  <a:lnTo>
                    <a:pt x="126466" y="530263"/>
                  </a:lnTo>
                  <a:lnTo>
                    <a:pt x="126466" y="528739"/>
                  </a:lnTo>
                  <a:lnTo>
                    <a:pt x="124942" y="527215"/>
                  </a:lnTo>
                  <a:lnTo>
                    <a:pt x="123418" y="525691"/>
                  </a:lnTo>
                  <a:lnTo>
                    <a:pt x="121894" y="524167"/>
                  </a:lnTo>
                  <a:lnTo>
                    <a:pt x="120370" y="521119"/>
                  </a:lnTo>
                  <a:lnTo>
                    <a:pt x="118846" y="519595"/>
                  </a:lnTo>
                  <a:lnTo>
                    <a:pt x="118846" y="518083"/>
                  </a:lnTo>
                  <a:lnTo>
                    <a:pt x="117322" y="515023"/>
                  </a:lnTo>
                  <a:lnTo>
                    <a:pt x="115798" y="513499"/>
                  </a:lnTo>
                  <a:lnTo>
                    <a:pt x="115798" y="511975"/>
                  </a:lnTo>
                  <a:lnTo>
                    <a:pt x="114274" y="510451"/>
                  </a:lnTo>
                  <a:lnTo>
                    <a:pt x="112750" y="507403"/>
                  </a:lnTo>
                  <a:lnTo>
                    <a:pt x="112750" y="505891"/>
                  </a:lnTo>
                  <a:lnTo>
                    <a:pt x="111226" y="504367"/>
                  </a:lnTo>
                  <a:lnTo>
                    <a:pt x="111226" y="502831"/>
                  </a:lnTo>
                  <a:lnTo>
                    <a:pt x="109702" y="499783"/>
                  </a:lnTo>
                  <a:lnTo>
                    <a:pt x="109702" y="498259"/>
                  </a:lnTo>
                  <a:lnTo>
                    <a:pt x="108178" y="496735"/>
                  </a:lnTo>
                  <a:lnTo>
                    <a:pt x="108178" y="493699"/>
                  </a:lnTo>
                  <a:lnTo>
                    <a:pt x="106654" y="492175"/>
                  </a:lnTo>
                  <a:lnTo>
                    <a:pt x="106654" y="490639"/>
                  </a:lnTo>
                  <a:lnTo>
                    <a:pt x="105143" y="489115"/>
                  </a:lnTo>
                  <a:lnTo>
                    <a:pt x="103606" y="486067"/>
                  </a:lnTo>
                  <a:lnTo>
                    <a:pt x="102082" y="484555"/>
                  </a:lnTo>
                  <a:lnTo>
                    <a:pt x="102082" y="483031"/>
                  </a:lnTo>
                  <a:lnTo>
                    <a:pt x="100558" y="479983"/>
                  </a:lnTo>
                  <a:lnTo>
                    <a:pt x="99047" y="478459"/>
                  </a:lnTo>
                  <a:lnTo>
                    <a:pt x="99047" y="476923"/>
                  </a:lnTo>
                  <a:lnTo>
                    <a:pt x="97510" y="475399"/>
                  </a:lnTo>
                  <a:lnTo>
                    <a:pt x="95986" y="472363"/>
                  </a:lnTo>
                  <a:lnTo>
                    <a:pt x="95986" y="470839"/>
                  </a:lnTo>
                  <a:lnTo>
                    <a:pt x="92951" y="469315"/>
                  </a:lnTo>
                  <a:lnTo>
                    <a:pt x="92951" y="467791"/>
                  </a:lnTo>
                  <a:lnTo>
                    <a:pt x="91414" y="464731"/>
                  </a:lnTo>
                  <a:lnTo>
                    <a:pt x="89890" y="463207"/>
                  </a:lnTo>
                  <a:lnTo>
                    <a:pt x="88379" y="461695"/>
                  </a:lnTo>
                  <a:lnTo>
                    <a:pt x="86855" y="458647"/>
                  </a:lnTo>
                  <a:lnTo>
                    <a:pt x="86855" y="457123"/>
                  </a:lnTo>
                  <a:lnTo>
                    <a:pt x="85331" y="455599"/>
                  </a:lnTo>
                  <a:lnTo>
                    <a:pt x="83807" y="454075"/>
                  </a:lnTo>
                  <a:lnTo>
                    <a:pt x="82283" y="452539"/>
                  </a:lnTo>
                  <a:lnTo>
                    <a:pt x="80759" y="449503"/>
                  </a:lnTo>
                  <a:lnTo>
                    <a:pt x="80759" y="447979"/>
                  </a:lnTo>
                  <a:lnTo>
                    <a:pt x="77711" y="444931"/>
                  </a:lnTo>
                  <a:lnTo>
                    <a:pt x="77711" y="443407"/>
                  </a:lnTo>
                  <a:lnTo>
                    <a:pt x="76187" y="441883"/>
                  </a:lnTo>
                  <a:lnTo>
                    <a:pt x="74663" y="440359"/>
                  </a:lnTo>
                  <a:lnTo>
                    <a:pt x="73139" y="438835"/>
                  </a:lnTo>
                  <a:lnTo>
                    <a:pt x="71615" y="435787"/>
                  </a:lnTo>
                  <a:lnTo>
                    <a:pt x="68567" y="434263"/>
                  </a:lnTo>
                  <a:lnTo>
                    <a:pt x="67043" y="432739"/>
                  </a:lnTo>
                  <a:lnTo>
                    <a:pt x="65519" y="429704"/>
                  </a:lnTo>
                  <a:lnTo>
                    <a:pt x="63995" y="428180"/>
                  </a:lnTo>
                  <a:lnTo>
                    <a:pt x="62471" y="426643"/>
                  </a:lnTo>
                  <a:lnTo>
                    <a:pt x="60947" y="425119"/>
                  </a:lnTo>
                  <a:lnTo>
                    <a:pt x="57899" y="422071"/>
                  </a:lnTo>
                  <a:lnTo>
                    <a:pt x="56375" y="420547"/>
                  </a:lnTo>
                  <a:lnTo>
                    <a:pt x="54851" y="419036"/>
                  </a:lnTo>
                  <a:lnTo>
                    <a:pt x="53327" y="417512"/>
                  </a:lnTo>
                  <a:lnTo>
                    <a:pt x="50279" y="414451"/>
                  </a:lnTo>
                  <a:lnTo>
                    <a:pt x="48755" y="412927"/>
                  </a:lnTo>
                  <a:lnTo>
                    <a:pt x="47231" y="411403"/>
                  </a:lnTo>
                  <a:lnTo>
                    <a:pt x="44183" y="408368"/>
                  </a:lnTo>
                  <a:lnTo>
                    <a:pt x="42671" y="406844"/>
                  </a:lnTo>
                  <a:lnTo>
                    <a:pt x="41135" y="405320"/>
                  </a:lnTo>
                  <a:lnTo>
                    <a:pt x="38087" y="403796"/>
                  </a:lnTo>
                  <a:lnTo>
                    <a:pt x="36575" y="400735"/>
                  </a:lnTo>
                  <a:lnTo>
                    <a:pt x="33515" y="399211"/>
                  </a:lnTo>
                  <a:lnTo>
                    <a:pt x="32003" y="397687"/>
                  </a:lnTo>
                  <a:lnTo>
                    <a:pt x="30479" y="394652"/>
                  </a:lnTo>
                  <a:lnTo>
                    <a:pt x="27431" y="393128"/>
                  </a:lnTo>
                  <a:lnTo>
                    <a:pt x="25907" y="391604"/>
                  </a:lnTo>
                  <a:lnTo>
                    <a:pt x="24383" y="390080"/>
                  </a:lnTo>
                  <a:lnTo>
                    <a:pt x="21335" y="387019"/>
                  </a:lnTo>
                  <a:lnTo>
                    <a:pt x="19811" y="385508"/>
                  </a:lnTo>
                  <a:lnTo>
                    <a:pt x="18287" y="383984"/>
                  </a:lnTo>
                  <a:lnTo>
                    <a:pt x="16763" y="382460"/>
                  </a:lnTo>
                  <a:lnTo>
                    <a:pt x="15239" y="379412"/>
                  </a:lnTo>
                  <a:lnTo>
                    <a:pt x="13715" y="377888"/>
                  </a:lnTo>
                  <a:lnTo>
                    <a:pt x="12191" y="376351"/>
                  </a:lnTo>
                  <a:lnTo>
                    <a:pt x="10667" y="373316"/>
                  </a:lnTo>
                  <a:lnTo>
                    <a:pt x="9143" y="371792"/>
                  </a:lnTo>
                  <a:lnTo>
                    <a:pt x="7619" y="370268"/>
                  </a:lnTo>
                  <a:lnTo>
                    <a:pt x="6095" y="368744"/>
                  </a:lnTo>
                  <a:lnTo>
                    <a:pt x="6095" y="367220"/>
                  </a:lnTo>
                  <a:lnTo>
                    <a:pt x="4571" y="364172"/>
                  </a:lnTo>
                  <a:lnTo>
                    <a:pt x="4571" y="362648"/>
                  </a:lnTo>
                  <a:lnTo>
                    <a:pt x="3047" y="359600"/>
                  </a:lnTo>
                  <a:lnTo>
                    <a:pt x="1523" y="358076"/>
                  </a:lnTo>
                  <a:lnTo>
                    <a:pt x="1523" y="356552"/>
                  </a:lnTo>
                  <a:lnTo>
                    <a:pt x="1523" y="355028"/>
                  </a:lnTo>
                  <a:lnTo>
                    <a:pt x="1523" y="353504"/>
                  </a:lnTo>
                  <a:lnTo>
                    <a:pt x="0" y="350456"/>
                  </a:lnTo>
                  <a:lnTo>
                    <a:pt x="0" y="341325"/>
                  </a:lnTo>
                  <a:lnTo>
                    <a:pt x="1523" y="339801"/>
                  </a:lnTo>
                  <a:lnTo>
                    <a:pt x="1523" y="336740"/>
                  </a:lnTo>
                  <a:lnTo>
                    <a:pt x="1523" y="335216"/>
                  </a:lnTo>
                  <a:lnTo>
                    <a:pt x="1523" y="333692"/>
                  </a:lnTo>
                  <a:lnTo>
                    <a:pt x="3047" y="332168"/>
                  </a:lnTo>
                  <a:lnTo>
                    <a:pt x="3047" y="329133"/>
                  </a:lnTo>
                  <a:lnTo>
                    <a:pt x="4571" y="327609"/>
                  </a:lnTo>
                  <a:lnTo>
                    <a:pt x="4571" y="326072"/>
                  </a:lnTo>
                  <a:lnTo>
                    <a:pt x="6095" y="323024"/>
                  </a:lnTo>
                  <a:lnTo>
                    <a:pt x="6095" y="321500"/>
                  </a:lnTo>
                  <a:lnTo>
                    <a:pt x="7619" y="319989"/>
                  </a:lnTo>
                  <a:lnTo>
                    <a:pt x="7619" y="318465"/>
                  </a:lnTo>
                  <a:lnTo>
                    <a:pt x="9143" y="315417"/>
                  </a:lnTo>
                  <a:lnTo>
                    <a:pt x="10667" y="313893"/>
                  </a:lnTo>
                  <a:lnTo>
                    <a:pt x="12191" y="312356"/>
                  </a:lnTo>
                  <a:lnTo>
                    <a:pt x="12191" y="309321"/>
                  </a:lnTo>
                  <a:lnTo>
                    <a:pt x="13715" y="307797"/>
                  </a:lnTo>
                  <a:lnTo>
                    <a:pt x="15239" y="306273"/>
                  </a:lnTo>
                  <a:lnTo>
                    <a:pt x="15239" y="304749"/>
                  </a:lnTo>
                  <a:lnTo>
                    <a:pt x="16763" y="301701"/>
                  </a:lnTo>
                  <a:lnTo>
                    <a:pt x="18287" y="300164"/>
                  </a:lnTo>
                  <a:lnTo>
                    <a:pt x="19811" y="298653"/>
                  </a:lnTo>
                  <a:lnTo>
                    <a:pt x="21335" y="297129"/>
                  </a:lnTo>
                  <a:lnTo>
                    <a:pt x="22859" y="294081"/>
                  </a:lnTo>
                  <a:lnTo>
                    <a:pt x="22859" y="292557"/>
                  </a:lnTo>
                  <a:lnTo>
                    <a:pt x="25907" y="291033"/>
                  </a:lnTo>
                  <a:lnTo>
                    <a:pt x="27431" y="287972"/>
                  </a:lnTo>
                  <a:lnTo>
                    <a:pt x="28955" y="286461"/>
                  </a:lnTo>
                  <a:lnTo>
                    <a:pt x="30479" y="284937"/>
                  </a:lnTo>
                  <a:lnTo>
                    <a:pt x="32003" y="283413"/>
                  </a:lnTo>
                  <a:lnTo>
                    <a:pt x="35051" y="281889"/>
                  </a:lnTo>
                  <a:lnTo>
                    <a:pt x="36575" y="278841"/>
                  </a:lnTo>
                  <a:lnTo>
                    <a:pt x="39611" y="277317"/>
                  </a:lnTo>
                  <a:lnTo>
                    <a:pt x="41135" y="275793"/>
                  </a:lnTo>
                  <a:lnTo>
                    <a:pt x="44183" y="272745"/>
                  </a:lnTo>
                  <a:lnTo>
                    <a:pt x="47231" y="271221"/>
                  </a:lnTo>
                  <a:lnTo>
                    <a:pt x="50279" y="269697"/>
                  </a:lnTo>
                  <a:lnTo>
                    <a:pt x="53327" y="268173"/>
                  </a:lnTo>
                  <a:lnTo>
                    <a:pt x="56375" y="265137"/>
                  </a:lnTo>
                  <a:lnTo>
                    <a:pt x="57899" y="263613"/>
                  </a:lnTo>
                  <a:lnTo>
                    <a:pt x="62471" y="262077"/>
                  </a:lnTo>
                  <a:lnTo>
                    <a:pt x="65519" y="259029"/>
                  </a:lnTo>
                  <a:lnTo>
                    <a:pt x="67043" y="257505"/>
                  </a:lnTo>
                  <a:lnTo>
                    <a:pt x="71615" y="255981"/>
                  </a:lnTo>
                  <a:lnTo>
                    <a:pt x="73139" y="254469"/>
                  </a:lnTo>
                  <a:lnTo>
                    <a:pt x="77711" y="251421"/>
                  </a:lnTo>
                  <a:lnTo>
                    <a:pt x="80759" y="249885"/>
                  </a:lnTo>
                  <a:lnTo>
                    <a:pt x="82283" y="248361"/>
                  </a:lnTo>
                  <a:lnTo>
                    <a:pt x="86855" y="246837"/>
                  </a:lnTo>
                  <a:lnTo>
                    <a:pt x="88379" y="243789"/>
                  </a:lnTo>
                  <a:lnTo>
                    <a:pt x="91414" y="242277"/>
                  </a:lnTo>
                  <a:lnTo>
                    <a:pt x="94475" y="240753"/>
                  </a:lnTo>
                  <a:lnTo>
                    <a:pt x="97510" y="237693"/>
                  </a:lnTo>
                  <a:lnTo>
                    <a:pt x="99047" y="236169"/>
                  </a:lnTo>
                  <a:lnTo>
                    <a:pt x="102082" y="234645"/>
                  </a:lnTo>
                  <a:lnTo>
                    <a:pt x="105143" y="233121"/>
                  </a:lnTo>
                  <a:lnTo>
                    <a:pt x="106654" y="231609"/>
                  </a:lnTo>
                  <a:lnTo>
                    <a:pt x="109702" y="228561"/>
                  </a:lnTo>
                  <a:lnTo>
                    <a:pt x="112750" y="227037"/>
                  </a:lnTo>
                  <a:lnTo>
                    <a:pt x="114274" y="223977"/>
                  </a:lnTo>
                  <a:lnTo>
                    <a:pt x="115798" y="222453"/>
                  </a:lnTo>
                  <a:lnTo>
                    <a:pt x="118846" y="220941"/>
                  </a:lnTo>
                  <a:lnTo>
                    <a:pt x="120370" y="219417"/>
                  </a:lnTo>
                  <a:lnTo>
                    <a:pt x="121894" y="217893"/>
                  </a:lnTo>
                  <a:lnTo>
                    <a:pt x="123418" y="214845"/>
                  </a:lnTo>
                  <a:lnTo>
                    <a:pt x="126466" y="213321"/>
                  </a:lnTo>
                  <a:lnTo>
                    <a:pt x="127990" y="211785"/>
                  </a:lnTo>
                  <a:lnTo>
                    <a:pt x="129514" y="208749"/>
                  </a:lnTo>
                  <a:lnTo>
                    <a:pt x="131038" y="207225"/>
                  </a:lnTo>
                  <a:lnTo>
                    <a:pt x="132562" y="205701"/>
                  </a:lnTo>
                  <a:lnTo>
                    <a:pt x="134086" y="204177"/>
                  </a:lnTo>
                  <a:lnTo>
                    <a:pt x="135610" y="201129"/>
                  </a:lnTo>
                  <a:lnTo>
                    <a:pt x="137134" y="199605"/>
                  </a:lnTo>
                  <a:lnTo>
                    <a:pt x="138658" y="198081"/>
                  </a:lnTo>
                  <a:lnTo>
                    <a:pt x="140182" y="196557"/>
                  </a:lnTo>
                  <a:lnTo>
                    <a:pt x="141693" y="193509"/>
                  </a:lnTo>
                  <a:lnTo>
                    <a:pt x="141693" y="191985"/>
                  </a:lnTo>
                  <a:lnTo>
                    <a:pt x="143230" y="190461"/>
                  </a:lnTo>
                  <a:lnTo>
                    <a:pt x="144754" y="187426"/>
                  </a:lnTo>
                  <a:lnTo>
                    <a:pt x="146278" y="185889"/>
                  </a:lnTo>
                  <a:lnTo>
                    <a:pt x="147789" y="184365"/>
                  </a:lnTo>
                  <a:lnTo>
                    <a:pt x="147789" y="182841"/>
                  </a:lnTo>
                  <a:lnTo>
                    <a:pt x="149326" y="179793"/>
                  </a:lnTo>
                  <a:lnTo>
                    <a:pt x="149326" y="178269"/>
                  </a:lnTo>
                  <a:lnTo>
                    <a:pt x="150850" y="176758"/>
                  </a:lnTo>
                  <a:lnTo>
                    <a:pt x="152361" y="173697"/>
                  </a:lnTo>
                  <a:lnTo>
                    <a:pt x="153885" y="172173"/>
                  </a:lnTo>
                  <a:lnTo>
                    <a:pt x="153885" y="170649"/>
                  </a:lnTo>
                  <a:lnTo>
                    <a:pt x="155422" y="169125"/>
                  </a:lnTo>
                  <a:lnTo>
                    <a:pt x="156946" y="166090"/>
                  </a:lnTo>
                  <a:lnTo>
                    <a:pt x="156946" y="164566"/>
                  </a:lnTo>
                  <a:lnTo>
                    <a:pt x="158457" y="163042"/>
                  </a:lnTo>
                  <a:lnTo>
                    <a:pt x="158457" y="161505"/>
                  </a:lnTo>
                  <a:lnTo>
                    <a:pt x="159981" y="158457"/>
                  </a:lnTo>
                  <a:lnTo>
                    <a:pt x="161518" y="156933"/>
                  </a:lnTo>
                  <a:lnTo>
                    <a:pt x="161518" y="155422"/>
                  </a:lnTo>
                  <a:lnTo>
                    <a:pt x="163029" y="152374"/>
                  </a:lnTo>
                  <a:lnTo>
                    <a:pt x="163029" y="150850"/>
                  </a:lnTo>
                  <a:lnTo>
                    <a:pt x="164553" y="149326"/>
                  </a:lnTo>
                  <a:lnTo>
                    <a:pt x="164553" y="147789"/>
                  </a:lnTo>
                  <a:lnTo>
                    <a:pt x="164553" y="146265"/>
                  </a:lnTo>
                  <a:lnTo>
                    <a:pt x="166077" y="143230"/>
                  </a:lnTo>
                  <a:lnTo>
                    <a:pt x="166077" y="141706"/>
                  </a:lnTo>
                  <a:lnTo>
                    <a:pt x="167601" y="140182"/>
                  </a:lnTo>
                  <a:lnTo>
                    <a:pt x="167601" y="137134"/>
                  </a:lnTo>
                  <a:lnTo>
                    <a:pt x="167601" y="135597"/>
                  </a:lnTo>
                  <a:lnTo>
                    <a:pt x="169125" y="134073"/>
                  </a:lnTo>
                  <a:lnTo>
                    <a:pt x="169125" y="132562"/>
                  </a:lnTo>
                  <a:lnTo>
                    <a:pt x="169125" y="129514"/>
                  </a:lnTo>
                  <a:lnTo>
                    <a:pt x="169125" y="127990"/>
                  </a:lnTo>
                  <a:lnTo>
                    <a:pt x="170649" y="126466"/>
                  </a:lnTo>
                  <a:lnTo>
                    <a:pt x="170649" y="123405"/>
                  </a:lnTo>
                  <a:lnTo>
                    <a:pt x="170649" y="121894"/>
                  </a:lnTo>
                  <a:lnTo>
                    <a:pt x="170649" y="120370"/>
                  </a:lnTo>
                  <a:lnTo>
                    <a:pt x="172173" y="118846"/>
                  </a:lnTo>
                  <a:lnTo>
                    <a:pt x="172173" y="106654"/>
                  </a:lnTo>
                  <a:lnTo>
                    <a:pt x="173697" y="105130"/>
                  </a:lnTo>
                  <a:lnTo>
                    <a:pt x="173697" y="0"/>
                  </a:lnTo>
                  <a:lnTo>
                    <a:pt x="175221" y="0"/>
                  </a:lnTo>
                  <a:lnTo>
                    <a:pt x="175221" y="13703"/>
                  </a:lnTo>
                  <a:lnTo>
                    <a:pt x="173697" y="15227"/>
                  </a:lnTo>
                  <a:lnTo>
                    <a:pt x="173697" y="85318"/>
                  </a:lnTo>
                  <a:lnTo>
                    <a:pt x="175221" y="86855"/>
                  </a:lnTo>
                  <a:lnTo>
                    <a:pt x="175221" y="105130"/>
                  </a:lnTo>
                  <a:lnTo>
                    <a:pt x="176745" y="106654"/>
                  </a:lnTo>
                  <a:lnTo>
                    <a:pt x="176745" y="120370"/>
                  </a:lnTo>
                  <a:lnTo>
                    <a:pt x="178269" y="121894"/>
                  </a:lnTo>
                  <a:lnTo>
                    <a:pt x="178269" y="123405"/>
                  </a:lnTo>
                  <a:lnTo>
                    <a:pt x="178269" y="126466"/>
                  </a:lnTo>
                  <a:lnTo>
                    <a:pt x="178269" y="127990"/>
                  </a:lnTo>
                  <a:lnTo>
                    <a:pt x="179793" y="129514"/>
                  </a:lnTo>
                  <a:lnTo>
                    <a:pt x="179793" y="132562"/>
                  </a:lnTo>
                  <a:lnTo>
                    <a:pt x="179793" y="134073"/>
                  </a:lnTo>
                  <a:lnTo>
                    <a:pt x="179793" y="135597"/>
                  </a:lnTo>
                  <a:lnTo>
                    <a:pt x="181317" y="137134"/>
                  </a:lnTo>
                  <a:lnTo>
                    <a:pt x="181317" y="140182"/>
                  </a:lnTo>
                  <a:lnTo>
                    <a:pt x="182841" y="141706"/>
                  </a:lnTo>
                  <a:lnTo>
                    <a:pt x="182841" y="143230"/>
                  </a:lnTo>
                  <a:lnTo>
                    <a:pt x="182841" y="146265"/>
                  </a:lnTo>
                  <a:lnTo>
                    <a:pt x="184365" y="147789"/>
                  </a:lnTo>
                  <a:lnTo>
                    <a:pt x="184365" y="149326"/>
                  </a:lnTo>
                  <a:lnTo>
                    <a:pt x="184365" y="150850"/>
                  </a:lnTo>
                  <a:lnTo>
                    <a:pt x="185889" y="152374"/>
                  </a:lnTo>
                  <a:lnTo>
                    <a:pt x="187413" y="155422"/>
                  </a:lnTo>
                  <a:lnTo>
                    <a:pt x="187413" y="156933"/>
                  </a:lnTo>
                  <a:lnTo>
                    <a:pt x="188937" y="158457"/>
                  </a:lnTo>
                  <a:lnTo>
                    <a:pt x="188937" y="161505"/>
                  </a:lnTo>
                  <a:lnTo>
                    <a:pt x="190461" y="163042"/>
                  </a:lnTo>
                  <a:lnTo>
                    <a:pt x="191985" y="164566"/>
                  </a:lnTo>
                  <a:lnTo>
                    <a:pt x="191985" y="166090"/>
                  </a:lnTo>
                  <a:lnTo>
                    <a:pt x="193509" y="169125"/>
                  </a:lnTo>
                  <a:lnTo>
                    <a:pt x="193509" y="170649"/>
                  </a:lnTo>
                  <a:lnTo>
                    <a:pt x="195033" y="172173"/>
                  </a:lnTo>
                  <a:lnTo>
                    <a:pt x="196557" y="173697"/>
                  </a:lnTo>
                  <a:lnTo>
                    <a:pt x="196557" y="176758"/>
                  </a:lnTo>
                  <a:lnTo>
                    <a:pt x="198081" y="178269"/>
                  </a:lnTo>
                  <a:lnTo>
                    <a:pt x="199605" y="179793"/>
                  </a:lnTo>
                  <a:lnTo>
                    <a:pt x="199605" y="182841"/>
                  </a:lnTo>
                  <a:lnTo>
                    <a:pt x="201129" y="184365"/>
                  </a:lnTo>
                  <a:lnTo>
                    <a:pt x="202653" y="185889"/>
                  </a:lnTo>
                  <a:lnTo>
                    <a:pt x="204165" y="187426"/>
                  </a:lnTo>
                  <a:lnTo>
                    <a:pt x="204165" y="190461"/>
                  </a:lnTo>
                  <a:lnTo>
                    <a:pt x="207225" y="191985"/>
                  </a:lnTo>
                  <a:lnTo>
                    <a:pt x="207225" y="193509"/>
                  </a:lnTo>
                  <a:lnTo>
                    <a:pt x="208749" y="196557"/>
                  </a:lnTo>
                  <a:lnTo>
                    <a:pt x="210261" y="198081"/>
                  </a:lnTo>
                  <a:lnTo>
                    <a:pt x="211797" y="199605"/>
                  </a:lnTo>
                  <a:lnTo>
                    <a:pt x="213321" y="201129"/>
                  </a:lnTo>
                  <a:lnTo>
                    <a:pt x="214833" y="204177"/>
                  </a:lnTo>
                  <a:lnTo>
                    <a:pt x="216357" y="205701"/>
                  </a:lnTo>
                  <a:lnTo>
                    <a:pt x="217881" y="207225"/>
                  </a:lnTo>
                  <a:lnTo>
                    <a:pt x="219405" y="208749"/>
                  </a:lnTo>
                  <a:lnTo>
                    <a:pt x="220929" y="211785"/>
                  </a:lnTo>
                  <a:lnTo>
                    <a:pt x="222453" y="213321"/>
                  </a:lnTo>
                  <a:lnTo>
                    <a:pt x="223977" y="214845"/>
                  </a:lnTo>
                  <a:lnTo>
                    <a:pt x="225501" y="217893"/>
                  </a:lnTo>
                  <a:lnTo>
                    <a:pt x="228549" y="219417"/>
                  </a:lnTo>
                  <a:lnTo>
                    <a:pt x="230073" y="220941"/>
                  </a:lnTo>
                  <a:lnTo>
                    <a:pt x="231597" y="222453"/>
                  </a:lnTo>
                  <a:lnTo>
                    <a:pt x="234645" y="223977"/>
                  </a:lnTo>
                  <a:lnTo>
                    <a:pt x="236169" y="227037"/>
                  </a:lnTo>
                  <a:lnTo>
                    <a:pt x="239217" y="228561"/>
                  </a:lnTo>
                  <a:lnTo>
                    <a:pt x="240741" y="231609"/>
                  </a:lnTo>
                  <a:lnTo>
                    <a:pt x="243789" y="233121"/>
                  </a:lnTo>
                  <a:lnTo>
                    <a:pt x="245313" y="234645"/>
                  </a:lnTo>
                  <a:lnTo>
                    <a:pt x="248361" y="236169"/>
                  </a:lnTo>
                  <a:lnTo>
                    <a:pt x="251409" y="237693"/>
                  </a:lnTo>
                  <a:lnTo>
                    <a:pt x="254457" y="240753"/>
                  </a:lnTo>
                  <a:lnTo>
                    <a:pt x="255981" y="242277"/>
                  </a:lnTo>
                  <a:lnTo>
                    <a:pt x="259029" y="243789"/>
                  </a:lnTo>
                  <a:lnTo>
                    <a:pt x="262064" y="246837"/>
                  </a:lnTo>
                  <a:lnTo>
                    <a:pt x="265125" y="248361"/>
                  </a:lnTo>
                  <a:lnTo>
                    <a:pt x="268160" y="249885"/>
                  </a:lnTo>
                  <a:lnTo>
                    <a:pt x="271208" y="251421"/>
                  </a:lnTo>
                  <a:lnTo>
                    <a:pt x="274256" y="254469"/>
                  </a:lnTo>
                  <a:lnTo>
                    <a:pt x="277304" y="255981"/>
                  </a:lnTo>
                  <a:lnTo>
                    <a:pt x="280352" y="257505"/>
                  </a:lnTo>
                  <a:lnTo>
                    <a:pt x="283400" y="259029"/>
                  </a:lnTo>
                  <a:lnTo>
                    <a:pt x="286448" y="262077"/>
                  </a:lnTo>
                  <a:lnTo>
                    <a:pt x="289496" y="263613"/>
                  </a:lnTo>
                  <a:lnTo>
                    <a:pt x="292544" y="265137"/>
                  </a:lnTo>
                  <a:lnTo>
                    <a:pt x="295592" y="268173"/>
                  </a:lnTo>
                  <a:lnTo>
                    <a:pt x="298640" y="269697"/>
                  </a:lnTo>
                  <a:lnTo>
                    <a:pt x="301688" y="271221"/>
                  </a:lnTo>
                  <a:lnTo>
                    <a:pt x="304736" y="272745"/>
                  </a:lnTo>
                  <a:lnTo>
                    <a:pt x="306260" y="275793"/>
                  </a:lnTo>
                  <a:lnTo>
                    <a:pt x="309308" y="277317"/>
                  </a:lnTo>
                  <a:lnTo>
                    <a:pt x="310832" y="278841"/>
                  </a:lnTo>
                  <a:lnTo>
                    <a:pt x="313880" y="281889"/>
                  </a:lnTo>
                  <a:lnTo>
                    <a:pt x="315404" y="283413"/>
                  </a:lnTo>
                  <a:lnTo>
                    <a:pt x="316928" y="284937"/>
                  </a:lnTo>
                  <a:lnTo>
                    <a:pt x="319976" y="286461"/>
                  </a:lnTo>
                  <a:lnTo>
                    <a:pt x="321500" y="287972"/>
                  </a:lnTo>
                  <a:lnTo>
                    <a:pt x="323011" y="291033"/>
                  </a:lnTo>
                  <a:lnTo>
                    <a:pt x="324535" y="292557"/>
                  </a:lnTo>
                  <a:lnTo>
                    <a:pt x="326072" y="294081"/>
                  </a:lnTo>
                  <a:lnTo>
                    <a:pt x="327583" y="297129"/>
                  </a:lnTo>
                  <a:lnTo>
                    <a:pt x="329107" y="298653"/>
                  </a:lnTo>
                  <a:lnTo>
                    <a:pt x="330631" y="300164"/>
                  </a:lnTo>
                  <a:lnTo>
                    <a:pt x="330631" y="301701"/>
                  </a:lnTo>
                  <a:lnTo>
                    <a:pt x="332168" y="304749"/>
                  </a:lnTo>
                  <a:lnTo>
                    <a:pt x="333679" y="306273"/>
                  </a:lnTo>
                  <a:lnTo>
                    <a:pt x="335203" y="307797"/>
                  </a:lnTo>
                  <a:lnTo>
                    <a:pt x="335203" y="309321"/>
                  </a:lnTo>
                  <a:lnTo>
                    <a:pt x="336727" y="312356"/>
                  </a:lnTo>
                  <a:lnTo>
                    <a:pt x="338251" y="313893"/>
                  </a:lnTo>
                  <a:lnTo>
                    <a:pt x="339775" y="315417"/>
                  </a:lnTo>
                  <a:lnTo>
                    <a:pt x="339775" y="318465"/>
                  </a:lnTo>
                  <a:lnTo>
                    <a:pt x="341299" y="319989"/>
                  </a:lnTo>
                  <a:lnTo>
                    <a:pt x="341299" y="321500"/>
                  </a:lnTo>
                  <a:lnTo>
                    <a:pt x="342823" y="323024"/>
                  </a:lnTo>
                  <a:lnTo>
                    <a:pt x="344347" y="326072"/>
                  </a:lnTo>
                  <a:lnTo>
                    <a:pt x="344347" y="327609"/>
                  </a:lnTo>
                  <a:lnTo>
                    <a:pt x="344347" y="329133"/>
                  </a:lnTo>
                  <a:lnTo>
                    <a:pt x="345871" y="332168"/>
                  </a:lnTo>
                  <a:lnTo>
                    <a:pt x="345871" y="333692"/>
                  </a:lnTo>
                  <a:lnTo>
                    <a:pt x="345871" y="335216"/>
                  </a:lnTo>
                  <a:lnTo>
                    <a:pt x="347395" y="336740"/>
                  </a:lnTo>
                  <a:lnTo>
                    <a:pt x="347395" y="339801"/>
                  </a:lnTo>
                  <a:lnTo>
                    <a:pt x="347395" y="341325"/>
                  </a:lnTo>
                  <a:lnTo>
                    <a:pt x="347395" y="356552"/>
                  </a:lnTo>
                  <a:lnTo>
                    <a:pt x="345871" y="358076"/>
                  </a:lnTo>
                  <a:lnTo>
                    <a:pt x="345871" y="359600"/>
                  </a:lnTo>
                  <a:lnTo>
                    <a:pt x="344347" y="362648"/>
                  </a:lnTo>
                  <a:lnTo>
                    <a:pt x="344347" y="364172"/>
                  </a:lnTo>
                  <a:lnTo>
                    <a:pt x="342823" y="367220"/>
                  </a:lnTo>
                  <a:lnTo>
                    <a:pt x="341299" y="368744"/>
                  </a:lnTo>
                  <a:lnTo>
                    <a:pt x="341299" y="370268"/>
                  </a:lnTo>
                  <a:lnTo>
                    <a:pt x="339775" y="371792"/>
                  </a:lnTo>
                  <a:lnTo>
                    <a:pt x="338251" y="373316"/>
                  </a:lnTo>
                  <a:lnTo>
                    <a:pt x="336727" y="376351"/>
                  </a:lnTo>
                  <a:lnTo>
                    <a:pt x="335203" y="377888"/>
                  </a:lnTo>
                  <a:lnTo>
                    <a:pt x="333679" y="379412"/>
                  </a:lnTo>
                  <a:lnTo>
                    <a:pt x="332168" y="382460"/>
                  </a:lnTo>
                  <a:lnTo>
                    <a:pt x="330631" y="383984"/>
                  </a:lnTo>
                  <a:lnTo>
                    <a:pt x="329107" y="385508"/>
                  </a:lnTo>
                  <a:lnTo>
                    <a:pt x="326072" y="387019"/>
                  </a:lnTo>
                  <a:lnTo>
                    <a:pt x="324535" y="390080"/>
                  </a:lnTo>
                  <a:lnTo>
                    <a:pt x="323011" y="391604"/>
                  </a:lnTo>
                  <a:lnTo>
                    <a:pt x="319976" y="393128"/>
                  </a:lnTo>
                  <a:lnTo>
                    <a:pt x="318439" y="394652"/>
                  </a:lnTo>
                  <a:lnTo>
                    <a:pt x="316928" y="397687"/>
                  </a:lnTo>
                  <a:lnTo>
                    <a:pt x="313880" y="399211"/>
                  </a:lnTo>
                  <a:lnTo>
                    <a:pt x="312343" y="400735"/>
                  </a:lnTo>
                  <a:lnTo>
                    <a:pt x="310832" y="403796"/>
                  </a:lnTo>
                  <a:lnTo>
                    <a:pt x="307784" y="405320"/>
                  </a:lnTo>
                  <a:lnTo>
                    <a:pt x="306260" y="406844"/>
                  </a:lnTo>
                  <a:lnTo>
                    <a:pt x="304736" y="408368"/>
                  </a:lnTo>
                  <a:lnTo>
                    <a:pt x="301688" y="411403"/>
                  </a:lnTo>
                  <a:lnTo>
                    <a:pt x="300164" y="412927"/>
                  </a:lnTo>
                  <a:lnTo>
                    <a:pt x="298640" y="414451"/>
                  </a:lnTo>
                  <a:lnTo>
                    <a:pt x="295592" y="417512"/>
                  </a:lnTo>
                  <a:lnTo>
                    <a:pt x="294068" y="419036"/>
                  </a:lnTo>
                  <a:lnTo>
                    <a:pt x="291020" y="420547"/>
                  </a:lnTo>
                  <a:lnTo>
                    <a:pt x="289496" y="422071"/>
                  </a:lnTo>
                  <a:lnTo>
                    <a:pt x="287972" y="425119"/>
                  </a:lnTo>
                  <a:lnTo>
                    <a:pt x="286448" y="426643"/>
                  </a:lnTo>
                  <a:lnTo>
                    <a:pt x="284924" y="428180"/>
                  </a:lnTo>
                  <a:lnTo>
                    <a:pt x="281876" y="429704"/>
                  </a:lnTo>
                  <a:lnTo>
                    <a:pt x="280352" y="432739"/>
                  </a:lnTo>
                  <a:lnTo>
                    <a:pt x="278828" y="434263"/>
                  </a:lnTo>
                  <a:lnTo>
                    <a:pt x="277304" y="435787"/>
                  </a:lnTo>
                  <a:lnTo>
                    <a:pt x="275780" y="438835"/>
                  </a:lnTo>
                  <a:lnTo>
                    <a:pt x="274256" y="440359"/>
                  </a:lnTo>
                  <a:lnTo>
                    <a:pt x="272732" y="441883"/>
                  </a:lnTo>
                  <a:lnTo>
                    <a:pt x="271208" y="443407"/>
                  </a:lnTo>
                  <a:lnTo>
                    <a:pt x="269697" y="444931"/>
                  </a:lnTo>
                  <a:lnTo>
                    <a:pt x="268160" y="447979"/>
                  </a:lnTo>
                  <a:lnTo>
                    <a:pt x="268160" y="449503"/>
                  </a:lnTo>
                  <a:lnTo>
                    <a:pt x="266636" y="452539"/>
                  </a:lnTo>
                  <a:lnTo>
                    <a:pt x="265125" y="454075"/>
                  </a:lnTo>
                  <a:lnTo>
                    <a:pt x="263601" y="455599"/>
                  </a:lnTo>
                  <a:lnTo>
                    <a:pt x="262064" y="457123"/>
                  </a:lnTo>
                  <a:lnTo>
                    <a:pt x="260540" y="458647"/>
                  </a:lnTo>
                  <a:lnTo>
                    <a:pt x="259029" y="461695"/>
                  </a:lnTo>
                  <a:lnTo>
                    <a:pt x="259029" y="463207"/>
                  </a:lnTo>
                  <a:lnTo>
                    <a:pt x="257505" y="464731"/>
                  </a:lnTo>
                  <a:lnTo>
                    <a:pt x="255981" y="467791"/>
                  </a:lnTo>
                  <a:lnTo>
                    <a:pt x="254457" y="469315"/>
                  </a:lnTo>
                  <a:lnTo>
                    <a:pt x="252933" y="470839"/>
                  </a:lnTo>
                  <a:lnTo>
                    <a:pt x="252933" y="472363"/>
                  </a:lnTo>
                  <a:lnTo>
                    <a:pt x="251409" y="475399"/>
                  </a:lnTo>
                  <a:lnTo>
                    <a:pt x="249885" y="476923"/>
                  </a:lnTo>
                  <a:lnTo>
                    <a:pt x="248361" y="478459"/>
                  </a:lnTo>
                  <a:lnTo>
                    <a:pt x="248361" y="479983"/>
                  </a:lnTo>
                  <a:lnTo>
                    <a:pt x="246837" y="483031"/>
                  </a:lnTo>
                  <a:lnTo>
                    <a:pt x="245313" y="484555"/>
                  </a:lnTo>
                  <a:lnTo>
                    <a:pt x="245313" y="486067"/>
                  </a:lnTo>
                  <a:lnTo>
                    <a:pt x="243789" y="489115"/>
                  </a:lnTo>
                  <a:lnTo>
                    <a:pt x="242265" y="490639"/>
                  </a:lnTo>
                  <a:lnTo>
                    <a:pt x="242265" y="492175"/>
                  </a:lnTo>
                  <a:lnTo>
                    <a:pt x="240741" y="493699"/>
                  </a:lnTo>
                  <a:lnTo>
                    <a:pt x="240741" y="496735"/>
                  </a:lnTo>
                  <a:lnTo>
                    <a:pt x="239217" y="498259"/>
                  </a:lnTo>
                  <a:lnTo>
                    <a:pt x="239217" y="499783"/>
                  </a:lnTo>
                  <a:lnTo>
                    <a:pt x="237693" y="502831"/>
                  </a:lnTo>
                  <a:lnTo>
                    <a:pt x="237693" y="504367"/>
                  </a:lnTo>
                  <a:lnTo>
                    <a:pt x="236169" y="505891"/>
                  </a:lnTo>
                  <a:lnTo>
                    <a:pt x="234645" y="507403"/>
                  </a:lnTo>
                  <a:lnTo>
                    <a:pt x="234645" y="510451"/>
                  </a:lnTo>
                  <a:lnTo>
                    <a:pt x="233121" y="511975"/>
                  </a:lnTo>
                  <a:lnTo>
                    <a:pt x="231597" y="513499"/>
                  </a:lnTo>
                  <a:lnTo>
                    <a:pt x="230073" y="515023"/>
                  </a:lnTo>
                  <a:lnTo>
                    <a:pt x="230073" y="518083"/>
                  </a:lnTo>
                  <a:lnTo>
                    <a:pt x="228549" y="519595"/>
                  </a:lnTo>
                  <a:lnTo>
                    <a:pt x="228549" y="521119"/>
                  </a:lnTo>
                  <a:lnTo>
                    <a:pt x="225501" y="524167"/>
                  </a:lnTo>
                  <a:lnTo>
                    <a:pt x="225501" y="525691"/>
                  </a:lnTo>
                  <a:lnTo>
                    <a:pt x="223977" y="527215"/>
                  </a:lnTo>
                  <a:lnTo>
                    <a:pt x="222453" y="528739"/>
                  </a:lnTo>
                  <a:lnTo>
                    <a:pt x="222453" y="530263"/>
                  </a:lnTo>
                  <a:lnTo>
                    <a:pt x="219405" y="533311"/>
                  </a:lnTo>
                  <a:lnTo>
                    <a:pt x="219405" y="534835"/>
                  </a:lnTo>
                  <a:lnTo>
                    <a:pt x="217881" y="537883"/>
                  </a:lnTo>
                  <a:lnTo>
                    <a:pt x="216357" y="539407"/>
                  </a:lnTo>
                  <a:lnTo>
                    <a:pt x="214833" y="540918"/>
                  </a:lnTo>
                  <a:lnTo>
                    <a:pt x="214833" y="542455"/>
                  </a:lnTo>
                  <a:lnTo>
                    <a:pt x="213321" y="543979"/>
                  </a:lnTo>
                  <a:lnTo>
                    <a:pt x="211797" y="547027"/>
                  </a:lnTo>
                  <a:lnTo>
                    <a:pt x="210261" y="548551"/>
                  </a:lnTo>
                  <a:lnTo>
                    <a:pt x="210261" y="550075"/>
                  </a:lnTo>
                  <a:lnTo>
                    <a:pt x="208749" y="553110"/>
                  </a:lnTo>
                  <a:lnTo>
                    <a:pt x="208749" y="554647"/>
                  </a:lnTo>
                  <a:lnTo>
                    <a:pt x="207225" y="556171"/>
                  </a:lnTo>
                  <a:lnTo>
                    <a:pt x="207225" y="557695"/>
                  </a:lnTo>
                  <a:lnTo>
                    <a:pt x="205701" y="560743"/>
                  </a:lnTo>
                  <a:lnTo>
                    <a:pt x="205701" y="562254"/>
                  </a:lnTo>
                  <a:lnTo>
                    <a:pt x="204165" y="563778"/>
                  </a:lnTo>
                  <a:lnTo>
                    <a:pt x="204165" y="565302"/>
                  </a:lnTo>
                  <a:lnTo>
                    <a:pt x="202653" y="568363"/>
                  </a:lnTo>
                  <a:lnTo>
                    <a:pt x="202653" y="569887"/>
                  </a:lnTo>
                  <a:lnTo>
                    <a:pt x="202653" y="571411"/>
                  </a:lnTo>
                  <a:lnTo>
                    <a:pt x="202653" y="574446"/>
                  </a:lnTo>
                  <a:lnTo>
                    <a:pt x="201129" y="575970"/>
                  </a:lnTo>
                  <a:lnTo>
                    <a:pt x="201129" y="577494"/>
                  </a:lnTo>
                  <a:lnTo>
                    <a:pt x="201129" y="579018"/>
                  </a:lnTo>
                  <a:lnTo>
                    <a:pt x="201129" y="580555"/>
                  </a:lnTo>
                  <a:lnTo>
                    <a:pt x="199605" y="583603"/>
                  </a:lnTo>
                  <a:lnTo>
                    <a:pt x="199605" y="592747"/>
                  </a:lnTo>
                  <a:lnTo>
                    <a:pt x="198081" y="594271"/>
                  </a:lnTo>
                  <a:lnTo>
                    <a:pt x="198081" y="597306"/>
                  </a:lnTo>
                  <a:lnTo>
                    <a:pt x="198081" y="598830"/>
                  </a:lnTo>
                  <a:lnTo>
                    <a:pt x="198081" y="600354"/>
                  </a:lnTo>
                  <a:lnTo>
                    <a:pt x="198081" y="603402"/>
                  </a:lnTo>
                  <a:lnTo>
                    <a:pt x="196557" y="604939"/>
                  </a:lnTo>
                  <a:lnTo>
                    <a:pt x="196557" y="606450"/>
                  </a:lnTo>
                  <a:lnTo>
                    <a:pt x="196557" y="607974"/>
                  </a:lnTo>
                  <a:lnTo>
                    <a:pt x="196557" y="611022"/>
                  </a:lnTo>
                  <a:lnTo>
                    <a:pt x="195033" y="612546"/>
                  </a:lnTo>
                  <a:lnTo>
                    <a:pt x="195033" y="614070"/>
                  </a:lnTo>
                  <a:lnTo>
                    <a:pt x="195033" y="615594"/>
                  </a:lnTo>
                  <a:lnTo>
                    <a:pt x="195033" y="618642"/>
                  </a:lnTo>
                  <a:lnTo>
                    <a:pt x="193509" y="620166"/>
                  </a:lnTo>
                  <a:lnTo>
                    <a:pt x="193509" y="629297"/>
                  </a:lnTo>
                  <a:lnTo>
                    <a:pt x="191985" y="632358"/>
                  </a:lnTo>
                  <a:lnTo>
                    <a:pt x="191985" y="641489"/>
                  </a:lnTo>
                  <a:lnTo>
                    <a:pt x="190461" y="643026"/>
                  </a:lnTo>
                  <a:lnTo>
                    <a:pt x="190461" y="646074"/>
                  </a:lnTo>
                  <a:lnTo>
                    <a:pt x="190461" y="647598"/>
                  </a:lnTo>
                  <a:lnTo>
                    <a:pt x="190461" y="649122"/>
                  </a:lnTo>
                  <a:lnTo>
                    <a:pt x="190461" y="650633"/>
                  </a:lnTo>
                  <a:lnTo>
                    <a:pt x="188937" y="653681"/>
                  </a:lnTo>
                  <a:lnTo>
                    <a:pt x="188937" y="668934"/>
                  </a:lnTo>
                  <a:lnTo>
                    <a:pt x="187413" y="670458"/>
                  </a:lnTo>
                  <a:lnTo>
                    <a:pt x="187413" y="682637"/>
                  </a:lnTo>
                  <a:lnTo>
                    <a:pt x="185889" y="684161"/>
                  </a:lnTo>
                  <a:lnTo>
                    <a:pt x="185889" y="685685"/>
                  </a:lnTo>
                  <a:lnTo>
                    <a:pt x="185889" y="688733"/>
                  </a:lnTo>
                  <a:lnTo>
                    <a:pt x="185889" y="690257"/>
                  </a:lnTo>
                  <a:lnTo>
                    <a:pt x="184365" y="691781"/>
                  </a:lnTo>
                  <a:lnTo>
                    <a:pt x="184365" y="707021"/>
                  </a:lnTo>
                  <a:lnTo>
                    <a:pt x="182841" y="710069"/>
                  </a:lnTo>
                  <a:lnTo>
                    <a:pt x="182841" y="746645"/>
                  </a:lnTo>
                  <a:lnTo>
                    <a:pt x="184365" y="748169"/>
                  </a:lnTo>
                  <a:lnTo>
                    <a:pt x="184365" y="781685"/>
                  </a:lnTo>
                  <a:lnTo>
                    <a:pt x="182841" y="783208"/>
                  </a:lnTo>
                  <a:lnTo>
                    <a:pt x="182841" y="799972"/>
                  </a:lnTo>
                  <a:lnTo>
                    <a:pt x="181317" y="801496"/>
                  </a:lnTo>
                  <a:lnTo>
                    <a:pt x="181317" y="812165"/>
                  </a:lnTo>
                  <a:lnTo>
                    <a:pt x="179793" y="813688"/>
                  </a:lnTo>
                  <a:lnTo>
                    <a:pt x="179793" y="883780"/>
                  </a:lnTo>
                  <a:lnTo>
                    <a:pt x="178269" y="885304"/>
                  </a:lnTo>
                  <a:lnTo>
                    <a:pt x="178269" y="905103"/>
                  </a:lnTo>
                  <a:lnTo>
                    <a:pt x="176745" y="906627"/>
                  </a:lnTo>
                  <a:lnTo>
                    <a:pt x="176745" y="952347"/>
                  </a:lnTo>
                  <a:lnTo>
                    <a:pt x="175221" y="953871"/>
                  </a:lnTo>
                  <a:lnTo>
                    <a:pt x="175221" y="990434"/>
                  </a:lnTo>
                  <a:lnTo>
                    <a:pt x="173697" y="990434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4" name="object 54"/>
          <p:cNvSpPr txBox="1"/>
          <p:nvPr/>
        </p:nvSpPr>
        <p:spPr>
          <a:xfrm>
            <a:off x="2865078" y="5655700"/>
            <a:ext cx="174625" cy="17907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000" spc="-10" dirty="0">
                <a:latin typeface="Arial"/>
                <a:cs typeface="Arial"/>
              </a:rPr>
              <a:t>*</a:t>
            </a:r>
            <a:r>
              <a:rPr sz="1000" dirty="0">
                <a:latin typeface="Arial"/>
                <a:cs typeface="Arial"/>
              </a:rPr>
              <a:t>**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55" name="object 55"/>
          <p:cNvGrpSpPr/>
          <p:nvPr/>
        </p:nvGrpSpPr>
        <p:grpSpPr>
          <a:xfrm>
            <a:off x="1729709" y="5614332"/>
            <a:ext cx="1652270" cy="1373505"/>
            <a:chOff x="1729709" y="5614332"/>
            <a:chExt cx="1652270" cy="1373505"/>
          </a:xfrm>
        </p:grpSpPr>
        <p:sp>
          <p:nvSpPr>
            <p:cNvPr id="56" name="object 56"/>
            <p:cNvSpPr/>
            <p:nvPr/>
          </p:nvSpPr>
          <p:spPr>
            <a:xfrm>
              <a:off x="3144428" y="5810119"/>
              <a:ext cx="0" cy="32384"/>
            </a:xfrm>
            <a:custGeom>
              <a:avLst/>
              <a:gdLst/>
              <a:ahLst/>
              <a:cxnLst/>
              <a:rect l="l" t="t" r="r" b="b"/>
              <a:pathLst>
                <a:path h="32385">
                  <a:moveTo>
                    <a:pt x="0" y="32016"/>
                  </a:moveTo>
                  <a:lnTo>
                    <a:pt x="0" y="32016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2758945" y="5810125"/>
              <a:ext cx="386080" cy="0"/>
            </a:xfrm>
            <a:custGeom>
              <a:avLst/>
              <a:gdLst/>
              <a:ahLst/>
              <a:cxnLst/>
              <a:rect l="l" t="t" r="r" b="b"/>
              <a:pathLst>
                <a:path w="386080">
                  <a:moveTo>
                    <a:pt x="385483" y="0"/>
                  </a:moveTo>
                  <a:lnTo>
                    <a:pt x="385483" y="0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2758944" y="5810125"/>
              <a:ext cx="0" cy="32384"/>
            </a:xfrm>
            <a:custGeom>
              <a:avLst/>
              <a:gdLst/>
              <a:ahLst/>
              <a:cxnLst/>
              <a:rect l="l" t="t" r="r" b="b"/>
              <a:pathLst>
                <a:path h="32385">
                  <a:moveTo>
                    <a:pt x="0" y="0"/>
                  </a:moveTo>
                  <a:lnTo>
                    <a:pt x="0" y="0"/>
                  </a:lnTo>
                  <a:lnTo>
                    <a:pt x="0" y="32016"/>
                  </a:lnTo>
                </a:path>
              </a:pathLst>
            </a:custGeom>
            <a:ln w="762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9" name="object 59"/>
            <p:cNvSpPr/>
            <p:nvPr/>
          </p:nvSpPr>
          <p:spPr>
            <a:xfrm>
              <a:off x="1753325" y="5618142"/>
              <a:ext cx="1624330" cy="1345565"/>
            </a:xfrm>
            <a:custGeom>
              <a:avLst/>
              <a:gdLst/>
              <a:ahLst/>
              <a:cxnLst/>
              <a:rect l="l" t="t" r="r" b="b"/>
              <a:pathLst>
                <a:path w="1624329" h="1345565">
                  <a:moveTo>
                    <a:pt x="0" y="1345476"/>
                  </a:moveTo>
                  <a:lnTo>
                    <a:pt x="1624228" y="1345476"/>
                  </a:lnTo>
                  <a:lnTo>
                    <a:pt x="1624228" y="0"/>
                  </a:lnTo>
                  <a:lnTo>
                    <a:pt x="0" y="0"/>
                  </a:lnTo>
                  <a:lnTo>
                    <a:pt x="0" y="1345476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1733519" y="6820383"/>
              <a:ext cx="20320" cy="0"/>
            </a:xfrm>
            <a:custGeom>
              <a:avLst/>
              <a:gdLst/>
              <a:ahLst/>
              <a:cxnLst/>
              <a:rect l="l" t="t" r="r" b="b"/>
              <a:pathLst>
                <a:path w="20319">
                  <a:moveTo>
                    <a:pt x="0" y="0"/>
                  </a:moveTo>
                  <a:lnTo>
                    <a:pt x="0" y="0"/>
                  </a:lnTo>
                  <a:lnTo>
                    <a:pt x="19812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1" name="object 61"/>
            <p:cNvSpPr/>
            <p:nvPr/>
          </p:nvSpPr>
          <p:spPr>
            <a:xfrm>
              <a:off x="1733519" y="6535440"/>
              <a:ext cx="20320" cy="0"/>
            </a:xfrm>
            <a:custGeom>
              <a:avLst/>
              <a:gdLst/>
              <a:ahLst/>
              <a:cxnLst/>
              <a:rect l="l" t="t" r="r" b="b"/>
              <a:pathLst>
                <a:path w="20319">
                  <a:moveTo>
                    <a:pt x="0" y="0"/>
                  </a:moveTo>
                  <a:lnTo>
                    <a:pt x="0" y="0"/>
                  </a:lnTo>
                  <a:lnTo>
                    <a:pt x="19812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2" name="object 62"/>
            <p:cNvSpPr/>
            <p:nvPr/>
          </p:nvSpPr>
          <p:spPr>
            <a:xfrm>
              <a:off x="1733519" y="6250495"/>
              <a:ext cx="20320" cy="0"/>
            </a:xfrm>
            <a:custGeom>
              <a:avLst/>
              <a:gdLst/>
              <a:ahLst/>
              <a:cxnLst/>
              <a:rect l="l" t="t" r="r" b="b"/>
              <a:pathLst>
                <a:path w="20319">
                  <a:moveTo>
                    <a:pt x="0" y="0"/>
                  </a:moveTo>
                  <a:lnTo>
                    <a:pt x="0" y="0"/>
                  </a:lnTo>
                  <a:lnTo>
                    <a:pt x="19812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3" name="object 63"/>
            <p:cNvSpPr/>
            <p:nvPr/>
          </p:nvSpPr>
          <p:spPr>
            <a:xfrm>
              <a:off x="1733519" y="5964026"/>
              <a:ext cx="20320" cy="0"/>
            </a:xfrm>
            <a:custGeom>
              <a:avLst/>
              <a:gdLst/>
              <a:ahLst/>
              <a:cxnLst/>
              <a:rect l="l" t="t" r="r" b="b"/>
              <a:pathLst>
                <a:path w="20319">
                  <a:moveTo>
                    <a:pt x="0" y="0"/>
                  </a:moveTo>
                  <a:lnTo>
                    <a:pt x="0" y="0"/>
                  </a:lnTo>
                  <a:lnTo>
                    <a:pt x="19812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4"/>
            <p:cNvSpPr/>
            <p:nvPr/>
          </p:nvSpPr>
          <p:spPr>
            <a:xfrm>
              <a:off x="1733519" y="5679083"/>
              <a:ext cx="20320" cy="0"/>
            </a:xfrm>
            <a:custGeom>
              <a:avLst/>
              <a:gdLst/>
              <a:ahLst/>
              <a:cxnLst/>
              <a:rect l="l" t="t" r="r" b="b"/>
              <a:pathLst>
                <a:path w="20319">
                  <a:moveTo>
                    <a:pt x="0" y="0"/>
                  </a:moveTo>
                  <a:lnTo>
                    <a:pt x="0" y="0"/>
                  </a:lnTo>
                  <a:lnTo>
                    <a:pt x="19812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5" name="object 65"/>
            <p:cNvSpPr/>
            <p:nvPr/>
          </p:nvSpPr>
          <p:spPr>
            <a:xfrm>
              <a:off x="1986446" y="6963613"/>
              <a:ext cx="0" cy="20320"/>
            </a:xfrm>
            <a:custGeom>
              <a:avLst/>
              <a:gdLst/>
              <a:ahLst/>
              <a:cxnLst/>
              <a:rect l="l" t="t" r="r" b="b"/>
              <a:pathLst>
                <a:path h="20320">
                  <a:moveTo>
                    <a:pt x="0" y="19811"/>
                  </a:moveTo>
                  <a:lnTo>
                    <a:pt x="0" y="19811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6" name="object 66"/>
            <p:cNvSpPr/>
            <p:nvPr/>
          </p:nvSpPr>
          <p:spPr>
            <a:xfrm>
              <a:off x="2371935" y="6963613"/>
              <a:ext cx="0" cy="20320"/>
            </a:xfrm>
            <a:custGeom>
              <a:avLst/>
              <a:gdLst/>
              <a:ahLst/>
              <a:cxnLst/>
              <a:rect l="l" t="t" r="r" b="b"/>
              <a:pathLst>
                <a:path h="20320">
                  <a:moveTo>
                    <a:pt x="0" y="19811"/>
                  </a:moveTo>
                  <a:lnTo>
                    <a:pt x="0" y="19811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7" name="object 67"/>
            <p:cNvSpPr/>
            <p:nvPr/>
          </p:nvSpPr>
          <p:spPr>
            <a:xfrm>
              <a:off x="2758944" y="6963613"/>
              <a:ext cx="0" cy="20320"/>
            </a:xfrm>
            <a:custGeom>
              <a:avLst/>
              <a:gdLst/>
              <a:ahLst/>
              <a:cxnLst/>
              <a:rect l="l" t="t" r="r" b="b"/>
              <a:pathLst>
                <a:path h="20320">
                  <a:moveTo>
                    <a:pt x="0" y="19811"/>
                  </a:moveTo>
                  <a:lnTo>
                    <a:pt x="0" y="19811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3144428" y="6963613"/>
              <a:ext cx="0" cy="20320"/>
            </a:xfrm>
            <a:custGeom>
              <a:avLst/>
              <a:gdLst/>
              <a:ahLst/>
              <a:cxnLst/>
              <a:rect l="l" t="t" r="r" b="b"/>
              <a:pathLst>
                <a:path h="20320">
                  <a:moveTo>
                    <a:pt x="0" y="19811"/>
                  </a:moveTo>
                  <a:lnTo>
                    <a:pt x="0" y="19811"/>
                  </a:lnTo>
                  <a:lnTo>
                    <a:pt x="0" y="0"/>
                  </a:lnTo>
                </a:path>
              </a:pathLst>
            </a:custGeom>
            <a:ln w="7620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9" name="object 69"/>
          <p:cNvSpPr txBox="1"/>
          <p:nvPr/>
        </p:nvSpPr>
        <p:spPr>
          <a:xfrm>
            <a:off x="1650838" y="6164600"/>
            <a:ext cx="82550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dirty="0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70" name="object 70"/>
          <p:cNvSpPr txBox="1"/>
          <p:nvPr/>
        </p:nvSpPr>
        <p:spPr>
          <a:xfrm>
            <a:off x="1565495" y="5881191"/>
            <a:ext cx="167640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0</a:t>
            </a:r>
            <a:r>
              <a:rPr sz="800" dirty="0">
                <a:latin typeface="Arial"/>
                <a:cs typeface="Arial"/>
              </a:rPr>
              <a:t>.5</a:t>
            </a:r>
            <a:endParaRPr sz="800">
              <a:latin typeface="Arial"/>
              <a:cs typeface="Arial"/>
            </a:endParaRPr>
          </a:p>
        </p:txBody>
      </p:sp>
      <p:sp>
        <p:nvSpPr>
          <p:cNvPr id="71" name="object 71"/>
          <p:cNvSpPr txBox="1"/>
          <p:nvPr/>
        </p:nvSpPr>
        <p:spPr>
          <a:xfrm>
            <a:off x="1565495" y="5597781"/>
            <a:ext cx="167640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1</a:t>
            </a:r>
            <a:r>
              <a:rPr sz="800" dirty="0">
                <a:latin typeface="Arial"/>
                <a:cs typeface="Arial"/>
              </a:rPr>
              <a:t>.0</a:t>
            </a:r>
            <a:endParaRPr sz="800">
              <a:latin typeface="Arial"/>
              <a:cs typeface="Arial"/>
            </a:endParaRPr>
          </a:p>
        </p:txBody>
      </p:sp>
      <p:sp>
        <p:nvSpPr>
          <p:cNvPr id="72" name="object 72"/>
          <p:cNvSpPr txBox="1"/>
          <p:nvPr/>
        </p:nvSpPr>
        <p:spPr>
          <a:xfrm>
            <a:off x="1530480" y="6448112"/>
            <a:ext cx="20129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-0</a:t>
            </a:r>
            <a:r>
              <a:rPr sz="800" dirty="0">
                <a:latin typeface="Arial"/>
                <a:cs typeface="Arial"/>
              </a:rPr>
              <a:t>.5</a:t>
            </a:r>
            <a:endParaRPr sz="800">
              <a:latin typeface="Arial"/>
              <a:cs typeface="Arial"/>
            </a:endParaRPr>
          </a:p>
        </p:txBody>
      </p:sp>
      <p:sp>
        <p:nvSpPr>
          <p:cNvPr id="73" name="object 73"/>
          <p:cNvSpPr txBox="1"/>
          <p:nvPr/>
        </p:nvSpPr>
        <p:spPr>
          <a:xfrm>
            <a:off x="1530480" y="6731419"/>
            <a:ext cx="20129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-1</a:t>
            </a:r>
            <a:r>
              <a:rPr sz="800" dirty="0">
                <a:latin typeface="Arial"/>
                <a:cs typeface="Arial"/>
              </a:rPr>
              <a:t>.0</a:t>
            </a:r>
            <a:endParaRPr sz="800">
              <a:latin typeface="Arial"/>
              <a:cs typeface="Arial"/>
            </a:endParaRPr>
          </a:p>
        </p:txBody>
      </p:sp>
      <p:pic>
        <p:nvPicPr>
          <p:cNvPr id="74" name="object 74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1642103" y="7016944"/>
            <a:ext cx="1650118" cy="643044"/>
          </a:xfrm>
          <a:prstGeom prst="rect">
            <a:avLst/>
          </a:prstGeom>
        </p:spPr>
      </p:pic>
      <p:sp>
        <p:nvSpPr>
          <p:cNvPr id="75" name="object 75"/>
          <p:cNvSpPr txBox="1"/>
          <p:nvPr/>
        </p:nvSpPr>
        <p:spPr>
          <a:xfrm>
            <a:off x="1798575" y="5634276"/>
            <a:ext cx="635000" cy="2698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Cortex, </a:t>
            </a:r>
            <a:r>
              <a:rPr sz="800" dirty="0">
                <a:latin typeface="Arial"/>
                <a:cs typeface="Arial"/>
              </a:rPr>
              <a:t> Stage</a:t>
            </a:r>
            <a:r>
              <a:rPr sz="800" spc="-3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1</a:t>
            </a:r>
            <a:r>
              <a:rPr sz="800" spc="-4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DAM</a:t>
            </a:r>
            <a:endParaRPr sz="800">
              <a:latin typeface="Arial"/>
              <a:cs typeface="Arial"/>
            </a:endParaRPr>
          </a:p>
        </p:txBody>
      </p:sp>
      <p:sp>
        <p:nvSpPr>
          <p:cNvPr id="76" name="object 76"/>
          <p:cNvSpPr txBox="1"/>
          <p:nvPr/>
        </p:nvSpPr>
        <p:spPr>
          <a:xfrm>
            <a:off x="296649" y="815019"/>
            <a:ext cx="9969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A</a:t>
            </a:r>
            <a:endParaRPr sz="800">
              <a:latin typeface="Arial"/>
              <a:cs typeface="Arial"/>
            </a:endParaRPr>
          </a:p>
        </p:txBody>
      </p:sp>
      <p:sp>
        <p:nvSpPr>
          <p:cNvPr id="86" name="object 86"/>
          <p:cNvSpPr txBox="1"/>
          <p:nvPr/>
        </p:nvSpPr>
        <p:spPr>
          <a:xfrm>
            <a:off x="2777255" y="3267039"/>
            <a:ext cx="53657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Gossypetin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87" name="object 87"/>
          <p:cNvSpPr txBox="1"/>
          <p:nvPr/>
        </p:nvSpPr>
        <p:spPr>
          <a:xfrm>
            <a:off x="793297" y="3270934"/>
            <a:ext cx="36131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dirty="0">
                <a:latin typeface="Arial"/>
                <a:cs typeface="Arial"/>
              </a:rPr>
              <a:t>V</a:t>
            </a:r>
            <a:r>
              <a:rPr sz="800" spc="-5" dirty="0">
                <a:latin typeface="Arial"/>
                <a:cs typeface="Arial"/>
              </a:rPr>
              <a:t>eh</a:t>
            </a:r>
            <a:r>
              <a:rPr sz="800" dirty="0">
                <a:latin typeface="Arial"/>
                <a:cs typeface="Arial"/>
              </a:rPr>
              <a:t>i</a:t>
            </a:r>
            <a:r>
              <a:rPr sz="800" spc="5" dirty="0">
                <a:latin typeface="Arial"/>
                <a:cs typeface="Arial"/>
              </a:rPr>
              <a:t>c</a:t>
            </a:r>
            <a:r>
              <a:rPr sz="800" dirty="0">
                <a:latin typeface="Arial"/>
                <a:cs typeface="Arial"/>
              </a:rPr>
              <a:t>le</a:t>
            </a:r>
          </a:p>
        </p:txBody>
      </p:sp>
      <p:sp>
        <p:nvSpPr>
          <p:cNvPr id="89" name="object 89"/>
          <p:cNvSpPr txBox="1"/>
          <p:nvPr/>
        </p:nvSpPr>
        <p:spPr>
          <a:xfrm>
            <a:off x="1535032" y="3152218"/>
            <a:ext cx="991869" cy="350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Cortex, </a:t>
            </a:r>
            <a:r>
              <a:rPr sz="800" dirty="0">
                <a:latin typeface="Arial"/>
                <a:cs typeface="Arial"/>
              </a:rPr>
              <a:t>Stage</a:t>
            </a:r>
            <a:r>
              <a:rPr sz="800" spc="-10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1</a:t>
            </a:r>
            <a:r>
              <a:rPr sz="800" spc="-20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DAM</a:t>
            </a:r>
          </a:p>
          <a:p>
            <a:pPr marL="23495" algn="ctr">
              <a:lnSpc>
                <a:spcPct val="100000"/>
              </a:lnSpc>
              <a:spcBef>
                <a:spcPts val="635"/>
              </a:spcBef>
            </a:pPr>
            <a:r>
              <a:rPr sz="800" spc="-5" dirty="0">
                <a:latin typeface="Arial"/>
                <a:cs typeface="Arial"/>
              </a:rPr>
              <a:t>5xFAD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11" name="object 111"/>
          <p:cNvSpPr txBox="1"/>
          <p:nvPr/>
        </p:nvSpPr>
        <p:spPr>
          <a:xfrm>
            <a:off x="4422000" y="3237143"/>
            <a:ext cx="36131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dirty="0">
                <a:latin typeface="Arial"/>
                <a:cs typeface="Arial"/>
              </a:rPr>
              <a:t>V</a:t>
            </a:r>
            <a:r>
              <a:rPr sz="800" spc="-5" dirty="0">
                <a:latin typeface="Arial"/>
                <a:cs typeface="Arial"/>
              </a:rPr>
              <a:t>eh</a:t>
            </a:r>
            <a:r>
              <a:rPr sz="800" dirty="0">
                <a:latin typeface="Arial"/>
                <a:cs typeface="Arial"/>
              </a:rPr>
              <a:t>i</a:t>
            </a:r>
            <a:r>
              <a:rPr sz="800" spc="5" dirty="0">
                <a:latin typeface="Arial"/>
                <a:cs typeface="Arial"/>
              </a:rPr>
              <a:t>c</a:t>
            </a:r>
            <a:r>
              <a:rPr sz="800" dirty="0">
                <a:latin typeface="Arial"/>
                <a:cs typeface="Arial"/>
              </a:rPr>
              <a:t>le</a:t>
            </a:r>
          </a:p>
        </p:txBody>
      </p:sp>
      <p:sp>
        <p:nvSpPr>
          <p:cNvPr id="113" name="object 113"/>
          <p:cNvSpPr txBox="1"/>
          <p:nvPr/>
        </p:nvSpPr>
        <p:spPr>
          <a:xfrm>
            <a:off x="6394434" y="3220703"/>
            <a:ext cx="53657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Gossypetin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21" name="object 121"/>
          <p:cNvSpPr txBox="1"/>
          <p:nvPr/>
        </p:nvSpPr>
        <p:spPr>
          <a:xfrm>
            <a:off x="5154919" y="3064559"/>
            <a:ext cx="991869" cy="41275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50520" marR="5080" indent="-338455">
              <a:lnSpc>
                <a:spcPct val="1587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Cortex,</a:t>
            </a:r>
            <a:r>
              <a:rPr sz="800" spc="-10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Stage</a:t>
            </a:r>
            <a:r>
              <a:rPr sz="800" spc="-1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2</a:t>
            </a:r>
            <a:r>
              <a:rPr sz="800" spc="-30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DAM </a:t>
            </a:r>
            <a:r>
              <a:rPr sz="800" spc="-204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5xFAD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32" name="object 132"/>
          <p:cNvSpPr txBox="1"/>
          <p:nvPr/>
        </p:nvSpPr>
        <p:spPr>
          <a:xfrm>
            <a:off x="1306315" y="1024640"/>
            <a:ext cx="1847027" cy="18299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25400">
              <a:lnSpc>
                <a:spcPct val="158800"/>
              </a:lnSpc>
              <a:spcBef>
                <a:spcPts val="100"/>
              </a:spcBef>
              <a:tabLst>
                <a:tab pos="1170305" algn="l"/>
              </a:tabLst>
            </a:pPr>
            <a:r>
              <a:rPr sz="800" spc="-5" dirty="0">
                <a:latin typeface="Arial"/>
                <a:cs typeface="Arial"/>
              </a:rPr>
              <a:t>Cortex, </a:t>
            </a:r>
            <a:r>
              <a:rPr sz="800" dirty="0">
                <a:latin typeface="Arial"/>
                <a:cs typeface="Arial"/>
              </a:rPr>
              <a:t>Homeostatic </a:t>
            </a:r>
            <a:r>
              <a:rPr sz="800" spc="-5" dirty="0">
                <a:latin typeface="Arial"/>
                <a:cs typeface="Arial"/>
              </a:rPr>
              <a:t>Microglia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135" name="object 135"/>
          <p:cNvSpPr/>
          <p:nvPr/>
        </p:nvSpPr>
        <p:spPr>
          <a:xfrm>
            <a:off x="3067050" y="1365551"/>
            <a:ext cx="381000" cy="245745"/>
          </a:xfrm>
          <a:custGeom>
            <a:avLst/>
            <a:gdLst/>
            <a:ahLst/>
            <a:cxnLst/>
            <a:rect l="l" t="t" r="r" b="b"/>
            <a:pathLst>
              <a:path w="381000" h="245744">
                <a:moveTo>
                  <a:pt x="0" y="60947"/>
                </a:moveTo>
                <a:lnTo>
                  <a:pt x="259029" y="60947"/>
                </a:lnTo>
                <a:lnTo>
                  <a:pt x="259029" y="0"/>
                </a:lnTo>
                <a:lnTo>
                  <a:pt x="380923" y="123418"/>
                </a:lnTo>
                <a:lnTo>
                  <a:pt x="259029" y="245325"/>
                </a:lnTo>
                <a:lnTo>
                  <a:pt x="259029" y="184365"/>
                </a:lnTo>
                <a:lnTo>
                  <a:pt x="0" y="184365"/>
                </a:lnTo>
                <a:lnTo>
                  <a:pt x="0" y="60947"/>
                </a:lnTo>
                <a:close/>
              </a:path>
            </a:pathLst>
          </a:custGeom>
          <a:solidFill>
            <a:schemeClr val="tx1"/>
          </a:solidFill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7" name="object 137"/>
          <p:cNvSpPr/>
          <p:nvPr/>
        </p:nvSpPr>
        <p:spPr>
          <a:xfrm>
            <a:off x="635369" y="1365551"/>
            <a:ext cx="381000" cy="245745"/>
          </a:xfrm>
          <a:custGeom>
            <a:avLst/>
            <a:gdLst/>
            <a:ahLst/>
            <a:cxnLst/>
            <a:rect l="l" t="t" r="r" b="b"/>
            <a:pathLst>
              <a:path w="381000" h="245744">
                <a:moveTo>
                  <a:pt x="380911" y="60947"/>
                </a:moveTo>
                <a:lnTo>
                  <a:pt x="121894" y="60947"/>
                </a:lnTo>
                <a:lnTo>
                  <a:pt x="121894" y="0"/>
                </a:lnTo>
                <a:lnTo>
                  <a:pt x="0" y="123418"/>
                </a:lnTo>
                <a:lnTo>
                  <a:pt x="121894" y="245325"/>
                </a:lnTo>
                <a:lnTo>
                  <a:pt x="121894" y="184365"/>
                </a:lnTo>
                <a:lnTo>
                  <a:pt x="380911" y="184365"/>
                </a:lnTo>
                <a:lnTo>
                  <a:pt x="380911" y="60947"/>
                </a:lnTo>
                <a:close/>
              </a:path>
            </a:pathLst>
          </a:custGeom>
          <a:solidFill>
            <a:schemeClr val="tx1"/>
          </a:solidFill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9" name="object 139"/>
          <p:cNvSpPr txBox="1"/>
          <p:nvPr/>
        </p:nvSpPr>
        <p:spPr>
          <a:xfrm>
            <a:off x="819227" y="1222268"/>
            <a:ext cx="18732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20" dirty="0">
                <a:latin typeface="Arial"/>
                <a:cs typeface="Arial"/>
              </a:rPr>
              <a:t>W</a:t>
            </a:r>
            <a:r>
              <a:rPr sz="800" dirty="0">
                <a:latin typeface="Arial"/>
                <a:cs typeface="Arial"/>
              </a:rPr>
              <a:t>T</a:t>
            </a:r>
          </a:p>
        </p:txBody>
      </p:sp>
      <p:sp>
        <p:nvSpPr>
          <p:cNvPr id="147" name="object 147"/>
          <p:cNvSpPr txBox="1"/>
          <p:nvPr/>
        </p:nvSpPr>
        <p:spPr>
          <a:xfrm>
            <a:off x="1855686" y="1340771"/>
            <a:ext cx="36131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dirty="0">
                <a:latin typeface="Arial"/>
                <a:cs typeface="Arial"/>
              </a:rPr>
              <a:t>V</a:t>
            </a:r>
            <a:r>
              <a:rPr sz="800" spc="-5" dirty="0">
                <a:latin typeface="Arial"/>
                <a:cs typeface="Arial"/>
              </a:rPr>
              <a:t>eh</a:t>
            </a:r>
            <a:r>
              <a:rPr sz="800" dirty="0">
                <a:latin typeface="Arial"/>
                <a:cs typeface="Arial"/>
              </a:rPr>
              <a:t>i</a:t>
            </a:r>
            <a:r>
              <a:rPr sz="800" spc="5" dirty="0">
                <a:latin typeface="Arial"/>
                <a:cs typeface="Arial"/>
              </a:rPr>
              <a:t>c</a:t>
            </a:r>
            <a:r>
              <a:rPr sz="800" dirty="0">
                <a:latin typeface="Arial"/>
                <a:cs typeface="Arial"/>
              </a:rPr>
              <a:t>le</a:t>
            </a:r>
          </a:p>
        </p:txBody>
      </p:sp>
      <p:sp>
        <p:nvSpPr>
          <p:cNvPr id="167" name="object 167"/>
          <p:cNvSpPr txBox="1"/>
          <p:nvPr/>
        </p:nvSpPr>
        <p:spPr>
          <a:xfrm>
            <a:off x="6394434" y="1228780"/>
            <a:ext cx="53657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Gossypetin</a:t>
            </a:r>
            <a:endParaRPr sz="800">
              <a:latin typeface="Arial"/>
              <a:cs typeface="Arial"/>
            </a:endParaRPr>
          </a:p>
        </p:txBody>
      </p:sp>
      <p:sp>
        <p:nvSpPr>
          <p:cNvPr id="175" name="object 175"/>
          <p:cNvSpPr txBox="1"/>
          <p:nvPr/>
        </p:nvSpPr>
        <p:spPr>
          <a:xfrm>
            <a:off x="5531287" y="1333214"/>
            <a:ext cx="33591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5</a:t>
            </a:r>
            <a:r>
              <a:rPr sz="800" spc="-20" dirty="0">
                <a:latin typeface="Arial"/>
                <a:cs typeface="Arial"/>
              </a:rPr>
              <a:t>x</a:t>
            </a:r>
            <a:r>
              <a:rPr sz="800" dirty="0">
                <a:latin typeface="Arial"/>
                <a:cs typeface="Arial"/>
              </a:rPr>
              <a:t>FAD</a:t>
            </a:r>
          </a:p>
        </p:txBody>
      </p:sp>
      <p:sp>
        <p:nvSpPr>
          <p:cNvPr id="190" name="object 190"/>
          <p:cNvSpPr txBox="1"/>
          <p:nvPr/>
        </p:nvSpPr>
        <p:spPr>
          <a:xfrm>
            <a:off x="524582" y="251056"/>
            <a:ext cx="478599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Arial"/>
                <a:cs typeface="Arial"/>
              </a:rPr>
              <a:t>Figure S5.</a:t>
            </a:r>
            <a:r>
              <a:rPr sz="800" b="1" spc="15" dirty="0">
                <a:latin typeface="Arial"/>
                <a:cs typeface="Arial"/>
              </a:rPr>
              <a:t> </a:t>
            </a:r>
            <a:r>
              <a:rPr sz="800" b="1" spc="-5" dirty="0">
                <a:latin typeface="Arial"/>
                <a:cs typeface="Arial"/>
              </a:rPr>
              <a:t>Transcriptomic</a:t>
            </a:r>
            <a:r>
              <a:rPr sz="800" b="1" spc="15" dirty="0">
                <a:latin typeface="Arial"/>
                <a:cs typeface="Arial"/>
              </a:rPr>
              <a:t> </a:t>
            </a:r>
            <a:r>
              <a:rPr sz="800" b="1" spc="-5" dirty="0">
                <a:latin typeface="Arial"/>
                <a:cs typeface="Arial"/>
              </a:rPr>
              <a:t>transition</a:t>
            </a:r>
            <a:r>
              <a:rPr sz="800" b="1" dirty="0">
                <a:latin typeface="Arial"/>
                <a:cs typeface="Arial"/>
              </a:rPr>
              <a:t> in </a:t>
            </a:r>
            <a:r>
              <a:rPr sz="800" b="1" spc="-5" dirty="0">
                <a:latin typeface="Arial"/>
                <a:cs typeface="Arial"/>
              </a:rPr>
              <a:t>cortex</a:t>
            </a:r>
            <a:r>
              <a:rPr sz="800" b="1" spc="25" dirty="0">
                <a:latin typeface="Arial"/>
                <a:cs typeface="Arial"/>
              </a:rPr>
              <a:t> </a:t>
            </a:r>
            <a:r>
              <a:rPr sz="800" b="1" dirty="0">
                <a:latin typeface="Arial"/>
                <a:cs typeface="Arial"/>
              </a:rPr>
              <a:t>microglia</a:t>
            </a:r>
            <a:r>
              <a:rPr sz="800" b="1" spc="-15" dirty="0">
                <a:latin typeface="Arial"/>
                <a:cs typeface="Arial"/>
              </a:rPr>
              <a:t> </a:t>
            </a:r>
            <a:r>
              <a:rPr sz="800" b="1" dirty="0">
                <a:latin typeface="Arial"/>
                <a:cs typeface="Arial"/>
              </a:rPr>
              <a:t>and</a:t>
            </a:r>
            <a:r>
              <a:rPr sz="800" b="1" spc="15" dirty="0">
                <a:latin typeface="Arial"/>
                <a:cs typeface="Arial"/>
              </a:rPr>
              <a:t> </a:t>
            </a:r>
            <a:r>
              <a:rPr sz="800" b="1" spc="-5" dirty="0">
                <a:latin typeface="Arial"/>
                <a:cs typeface="Arial"/>
              </a:rPr>
              <a:t>measurement</a:t>
            </a:r>
            <a:r>
              <a:rPr sz="800" b="1" spc="10" dirty="0">
                <a:latin typeface="Arial"/>
                <a:cs typeface="Arial"/>
              </a:rPr>
              <a:t> </a:t>
            </a:r>
            <a:r>
              <a:rPr sz="800" b="1" dirty="0">
                <a:latin typeface="Arial"/>
                <a:cs typeface="Arial"/>
              </a:rPr>
              <a:t>of</a:t>
            </a:r>
            <a:r>
              <a:rPr sz="800" b="1" spc="5" dirty="0">
                <a:latin typeface="Arial"/>
                <a:cs typeface="Arial"/>
              </a:rPr>
              <a:t> </a:t>
            </a:r>
            <a:r>
              <a:rPr sz="800" b="1" spc="-15" dirty="0">
                <a:latin typeface="Arial"/>
                <a:cs typeface="Arial"/>
              </a:rPr>
              <a:t>DAM</a:t>
            </a:r>
            <a:r>
              <a:rPr sz="800" b="1" spc="40" dirty="0">
                <a:latin typeface="Arial"/>
                <a:cs typeface="Arial"/>
              </a:rPr>
              <a:t> </a:t>
            </a:r>
            <a:r>
              <a:rPr sz="800" b="1" spc="-5" dirty="0">
                <a:latin typeface="Arial"/>
                <a:cs typeface="Arial"/>
              </a:rPr>
              <a:t>signature</a:t>
            </a:r>
            <a:r>
              <a:rPr sz="800" b="1" spc="15" dirty="0">
                <a:latin typeface="Arial"/>
                <a:cs typeface="Arial"/>
              </a:rPr>
              <a:t> </a:t>
            </a:r>
            <a:r>
              <a:rPr sz="800" b="1" spc="-5" dirty="0">
                <a:latin typeface="Arial"/>
                <a:cs typeface="Arial"/>
              </a:rPr>
              <a:t>score</a:t>
            </a:r>
            <a:endParaRPr sz="800">
              <a:latin typeface="Arial"/>
              <a:cs typeface="Arial"/>
            </a:endParaRPr>
          </a:p>
        </p:txBody>
      </p:sp>
      <p:sp>
        <p:nvSpPr>
          <p:cNvPr id="193" name="object 193"/>
          <p:cNvSpPr txBox="1"/>
          <p:nvPr/>
        </p:nvSpPr>
        <p:spPr>
          <a:xfrm>
            <a:off x="1330886" y="6013331"/>
            <a:ext cx="142240" cy="545465"/>
          </a:xfrm>
          <a:prstGeom prst="rect">
            <a:avLst/>
          </a:prstGeom>
        </p:spPr>
        <p:txBody>
          <a:bodyPr vert="vert270" wrap="square" lIns="0" tIns="44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35"/>
              </a:spcBef>
            </a:pPr>
            <a:r>
              <a:rPr sz="800" spc="-5" dirty="0">
                <a:latin typeface="Arial"/>
                <a:cs typeface="Arial"/>
              </a:rPr>
              <a:t>DA</a:t>
            </a:r>
            <a:r>
              <a:rPr sz="800" dirty="0">
                <a:latin typeface="Arial"/>
                <a:cs typeface="Arial"/>
              </a:rPr>
              <a:t>M</a:t>
            </a:r>
            <a:r>
              <a:rPr sz="800" spc="-10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Score</a:t>
            </a:r>
            <a:endParaRPr sz="800">
              <a:latin typeface="Arial"/>
              <a:cs typeface="Arial"/>
            </a:endParaRPr>
          </a:p>
        </p:txBody>
      </p:sp>
      <p:grpSp>
        <p:nvGrpSpPr>
          <p:cNvPr id="250" name="그룹 249">
            <a:extLst>
              <a:ext uri="{FF2B5EF4-FFF2-40B4-BE49-F238E27FC236}">
                <a16:creationId xmlns:a16="http://schemas.microsoft.com/office/drawing/2014/main" id="{78D4D9E3-A026-EA55-74AB-CE5F225EBB6A}"/>
              </a:ext>
            </a:extLst>
          </p:cNvPr>
          <p:cNvGrpSpPr/>
          <p:nvPr/>
        </p:nvGrpSpPr>
        <p:grpSpPr>
          <a:xfrm>
            <a:off x="396345" y="1493551"/>
            <a:ext cx="3103180" cy="1322111"/>
            <a:chOff x="0" y="1376986"/>
            <a:chExt cx="12254168" cy="5220891"/>
          </a:xfrm>
        </p:grpSpPr>
        <p:pic>
          <p:nvPicPr>
            <p:cNvPr id="251" name="그림 250">
              <a:extLst>
                <a:ext uri="{FF2B5EF4-FFF2-40B4-BE49-F238E27FC236}">
                  <a16:creationId xmlns:a16="http://schemas.microsoft.com/office/drawing/2014/main" id="{23519E4B-0B6C-2972-F3B8-76134BF008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tretch>
              <a:fillRect/>
            </a:stretch>
          </p:blipFill>
          <p:spPr>
            <a:xfrm>
              <a:off x="0" y="1376986"/>
              <a:ext cx="12192000" cy="5220891"/>
            </a:xfrm>
            <a:prstGeom prst="rect">
              <a:avLst/>
            </a:prstGeom>
          </p:spPr>
        </p:pic>
        <p:cxnSp>
          <p:nvCxnSpPr>
            <p:cNvPr id="252" name="직선 연결선 251">
              <a:extLst>
                <a:ext uri="{FF2B5EF4-FFF2-40B4-BE49-F238E27FC236}">
                  <a16:creationId xmlns:a16="http://schemas.microsoft.com/office/drawing/2014/main" id="{E498DB99-FED5-8E45-66AC-CF16C1974894}"/>
                </a:ext>
              </a:extLst>
            </p:cNvPr>
            <p:cNvCxnSpPr/>
            <p:nvPr/>
          </p:nvCxnSpPr>
          <p:spPr>
            <a:xfrm rot="10800000">
              <a:off x="9982806" y="3352800"/>
              <a:ext cx="915436" cy="431749"/>
            </a:xfrm>
            <a:prstGeom prst="line">
              <a:avLst/>
            </a:prstGeom>
            <a:ln w="3175">
              <a:solidFill>
                <a:schemeClr val="dk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16A8DAC1-CD3B-3D27-4ADB-E8E515210FE8}"/>
                </a:ext>
              </a:extLst>
            </p:cNvPr>
            <p:cNvSpPr txBox="1"/>
            <p:nvPr/>
          </p:nvSpPr>
          <p:spPr>
            <a:xfrm>
              <a:off x="10680339" y="3592428"/>
              <a:ext cx="1573829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en-US" altLang="ko-KR" sz="700" i="1" dirty="0" err="1">
                  <a:latin typeface="Arial"/>
                  <a:cs typeface="Arial"/>
                </a:rPr>
                <a:t>Apoe</a:t>
              </a:r>
              <a:endParaRPr lang="en-US" altLang="ko-KR" sz="700" i="1" dirty="0">
                <a:latin typeface="Arial"/>
                <a:cs typeface="Arial"/>
              </a:endParaRPr>
            </a:p>
          </p:txBody>
        </p:sp>
        <p:cxnSp>
          <p:nvCxnSpPr>
            <p:cNvPr id="254" name="직선 연결선 253">
              <a:extLst>
                <a:ext uri="{FF2B5EF4-FFF2-40B4-BE49-F238E27FC236}">
                  <a16:creationId xmlns:a16="http://schemas.microsoft.com/office/drawing/2014/main" id="{5F07F218-BEB8-4E6F-5CA2-B9EB570F0635}"/>
                </a:ext>
              </a:extLst>
            </p:cNvPr>
            <p:cNvCxnSpPr/>
            <p:nvPr/>
          </p:nvCxnSpPr>
          <p:spPr>
            <a:xfrm rot="10800000">
              <a:off x="4988802" y="5336581"/>
              <a:ext cx="896288" cy="152398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91790754-C2B4-CA77-76B4-E15291B7D324}"/>
                </a:ext>
              </a:extLst>
            </p:cNvPr>
            <p:cNvSpPr txBox="1"/>
            <p:nvPr/>
          </p:nvSpPr>
          <p:spPr>
            <a:xfrm>
              <a:off x="3334808" y="4941576"/>
              <a:ext cx="1851686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P2ry12</a:t>
              </a:r>
            </a:p>
          </p:txBody>
        </p:sp>
        <p:cxnSp>
          <p:nvCxnSpPr>
            <p:cNvPr id="256" name="직선 연결선 255">
              <a:extLst>
                <a:ext uri="{FF2B5EF4-FFF2-40B4-BE49-F238E27FC236}">
                  <a16:creationId xmlns:a16="http://schemas.microsoft.com/office/drawing/2014/main" id="{70753116-12A0-DE50-E1B7-3BC1607822A6}"/>
                </a:ext>
              </a:extLst>
            </p:cNvPr>
            <p:cNvCxnSpPr/>
            <p:nvPr/>
          </p:nvCxnSpPr>
          <p:spPr>
            <a:xfrm flipV="1">
              <a:off x="7982112" y="4327138"/>
              <a:ext cx="822925" cy="218937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7F782B61-6AF1-F7F6-41DF-25F91D60C2AF}"/>
                </a:ext>
              </a:extLst>
            </p:cNvPr>
            <p:cNvSpPr txBox="1"/>
            <p:nvPr/>
          </p:nvSpPr>
          <p:spPr>
            <a:xfrm>
              <a:off x="8728833" y="4101731"/>
              <a:ext cx="1573833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Ftl1</a:t>
              </a:r>
            </a:p>
          </p:txBody>
        </p:sp>
        <p:cxnSp>
          <p:nvCxnSpPr>
            <p:cNvPr id="258" name="직선 연결선 257">
              <a:extLst>
                <a:ext uri="{FF2B5EF4-FFF2-40B4-BE49-F238E27FC236}">
                  <a16:creationId xmlns:a16="http://schemas.microsoft.com/office/drawing/2014/main" id="{05365E7E-2DB9-8C39-DA9C-F4570BAB9F58}"/>
                </a:ext>
              </a:extLst>
            </p:cNvPr>
            <p:cNvCxnSpPr/>
            <p:nvPr/>
          </p:nvCxnSpPr>
          <p:spPr>
            <a:xfrm rot="5400000" flipH="1" flipV="1">
              <a:off x="6950533" y="3748774"/>
              <a:ext cx="1471542" cy="439216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1E5B7F01-3D90-ECB0-2799-47061309B86D}"/>
                </a:ext>
              </a:extLst>
            </p:cNvPr>
            <p:cNvSpPr txBox="1"/>
            <p:nvPr/>
          </p:nvSpPr>
          <p:spPr>
            <a:xfrm>
              <a:off x="6922335" y="2479473"/>
              <a:ext cx="2493284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H2-DMa</a:t>
              </a:r>
            </a:p>
          </p:txBody>
        </p:sp>
        <p:cxnSp>
          <p:nvCxnSpPr>
            <p:cNvPr id="260" name="직선 연결선 259">
              <a:extLst>
                <a:ext uri="{FF2B5EF4-FFF2-40B4-BE49-F238E27FC236}">
                  <a16:creationId xmlns:a16="http://schemas.microsoft.com/office/drawing/2014/main" id="{53E0837C-8C81-5567-DA0A-28B4DDEF2E37}"/>
                </a:ext>
              </a:extLst>
            </p:cNvPr>
            <p:cNvCxnSpPr>
              <a:cxnSpLocks/>
            </p:cNvCxnSpPr>
            <p:nvPr/>
          </p:nvCxnSpPr>
          <p:spPr>
            <a:xfrm>
              <a:off x="3030284" y="1697866"/>
              <a:ext cx="1221831" cy="460067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3EF9C943-B06A-8CB3-B4F2-BF9D722EDD4E}"/>
                </a:ext>
              </a:extLst>
            </p:cNvPr>
            <p:cNvSpPr txBox="1"/>
            <p:nvPr/>
          </p:nvSpPr>
          <p:spPr>
            <a:xfrm>
              <a:off x="3772655" y="1762928"/>
              <a:ext cx="1682704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 err="1">
                  <a:solidFill>
                    <a:srgbClr val="000000"/>
                  </a:solidFill>
                  <a:latin typeface="Arial"/>
                  <a:cs typeface="Arial"/>
                </a:rPr>
                <a:t>Gatm</a:t>
              </a:r>
              <a:endParaRPr kumimoji="0" lang="en-US" altLang="ko-KR" sz="700" b="0" i="1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262" name="직선 연결선 261">
              <a:extLst>
                <a:ext uri="{FF2B5EF4-FFF2-40B4-BE49-F238E27FC236}">
                  <a16:creationId xmlns:a16="http://schemas.microsoft.com/office/drawing/2014/main" id="{BFD86309-B844-EBC8-2FD6-B737C2070D8D}"/>
                </a:ext>
              </a:extLst>
            </p:cNvPr>
            <p:cNvCxnSpPr/>
            <p:nvPr/>
          </p:nvCxnSpPr>
          <p:spPr>
            <a:xfrm rot="16200000" flipV="1">
              <a:off x="5212991" y="4529770"/>
              <a:ext cx="1041461" cy="495957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B8EE967F-6043-DBF1-4F30-C2FE469D47F5}"/>
                </a:ext>
              </a:extLst>
            </p:cNvPr>
            <p:cNvSpPr txBox="1"/>
            <p:nvPr/>
          </p:nvSpPr>
          <p:spPr>
            <a:xfrm>
              <a:off x="4381802" y="3555609"/>
              <a:ext cx="1899148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Cx3cr1</a:t>
              </a:r>
            </a:p>
          </p:txBody>
        </p:sp>
      </p:grpSp>
      <p:grpSp>
        <p:nvGrpSpPr>
          <p:cNvPr id="264" name="그룹 263">
            <a:extLst>
              <a:ext uri="{FF2B5EF4-FFF2-40B4-BE49-F238E27FC236}">
                <a16:creationId xmlns:a16="http://schemas.microsoft.com/office/drawing/2014/main" id="{80E34878-77A3-9DF8-F627-794218E16096}"/>
              </a:ext>
            </a:extLst>
          </p:cNvPr>
          <p:cNvGrpSpPr/>
          <p:nvPr/>
        </p:nvGrpSpPr>
        <p:grpSpPr>
          <a:xfrm>
            <a:off x="4031028" y="1493551"/>
            <a:ext cx="3087438" cy="1322111"/>
            <a:chOff x="0" y="1417638"/>
            <a:chExt cx="12192000" cy="5220891"/>
          </a:xfrm>
        </p:grpSpPr>
        <p:pic>
          <p:nvPicPr>
            <p:cNvPr id="265" name="그림 264">
              <a:extLst>
                <a:ext uri="{FF2B5EF4-FFF2-40B4-BE49-F238E27FC236}">
                  <a16:creationId xmlns:a16="http://schemas.microsoft.com/office/drawing/2014/main" id="{1BCDFF4F-577B-43E6-4DAE-A8EEEEA1E2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tretch>
              <a:fillRect/>
            </a:stretch>
          </p:blipFill>
          <p:spPr>
            <a:xfrm>
              <a:off x="0" y="1417638"/>
              <a:ext cx="12192000" cy="5220891"/>
            </a:xfrm>
            <a:prstGeom prst="rect">
              <a:avLst/>
            </a:prstGeom>
          </p:spPr>
        </p:pic>
        <p:cxnSp>
          <p:nvCxnSpPr>
            <p:cNvPr id="266" name="직선 연결선 265">
              <a:extLst>
                <a:ext uri="{FF2B5EF4-FFF2-40B4-BE49-F238E27FC236}">
                  <a16:creationId xmlns:a16="http://schemas.microsoft.com/office/drawing/2014/main" id="{8C9AB3E3-19D3-0C18-7D56-2FAC1F5734CB}"/>
                </a:ext>
              </a:extLst>
            </p:cNvPr>
            <p:cNvCxnSpPr/>
            <p:nvPr/>
          </p:nvCxnSpPr>
          <p:spPr>
            <a:xfrm rot="16200000" flipV="1">
              <a:off x="5069343" y="4333328"/>
              <a:ext cx="2034264" cy="517071"/>
            </a:xfrm>
            <a:prstGeom prst="line">
              <a:avLst/>
            </a:prstGeom>
            <a:ln w="3175">
              <a:solidFill>
                <a:schemeClr val="dk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0EF91461-0227-16BD-2A80-87802E4B3366}"/>
                </a:ext>
              </a:extLst>
            </p:cNvPr>
            <p:cNvSpPr txBox="1"/>
            <p:nvPr/>
          </p:nvSpPr>
          <p:spPr>
            <a:xfrm>
              <a:off x="4625562" y="2856659"/>
              <a:ext cx="1990912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en-US" altLang="ko-KR" sz="700" i="1" dirty="0">
                  <a:latin typeface="Arial"/>
                  <a:cs typeface="Arial"/>
                </a:rPr>
                <a:t>Spp1</a:t>
              </a:r>
            </a:p>
          </p:txBody>
        </p:sp>
        <p:cxnSp>
          <p:nvCxnSpPr>
            <p:cNvPr id="268" name="직선 연결선 267">
              <a:extLst>
                <a:ext uri="{FF2B5EF4-FFF2-40B4-BE49-F238E27FC236}">
                  <a16:creationId xmlns:a16="http://schemas.microsoft.com/office/drawing/2014/main" id="{26F6D968-3655-909D-B3B1-B2C11838C2A7}"/>
                </a:ext>
              </a:extLst>
            </p:cNvPr>
            <p:cNvCxnSpPr/>
            <p:nvPr/>
          </p:nvCxnSpPr>
          <p:spPr>
            <a:xfrm rot="5400000" flipH="1" flipV="1">
              <a:off x="6232755" y="5227041"/>
              <a:ext cx="767438" cy="1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B5F48BC0-D217-2584-F8C3-02F8C661560C}"/>
                </a:ext>
              </a:extLst>
            </p:cNvPr>
            <p:cNvSpPr txBox="1"/>
            <p:nvPr/>
          </p:nvSpPr>
          <p:spPr>
            <a:xfrm>
              <a:off x="6008678" y="4161270"/>
              <a:ext cx="1202655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 err="1">
                  <a:solidFill>
                    <a:srgbClr val="000000"/>
                  </a:solidFill>
                  <a:latin typeface="Arial"/>
                  <a:cs typeface="Arial"/>
                </a:rPr>
                <a:t>Lpl</a:t>
              </a:r>
              <a:endParaRPr kumimoji="0" lang="en-US" altLang="ko-KR" sz="700" b="0" i="1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270" name="직선 연결선 269">
              <a:extLst>
                <a:ext uri="{FF2B5EF4-FFF2-40B4-BE49-F238E27FC236}">
                  <a16:creationId xmlns:a16="http://schemas.microsoft.com/office/drawing/2014/main" id="{A302D68B-DF47-6C7F-84BD-7EBDAC02EC4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717945" y="5205823"/>
              <a:ext cx="1413511" cy="433582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5801AF42-FB21-2094-05C2-ADCF70AE3D98}"/>
                </a:ext>
              </a:extLst>
            </p:cNvPr>
            <p:cNvSpPr txBox="1"/>
            <p:nvPr/>
          </p:nvSpPr>
          <p:spPr>
            <a:xfrm>
              <a:off x="7744372" y="4810826"/>
              <a:ext cx="1847859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Trem2</a:t>
              </a:r>
            </a:p>
          </p:txBody>
        </p:sp>
        <p:cxnSp>
          <p:nvCxnSpPr>
            <p:cNvPr id="272" name="직선 연결선 271">
              <a:extLst>
                <a:ext uri="{FF2B5EF4-FFF2-40B4-BE49-F238E27FC236}">
                  <a16:creationId xmlns:a16="http://schemas.microsoft.com/office/drawing/2014/main" id="{D12B4217-AEC2-2B76-B532-D047CD682906}"/>
                </a:ext>
              </a:extLst>
            </p:cNvPr>
            <p:cNvCxnSpPr/>
            <p:nvPr/>
          </p:nvCxnSpPr>
          <p:spPr>
            <a:xfrm flipV="1">
              <a:off x="6906775" y="4904386"/>
              <a:ext cx="822925" cy="218937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D71044A9-EE31-A2B2-7EA7-6FE6CB6D78F8}"/>
                </a:ext>
              </a:extLst>
            </p:cNvPr>
            <p:cNvSpPr txBox="1"/>
            <p:nvPr/>
          </p:nvSpPr>
          <p:spPr>
            <a:xfrm>
              <a:off x="7362355" y="4304489"/>
              <a:ext cx="2085393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Clec7a</a:t>
              </a:r>
            </a:p>
          </p:txBody>
        </p:sp>
        <p:cxnSp>
          <p:nvCxnSpPr>
            <p:cNvPr id="274" name="직선 연결선 273">
              <a:extLst>
                <a:ext uri="{FF2B5EF4-FFF2-40B4-BE49-F238E27FC236}">
                  <a16:creationId xmlns:a16="http://schemas.microsoft.com/office/drawing/2014/main" id="{02E4C264-9465-A1A8-B8EE-33473502BA1A}"/>
                </a:ext>
              </a:extLst>
            </p:cNvPr>
            <p:cNvCxnSpPr/>
            <p:nvPr/>
          </p:nvCxnSpPr>
          <p:spPr>
            <a:xfrm rot="5400000" flipH="1" flipV="1">
              <a:off x="6902908" y="3767824"/>
              <a:ext cx="1471542" cy="439216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A832C841-9011-18BF-304B-F916BBA7CE5B}"/>
                </a:ext>
              </a:extLst>
            </p:cNvPr>
            <p:cNvSpPr txBox="1"/>
            <p:nvPr/>
          </p:nvSpPr>
          <p:spPr>
            <a:xfrm>
              <a:off x="6966007" y="2520125"/>
              <a:ext cx="2481741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H2-DMa</a:t>
              </a:r>
            </a:p>
          </p:txBody>
        </p:sp>
        <p:cxnSp>
          <p:nvCxnSpPr>
            <p:cNvPr id="276" name="직선 연결선 275">
              <a:extLst>
                <a:ext uri="{FF2B5EF4-FFF2-40B4-BE49-F238E27FC236}">
                  <a16:creationId xmlns:a16="http://schemas.microsoft.com/office/drawing/2014/main" id="{04A4E8BC-9E4E-525B-F96A-69521ABFEAEB}"/>
                </a:ext>
              </a:extLst>
            </p:cNvPr>
            <p:cNvCxnSpPr/>
            <p:nvPr/>
          </p:nvCxnSpPr>
          <p:spPr>
            <a:xfrm rot="16200000" flipH="1">
              <a:off x="3006012" y="1981109"/>
              <a:ext cx="713689" cy="242455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3779AFA9-4A95-9ECB-E5FC-69E17F926B20}"/>
                </a:ext>
              </a:extLst>
            </p:cNvPr>
            <p:cNvSpPr txBox="1"/>
            <p:nvPr/>
          </p:nvSpPr>
          <p:spPr>
            <a:xfrm>
              <a:off x="2963614" y="2459181"/>
              <a:ext cx="1494763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Ftl1</a:t>
              </a:r>
            </a:p>
          </p:txBody>
        </p:sp>
        <p:cxnSp>
          <p:nvCxnSpPr>
            <p:cNvPr id="278" name="직선 연결선 277">
              <a:extLst>
                <a:ext uri="{FF2B5EF4-FFF2-40B4-BE49-F238E27FC236}">
                  <a16:creationId xmlns:a16="http://schemas.microsoft.com/office/drawing/2014/main" id="{ECB88DAF-EF71-9DEC-397B-F3E5FDE549F4}"/>
                </a:ext>
              </a:extLst>
            </p:cNvPr>
            <p:cNvCxnSpPr/>
            <p:nvPr/>
          </p:nvCxnSpPr>
          <p:spPr>
            <a:xfrm rot="10800000" flipV="1">
              <a:off x="4736931" y="4871897"/>
              <a:ext cx="797130" cy="283776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10271F40-FD5B-C651-C4EB-71DE1DD99B7A}"/>
                </a:ext>
              </a:extLst>
            </p:cNvPr>
            <p:cNvSpPr txBox="1"/>
            <p:nvPr/>
          </p:nvSpPr>
          <p:spPr>
            <a:xfrm>
              <a:off x="3124208" y="4885839"/>
              <a:ext cx="1883039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 err="1">
                  <a:solidFill>
                    <a:srgbClr val="000000"/>
                  </a:solidFill>
                  <a:latin typeface="Arial"/>
                  <a:cs typeface="Arial"/>
                </a:rPr>
                <a:t>Siglech</a:t>
              </a:r>
              <a:endParaRPr kumimoji="0" lang="en-US" altLang="ko-KR" sz="700" b="0" i="1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280" name="그룹 279">
            <a:extLst>
              <a:ext uri="{FF2B5EF4-FFF2-40B4-BE49-F238E27FC236}">
                <a16:creationId xmlns:a16="http://schemas.microsoft.com/office/drawing/2014/main" id="{A5F32B85-4733-0867-5DC2-64625AFD8843}"/>
              </a:ext>
            </a:extLst>
          </p:cNvPr>
          <p:cNvGrpSpPr/>
          <p:nvPr/>
        </p:nvGrpSpPr>
        <p:grpSpPr>
          <a:xfrm>
            <a:off x="396344" y="3494194"/>
            <a:ext cx="3087438" cy="1322111"/>
            <a:chOff x="0" y="1376986"/>
            <a:chExt cx="12192000" cy="5220891"/>
          </a:xfrm>
        </p:grpSpPr>
        <p:pic>
          <p:nvPicPr>
            <p:cNvPr id="281" name="그림 280">
              <a:extLst>
                <a:ext uri="{FF2B5EF4-FFF2-40B4-BE49-F238E27FC236}">
                  <a16:creationId xmlns:a16="http://schemas.microsoft.com/office/drawing/2014/main" id="{0156D5E8-D260-DAF5-C61B-3A6C366C35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tretch>
              <a:fillRect/>
            </a:stretch>
          </p:blipFill>
          <p:spPr>
            <a:xfrm>
              <a:off x="0" y="1376986"/>
              <a:ext cx="12192000" cy="5220891"/>
            </a:xfrm>
            <a:prstGeom prst="rect">
              <a:avLst/>
            </a:prstGeom>
          </p:spPr>
        </p:pic>
        <p:cxnSp>
          <p:nvCxnSpPr>
            <p:cNvPr id="282" name="직선 연결선 281">
              <a:extLst>
                <a:ext uri="{FF2B5EF4-FFF2-40B4-BE49-F238E27FC236}">
                  <a16:creationId xmlns:a16="http://schemas.microsoft.com/office/drawing/2014/main" id="{71C95DCB-6907-8ADE-070B-4462208268CF}"/>
                </a:ext>
              </a:extLst>
            </p:cNvPr>
            <p:cNvCxnSpPr/>
            <p:nvPr/>
          </p:nvCxnSpPr>
          <p:spPr>
            <a:xfrm flipV="1">
              <a:off x="7346812" y="4544239"/>
              <a:ext cx="1266981" cy="882690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2D0E126F-5117-1D57-3ACB-9B22696F5A87}"/>
                </a:ext>
              </a:extLst>
            </p:cNvPr>
            <p:cNvSpPr txBox="1"/>
            <p:nvPr/>
          </p:nvSpPr>
          <p:spPr>
            <a:xfrm>
              <a:off x="8349111" y="4092411"/>
              <a:ext cx="2133013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H2-DMa</a:t>
              </a:r>
            </a:p>
          </p:txBody>
        </p:sp>
        <p:cxnSp>
          <p:nvCxnSpPr>
            <p:cNvPr id="284" name="직선 연결선 283">
              <a:extLst>
                <a:ext uri="{FF2B5EF4-FFF2-40B4-BE49-F238E27FC236}">
                  <a16:creationId xmlns:a16="http://schemas.microsoft.com/office/drawing/2014/main" id="{0234A255-E5B0-F87E-B081-CF81E1F177FB}"/>
                </a:ext>
              </a:extLst>
            </p:cNvPr>
            <p:cNvCxnSpPr/>
            <p:nvPr/>
          </p:nvCxnSpPr>
          <p:spPr>
            <a:xfrm flipV="1">
              <a:off x="7504796" y="4882410"/>
              <a:ext cx="1365850" cy="519926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0AB1B3AD-F726-FE63-C36B-46304E4F5FBD}"/>
                </a:ext>
              </a:extLst>
            </p:cNvPr>
            <p:cNvSpPr txBox="1"/>
            <p:nvPr/>
          </p:nvSpPr>
          <p:spPr>
            <a:xfrm>
              <a:off x="8392438" y="4489047"/>
              <a:ext cx="1661454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 err="1">
                  <a:solidFill>
                    <a:srgbClr val="000000"/>
                  </a:solidFill>
                  <a:latin typeface="Arial"/>
                  <a:cs typeface="Arial"/>
                </a:rPr>
                <a:t>Lpl</a:t>
              </a:r>
              <a:endParaRPr kumimoji="0" lang="en-US" altLang="ko-KR" sz="700" b="0" i="1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286" name="직선 연결선 285">
              <a:extLst>
                <a:ext uri="{FF2B5EF4-FFF2-40B4-BE49-F238E27FC236}">
                  <a16:creationId xmlns:a16="http://schemas.microsoft.com/office/drawing/2014/main" id="{539F07E0-12B4-81FA-EE9B-B9C243C32B51}"/>
                </a:ext>
              </a:extLst>
            </p:cNvPr>
            <p:cNvCxnSpPr/>
            <p:nvPr/>
          </p:nvCxnSpPr>
          <p:spPr>
            <a:xfrm flipV="1">
              <a:off x="8330608" y="3949331"/>
              <a:ext cx="622887" cy="566332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63F303BC-78CC-CE13-94B8-A2361976ED26}"/>
                </a:ext>
              </a:extLst>
            </p:cNvPr>
            <p:cNvSpPr txBox="1"/>
            <p:nvPr/>
          </p:nvSpPr>
          <p:spPr>
            <a:xfrm>
              <a:off x="8463850" y="3331876"/>
              <a:ext cx="2103795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Clec7a</a:t>
              </a:r>
            </a:p>
          </p:txBody>
        </p:sp>
        <p:cxnSp>
          <p:nvCxnSpPr>
            <p:cNvPr id="288" name="직선 연결선 287">
              <a:extLst>
                <a:ext uri="{FF2B5EF4-FFF2-40B4-BE49-F238E27FC236}">
                  <a16:creationId xmlns:a16="http://schemas.microsoft.com/office/drawing/2014/main" id="{FD04D1F0-4A28-29AE-48BC-0E8A44E8EE99}"/>
                </a:ext>
              </a:extLst>
            </p:cNvPr>
            <p:cNvCxnSpPr/>
            <p:nvPr/>
          </p:nvCxnSpPr>
          <p:spPr>
            <a:xfrm rot="10800000">
              <a:off x="4742248" y="5142373"/>
              <a:ext cx="943110" cy="447235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954BF5DB-71B4-C269-57DF-8A3940444AF4}"/>
                </a:ext>
              </a:extLst>
            </p:cNvPr>
            <p:cNvSpPr txBox="1"/>
            <p:nvPr/>
          </p:nvSpPr>
          <p:spPr>
            <a:xfrm>
              <a:off x="3432681" y="4696463"/>
              <a:ext cx="1692761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 err="1">
                  <a:solidFill>
                    <a:srgbClr val="000000"/>
                  </a:solidFill>
                  <a:latin typeface="Arial"/>
                  <a:cs typeface="Arial"/>
                </a:rPr>
                <a:t>Apoe</a:t>
              </a:r>
              <a:endParaRPr kumimoji="0" lang="en-US" altLang="ko-KR" sz="700" b="0" i="1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290" name="직선 연결선 289">
              <a:extLst>
                <a:ext uri="{FF2B5EF4-FFF2-40B4-BE49-F238E27FC236}">
                  <a16:creationId xmlns:a16="http://schemas.microsoft.com/office/drawing/2014/main" id="{C36B1AEE-3A05-B0CE-8F29-6D839DC052F1}"/>
                </a:ext>
              </a:extLst>
            </p:cNvPr>
            <p:cNvCxnSpPr>
              <a:cxnSpLocks/>
            </p:cNvCxnSpPr>
            <p:nvPr/>
          </p:nvCxnSpPr>
          <p:spPr>
            <a:xfrm>
              <a:off x="2038472" y="1716916"/>
              <a:ext cx="1430179" cy="255068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5691B985-F30F-F4B3-E496-350FD91011B1}"/>
                </a:ext>
              </a:extLst>
            </p:cNvPr>
            <p:cNvSpPr txBox="1"/>
            <p:nvPr/>
          </p:nvSpPr>
          <p:spPr>
            <a:xfrm>
              <a:off x="3152719" y="1601533"/>
              <a:ext cx="1512292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Ftl1</a:t>
              </a:r>
            </a:p>
          </p:txBody>
        </p:sp>
        <p:cxnSp>
          <p:nvCxnSpPr>
            <p:cNvPr id="292" name="직선 연결선 291">
              <a:extLst>
                <a:ext uri="{FF2B5EF4-FFF2-40B4-BE49-F238E27FC236}">
                  <a16:creationId xmlns:a16="http://schemas.microsoft.com/office/drawing/2014/main" id="{7C478144-1161-9AF2-409E-81FA95007960}"/>
                </a:ext>
              </a:extLst>
            </p:cNvPr>
            <p:cNvCxnSpPr/>
            <p:nvPr/>
          </p:nvCxnSpPr>
          <p:spPr>
            <a:xfrm rot="10800000" flipV="1">
              <a:off x="3945118" y="4260462"/>
              <a:ext cx="797130" cy="283776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0024E53F-644E-8357-AF21-1E9B0A23E8CD}"/>
                </a:ext>
              </a:extLst>
            </p:cNvPr>
            <p:cNvSpPr txBox="1"/>
            <p:nvPr/>
          </p:nvSpPr>
          <p:spPr>
            <a:xfrm>
              <a:off x="2586296" y="4149240"/>
              <a:ext cx="1692761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Spp1</a:t>
              </a:r>
            </a:p>
          </p:txBody>
        </p:sp>
      </p:grpSp>
      <p:grpSp>
        <p:nvGrpSpPr>
          <p:cNvPr id="294" name="그룹 293">
            <a:extLst>
              <a:ext uri="{FF2B5EF4-FFF2-40B4-BE49-F238E27FC236}">
                <a16:creationId xmlns:a16="http://schemas.microsoft.com/office/drawing/2014/main" id="{7A4C81F3-01D6-E403-85BC-2ECC869C0402}"/>
              </a:ext>
            </a:extLst>
          </p:cNvPr>
          <p:cNvGrpSpPr/>
          <p:nvPr/>
        </p:nvGrpSpPr>
        <p:grpSpPr>
          <a:xfrm>
            <a:off x="4031029" y="3494193"/>
            <a:ext cx="3087437" cy="1322111"/>
            <a:chOff x="0" y="1338886"/>
            <a:chExt cx="12192000" cy="5220891"/>
          </a:xfrm>
        </p:grpSpPr>
        <p:pic>
          <p:nvPicPr>
            <p:cNvPr id="295" name="그림 294">
              <a:extLst>
                <a:ext uri="{FF2B5EF4-FFF2-40B4-BE49-F238E27FC236}">
                  <a16:creationId xmlns:a16="http://schemas.microsoft.com/office/drawing/2014/main" id="{D1F44FEB-8764-18E5-8EB7-0077B4D612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tretch>
              <a:fillRect/>
            </a:stretch>
          </p:blipFill>
          <p:spPr>
            <a:xfrm>
              <a:off x="0" y="1338886"/>
              <a:ext cx="12192000" cy="5220891"/>
            </a:xfrm>
            <a:prstGeom prst="rect">
              <a:avLst/>
            </a:prstGeom>
          </p:spPr>
        </p:pic>
        <p:cxnSp>
          <p:nvCxnSpPr>
            <p:cNvPr id="296" name="직선 연결선 295">
              <a:extLst>
                <a:ext uri="{FF2B5EF4-FFF2-40B4-BE49-F238E27FC236}">
                  <a16:creationId xmlns:a16="http://schemas.microsoft.com/office/drawing/2014/main" id="{125F624C-8629-B457-4F0A-590A0EDE336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46810" y="4767385"/>
              <a:ext cx="226035" cy="789998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97" name="TextBox 296">
              <a:extLst>
                <a:ext uri="{FF2B5EF4-FFF2-40B4-BE49-F238E27FC236}">
                  <a16:creationId xmlns:a16="http://schemas.microsoft.com/office/drawing/2014/main" id="{F00D9F03-0C63-709F-10EC-BE44C676AB08}"/>
                </a:ext>
              </a:extLst>
            </p:cNvPr>
            <p:cNvSpPr txBox="1"/>
            <p:nvPr/>
          </p:nvSpPr>
          <p:spPr>
            <a:xfrm>
              <a:off x="6587629" y="3922706"/>
              <a:ext cx="2102098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H2-DMa</a:t>
              </a:r>
            </a:p>
          </p:txBody>
        </p:sp>
        <p:cxnSp>
          <p:nvCxnSpPr>
            <p:cNvPr id="298" name="직선 연결선 297">
              <a:extLst>
                <a:ext uri="{FF2B5EF4-FFF2-40B4-BE49-F238E27FC236}">
                  <a16:creationId xmlns:a16="http://schemas.microsoft.com/office/drawing/2014/main" id="{BD2E30CC-8BB1-E563-ADB8-393BA655DF05}"/>
                </a:ext>
              </a:extLst>
            </p:cNvPr>
            <p:cNvCxnSpPr/>
            <p:nvPr/>
          </p:nvCxnSpPr>
          <p:spPr>
            <a:xfrm flipV="1">
              <a:off x="7562473" y="5425539"/>
              <a:ext cx="1571793" cy="181852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id="{6EFF9046-2DCA-92AD-8CEA-6ACEEC86C79B}"/>
                </a:ext>
              </a:extLst>
            </p:cNvPr>
            <p:cNvSpPr txBox="1"/>
            <p:nvPr/>
          </p:nvSpPr>
          <p:spPr>
            <a:xfrm>
              <a:off x="8792963" y="4932895"/>
              <a:ext cx="1403745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 err="1">
                  <a:solidFill>
                    <a:srgbClr val="000000"/>
                  </a:solidFill>
                  <a:latin typeface="Arial"/>
                  <a:cs typeface="Arial"/>
                </a:rPr>
                <a:t>Lpl</a:t>
              </a:r>
              <a:endParaRPr kumimoji="0" lang="en-US" altLang="ko-KR" sz="700" b="0" i="1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300" name="직선 연결선 299">
              <a:extLst>
                <a:ext uri="{FF2B5EF4-FFF2-40B4-BE49-F238E27FC236}">
                  <a16:creationId xmlns:a16="http://schemas.microsoft.com/office/drawing/2014/main" id="{12E5FA26-18D7-72C4-15B0-9D6C15641C21}"/>
                </a:ext>
              </a:extLst>
            </p:cNvPr>
            <p:cNvCxnSpPr/>
            <p:nvPr/>
          </p:nvCxnSpPr>
          <p:spPr>
            <a:xfrm flipV="1">
              <a:off x="8187721" y="4859207"/>
              <a:ext cx="622887" cy="566332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301" name="TextBox 300">
              <a:extLst>
                <a:ext uri="{FF2B5EF4-FFF2-40B4-BE49-F238E27FC236}">
                  <a16:creationId xmlns:a16="http://schemas.microsoft.com/office/drawing/2014/main" id="{B5D3DAB8-AEAA-E891-E9C3-36C3A2AD8A2D}"/>
                </a:ext>
              </a:extLst>
            </p:cNvPr>
            <p:cNvSpPr txBox="1"/>
            <p:nvPr/>
          </p:nvSpPr>
          <p:spPr>
            <a:xfrm>
              <a:off x="8292218" y="4210230"/>
              <a:ext cx="1845328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Clec7a</a:t>
              </a:r>
            </a:p>
          </p:txBody>
        </p:sp>
        <p:cxnSp>
          <p:nvCxnSpPr>
            <p:cNvPr id="302" name="직선 연결선 301">
              <a:extLst>
                <a:ext uri="{FF2B5EF4-FFF2-40B4-BE49-F238E27FC236}">
                  <a16:creationId xmlns:a16="http://schemas.microsoft.com/office/drawing/2014/main" id="{6DDC9A5A-A5D1-413E-F22A-0DEA7C3120DA}"/>
                </a:ext>
              </a:extLst>
            </p:cNvPr>
            <p:cNvCxnSpPr/>
            <p:nvPr/>
          </p:nvCxnSpPr>
          <p:spPr>
            <a:xfrm rot="16200000" flipH="1">
              <a:off x="1793330" y="4637968"/>
              <a:ext cx="713689" cy="242455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303" name="TextBox 302">
              <a:extLst>
                <a:ext uri="{FF2B5EF4-FFF2-40B4-BE49-F238E27FC236}">
                  <a16:creationId xmlns:a16="http://schemas.microsoft.com/office/drawing/2014/main" id="{CBCD52C9-0DBD-2B7C-2179-03AF082B8074}"/>
                </a:ext>
              </a:extLst>
            </p:cNvPr>
            <p:cNvSpPr txBox="1"/>
            <p:nvPr/>
          </p:nvSpPr>
          <p:spPr>
            <a:xfrm>
              <a:off x="1002367" y="3827364"/>
              <a:ext cx="1434298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Ftl1</a:t>
              </a:r>
            </a:p>
          </p:txBody>
        </p:sp>
        <p:cxnSp>
          <p:nvCxnSpPr>
            <p:cNvPr id="304" name="직선 연결선 303">
              <a:extLst>
                <a:ext uri="{FF2B5EF4-FFF2-40B4-BE49-F238E27FC236}">
                  <a16:creationId xmlns:a16="http://schemas.microsoft.com/office/drawing/2014/main" id="{7DEF7C51-A057-D4B9-F6A7-5BDDB31F2F96}"/>
                </a:ext>
              </a:extLst>
            </p:cNvPr>
            <p:cNvCxnSpPr/>
            <p:nvPr/>
          </p:nvCxnSpPr>
          <p:spPr>
            <a:xfrm rot="16200000" flipH="1">
              <a:off x="3313171" y="4944446"/>
              <a:ext cx="847959" cy="169533"/>
            </a:xfrm>
            <a:prstGeom prst="line">
              <a:avLst/>
            </a:prstGeom>
            <a:noFill/>
            <a:ln w="3175" cap="flat" cmpd="sng" algn="ctr">
              <a:solidFill>
                <a:srgbClr val="000000">
                  <a:alpha val="100000"/>
                </a:srgbClr>
              </a:solidFill>
              <a:prstDash val="solid"/>
            </a:ln>
          </p:spPr>
        </p:cxn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id="{3C892D19-0205-5433-84BC-D04EB2334CD3}"/>
                </a:ext>
              </a:extLst>
            </p:cNvPr>
            <p:cNvSpPr txBox="1"/>
            <p:nvPr/>
          </p:nvSpPr>
          <p:spPr>
            <a:xfrm>
              <a:off x="2603633" y="3939449"/>
              <a:ext cx="1696715" cy="789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indent="0" algn="ctr" defTabSz="914400" rtl="0" eaLnBrk="1" latinLnBrk="1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None/>
                <a:defRPr/>
              </a:pPr>
              <a:r>
                <a:rPr kumimoji="0" lang="en-US" altLang="ko-KR" sz="700" b="0" i="1" u="none" strike="noStrike" kern="1200" cap="none" spc="0" normalizeH="0" baseline="0" dirty="0">
                  <a:solidFill>
                    <a:srgbClr val="000000"/>
                  </a:solidFill>
                  <a:latin typeface="Arial"/>
                  <a:cs typeface="Arial"/>
                </a:rPr>
                <a:t>Spp1</a:t>
              </a:r>
            </a:p>
          </p:txBody>
        </p:sp>
      </p:grpSp>
      <p:sp>
        <p:nvSpPr>
          <p:cNvPr id="343" name="object 111">
            <a:extLst>
              <a:ext uri="{FF2B5EF4-FFF2-40B4-BE49-F238E27FC236}">
                <a16:creationId xmlns:a16="http://schemas.microsoft.com/office/drawing/2014/main" id="{FFE3EBB9-2B84-497D-76D3-1B929402CF80}"/>
              </a:ext>
            </a:extLst>
          </p:cNvPr>
          <p:cNvSpPr txBox="1"/>
          <p:nvPr/>
        </p:nvSpPr>
        <p:spPr>
          <a:xfrm>
            <a:off x="4415868" y="1192520"/>
            <a:ext cx="36131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dirty="0">
                <a:latin typeface="Arial"/>
                <a:cs typeface="Arial"/>
              </a:rPr>
              <a:t>V</a:t>
            </a:r>
            <a:r>
              <a:rPr sz="800" spc="-5" dirty="0">
                <a:latin typeface="Arial"/>
                <a:cs typeface="Arial"/>
              </a:rPr>
              <a:t>eh</a:t>
            </a:r>
            <a:r>
              <a:rPr sz="800" dirty="0">
                <a:latin typeface="Arial"/>
                <a:cs typeface="Arial"/>
              </a:rPr>
              <a:t>i</a:t>
            </a:r>
            <a:r>
              <a:rPr sz="800" spc="5" dirty="0">
                <a:latin typeface="Arial"/>
                <a:cs typeface="Arial"/>
              </a:rPr>
              <a:t>c</a:t>
            </a:r>
            <a:r>
              <a:rPr sz="800" dirty="0">
                <a:latin typeface="Arial"/>
                <a:cs typeface="Arial"/>
              </a:rPr>
              <a:t>le</a:t>
            </a:r>
          </a:p>
        </p:txBody>
      </p:sp>
      <p:sp>
        <p:nvSpPr>
          <p:cNvPr id="345" name="object 175">
            <a:extLst>
              <a:ext uri="{FF2B5EF4-FFF2-40B4-BE49-F238E27FC236}">
                <a16:creationId xmlns:a16="http://schemas.microsoft.com/office/drawing/2014/main" id="{37D254D3-3535-3055-50F4-9ABD5FFB34A4}"/>
              </a:ext>
            </a:extLst>
          </p:cNvPr>
          <p:cNvSpPr txBox="1"/>
          <p:nvPr/>
        </p:nvSpPr>
        <p:spPr>
          <a:xfrm>
            <a:off x="2957693" y="1218228"/>
            <a:ext cx="33591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5" dirty="0">
                <a:latin typeface="Arial"/>
                <a:cs typeface="Arial"/>
              </a:rPr>
              <a:t>5</a:t>
            </a:r>
            <a:r>
              <a:rPr sz="800" spc="-20" dirty="0">
                <a:latin typeface="Arial"/>
                <a:cs typeface="Arial"/>
              </a:rPr>
              <a:t>x</a:t>
            </a:r>
            <a:r>
              <a:rPr sz="800" dirty="0">
                <a:latin typeface="Arial"/>
                <a:cs typeface="Arial"/>
              </a:rPr>
              <a:t>FAD</a:t>
            </a:r>
          </a:p>
        </p:txBody>
      </p:sp>
      <p:sp>
        <p:nvSpPr>
          <p:cNvPr id="347" name="object 132">
            <a:extLst>
              <a:ext uri="{FF2B5EF4-FFF2-40B4-BE49-F238E27FC236}">
                <a16:creationId xmlns:a16="http://schemas.microsoft.com/office/drawing/2014/main" id="{26329D5B-3428-31D2-2960-5C419AB79468}"/>
              </a:ext>
            </a:extLst>
          </p:cNvPr>
          <p:cNvSpPr txBox="1"/>
          <p:nvPr/>
        </p:nvSpPr>
        <p:spPr>
          <a:xfrm>
            <a:off x="4955939" y="1019642"/>
            <a:ext cx="1847027" cy="18299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25400">
              <a:lnSpc>
                <a:spcPct val="158800"/>
              </a:lnSpc>
              <a:spcBef>
                <a:spcPts val="100"/>
              </a:spcBef>
              <a:tabLst>
                <a:tab pos="1170305" algn="l"/>
              </a:tabLst>
            </a:pPr>
            <a:r>
              <a:rPr sz="800" spc="-5" dirty="0">
                <a:latin typeface="Arial"/>
                <a:cs typeface="Arial"/>
              </a:rPr>
              <a:t>Cortex, </a:t>
            </a:r>
            <a:r>
              <a:rPr sz="800" dirty="0">
                <a:latin typeface="Arial"/>
                <a:cs typeface="Arial"/>
              </a:rPr>
              <a:t>Homeostatic </a:t>
            </a:r>
            <a:r>
              <a:rPr sz="800" spc="-5" dirty="0">
                <a:latin typeface="Arial"/>
                <a:cs typeface="Arial"/>
              </a:rPr>
              <a:t>Microglia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5FA7078A-0A54-71AB-4A89-93897558CAC1}"/>
              </a:ext>
            </a:extLst>
          </p:cNvPr>
          <p:cNvSpPr txBox="1"/>
          <p:nvPr/>
        </p:nvSpPr>
        <p:spPr>
          <a:xfrm>
            <a:off x="524079" y="1589153"/>
            <a:ext cx="74153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ctr" defTabSz="914400" rtl="0" eaLnBrk="1" latinLnBrk="1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700" b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 # DEG = 55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225115AA-56E1-5C16-7CD2-26AFC2992BFC}"/>
              </a:ext>
            </a:extLst>
          </p:cNvPr>
          <p:cNvSpPr txBox="1"/>
          <p:nvPr/>
        </p:nvSpPr>
        <p:spPr>
          <a:xfrm>
            <a:off x="2727416" y="1583508"/>
            <a:ext cx="74153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ctr" defTabSz="914400" rtl="0" eaLnBrk="1" latinLnBrk="1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700" b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 # DEG = </a:t>
            </a:r>
            <a:r>
              <a:rPr lang="en-US" altLang="ko-KR" sz="700" dirty="0">
                <a:solidFill>
                  <a:srgbClr val="000000"/>
                </a:solidFill>
                <a:latin typeface="Arial"/>
                <a:cs typeface="Arial"/>
              </a:rPr>
              <a:t>122</a:t>
            </a:r>
            <a:endParaRPr kumimoji="0" lang="en-US" altLang="ko-KR" sz="700" b="0" u="none" strike="noStrike" kern="1200" cap="none" spc="0" normalizeH="0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94B702E4-31C7-A3B6-1E03-6D63E9C01FB2}"/>
              </a:ext>
            </a:extLst>
          </p:cNvPr>
          <p:cNvSpPr txBox="1"/>
          <p:nvPr/>
        </p:nvSpPr>
        <p:spPr>
          <a:xfrm>
            <a:off x="4174059" y="1586659"/>
            <a:ext cx="74153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ctr" defTabSz="914400" rtl="0" eaLnBrk="1" latinLnBrk="1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700" b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 # DEG = 3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104602FB-DFC5-6C1C-38CB-67C32F4B93EE}"/>
              </a:ext>
            </a:extLst>
          </p:cNvPr>
          <p:cNvSpPr txBox="1"/>
          <p:nvPr/>
        </p:nvSpPr>
        <p:spPr>
          <a:xfrm>
            <a:off x="6377396" y="1581014"/>
            <a:ext cx="74153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ctr" defTabSz="914400" rtl="0" eaLnBrk="1" latinLnBrk="1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700" b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 # DEG = </a:t>
            </a:r>
            <a:r>
              <a:rPr lang="en-US" altLang="ko-KR" sz="700" dirty="0">
                <a:solidFill>
                  <a:srgbClr val="000000"/>
                </a:solidFill>
                <a:latin typeface="Arial"/>
                <a:cs typeface="Arial"/>
              </a:rPr>
              <a:t>26</a:t>
            </a:r>
            <a:endParaRPr kumimoji="0" lang="en-US" altLang="ko-KR" sz="700" b="0" u="none" strike="noStrike" kern="1200" cap="none" spc="0" normalizeH="0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3A0E02EC-D2AF-3DC4-AB96-73B0021CC07E}"/>
              </a:ext>
            </a:extLst>
          </p:cNvPr>
          <p:cNvSpPr txBox="1"/>
          <p:nvPr/>
        </p:nvSpPr>
        <p:spPr>
          <a:xfrm>
            <a:off x="4173588" y="3550484"/>
            <a:ext cx="74153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ctr" defTabSz="914400" rtl="0" eaLnBrk="1" latinLnBrk="1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700" b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 # DEG = 6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3D174349-CDC4-4643-CC11-456074EB6837}"/>
              </a:ext>
            </a:extLst>
          </p:cNvPr>
          <p:cNvSpPr txBox="1"/>
          <p:nvPr/>
        </p:nvSpPr>
        <p:spPr>
          <a:xfrm>
            <a:off x="6376925" y="3544839"/>
            <a:ext cx="74153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ctr" defTabSz="914400" rtl="0" eaLnBrk="1" latinLnBrk="1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700" b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 # DEG = </a:t>
            </a:r>
            <a:r>
              <a:rPr lang="en-US" altLang="ko-KR" sz="700" dirty="0">
                <a:solidFill>
                  <a:srgbClr val="000000"/>
                </a:solidFill>
                <a:latin typeface="Arial"/>
                <a:cs typeface="Arial"/>
              </a:rPr>
              <a:t>57</a:t>
            </a:r>
            <a:endParaRPr kumimoji="0" lang="en-US" altLang="ko-KR" sz="700" b="0" u="none" strike="noStrike" kern="1200" cap="none" spc="0" normalizeH="0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4E5A117A-691D-4757-26DF-9FB7EE86A49B}"/>
              </a:ext>
            </a:extLst>
          </p:cNvPr>
          <p:cNvSpPr txBox="1"/>
          <p:nvPr/>
        </p:nvSpPr>
        <p:spPr>
          <a:xfrm>
            <a:off x="520759" y="3665730"/>
            <a:ext cx="74153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ctr" defTabSz="914400" rtl="0" eaLnBrk="1" latinLnBrk="1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700" b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 # DEG = </a:t>
            </a:r>
            <a:r>
              <a:rPr lang="en-US" altLang="ko-KR" sz="700" dirty="0">
                <a:solidFill>
                  <a:srgbClr val="000000"/>
                </a:solidFill>
                <a:latin typeface="Arial"/>
                <a:cs typeface="Arial"/>
              </a:rPr>
              <a:t>65</a:t>
            </a:r>
            <a:endParaRPr kumimoji="0" lang="en-US" altLang="ko-KR" sz="700" b="0" u="none" strike="noStrike" kern="1200" cap="none" spc="0" normalizeH="0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08F486C7-3DBF-12CE-1414-EF757D4B89F9}"/>
              </a:ext>
            </a:extLst>
          </p:cNvPr>
          <p:cNvSpPr txBox="1"/>
          <p:nvPr/>
        </p:nvSpPr>
        <p:spPr>
          <a:xfrm>
            <a:off x="2724096" y="3660085"/>
            <a:ext cx="74153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ctr" defTabSz="914400" rtl="0" eaLnBrk="1" latinLnBrk="1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700" b="0" u="none" strike="noStrike" kern="1200" cap="none" spc="0" normalizeH="0" baseline="0" dirty="0">
                <a:solidFill>
                  <a:srgbClr val="000000"/>
                </a:solidFill>
                <a:latin typeface="Arial"/>
                <a:cs typeface="Arial"/>
              </a:rPr>
              <a:t> # DEG = </a:t>
            </a:r>
            <a:r>
              <a:rPr lang="en-US" altLang="ko-KR" sz="700" dirty="0">
                <a:solidFill>
                  <a:srgbClr val="000000"/>
                </a:solidFill>
                <a:latin typeface="Arial"/>
                <a:cs typeface="Arial"/>
              </a:rPr>
              <a:t>30</a:t>
            </a:r>
            <a:endParaRPr kumimoji="0" lang="en-US" altLang="ko-KR" sz="700" b="0" u="none" strike="noStrike" kern="1200" cap="none" spc="0" normalizeH="0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</TotalTime>
  <Words>142</Words>
  <Application>Microsoft Office PowerPoint</Application>
  <PresentationFormat>사용자 지정</PresentationFormat>
  <Paragraphs>6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5</dc:title>
  <cp:lastModifiedBy>조경원</cp:lastModifiedBy>
  <cp:revision>3</cp:revision>
  <dcterms:created xsi:type="dcterms:W3CDTF">2022-03-15T12:21:05Z</dcterms:created>
  <dcterms:modified xsi:type="dcterms:W3CDTF">2022-09-15T17:08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1-12-23T00:00:00Z</vt:filetime>
  </property>
  <property fmtid="{D5CDD505-2E9C-101B-9397-08002B2CF9AE}" pid="3" name="Creator">
    <vt:lpwstr>Adobe Illustrator CS6 (Windows)</vt:lpwstr>
  </property>
  <property fmtid="{D5CDD505-2E9C-101B-9397-08002B2CF9AE}" pid="4" name="LastSaved">
    <vt:filetime>2022-03-15T00:00:00Z</vt:filetime>
  </property>
</Properties>
</file>